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ppt/ink/ink2.xml" ContentType="application/inkml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17"/>
  </p:notesMasterIdLst>
  <p:sldIdLst>
    <p:sldId id="256" r:id="rId3"/>
    <p:sldId id="257" r:id="rId4"/>
    <p:sldId id="266" r:id="rId5"/>
    <p:sldId id="259" r:id="rId6"/>
    <p:sldId id="258" r:id="rId7"/>
    <p:sldId id="267" r:id="rId8"/>
    <p:sldId id="261" r:id="rId9"/>
    <p:sldId id="262" r:id="rId10"/>
    <p:sldId id="263" r:id="rId11"/>
    <p:sldId id="272" r:id="rId12"/>
    <p:sldId id="268" r:id="rId13"/>
    <p:sldId id="269" r:id="rId14"/>
    <p:sldId id="270" r:id="rId15"/>
    <p:sldId id="271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98693C1-2D78-F347-664D-9399BF3EDDF3}" name="Papaioannou, Ioannis" initials="IP" userId="S::rmhaip0@ucl.ac.uk::27d0d6e0-1133-45d1-b366-9071ba1a55b0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onticos, Markella" initials="PM" lastIdx="2" clrIdx="0">
    <p:extLst>
      <p:ext uri="{19B8F6BF-5375-455C-9EA6-DF929625EA0E}">
        <p15:presenceInfo xmlns:p15="http://schemas.microsoft.com/office/powerpoint/2012/main" userId="S::rmhampo@ucl.ac.uk::8ef50869-c47f-477f-819f-244d7318bb2d" providerId="AD"/>
      </p:ext>
    </p:extLst>
  </p:cmAuthor>
  <p:cmAuthor id="2" name="Papaioannou, Ioannis" initials="PI" lastIdx="1" clrIdx="1">
    <p:extLst>
      <p:ext uri="{19B8F6BF-5375-455C-9EA6-DF929625EA0E}">
        <p15:presenceInfo xmlns:p15="http://schemas.microsoft.com/office/powerpoint/2012/main" userId="Papaioannou, Ioanni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041" autoAdjust="0"/>
  </p:normalViewPr>
  <p:slideViewPr>
    <p:cSldViewPr snapToGrid="0">
      <p:cViewPr varScale="1">
        <p:scale>
          <a:sx n="101" d="100"/>
          <a:sy n="101" d="100"/>
        </p:scale>
        <p:origin x="9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commentAuthors" Target="commentAuthors.xml"/><Relationship Id="rId3" Type="http://schemas.openxmlformats.org/officeDocument/2006/relationships/slide" Target="slides/slide1.xml"/><Relationship Id="rId21" Type="http://schemas.openxmlformats.org/officeDocument/2006/relationships/theme" Target="theme/them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microsoft.com/office/2018/10/relationships/authors" Target="authors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microsoft.com/office/2016/11/relationships/changesInfo" Target="changesInfos/changesInfo1.xml"/><Relationship Id="rId10" Type="http://schemas.openxmlformats.org/officeDocument/2006/relationships/slide" Target="slides/slide8.xml"/><Relationship Id="rId19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apaioannou, Ioannis" userId="27d0d6e0-1133-45d1-b366-9071ba1a55b0" providerId="ADAL" clId="{09A5A6E7-5AD0-42C9-91F3-0518137A29BA}"/>
    <pc:docChg chg="undo custSel addSld modSld">
      <pc:chgData name="Papaioannou, Ioannis" userId="27d0d6e0-1133-45d1-b366-9071ba1a55b0" providerId="ADAL" clId="{09A5A6E7-5AD0-42C9-91F3-0518137A29BA}" dt="2024-03-26T04:59:13.063" v="1244" actId="1076"/>
      <pc:docMkLst>
        <pc:docMk/>
      </pc:docMkLst>
      <pc:sldChg chg="addSp delSp modSp mod">
        <pc:chgData name="Papaioannou, Ioannis" userId="27d0d6e0-1133-45d1-b366-9071ba1a55b0" providerId="ADAL" clId="{09A5A6E7-5AD0-42C9-91F3-0518137A29BA}" dt="2024-03-10T13:41:38.846" v="382" actId="1076"/>
        <pc:sldMkLst>
          <pc:docMk/>
          <pc:sldMk cId="1783988844" sldId="256"/>
        </pc:sldMkLst>
        <pc:spChg chg="add mod">
          <ac:chgData name="Papaioannou, Ioannis" userId="27d0d6e0-1133-45d1-b366-9071ba1a55b0" providerId="ADAL" clId="{09A5A6E7-5AD0-42C9-91F3-0518137A29BA}" dt="2024-03-10T13:39:52.002" v="376" actId="1036"/>
          <ac:spMkLst>
            <pc:docMk/>
            <pc:sldMk cId="1783988844" sldId="256"/>
            <ac:spMk id="2" creationId="{F0BEF6A5-880B-1684-7F3A-762BE2CC97B2}"/>
          </ac:spMkLst>
        </pc:spChg>
        <pc:spChg chg="mod">
          <ac:chgData name="Papaioannou, Ioannis" userId="27d0d6e0-1133-45d1-b366-9071ba1a55b0" providerId="ADAL" clId="{09A5A6E7-5AD0-42C9-91F3-0518137A29BA}" dt="2024-02-22T16:48:11.676" v="34" actId="1076"/>
          <ac:spMkLst>
            <pc:docMk/>
            <pc:sldMk cId="1783988844" sldId="256"/>
            <ac:spMk id="5" creationId="{9D7FE762-1A09-5608-35F3-82B99B644A3D}"/>
          </ac:spMkLst>
        </pc:spChg>
        <pc:spChg chg="mod">
          <ac:chgData name="Papaioannou, Ioannis" userId="27d0d6e0-1133-45d1-b366-9071ba1a55b0" providerId="ADAL" clId="{09A5A6E7-5AD0-42C9-91F3-0518137A29BA}" dt="2024-02-22T16:48:07.232" v="33" actId="14100"/>
          <ac:spMkLst>
            <pc:docMk/>
            <pc:sldMk cId="1783988844" sldId="256"/>
            <ac:spMk id="12" creationId="{D256E583-9CF0-7E8A-F921-602F81B40AEA}"/>
          </ac:spMkLst>
        </pc:spChg>
        <pc:spChg chg="mod">
          <ac:chgData name="Papaioannou, Ioannis" userId="27d0d6e0-1133-45d1-b366-9071ba1a55b0" providerId="ADAL" clId="{09A5A6E7-5AD0-42C9-91F3-0518137A29BA}" dt="2024-02-22T16:48:25.295" v="36" actId="1076"/>
          <ac:spMkLst>
            <pc:docMk/>
            <pc:sldMk cId="1783988844" sldId="256"/>
            <ac:spMk id="20" creationId="{B0EAA019-14C7-0F2C-E08F-973938194268}"/>
          </ac:spMkLst>
        </pc:spChg>
        <pc:spChg chg="mod">
          <ac:chgData name="Papaioannou, Ioannis" userId="27d0d6e0-1133-45d1-b366-9071ba1a55b0" providerId="ADAL" clId="{09A5A6E7-5AD0-42C9-91F3-0518137A29BA}" dt="2024-03-10T13:30:13.725" v="357" actId="1076"/>
          <ac:spMkLst>
            <pc:docMk/>
            <pc:sldMk cId="1783988844" sldId="256"/>
            <ac:spMk id="21" creationId="{A4196A9E-DBEE-CF70-F857-56E26493FEA9}"/>
          </ac:spMkLst>
        </pc:spChg>
        <pc:spChg chg="mod">
          <ac:chgData name="Papaioannou, Ioannis" userId="27d0d6e0-1133-45d1-b366-9071ba1a55b0" providerId="ADAL" clId="{09A5A6E7-5AD0-42C9-91F3-0518137A29BA}" dt="2024-02-22T16:48:32.752" v="37" actId="1076"/>
          <ac:spMkLst>
            <pc:docMk/>
            <pc:sldMk cId="1783988844" sldId="256"/>
            <ac:spMk id="24" creationId="{F863FC06-8519-5F15-A418-0A68892E4F59}"/>
          </ac:spMkLst>
        </pc:spChg>
        <pc:spChg chg="mod">
          <ac:chgData name="Papaioannou, Ioannis" userId="27d0d6e0-1133-45d1-b366-9071ba1a55b0" providerId="ADAL" clId="{09A5A6E7-5AD0-42C9-91F3-0518137A29BA}" dt="2024-02-22T16:48:42.536" v="39" actId="1076"/>
          <ac:spMkLst>
            <pc:docMk/>
            <pc:sldMk cId="1783988844" sldId="256"/>
            <ac:spMk id="26" creationId="{E5E1AE59-8AD0-EE69-77C0-E60C4EE5CDF5}"/>
          </ac:spMkLst>
        </pc:spChg>
        <pc:spChg chg="mod">
          <ac:chgData name="Papaioannou, Ioannis" userId="27d0d6e0-1133-45d1-b366-9071ba1a55b0" providerId="ADAL" clId="{09A5A6E7-5AD0-42C9-91F3-0518137A29BA}" dt="2024-03-10T13:39:28.207" v="365" actId="1076"/>
          <ac:spMkLst>
            <pc:docMk/>
            <pc:sldMk cId="1783988844" sldId="256"/>
            <ac:spMk id="53" creationId="{9499A77C-133B-137E-36E8-DF4383C196E0}"/>
          </ac:spMkLst>
        </pc:spChg>
        <pc:spChg chg="mod">
          <ac:chgData name="Papaioannou, Ioannis" userId="27d0d6e0-1133-45d1-b366-9071ba1a55b0" providerId="ADAL" clId="{09A5A6E7-5AD0-42C9-91F3-0518137A29BA}" dt="2024-02-22T16:43:58.276" v="10" actId="1076"/>
          <ac:spMkLst>
            <pc:docMk/>
            <pc:sldMk cId="1783988844" sldId="256"/>
            <ac:spMk id="54" creationId="{9148308D-6424-4DA9-DCA3-6D2E41261E43}"/>
          </ac:spMkLst>
        </pc:spChg>
        <pc:spChg chg="mod">
          <ac:chgData name="Papaioannou, Ioannis" userId="27d0d6e0-1133-45d1-b366-9071ba1a55b0" providerId="ADAL" clId="{09A5A6E7-5AD0-42C9-91F3-0518137A29BA}" dt="2024-02-22T16:48:36.662" v="38" actId="1076"/>
          <ac:spMkLst>
            <pc:docMk/>
            <pc:sldMk cId="1783988844" sldId="256"/>
            <ac:spMk id="55" creationId="{B83B2295-32E6-F04B-FB94-F4D50DF273AE}"/>
          </ac:spMkLst>
        </pc:spChg>
        <pc:picChg chg="mod">
          <ac:chgData name="Papaioannou, Ioannis" userId="27d0d6e0-1133-45d1-b366-9071ba1a55b0" providerId="ADAL" clId="{09A5A6E7-5AD0-42C9-91F3-0518137A29BA}" dt="2024-02-22T16:47:49.832" v="30" actId="1076"/>
          <ac:picMkLst>
            <pc:docMk/>
            <pc:sldMk cId="1783988844" sldId="256"/>
            <ac:picMk id="11" creationId="{63A0BF3A-AF5F-5870-F66F-2BE69BC3DEF8}"/>
          </ac:picMkLst>
        </pc:picChg>
        <pc:picChg chg="del mod">
          <ac:chgData name="Papaioannou, Ioannis" userId="27d0d6e0-1133-45d1-b366-9071ba1a55b0" providerId="ADAL" clId="{09A5A6E7-5AD0-42C9-91F3-0518137A29BA}" dt="2024-03-10T13:41:26.839" v="378" actId="478"/>
          <ac:picMkLst>
            <pc:docMk/>
            <pc:sldMk cId="1783988844" sldId="256"/>
            <ac:picMk id="17" creationId="{6C32DC27-B56E-5065-1794-E24266D7A9CE}"/>
          </ac:picMkLst>
        </pc:picChg>
        <pc:picChg chg="mod">
          <ac:chgData name="Papaioannou, Ioannis" userId="27d0d6e0-1133-45d1-b366-9071ba1a55b0" providerId="ADAL" clId="{09A5A6E7-5AD0-42C9-91F3-0518137A29BA}" dt="2024-03-10T13:22:30.640" v="354" actId="1076"/>
          <ac:picMkLst>
            <pc:docMk/>
            <pc:sldMk cId="1783988844" sldId="256"/>
            <ac:picMk id="19" creationId="{BC7D0C30-9751-A5A0-8F65-295055330FF7}"/>
          </ac:picMkLst>
        </pc:picChg>
        <pc:picChg chg="mod">
          <ac:chgData name="Papaioannou, Ioannis" userId="27d0d6e0-1133-45d1-b366-9071ba1a55b0" providerId="ADAL" clId="{09A5A6E7-5AD0-42C9-91F3-0518137A29BA}" dt="2024-02-22T16:47:49.832" v="30" actId="1076"/>
          <ac:picMkLst>
            <pc:docMk/>
            <pc:sldMk cId="1783988844" sldId="256"/>
            <ac:picMk id="23" creationId="{2BC06D45-542B-2253-6C24-06633B7B0B9D}"/>
          </ac:picMkLst>
        </pc:picChg>
        <pc:picChg chg="mod">
          <ac:chgData name="Papaioannou, Ioannis" userId="27d0d6e0-1133-45d1-b366-9071ba1a55b0" providerId="ADAL" clId="{09A5A6E7-5AD0-42C9-91F3-0518137A29BA}" dt="2024-02-22T16:47:49.832" v="30" actId="1076"/>
          <ac:picMkLst>
            <pc:docMk/>
            <pc:sldMk cId="1783988844" sldId="256"/>
            <ac:picMk id="25" creationId="{F2F2D079-D5C2-B4B0-73B0-BF6670D90E42}"/>
          </ac:picMkLst>
        </pc:picChg>
        <pc:picChg chg="add mod">
          <ac:chgData name="Papaioannou, Ioannis" userId="27d0d6e0-1133-45d1-b366-9071ba1a55b0" providerId="ADAL" clId="{09A5A6E7-5AD0-42C9-91F3-0518137A29BA}" dt="2024-03-10T13:41:38.846" v="382" actId="1076"/>
          <ac:picMkLst>
            <pc:docMk/>
            <pc:sldMk cId="1783988844" sldId="256"/>
            <ac:picMk id="27" creationId="{0993C4F0-9CD9-0119-F6CD-4E6DD55BCC29}"/>
          </ac:picMkLst>
        </pc:picChg>
        <pc:cxnChg chg="add del">
          <ac:chgData name="Papaioannou, Ioannis" userId="27d0d6e0-1133-45d1-b366-9071ba1a55b0" providerId="ADAL" clId="{09A5A6E7-5AD0-42C9-91F3-0518137A29BA}" dt="2024-02-22T16:42:05.417" v="4" actId="478"/>
          <ac:cxnSpMkLst>
            <pc:docMk/>
            <pc:sldMk cId="1783988844" sldId="256"/>
            <ac:cxnSpMk id="9" creationId="{0A4747B2-4F00-79EF-CDC4-615553A3167A}"/>
          </ac:cxnSpMkLst>
        </pc:cxnChg>
        <pc:cxnChg chg="add mod">
          <ac:chgData name="Papaioannou, Ioannis" userId="27d0d6e0-1133-45d1-b366-9071ba1a55b0" providerId="ADAL" clId="{09A5A6E7-5AD0-42C9-91F3-0518137A29BA}" dt="2024-03-10T13:39:55.553" v="377" actId="14100"/>
          <ac:cxnSpMkLst>
            <pc:docMk/>
            <pc:sldMk cId="1783988844" sldId="256"/>
            <ac:cxnSpMk id="15" creationId="{41E0F4BA-63A5-4D84-2500-D66C2D739CD0}"/>
          </ac:cxnSpMkLst>
        </pc:cxnChg>
      </pc:sldChg>
      <pc:sldChg chg="addSp delSp modSp mod">
        <pc:chgData name="Papaioannou, Ioannis" userId="27d0d6e0-1133-45d1-b366-9071ba1a55b0" providerId="ADAL" clId="{09A5A6E7-5AD0-42C9-91F3-0518137A29BA}" dt="2024-03-10T10:53:58.693" v="352" actId="571"/>
        <pc:sldMkLst>
          <pc:docMk/>
          <pc:sldMk cId="2731541974" sldId="258"/>
        </pc:sldMkLst>
        <pc:spChg chg="add mod">
          <ac:chgData name="Papaioannou, Ioannis" userId="27d0d6e0-1133-45d1-b366-9071ba1a55b0" providerId="ADAL" clId="{09A5A6E7-5AD0-42C9-91F3-0518137A29BA}" dt="2024-03-10T10:08:37.353" v="65" actId="1076"/>
          <ac:spMkLst>
            <pc:docMk/>
            <pc:sldMk cId="2731541974" sldId="258"/>
            <ac:spMk id="9" creationId="{48D82FA3-73E1-C94A-6C71-2CBE5CBB1A98}"/>
          </ac:spMkLst>
        </pc:spChg>
        <pc:spChg chg="mod">
          <ac:chgData name="Papaioannou, Ioannis" userId="27d0d6e0-1133-45d1-b366-9071ba1a55b0" providerId="ADAL" clId="{09A5A6E7-5AD0-42C9-91F3-0518137A29BA}" dt="2024-03-10T10:48:12.039" v="337" actId="1076"/>
          <ac:spMkLst>
            <pc:docMk/>
            <pc:sldMk cId="2731541974" sldId="258"/>
            <ac:spMk id="13" creationId="{9B4E1444-D491-9690-0B1E-B70B66DCE323}"/>
          </ac:spMkLst>
        </pc:spChg>
        <pc:spChg chg="mod">
          <ac:chgData name="Papaioannou, Ioannis" userId="27d0d6e0-1133-45d1-b366-9071ba1a55b0" providerId="ADAL" clId="{09A5A6E7-5AD0-42C9-91F3-0518137A29BA}" dt="2024-03-10T10:40:18.189" v="322" actId="1076"/>
          <ac:spMkLst>
            <pc:docMk/>
            <pc:sldMk cId="2731541974" sldId="258"/>
            <ac:spMk id="26" creationId="{6B623AEC-DE4A-21B5-2A9A-B4BA632452C9}"/>
          </ac:spMkLst>
        </pc:spChg>
        <pc:spChg chg="mod">
          <ac:chgData name="Papaioannou, Ioannis" userId="27d0d6e0-1133-45d1-b366-9071ba1a55b0" providerId="ADAL" clId="{09A5A6E7-5AD0-42C9-91F3-0518137A29BA}" dt="2024-03-10T10:39:13.791" v="318" actId="1076"/>
          <ac:spMkLst>
            <pc:docMk/>
            <pc:sldMk cId="2731541974" sldId="258"/>
            <ac:spMk id="27" creationId="{16E73462-4B9F-AA46-4F33-A010E9635393}"/>
          </ac:spMkLst>
        </pc:spChg>
        <pc:spChg chg="mod">
          <ac:chgData name="Papaioannou, Ioannis" userId="27d0d6e0-1133-45d1-b366-9071ba1a55b0" providerId="ADAL" clId="{09A5A6E7-5AD0-42C9-91F3-0518137A29BA}" dt="2024-03-10T10:40:31.908" v="327" actId="1076"/>
          <ac:spMkLst>
            <pc:docMk/>
            <pc:sldMk cId="2731541974" sldId="258"/>
            <ac:spMk id="28" creationId="{A02A8AB1-9E5E-771B-52FF-A366E4EB6C5B}"/>
          </ac:spMkLst>
        </pc:spChg>
        <pc:spChg chg="mod">
          <ac:chgData name="Papaioannou, Ioannis" userId="27d0d6e0-1133-45d1-b366-9071ba1a55b0" providerId="ADAL" clId="{09A5A6E7-5AD0-42C9-91F3-0518137A29BA}" dt="2024-03-10T10:40:28.622" v="326" actId="1076"/>
          <ac:spMkLst>
            <pc:docMk/>
            <pc:sldMk cId="2731541974" sldId="258"/>
            <ac:spMk id="29" creationId="{CC027824-C764-618B-11C8-36268260F2B9}"/>
          </ac:spMkLst>
        </pc:spChg>
        <pc:spChg chg="add mod">
          <ac:chgData name="Papaioannou, Ioannis" userId="27d0d6e0-1133-45d1-b366-9071ba1a55b0" providerId="ADAL" clId="{09A5A6E7-5AD0-42C9-91F3-0518137A29BA}" dt="2024-03-10T10:08:58.320" v="71" actId="1038"/>
          <ac:spMkLst>
            <pc:docMk/>
            <pc:sldMk cId="2731541974" sldId="258"/>
            <ac:spMk id="31" creationId="{118BCABD-B5C9-9268-89B4-02A2122BF2EF}"/>
          </ac:spMkLst>
        </pc:spChg>
        <pc:spChg chg="add mod">
          <ac:chgData name="Papaioannou, Ioannis" userId="27d0d6e0-1133-45d1-b366-9071ba1a55b0" providerId="ADAL" clId="{09A5A6E7-5AD0-42C9-91F3-0518137A29BA}" dt="2024-03-10T10:08:50.692" v="70" actId="571"/>
          <ac:spMkLst>
            <pc:docMk/>
            <pc:sldMk cId="2731541974" sldId="258"/>
            <ac:spMk id="32" creationId="{E5632058-BCD3-7457-0A67-C014CDB257A9}"/>
          </ac:spMkLst>
        </pc:spChg>
        <pc:spChg chg="add mod">
          <ac:chgData name="Papaioannou, Ioannis" userId="27d0d6e0-1133-45d1-b366-9071ba1a55b0" providerId="ADAL" clId="{09A5A6E7-5AD0-42C9-91F3-0518137A29BA}" dt="2024-03-10T10:09:02.548" v="72" actId="1038"/>
          <ac:spMkLst>
            <pc:docMk/>
            <pc:sldMk cId="2731541974" sldId="258"/>
            <ac:spMk id="33" creationId="{52B7513F-C1CC-86CA-F0E6-FFDE4EA7F37F}"/>
          </ac:spMkLst>
        </pc:spChg>
        <pc:spChg chg="add mod">
          <ac:chgData name="Papaioannou, Ioannis" userId="27d0d6e0-1133-45d1-b366-9071ba1a55b0" providerId="ADAL" clId="{09A5A6E7-5AD0-42C9-91F3-0518137A29BA}" dt="2024-03-10T10:09:20.647" v="73" actId="571"/>
          <ac:spMkLst>
            <pc:docMk/>
            <pc:sldMk cId="2731541974" sldId="258"/>
            <ac:spMk id="34" creationId="{4A2E0B7C-DC2C-A662-3FB1-02F3951E3813}"/>
          </ac:spMkLst>
        </pc:spChg>
        <pc:spChg chg="add mod">
          <ac:chgData name="Papaioannou, Ioannis" userId="27d0d6e0-1133-45d1-b366-9071ba1a55b0" providerId="ADAL" clId="{09A5A6E7-5AD0-42C9-91F3-0518137A29BA}" dt="2024-03-10T10:09:40.822" v="75" actId="1076"/>
          <ac:spMkLst>
            <pc:docMk/>
            <pc:sldMk cId="2731541974" sldId="258"/>
            <ac:spMk id="35" creationId="{07A2C486-8C21-F11C-0829-BFB342568FA2}"/>
          </ac:spMkLst>
        </pc:spChg>
        <pc:spChg chg="add mod">
          <ac:chgData name="Papaioannou, Ioannis" userId="27d0d6e0-1133-45d1-b366-9071ba1a55b0" providerId="ADAL" clId="{09A5A6E7-5AD0-42C9-91F3-0518137A29BA}" dt="2024-03-10T10:09:40.822" v="75" actId="1076"/>
          <ac:spMkLst>
            <pc:docMk/>
            <pc:sldMk cId="2731541974" sldId="258"/>
            <ac:spMk id="36" creationId="{5633D25E-6693-133B-3D6B-32B2F4BF8F3E}"/>
          </ac:spMkLst>
        </pc:spChg>
        <pc:spChg chg="add mod">
          <ac:chgData name="Papaioannou, Ioannis" userId="27d0d6e0-1133-45d1-b366-9071ba1a55b0" providerId="ADAL" clId="{09A5A6E7-5AD0-42C9-91F3-0518137A29BA}" dt="2024-03-10T10:09:40.822" v="75" actId="1076"/>
          <ac:spMkLst>
            <pc:docMk/>
            <pc:sldMk cId="2731541974" sldId="258"/>
            <ac:spMk id="37" creationId="{16255447-1EB8-853C-DF8E-6F311D7933D9}"/>
          </ac:spMkLst>
        </pc:spChg>
        <pc:spChg chg="add mod">
          <ac:chgData name="Papaioannou, Ioannis" userId="27d0d6e0-1133-45d1-b366-9071ba1a55b0" providerId="ADAL" clId="{09A5A6E7-5AD0-42C9-91F3-0518137A29BA}" dt="2024-03-10T10:09:44.209" v="76" actId="1076"/>
          <ac:spMkLst>
            <pc:docMk/>
            <pc:sldMk cId="2731541974" sldId="258"/>
            <ac:spMk id="38" creationId="{01B8E99A-692B-A5D7-675E-5DB571DEE883}"/>
          </ac:spMkLst>
        </pc:spChg>
        <pc:spChg chg="add mod">
          <ac:chgData name="Papaioannou, Ioannis" userId="27d0d6e0-1133-45d1-b366-9071ba1a55b0" providerId="ADAL" clId="{09A5A6E7-5AD0-42C9-91F3-0518137A29BA}" dt="2024-03-10T10:15:43.025" v="191" actId="20577"/>
          <ac:spMkLst>
            <pc:docMk/>
            <pc:sldMk cId="2731541974" sldId="258"/>
            <ac:spMk id="39" creationId="{95B9921D-B80C-3553-CB26-9027ACBADD16}"/>
          </ac:spMkLst>
        </pc:spChg>
        <pc:spChg chg="add mod">
          <ac:chgData name="Papaioannou, Ioannis" userId="27d0d6e0-1133-45d1-b366-9071ba1a55b0" providerId="ADAL" clId="{09A5A6E7-5AD0-42C9-91F3-0518137A29BA}" dt="2024-03-10T10:10:43.611" v="110" actId="20577"/>
          <ac:spMkLst>
            <pc:docMk/>
            <pc:sldMk cId="2731541974" sldId="258"/>
            <ac:spMk id="40" creationId="{D7FC54BC-1222-5DBE-3B82-E0C5A57E38E6}"/>
          </ac:spMkLst>
        </pc:spChg>
        <pc:spChg chg="add mod">
          <ac:chgData name="Papaioannou, Ioannis" userId="27d0d6e0-1133-45d1-b366-9071ba1a55b0" providerId="ADAL" clId="{09A5A6E7-5AD0-42C9-91F3-0518137A29BA}" dt="2024-03-10T10:17:03.267" v="192" actId="20577"/>
          <ac:spMkLst>
            <pc:docMk/>
            <pc:sldMk cId="2731541974" sldId="258"/>
            <ac:spMk id="41" creationId="{2C59481F-3BE6-FF0C-0C0E-CE3B397EB40C}"/>
          </ac:spMkLst>
        </pc:spChg>
        <pc:spChg chg="add mod">
          <ac:chgData name="Papaioannou, Ioannis" userId="27d0d6e0-1133-45d1-b366-9071ba1a55b0" providerId="ADAL" clId="{09A5A6E7-5AD0-42C9-91F3-0518137A29BA}" dt="2024-03-10T10:13:22.533" v="133" actId="20577"/>
          <ac:spMkLst>
            <pc:docMk/>
            <pc:sldMk cId="2731541974" sldId="258"/>
            <ac:spMk id="42" creationId="{3CCEEE1F-C554-2D0B-9B47-D39DF19771C0}"/>
          </ac:spMkLst>
        </pc:spChg>
        <pc:spChg chg="add mod">
          <ac:chgData name="Papaioannou, Ioannis" userId="27d0d6e0-1133-45d1-b366-9071ba1a55b0" providerId="ADAL" clId="{09A5A6E7-5AD0-42C9-91F3-0518137A29BA}" dt="2024-03-10T10:18:10.037" v="270" actId="14100"/>
          <ac:spMkLst>
            <pc:docMk/>
            <pc:sldMk cId="2731541974" sldId="258"/>
            <ac:spMk id="45" creationId="{3960A0EF-AD57-F396-757E-68A6D5739FDE}"/>
          </ac:spMkLst>
        </pc:spChg>
        <pc:spChg chg="add del mod">
          <ac:chgData name="Papaioannou, Ioannis" userId="27d0d6e0-1133-45d1-b366-9071ba1a55b0" providerId="ADAL" clId="{09A5A6E7-5AD0-42C9-91F3-0518137A29BA}" dt="2024-03-10T10:40:23.749" v="325" actId="478"/>
          <ac:spMkLst>
            <pc:docMk/>
            <pc:sldMk cId="2731541974" sldId="258"/>
            <ac:spMk id="48" creationId="{84B6F3A9-64B0-ECB6-2850-481E3B364871}"/>
          </ac:spMkLst>
        </pc:spChg>
        <pc:spChg chg="add mod">
          <ac:chgData name="Papaioannou, Ioannis" userId="27d0d6e0-1133-45d1-b366-9071ba1a55b0" providerId="ADAL" clId="{09A5A6E7-5AD0-42C9-91F3-0518137A29BA}" dt="2024-03-10T10:40:18.189" v="322" actId="1076"/>
          <ac:spMkLst>
            <pc:docMk/>
            <pc:sldMk cId="2731541974" sldId="258"/>
            <ac:spMk id="49" creationId="{2E8F2456-6A5C-7D87-AADF-AC46912E66C7}"/>
          </ac:spMkLst>
        </pc:spChg>
        <pc:spChg chg="add del mod">
          <ac:chgData name="Papaioannou, Ioannis" userId="27d0d6e0-1133-45d1-b366-9071ba1a55b0" providerId="ADAL" clId="{09A5A6E7-5AD0-42C9-91F3-0518137A29BA}" dt="2024-03-10T10:38:10.234" v="311" actId="478"/>
          <ac:spMkLst>
            <pc:docMk/>
            <pc:sldMk cId="2731541974" sldId="258"/>
            <ac:spMk id="50" creationId="{19FD893B-851B-989B-B7B7-0312B00524B4}"/>
          </ac:spMkLst>
        </pc:spChg>
        <pc:spChg chg="add del mod">
          <ac:chgData name="Papaioannou, Ioannis" userId="27d0d6e0-1133-45d1-b366-9071ba1a55b0" providerId="ADAL" clId="{09A5A6E7-5AD0-42C9-91F3-0518137A29BA}" dt="2024-03-10T10:38:10.234" v="311" actId="478"/>
          <ac:spMkLst>
            <pc:docMk/>
            <pc:sldMk cId="2731541974" sldId="258"/>
            <ac:spMk id="51" creationId="{937ACA24-2685-D298-5864-BDF7FDEF7CD7}"/>
          </ac:spMkLst>
        </pc:spChg>
        <pc:spChg chg="add mod">
          <ac:chgData name="Papaioannou, Ioannis" userId="27d0d6e0-1133-45d1-b366-9071ba1a55b0" providerId="ADAL" clId="{09A5A6E7-5AD0-42C9-91F3-0518137A29BA}" dt="2024-03-10T10:53:38.620" v="351" actId="1076"/>
          <ac:spMkLst>
            <pc:docMk/>
            <pc:sldMk cId="2731541974" sldId="258"/>
            <ac:spMk id="58" creationId="{69C554A6-77FD-CAD5-29CD-110A0793B460}"/>
          </ac:spMkLst>
        </pc:spChg>
        <pc:spChg chg="add mod">
          <ac:chgData name="Papaioannou, Ioannis" userId="27d0d6e0-1133-45d1-b366-9071ba1a55b0" providerId="ADAL" clId="{09A5A6E7-5AD0-42C9-91F3-0518137A29BA}" dt="2024-03-10T10:53:34.565" v="350" actId="571"/>
          <ac:spMkLst>
            <pc:docMk/>
            <pc:sldMk cId="2731541974" sldId="258"/>
            <ac:spMk id="59" creationId="{18B4C3C4-72ED-BC41-499D-CB684DD4F99B}"/>
          </ac:spMkLst>
        </pc:spChg>
        <pc:spChg chg="add mod">
          <ac:chgData name="Papaioannou, Ioannis" userId="27d0d6e0-1133-45d1-b366-9071ba1a55b0" providerId="ADAL" clId="{09A5A6E7-5AD0-42C9-91F3-0518137A29BA}" dt="2024-03-10T10:53:38.620" v="351" actId="1076"/>
          <ac:spMkLst>
            <pc:docMk/>
            <pc:sldMk cId="2731541974" sldId="258"/>
            <ac:spMk id="60" creationId="{9FDFE927-58DB-424F-3022-5F4278FBF997}"/>
          </ac:spMkLst>
        </pc:spChg>
        <pc:spChg chg="add mod">
          <ac:chgData name="Papaioannou, Ioannis" userId="27d0d6e0-1133-45d1-b366-9071ba1a55b0" providerId="ADAL" clId="{09A5A6E7-5AD0-42C9-91F3-0518137A29BA}" dt="2024-03-10T10:53:58.693" v="352" actId="571"/>
          <ac:spMkLst>
            <pc:docMk/>
            <pc:sldMk cId="2731541974" sldId="258"/>
            <ac:spMk id="61" creationId="{22B940D7-B9C2-89AC-42F7-57595331C774}"/>
          </ac:spMkLst>
        </pc:spChg>
        <pc:spChg chg="add mod">
          <ac:chgData name="Papaioannou, Ioannis" userId="27d0d6e0-1133-45d1-b366-9071ba1a55b0" providerId="ADAL" clId="{09A5A6E7-5AD0-42C9-91F3-0518137A29BA}" dt="2024-03-10T10:53:58.693" v="352" actId="571"/>
          <ac:spMkLst>
            <pc:docMk/>
            <pc:sldMk cId="2731541974" sldId="258"/>
            <ac:spMk id="62" creationId="{09696DAF-78C2-67F8-70A1-BD255AF942A8}"/>
          </ac:spMkLst>
        </pc:spChg>
        <pc:picChg chg="add del mod">
          <ac:chgData name="Papaioannou, Ioannis" userId="27d0d6e0-1133-45d1-b366-9071ba1a55b0" providerId="ADAL" clId="{09A5A6E7-5AD0-42C9-91F3-0518137A29BA}" dt="2024-03-10T10:29:13.832" v="304" actId="478"/>
          <ac:picMkLst>
            <pc:docMk/>
            <pc:sldMk cId="2731541974" sldId="258"/>
            <ac:picMk id="18" creationId="{9732B990-FEB6-A28B-D8FD-4E6841947501}"/>
          </ac:picMkLst>
        </pc:picChg>
        <pc:picChg chg="del">
          <ac:chgData name="Papaioannou, Ioannis" userId="27d0d6e0-1133-45d1-b366-9071ba1a55b0" providerId="ADAL" clId="{09A5A6E7-5AD0-42C9-91F3-0518137A29BA}" dt="2024-03-10T10:17:23.176" v="194" actId="478"/>
          <ac:picMkLst>
            <pc:docMk/>
            <pc:sldMk cId="2731541974" sldId="258"/>
            <ac:picMk id="22" creationId="{0B9040E2-C572-8C81-F583-1FD4744DC28E}"/>
          </ac:picMkLst>
        </pc:picChg>
        <pc:picChg chg="del">
          <ac:chgData name="Papaioannou, Ioannis" userId="27d0d6e0-1133-45d1-b366-9071ba1a55b0" providerId="ADAL" clId="{09A5A6E7-5AD0-42C9-91F3-0518137A29BA}" dt="2024-03-10T10:17:09.029" v="193" actId="478"/>
          <ac:picMkLst>
            <pc:docMk/>
            <pc:sldMk cId="2731541974" sldId="258"/>
            <ac:picMk id="30" creationId="{C0041292-F2C6-A72D-1555-41EB75D1CD8C}"/>
          </ac:picMkLst>
        </pc:picChg>
        <pc:picChg chg="add del mod">
          <ac:chgData name="Papaioannou, Ioannis" userId="27d0d6e0-1133-45d1-b366-9071ba1a55b0" providerId="ADAL" clId="{09A5A6E7-5AD0-42C9-91F3-0518137A29BA}" dt="2024-03-10T10:52:44.187" v="345" actId="478"/>
          <ac:picMkLst>
            <pc:docMk/>
            <pc:sldMk cId="2731541974" sldId="258"/>
            <ac:picMk id="44" creationId="{8E02A5F6-3D9F-F7A8-0F36-D1BAF9498AA4}"/>
          </ac:picMkLst>
        </pc:picChg>
        <pc:picChg chg="add del mod">
          <ac:chgData name="Papaioannou, Ioannis" userId="27d0d6e0-1133-45d1-b366-9071ba1a55b0" providerId="ADAL" clId="{09A5A6E7-5AD0-42C9-91F3-0518137A29BA}" dt="2024-03-10T10:49:12.536" v="339" actId="478"/>
          <ac:picMkLst>
            <pc:docMk/>
            <pc:sldMk cId="2731541974" sldId="258"/>
            <ac:picMk id="47" creationId="{89BB377D-9958-F2C9-1DBB-B95804F46068}"/>
          </ac:picMkLst>
        </pc:picChg>
        <pc:picChg chg="add del mod">
          <ac:chgData name="Papaioannou, Ioannis" userId="27d0d6e0-1133-45d1-b366-9071ba1a55b0" providerId="ADAL" clId="{09A5A6E7-5AD0-42C9-91F3-0518137A29BA}" dt="2024-03-10T10:47:42.295" v="335" actId="478"/>
          <ac:picMkLst>
            <pc:docMk/>
            <pc:sldMk cId="2731541974" sldId="258"/>
            <ac:picMk id="53" creationId="{44A25EC6-55F3-9C50-E0DC-AA8E2EF386C8}"/>
          </ac:picMkLst>
        </pc:picChg>
        <pc:picChg chg="add del mod">
          <ac:chgData name="Papaioannou, Ioannis" userId="27d0d6e0-1133-45d1-b366-9071ba1a55b0" providerId="ADAL" clId="{09A5A6E7-5AD0-42C9-91F3-0518137A29BA}" dt="2024-03-10T10:52:42.074" v="344" actId="478"/>
          <ac:picMkLst>
            <pc:docMk/>
            <pc:sldMk cId="2731541974" sldId="258"/>
            <ac:picMk id="55" creationId="{2754DAB0-9844-748B-5BC8-5FB863A51DBB}"/>
          </ac:picMkLst>
        </pc:picChg>
        <pc:picChg chg="add mod">
          <ac:chgData name="Papaioannou, Ioannis" userId="27d0d6e0-1133-45d1-b366-9071ba1a55b0" providerId="ADAL" clId="{09A5A6E7-5AD0-42C9-91F3-0518137A29BA}" dt="2024-03-10T10:52:49.985" v="349" actId="1076"/>
          <ac:picMkLst>
            <pc:docMk/>
            <pc:sldMk cId="2731541974" sldId="258"/>
            <ac:picMk id="57" creationId="{0D176E81-92DF-7B52-588A-ADFB35BACE33}"/>
          </ac:picMkLst>
        </pc:picChg>
      </pc:sldChg>
      <pc:sldChg chg="addSp delSp modSp mod">
        <pc:chgData name="Papaioannou, Ioannis" userId="27d0d6e0-1133-45d1-b366-9071ba1a55b0" providerId="ADAL" clId="{09A5A6E7-5AD0-42C9-91F3-0518137A29BA}" dt="2024-03-23T10:13:19.391" v="892" actId="1076"/>
        <pc:sldMkLst>
          <pc:docMk/>
          <pc:sldMk cId="905110383" sldId="259"/>
        </pc:sldMkLst>
        <pc:spChg chg="mod">
          <ac:chgData name="Papaioannou, Ioannis" userId="27d0d6e0-1133-45d1-b366-9071ba1a55b0" providerId="ADAL" clId="{09A5A6E7-5AD0-42C9-91F3-0518137A29BA}" dt="2024-02-22T17:05:04.367" v="42" actId="1076"/>
          <ac:spMkLst>
            <pc:docMk/>
            <pc:sldMk cId="905110383" sldId="259"/>
            <ac:spMk id="3" creationId="{0C2155DD-7AD9-ABA6-D376-3DAFB90C3306}"/>
          </ac:spMkLst>
        </pc:spChg>
        <pc:spChg chg="mod">
          <ac:chgData name="Papaioannou, Ioannis" userId="27d0d6e0-1133-45d1-b366-9071ba1a55b0" providerId="ADAL" clId="{09A5A6E7-5AD0-42C9-91F3-0518137A29BA}" dt="2024-02-22T17:05:04.367" v="42" actId="1076"/>
          <ac:spMkLst>
            <pc:docMk/>
            <pc:sldMk cId="905110383" sldId="259"/>
            <ac:spMk id="4" creationId="{58F8AE33-ECA7-5429-C641-FC4A12F890EC}"/>
          </ac:spMkLst>
        </pc:spChg>
        <pc:spChg chg="add mod">
          <ac:chgData name="Papaioannou, Ioannis" userId="27d0d6e0-1133-45d1-b366-9071ba1a55b0" providerId="ADAL" clId="{09A5A6E7-5AD0-42C9-91F3-0518137A29BA}" dt="2024-03-10T15:50:58.520" v="394" actId="1076"/>
          <ac:spMkLst>
            <pc:docMk/>
            <pc:sldMk cId="905110383" sldId="259"/>
            <ac:spMk id="14" creationId="{D6BF7955-C017-E284-56E6-47B9E8821DC6}"/>
          </ac:spMkLst>
        </pc:spChg>
        <pc:spChg chg="mod">
          <ac:chgData name="Papaioannou, Ioannis" userId="27d0d6e0-1133-45d1-b366-9071ba1a55b0" providerId="ADAL" clId="{09A5A6E7-5AD0-42C9-91F3-0518137A29BA}" dt="2024-03-10T10:41:17.257" v="329" actId="1036"/>
          <ac:spMkLst>
            <pc:docMk/>
            <pc:sldMk cId="905110383" sldId="259"/>
            <ac:spMk id="20" creationId="{149CD344-022E-24D0-7219-C7D1F16DF709}"/>
          </ac:spMkLst>
        </pc:spChg>
        <pc:spChg chg="mod">
          <ac:chgData name="Papaioannou, Ioannis" userId="27d0d6e0-1133-45d1-b366-9071ba1a55b0" providerId="ADAL" clId="{09A5A6E7-5AD0-42C9-91F3-0518137A29BA}" dt="2024-03-23T10:13:19.391" v="892" actId="1076"/>
          <ac:spMkLst>
            <pc:docMk/>
            <pc:sldMk cId="905110383" sldId="259"/>
            <ac:spMk id="22" creationId="{143DBF08-1FA5-299F-D3DC-AA8C7DC0A6AE}"/>
          </ac:spMkLst>
        </pc:spChg>
        <pc:spChg chg="mod">
          <ac:chgData name="Papaioannou, Ioannis" userId="27d0d6e0-1133-45d1-b366-9071ba1a55b0" providerId="ADAL" clId="{09A5A6E7-5AD0-42C9-91F3-0518137A29BA}" dt="2024-03-10T10:41:17.257" v="329" actId="1036"/>
          <ac:spMkLst>
            <pc:docMk/>
            <pc:sldMk cId="905110383" sldId="259"/>
            <ac:spMk id="23" creationId="{CD599E63-5E7F-CA3C-4528-BB80371FF57C}"/>
          </ac:spMkLst>
        </pc:spChg>
        <pc:spChg chg="mod">
          <ac:chgData name="Papaioannou, Ioannis" userId="27d0d6e0-1133-45d1-b366-9071ba1a55b0" providerId="ADAL" clId="{09A5A6E7-5AD0-42C9-91F3-0518137A29BA}" dt="2024-03-10T16:09:34.778" v="562" actId="1076"/>
          <ac:spMkLst>
            <pc:docMk/>
            <pc:sldMk cId="905110383" sldId="259"/>
            <ac:spMk id="24" creationId="{04D4DE9A-B1B0-9E32-58A3-B8D2AE69D604}"/>
          </ac:spMkLst>
        </pc:spChg>
        <pc:spChg chg="add mod">
          <ac:chgData name="Papaioannou, Ioannis" userId="27d0d6e0-1133-45d1-b366-9071ba1a55b0" providerId="ADAL" clId="{09A5A6E7-5AD0-42C9-91F3-0518137A29BA}" dt="2024-03-10T15:51:00.750" v="395" actId="1076"/>
          <ac:spMkLst>
            <pc:docMk/>
            <pc:sldMk cId="905110383" sldId="259"/>
            <ac:spMk id="33" creationId="{B7EE6EC6-DF68-1112-87D4-658EFF56EE3B}"/>
          </ac:spMkLst>
        </pc:spChg>
        <pc:spChg chg="add mod">
          <ac:chgData name="Papaioannou, Ioannis" userId="27d0d6e0-1133-45d1-b366-9071ba1a55b0" providerId="ADAL" clId="{09A5A6E7-5AD0-42C9-91F3-0518137A29BA}" dt="2024-03-10T15:51:58.553" v="401" actId="1076"/>
          <ac:spMkLst>
            <pc:docMk/>
            <pc:sldMk cId="905110383" sldId="259"/>
            <ac:spMk id="36" creationId="{4AC80706-0308-C948-D23C-4369ACA2BD74}"/>
          </ac:spMkLst>
        </pc:spChg>
        <pc:spChg chg="add mod">
          <ac:chgData name="Papaioannou, Ioannis" userId="27d0d6e0-1133-45d1-b366-9071ba1a55b0" providerId="ADAL" clId="{09A5A6E7-5AD0-42C9-91F3-0518137A29BA}" dt="2024-03-10T15:52:34.686" v="433" actId="20577"/>
          <ac:spMkLst>
            <pc:docMk/>
            <pc:sldMk cId="905110383" sldId="259"/>
            <ac:spMk id="48" creationId="{3FF62DA3-4322-C51D-104D-F732C3F04C2E}"/>
          </ac:spMkLst>
        </pc:spChg>
        <pc:spChg chg="add mod">
          <ac:chgData name="Papaioannou, Ioannis" userId="27d0d6e0-1133-45d1-b366-9071ba1a55b0" providerId="ADAL" clId="{09A5A6E7-5AD0-42C9-91F3-0518137A29BA}" dt="2024-03-10T15:53:23.818" v="492" actId="1076"/>
          <ac:spMkLst>
            <pc:docMk/>
            <pc:sldMk cId="905110383" sldId="259"/>
            <ac:spMk id="49" creationId="{A4FC3B81-E9F4-107C-E461-E06CD7A831A5}"/>
          </ac:spMkLst>
        </pc:spChg>
        <pc:spChg chg="add mod">
          <ac:chgData name="Papaioannou, Ioannis" userId="27d0d6e0-1133-45d1-b366-9071ba1a55b0" providerId="ADAL" clId="{09A5A6E7-5AD0-42C9-91F3-0518137A29BA}" dt="2024-03-10T15:53:58.133" v="494" actId="1076"/>
          <ac:spMkLst>
            <pc:docMk/>
            <pc:sldMk cId="905110383" sldId="259"/>
            <ac:spMk id="50" creationId="{109E150E-D9CC-5B47-C8E1-24407908DE76}"/>
          </ac:spMkLst>
        </pc:spChg>
        <pc:spChg chg="add mod">
          <ac:chgData name="Papaioannou, Ioannis" userId="27d0d6e0-1133-45d1-b366-9071ba1a55b0" providerId="ADAL" clId="{09A5A6E7-5AD0-42C9-91F3-0518137A29BA}" dt="2024-03-10T15:55:45.701" v="509" actId="6549"/>
          <ac:spMkLst>
            <pc:docMk/>
            <pc:sldMk cId="905110383" sldId="259"/>
            <ac:spMk id="51" creationId="{257A5690-9955-A97C-2A38-A8294F9C4E92}"/>
          </ac:spMkLst>
        </pc:spChg>
        <pc:spChg chg="add mod">
          <ac:chgData name="Papaioannou, Ioannis" userId="27d0d6e0-1133-45d1-b366-9071ba1a55b0" providerId="ADAL" clId="{09A5A6E7-5AD0-42C9-91F3-0518137A29BA}" dt="2024-03-10T15:57:18.967" v="539" actId="1076"/>
          <ac:spMkLst>
            <pc:docMk/>
            <pc:sldMk cId="905110383" sldId="259"/>
            <ac:spMk id="52" creationId="{4F274987-D584-BB41-B718-9B922972C550}"/>
          </ac:spMkLst>
        </pc:spChg>
        <pc:spChg chg="add mod">
          <ac:chgData name="Papaioannou, Ioannis" userId="27d0d6e0-1133-45d1-b366-9071ba1a55b0" providerId="ADAL" clId="{09A5A6E7-5AD0-42C9-91F3-0518137A29BA}" dt="2024-03-10T15:57:34.543" v="552" actId="20577"/>
          <ac:spMkLst>
            <pc:docMk/>
            <pc:sldMk cId="905110383" sldId="259"/>
            <ac:spMk id="53" creationId="{2154960D-AE91-1055-D4A8-91BEED67523E}"/>
          </ac:spMkLst>
        </pc:spChg>
        <pc:picChg chg="mod">
          <ac:chgData name="Papaioannou, Ioannis" userId="27d0d6e0-1133-45d1-b366-9071ba1a55b0" providerId="ADAL" clId="{09A5A6E7-5AD0-42C9-91F3-0518137A29BA}" dt="2024-03-23T10:13:03.859" v="890" actId="1076"/>
          <ac:picMkLst>
            <pc:docMk/>
            <pc:sldMk cId="905110383" sldId="259"/>
            <ac:picMk id="11" creationId="{61F1ED7E-FA28-CB98-53A1-E8725AD0AC87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19" creationId="{65E134F0-551E-AEE1-C65F-8368D6F92609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21" creationId="{3F32434A-9F5F-FA7F-F912-51CC503D81CA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32" creationId="{349710CD-D759-902A-4E9A-4179AFC8FAB4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34" creationId="{782E503A-BD32-11C4-AAB6-6462DB497AC6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35" creationId="{344395E0-236A-6828-6FCE-53BABE178775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37" creationId="{D9A0E98F-CE5E-4A2E-D8AF-D377C169B938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39" creationId="{2664B09F-2C6A-3CFE-AEDD-A0A37E5028A6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41" creationId="{B52D12E1-2062-B859-2480-4E13A9539470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42" creationId="{F2C74E8A-AC59-78B6-65E5-CFA3CB087BC3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44" creationId="{6ADD6146-20A1-8ACD-761B-9ACB4D05CD13}"/>
          </ac:picMkLst>
        </pc:picChg>
        <pc:picChg chg="del">
          <ac:chgData name="Papaioannou, Ioannis" userId="27d0d6e0-1133-45d1-b366-9071ba1a55b0" providerId="ADAL" clId="{09A5A6E7-5AD0-42C9-91F3-0518137A29BA}" dt="2024-03-10T16:11:13.437" v="575" actId="478"/>
          <ac:picMkLst>
            <pc:docMk/>
            <pc:sldMk cId="905110383" sldId="259"/>
            <ac:picMk id="45" creationId="{BE65B48E-6C11-01FF-D2B7-FD392CDC342A}"/>
          </ac:picMkLst>
        </pc:picChg>
        <pc:picChg chg="add del">
          <ac:chgData name="Papaioannou, Ioannis" userId="27d0d6e0-1133-45d1-b366-9071ba1a55b0" providerId="ADAL" clId="{09A5A6E7-5AD0-42C9-91F3-0518137A29BA}" dt="2024-03-10T16:11:08.500" v="573" actId="478"/>
          <ac:picMkLst>
            <pc:docMk/>
            <pc:sldMk cId="905110383" sldId="259"/>
            <ac:picMk id="55" creationId="{BFA2B5FD-C0F3-FC11-417F-8F0316DFCC49}"/>
          </ac:picMkLst>
        </pc:picChg>
        <pc:picChg chg="add del mod">
          <ac:chgData name="Papaioannou, Ioannis" userId="27d0d6e0-1133-45d1-b366-9071ba1a55b0" providerId="ADAL" clId="{09A5A6E7-5AD0-42C9-91F3-0518137A29BA}" dt="2024-03-10T16:11:07.103" v="572" actId="478"/>
          <ac:picMkLst>
            <pc:docMk/>
            <pc:sldMk cId="905110383" sldId="259"/>
            <ac:picMk id="57" creationId="{7F6F2BA0-AF9D-A1B7-AB66-068B4AD64436}"/>
          </ac:picMkLst>
        </pc:picChg>
        <pc:picChg chg="add del mod">
          <ac:chgData name="Papaioannou, Ioannis" userId="27d0d6e0-1133-45d1-b366-9071ba1a55b0" providerId="ADAL" clId="{09A5A6E7-5AD0-42C9-91F3-0518137A29BA}" dt="2024-03-10T16:11:05.951" v="571" actId="478"/>
          <ac:picMkLst>
            <pc:docMk/>
            <pc:sldMk cId="905110383" sldId="259"/>
            <ac:picMk id="58" creationId="{255D2977-BF13-1AE9-53B1-86047384FA70}"/>
          </ac:picMkLst>
        </pc:picChg>
        <pc:picChg chg="add mod">
          <ac:chgData name="Papaioannou, Ioannis" userId="27d0d6e0-1133-45d1-b366-9071ba1a55b0" providerId="ADAL" clId="{09A5A6E7-5AD0-42C9-91F3-0518137A29BA}" dt="2024-03-10T17:59:28.472" v="888" actId="1076"/>
          <ac:picMkLst>
            <pc:docMk/>
            <pc:sldMk cId="905110383" sldId="259"/>
            <ac:picMk id="60" creationId="{3639585F-55E9-3DD0-385F-228DDB1FF3D0}"/>
          </ac:picMkLst>
        </pc:picChg>
        <pc:cxnChg chg="add mod">
          <ac:chgData name="Papaioannou, Ioannis" userId="27d0d6e0-1133-45d1-b366-9071ba1a55b0" providerId="ADAL" clId="{09A5A6E7-5AD0-42C9-91F3-0518137A29BA}" dt="2024-03-10T15:52:22.843" v="408" actId="13822"/>
          <ac:cxnSpMkLst>
            <pc:docMk/>
            <pc:sldMk cId="905110383" sldId="259"/>
            <ac:cxnSpMk id="40" creationId="{A535B4FA-6514-BAAC-E2A6-3E33C9F7F12A}"/>
          </ac:cxnSpMkLst>
        </pc:cxnChg>
      </pc:sldChg>
      <pc:sldChg chg="addSp delSp modSp mod">
        <pc:chgData name="Papaioannou, Ioannis" userId="27d0d6e0-1133-45d1-b366-9071ba1a55b0" providerId="ADAL" clId="{09A5A6E7-5AD0-42C9-91F3-0518137A29BA}" dt="2024-03-26T03:30:59.578" v="1007" actId="14100"/>
        <pc:sldMkLst>
          <pc:docMk/>
          <pc:sldMk cId="1934854818" sldId="262"/>
        </pc:sldMkLst>
        <pc:spChg chg="add mod">
          <ac:chgData name="Papaioannou, Ioannis" userId="27d0d6e0-1133-45d1-b366-9071ba1a55b0" providerId="ADAL" clId="{09A5A6E7-5AD0-42C9-91F3-0518137A29BA}" dt="2024-03-26T03:30:41.367" v="1004" actId="571"/>
          <ac:spMkLst>
            <pc:docMk/>
            <pc:sldMk cId="1934854818" sldId="262"/>
            <ac:spMk id="3" creationId="{65A905C5-AF4A-D18E-0386-1A345F0E6E75}"/>
          </ac:spMkLst>
        </pc:spChg>
        <pc:spChg chg="mod">
          <ac:chgData name="Papaioannou, Ioannis" userId="27d0d6e0-1133-45d1-b366-9071ba1a55b0" providerId="ADAL" clId="{09A5A6E7-5AD0-42C9-91F3-0518137A29BA}" dt="2024-03-23T10:37:37.824" v="942" actId="1076"/>
          <ac:spMkLst>
            <pc:docMk/>
            <pc:sldMk cId="1934854818" sldId="262"/>
            <ac:spMk id="15" creationId="{7F18ABF3-450E-F50A-8F29-540B2862B5AB}"/>
          </ac:spMkLst>
        </pc:spChg>
        <pc:spChg chg="mod">
          <ac:chgData name="Papaioannou, Ioannis" userId="27d0d6e0-1133-45d1-b366-9071ba1a55b0" providerId="ADAL" clId="{09A5A6E7-5AD0-42C9-91F3-0518137A29BA}" dt="2024-03-26T03:30:41.367" v="1004" actId="571"/>
          <ac:spMkLst>
            <pc:docMk/>
            <pc:sldMk cId="1934854818" sldId="262"/>
            <ac:spMk id="16" creationId="{1AFEF2B2-0575-8118-5275-53A9303FEDDD}"/>
          </ac:spMkLst>
        </pc:spChg>
        <pc:spChg chg="mod">
          <ac:chgData name="Papaioannou, Ioannis" userId="27d0d6e0-1133-45d1-b366-9071ba1a55b0" providerId="ADAL" clId="{09A5A6E7-5AD0-42C9-91F3-0518137A29BA}" dt="2024-03-23T10:37:37.824" v="942" actId="1076"/>
          <ac:spMkLst>
            <pc:docMk/>
            <pc:sldMk cId="1934854818" sldId="262"/>
            <ac:spMk id="17" creationId="{F1D5FEE7-E2AF-D8CB-7011-801EF7147C3C}"/>
          </ac:spMkLst>
        </pc:spChg>
        <pc:spChg chg="mod">
          <ac:chgData name="Papaioannou, Ioannis" userId="27d0d6e0-1133-45d1-b366-9071ba1a55b0" providerId="ADAL" clId="{09A5A6E7-5AD0-42C9-91F3-0518137A29BA}" dt="2024-03-23T10:37:37.824" v="942" actId="1076"/>
          <ac:spMkLst>
            <pc:docMk/>
            <pc:sldMk cId="1934854818" sldId="262"/>
            <ac:spMk id="18" creationId="{8F3A9F86-B694-FA5A-21CA-4315EE2B5B37}"/>
          </ac:spMkLst>
        </pc:spChg>
        <pc:spChg chg="mod">
          <ac:chgData name="Papaioannou, Ioannis" userId="27d0d6e0-1133-45d1-b366-9071ba1a55b0" providerId="ADAL" clId="{09A5A6E7-5AD0-42C9-91F3-0518137A29BA}" dt="2024-03-26T03:30:41.367" v="1004" actId="571"/>
          <ac:spMkLst>
            <pc:docMk/>
            <pc:sldMk cId="1934854818" sldId="262"/>
            <ac:spMk id="19" creationId="{A1151C06-37F6-F6CF-5771-A39177D8A989}"/>
          </ac:spMkLst>
        </pc:spChg>
        <pc:spChg chg="mod">
          <ac:chgData name="Papaioannou, Ioannis" userId="27d0d6e0-1133-45d1-b366-9071ba1a55b0" providerId="ADAL" clId="{09A5A6E7-5AD0-42C9-91F3-0518137A29BA}" dt="2024-03-23T10:37:37.824" v="942" actId="1076"/>
          <ac:spMkLst>
            <pc:docMk/>
            <pc:sldMk cId="1934854818" sldId="262"/>
            <ac:spMk id="20" creationId="{DBFB03F8-1828-A3A9-774C-6CD0B028C830}"/>
          </ac:spMkLst>
        </pc:spChg>
        <pc:spChg chg="mod">
          <ac:chgData name="Papaioannou, Ioannis" userId="27d0d6e0-1133-45d1-b366-9071ba1a55b0" providerId="ADAL" clId="{09A5A6E7-5AD0-42C9-91F3-0518137A29BA}" dt="2024-03-23T10:37:37.824" v="942" actId="1076"/>
          <ac:spMkLst>
            <pc:docMk/>
            <pc:sldMk cId="1934854818" sldId="262"/>
            <ac:spMk id="23" creationId="{9706F11F-BFEF-296E-E127-67FC30948410}"/>
          </ac:spMkLst>
        </pc:spChg>
        <pc:spChg chg="add mod">
          <ac:chgData name="Papaioannou, Ioannis" userId="27d0d6e0-1133-45d1-b366-9071ba1a55b0" providerId="ADAL" clId="{09A5A6E7-5AD0-42C9-91F3-0518137A29BA}" dt="2024-03-23T10:36:18.232" v="926" actId="1076"/>
          <ac:spMkLst>
            <pc:docMk/>
            <pc:sldMk cId="1934854818" sldId="262"/>
            <ac:spMk id="25" creationId="{13244759-3746-FEF8-80C6-214DD6C48460}"/>
          </ac:spMkLst>
        </pc:spChg>
        <pc:spChg chg="add mod">
          <ac:chgData name="Papaioannou, Ioannis" userId="27d0d6e0-1133-45d1-b366-9071ba1a55b0" providerId="ADAL" clId="{09A5A6E7-5AD0-42C9-91F3-0518137A29BA}" dt="2024-03-26T03:30:59.578" v="1007" actId="14100"/>
          <ac:spMkLst>
            <pc:docMk/>
            <pc:sldMk cId="1934854818" sldId="262"/>
            <ac:spMk id="25" creationId="{5558CA01-A6DF-684F-DAFB-7153A06903E0}"/>
          </ac:spMkLst>
        </pc:spChg>
        <pc:spChg chg="add mod">
          <ac:chgData name="Papaioannou, Ioannis" userId="27d0d6e0-1133-45d1-b366-9071ba1a55b0" providerId="ADAL" clId="{09A5A6E7-5AD0-42C9-91F3-0518137A29BA}" dt="2024-03-26T03:30:41.367" v="1004" actId="571"/>
          <ac:spMkLst>
            <pc:docMk/>
            <pc:sldMk cId="1934854818" sldId="262"/>
            <ac:spMk id="28" creationId="{7A2BDE81-A33E-E7E0-8DB4-73201EF2D7CC}"/>
          </ac:spMkLst>
        </pc:spChg>
        <pc:spChg chg="add del">
          <ac:chgData name="Papaioannou, Ioannis" userId="27d0d6e0-1133-45d1-b366-9071ba1a55b0" providerId="ADAL" clId="{09A5A6E7-5AD0-42C9-91F3-0518137A29BA}" dt="2024-03-23T10:36:45.757" v="929" actId="478"/>
          <ac:spMkLst>
            <pc:docMk/>
            <pc:sldMk cId="1934854818" sldId="262"/>
            <ac:spMk id="30" creationId="{4DD068D1-B8AC-42C7-4B05-404CEE149024}"/>
          </ac:spMkLst>
        </pc:spChg>
        <pc:spChg chg="add del mod">
          <ac:chgData name="Papaioannou, Ioannis" userId="27d0d6e0-1133-45d1-b366-9071ba1a55b0" providerId="ADAL" clId="{09A5A6E7-5AD0-42C9-91F3-0518137A29BA}" dt="2024-03-23T10:40:52.437" v="996" actId="478"/>
          <ac:spMkLst>
            <pc:docMk/>
            <pc:sldMk cId="1934854818" sldId="262"/>
            <ac:spMk id="34" creationId="{961AE3E6-ABC6-181F-25E0-F66E78B42266}"/>
          </ac:spMkLst>
        </pc:spChg>
        <pc:spChg chg="add mod">
          <ac:chgData name="Papaioannou, Ioannis" userId="27d0d6e0-1133-45d1-b366-9071ba1a55b0" providerId="ADAL" clId="{09A5A6E7-5AD0-42C9-91F3-0518137A29BA}" dt="2024-03-23T10:41:04.302" v="998" actId="1076"/>
          <ac:spMkLst>
            <pc:docMk/>
            <pc:sldMk cId="1934854818" sldId="262"/>
            <ac:spMk id="35" creationId="{DEFC00D4-AAD8-79B7-FE40-EDA4312615AD}"/>
          </ac:spMkLst>
        </pc:spChg>
        <pc:grpChg chg="add mod">
          <ac:chgData name="Papaioannou, Ioannis" userId="27d0d6e0-1133-45d1-b366-9071ba1a55b0" providerId="ADAL" clId="{09A5A6E7-5AD0-42C9-91F3-0518137A29BA}" dt="2024-03-26T03:30:41.367" v="1004" actId="571"/>
          <ac:grpSpMkLst>
            <pc:docMk/>
            <pc:sldMk cId="1934854818" sldId="262"/>
            <ac:grpSpMk id="31" creationId="{71CB408B-F0D6-7A26-E5FB-7331787ED1DD}"/>
          </ac:grpSpMkLst>
        </pc:grpChg>
        <pc:grpChg chg="add mod">
          <ac:chgData name="Papaioannou, Ioannis" userId="27d0d6e0-1133-45d1-b366-9071ba1a55b0" providerId="ADAL" clId="{09A5A6E7-5AD0-42C9-91F3-0518137A29BA}" dt="2024-03-23T10:37:37.824" v="942" actId="1076"/>
          <ac:grpSpMkLst>
            <pc:docMk/>
            <pc:sldMk cId="1934854818" sldId="262"/>
            <ac:grpSpMk id="32" creationId="{0550A726-8816-D262-06A8-F31B8B4317E2}"/>
          </ac:grpSpMkLst>
        </pc:grpChg>
        <pc:picChg chg="add mod">
          <ac:chgData name="Papaioannou, Ioannis" userId="27d0d6e0-1133-45d1-b366-9071ba1a55b0" providerId="ADAL" clId="{09A5A6E7-5AD0-42C9-91F3-0518137A29BA}" dt="2024-03-23T10:36:18.232" v="926" actId="1076"/>
          <ac:picMkLst>
            <pc:docMk/>
            <pc:sldMk cId="1934854818" sldId="262"/>
            <ac:picMk id="3" creationId="{5A6ED7AE-8317-D1D9-7C41-22495D6D1EDF}"/>
          </ac:picMkLst>
        </pc:picChg>
        <pc:picChg chg="mod">
          <ac:chgData name="Papaioannou, Ioannis" userId="27d0d6e0-1133-45d1-b366-9071ba1a55b0" providerId="ADAL" clId="{09A5A6E7-5AD0-42C9-91F3-0518137A29BA}" dt="2024-03-23T10:37:37.824" v="942" actId="1076"/>
          <ac:picMkLst>
            <pc:docMk/>
            <pc:sldMk cId="1934854818" sldId="262"/>
            <ac:picMk id="12" creationId="{B5F3576A-1F77-3D86-8002-57D10833F531}"/>
          </ac:picMkLst>
        </pc:picChg>
        <pc:picChg chg="mod">
          <ac:chgData name="Papaioannou, Ioannis" userId="27d0d6e0-1133-45d1-b366-9071ba1a55b0" providerId="ADAL" clId="{09A5A6E7-5AD0-42C9-91F3-0518137A29BA}" dt="2024-03-23T10:37:37.824" v="942" actId="1076"/>
          <ac:picMkLst>
            <pc:docMk/>
            <pc:sldMk cId="1934854818" sldId="262"/>
            <ac:picMk id="13" creationId="{E3A3B174-E4C8-F26C-EB4D-804563F9567F}"/>
          </ac:picMkLst>
        </pc:picChg>
        <pc:picChg chg="mod">
          <ac:chgData name="Papaioannou, Ioannis" userId="27d0d6e0-1133-45d1-b366-9071ba1a55b0" providerId="ADAL" clId="{09A5A6E7-5AD0-42C9-91F3-0518137A29BA}" dt="2024-03-26T03:30:41.367" v="1004" actId="571"/>
          <ac:picMkLst>
            <pc:docMk/>
            <pc:sldMk cId="1934854818" sldId="262"/>
            <ac:picMk id="14" creationId="{25E58EBA-8944-5FA6-ABFC-9B19EE1AEBC7}"/>
          </ac:picMkLst>
        </pc:picChg>
        <pc:picChg chg="add mod">
          <ac:chgData name="Papaioannou, Ioannis" userId="27d0d6e0-1133-45d1-b366-9071ba1a55b0" providerId="ADAL" clId="{09A5A6E7-5AD0-42C9-91F3-0518137A29BA}" dt="2024-03-23T10:39:00.155" v="950" actId="1076"/>
          <ac:picMkLst>
            <pc:docMk/>
            <pc:sldMk cId="1934854818" sldId="262"/>
            <ac:picMk id="33" creationId="{C857B45B-18ED-B9B6-0B19-C74FE179E743}"/>
          </ac:picMkLst>
        </pc:picChg>
        <pc:cxnChg chg="del mod">
          <ac:chgData name="Papaioannou, Ioannis" userId="27d0d6e0-1133-45d1-b366-9071ba1a55b0" providerId="ADAL" clId="{09A5A6E7-5AD0-42C9-91F3-0518137A29BA}" dt="2024-03-23T10:36:43.363" v="928" actId="478"/>
          <ac:cxnSpMkLst>
            <pc:docMk/>
            <pc:sldMk cId="1934854818" sldId="262"/>
            <ac:cxnSpMk id="29" creationId="{AC518064-A65C-2D84-9CEB-855261F8F866}"/>
          </ac:cxnSpMkLst>
        </pc:cxnChg>
      </pc:sldChg>
      <pc:sldChg chg="addSp delSp modSp mod">
        <pc:chgData name="Papaioannou, Ioannis" userId="27d0d6e0-1133-45d1-b366-9071ba1a55b0" providerId="ADAL" clId="{09A5A6E7-5AD0-42C9-91F3-0518137A29BA}" dt="2024-03-26T04:39:28.793" v="1148" actId="14100"/>
        <pc:sldMkLst>
          <pc:docMk/>
          <pc:sldMk cId="1358340535" sldId="263"/>
        </pc:sldMkLst>
        <pc:spChg chg="mod">
          <ac:chgData name="Papaioannou, Ioannis" userId="27d0d6e0-1133-45d1-b366-9071ba1a55b0" providerId="ADAL" clId="{09A5A6E7-5AD0-42C9-91F3-0518137A29BA}" dt="2024-03-26T04:34:24.835" v="1110" actId="1076"/>
          <ac:spMkLst>
            <pc:docMk/>
            <pc:sldMk cId="1358340535" sldId="263"/>
            <ac:spMk id="2" creationId="{C958BD29-9B4A-3439-058B-25B4B0D09DC9}"/>
          </ac:spMkLst>
        </pc:spChg>
        <pc:spChg chg="mod">
          <ac:chgData name="Papaioannou, Ioannis" userId="27d0d6e0-1133-45d1-b366-9071ba1a55b0" providerId="ADAL" clId="{09A5A6E7-5AD0-42C9-91F3-0518137A29BA}" dt="2024-03-26T04:25:23.705" v="1008" actId="1076"/>
          <ac:spMkLst>
            <pc:docMk/>
            <pc:sldMk cId="1358340535" sldId="263"/>
            <ac:spMk id="3" creationId="{6C49AA6C-72D5-809D-013C-C0012325D236}"/>
          </ac:spMkLst>
        </pc:spChg>
        <pc:spChg chg="mod">
          <ac:chgData name="Papaioannou, Ioannis" userId="27d0d6e0-1133-45d1-b366-9071ba1a55b0" providerId="ADAL" clId="{09A5A6E7-5AD0-42C9-91F3-0518137A29BA}" dt="2024-03-26T04:25:23.705" v="1008" actId="1076"/>
          <ac:spMkLst>
            <pc:docMk/>
            <pc:sldMk cId="1358340535" sldId="263"/>
            <ac:spMk id="6" creationId="{AAE7BC3C-FA36-89A8-CEB6-C539C407F467}"/>
          </ac:spMkLst>
        </pc:spChg>
        <pc:spChg chg="mod">
          <ac:chgData name="Papaioannou, Ioannis" userId="27d0d6e0-1133-45d1-b366-9071ba1a55b0" providerId="ADAL" clId="{09A5A6E7-5AD0-42C9-91F3-0518137A29BA}" dt="2024-03-26T04:34:01.383" v="1107" actId="732"/>
          <ac:spMkLst>
            <pc:docMk/>
            <pc:sldMk cId="1358340535" sldId="263"/>
            <ac:spMk id="8" creationId="{E9326353-2AD2-B794-5976-B918F5BF3CE8}"/>
          </ac:spMkLst>
        </pc:spChg>
        <pc:spChg chg="mod">
          <ac:chgData name="Papaioannou, Ioannis" userId="27d0d6e0-1133-45d1-b366-9071ba1a55b0" providerId="ADAL" clId="{09A5A6E7-5AD0-42C9-91F3-0518137A29BA}" dt="2024-03-26T04:34:01.383" v="1107" actId="732"/>
          <ac:spMkLst>
            <pc:docMk/>
            <pc:sldMk cId="1358340535" sldId="263"/>
            <ac:spMk id="9" creationId="{AA16CA11-994B-AFC8-C85E-342481E6FC67}"/>
          </ac:spMkLst>
        </pc:spChg>
        <pc:spChg chg="mod">
          <ac:chgData name="Papaioannou, Ioannis" userId="27d0d6e0-1133-45d1-b366-9071ba1a55b0" providerId="ADAL" clId="{09A5A6E7-5AD0-42C9-91F3-0518137A29BA}" dt="2024-03-26T04:31:09.434" v="1069" actId="571"/>
          <ac:spMkLst>
            <pc:docMk/>
            <pc:sldMk cId="1358340535" sldId="263"/>
            <ac:spMk id="14" creationId="{D0A20ACC-4EFD-A662-76D3-0C08FA9A4D98}"/>
          </ac:spMkLst>
        </pc:spChg>
        <pc:spChg chg="mod">
          <ac:chgData name="Papaioannou, Ioannis" userId="27d0d6e0-1133-45d1-b366-9071ba1a55b0" providerId="ADAL" clId="{09A5A6E7-5AD0-42C9-91F3-0518137A29BA}" dt="2024-03-26T04:31:09.434" v="1069" actId="571"/>
          <ac:spMkLst>
            <pc:docMk/>
            <pc:sldMk cId="1358340535" sldId="263"/>
            <ac:spMk id="15" creationId="{ED1BDBDD-44F7-AA89-9F09-EDFA2D0BCD6F}"/>
          </ac:spMkLst>
        </pc:spChg>
        <pc:spChg chg="mod">
          <ac:chgData name="Papaioannou, Ioannis" userId="27d0d6e0-1133-45d1-b366-9071ba1a55b0" providerId="ADAL" clId="{09A5A6E7-5AD0-42C9-91F3-0518137A29BA}" dt="2024-03-26T04:31:09.434" v="1069" actId="571"/>
          <ac:spMkLst>
            <pc:docMk/>
            <pc:sldMk cId="1358340535" sldId="263"/>
            <ac:spMk id="16" creationId="{7BED3FF6-D479-E8FE-373A-2ED3E85CB65C}"/>
          </ac:spMkLst>
        </pc:spChg>
        <pc:spChg chg="mod">
          <ac:chgData name="Papaioannou, Ioannis" userId="27d0d6e0-1133-45d1-b366-9071ba1a55b0" providerId="ADAL" clId="{09A5A6E7-5AD0-42C9-91F3-0518137A29BA}" dt="2024-03-26T04:31:09.434" v="1069" actId="571"/>
          <ac:spMkLst>
            <pc:docMk/>
            <pc:sldMk cId="1358340535" sldId="263"/>
            <ac:spMk id="17" creationId="{3D78C35C-B803-B04B-277D-4F4401FA0895}"/>
          </ac:spMkLst>
        </pc:spChg>
        <pc:spChg chg="mod">
          <ac:chgData name="Papaioannou, Ioannis" userId="27d0d6e0-1133-45d1-b366-9071ba1a55b0" providerId="ADAL" clId="{09A5A6E7-5AD0-42C9-91F3-0518137A29BA}" dt="2024-03-26T04:34:01.383" v="1107" actId="732"/>
          <ac:spMkLst>
            <pc:docMk/>
            <pc:sldMk cId="1358340535" sldId="263"/>
            <ac:spMk id="18" creationId="{735DDD33-D945-06EE-5056-F69D006E1773}"/>
          </ac:spMkLst>
        </pc:spChg>
        <pc:spChg chg="mod">
          <ac:chgData name="Papaioannou, Ioannis" userId="27d0d6e0-1133-45d1-b366-9071ba1a55b0" providerId="ADAL" clId="{09A5A6E7-5AD0-42C9-91F3-0518137A29BA}" dt="2024-03-26T04:34:24.835" v="1110" actId="1076"/>
          <ac:spMkLst>
            <pc:docMk/>
            <pc:sldMk cId="1358340535" sldId="263"/>
            <ac:spMk id="19" creationId="{4A8886BA-C104-C0BA-111A-331DFA51B03E}"/>
          </ac:spMkLst>
        </pc:spChg>
        <pc:spChg chg="mod">
          <ac:chgData name="Papaioannou, Ioannis" userId="27d0d6e0-1133-45d1-b366-9071ba1a55b0" providerId="ADAL" clId="{09A5A6E7-5AD0-42C9-91F3-0518137A29BA}" dt="2024-03-26T04:25:23.705" v="1008" actId="1076"/>
          <ac:spMkLst>
            <pc:docMk/>
            <pc:sldMk cId="1358340535" sldId="263"/>
            <ac:spMk id="21" creationId="{FFBD5BD0-F438-8637-5D25-B3A17BB2B552}"/>
          </ac:spMkLst>
        </pc:spChg>
        <pc:spChg chg="mod">
          <ac:chgData name="Papaioannou, Ioannis" userId="27d0d6e0-1133-45d1-b366-9071ba1a55b0" providerId="ADAL" clId="{09A5A6E7-5AD0-42C9-91F3-0518137A29BA}" dt="2024-03-26T04:25:23.705" v="1008" actId="1076"/>
          <ac:spMkLst>
            <pc:docMk/>
            <pc:sldMk cId="1358340535" sldId="263"/>
            <ac:spMk id="22" creationId="{3144D51A-C19A-CA27-7E50-FD9A93400158}"/>
          </ac:spMkLst>
        </pc:spChg>
        <pc:spChg chg="mod">
          <ac:chgData name="Papaioannou, Ioannis" userId="27d0d6e0-1133-45d1-b366-9071ba1a55b0" providerId="ADAL" clId="{09A5A6E7-5AD0-42C9-91F3-0518137A29BA}" dt="2024-03-26T04:31:09.434" v="1069" actId="571"/>
          <ac:spMkLst>
            <pc:docMk/>
            <pc:sldMk cId="1358340535" sldId="263"/>
            <ac:spMk id="23" creationId="{7053130D-5B6F-1617-88A5-ACBD0005573F}"/>
          </ac:spMkLst>
        </pc:spChg>
        <pc:spChg chg="mod">
          <ac:chgData name="Papaioannou, Ioannis" userId="27d0d6e0-1133-45d1-b366-9071ba1a55b0" providerId="ADAL" clId="{09A5A6E7-5AD0-42C9-91F3-0518137A29BA}" dt="2024-03-26T04:31:09.434" v="1069" actId="571"/>
          <ac:spMkLst>
            <pc:docMk/>
            <pc:sldMk cId="1358340535" sldId="263"/>
            <ac:spMk id="24" creationId="{70DA175B-314C-5321-D1A8-78431090A39E}"/>
          </ac:spMkLst>
        </pc:spChg>
        <pc:spChg chg="mod">
          <ac:chgData name="Papaioannou, Ioannis" userId="27d0d6e0-1133-45d1-b366-9071ba1a55b0" providerId="ADAL" clId="{09A5A6E7-5AD0-42C9-91F3-0518137A29BA}" dt="2024-03-26T04:26:37.609" v="1025" actId="164"/>
          <ac:spMkLst>
            <pc:docMk/>
            <pc:sldMk cId="1358340535" sldId="263"/>
            <ac:spMk id="25" creationId="{D476B235-64DD-7413-3ED3-DFA59D9B2716}"/>
          </ac:spMkLst>
        </pc:spChg>
        <pc:spChg chg="mod">
          <ac:chgData name="Papaioannou, Ioannis" userId="27d0d6e0-1133-45d1-b366-9071ba1a55b0" providerId="ADAL" clId="{09A5A6E7-5AD0-42C9-91F3-0518137A29BA}" dt="2024-03-26T04:34:01.383" v="1107" actId="732"/>
          <ac:spMkLst>
            <pc:docMk/>
            <pc:sldMk cId="1358340535" sldId="263"/>
            <ac:spMk id="26" creationId="{7766872C-0A07-1922-62AE-9D32E8C505F2}"/>
          </ac:spMkLst>
        </pc:spChg>
        <pc:spChg chg="mod">
          <ac:chgData name="Papaioannou, Ioannis" userId="27d0d6e0-1133-45d1-b366-9071ba1a55b0" providerId="ADAL" clId="{09A5A6E7-5AD0-42C9-91F3-0518137A29BA}" dt="2024-03-26T04:34:24.835" v="1110" actId="1076"/>
          <ac:spMkLst>
            <pc:docMk/>
            <pc:sldMk cId="1358340535" sldId="263"/>
            <ac:spMk id="27" creationId="{EFF7B304-0A2D-CFCD-508D-9C3298095EC2}"/>
          </ac:spMkLst>
        </pc:spChg>
        <pc:spChg chg="mod">
          <ac:chgData name="Papaioannou, Ioannis" userId="27d0d6e0-1133-45d1-b366-9071ba1a55b0" providerId="ADAL" clId="{09A5A6E7-5AD0-42C9-91F3-0518137A29BA}" dt="2024-03-26T04:25:28.842" v="1009" actId="1076"/>
          <ac:spMkLst>
            <pc:docMk/>
            <pc:sldMk cId="1358340535" sldId="263"/>
            <ac:spMk id="28" creationId="{48B1942E-3A20-FF6E-39D0-60D2D2FC063F}"/>
          </ac:spMkLst>
        </pc:spChg>
        <pc:spChg chg="add mod">
          <ac:chgData name="Papaioannou, Ioannis" userId="27d0d6e0-1133-45d1-b366-9071ba1a55b0" providerId="ADAL" clId="{09A5A6E7-5AD0-42C9-91F3-0518137A29BA}" dt="2024-03-26T04:34:34.867" v="1113" actId="164"/>
          <ac:spMkLst>
            <pc:docMk/>
            <pc:sldMk cId="1358340535" sldId="263"/>
            <ac:spMk id="35" creationId="{6465EFB9-603A-5F0F-7EE2-D265A9E569CF}"/>
          </ac:spMkLst>
        </pc:spChg>
        <pc:spChg chg="add mod">
          <ac:chgData name="Papaioannou, Ioannis" userId="27d0d6e0-1133-45d1-b366-9071ba1a55b0" providerId="ADAL" clId="{09A5A6E7-5AD0-42C9-91F3-0518137A29BA}" dt="2024-03-26T04:31:09.434" v="1069" actId="571"/>
          <ac:spMkLst>
            <pc:docMk/>
            <pc:sldMk cId="1358340535" sldId="263"/>
            <ac:spMk id="36" creationId="{D6D74EE4-2EC2-8071-9EE1-4634A98E74F9}"/>
          </ac:spMkLst>
        </pc:spChg>
        <pc:spChg chg="add mod">
          <ac:chgData name="Papaioannou, Ioannis" userId="27d0d6e0-1133-45d1-b366-9071ba1a55b0" providerId="ADAL" clId="{09A5A6E7-5AD0-42C9-91F3-0518137A29BA}" dt="2024-03-26T04:31:21.499" v="1096" actId="20577"/>
          <ac:spMkLst>
            <pc:docMk/>
            <pc:sldMk cId="1358340535" sldId="263"/>
            <ac:spMk id="37" creationId="{3E027B03-9A7F-7DD6-F891-ED6E980CC2C8}"/>
          </ac:spMkLst>
        </pc:spChg>
        <pc:spChg chg="add mod">
          <ac:chgData name="Papaioannou, Ioannis" userId="27d0d6e0-1133-45d1-b366-9071ba1a55b0" providerId="ADAL" clId="{09A5A6E7-5AD0-42C9-91F3-0518137A29BA}" dt="2024-03-26T04:32:12.609" v="1097"/>
          <ac:spMkLst>
            <pc:docMk/>
            <pc:sldMk cId="1358340535" sldId="263"/>
            <ac:spMk id="38" creationId="{B304F264-759B-3877-EBE5-B86E3742DC29}"/>
          </ac:spMkLst>
        </pc:spChg>
        <pc:spChg chg="add mod">
          <ac:chgData name="Papaioannou, Ioannis" userId="27d0d6e0-1133-45d1-b366-9071ba1a55b0" providerId="ADAL" clId="{09A5A6E7-5AD0-42C9-91F3-0518137A29BA}" dt="2024-03-26T04:32:46.250" v="1101" actId="1038"/>
          <ac:spMkLst>
            <pc:docMk/>
            <pc:sldMk cId="1358340535" sldId="263"/>
            <ac:spMk id="39" creationId="{85B181E3-ADEB-6274-1B27-299467C55889}"/>
          </ac:spMkLst>
        </pc:spChg>
        <pc:spChg chg="add del mod">
          <ac:chgData name="Papaioannou, Ioannis" userId="27d0d6e0-1133-45d1-b366-9071ba1a55b0" providerId="ADAL" clId="{09A5A6E7-5AD0-42C9-91F3-0518137A29BA}" dt="2024-03-26T04:33:22.708" v="1104" actId="478"/>
          <ac:spMkLst>
            <pc:docMk/>
            <pc:sldMk cId="1358340535" sldId="263"/>
            <ac:spMk id="40" creationId="{F355001D-EB45-1622-9E1A-228828FF7754}"/>
          </ac:spMkLst>
        </pc:spChg>
        <pc:spChg chg="add mod">
          <ac:chgData name="Papaioannou, Ioannis" userId="27d0d6e0-1133-45d1-b366-9071ba1a55b0" providerId="ADAL" clId="{09A5A6E7-5AD0-42C9-91F3-0518137A29BA}" dt="2024-03-26T04:34:05.710" v="1108" actId="1076"/>
          <ac:spMkLst>
            <pc:docMk/>
            <pc:sldMk cId="1358340535" sldId="263"/>
            <ac:spMk id="41" creationId="{A0F78179-CDAB-937B-6C9F-DD1EB16B820C}"/>
          </ac:spMkLst>
        </pc:spChg>
        <pc:spChg chg="add mod">
          <ac:chgData name="Papaioannou, Ioannis" userId="27d0d6e0-1133-45d1-b366-9071ba1a55b0" providerId="ADAL" clId="{09A5A6E7-5AD0-42C9-91F3-0518137A29BA}" dt="2024-03-26T04:35:13.956" v="1116" actId="1076"/>
          <ac:spMkLst>
            <pc:docMk/>
            <pc:sldMk cId="1358340535" sldId="263"/>
            <ac:spMk id="44" creationId="{61794B5C-AA83-C65F-8458-89108179F265}"/>
          </ac:spMkLst>
        </pc:spChg>
        <pc:spChg chg="add mod">
          <ac:chgData name="Papaioannou, Ioannis" userId="27d0d6e0-1133-45d1-b366-9071ba1a55b0" providerId="ADAL" clId="{09A5A6E7-5AD0-42C9-91F3-0518137A29BA}" dt="2024-03-26T04:36:13.760" v="1122" actId="14100"/>
          <ac:spMkLst>
            <pc:docMk/>
            <pc:sldMk cId="1358340535" sldId="263"/>
            <ac:spMk id="45" creationId="{1BC16573-5E65-D197-C92E-9D9375CA3250}"/>
          </ac:spMkLst>
        </pc:spChg>
        <pc:spChg chg="add mod">
          <ac:chgData name="Papaioannou, Ioannis" userId="27d0d6e0-1133-45d1-b366-9071ba1a55b0" providerId="ADAL" clId="{09A5A6E7-5AD0-42C9-91F3-0518137A29BA}" dt="2024-03-26T04:36:28.329" v="1131" actId="1076"/>
          <ac:spMkLst>
            <pc:docMk/>
            <pc:sldMk cId="1358340535" sldId="263"/>
            <ac:spMk id="46" creationId="{4436EAB0-4270-3104-CF00-C226D14AB41D}"/>
          </ac:spMkLst>
        </pc:spChg>
        <pc:grpChg chg="add mod">
          <ac:chgData name="Papaioannou, Ioannis" userId="27d0d6e0-1133-45d1-b366-9071ba1a55b0" providerId="ADAL" clId="{09A5A6E7-5AD0-42C9-91F3-0518137A29BA}" dt="2024-03-26T04:31:09.434" v="1069" actId="571"/>
          <ac:grpSpMkLst>
            <pc:docMk/>
            <pc:sldMk cId="1358340535" sldId="263"/>
            <ac:grpSpMk id="20" creationId="{83CB0300-445C-66C6-5350-6DAB0CA22870}"/>
          </ac:grpSpMkLst>
        </pc:grpChg>
        <pc:grpChg chg="add mod">
          <ac:chgData name="Papaioannou, Ioannis" userId="27d0d6e0-1133-45d1-b366-9071ba1a55b0" providerId="ADAL" clId="{09A5A6E7-5AD0-42C9-91F3-0518137A29BA}" dt="2024-03-26T04:26:39.811" v="1026" actId="1076"/>
          <ac:grpSpMkLst>
            <pc:docMk/>
            <pc:sldMk cId="1358340535" sldId="263"/>
            <ac:grpSpMk id="29" creationId="{F9E7E111-F260-9B30-8BF7-59F78CD65A55}"/>
          </ac:grpSpMkLst>
        </pc:grpChg>
        <pc:grpChg chg="add mod">
          <ac:chgData name="Papaioannou, Ioannis" userId="27d0d6e0-1133-45d1-b366-9071ba1a55b0" providerId="ADAL" clId="{09A5A6E7-5AD0-42C9-91F3-0518137A29BA}" dt="2024-03-26T04:34:01.383" v="1107" actId="732"/>
          <ac:grpSpMkLst>
            <pc:docMk/>
            <pc:sldMk cId="1358340535" sldId="263"/>
            <ac:grpSpMk id="30" creationId="{F351CAA6-F7E7-8B39-9025-4B09B4B7C6E1}"/>
          </ac:grpSpMkLst>
        </pc:grpChg>
        <pc:grpChg chg="add mod">
          <ac:chgData name="Papaioannou, Ioannis" userId="27d0d6e0-1133-45d1-b366-9071ba1a55b0" providerId="ADAL" clId="{09A5A6E7-5AD0-42C9-91F3-0518137A29BA}" dt="2024-03-26T04:34:24.835" v="1110" actId="1076"/>
          <ac:grpSpMkLst>
            <pc:docMk/>
            <pc:sldMk cId="1358340535" sldId="263"/>
            <ac:grpSpMk id="32" creationId="{063BC638-1081-EAB2-0D50-590056C290B5}"/>
          </ac:grpSpMkLst>
        </pc:grpChg>
        <pc:grpChg chg="add mod">
          <ac:chgData name="Papaioannou, Ioannis" userId="27d0d6e0-1133-45d1-b366-9071ba1a55b0" providerId="ADAL" clId="{09A5A6E7-5AD0-42C9-91F3-0518137A29BA}" dt="2024-03-26T04:34:38.692" v="1114" actId="1076"/>
          <ac:grpSpMkLst>
            <pc:docMk/>
            <pc:sldMk cId="1358340535" sldId="263"/>
            <ac:grpSpMk id="42" creationId="{160A5978-9F16-9183-9269-D14F9B09C7BC}"/>
          </ac:grpSpMkLst>
        </pc:grpChg>
        <pc:picChg chg="mod">
          <ac:chgData name="Papaioannou, Ioannis" userId="27d0d6e0-1133-45d1-b366-9071ba1a55b0" providerId="ADAL" clId="{09A5A6E7-5AD0-42C9-91F3-0518137A29BA}" dt="2024-03-26T04:25:44.668" v="1014" actId="732"/>
          <ac:picMkLst>
            <pc:docMk/>
            <pc:sldMk cId="1358340535" sldId="263"/>
            <ac:picMk id="4" creationId="{64F2952F-A7A5-B7D1-497D-BA577B44B9CE}"/>
          </ac:picMkLst>
        </pc:picChg>
        <pc:picChg chg="mod">
          <ac:chgData name="Papaioannou, Ioannis" userId="27d0d6e0-1133-45d1-b366-9071ba1a55b0" providerId="ADAL" clId="{09A5A6E7-5AD0-42C9-91F3-0518137A29BA}" dt="2024-03-26T04:31:09.434" v="1069" actId="571"/>
          <ac:picMkLst>
            <pc:docMk/>
            <pc:sldMk cId="1358340535" sldId="263"/>
            <ac:picMk id="7" creationId="{652C654C-A53C-22FA-B4D2-8F78B38F81C1}"/>
          </ac:picMkLst>
        </pc:picChg>
        <pc:picChg chg="mod">
          <ac:chgData name="Papaioannou, Ioannis" userId="27d0d6e0-1133-45d1-b366-9071ba1a55b0" providerId="ADAL" clId="{09A5A6E7-5AD0-42C9-91F3-0518137A29BA}" dt="2024-03-26T04:26:37.609" v="1025" actId="164"/>
          <ac:picMkLst>
            <pc:docMk/>
            <pc:sldMk cId="1358340535" sldId="263"/>
            <ac:picMk id="11" creationId="{3D92CE0D-2F55-4716-F21A-C9967049CF04}"/>
          </ac:picMkLst>
        </pc:picChg>
        <pc:picChg chg="mod">
          <ac:chgData name="Papaioannou, Ioannis" userId="27d0d6e0-1133-45d1-b366-9071ba1a55b0" providerId="ADAL" clId="{09A5A6E7-5AD0-42C9-91F3-0518137A29BA}" dt="2024-03-26T04:34:24.835" v="1110" actId="1076"/>
          <ac:picMkLst>
            <pc:docMk/>
            <pc:sldMk cId="1358340535" sldId="263"/>
            <ac:picMk id="12" creationId="{7E352516-7147-9605-6EB5-9088257FB0BA}"/>
          </ac:picMkLst>
        </pc:picChg>
        <pc:picChg chg="mod">
          <ac:chgData name="Papaioannou, Ioannis" userId="27d0d6e0-1133-45d1-b366-9071ba1a55b0" providerId="ADAL" clId="{09A5A6E7-5AD0-42C9-91F3-0518137A29BA}" dt="2024-03-26T04:34:01.383" v="1107" actId="732"/>
          <ac:picMkLst>
            <pc:docMk/>
            <pc:sldMk cId="1358340535" sldId="263"/>
            <ac:picMk id="13" creationId="{5E1EDE3B-B4BE-9D8F-E123-46F4192DC327}"/>
          </ac:picMkLst>
        </pc:picChg>
        <pc:picChg chg="del">
          <ac:chgData name="Papaioannou, Ioannis" userId="27d0d6e0-1133-45d1-b366-9071ba1a55b0" providerId="ADAL" clId="{09A5A6E7-5AD0-42C9-91F3-0518137A29BA}" dt="2024-03-26T04:36:46.510" v="1132" actId="478"/>
          <ac:picMkLst>
            <pc:docMk/>
            <pc:sldMk cId="1358340535" sldId="263"/>
            <ac:picMk id="31" creationId="{50BECEA1-C418-70E9-84CC-FE58E670104C}"/>
          </ac:picMkLst>
        </pc:picChg>
        <pc:picChg chg="add mod modCrop">
          <ac:chgData name="Papaioannou, Ioannis" userId="27d0d6e0-1133-45d1-b366-9071ba1a55b0" providerId="ADAL" clId="{09A5A6E7-5AD0-42C9-91F3-0518137A29BA}" dt="2024-03-26T04:34:34.867" v="1113" actId="164"/>
          <ac:picMkLst>
            <pc:docMk/>
            <pc:sldMk cId="1358340535" sldId="263"/>
            <ac:picMk id="34" creationId="{69FEFFBF-C37A-47C4-DA40-53AFA0F4F368}"/>
          </ac:picMkLst>
        </pc:picChg>
        <pc:picChg chg="add mod">
          <ac:chgData name="Papaioannou, Ioannis" userId="27d0d6e0-1133-45d1-b366-9071ba1a55b0" providerId="ADAL" clId="{09A5A6E7-5AD0-42C9-91F3-0518137A29BA}" dt="2024-03-26T04:37:29.661" v="1138" actId="732"/>
          <ac:picMkLst>
            <pc:docMk/>
            <pc:sldMk cId="1358340535" sldId="263"/>
            <ac:picMk id="43" creationId="{6DDFD04A-835A-6DB4-7CFD-E65C91939AD3}"/>
          </ac:picMkLst>
        </pc:picChg>
        <pc:picChg chg="add mod">
          <ac:chgData name="Papaioannou, Ioannis" userId="27d0d6e0-1133-45d1-b366-9071ba1a55b0" providerId="ADAL" clId="{09A5A6E7-5AD0-42C9-91F3-0518137A29BA}" dt="2024-03-26T04:39:28.793" v="1148" actId="14100"/>
          <ac:picMkLst>
            <pc:docMk/>
            <pc:sldMk cId="1358340535" sldId="263"/>
            <ac:picMk id="48" creationId="{6E06BE5E-F3E6-E3A2-2E8A-9BCDB90F44A0}"/>
          </ac:picMkLst>
        </pc:picChg>
        <pc:inkChg chg="mod">
          <ac:chgData name="Papaioannou, Ioannis" userId="27d0d6e0-1133-45d1-b366-9071ba1a55b0" providerId="ADAL" clId="{09A5A6E7-5AD0-42C9-91F3-0518137A29BA}" dt="2024-03-26T04:26:37.609" v="1025" actId="164"/>
          <ac:inkMkLst>
            <pc:docMk/>
            <pc:sldMk cId="1358340535" sldId="263"/>
            <ac:inkMk id="5" creationId="{0FDC1146-7821-183A-1BDA-70A3F61A5BE7}"/>
          </ac:inkMkLst>
        </pc:inkChg>
      </pc:sldChg>
      <pc:sldChg chg="addSp delSp modSp mod">
        <pc:chgData name="Papaioannou, Ioannis" userId="27d0d6e0-1133-45d1-b366-9071ba1a55b0" providerId="ADAL" clId="{09A5A6E7-5AD0-42C9-91F3-0518137A29BA}" dt="2024-03-10T17:24:29.740" v="583" actId="571"/>
        <pc:sldMkLst>
          <pc:docMk/>
          <pc:sldMk cId="1608280500" sldId="266"/>
        </pc:sldMkLst>
        <pc:spChg chg="add del">
          <ac:chgData name="Papaioannou, Ioannis" userId="27d0d6e0-1133-45d1-b366-9071ba1a55b0" providerId="ADAL" clId="{09A5A6E7-5AD0-42C9-91F3-0518137A29BA}" dt="2024-03-10T15:38:52.230" v="386" actId="478"/>
          <ac:spMkLst>
            <pc:docMk/>
            <pc:sldMk cId="1608280500" sldId="266"/>
            <ac:spMk id="4" creationId="{13CD6C51-E038-4690-6BBB-0C169D5B1BB9}"/>
          </ac:spMkLst>
        </pc:spChg>
        <pc:spChg chg="add mod">
          <ac:chgData name="Papaioannou, Ioannis" userId="27d0d6e0-1133-45d1-b366-9071ba1a55b0" providerId="ADAL" clId="{09A5A6E7-5AD0-42C9-91F3-0518137A29BA}" dt="2024-03-10T17:24:29.740" v="583" actId="571"/>
          <ac:spMkLst>
            <pc:docMk/>
            <pc:sldMk cId="1608280500" sldId="266"/>
            <ac:spMk id="17" creationId="{BF293408-33CA-A0A8-1CB1-3D020796E2B1}"/>
          </ac:spMkLst>
        </pc:spChg>
        <pc:spChg chg="mod">
          <ac:chgData name="Papaioannou, Ioannis" userId="27d0d6e0-1133-45d1-b366-9071ba1a55b0" providerId="ADAL" clId="{09A5A6E7-5AD0-42C9-91F3-0518137A29BA}" dt="2024-03-10T17:13:55.235" v="582" actId="1036"/>
          <ac:spMkLst>
            <pc:docMk/>
            <pc:sldMk cId="1608280500" sldId="266"/>
            <ac:spMk id="43" creationId="{B5B34BBA-A603-4288-BBBD-1331CC5FC8CD}"/>
          </ac:spMkLst>
        </pc:spChg>
        <pc:spChg chg="mod">
          <ac:chgData name="Papaioannou, Ioannis" userId="27d0d6e0-1133-45d1-b366-9071ba1a55b0" providerId="ADAL" clId="{09A5A6E7-5AD0-42C9-91F3-0518137A29BA}" dt="2024-03-10T15:49:19.734" v="387" actId="1076"/>
          <ac:spMkLst>
            <pc:docMk/>
            <pc:sldMk cId="1608280500" sldId="266"/>
            <ac:spMk id="47" creationId="{F72E833C-86C3-489C-BDC9-7A152FAE814C}"/>
          </ac:spMkLst>
        </pc:spChg>
        <pc:picChg chg="del">
          <ac:chgData name="Papaioannou, Ioannis" userId="27d0d6e0-1133-45d1-b366-9071ba1a55b0" providerId="ADAL" clId="{09A5A6E7-5AD0-42C9-91F3-0518137A29BA}" dt="2024-03-10T15:49:23.473" v="388" actId="478"/>
          <ac:picMkLst>
            <pc:docMk/>
            <pc:sldMk cId="1608280500" sldId="266"/>
            <ac:picMk id="5" creationId="{0D564AD1-B804-0E7A-A4C2-7961CDF80E68}"/>
          </ac:picMkLst>
        </pc:picChg>
        <pc:picChg chg="add mod">
          <ac:chgData name="Papaioannou, Ioannis" userId="27d0d6e0-1133-45d1-b366-9071ba1a55b0" providerId="ADAL" clId="{09A5A6E7-5AD0-42C9-91F3-0518137A29BA}" dt="2024-03-10T15:49:32.156" v="391" actId="14100"/>
          <ac:picMkLst>
            <pc:docMk/>
            <pc:sldMk cId="1608280500" sldId="266"/>
            <ac:picMk id="13" creationId="{693BDD8A-F8FD-BA0B-4947-17473D54E10D}"/>
          </ac:picMkLst>
        </pc:picChg>
        <pc:picChg chg="mod">
          <ac:chgData name="Papaioannou, Ioannis" userId="27d0d6e0-1133-45d1-b366-9071ba1a55b0" providerId="ADAL" clId="{09A5A6E7-5AD0-42C9-91F3-0518137A29BA}" dt="2024-02-22T16:59:18.147" v="41" actId="688"/>
          <ac:picMkLst>
            <pc:docMk/>
            <pc:sldMk cId="1608280500" sldId="266"/>
            <ac:picMk id="42" creationId="{9E490237-8AF9-4A76-9CAA-AB9EB66D86D8}"/>
          </ac:picMkLst>
        </pc:picChg>
      </pc:sldChg>
      <pc:sldChg chg="addSp delSp modSp mod">
        <pc:chgData name="Papaioannou, Ioannis" userId="27d0d6e0-1133-45d1-b366-9071ba1a55b0" providerId="ADAL" clId="{09A5A6E7-5AD0-42C9-91F3-0518137A29BA}" dt="2024-03-26T03:26:35.950" v="1002" actId="1076"/>
        <pc:sldMkLst>
          <pc:docMk/>
          <pc:sldMk cId="4106415198" sldId="267"/>
        </pc:sldMkLst>
        <pc:spChg chg="mod">
          <ac:chgData name="Papaioannou, Ioannis" userId="27d0d6e0-1133-45d1-b366-9071ba1a55b0" providerId="ADAL" clId="{09A5A6E7-5AD0-42C9-91F3-0518137A29BA}" dt="2024-03-23T10:29:20.031" v="906" actId="1076"/>
          <ac:spMkLst>
            <pc:docMk/>
            <pc:sldMk cId="4106415198" sldId="267"/>
            <ac:spMk id="4" creationId="{885793FE-48AB-CB3C-B706-1B1E6CAC35D9}"/>
          </ac:spMkLst>
        </pc:spChg>
        <pc:spChg chg="add mod">
          <ac:chgData name="Papaioannou, Ioannis" userId="27d0d6e0-1133-45d1-b366-9071ba1a55b0" providerId="ADAL" clId="{09A5A6E7-5AD0-42C9-91F3-0518137A29BA}" dt="2024-03-23T10:29:16.257" v="905" actId="115"/>
          <ac:spMkLst>
            <pc:docMk/>
            <pc:sldMk cId="4106415198" sldId="267"/>
            <ac:spMk id="8" creationId="{13C5F23F-9C54-9BF0-5F69-86652E08ACEB}"/>
          </ac:spMkLst>
        </pc:spChg>
        <pc:spChg chg="mod">
          <ac:chgData name="Papaioannou, Ioannis" userId="27d0d6e0-1133-45d1-b366-9071ba1a55b0" providerId="ADAL" clId="{09A5A6E7-5AD0-42C9-91F3-0518137A29BA}" dt="2024-03-26T03:26:35.950" v="1002" actId="1076"/>
          <ac:spMkLst>
            <pc:docMk/>
            <pc:sldMk cId="4106415198" sldId="267"/>
            <ac:spMk id="9" creationId="{F264FB75-7D58-1165-097B-06613D3F31B6}"/>
          </ac:spMkLst>
        </pc:spChg>
        <pc:spChg chg="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10" creationId="{5E72F9D9-F1FE-BF08-0F1C-765A7588EAF9}"/>
          </ac:spMkLst>
        </pc:spChg>
        <pc:spChg chg="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11" creationId="{4431568B-B19C-A308-88DE-DFEC6F21F1FB}"/>
          </ac:spMkLst>
        </pc:spChg>
        <pc:spChg chg="add 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12" creationId="{6E5C56FF-630D-24D0-D7C5-6C1975DCD67A}"/>
          </ac:spMkLst>
        </pc:spChg>
        <pc:spChg chg="add 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13" creationId="{C1575AF9-3607-C46F-A134-A77CF6E423C1}"/>
          </ac:spMkLst>
        </pc:spChg>
        <pc:spChg chg="mod">
          <ac:chgData name="Papaioannou, Ioannis" userId="27d0d6e0-1133-45d1-b366-9071ba1a55b0" providerId="ADAL" clId="{09A5A6E7-5AD0-42C9-91F3-0518137A29BA}" dt="2024-03-26T03:26:35.950" v="1002" actId="1076"/>
          <ac:spMkLst>
            <pc:docMk/>
            <pc:sldMk cId="4106415198" sldId="267"/>
            <ac:spMk id="14" creationId="{5066F0DF-11D8-D723-9AF6-B179C86CEDC0}"/>
          </ac:spMkLst>
        </pc:spChg>
        <pc:spChg chg="mod">
          <ac:chgData name="Papaioannou, Ioannis" userId="27d0d6e0-1133-45d1-b366-9071ba1a55b0" providerId="ADAL" clId="{09A5A6E7-5AD0-42C9-91F3-0518137A29BA}" dt="2024-03-26T03:26:35.950" v="1002" actId="1076"/>
          <ac:spMkLst>
            <pc:docMk/>
            <pc:sldMk cId="4106415198" sldId="267"/>
            <ac:spMk id="15" creationId="{56EA631A-1912-382C-A628-D04380C8C308}"/>
          </ac:spMkLst>
        </pc:spChg>
        <pc:spChg chg="mod">
          <ac:chgData name="Papaioannou, Ioannis" userId="27d0d6e0-1133-45d1-b366-9071ba1a55b0" providerId="ADAL" clId="{09A5A6E7-5AD0-42C9-91F3-0518137A29BA}" dt="2024-03-26T03:26:35.950" v="1002" actId="1076"/>
          <ac:spMkLst>
            <pc:docMk/>
            <pc:sldMk cId="4106415198" sldId="267"/>
            <ac:spMk id="16" creationId="{0DE1D657-AAD9-E8E8-ADFE-A373B3D91CD7}"/>
          </ac:spMkLst>
        </pc:spChg>
        <pc:spChg chg="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17" creationId="{F8FBF526-7B58-945E-F910-2A599ADCA24E}"/>
          </ac:spMkLst>
        </pc:spChg>
        <pc:spChg chg="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18" creationId="{51C5407B-C2B4-338E-6FDE-AB32F560E00C}"/>
          </ac:spMkLst>
        </pc:spChg>
        <pc:spChg chg="add 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19" creationId="{B4D2D12A-BDFC-C442-1EF8-951235C9B71D}"/>
          </ac:spMkLst>
        </pc:spChg>
        <pc:spChg chg="add 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20" creationId="{45E8D235-A1D1-9BBB-7DF9-24A784FD8E49}"/>
          </ac:spMkLst>
        </pc:spChg>
        <pc:spChg chg="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21" creationId="{8D0DE743-20D0-267C-0297-05585C100F55}"/>
          </ac:spMkLst>
        </pc:spChg>
        <pc:spChg chg="add 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22" creationId="{B6E00BEC-8A42-8100-3ED1-E88EAD8BA0E7}"/>
          </ac:spMkLst>
        </pc:spChg>
        <pc:spChg chg="add 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23" creationId="{580F1045-D588-B73B-D3B8-A40013C9560E}"/>
          </ac:spMkLst>
        </pc:spChg>
        <pc:spChg chg="add mod">
          <ac:chgData name="Papaioannou, Ioannis" userId="27d0d6e0-1133-45d1-b366-9071ba1a55b0" providerId="ADAL" clId="{09A5A6E7-5AD0-42C9-91F3-0518137A29BA}" dt="2024-03-10T17:38:49.002" v="858" actId="1035"/>
          <ac:spMkLst>
            <pc:docMk/>
            <pc:sldMk cId="4106415198" sldId="267"/>
            <ac:spMk id="24" creationId="{5045FC47-5419-DF81-2F4E-520C371A7E59}"/>
          </ac:spMkLst>
        </pc:spChg>
        <pc:spChg chg="add 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25" creationId="{CC5C0157-9E13-AA68-282E-8F17F881AA40}"/>
          </ac:spMkLst>
        </pc:spChg>
        <pc:spChg chg="add 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26" creationId="{CE22AEEE-5E07-3BB1-C871-9AC5AF7BAE5F}"/>
          </ac:spMkLst>
        </pc:spChg>
        <pc:spChg chg="add mod">
          <ac:chgData name="Papaioannou, Ioannis" userId="27d0d6e0-1133-45d1-b366-9071ba1a55b0" providerId="ADAL" clId="{09A5A6E7-5AD0-42C9-91F3-0518137A29BA}" dt="2024-03-23T10:28:45.733" v="899" actId="1076"/>
          <ac:spMkLst>
            <pc:docMk/>
            <pc:sldMk cId="4106415198" sldId="267"/>
            <ac:spMk id="27" creationId="{2A3153A1-43A5-136C-6599-6EFACC8A8330}"/>
          </ac:spMkLst>
        </pc:spChg>
        <pc:spChg chg="add del mod">
          <ac:chgData name="Papaioannou, Ioannis" userId="27d0d6e0-1133-45d1-b366-9071ba1a55b0" providerId="ADAL" clId="{09A5A6E7-5AD0-42C9-91F3-0518137A29BA}" dt="2024-03-10T17:38:40.640" v="854" actId="478"/>
          <ac:spMkLst>
            <pc:docMk/>
            <pc:sldMk cId="4106415198" sldId="267"/>
            <ac:spMk id="28" creationId="{B6CFD7F7-D30F-987F-9C50-D69118C3386A}"/>
          </ac:spMkLst>
        </pc:spChg>
        <pc:spChg chg="add mod">
          <ac:chgData name="Papaioannou, Ioannis" userId="27d0d6e0-1133-45d1-b366-9071ba1a55b0" providerId="ADAL" clId="{09A5A6E7-5AD0-42C9-91F3-0518137A29BA}" dt="2024-03-10T17:38:49.002" v="858" actId="1035"/>
          <ac:spMkLst>
            <pc:docMk/>
            <pc:sldMk cId="4106415198" sldId="267"/>
            <ac:spMk id="29" creationId="{882CAC0D-7B37-992C-F621-64EA966B564F}"/>
          </ac:spMkLst>
        </pc:spChg>
        <pc:spChg chg="add mod">
          <ac:chgData name="Papaioannou, Ioannis" userId="27d0d6e0-1133-45d1-b366-9071ba1a55b0" providerId="ADAL" clId="{09A5A6E7-5AD0-42C9-91F3-0518137A29BA}" dt="2024-03-23T10:27:59.383" v="893" actId="164"/>
          <ac:spMkLst>
            <pc:docMk/>
            <pc:sldMk cId="4106415198" sldId="267"/>
            <ac:spMk id="30" creationId="{A632B3D9-FCFB-ED11-7E9C-9B44543296BE}"/>
          </ac:spMkLst>
        </pc:spChg>
        <pc:spChg chg="add mod">
          <ac:chgData name="Papaioannou, Ioannis" userId="27d0d6e0-1133-45d1-b366-9071ba1a55b0" providerId="ADAL" clId="{09A5A6E7-5AD0-42C9-91F3-0518137A29BA}" dt="2024-03-23T10:27:59.383" v="893" actId="164"/>
          <ac:spMkLst>
            <pc:docMk/>
            <pc:sldMk cId="4106415198" sldId="267"/>
            <ac:spMk id="31" creationId="{9FB8648E-ADDD-2AF8-6C92-3060317995D2}"/>
          </ac:spMkLst>
        </pc:spChg>
        <pc:spChg chg="add mod">
          <ac:chgData name="Papaioannou, Ioannis" userId="27d0d6e0-1133-45d1-b366-9071ba1a55b0" providerId="ADAL" clId="{09A5A6E7-5AD0-42C9-91F3-0518137A29BA}" dt="2024-03-23T10:27:59.383" v="893" actId="164"/>
          <ac:spMkLst>
            <pc:docMk/>
            <pc:sldMk cId="4106415198" sldId="267"/>
            <ac:spMk id="32" creationId="{A0E9C516-27EE-7F21-5CD6-60FEB1C1D1FD}"/>
          </ac:spMkLst>
        </pc:spChg>
        <pc:spChg chg="add mod">
          <ac:chgData name="Papaioannou, Ioannis" userId="27d0d6e0-1133-45d1-b366-9071ba1a55b0" providerId="ADAL" clId="{09A5A6E7-5AD0-42C9-91F3-0518137A29BA}" dt="2024-03-23T10:27:59.383" v="893" actId="164"/>
          <ac:spMkLst>
            <pc:docMk/>
            <pc:sldMk cId="4106415198" sldId="267"/>
            <ac:spMk id="33" creationId="{73AF92BF-CA9B-0F81-91FE-D04A8DD159D5}"/>
          </ac:spMkLst>
        </pc:spChg>
        <pc:spChg chg="add mod">
          <ac:chgData name="Papaioannou, Ioannis" userId="27d0d6e0-1133-45d1-b366-9071ba1a55b0" providerId="ADAL" clId="{09A5A6E7-5AD0-42C9-91F3-0518137A29BA}" dt="2024-03-23T10:27:59.383" v="893" actId="164"/>
          <ac:spMkLst>
            <pc:docMk/>
            <pc:sldMk cId="4106415198" sldId="267"/>
            <ac:spMk id="34" creationId="{8D9BD21D-F354-8FC1-8D0F-912A198451F7}"/>
          </ac:spMkLst>
        </pc:spChg>
        <pc:spChg chg="add mod">
          <ac:chgData name="Papaioannou, Ioannis" userId="27d0d6e0-1133-45d1-b366-9071ba1a55b0" providerId="ADAL" clId="{09A5A6E7-5AD0-42C9-91F3-0518137A29BA}" dt="2024-03-23T10:27:59.383" v="893" actId="164"/>
          <ac:spMkLst>
            <pc:docMk/>
            <pc:sldMk cId="4106415198" sldId="267"/>
            <ac:spMk id="35" creationId="{786002C5-C259-B71F-0436-A742318BAF66}"/>
          </ac:spMkLst>
        </pc:spChg>
        <pc:spChg chg="add mod">
          <ac:chgData name="Papaioannou, Ioannis" userId="27d0d6e0-1133-45d1-b366-9071ba1a55b0" providerId="ADAL" clId="{09A5A6E7-5AD0-42C9-91F3-0518137A29BA}" dt="2024-03-23T10:27:59.383" v="893" actId="164"/>
          <ac:spMkLst>
            <pc:docMk/>
            <pc:sldMk cId="4106415198" sldId="267"/>
            <ac:spMk id="36" creationId="{E45E3D1C-00FD-FA0B-091E-1945955E13EC}"/>
          </ac:spMkLst>
        </pc:spChg>
        <pc:spChg chg="add mod">
          <ac:chgData name="Papaioannou, Ioannis" userId="27d0d6e0-1133-45d1-b366-9071ba1a55b0" providerId="ADAL" clId="{09A5A6E7-5AD0-42C9-91F3-0518137A29BA}" dt="2024-03-23T10:27:59.383" v="893" actId="164"/>
          <ac:spMkLst>
            <pc:docMk/>
            <pc:sldMk cId="4106415198" sldId="267"/>
            <ac:spMk id="37" creationId="{EE664FDC-7F3B-40B5-40E1-BAD5B2B32891}"/>
          </ac:spMkLst>
        </pc:spChg>
        <pc:grpChg chg="add mod">
          <ac:chgData name="Papaioannou, Ioannis" userId="27d0d6e0-1133-45d1-b366-9071ba1a55b0" providerId="ADAL" clId="{09A5A6E7-5AD0-42C9-91F3-0518137A29BA}" dt="2024-03-23T10:28:56.979" v="902" actId="1076"/>
          <ac:grpSpMkLst>
            <pc:docMk/>
            <pc:sldMk cId="4106415198" sldId="267"/>
            <ac:grpSpMk id="2" creationId="{D8C2D7AE-089F-8EA5-4C46-DFABFCDCA9A3}"/>
          </ac:grpSpMkLst>
        </pc:grpChg>
        <pc:picChg chg="mod modCrop">
          <ac:chgData name="Papaioannou, Ioannis" userId="27d0d6e0-1133-45d1-b366-9071ba1a55b0" providerId="ADAL" clId="{09A5A6E7-5AD0-42C9-91F3-0518137A29BA}" dt="2024-03-26T03:26:35.950" v="1002" actId="1076"/>
          <ac:picMkLst>
            <pc:docMk/>
            <pc:sldMk cId="4106415198" sldId="267"/>
            <ac:picMk id="3" creationId="{F4F8A386-C9FB-167A-A4A8-1DCDB752834B}"/>
          </ac:picMkLst>
        </pc:picChg>
        <pc:picChg chg="add mod">
          <ac:chgData name="Papaioannou, Ioannis" userId="27d0d6e0-1133-45d1-b366-9071ba1a55b0" providerId="ADAL" clId="{09A5A6E7-5AD0-42C9-91F3-0518137A29BA}" dt="2024-03-23T10:27:59.383" v="893" actId="164"/>
          <ac:picMkLst>
            <pc:docMk/>
            <pc:sldMk cId="4106415198" sldId="267"/>
            <ac:picMk id="5" creationId="{70F566EC-C352-412A-D1D3-4C5AC9CEBC1E}"/>
          </ac:picMkLst>
        </pc:picChg>
        <pc:picChg chg="mod">
          <ac:chgData name="Papaioannou, Ioannis" userId="27d0d6e0-1133-45d1-b366-9071ba1a55b0" providerId="ADAL" clId="{09A5A6E7-5AD0-42C9-91F3-0518137A29BA}" dt="2024-03-23T10:28:45.733" v="899" actId="1076"/>
          <ac:picMkLst>
            <pc:docMk/>
            <pc:sldMk cId="4106415198" sldId="267"/>
            <ac:picMk id="6" creationId="{A6A80319-A7D0-7F6C-3331-9BA721EAF4BA}"/>
          </ac:picMkLst>
        </pc:picChg>
      </pc:sldChg>
      <pc:sldChg chg="addSp delSp modSp mod">
        <pc:chgData name="Papaioannou, Ioannis" userId="27d0d6e0-1133-45d1-b366-9071ba1a55b0" providerId="ADAL" clId="{09A5A6E7-5AD0-42C9-91F3-0518137A29BA}" dt="2024-03-26T04:48:00.971" v="1185" actId="478"/>
        <pc:sldMkLst>
          <pc:docMk/>
          <pc:sldMk cId="3205824443" sldId="269"/>
        </pc:sldMkLst>
        <pc:spChg chg="mod">
          <ac:chgData name="Papaioannou, Ioannis" userId="27d0d6e0-1133-45d1-b366-9071ba1a55b0" providerId="ADAL" clId="{09A5A6E7-5AD0-42C9-91F3-0518137A29BA}" dt="2024-03-26T04:47:11.396" v="1174" actId="1037"/>
          <ac:spMkLst>
            <pc:docMk/>
            <pc:sldMk cId="3205824443" sldId="269"/>
            <ac:spMk id="20" creationId="{359127C1-5C87-ECB5-4B01-CABAEFC05844}"/>
          </ac:spMkLst>
        </pc:spChg>
        <pc:picChg chg="add del mod modCrop">
          <ac:chgData name="Papaioannou, Ioannis" userId="27d0d6e0-1133-45d1-b366-9071ba1a55b0" providerId="ADAL" clId="{09A5A6E7-5AD0-42C9-91F3-0518137A29BA}" dt="2024-03-26T04:48:00.971" v="1185" actId="478"/>
          <ac:picMkLst>
            <pc:docMk/>
            <pc:sldMk cId="3205824443" sldId="269"/>
            <ac:picMk id="2" creationId="{E6479F51-5FF5-44F2-EC52-0162D3427873}"/>
          </ac:picMkLst>
        </pc:picChg>
        <pc:picChg chg="add del">
          <ac:chgData name="Papaioannou, Ioannis" userId="27d0d6e0-1133-45d1-b366-9071ba1a55b0" providerId="ADAL" clId="{09A5A6E7-5AD0-42C9-91F3-0518137A29BA}" dt="2024-03-26T04:47:13.247" v="1176" actId="22"/>
          <ac:picMkLst>
            <pc:docMk/>
            <pc:sldMk cId="3205824443" sldId="269"/>
            <ac:picMk id="5" creationId="{51601669-748D-4303-B73F-89D204B89C19}"/>
          </ac:picMkLst>
        </pc:picChg>
      </pc:sldChg>
      <pc:sldChg chg="addSp delSp modSp mod">
        <pc:chgData name="Papaioannou, Ioannis" userId="27d0d6e0-1133-45d1-b366-9071ba1a55b0" providerId="ADAL" clId="{09A5A6E7-5AD0-42C9-91F3-0518137A29BA}" dt="2024-03-26T04:59:13.063" v="1244" actId="1076"/>
        <pc:sldMkLst>
          <pc:docMk/>
          <pc:sldMk cId="3619489513" sldId="270"/>
        </pc:sldMkLst>
        <pc:spChg chg="add mod">
          <ac:chgData name="Papaioannou, Ioannis" userId="27d0d6e0-1133-45d1-b366-9071ba1a55b0" providerId="ADAL" clId="{09A5A6E7-5AD0-42C9-91F3-0518137A29BA}" dt="2024-03-26T04:56:16.126" v="1192" actId="1076"/>
          <ac:spMkLst>
            <pc:docMk/>
            <pc:sldMk cId="3619489513" sldId="270"/>
            <ac:spMk id="2" creationId="{5FDB9CC5-513C-B313-C028-1A14D1DDAB22}"/>
          </ac:spMkLst>
        </pc:spChg>
        <pc:spChg chg="add mod">
          <ac:chgData name="Papaioannou, Ioannis" userId="27d0d6e0-1133-45d1-b366-9071ba1a55b0" providerId="ADAL" clId="{09A5A6E7-5AD0-42C9-91F3-0518137A29BA}" dt="2024-03-26T04:56:22.492" v="1194" actId="20577"/>
          <ac:spMkLst>
            <pc:docMk/>
            <pc:sldMk cId="3619489513" sldId="270"/>
            <ac:spMk id="3" creationId="{CA84B725-5BD1-D101-460A-FBDCAE8728F8}"/>
          </ac:spMkLst>
        </pc:spChg>
        <pc:spChg chg="add mod">
          <ac:chgData name="Papaioannou, Ioannis" userId="27d0d6e0-1133-45d1-b366-9071ba1a55b0" providerId="ADAL" clId="{09A5A6E7-5AD0-42C9-91F3-0518137A29BA}" dt="2024-03-26T04:56:28.983" v="1196" actId="20577"/>
          <ac:spMkLst>
            <pc:docMk/>
            <pc:sldMk cId="3619489513" sldId="270"/>
            <ac:spMk id="4" creationId="{DCAD1C7D-A30B-0233-902B-2F947BDEED07}"/>
          </ac:spMkLst>
        </pc:spChg>
        <pc:spChg chg="add mod">
          <ac:chgData name="Papaioannou, Ioannis" userId="27d0d6e0-1133-45d1-b366-9071ba1a55b0" providerId="ADAL" clId="{09A5A6E7-5AD0-42C9-91F3-0518137A29BA}" dt="2024-03-26T04:56:33.037" v="1198" actId="20577"/>
          <ac:spMkLst>
            <pc:docMk/>
            <pc:sldMk cId="3619489513" sldId="270"/>
            <ac:spMk id="6" creationId="{070AD61B-B356-29A6-CE2E-E9C9FF3F9C09}"/>
          </ac:spMkLst>
        </pc:spChg>
        <pc:spChg chg="add mod">
          <ac:chgData name="Papaioannou, Ioannis" userId="27d0d6e0-1133-45d1-b366-9071ba1a55b0" providerId="ADAL" clId="{09A5A6E7-5AD0-42C9-91F3-0518137A29BA}" dt="2024-03-26T04:56:37.303" v="1200" actId="20577"/>
          <ac:spMkLst>
            <pc:docMk/>
            <pc:sldMk cId="3619489513" sldId="270"/>
            <ac:spMk id="7" creationId="{57951800-5779-86F4-D435-D758471A7C15}"/>
          </ac:spMkLst>
        </pc:spChg>
        <pc:spChg chg="mod">
          <ac:chgData name="Papaioannou, Ioannis" userId="27d0d6e0-1133-45d1-b366-9071ba1a55b0" providerId="ADAL" clId="{09A5A6E7-5AD0-42C9-91F3-0518137A29BA}" dt="2024-03-26T04:59:13.063" v="1244" actId="1076"/>
          <ac:spMkLst>
            <pc:docMk/>
            <pc:sldMk cId="3619489513" sldId="270"/>
            <ac:spMk id="10" creationId="{19BAAFFC-35E3-95FD-33D0-D0319F51DEBC}"/>
          </ac:spMkLst>
        </pc:spChg>
        <pc:spChg chg="mod">
          <ac:chgData name="Papaioannou, Ioannis" userId="27d0d6e0-1133-45d1-b366-9071ba1a55b0" providerId="ADAL" clId="{09A5A6E7-5AD0-42C9-91F3-0518137A29BA}" dt="2024-03-26T04:59:10.818" v="1243" actId="1076"/>
          <ac:spMkLst>
            <pc:docMk/>
            <pc:sldMk cId="3619489513" sldId="270"/>
            <ac:spMk id="11" creationId="{FACE4584-7B8D-7519-CC95-3E884FDAD333}"/>
          </ac:spMkLst>
        </pc:spChg>
        <pc:spChg chg="add mod">
          <ac:chgData name="Papaioannou, Ioannis" userId="27d0d6e0-1133-45d1-b366-9071ba1a55b0" providerId="ADAL" clId="{09A5A6E7-5AD0-42C9-91F3-0518137A29BA}" dt="2024-03-26T04:56:41.826" v="1202" actId="20577"/>
          <ac:spMkLst>
            <pc:docMk/>
            <pc:sldMk cId="3619489513" sldId="270"/>
            <ac:spMk id="12" creationId="{C9D4C46E-B7CC-514A-F276-7EC40E57395F}"/>
          </ac:spMkLst>
        </pc:spChg>
        <pc:spChg chg="add mod">
          <ac:chgData name="Papaioannou, Ioannis" userId="27d0d6e0-1133-45d1-b366-9071ba1a55b0" providerId="ADAL" clId="{09A5A6E7-5AD0-42C9-91F3-0518137A29BA}" dt="2024-03-26T04:57:08.214" v="1217" actId="1038"/>
          <ac:spMkLst>
            <pc:docMk/>
            <pc:sldMk cId="3619489513" sldId="270"/>
            <ac:spMk id="13" creationId="{5FFB6C31-0EC1-B2C8-1554-21E67039AFDF}"/>
          </ac:spMkLst>
        </pc:spChg>
        <pc:spChg chg="add mod">
          <ac:chgData name="Papaioannou, Ioannis" userId="27d0d6e0-1133-45d1-b366-9071ba1a55b0" providerId="ADAL" clId="{09A5A6E7-5AD0-42C9-91F3-0518137A29BA}" dt="2024-03-26T04:57:08.214" v="1217" actId="1038"/>
          <ac:spMkLst>
            <pc:docMk/>
            <pc:sldMk cId="3619489513" sldId="270"/>
            <ac:spMk id="14" creationId="{4CE8C495-667B-A2EA-2A1A-F7B09EC5C3A5}"/>
          </ac:spMkLst>
        </pc:spChg>
        <pc:spChg chg="add mod">
          <ac:chgData name="Papaioannou, Ioannis" userId="27d0d6e0-1133-45d1-b366-9071ba1a55b0" providerId="ADAL" clId="{09A5A6E7-5AD0-42C9-91F3-0518137A29BA}" dt="2024-03-26T04:57:08.214" v="1217" actId="1038"/>
          <ac:spMkLst>
            <pc:docMk/>
            <pc:sldMk cId="3619489513" sldId="270"/>
            <ac:spMk id="15" creationId="{2F37F4B2-A5FC-C0A5-71FB-F9E066918F18}"/>
          </ac:spMkLst>
        </pc:spChg>
        <pc:spChg chg="add mod">
          <ac:chgData name="Papaioannou, Ioannis" userId="27d0d6e0-1133-45d1-b366-9071ba1a55b0" providerId="ADAL" clId="{09A5A6E7-5AD0-42C9-91F3-0518137A29BA}" dt="2024-03-26T04:57:13.949" v="1220" actId="1037"/>
          <ac:spMkLst>
            <pc:docMk/>
            <pc:sldMk cId="3619489513" sldId="270"/>
            <ac:spMk id="16" creationId="{4AAD6096-D04C-24EE-D8BF-3F2E42FC9A2E}"/>
          </ac:spMkLst>
        </pc:spChg>
        <pc:spChg chg="add mod">
          <ac:chgData name="Papaioannou, Ioannis" userId="27d0d6e0-1133-45d1-b366-9071ba1a55b0" providerId="ADAL" clId="{09A5A6E7-5AD0-42C9-91F3-0518137A29BA}" dt="2024-03-26T04:57:22.319" v="1224" actId="20577"/>
          <ac:spMkLst>
            <pc:docMk/>
            <pc:sldMk cId="3619489513" sldId="270"/>
            <ac:spMk id="19" creationId="{9A1C6FA8-E7A7-E56A-EDCE-7BB8BB50C41D}"/>
          </ac:spMkLst>
        </pc:spChg>
        <pc:spChg chg="add mod">
          <ac:chgData name="Papaioannou, Ioannis" userId="27d0d6e0-1133-45d1-b366-9071ba1a55b0" providerId="ADAL" clId="{09A5A6E7-5AD0-42C9-91F3-0518137A29BA}" dt="2024-03-26T04:57:25.120" v="1226" actId="20577"/>
          <ac:spMkLst>
            <pc:docMk/>
            <pc:sldMk cId="3619489513" sldId="270"/>
            <ac:spMk id="20" creationId="{EB3D5B41-9420-75DB-9C3E-3A55272CCCFC}"/>
          </ac:spMkLst>
        </pc:spChg>
        <pc:spChg chg="add mod">
          <ac:chgData name="Papaioannou, Ioannis" userId="27d0d6e0-1133-45d1-b366-9071ba1a55b0" providerId="ADAL" clId="{09A5A6E7-5AD0-42C9-91F3-0518137A29BA}" dt="2024-03-26T04:57:39.941" v="1228" actId="1076"/>
          <ac:spMkLst>
            <pc:docMk/>
            <pc:sldMk cId="3619489513" sldId="270"/>
            <ac:spMk id="21" creationId="{2D1C12AE-CA4F-C615-CF99-4071107319FA}"/>
          </ac:spMkLst>
        </pc:spChg>
        <pc:spChg chg="add del mod">
          <ac:chgData name="Papaioannou, Ioannis" userId="27d0d6e0-1133-45d1-b366-9071ba1a55b0" providerId="ADAL" clId="{09A5A6E7-5AD0-42C9-91F3-0518137A29BA}" dt="2024-03-26T04:58:41.451" v="1242" actId="478"/>
          <ac:spMkLst>
            <pc:docMk/>
            <pc:sldMk cId="3619489513" sldId="270"/>
            <ac:spMk id="22" creationId="{5413F375-8E3B-6A2A-C22B-6B5793D90DE4}"/>
          </ac:spMkLst>
        </pc:spChg>
        <pc:spChg chg="add del mod">
          <ac:chgData name="Papaioannou, Ioannis" userId="27d0d6e0-1133-45d1-b366-9071ba1a55b0" providerId="ADAL" clId="{09A5A6E7-5AD0-42C9-91F3-0518137A29BA}" dt="2024-03-26T04:58:41.451" v="1242" actId="478"/>
          <ac:spMkLst>
            <pc:docMk/>
            <pc:sldMk cId="3619489513" sldId="270"/>
            <ac:spMk id="23" creationId="{B67225E4-7CCC-91EA-1548-4A13321F0975}"/>
          </ac:spMkLst>
        </pc:spChg>
        <pc:spChg chg="add mod">
          <ac:chgData name="Papaioannou, Ioannis" userId="27d0d6e0-1133-45d1-b366-9071ba1a55b0" providerId="ADAL" clId="{09A5A6E7-5AD0-42C9-91F3-0518137A29BA}" dt="2024-03-26T04:57:58.678" v="1233" actId="1036"/>
          <ac:spMkLst>
            <pc:docMk/>
            <pc:sldMk cId="3619489513" sldId="270"/>
            <ac:spMk id="24" creationId="{4C3041F6-8666-E790-CE77-84A61463AB91}"/>
          </ac:spMkLst>
        </pc:spChg>
        <pc:spChg chg="add mod">
          <ac:chgData name="Papaioannou, Ioannis" userId="27d0d6e0-1133-45d1-b366-9071ba1a55b0" providerId="ADAL" clId="{09A5A6E7-5AD0-42C9-91F3-0518137A29BA}" dt="2024-03-26T04:57:53.680" v="1231" actId="1076"/>
          <ac:spMkLst>
            <pc:docMk/>
            <pc:sldMk cId="3619489513" sldId="270"/>
            <ac:spMk id="25" creationId="{16F362F4-754D-1A7A-C387-B12D754D1393}"/>
          </ac:spMkLst>
        </pc:spChg>
        <pc:spChg chg="add mod">
          <ac:chgData name="Papaioannou, Ioannis" userId="27d0d6e0-1133-45d1-b366-9071ba1a55b0" providerId="ADAL" clId="{09A5A6E7-5AD0-42C9-91F3-0518137A29BA}" dt="2024-03-26T04:58:03.711" v="1234" actId="1076"/>
          <ac:spMkLst>
            <pc:docMk/>
            <pc:sldMk cId="3619489513" sldId="270"/>
            <ac:spMk id="26" creationId="{BBC289CB-C845-3301-1259-661D80D3579D}"/>
          </ac:spMkLst>
        </pc:spChg>
        <pc:spChg chg="add mod">
          <ac:chgData name="Papaioannou, Ioannis" userId="27d0d6e0-1133-45d1-b366-9071ba1a55b0" providerId="ADAL" clId="{09A5A6E7-5AD0-42C9-91F3-0518137A29BA}" dt="2024-03-26T04:58:06.979" v="1235" actId="1076"/>
          <ac:spMkLst>
            <pc:docMk/>
            <pc:sldMk cId="3619489513" sldId="270"/>
            <ac:spMk id="27" creationId="{F77E4537-D205-9E5A-4A52-0F20750CA9E3}"/>
          </ac:spMkLst>
        </pc:spChg>
        <pc:spChg chg="add mod">
          <ac:chgData name="Papaioannou, Ioannis" userId="27d0d6e0-1133-45d1-b366-9071ba1a55b0" providerId="ADAL" clId="{09A5A6E7-5AD0-42C9-91F3-0518137A29BA}" dt="2024-03-26T04:58:15.468" v="1237" actId="1076"/>
          <ac:spMkLst>
            <pc:docMk/>
            <pc:sldMk cId="3619489513" sldId="270"/>
            <ac:spMk id="28" creationId="{25A9911F-5BD1-D657-20A6-18D9F0E261E7}"/>
          </ac:spMkLst>
        </pc:spChg>
        <pc:spChg chg="add mod">
          <ac:chgData name="Papaioannou, Ioannis" userId="27d0d6e0-1133-45d1-b366-9071ba1a55b0" providerId="ADAL" clId="{09A5A6E7-5AD0-42C9-91F3-0518137A29BA}" dt="2024-03-26T04:58:21.738" v="1238" actId="1076"/>
          <ac:spMkLst>
            <pc:docMk/>
            <pc:sldMk cId="3619489513" sldId="270"/>
            <ac:spMk id="29" creationId="{EDCFC4AE-B431-6FF0-4D1F-32BE2CBEE0B9}"/>
          </ac:spMkLst>
        </pc:spChg>
        <pc:spChg chg="add mod">
          <ac:chgData name="Papaioannou, Ioannis" userId="27d0d6e0-1133-45d1-b366-9071ba1a55b0" providerId="ADAL" clId="{09A5A6E7-5AD0-42C9-91F3-0518137A29BA}" dt="2024-03-26T04:58:26.890" v="1239" actId="1076"/>
          <ac:spMkLst>
            <pc:docMk/>
            <pc:sldMk cId="3619489513" sldId="270"/>
            <ac:spMk id="30" creationId="{43435353-3533-F883-11C7-CA5DEFB964FC}"/>
          </ac:spMkLst>
        </pc:spChg>
        <pc:spChg chg="add mod">
          <ac:chgData name="Papaioannou, Ioannis" userId="27d0d6e0-1133-45d1-b366-9071ba1a55b0" providerId="ADAL" clId="{09A5A6E7-5AD0-42C9-91F3-0518137A29BA}" dt="2024-03-26T04:58:31.083" v="1240" actId="1076"/>
          <ac:spMkLst>
            <pc:docMk/>
            <pc:sldMk cId="3619489513" sldId="270"/>
            <ac:spMk id="31" creationId="{BEE2717D-5BDC-9E78-1EF7-23C820874804}"/>
          </ac:spMkLst>
        </pc:spChg>
        <pc:spChg chg="add mod">
          <ac:chgData name="Papaioannou, Ioannis" userId="27d0d6e0-1133-45d1-b366-9071ba1a55b0" providerId="ADAL" clId="{09A5A6E7-5AD0-42C9-91F3-0518137A29BA}" dt="2024-03-26T04:58:35.651" v="1241" actId="1076"/>
          <ac:spMkLst>
            <pc:docMk/>
            <pc:sldMk cId="3619489513" sldId="270"/>
            <ac:spMk id="32" creationId="{5D1238C1-E85A-C073-3F3E-5D86E0CBE8D9}"/>
          </ac:spMkLst>
        </pc:spChg>
        <pc:spChg chg="add mod">
          <ac:chgData name="Papaioannou, Ioannis" userId="27d0d6e0-1133-45d1-b366-9071ba1a55b0" providerId="ADAL" clId="{09A5A6E7-5AD0-42C9-91F3-0518137A29BA}" dt="2024-03-26T04:57:44.258" v="1229" actId="571"/>
          <ac:spMkLst>
            <pc:docMk/>
            <pc:sldMk cId="3619489513" sldId="270"/>
            <ac:spMk id="33" creationId="{AF6F220F-AC6B-D905-B596-000220F27E64}"/>
          </ac:spMkLst>
        </pc:spChg>
        <pc:spChg chg="add mod">
          <ac:chgData name="Papaioannou, Ioannis" userId="27d0d6e0-1133-45d1-b366-9071ba1a55b0" providerId="ADAL" clId="{09A5A6E7-5AD0-42C9-91F3-0518137A29BA}" dt="2024-03-26T04:57:49.155" v="1230" actId="571"/>
          <ac:spMkLst>
            <pc:docMk/>
            <pc:sldMk cId="3619489513" sldId="270"/>
            <ac:spMk id="34" creationId="{7D3CE195-F962-72F3-CD90-75B65179A722}"/>
          </ac:spMkLst>
        </pc:spChg>
      </pc:sldChg>
      <pc:sldChg chg="addSp delSp modSp new mod">
        <pc:chgData name="Papaioannou, Ioannis" userId="27d0d6e0-1133-45d1-b366-9071ba1a55b0" providerId="ADAL" clId="{09A5A6E7-5AD0-42C9-91F3-0518137A29BA}" dt="2024-03-26T04:39:18.108" v="1147" actId="14100"/>
        <pc:sldMkLst>
          <pc:docMk/>
          <pc:sldMk cId="1938404681" sldId="272"/>
        </pc:sldMkLst>
        <pc:spChg chg="del">
          <ac:chgData name="Papaioannou, Ioannis" userId="27d0d6e0-1133-45d1-b366-9071ba1a55b0" providerId="ADAL" clId="{09A5A6E7-5AD0-42C9-91F3-0518137A29BA}" dt="2024-03-26T04:38:41.089" v="1140" actId="478"/>
          <ac:spMkLst>
            <pc:docMk/>
            <pc:sldMk cId="1938404681" sldId="272"/>
            <ac:spMk id="2" creationId="{F5424B73-7CC3-AE5F-DA73-3257DFE5BE01}"/>
          </ac:spMkLst>
        </pc:spChg>
        <pc:spChg chg="del">
          <ac:chgData name="Papaioannou, Ioannis" userId="27d0d6e0-1133-45d1-b366-9071ba1a55b0" providerId="ADAL" clId="{09A5A6E7-5AD0-42C9-91F3-0518137A29BA}" dt="2024-03-26T04:38:41.089" v="1140" actId="478"/>
          <ac:spMkLst>
            <pc:docMk/>
            <pc:sldMk cId="1938404681" sldId="272"/>
            <ac:spMk id="3" creationId="{156483CD-8956-534F-C625-E393BEE864C2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7" creationId="{9C06F814-6402-5F64-3B54-3F921671868F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9" creationId="{DC99ED75-16A9-E9E4-D0D8-4EFBB1EA7A77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10" creationId="{AC192D49-3779-773B-40D0-C646A5C87B74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14" creationId="{B242167E-8B8B-CCF8-CB15-8E813FE71897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15" creationId="{97730379-E969-530C-B7D1-D0515759DEE1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16" creationId="{5C18D6DF-0B79-7223-F192-8F12D23575E8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17" creationId="{404DD825-D237-5605-0C56-3FDD6BB0712E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20" creationId="{DE0FF45C-7B33-1092-78B7-27FAD6D973EC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21" creationId="{B073EC57-4B30-7792-B7DD-3DB52889BDD2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22" creationId="{FE41C95B-32C5-213D-400D-C00579AF59A5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23" creationId="{E2A2F0B6-EEDF-20A6-B0AE-D9AA897CC432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26" creationId="{C905AF88-563F-6B94-5E13-8FEDCE15DDAA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27" creationId="{7790096E-B864-D526-22FB-C4F8BB2E7563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28" creationId="{300E5DAB-94EA-1FC5-681F-DB11B983C305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29" creationId="{E2338310-2DD4-BFA4-733A-08E9801D740E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30" creationId="{15934693-FBE2-DCDC-F2E0-C19BDEEF21F1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31" creationId="{B1E3B98D-06E4-7E07-54F9-2A8DD7273EFD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34" creationId="{DE20AA59-4EE3-A94B-3C84-55653281763A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35" creationId="{76118E17-D03F-5CD2-4B51-39635AE177A4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36" creationId="{60B5D88B-B653-1DC9-3D02-58F5A81DEF83}"/>
          </ac:spMkLst>
        </pc:spChg>
        <pc:spChg chg="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39" creationId="{417A63A0-2A1C-1F91-EE76-03F4763EDE9D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40" creationId="{67C6AF7B-13DD-0CCA-D62A-1147AD51A982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41" creationId="{2A60A5AF-48A0-CF9A-79E7-48B156498A5C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42" creationId="{41A7CA88-3FD7-C229-1C89-7416E86F86A9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43" creationId="{6B200875-74C8-EDDA-4A19-4ACFF05D3EC7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44" creationId="{536D637A-5ECA-176F-2E5B-229A5A0635E6}"/>
          </ac:spMkLst>
        </pc:spChg>
        <pc:spChg chg="add mod">
          <ac:chgData name="Papaioannou, Ioannis" userId="27d0d6e0-1133-45d1-b366-9071ba1a55b0" providerId="ADAL" clId="{09A5A6E7-5AD0-42C9-91F3-0518137A29BA}" dt="2024-03-26T04:39:09.114" v="1143"/>
          <ac:spMkLst>
            <pc:docMk/>
            <pc:sldMk cId="1938404681" sldId="272"/>
            <ac:spMk id="45" creationId="{89BC7027-1E8A-E3F2-6552-408DF44DEF3B}"/>
          </ac:spMkLst>
        </pc:spChg>
        <pc:grpChg chg="add mod">
          <ac:chgData name="Papaioannou, Ioannis" userId="27d0d6e0-1133-45d1-b366-9071ba1a55b0" providerId="ADAL" clId="{09A5A6E7-5AD0-42C9-91F3-0518137A29BA}" dt="2024-03-26T04:39:09.114" v="1143"/>
          <ac:grpSpMkLst>
            <pc:docMk/>
            <pc:sldMk cId="1938404681" sldId="272"/>
            <ac:grpSpMk id="11" creationId="{3AED6B2A-799C-EEF0-C927-055C1C0EB8D0}"/>
          </ac:grpSpMkLst>
        </pc:grpChg>
        <pc:grpChg chg="add mod">
          <ac:chgData name="Papaioannou, Ioannis" userId="27d0d6e0-1133-45d1-b366-9071ba1a55b0" providerId="ADAL" clId="{09A5A6E7-5AD0-42C9-91F3-0518137A29BA}" dt="2024-03-26T04:39:09.114" v="1143"/>
          <ac:grpSpMkLst>
            <pc:docMk/>
            <pc:sldMk cId="1938404681" sldId="272"/>
            <ac:grpSpMk id="18" creationId="{3C522663-5620-8413-6ACD-BB53CCE68ECF}"/>
          </ac:grpSpMkLst>
        </pc:grpChg>
        <pc:grpChg chg="add mod">
          <ac:chgData name="Papaioannou, Ioannis" userId="27d0d6e0-1133-45d1-b366-9071ba1a55b0" providerId="ADAL" clId="{09A5A6E7-5AD0-42C9-91F3-0518137A29BA}" dt="2024-03-26T04:39:09.114" v="1143"/>
          <ac:grpSpMkLst>
            <pc:docMk/>
            <pc:sldMk cId="1938404681" sldId="272"/>
            <ac:grpSpMk id="24" creationId="{9B8A5246-041D-C142-B218-ED86EEE4DD98}"/>
          </ac:grpSpMkLst>
        </pc:grpChg>
        <pc:grpChg chg="add mod">
          <ac:chgData name="Papaioannou, Ioannis" userId="27d0d6e0-1133-45d1-b366-9071ba1a55b0" providerId="ADAL" clId="{09A5A6E7-5AD0-42C9-91F3-0518137A29BA}" dt="2024-03-26T04:39:09.114" v="1143"/>
          <ac:grpSpMkLst>
            <pc:docMk/>
            <pc:sldMk cId="1938404681" sldId="272"/>
            <ac:grpSpMk id="32" creationId="{44EC4933-C5AC-8A9C-FE15-8875581AFC10}"/>
          </ac:grpSpMkLst>
        </pc:grpChg>
        <pc:grpChg chg="add mod">
          <ac:chgData name="Papaioannou, Ioannis" userId="27d0d6e0-1133-45d1-b366-9071ba1a55b0" providerId="ADAL" clId="{09A5A6E7-5AD0-42C9-91F3-0518137A29BA}" dt="2024-03-26T04:39:09.114" v="1143"/>
          <ac:grpSpMkLst>
            <pc:docMk/>
            <pc:sldMk cId="1938404681" sldId="272"/>
            <ac:grpSpMk id="37" creationId="{D61850B7-31A3-53D7-EEC2-36CE96895557}"/>
          </ac:grpSpMkLst>
        </pc:grpChg>
        <pc:picChg chg="add mod">
          <ac:chgData name="Papaioannou, Ioannis" userId="27d0d6e0-1133-45d1-b366-9071ba1a55b0" providerId="ADAL" clId="{09A5A6E7-5AD0-42C9-91F3-0518137A29BA}" dt="2024-03-26T04:39:18.108" v="1147" actId="14100"/>
          <ac:picMkLst>
            <pc:docMk/>
            <pc:sldMk cId="1938404681" sldId="272"/>
            <ac:picMk id="5" creationId="{90410DB8-75FE-BC52-70BA-044CF3549ED2}"/>
          </ac:picMkLst>
        </pc:picChg>
        <pc:picChg chg="add mod">
          <ac:chgData name="Papaioannou, Ioannis" userId="27d0d6e0-1133-45d1-b366-9071ba1a55b0" providerId="ADAL" clId="{09A5A6E7-5AD0-42C9-91F3-0518137A29BA}" dt="2024-03-26T04:39:09.114" v="1143"/>
          <ac:picMkLst>
            <pc:docMk/>
            <pc:sldMk cId="1938404681" sldId="272"/>
            <ac:picMk id="6" creationId="{C037B612-3E26-E651-B74C-07E5C37D2A67}"/>
          </ac:picMkLst>
        </pc:picChg>
        <pc:picChg chg="add mod">
          <ac:chgData name="Papaioannou, Ioannis" userId="27d0d6e0-1133-45d1-b366-9071ba1a55b0" providerId="ADAL" clId="{09A5A6E7-5AD0-42C9-91F3-0518137A29BA}" dt="2024-03-26T04:39:09.114" v="1143"/>
          <ac:picMkLst>
            <pc:docMk/>
            <pc:sldMk cId="1938404681" sldId="272"/>
            <ac:picMk id="8" creationId="{F74298BC-70FD-8E5E-D8B2-56AADC4A8FB4}"/>
          </ac:picMkLst>
        </pc:picChg>
        <pc:picChg chg="mod">
          <ac:chgData name="Papaioannou, Ioannis" userId="27d0d6e0-1133-45d1-b366-9071ba1a55b0" providerId="ADAL" clId="{09A5A6E7-5AD0-42C9-91F3-0518137A29BA}" dt="2024-03-26T04:39:09.114" v="1143"/>
          <ac:picMkLst>
            <pc:docMk/>
            <pc:sldMk cId="1938404681" sldId="272"/>
            <ac:picMk id="13" creationId="{58FFA765-6F88-3F12-0550-63B77E7B153C}"/>
          </ac:picMkLst>
        </pc:picChg>
        <pc:picChg chg="mod">
          <ac:chgData name="Papaioannou, Ioannis" userId="27d0d6e0-1133-45d1-b366-9071ba1a55b0" providerId="ADAL" clId="{09A5A6E7-5AD0-42C9-91F3-0518137A29BA}" dt="2024-03-26T04:39:09.114" v="1143"/>
          <ac:picMkLst>
            <pc:docMk/>
            <pc:sldMk cId="1938404681" sldId="272"/>
            <ac:picMk id="19" creationId="{472E72EF-2F46-C5E1-D6AE-5986BBD08321}"/>
          </ac:picMkLst>
        </pc:picChg>
        <pc:picChg chg="mod">
          <ac:chgData name="Papaioannou, Ioannis" userId="27d0d6e0-1133-45d1-b366-9071ba1a55b0" providerId="ADAL" clId="{09A5A6E7-5AD0-42C9-91F3-0518137A29BA}" dt="2024-03-26T04:39:09.114" v="1143"/>
          <ac:picMkLst>
            <pc:docMk/>
            <pc:sldMk cId="1938404681" sldId="272"/>
            <ac:picMk id="25" creationId="{E771275F-0274-F7C1-7270-272AB4C84DA2}"/>
          </ac:picMkLst>
        </pc:picChg>
        <pc:picChg chg="mod">
          <ac:chgData name="Papaioannou, Ioannis" userId="27d0d6e0-1133-45d1-b366-9071ba1a55b0" providerId="ADAL" clId="{09A5A6E7-5AD0-42C9-91F3-0518137A29BA}" dt="2024-03-26T04:39:09.114" v="1143"/>
          <ac:picMkLst>
            <pc:docMk/>
            <pc:sldMk cId="1938404681" sldId="272"/>
            <ac:picMk id="33" creationId="{33BD5FB9-81E8-5644-D4A1-23B30860786B}"/>
          </ac:picMkLst>
        </pc:picChg>
        <pc:picChg chg="mod">
          <ac:chgData name="Papaioannou, Ioannis" userId="27d0d6e0-1133-45d1-b366-9071ba1a55b0" providerId="ADAL" clId="{09A5A6E7-5AD0-42C9-91F3-0518137A29BA}" dt="2024-03-26T04:39:09.114" v="1143"/>
          <ac:picMkLst>
            <pc:docMk/>
            <pc:sldMk cId="1938404681" sldId="272"/>
            <ac:picMk id="38" creationId="{FEBDB793-0746-8E86-7E17-8E14B19BAAFD}"/>
          </ac:picMkLst>
        </pc:picChg>
        <pc:inkChg chg="mod">
          <ac:chgData name="Papaioannou, Ioannis" userId="27d0d6e0-1133-45d1-b366-9071ba1a55b0" providerId="ADAL" clId="{09A5A6E7-5AD0-42C9-91F3-0518137A29BA}" dt="2024-03-26T04:39:09.114" v="1143"/>
          <ac:inkMkLst>
            <pc:docMk/>
            <pc:sldMk cId="1938404681" sldId="272"/>
            <ac:inkMk id="12" creationId="{C86DD16C-C5D0-B443-D459-BEA081F05104}"/>
          </ac:inkMkLst>
        </pc:inkChg>
      </pc:sldChg>
    </pc:docChg>
  </pc:docChgLst>
  <pc:docChgLst>
    <pc:chgData name="Papaioannou, Ioannis" userId="27d0d6e0-1133-45d1-b366-9071ba1a55b0" providerId="ADAL" clId="{BED77CB9-8C6B-4C5A-AA77-9AC9B96531A9}"/>
    <pc:docChg chg="modSld">
      <pc:chgData name="Papaioannou, Ioannis" userId="27d0d6e0-1133-45d1-b366-9071ba1a55b0" providerId="ADAL" clId="{BED77CB9-8C6B-4C5A-AA77-9AC9B96531A9}" dt="2023-10-12T09:27:07.177" v="2"/>
      <pc:docMkLst>
        <pc:docMk/>
      </pc:docMkLst>
      <pc:sldChg chg="modSp mod addCm">
        <pc:chgData name="Papaioannou, Ioannis" userId="27d0d6e0-1133-45d1-b366-9071ba1a55b0" providerId="ADAL" clId="{BED77CB9-8C6B-4C5A-AA77-9AC9B96531A9}" dt="2023-10-12T09:26:40.601" v="1"/>
        <pc:sldMkLst>
          <pc:docMk/>
          <pc:sldMk cId="1783988844" sldId="256"/>
        </pc:sldMkLst>
        <pc:picChg chg="mod modCrop">
          <ac:chgData name="Papaioannou, Ioannis" userId="27d0d6e0-1133-45d1-b366-9071ba1a55b0" providerId="ADAL" clId="{BED77CB9-8C6B-4C5A-AA77-9AC9B96531A9}" dt="2023-10-12T09:22:57.935" v="0" actId="732"/>
          <ac:picMkLst>
            <pc:docMk/>
            <pc:sldMk cId="1783988844" sldId="256"/>
            <ac:picMk id="2" creationId="{77121E52-3070-6894-1F08-370B3A2D6958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add">
              <pc226:chgData name="Papaioannou, Ioannis" userId="27d0d6e0-1133-45d1-b366-9071ba1a55b0" providerId="ADAL" clId="{BED77CB9-8C6B-4C5A-AA77-9AC9B96531A9}" dt="2023-10-12T09:26:40.601" v="1"/>
              <pc2:cmMkLst xmlns:pc2="http://schemas.microsoft.com/office/powerpoint/2019/9/main/command">
                <pc:docMk/>
                <pc:sldMk cId="1783988844" sldId="256"/>
                <pc2:cmMk id="{23DDDB77-FBD8-40B9-B47B-AC649DB25F08}"/>
              </pc2:cmMkLst>
            </pc226:cmChg>
          </p:ext>
        </pc:extLst>
      </pc:sldChg>
      <pc:sldChg chg="addCm">
        <pc:chgData name="Papaioannou, Ioannis" userId="27d0d6e0-1133-45d1-b366-9071ba1a55b0" providerId="ADAL" clId="{BED77CB9-8C6B-4C5A-AA77-9AC9B96531A9}" dt="2023-10-12T09:27:07.177" v="2"/>
        <pc:sldMkLst>
          <pc:docMk/>
          <pc:sldMk cId="1608280500" sldId="266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add">
              <pc226:chgData name="Papaioannou, Ioannis" userId="27d0d6e0-1133-45d1-b366-9071ba1a55b0" providerId="ADAL" clId="{BED77CB9-8C6B-4C5A-AA77-9AC9B96531A9}" dt="2023-10-12T09:27:07.177" v="2"/>
              <pc2:cmMkLst xmlns:pc2="http://schemas.microsoft.com/office/powerpoint/2019/9/main/command">
                <pc:docMk/>
                <pc:sldMk cId="1608280500" sldId="266"/>
                <pc2:cmMk id="{E2BE4A36-66FB-45CA-82A4-98B4AC064538}"/>
              </pc2:cmMkLst>
            </pc226:cmChg>
          </p:ext>
        </pc:extLst>
      </pc:sldChg>
    </pc:docChg>
  </pc:docChgLst>
  <pc:docChgLst>
    <pc:chgData name="Ponticos, Markella" userId="S::rmhampo@ucl.ac.uk::8ef50869-c47f-477f-819f-244d7318bb2d" providerId="AD" clId="Web-{B6826C23-1DB4-419F-F4C2-5947BE97630A}"/>
    <pc:docChg chg="modSld">
      <pc:chgData name="Ponticos, Markella" userId="S::rmhampo@ucl.ac.uk::8ef50869-c47f-477f-819f-244d7318bb2d" providerId="AD" clId="Web-{B6826C23-1DB4-419F-F4C2-5947BE97630A}" dt="2024-02-29T14:08:15.593" v="24" actId="1076"/>
      <pc:docMkLst>
        <pc:docMk/>
      </pc:docMkLst>
      <pc:sldChg chg="modSp">
        <pc:chgData name="Ponticos, Markella" userId="S::rmhampo@ucl.ac.uk::8ef50869-c47f-477f-819f-244d7318bb2d" providerId="AD" clId="Web-{B6826C23-1DB4-419F-F4C2-5947BE97630A}" dt="2024-02-29T13:41:05.530" v="8" actId="1076"/>
        <pc:sldMkLst>
          <pc:docMk/>
          <pc:sldMk cId="2731541974" sldId="258"/>
        </pc:sldMkLst>
        <pc:spChg chg="mod">
          <ac:chgData name="Ponticos, Markella" userId="S::rmhampo@ucl.ac.uk::8ef50869-c47f-477f-819f-244d7318bb2d" providerId="AD" clId="Web-{B6826C23-1DB4-419F-F4C2-5947BE97630A}" dt="2024-02-29T13:36:44.479" v="1" actId="1076"/>
          <ac:spMkLst>
            <pc:docMk/>
            <pc:sldMk cId="2731541974" sldId="258"/>
            <ac:spMk id="13" creationId="{9B4E1444-D491-9690-0B1E-B70B66DCE323}"/>
          </ac:spMkLst>
        </pc:spChg>
        <pc:spChg chg="mod">
          <ac:chgData name="Ponticos, Markella" userId="S::rmhampo@ucl.ac.uk::8ef50869-c47f-477f-819f-244d7318bb2d" providerId="AD" clId="Web-{B6826C23-1DB4-419F-F4C2-5947BE97630A}" dt="2024-02-29T13:40:52.576" v="7" actId="1076"/>
          <ac:spMkLst>
            <pc:docMk/>
            <pc:sldMk cId="2731541974" sldId="258"/>
            <ac:spMk id="28" creationId="{A02A8AB1-9E5E-771B-52FF-A366E4EB6C5B}"/>
          </ac:spMkLst>
        </pc:spChg>
        <pc:spChg chg="mod">
          <ac:chgData name="Ponticos, Markella" userId="S::rmhampo@ucl.ac.uk::8ef50869-c47f-477f-819f-244d7318bb2d" providerId="AD" clId="Web-{B6826C23-1DB4-419F-F4C2-5947BE97630A}" dt="2024-02-29T13:41:05.530" v="8" actId="1076"/>
          <ac:spMkLst>
            <pc:docMk/>
            <pc:sldMk cId="2731541974" sldId="258"/>
            <ac:spMk id="29" creationId="{CC027824-C764-618B-11C8-36268260F2B9}"/>
          </ac:spMkLst>
        </pc:spChg>
        <pc:picChg chg="mod">
          <ac:chgData name="Ponticos, Markella" userId="S::rmhampo@ucl.ac.uk::8ef50869-c47f-477f-819f-244d7318bb2d" providerId="AD" clId="Web-{B6826C23-1DB4-419F-F4C2-5947BE97630A}" dt="2024-02-29T13:40:41.356" v="5" actId="1076"/>
          <ac:picMkLst>
            <pc:docMk/>
            <pc:sldMk cId="2731541974" sldId="258"/>
            <ac:picMk id="18" creationId="{9732B990-FEB6-A28B-D8FD-4E6841947501}"/>
          </ac:picMkLst>
        </pc:picChg>
      </pc:sldChg>
      <pc:sldChg chg="modSp">
        <pc:chgData name="Ponticos, Markella" userId="S::rmhampo@ucl.ac.uk::8ef50869-c47f-477f-819f-244d7318bb2d" providerId="AD" clId="Web-{B6826C23-1DB4-419F-F4C2-5947BE97630A}" dt="2024-02-29T13:48:56.207" v="11" actId="1076"/>
        <pc:sldMkLst>
          <pc:docMk/>
          <pc:sldMk cId="1934854818" sldId="262"/>
        </pc:sldMkLst>
        <pc:spChg chg="mod">
          <ac:chgData name="Ponticos, Markella" userId="S::rmhampo@ucl.ac.uk::8ef50869-c47f-477f-819f-244d7318bb2d" providerId="AD" clId="Web-{B6826C23-1DB4-419F-F4C2-5947BE97630A}" dt="2024-02-29T13:48:56.207" v="11" actId="1076"/>
          <ac:spMkLst>
            <pc:docMk/>
            <pc:sldMk cId="1934854818" sldId="262"/>
            <ac:spMk id="19" creationId="{A1151C06-37F6-F6CF-5771-A39177D8A989}"/>
          </ac:spMkLst>
        </pc:spChg>
      </pc:sldChg>
      <pc:sldChg chg="modSp">
        <pc:chgData name="Ponticos, Markella" userId="S::rmhampo@ucl.ac.uk::8ef50869-c47f-477f-819f-244d7318bb2d" providerId="AD" clId="Web-{B6826C23-1DB4-419F-F4C2-5947BE97630A}" dt="2024-02-29T14:00:10.618" v="17" actId="1076"/>
        <pc:sldMkLst>
          <pc:docMk/>
          <pc:sldMk cId="1358340535" sldId="263"/>
        </pc:sldMkLst>
        <pc:spChg chg="mod">
          <ac:chgData name="Ponticos, Markella" userId="S::rmhampo@ucl.ac.uk::8ef50869-c47f-477f-819f-244d7318bb2d" providerId="AD" clId="Web-{B6826C23-1DB4-419F-F4C2-5947BE97630A}" dt="2024-02-29T13:56:38.024" v="13" actId="1076"/>
          <ac:spMkLst>
            <pc:docMk/>
            <pc:sldMk cId="1358340535" sldId="263"/>
            <ac:spMk id="25" creationId="{D476B235-64DD-7413-3ED3-DFA59D9B2716}"/>
          </ac:spMkLst>
        </pc:spChg>
        <pc:spChg chg="mod">
          <ac:chgData name="Ponticos, Markella" userId="S::rmhampo@ucl.ac.uk::8ef50869-c47f-477f-819f-244d7318bb2d" providerId="AD" clId="Web-{B6826C23-1DB4-419F-F4C2-5947BE97630A}" dt="2024-02-29T14:00:10.618" v="17" actId="1076"/>
          <ac:spMkLst>
            <pc:docMk/>
            <pc:sldMk cId="1358340535" sldId="263"/>
            <ac:spMk id="27" creationId="{EFF7B304-0A2D-CFCD-508D-9C3298095EC2}"/>
          </ac:spMkLst>
        </pc:spChg>
        <pc:spChg chg="mod">
          <ac:chgData name="Ponticos, Markella" userId="S::rmhampo@ucl.ac.uk::8ef50869-c47f-477f-819f-244d7318bb2d" providerId="AD" clId="Web-{B6826C23-1DB4-419F-F4C2-5947BE97630A}" dt="2024-02-29T13:58:04.468" v="15" actId="1076"/>
          <ac:spMkLst>
            <pc:docMk/>
            <pc:sldMk cId="1358340535" sldId="263"/>
            <ac:spMk id="28" creationId="{48B1942E-3A20-FF6E-39D0-60D2D2FC063F}"/>
          </ac:spMkLst>
        </pc:spChg>
        <pc:picChg chg="mod">
          <ac:chgData name="Ponticos, Markella" userId="S::rmhampo@ucl.ac.uk::8ef50869-c47f-477f-819f-244d7318bb2d" providerId="AD" clId="Web-{B6826C23-1DB4-419F-F4C2-5947BE97630A}" dt="2024-02-29T13:56:31.117" v="12"/>
          <ac:picMkLst>
            <pc:docMk/>
            <pc:sldMk cId="1358340535" sldId="263"/>
            <ac:picMk id="11" creationId="{3D92CE0D-2F55-4716-F21A-C9967049CF04}"/>
          </ac:picMkLst>
        </pc:picChg>
        <pc:picChg chg="mod">
          <ac:chgData name="Ponticos, Markella" userId="S::rmhampo@ucl.ac.uk::8ef50869-c47f-477f-819f-244d7318bb2d" providerId="AD" clId="Web-{B6826C23-1DB4-419F-F4C2-5947BE97630A}" dt="2024-02-29T14:00:07.368" v="16" actId="1076"/>
          <ac:picMkLst>
            <pc:docMk/>
            <pc:sldMk cId="1358340535" sldId="263"/>
            <ac:picMk id="12" creationId="{7E352516-7147-9605-6EB5-9088257FB0BA}"/>
          </ac:picMkLst>
        </pc:picChg>
        <pc:picChg chg="mod">
          <ac:chgData name="Ponticos, Markella" userId="S::rmhampo@ucl.ac.uk::8ef50869-c47f-477f-819f-244d7318bb2d" providerId="AD" clId="Web-{B6826C23-1DB4-419F-F4C2-5947BE97630A}" dt="2024-02-29T13:56:51.056" v="14" actId="1076"/>
          <ac:picMkLst>
            <pc:docMk/>
            <pc:sldMk cId="1358340535" sldId="263"/>
            <ac:picMk id="31" creationId="{50BECEA1-C418-70E9-84CC-FE58E670104C}"/>
          </ac:picMkLst>
        </pc:picChg>
      </pc:sldChg>
      <pc:sldChg chg="modSp">
        <pc:chgData name="Ponticos, Markella" userId="S::rmhampo@ucl.ac.uk::8ef50869-c47f-477f-819f-244d7318bb2d" providerId="AD" clId="Web-{B6826C23-1DB4-419F-F4C2-5947BE97630A}" dt="2024-02-29T13:46:43.243" v="10" actId="14100"/>
        <pc:sldMkLst>
          <pc:docMk/>
          <pc:sldMk cId="4106415198" sldId="267"/>
        </pc:sldMkLst>
        <pc:spChg chg="mod">
          <ac:chgData name="Ponticos, Markella" userId="S::rmhampo@ucl.ac.uk::8ef50869-c47f-477f-819f-244d7318bb2d" providerId="AD" clId="Web-{B6826C23-1DB4-419F-F4C2-5947BE97630A}" dt="2024-02-29T13:46:43.243" v="10" actId="14100"/>
          <ac:spMkLst>
            <pc:docMk/>
            <pc:sldMk cId="4106415198" sldId="267"/>
            <ac:spMk id="11" creationId="{4431568B-B19C-A308-88DE-DFEC6F21F1FB}"/>
          </ac:spMkLst>
        </pc:spChg>
      </pc:sldChg>
      <pc:sldChg chg="modSp">
        <pc:chgData name="Ponticos, Markella" userId="S::rmhampo@ucl.ac.uk::8ef50869-c47f-477f-819f-244d7318bb2d" providerId="AD" clId="Web-{B6826C23-1DB4-419F-F4C2-5947BE97630A}" dt="2024-02-29T14:02:56.475" v="22" actId="1076"/>
        <pc:sldMkLst>
          <pc:docMk/>
          <pc:sldMk cId="3205824443" sldId="269"/>
        </pc:sldMkLst>
        <pc:spChg chg="mod">
          <ac:chgData name="Ponticos, Markella" userId="S::rmhampo@ucl.ac.uk::8ef50869-c47f-477f-819f-244d7318bb2d" providerId="AD" clId="Web-{B6826C23-1DB4-419F-F4C2-5947BE97630A}" dt="2024-02-29T14:02:56.475" v="22" actId="1076"/>
          <ac:spMkLst>
            <pc:docMk/>
            <pc:sldMk cId="3205824443" sldId="269"/>
            <ac:spMk id="20" creationId="{359127C1-5C87-ECB5-4B01-CABAEFC05844}"/>
          </ac:spMkLst>
        </pc:spChg>
      </pc:sldChg>
      <pc:sldChg chg="modSp">
        <pc:chgData name="Ponticos, Markella" userId="S::rmhampo@ucl.ac.uk::8ef50869-c47f-477f-819f-244d7318bb2d" providerId="AD" clId="Web-{B6826C23-1DB4-419F-F4C2-5947BE97630A}" dt="2024-02-29T14:08:15.593" v="24" actId="1076"/>
        <pc:sldMkLst>
          <pc:docMk/>
          <pc:sldMk cId="3619489513" sldId="270"/>
        </pc:sldMkLst>
        <pc:spChg chg="mod">
          <ac:chgData name="Ponticos, Markella" userId="S::rmhampo@ucl.ac.uk::8ef50869-c47f-477f-819f-244d7318bb2d" providerId="AD" clId="Web-{B6826C23-1DB4-419F-F4C2-5947BE97630A}" dt="2024-02-29T14:08:15.593" v="24" actId="1076"/>
          <ac:spMkLst>
            <pc:docMk/>
            <pc:sldMk cId="3619489513" sldId="270"/>
            <ac:spMk id="9" creationId="{786C362D-B87D-D7A7-BCBA-20E8AA75AE81}"/>
          </ac:spMkLst>
        </pc:spChg>
      </pc:sldChg>
    </pc:docChg>
  </pc:docChgLst>
  <pc:docChgLst>
    <pc:chgData name="Ponticos, Markella" userId="S::rmhampo@ucl.ac.uk::8ef50869-c47f-477f-819f-244d7318bb2d" providerId="AD" clId="Web-{D2B7C858-DBC0-C187-4643-380BBA0B5A56}"/>
    <pc:docChg chg="modSld">
      <pc:chgData name="Ponticos, Markella" userId="S::rmhampo@ucl.ac.uk::8ef50869-c47f-477f-819f-244d7318bb2d" providerId="AD" clId="Web-{D2B7C858-DBC0-C187-4643-380BBA0B5A56}" dt="2023-11-15T09:44:35.424" v="9" actId="1076"/>
      <pc:docMkLst>
        <pc:docMk/>
      </pc:docMkLst>
      <pc:sldChg chg="modSp">
        <pc:chgData name="Ponticos, Markella" userId="S::rmhampo@ucl.ac.uk::8ef50869-c47f-477f-819f-244d7318bb2d" providerId="AD" clId="Web-{D2B7C858-DBC0-C187-4643-380BBA0B5A56}" dt="2023-11-15T09:40:51.559" v="0" actId="14100"/>
        <pc:sldMkLst>
          <pc:docMk/>
          <pc:sldMk cId="1358340535" sldId="263"/>
        </pc:sldMkLst>
        <pc:picChg chg="mod">
          <ac:chgData name="Ponticos, Markella" userId="S::rmhampo@ucl.ac.uk::8ef50869-c47f-477f-819f-244d7318bb2d" providerId="AD" clId="Web-{D2B7C858-DBC0-C187-4643-380BBA0B5A56}" dt="2023-11-15T09:40:51.559" v="0" actId="14100"/>
          <ac:picMkLst>
            <pc:docMk/>
            <pc:sldMk cId="1358340535" sldId="263"/>
            <ac:picMk id="31" creationId="{50BECEA1-C418-70E9-84CC-FE58E670104C}"/>
          </ac:picMkLst>
        </pc:picChg>
      </pc:sldChg>
      <pc:sldChg chg="addSp modSp">
        <pc:chgData name="Ponticos, Markella" userId="S::rmhampo@ucl.ac.uk::8ef50869-c47f-477f-819f-244d7318bb2d" providerId="AD" clId="Web-{D2B7C858-DBC0-C187-4643-380BBA0B5A56}" dt="2023-11-15T09:44:35.424" v="9" actId="1076"/>
        <pc:sldMkLst>
          <pc:docMk/>
          <pc:sldMk cId="711307936" sldId="271"/>
        </pc:sldMkLst>
        <pc:spChg chg="add mod">
          <ac:chgData name="Ponticos, Markella" userId="S::rmhampo@ucl.ac.uk::8ef50869-c47f-477f-819f-244d7318bb2d" providerId="AD" clId="Web-{D2B7C858-DBC0-C187-4643-380BBA0B5A56}" dt="2023-11-15T09:44:35.424" v="9" actId="1076"/>
          <ac:spMkLst>
            <pc:docMk/>
            <pc:sldMk cId="711307936" sldId="271"/>
            <ac:spMk id="2" creationId="{B1C664A6-6367-01E6-1AAB-5567E758C241}"/>
          </ac:spMkLst>
        </pc:spChg>
      </pc:sldChg>
    </pc:docChg>
  </pc:docChgLst>
  <pc:docChgLst>
    <pc:chgData name="Ponticos, Markella" userId="S::rmhampo@ucl.ac.uk::8ef50869-c47f-477f-819f-244d7318bb2d" providerId="AD" clId="Web-{EAF9D0CF-70F5-464A-7FDF-A6F19BD1C207}"/>
    <pc:docChg chg="addSld modSld addMainMaster">
      <pc:chgData name="Ponticos, Markella" userId="S::rmhampo@ucl.ac.uk::8ef50869-c47f-477f-819f-244d7318bb2d" providerId="AD" clId="Web-{EAF9D0CF-70F5-464A-7FDF-A6F19BD1C207}" dt="2022-06-24T13:05:08.884" v="4"/>
      <pc:docMkLst>
        <pc:docMk/>
      </pc:docMkLst>
      <pc:sldChg chg="addSp delSp modSp">
        <pc:chgData name="Ponticos, Markella" userId="S::rmhampo@ucl.ac.uk::8ef50869-c47f-477f-819f-244d7318bb2d" providerId="AD" clId="Web-{EAF9D0CF-70F5-464A-7FDF-A6F19BD1C207}" dt="2022-06-24T13:05:08.884" v="4"/>
        <pc:sldMkLst>
          <pc:docMk/>
          <pc:sldMk cId="1358340535" sldId="263"/>
        </pc:sldMkLst>
        <pc:picChg chg="add del mod">
          <ac:chgData name="Ponticos, Markella" userId="S::rmhampo@ucl.ac.uk::8ef50869-c47f-477f-819f-244d7318bb2d" providerId="AD" clId="Web-{EAF9D0CF-70F5-464A-7FDF-A6F19BD1C207}" dt="2022-06-24T13:04:30.694" v="2"/>
          <ac:picMkLst>
            <pc:docMk/>
            <pc:sldMk cId="1358340535" sldId="263"/>
            <ac:picMk id="2" creationId="{E107145A-B2CB-CE28-4D83-28DAD86C3F92}"/>
          </ac:picMkLst>
        </pc:picChg>
        <pc:picChg chg="add del mod">
          <ac:chgData name="Ponticos, Markella" userId="S::rmhampo@ucl.ac.uk::8ef50869-c47f-477f-819f-244d7318bb2d" providerId="AD" clId="Web-{EAF9D0CF-70F5-464A-7FDF-A6F19BD1C207}" dt="2022-06-24T13:05:08.884" v="4"/>
          <ac:picMkLst>
            <pc:docMk/>
            <pc:sldMk cId="1358340535" sldId="263"/>
            <ac:picMk id="4" creationId="{44AB64C8-0D8A-5074-DB79-E3EFC05F50FB}"/>
          </ac:picMkLst>
        </pc:picChg>
      </pc:sldChg>
      <pc:sldChg chg="add">
        <pc:chgData name="Ponticos, Markella" userId="S::rmhampo@ucl.ac.uk::8ef50869-c47f-477f-819f-244d7318bb2d" providerId="AD" clId="Web-{EAF9D0CF-70F5-464A-7FDF-A6F19BD1C207}" dt="2022-06-24T12:37:34.281" v="0"/>
        <pc:sldMkLst>
          <pc:docMk/>
          <pc:sldMk cId="1608280500" sldId="266"/>
        </pc:sldMkLst>
      </pc:sldChg>
      <pc:sldMasterChg chg="add addSldLayout">
        <pc:chgData name="Ponticos, Markella" userId="S::rmhampo@ucl.ac.uk::8ef50869-c47f-477f-819f-244d7318bb2d" providerId="AD" clId="Web-{EAF9D0CF-70F5-464A-7FDF-A6F19BD1C207}" dt="2022-06-24T12:37:34.281" v="0"/>
        <pc:sldMasterMkLst>
          <pc:docMk/>
          <pc:sldMasterMk cId="621311168" sldId="2147483660"/>
        </pc:sldMasterMkLst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4160876725" sldId="2147483661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1368262833" sldId="2147483662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1504598639" sldId="2147483663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2213605447" sldId="2147483664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1570657871" sldId="2147483665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1360905723" sldId="2147483666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1752490362" sldId="2147483667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575873249" sldId="2147483668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3386065336" sldId="2147483669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46259938" sldId="2147483670"/>
          </pc:sldLayoutMkLst>
        </pc:sldLayoutChg>
        <pc:sldLayoutChg chg="add">
          <pc:chgData name="Ponticos, Markella" userId="S::rmhampo@ucl.ac.uk::8ef50869-c47f-477f-819f-244d7318bb2d" providerId="AD" clId="Web-{EAF9D0CF-70F5-464A-7FDF-A6F19BD1C207}" dt="2022-06-24T12:37:34.281" v="0"/>
          <pc:sldLayoutMkLst>
            <pc:docMk/>
            <pc:sldMasterMk cId="621311168" sldId="2147483660"/>
            <pc:sldLayoutMk cId="2732821448" sldId="2147483671"/>
          </pc:sldLayoutMkLst>
        </pc:sldLayoutChg>
      </pc:sldMasterChg>
    </pc:docChg>
  </pc:docChgLst>
  <pc:docChgLst>
    <pc:chgData name="Papaioannou, Ioannis" userId="27d0d6e0-1133-45d1-b366-9071ba1a55b0" providerId="ADAL" clId="{AE32242B-AB1C-496F-9B1A-20E25321956D}"/>
    <pc:docChg chg="undo custSel addSld modSld sldOrd">
      <pc:chgData name="Papaioannou, Ioannis" userId="27d0d6e0-1133-45d1-b366-9071ba1a55b0" providerId="ADAL" clId="{AE32242B-AB1C-496F-9B1A-20E25321956D}" dt="2023-07-18T10:02:51.606" v="877" actId="571"/>
      <pc:docMkLst>
        <pc:docMk/>
      </pc:docMkLst>
      <pc:sldChg chg="addSp delSp modSp mod">
        <pc:chgData name="Papaioannou, Ioannis" userId="27d0d6e0-1133-45d1-b366-9071ba1a55b0" providerId="ADAL" clId="{AE32242B-AB1C-496F-9B1A-20E25321956D}" dt="2023-07-16T12:44:42.634" v="638" actId="20577"/>
        <pc:sldMkLst>
          <pc:docMk/>
          <pc:sldMk cId="1783988844" sldId="256"/>
        </pc:sldMkLst>
        <pc:spChg chg="add del mod">
          <ac:chgData name="Papaioannou, Ioannis" userId="27d0d6e0-1133-45d1-b366-9071ba1a55b0" providerId="ADAL" clId="{AE32242B-AB1C-496F-9B1A-20E25321956D}" dt="2023-07-16T12:43:43.258" v="625"/>
          <ac:spMkLst>
            <pc:docMk/>
            <pc:sldMk cId="1783988844" sldId="256"/>
            <ac:spMk id="2" creationId="{0FE75768-8EFE-6E41-4042-3B50F62B262F}"/>
          </ac:spMkLst>
        </pc:spChg>
        <pc:spChg chg="add mod">
          <ac:chgData name="Papaioannou, Ioannis" userId="27d0d6e0-1133-45d1-b366-9071ba1a55b0" providerId="ADAL" clId="{AE32242B-AB1C-496F-9B1A-20E25321956D}" dt="2023-07-16T12:44:14.429" v="630" actId="20577"/>
          <ac:spMkLst>
            <pc:docMk/>
            <pc:sldMk cId="1783988844" sldId="256"/>
            <ac:spMk id="3" creationId="{04F7D3DD-32AA-780D-8D19-638513B3954B}"/>
          </ac:spMkLst>
        </pc:spChg>
        <pc:spChg chg="add mod">
          <ac:chgData name="Papaioannou, Ioannis" userId="27d0d6e0-1133-45d1-b366-9071ba1a55b0" providerId="ADAL" clId="{AE32242B-AB1C-496F-9B1A-20E25321956D}" dt="2023-07-16T12:44:12.132" v="628" actId="1076"/>
          <ac:spMkLst>
            <pc:docMk/>
            <pc:sldMk cId="1783988844" sldId="256"/>
            <ac:spMk id="6" creationId="{FAC3BE54-E60B-9283-82B0-490B2EA549FF}"/>
          </ac:spMkLst>
        </pc:spChg>
        <pc:spChg chg="add mod">
          <ac:chgData name="Papaioannou, Ioannis" userId="27d0d6e0-1133-45d1-b366-9071ba1a55b0" providerId="ADAL" clId="{AE32242B-AB1C-496F-9B1A-20E25321956D}" dt="2023-07-16T12:44:42.634" v="638" actId="20577"/>
          <ac:spMkLst>
            <pc:docMk/>
            <pc:sldMk cId="1783988844" sldId="256"/>
            <ac:spMk id="7" creationId="{124DCE07-3F8B-D0BC-4530-DADA81D3FEF4}"/>
          </ac:spMkLst>
        </pc:spChg>
        <pc:spChg chg="add mod">
          <ac:chgData name="Papaioannou, Ioannis" userId="27d0d6e0-1133-45d1-b366-9071ba1a55b0" providerId="ADAL" clId="{AE32242B-AB1C-496F-9B1A-20E25321956D}" dt="2023-07-16T12:44:38.260" v="633" actId="20577"/>
          <ac:spMkLst>
            <pc:docMk/>
            <pc:sldMk cId="1783988844" sldId="256"/>
            <ac:spMk id="8" creationId="{0C831AA3-76B4-7CBA-F8C6-01FE4F300656}"/>
          </ac:spMkLst>
        </pc:spChg>
      </pc:sldChg>
      <pc:sldChg chg="addSp modSp mod">
        <pc:chgData name="Papaioannou, Ioannis" userId="27d0d6e0-1133-45d1-b366-9071ba1a55b0" providerId="ADAL" clId="{AE32242B-AB1C-496F-9B1A-20E25321956D}" dt="2023-07-16T12:46:17.496" v="674" actId="1036"/>
        <pc:sldMkLst>
          <pc:docMk/>
          <pc:sldMk cId="1419449853" sldId="257"/>
        </pc:sldMkLst>
        <pc:spChg chg="mod">
          <ac:chgData name="Papaioannou, Ioannis" userId="27d0d6e0-1133-45d1-b366-9071ba1a55b0" providerId="ADAL" clId="{AE32242B-AB1C-496F-9B1A-20E25321956D}" dt="2023-07-16T12:45:49.316" v="653" actId="1076"/>
          <ac:spMkLst>
            <pc:docMk/>
            <pc:sldMk cId="1419449853" sldId="257"/>
            <ac:spMk id="3" creationId="{FE5EEAF1-A486-2503-5C01-6EB8BF1AEEC9}"/>
          </ac:spMkLst>
        </pc:spChg>
        <pc:spChg chg="add mod">
          <ac:chgData name="Papaioannou, Ioannis" userId="27d0d6e0-1133-45d1-b366-9071ba1a55b0" providerId="ADAL" clId="{AE32242B-AB1C-496F-9B1A-20E25321956D}" dt="2023-07-16T12:45:54.487" v="655" actId="1076"/>
          <ac:spMkLst>
            <pc:docMk/>
            <pc:sldMk cId="1419449853" sldId="257"/>
            <ac:spMk id="7" creationId="{263C4422-D1FE-AC2D-9BB9-6191C9B1C339}"/>
          </ac:spMkLst>
        </pc:spChg>
        <pc:spChg chg="add mod">
          <ac:chgData name="Papaioannou, Ioannis" userId="27d0d6e0-1133-45d1-b366-9071ba1a55b0" providerId="ADAL" clId="{AE32242B-AB1C-496F-9B1A-20E25321956D}" dt="2023-07-16T12:45:49.316" v="653" actId="1076"/>
          <ac:spMkLst>
            <pc:docMk/>
            <pc:sldMk cId="1419449853" sldId="257"/>
            <ac:spMk id="8" creationId="{20AFCB14-25FC-FB46-76A5-A1454EED26F7}"/>
          </ac:spMkLst>
        </pc:spChg>
        <pc:spChg chg="add mod">
          <ac:chgData name="Papaioannou, Ioannis" userId="27d0d6e0-1133-45d1-b366-9071ba1a55b0" providerId="ADAL" clId="{AE32242B-AB1C-496F-9B1A-20E25321956D}" dt="2023-07-16T12:46:17.496" v="674" actId="1036"/>
          <ac:spMkLst>
            <pc:docMk/>
            <pc:sldMk cId="1419449853" sldId="257"/>
            <ac:spMk id="9" creationId="{08129A36-E324-85F6-9512-ECEA7B4CAF6C}"/>
          </ac:spMkLst>
        </pc:spChg>
        <pc:spChg chg="add mod">
          <ac:chgData name="Papaioannou, Ioannis" userId="27d0d6e0-1133-45d1-b366-9071ba1a55b0" providerId="ADAL" clId="{AE32242B-AB1C-496F-9B1A-20E25321956D}" dt="2023-07-16T12:46:03.186" v="665" actId="1037"/>
          <ac:spMkLst>
            <pc:docMk/>
            <pc:sldMk cId="1419449853" sldId="257"/>
            <ac:spMk id="10" creationId="{267B511B-44BE-16CE-5A61-A757B9366098}"/>
          </ac:spMkLst>
        </pc:spChg>
        <pc:spChg chg="mod">
          <ac:chgData name="Papaioannou, Ioannis" userId="27d0d6e0-1133-45d1-b366-9071ba1a55b0" providerId="ADAL" clId="{AE32242B-AB1C-496F-9B1A-20E25321956D}" dt="2023-07-16T12:45:49.316" v="653" actId="1076"/>
          <ac:spMkLst>
            <pc:docMk/>
            <pc:sldMk cId="1419449853" sldId="257"/>
            <ac:spMk id="11" creationId="{B1E772CA-BA61-D220-47D3-ABF571A4256F}"/>
          </ac:spMkLst>
        </pc:spChg>
        <pc:spChg chg="mod">
          <ac:chgData name="Papaioannou, Ioannis" userId="27d0d6e0-1133-45d1-b366-9071ba1a55b0" providerId="ADAL" clId="{AE32242B-AB1C-496F-9B1A-20E25321956D}" dt="2023-07-16T12:45:49.316" v="653" actId="1076"/>
          <ac:spMkLst>
            <pc:docMk/>
            <pc:sldMk cId="1419449853" sldId="257"/>
            <ac:spMk id="18" creationId="{627A2E1D-4C02-2536-C8DA-130733F31E3A}"/>
          </ac:spMkLst>
        </pc:spChg>
        <pc:picChg chg="mod">
          <ac:chgData name="Papaioannou, Ioannis" userId="27d0d6e0-1133-45d1-b366-9071ba1a55b0" providerId="ADAL" clId="{AE32242B-AB1C-496F-9B1A-20E25321956D}" dt="2023-07-16T12:45:49.316" v="653" actId="1076"/>
          <ac:picMkLst>
            <pc:docMk/>
            <pc:sldMk cId="1419449853" sldId="257"/>
            <ac:picMk id="4" creationId="{00000000-0000-0000-0000-000000000000}"/>
          </ac:picMkLst>
        </pc:picChg>
      </pc:sldChg>
      <pc:sldChg chg="addSp modSp mod">
        <pc:chgData name="Papaioannou, Ioannis" userId="27d0d6e0-1133-45d1-b366-9071ba1a55b0" providerId="ADAL" clId="{AE32242B-AB1C-496F-9B1A-20E25321956D}" dt="2023-07-16T12:48:43.056" v="708" actId="20577"/>
        <pc:sldMkLst>
          <pc:docMk/>
          <pc:sldMk cId="2731541974" sldId="258"/>
        </pc:sldMkLst>
        <pc:spChg chg="add mod">
          <ac:chgData name="Papaioannou, Ioannis" userId="27d0d6e0-1133-45d1-b366-9071ba1a55b0" providerId="ADAL" clId="{AE32242B-AB1C-496F-9B1A-20E25321956D}" dt="2023-07-16T11:53:42.253" v="249" actId="1076"/>
          <ac:spMkLst>
            <pc:docMk/>
            <pc:sldMk cId="2731541974" sldId="258"/>
            <ac:spMk id="3" creationId="{CD4E6264-A2FF-21EA-597A-607EA3D2EA73}"/>
          </ac:spMkLst>
        </pc:spChg>
        <pc:spChg chg="add mod">
          <ac:chgData name="Papaioannou, Ioannis" userId="27d0d6e0-1133-45d1-b366-9071ba1a55b0" providerId="ADAL" clId="{AE32242B-AB1C-496F-9B1A-20E25321956D}" dt="2023-07-16T11:53:47.139" v="253" actId="1037"/>
          <ac:spMkLst>
            <pc:docMk/>
            <pc:sldMk cId="2731541974" sldId="258"/>
            <ac:spMk id="4" creationId="{384BCCEF-585B-7300-481A-806D94988A95}"/>
          </ac:spMkLst>
        </pc:spChg>
        <pc:spChg chg="add mod">
          <ac:chgData name="Papaioannou, Ioannis" userId="27d0d6e0-1133-45d1-b366-9071ba1a55b0" providerId="ADAL" clId="{AE32242B-AB1C-496F-9B1A-20E25321956D}" dt="2023-07-16T11:53:51.710" v="254" actId="571"/>
          <ac:spMkLst>
            <pc:docMk/>
            <pc:sldMk cId="2731541974" sldId="258"/>
            <ac:spMk id="8" creationId="{E8C8B088-6FB8-A60D-F15E-50A17F46EC62}"/>
          </ac:spMkLst>
        </pc:spChg>
        <pc:spChg chg="add mod">
          <ac:chgData name="Papaioannou, Ioannis" userId="27d0d6e0-1133-45d1-b366-9071ba1a55b0" providerId="ADAL" clId="{AE32242B-AB1C-496F-9B1A-20E25321956D}" dt="2023-07-16T11:55:20.161" v="378" actId="1036"/>
          <ac:spMkLst>
            <pc:docMk/>
            <pc:sldMk cId="2731541974" sldId="258"/>
            <ac:spMk id="11" creationId="{B907CA25-A7EE-C2B2-10C9-464034F5866E}"/>
          </ac:spMkLst>
        </pc:spChg>
        <pc:spChg chg="add mod">
          <ac:chgData name="Papaioannou, Ioannis" userId="27d0d6e0-1133-45d1-b366-9071ba1a55b0" providerId="ADAL" clId="{AE32242B-AB1C-496F-9B1A-20E25321956D}" dt="2023-07-16T11:57:17.306" v="390" actId="1076"/>
          <ac:spMkLst>
            <pc:docMk/>
            <pc:sldMk cId="2731541974" sldId="258"/>
            <ac:spMk id="12" creationId="{1CC966A9-0988-B170-DDF9-0910C8BD3C8B}"/>
          </ac:spMkLst>
        </pc:spChg>
        <pc:spChg chg="mod">
          <ac:chgData name="Papaioannou, Ioannis" userId="27d0d6e0-1133-45d1-b366-9071ba1a55b0" providerId="ADAL" clId="{AE32242B-AB1C-496F-9B1A-20E25321956D}" dt="2023-07-16T11:57:07.459" v="386" actId="1076"/>
          <ac:spMkLst>
            <pc:docMk/>
            <pc:sldMk cId="2731541974" sldId="258"/>
            <ac:spMk id="17" creationId="{EEB02D4F-522B-88D1-F363-B1C46C1F8FFE}"/>
          </ac:spMkLst>
        </pc:spChg>
        <pc:spChg chg="add mod">
          <ac:chgData name="Papaioannou, Ioannis" userId="27d0d6e0-1133-45d1-b366-9071ba1a55b0" providerId="ADAL" clId="{AE32242B-AB1C-496F-9B1A-20E25321956D}" dt="2023-07-16T11:57:17.306" v="390" actId="1076"/>
          <ac:spMkLst>
            <pc:docMk/>
            <pc:sldMk cId="2731541974" sldId="258"/>
            <ac:spMk id="23" creationId="{4D5FFCB5-18F5-6578-3195-530DEC8B7860}"/>
          </ac:spMkLst>
        </pc:spChg>
        <pc:spChg chg="add mod">
          <ac:chgData name="Papaioannou, Ioannis" userId="27d0d6e0-1133-45d1-b366-9071ba1a55b0" providerId="ADAL" clId="{AE32242B-AB1C-496F-9B1A-20E25321956D}" dt="2023-07-16T11:57:39.991" v="395" actId="20577"/>
          <ac:spMkLst>
            <pc:docMk/>
            <pc:sldMk cId="2731541974" sldId="258"/>
            <ac:spMk id="24" creationId="{8AF7D4A4-5B95-1A1E-4497-E3D1B63CD8B4}"/>
          </ac:spMkLst>
        </pc:spChg>
        <pc:spChg chg="add mod">
          <ac:chgData name="Papaioannou, Ioannis" userId="27d0d6e0-1133-45d1-b366-9071ba1a55b0" providerId="ADAL" clId="{AE32242B-AB1C-496F-9B1A-20E25321956D}" dt="2023-07-16T11:57:37.764" v="394" actId="20577"/>
          <ac:spMkLst>
            <pc:docMk/>
            <pc:sldMk cId="2731541974" sldId="258"/>
            <ac:spMk id="25" creationId="{9BD089CB-5098-CDEF-6C92-B6A797526734}"/>
          </ac:spMkLst>
        </pc:spChg>
        <pc:spChg chg="add mod">
          <ac:chgData name="Papaioannou, Ioannis" userId="27d0d6e0-1133-45d1-b366-9071ba1a55b0" providerId="ADAL" clId="{AE32242B-AB1C-496F-9B1A-20E25321956D}" dt="2023-07-16T12:48:43.056" v="708" actId="20577"/>
          <ac:spMkLst>
            <pc:docMk/>
            <pc:sldMk cId="2731541974" sldId="258"/>
            <ac:spMk id="26" creationId="{6B623AEC-DE4A-21B5-2A9A-B4BA632452C9}"/>
          </ac:spMkLst>
        </pc:spChg>
        <pc:spChg chg="add mod">
          <ac:chgData name="Papaioannou, Ioannis" userId="27d0d6e0-1133-45d1-b366-9071ba1a55b0" providerId="ADAL" clId="{AE32242B-AB1C-496F-9B1A-20E25321956D}" dt="2023-07-16T11:57:53.002" v="396" actId="571"/>
          <ac:spMkLst>
            <pc:docMk/>
            <pc:sldMk cId="2731541974" sldId="258"/>
            <ac:spMk id="27" creationId="{16E73462-4B9F-AA46-4F33-A010E9635393}"/>
          </ac:spMkLst>
        </pc:spChg>
        <pc:spChg chg="add mod">
          <ac:chgData name="Papaioannou, Ioannis" userId="27d0d6e0-1133-45d1-b366-9071ba1a55b0" providerId="ADAL" clId="{AE32242B-AB1C-496F-9B1A-20E25321956D}" dt="2023-07-16T11:58:14.277" v="400" actId="20577"/>
          <ac:spMkLst>
            <pc:docMk/>
            <pc:sldMk cId="2731541974" sldId="258"/>
            <ac:spMk id="28" creationId="{A02A8AB1-9E5E-771B-52FF-A366E4EB6C5B}"/>
          </ac:spMkLst>
        </pc:spChg>
        <pc:spChg chg="add mod">
          <ac:chgData name="Papaioannou, Ioannis" userId="27d0d6e0-1133-45d1-b366-9071ba1a55b0" providerId="ADAL" clId="{AE32242B-AB1C-496F-9B1A-20E25321956D}" dt="2023-07-16T11:58:09.403" v="398" actId="571"/>
          <ac:spMkLst>
            <pc:docMk/>
            <pc:sldMk cId="2731541974" sldId="258"/>
            <ac:spMk id="29" creationId="{CC027824-C764-618B-11C8-36268260F2B9}"/>
          </ac:spMkLst>
        </pc:spChg>
        <pc:picChg chg="mod">
          <ac:chgData name="Papaioannou, Ioannis" userId="27d0d6e0-1133-45d1-b366-9071ba1a55b0" providerId="ADAL" clId="{AE32242B-AB1C-496F-9B1A-20E25321956D}" dt="2023-07-16T11:57:17.306" v="390" actId="1076"/>
          <ac:picMkLst>
            <pc:docMk/>
            <pc:sldMk cId="2731541974" sldId="258"/>
            <ac:picMk id="5" creationId="{918CCB07-2FBD-D1F9-24D2-49EA0AC7821A}"/>
          </ac:picMkLst>
        </pc:picChg>
        <pc:cxnChg chg="add mod">
          <ac:chgData name="Papaioannou, Ioannis" userId="27d0d6e0-1133-45d1-b366-9071ba1a55b0" providerId="ADAL" clId="{AE32242B-AB1C-496F-9B1A-20E25321956D}" dt="2023-07-16T11:54:36.192" v="256" actId="13822"/>
          <ac:cxnSpMkLst>
            <pc:docMk/>
            <pc:sldMk cId="2731541974" sldId="258"/>
            <ac:cxnSpMk id="10" creationId="{101BF665-1556-9861-45E6-5EE8504304FF}"/>
          </ac:cxnSpMkLst>
        </pc:cxnChg>
      </pc:sldChg>
      <pc:sldChg chg="addSp delSp modSp mod">
        <pc:chgData name="Papaioannou, Ioannis" userId="27d0d6e0-1133-45d1-b366-9071ba1a55b0" providerId="ADAL" clId="{AE32242B-AB1C-496F-9B1A-20E25321956D}" dt="2023-07-16T12:51:22.582" v="735" actId="20577"/>
        <pc:sldMkLst>
          <pc:docMk/>
          <pc:sldMk cId="905110383" sldId="259"/>
        </pc:sldMkLst>
        <pc:spChg chg="add mod">
          <ac:chgData name="Papaioannou, Ioannis" userId="27d0d6e0-1133-45d1-b366-9071ba1a55b0" providerId="ADAL" clId="{AE32242B-AB1C-496F-9B1A-20E25321956D}" dt="2023-07-16T12:51:22.582" v="735" actId="20577"/>
          <ac:spMkLst>
            <pc:docMk/>
            <pc:sldMk cId="905110383" sldId="259"/>
            <ac:spMk id="3" creationId="{0C2155DD-7AD9-ABA6-D376-3DAFB90C3306}"/>
          </ac:spMkLst>
        </pc:spChg>
        <pc:spChg chg="add mod">
          <ac:chgData name="Papaioannou, Ioannis" userId="27d0d6e0-1133-45d1-b366-9071ba1a55b0" providerId="ADAL" clId="{AE32242B-AB1C-496F-9B1A-20E25321956D}" dt="2023-07-16T12:47:10.870" v="690" actId="20577"/>
          <ac:spMkLst>
            <pc:docMk/>
            <pc:sldMk cId="905110383" sldId="259"/>
            <ac:spMk id="4" creationId="{58F8AE33-ECA7-5429-C641-FC4A12F890EC}"/>
          </ac:spMkLst>
        </pc:spChg>
        <pc:spChg chg="add mod">
          <ac:chgData name="Papaioannou, Ioannis" userId="27d0d6e0-1133-45d1-b366-9071ba1a55b0" providerId="ADAL" clId="{AE32242B-AB1C-496F-9B1A-20E25321956D}" dt="2023-07-16T11:46:53.540" v="188" actId="1035"/>
          <ac:spMkLst>
            <pc:docMk/>
            <pc:sldMk cId="905110383" sldId="259"/>
            <ac:spMk id="8" creationId="{1824169E-362F-A4FE-43A9-27DB685FED10}"/>
          </ac:spMkLst>
        </pc:spChg>
        <pc:spChg chg="add mod">
          <ac:chgData name="Papaioannou, Ioannis" userId="27d0d6e0-1133-45d1-b366-9071ba1a55b0" providerId="ADAL" clId="{AE32242B-AB1C-496F-9B1A-20E25321956D}" dt="2023-07-16T12:49:44.772" v="712" actId="1036"/>
          <ac:spMkLst>
            <pc:docMk/>
            <pc:sldMk cId="905110383" sldId="259"/>
            <ac:spMk id="12" creationId="{AB480954-94FF-681D-F7AB-D4A1ACAAB225}"/>
          </ac:spMkLst>
        </pc:spChg>
        <pc:spChg chg="add mod">
          <ac:chgData name="Papaioannou, Ioannis" userId="27d0d6e0-1133-45d1-b366-9071ba1a55b0" providerId="ADAL" clId="{AE32242B-AB1C-496F-9B1A-20E25321956D}" dt="2023-07-16T11:48:19.210" v="213" actId="1038"/>
          <ac:spMkLst>
            <pc:docMk/>
            <pc:sldMk cId="905110383" sldId="259"/>
            <ac:spMk id="13" creationId="{06680A63-C083-BDC3-7C89-4092E2B0A8F0}"/>
          </ac:spMkLst>
        </pc:spChg>
        <pc:spChg chg="add del mod">
          <ac:chgData name="Papaioannou, Ioannis" userId="27d0d6e0-1133-45d1-b366-9071ba1a55b0" providerId="ADAL" clId="{AE32242B-AB1C-496F-9B1A-20E25321956D}" dt="2023-07-16T11:48:05.628" v="198" actId="478"/>
          <ac:spMkLst>
            <pc:docMk/>
            <pc:sldMk cId="905110383" sldId="259"/>
            <ac:spMk id="14" creationId="{1E18B24F-9240-B464-9EA9-84DC71BB3374}"/>
          </ac:spMkLst>
        </pc:spChg>
        <pc:spChg chg="mod">
          <ac:chgData name="Papaioannou, Ioannis" userId="27d0d6e0-1133-45d1-b366-9071ba1a55b0" providerId="ADAL" clId="{AE32242B-AB1C-496F-9B1A-20E25321956D}" dt="2023-07-16T11:48:32.152" v="215" actId="1076"/>
          <ac:spMkLst>
            <pc:docMk/>
            <pc:sldMk cId="905110383" sldId="259"/>
            <ac:spMk id="16" creationId="{0E1BF01B-A8F0-241B-EF34-8B75213E34C1}"/>
          </ac:spMkLst>
        </pc:spChg>
        <pc:spChg chg="add del mod">
          <ac:chgData name="Papaioannou, Ioannis" userId="27d0d6e0-1133-45d1-b366-9071ba1a55b0" providerId="ADAL" clId="{AE32242B-AB1C-496F-9B1A-20E25321956D}" dt="2023-07-16T11:48:05.628" v="198" actId="478"/>
          <ac:spMkLst>
            <pc:docMk/>
            <pc:sldMk cId="905110383" sldId="259"/>
            <ac:spMk id="19" creationId="{3A69A998-1618-C56E-E06D-D15707D548AE}"/>
          </ac:spMkLst>
        </pc:spChg>
        <pc:spChg chg="add mod">
          <ac:chgData name="Papaioannou, Ioannis" userId="27d0d6e0-1133-45d1-b366-9071ba1a55b0" providerId="ADAL" clId="{AE32242B-AB1C-496F-9B1A-20E25321956D}" dt="2023-07-16T12:48:58.437" v="709" actId="20577"/>
          <ac:spMkLst>
            <pc:docMk/>
            <pc:sldMk cId="905110383" sldId="259"/>
            <ac:spMk id="20" creationId="{149CD344-022E-24D0-7219-C7D1F16DF709}"/>
          </ac:spMkLst>
        </pc:spChg>
        <pc:spChg chg="add mod">
          <ac:chgData name="Papaioannou, Ioannis" userId="27d0d6e0-1133-45d1-b366-9071ba1a55b0" providerId="ADAL" clId="{AE32242B-AB1C-496F-9B1A-20E25321956D}" dt="2023-07-16T12:47:31.078" v="706" actId="1036"/>
          <ac:spMkLst>
            <pc:docMk/>
            <pc:sldMk cId="905110383" sldId="259"/>
            <ac:spMk id="23" creationId="{CD599E63-5E7F-CA3C-4528-BB80371FF57C}"/>
          </ac:spMkLst>
        </pc:spChg>
        <pc:spChg chg="add mod">
          <ac:chgData name="Papaioannou, Ioannis" userId="27d0d6e0-1133-45d1-b366-9071ba1a55b0" providerId="ADAL" clId="{AE32242B-AB1C-496F-9B1A-20E25321956D}" dt="2023-07-16T11:56:24.504" v="383" actId="1035"/>
          <ac:spMkLst>
            <pc:docMk/>
            <pc:sldMk cId="905110383" sldId="259"/>
            <ac:spMk id="25" creationId="{52E3F97E-9698-CCD4-0CAC-C1113ABB25AB}"/>
          </ac:spMkLst>
        </pc:spChg>
        <pc:spChg chg="add mod">
          <ac:chgData name="Papaioannou, Ioannis" userId="27d0d6e0-1133-45d1-b366-9071ba1a55b0" providerId="ADAL" clId="{AE32242B-AB1C-496F-9B1A-20E25321956D}" dt="2023-07-16T11:56:24.504" v="383" actId="1035"/>
          <ac:spMkLst>
            <pc:docMk/>
            <pc:sldMk cId="905110383" sldId="259"/>
            <ac:spMk id="26" creationId="{353E1F13-F346-5C1B-C23B-397D0EA25D3B}"/>
          </ac:spMkLst>
        </pc:spChg>
        <pc:spChg chg="add mod">
          <ac:chgData name="Papaioannou, Ioannis" userId="27d0d6e0-1133-45d1-b366-9071ba1a55b0" providerId="ADAL" clId="{AE32242B-AB1C-496F-9B1A-20E25321956D}" dt="2023-07-16T12:49:48.431" v="714" actId="1036"/>
          <ac:spMkLst>
            <pc:docMk/>
            <pc:sldMk cId="905110383" sldId="259"/>
            <ac:spMk id="30" creationId="{4B9B8998-970E-1A0E-65B2-FE6D15D12859}"/>
          </ac:spMkLst>
        </pc:spChg>
        <pc:spChg chg="add mod">
          <ac:chgData name="Papaioannou, Ioannis" userId="27d0d6e0-1133-45d1-b366-9071ba1a55b0" providerId="ADAL" clId="{AE32242B-AB1C-496F-9B1A-20E25321956D}" dt="2023-07-16T12:49:23.007" v="710" actId="571"/>
          <ac:spMkLst>
            <pc:docMk/>
            <pc:sldMk cId="905110383" sldId="259"/>
            <ac:spMk id="31" creationId="{3D42C36D-E187-27AE-024E-314C55D396B6}"/>
          </ac:spMkLst>
        </pc:spChg>
      </pc:sldChg>
      <pc:sldChg chg="addSp modSp mod">
        <pc:chgData name="Papaioannou, Ioannis" userId="27d0d6e0-1133-45d1-b366-9071ba1a55b0" providerId="ADAL" clId="{AE32242B-AB1C-496F-9B1A-20E25321956D}" dt="2023-07-16T12:37:11.469" v="583" actId="1076"/>
        <pc:sldMkLst>
          <pc:docMk/>
          <pc:sldMk cId="1022482673" sldId="261"/>
        </pc:sldMkLst>
        <pc:spChg chg="mod">
          <ac:chgData name="Papaioannou, Ioannis" userId="27d0d6e0-1133-45d1-b366-9071ba1a55b0" providerId="ADAL" clId="{AE32242B-AB1C-496F-9B1A-20E25321956D}" dt="2023-07-16T12:30:21.008" v="404" actId="1076"/>
          <ac:spMkLst>
            <pc:docMk/>
            <pc:sldMk cId="1022482673" sldId="261"/>
            <ac:spMk id="2" creationId="{542C09B3-CEEE-27AC-EE4E-A362202369B9}"/>
          </ac:spMkLst>
        </pc:spChg>
        <pc:spChg chg="add mod">
          <ac:chgData name="Papaioannou, Ioannis" userId="27d0d6e0-1133-45d1-b366-9071ba1a55b0" providerId="ADAL" clId="{AE32242B-AB1C-496F-9B1A-20E25321956D}" dt="2023-07-16T12:32:39.138" v="447" actId="20577"/>
          <ac:spMkLst>
            <pc:docMk/>
            <pc:sldMk cId="1022482673" sldId="261"/>
            <ac:spMk id="4" creationId="{4C8B551D-045E-BF60-1C3E-2DD9C6263823}"/>
          </ac:spMkLst>
        </pc:spChg>
        <pc:spChg chg="add mod">
          <ac:chgData name="Papaioannou, Ioannis" userId="27d0d6e0-1133-45d1-b366-9071ba1a55b0" providerId="ADAL" clId="{AE32242B-AB1C-496F-9B1A-20E25321956D}" dt="2023-07-16T12:32:36.896" v="445" actId="20577"/>
          <ac:spMkLst>
            <pc:docMk/>
            <pc:sldMk cId="1022482673" sldId="261"/>
            <ac:spMk id="5" creationId="{81E519C6-1A0D-A13D-3759-E5E690024443}"/>
          </ac:spMkLst>
        </pc:spChg>
        <pc:spChg chg="add mod">
          <ac:chgData name="Papaioannou, Ioannis" userId="27d0d6e0-1133-45d1-b366-9071ba1a55b0" providerId="ADAL" clId="{AE32242B-AB1C-496F-9B1A-20E25321956D}" dt="2023-07-16T12:30:40.178" v="407" actId="571"/>
          <ac:spMkLst>
            <pc:docMk/>
            <pc:sldMk cId="1022482673" sldId="261"/>
            <ac:spMk id="6" creationId="{20953A7F-AB3D-AD98-1409-9B37B0A2C877}"/>
          </ac:spMkLst>
        </pc:spChg>
        <pc:spChg chg="add mod">
          <ac:chgData name="Papaioannou, Ioannis" userId="27d0d6e0-1133-45d1-b366-9071ba1a55b0" providerId="ADAL" clId="{AE32242B-AB1C-496F-9B1A-20E25321956D}" dt="2023-07-16T12:30:40.178" v="407" actId="571"/>
          <ac:spMkLst>
            <pc:docMk/>
            <pc:sldMk cId="1022482673" sldId="261"/>
            <ac:spMk id="7" creationId="{D16081AE-B3E8-2EF1-7F07-4F4AF82B7D11}"/>
          </ac:spMkLst>
        </pc:spChg>
        <pc:spChg chg="add mod">
          <ac:chgData name="Papaioannou, Ioannis" userId="27d0d6e0-1133-45d1-b366-9071ba1a55b0" providerId="ADAL" clId="{AE32242B-AB1C-496F-9B1A-20E25321956D}" dt="2023-07-16T12:32:30.256" v="443" actId="20577"/>
          <ac:spMkLst>
            <pc:docMk/>
            <pc:sldMk cId="1022482673" sldId="261"/>
            <ac:spMk id="9" creationId="{4FC5FEA3-70A5-8611-B8AE-F575B44765E3}"/>
          </ac:spMkLst>
        </pc:spChg>
        <pc:spChg chg="add mod">
          <ac:chgData name="Papaioannou, Ioannis" userId="27d0d6e0-1133-45d1-b366-9071ba1a55b0" providerId="ADAL" clId="{AE32242B-AB1C-496F-9B1A-20E25321956D}" dt="2023-07-16T12:32:25.937" v="441" actId="20577"/>
          <ac:spMkLst>
            <pc:docMk/>
            <pc:sldMk cId="1022482673" sldId="261"/>
            <ac:spMk id="11" creationId="{AEBEB3FD-DA1C-33FA-DEAC-1D3F8A03EB7D}"/>
          </ac:spMkLst>
        </pc:spChg>
        <pc:spChg chg="mod">
          <ac:chgData name="Papaioannou, Ioannis" userId="27d0d6e0-1133-45d1-b366-9071ba1a55b0" providerId="ADAL" clId="{AE32242B-AB1C-496F-9B1A-20E25321956D}" dt="2023-07-16T12:30:21.008" v="404" actId="1076"/>
          <ac:spMkLst>
            <pc:docMk/>
            <pc:sldMk cId="1022482673" sldId="261"/>
            <ac:spMk id="12" creationId="{8AAE4A41-7235-59AA-E902-49C3C731FD97}"/>
          </ac:spMkLst>
        </pc:spChg>
        <pc:spChg chg="add mod">
          <ac:chgData name="Papaioannou, Ioannis" userId="27d0d6e0-1133-45d1-b366-9071ba1a55b0" providerId="ADAL" clId="{AE32242B-AB1C-496F-9B1A-20E25321956D}" dt="2023-07-16T12:32:14.347" v="434" actId="1036"/>
          <ac:spMkLst>
            <pc:docMk/>
            <pc:sldMk cId="1022482673" sldId="261"/>
            <ac:spMk id="15" creationId="{3E88507C-4281-EEDE-494E-80DC17D18A47}"/>
          </ac:spMkLst>
        </pc:spChg>
        <pc:spChg chg="mod">
          <ac:chgData name="Papaioannou, Ioannis" userId="27d0d6e0-1133-45d1-b366-9071ba1a55b0" providerId="ADAL" clId="{AE32242B-AB1C-496F-9B1A-20E25321956D}" dt="2023-07-16T12:31:24.229" v="425" actId="1038"/>
          <ac:spMkLst>
            <pc:docMk/>
            <pc:sldMk cId="1022482673" sldId="261"/>
            <ac:spMk id="16" creationId="{438F2016-A450-60DC-6554-C60B924EC593}"/>
          </ac:spMkLst>
        </pc:spChg>
        <pc:spChg chg="mod">
          <ac:chgData name="Papaioannou, Ioannis" userId="27d0d6e0-1133-45d1-b366-9071ba1a55b0" providerId="ADAL" clId="{AE32242B-AB1C-496F-9B1A-20E25321956D}" dt="2023-07-16T12:31:24.229" v="425" actId="1038"/>
          <ac:spMkLst>
            <pc:docMk/>
            <pc:sldMk cId="1022482673" sldId="261"/>
            <ac:spMk id="17" creationId="{FACEF8B2-68B2-CC5E-1076-5F8565DC8BD5}"/>
          </ac:spMkLst>
        </pc:spChg>
        <pc:spChg chg="add mod">
          <ac:chgData name="Papaioannou, Ioannis" userId="27d0d6e0-1133-45d1-b366-9071ba1a55b0" providerId="ADAL" clId="{AE32242B-AB1C-496F-9B1A-20E25321956D}" dt="2023-07-16T12:37:11.469" v="583" actId="1076"/>
          <ac:spMkLst>
            <pc:docMk/>
            <pc:sldMk cId="1022482673" sldId="261"/>
            <ac:spMk id="18" creationId="{6788266F-7076-5A71-392C-8ED545B807BA}"/>
          </ac:spMkLst>
        </pc:spChg>
        <pc:grpChg chg="mod">
          <ac:chgData name="Papaioannou, Ioannis" userId="27d0d6e0-1133-45d1-b366-9071ba1a55b0" providerId="ADAL" clId="{AE32242B-AB1C-496F-9B1A-20E25321956D}" dt="2023-07-16T12:30:21.008" v="404" actId="1076"/>
          <ac:grpSpMkLst>
            <pc:docMk/>
            <pc:sldMk cId="1022482673" sldId="261"/>
            <ac:grpSpMk id="13" creationId="{8F2A8952-A4EA-26BB-E650-B9E9E6A9F7B2}"/>
          </ac:grpSpMkLst>
        </pc:grpChg>
        <pc:picChg chg="mod">
          <ac:chgData name="Papaioannou, Ioannis" userId="27d0d6e0-1133-45d1-b366-9071ba1a55b0" providerId="ADAL" clId="{AE32242B-AB1C-496F-9B1A-20E25321956D}" dt="2023-07-16T12:30:21.008" v="404" actId="1076"/>
          <ac:picMkLst>
            <pc:docMk/>
            <pc:sldMk cId="1022482673" sldId="261"/>
            <ac:picMk id="8" creationId="{439F1EB9-1683-6C28-2EB0-BAEE4A6FDA2A}"/>
          </ac:picMkLst>
        </pc:picChg>
        <pc:picChg chg="mod">
          <ac:chgData name="Papaioannou, Ioannis" userId="27d0d6e0-1133-45d1-b366-9071ba1a55b0" providerId="ADAL" clId="{AE32242B-AB1C-496F-9B1A-20E25321956D}" dt="2023-07-16T12:31:24.229" v="425" actId="1038"/>
          <ac:picMkLst>
            <pc:docMk/>
            <pc:sldMk cId="1022482673" sldId="261"/>
            <ac:picMk id="14" creationId="{D0D0BF71-9037-DC8B-1481-26F9C896D48C}"/>
          </ac:picMkLst>
        </pc:picChg>
      </pc:sldChg>
      <pc:sldChg chg="addSp modSp mod">
        <pc:chgData name="Papaioannou, Ioannis" userId="27d0d6e0-1133-45d1-b366-9071ba1a55b0" providerId="ADAL" clId="{AE32242B-AB1C-496F-9B1A-20E25321956D}" dt="2023-07-16T21:40:20.499" v="747" actId="20577"/>
        <pc:sldMkLst>
          <pc:docMk/>
          <pc:sldMk cId="1934854818" sldId="262"/>
        </pc:sldMkLst>
        <pc:spChg chg="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2" creationId="{58012A5E-C80D-E6F4-5D46-9A4B72A10E52}"/>
          </ac:spMkLst>
        </pc:spChg>
        <pc:spChg chg="add 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7" creationId="{6CFA864F-00E5-9B5E-6F26-9C4134E770FE}"/>
          </ac:spMkLst>
        </pc:spChg>
        <pc:spChg chg="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8" creationId="{4AB30319-4E42-5D64-D14E-3002682463E3}"/>
          </ac:spMkLst>
        </pc:spChg>
        <pc:spChg chg="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9" creationId="{890D0D29-632E-01B5-A151-B1BAA3047027}"/>
          </ac:spMkLst>
        </pc:spChg>
        <pc:spChg chg="mod">
          <ac:chgData name="Papaioannou, Ioannis" userId="27d0d6e0-1133-45d1-b366-9071ba1a55b0" providerId="ADAL" clId="{AE32242B-AB1C-496F-9B1A-20E25321956D}" dt="2023-07-16T21:40:20.499" v="747" actId="20577"/>
          <ac:spMkLst>
            <pc:docMk/>
            <pc:sldMk cId="1934854818" sldId="262"/>
            <ac:spMk id="10" creationId="{3C16DB6D-2F93-6176-465F-9A95D192B8D8}"/>
          </ac:spMkLst>
        </pc:spChg>
        <pc:spChg chg="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11" creationId="{38E85E57-708A-8E9F-D247-27B0EA128805}"/>
          </ac:spMkLst>
        </pc:spChg>
        <pc:spChg chg="mod">
          <ac:chgData name="Papaioannou, Ioannis" userId="27d0d6e0-1133-45d1-b366-9071ba1a55b0" providerId="ADAL" clId="{AE32242B-AB1C-496F-9B1A-20E25321956D}" dt="2023-07-16T12:34:20.565" v="476" actId="1037"/>
          <ac:spMkLst>
            <pc:docMk/>
            <pc:sldMk cId="1934854818" sldId="262"/>
            <ac:spMk id="15" creationId="{7F18ABF3-450E-F50A-8F29-540B2862B5AB}"/>
          </ac:spMkLst>
        </pc:spChg>
        <pc:spChg chg="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16" creationId="{1AFEF2B2-0575-8118-5275-53A9303FEDDD}"/>
          </ac:spMkLst>
        </pc:spChg>
        <pc:spChg chg="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17" creationId="{F1D5FEE7-E2AF-D8CB-7011-801EF7147C3C}"/>
          </ac:spMkLst>
        </pc:spChg>
        <pc:spChg chg="mod">
          <ac:chgData name="Papaioannou, Ioannis" userId="27d0d6e0-1133-45d1-b366-9071ba1a55b0" providerId="ADAL" clId="{AE32242B-AB1C-496F-9B1A-20E25321956D}" dt="2023-07-16T12:34:20.565" v="476" actId="1037"/>
          <ac:spMkLst>
            <pc:docMk/>
            <pc:sldMk cId="1934854818" sldId="262"/>
            <ac:spMk id="18" creationId="{8F3A9F86-B694-FA5A-21CA-4315EE2B5B37}"/>
          </ac:spMkLst>
        </pc:spChg>
        <pc:spChg chg="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19" creationId="{A1151C06-37F6-F6CF-5771-A39177D8A989}"/>
          </ac:spMkLst>
        </pc:spChg>
        <pc:spChg chg="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20" creationId="{DBFB03F8-1828-A3A9-774C-6CD0B028C830}"/>
          </ac:spMkLst>
        </pc:spChg>
        <pc:spChg chg="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21" creationId="{7B99ACD6-9F6A-5CA7-A0B5-EB50CBA71783}"/>
          </ac:spMkLst>
        </pc:spChg>
        <pc:spChg chg="add 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22" creationId="{DDF32692-198B-8E5A-45BA-4236CC7D6E51}"/>
          </ac:spMkLst>
        </pc:spChg>
        <pc:spChg chg="add 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23" creationId="{9706F11F-BFEF-296E-E127-67FC30948410}"/>
          </ac:spMkLst>
        </pc:spChg>
        <pc:spChg chg="add 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24" creationId="{53859E71-4C8A-0838-25F8-60711A94D5EA}"/>
          </ac:spMkLst>
        </pc:spChg>
        <pc:spChg chg="add mod">
          <ac:chgData name="Papaioannou, Ioannis" userId="27d0d6e0-1133-45d1-b366-9071ba1a55b0" providerId="ADAL" clId="{AE32242B-AB1C-496F-9B1A-20E25321956D}" dt="2023-07-16T12:34:00.929" v="459" actId="571"/>
          <ac:spMkLst>
            <pc:docMk/>
            <pc:sldMk cId="1934854818" sldId="262"/>
            <ac:spMk id="26" creationId="{08686403-DB9E-4EFA-7D90-4457076FB223}"/>
          </ac:spMkLst>
        </pc:spChg>
        <pc:spChg chg="add mod">
          <ac:chgData name="Papaioannou, Ioannis" userId="27d0d6e0-1133-45d1-b366-9071ba1a55b0" providerId="ADAL" clId="{AE32242B-AB1C-496F-9B1A-20E25321956D}" dt="2023-07-16T12:34:15.890" v="469" actId="1037"/>
          <ac:spMkLst>
            <pc:docMk/>
            <pc:sldMk cId="1934854818" sldId="262"/>
            <ac:spMk id="27" creationId="{3C556FE6-23FF-436D-6A09-FB025EDA35A5}"/>
          </ac:spMkLst>
        </pc:spChg>
        <pc:spChg chg="add mod">
          <ac:chgData name="Papaioannou, Ioannis" userId="27d0d6e0-1133-45d1-b366-9071ba1a55b0" providerId="ADAL" clId="{AE32242B-AB1C-496F-9B1A-20E25321956D}" dt="2023-07-16T12:36:29.209" v="581" actId="14100"/>
          <ac:spMkLst>
            <pc:docMk/>
            <pc:sldMk cId="1934854818" sldId="262"/>
            <ac:spMk id="30" creationId="{4DD068D1-B8AC-42C7-4B05-404CEE149024}"/>
          </ac:spMkLst>
        </pc:spChg>
        <pc:picChg chg="mod">
          <ac:chgData name="Papaioannou, Ioannis" userId="27d0d6e0-1133-45d1-b366-9071ba1a55b0" providerId="ADAL" clId="{AE32242B-AB1C-496F-9B1A-20E25321956D}" dt="2023-07-16T12:34:15.890" v="469" actId="1037"/>
          <ac:picMkLst>
            <pc:docMk/>
            <pc:sldMk cId="1934854818" sldId="262"/>
            <ac:picMk id="4" creationId="{EFB21EEC-04FE-E1E5-C0CD-7B593D9FC7B9}"/>
          </ac:picMkLst>
        </pc:picChg>
        <pc:picChg chg="mod">
          <ac:chgData name="Papaioannou, Ioannis" userId="27d0d6e0-1133-45d1-b366-9071ba1a55b0" providerId="ADAL" clId="{AE32242B-AB1C-496F-9B1A-20E25321956D}" dt="2023-07-16T12:34:15.890" v="469" actId="1037"/>
          <ac:picMkLst>
            <pc:docMk/>
            <pc:sldMk cId="1934854818" sldId="262"/>
            <ac:picMk id="5" creationId="{E8209F31-4F50-6FCC-600A-481C7AF930DA}"/>
          </ac:picMkLst>
        </pc:picChg>
        <pc:picChg chg="mod">
          <ac:chgData name="Papaioannou, Ioannis" userId="27d0d6e0-1133-45d1-b366-9071ba1a55b0" providerId="ADAL" clId="{AE32242B-AB1C-496F-9B1A-20E25321956D}" dt="2023-07-16T12:34:15.890" v="469" actId="1037"/>
          <ac:picMkLst>
            <pc:docMk/>
            <pc:sldMk cId="1934854818" sldId="262"/>
            <ac:picMk id="6" creationId="{C62F8E07-7152-E5A5-778A-674A9AFDDF88}"/>
          </ac:picMkLst>
        </pc:picChg>
        <pc:picChg chg="mod">
          <ac:chgData name="Papaioannou, Ioannis" userId="27d0d6e0-1133-45d1-b366-9071ba1a55b0" providerId="ADAL" clId="{AE32242B-AB1C-496F-9B1A-20E25321956D}" dt="2023-07-16T12:34:20.565" v="476" actId="1037"/>
          <ac:picMkLst>
            <pc:docMk/>
            <pc:sldMk cId="1934854818" sldId="262"/>
            <ac:picMk id="12" creationId="{B5F3576A-1F77-3D86-8002-57D10833F531}"/>
          </ac:picMkLst>
        </pc:picChg>
        <pc:picChg chg="mod">
          <ac:chgData name="Papaioannou, Ioannis" userId="27d0d6e0-1133-45d1-b366-9071ba1a55b0" providerId="ADAL" clId="{AE32242B-AB1C-496F-9B1A-20E25321956D}" dt="2023-07-16T12:34:15.890" v="469" actId="1037"/>
          <ac:picMkLst>
            <pc:docMk/>
            <pc:sldMk cId="1934854818" sldId="262"/>
            <ac:picMk id="13" creationId="{E3A3B174-E4C8-F26C-EB4D-804563F9567F}"/>
          </ac:picMkLst>
        </pc:picChg>
        <pc:picChg chg="mod">
          <ac:chgData name="Papaioannou, Ioannis" userId="27d0d6e0-1133-45d1-b366-9071ba1a55b0" providerId="ADAL" clId="{AE32242B-AB1C-496F-9B1A-20E25321956D}" dt="2023-07-16T12:34:15.890" v="469" actId="1037"/>
          <ac:picMkLst>
            <pc:docMk/>
            <pc:sldMk cId="1934854818" sldId="262"/>
            <ac:picMk id="14" creationId="{25E58EBA-8944-5FA6-ABFC-9B19EE1AEBC7}"/>
          </ac:picMkLst>
        </pc:picChg>
        <pc:picChg chg="add mod">
          <ac:chgData name="Papaioannou, Ioannis" userId="27d0d6e0-1133-45d1-b366-9071ba1a55b0" providerId="ADAL" clId="{AE32242B-AB1C-496F-9B1A-20E25321956D}" dt="2023-07-16T12:34:00.929" v="459" actId="571"/>
          <ac:picMkLst>
            <pc:docMk/>
            <pc:sldMk cId="1934854818" sldId="262"/>
            <ac:picMk id="25" creationId="{777C7EC2-3CEA-B4B6-7224-AAF939168391}"/>
          </ac:picMkLst>
        </pc:picChg>
        <pc:cxnChg chg="add mod">
          <ac:chgData name="Papaioannou, Ioannis" userId="27d0d6e0-1133-45d1-b366-9071ba1a55b0" providerId="ADAL" clId="{AE32242B-AB1C-496F-9B1A-20E25321956D}" dt="2023-07-16T12:35:04.375" v="479" actId="693"/>
          <ac:cxnSpMkLst>
            <pc:docMk/>
            <pc:sldMk cId="1934854818" sldId="262"/>
            <ac:cxnSpMk id="29" creationId="{AC518064-A65C-2D84-9CEB-855261F8F866}"/>
          </ac:cxnSpMkLst>
        </pc:cxnChg>
      </pc:sldChg>
      <pc:sldChg chg="addSp modSp mod ord">
        <pc:chgData name="Papaioannou, Ioannis" userId="27d0d6e0-1133-45d1-b366-9071ba1a55b0" providerId="ADAL" clId="{AE32242B-AB1C-496F-9B1A-20E25321956D}" dt="2023-07-16T21:40:34.738" v="749"/>
        <pc:sldMkLst>
          <pc:docMk/>
          <pc:sldMk cId="1358340535" sldId="263"/>
        </pc:sldMkLst>
        <pc:spChg chg="add mod">
          <ac:chgData name="Papaioannou, Ioannis" userId="27d0d6e0-1133-45d1-b366-9071ba1a55b0" providerId="ADAL" clId="{AE32242B-AB1C-496F-9B1A-20E25321956D}" dt="2023-07-16T12:37:50.760" v="587" actId="1076"/>
          <ac:spMkLst>
            <pc:docMk/>
            <pc:sldMk cId="1358340535" sldId="263"/>
            <ac:spMk id="3" creationId="{6C49AA6C-72D5-809D-013C-C0012325D236}"/>
          </ac:spMkLst>
        </pc:spChg>
        <pc:spChg chg="add mod">
          <ac:chgData name="Papaioannou, Ioannis" userId="27d0d6e0-1133-45d1-b366-9071ba1a55b0" providerId="ADAL" clId="{AE32242B-AB1C-496F-9B1A-20E25321956D}" dt="2023-07-16T12:37:50.760" v="587" actId="1076"/>
          <ac:spMkLst>
            <pc:docMk/>
            <pc:sldMk cId="1358340535" sldId="263"/>
            <ac:spMk id="6" creationId="{AAE7BC3C-FA36-89A8-CEB6-C539C407F467}"/>
          </ac:spMkLst>
        </pc:spChg>
        <pc:spChg chg="add mod">
          <ac:chgData name="Papaioannou, Ioannis" userId="27d0d6e0-1133-45d1-b366-9071ba1a55b0" providerId="ADAL" clId="{AE32242B-AB1C-496F-9B1A-20E25321956D}" dt="2023-07-16T12:38:30.083" v="592" actId="20577"/>
          <ac:spMkLst>
            <pc:docMk/>
            <pc:sldMk cId="1358340535" sldId="263"/>
            <ac:spMk id="8" creationId="{E9326353-2AD2-B794-5976-B918F5BF3CE8}"/>
          </ac:spMkLst>
        </pc:spChg>
        <pc:spChg chg="add mod">
          <ac:chgData name="Papaioannou, Ioannis" userId="27d0d6e0-1133-45d1-b366-9071ba1a55b0" providerId="ADAL" clId="{AE32242B-AB1C-496F-9B1A-20E25321956D}" dt="2023-07-16T12:38:34.106" v="596" actId="20577"/>
          <ac:spMkLst>
            <pc:docMk/>
            <pc:sldMk cId="1358340535" sldId="263"/>
            <ac:spMk id="9" creationId="{AA16CA11-994B-AFC8-C85E-342481E6FC67}"/>
          </ac:spMkLst>
        </pc:spChg>
        <pc:spChg chg="mod">
          <ac:chgData name="Papaioannou, Ioannis" userId="27d0d6e0-1133-45d1-b366-9071ba1a55b0" providerId="ADAL" clId="{AE32242B-AB1C-496F-9B1A-20E25321956D}" dt="2023-07-16T21:40:15.629" v="745" actId="20577"/>
          <ac:spMkLst>
            <pc:docMk/>
            <pc:sldMk cId="1358340535" sldId="263"/>
            <ac:spMk id="10" creationId="{3C16DB6D-2F93-6176-465F-9A95D192B8D8}"/>
          </ac:spMkLst>
        </pc:spChg>
        <pc:spChg chg="add mod">
          <ac:chgData name="Papaioannou, Ioannis" userId="27d0d6e0-1133-45d1-b366-9071ba1a55b0" providerId="ADAL" clId="{AE32242B-AB1C-496F-9B1A-20E25321956D}" dt="2023-07-16T12:42:09.157" v="619" actId="20577"/>
          <ac:spMkLst>
            <pc:docMk/>
            <pc:sldMk cId="1358340535" sldId="263"/>
            <ac:spMk id="14" creationId="{D0A20ACC-4EFD-A662-76D3-0C08FA9A4D98}"/>
          </ac:spMkLst>
        </pc:spChg>
        <pc:spChg chg="add mod">
          <ac:chgData name="Papaioannou, Ioannis" userId="27d0d6e0-1133-45d1-b366-9071ba1a55b0" providerId="ADAL" clId="{AE32242B-AB1C-496F-9B1A-20E25321956D}" dt="2023-07-16T12:41:58.884" v="615" actId="1076"/>
          <ac:spMkLst>
            <pc:docMk/>
            <pc:sldMk cId="1358340535" sldId="263"/>
            <ac:spMk id="15" creationId="{ED1BDBDD-44F7-AA89-9F09-EDFA2D0BCD6F}"/>
          </ac:spMkLst>
        </pc:spChg>
        <pc:spChg chg="add mod">
          <ac:chgData name="Papaioannou, Ioannis" userId="27d0d6e0-1133-45d1-b366-9071ba1a55b0" providerId="ADAL" clId="{AE32242B-AB1C-496F-9B1A-20E25321956D}" dt="2023-07-16T12:42:02.742" v="616" actId="1076"/>
          <ac:spMkLst>
            <pc:docMk/>
            <pc:sldMk cId="1358340535" sldId="263"/>
            <ac:spMk id="16" creationId="{7BED3FF6-D479-E8FE-373A-2ED3E85CB65C}"/>
          </ac:spMkLst>
        </pc:spChg>
        <pc:spChg chg="add mod">
          <ac:chgData name="Papaioannou, Ioannis" userId="27d0d6e0-1133-45d1-b366-9071ba1a55b0" providerId="ADAL" clId="{AE32242B-AB1C-496F-9B1A-20E25321956D}" dt="2023-07-16T12:42:13.647" v="621" actId="20577"/>
          <ac:spMkLst>
            <pc:docMk/>
            <pc:sldMk cId="1358340535" sldId="263"/>
            <ac:spMk id="17" creationId="{3D78C35C-B803-B04B-277D-4F4401FA0895}"/>
          </ac:spMkLst>
        </pc:spChg>
        <pc:spChg chg="add mod">
          <ac:chgData name="Papaioannou, Ioannis" userId="27d0d6e0-1133-45d1-b366-9071ba1a55b0" providerId="ADAL" clId="{AE32242B-AB1C-496F-9B1A-20E25321956D}" dt="2023-07-16T12:42:24.002" v="622" actId="571"/>
          <ac:spMkLst>
            <pc:docMk/>
            <pc:sldMk cId="1358340535" sldId="263"/>
            <ac:spMk id="19" creationId="{4A8886BA-C104-C0BA-111A-331DFA51B03E}"/>
          </ac:spMkLst>
        </pc:spChg>
        <pc:spChg chg="mod">
          <ac:chgData name="Papaioannou, Ioannis" userId="27d0d6e0-1133-45d1-b366-9071ba1a55b0" providerId="ADAL" clId="{AE32242B-AB1C-496F-9B1A-20E25321956D}" dt="2023-07-16T12:37:53.776" v="588" actId="1076"/>
          <ac:spMkLst>
            <pc:docMk/>
            <pc:sldMk cId="1358340535" sldId="263"/>
            <ac:spMk id="21" creationId="{FFBD5BD0-F438-8637-5D25-B3A17BB2B552}"/>
          </ac:spMkLst>
        </pc:spChg>
        <pc:picChg chg="mod">
          <ac:chgData name="Papaioannou, Ioannis" userId="27d0d6e0-1133-45d1-b366-9071ba1a55b0" providerId="ADAL" clId="{AE32242B-AB1C-496F-9B1A-20E25321956D}" dt="2023-07-16T12:37:39.118" v="586" actId="1076"/>
          <ac:picMkLst>
            <pc:docMk/>
            <pc:sldMk cId="1358340535" sldId="263"/>
            <ac:picMk id="4" creationId="{64F2952F-A7A5-B7D1-497D-BA577B44B9CE}"/>
          </ac:picMkLst>
        </pc:picChg>
      </pc:sldChg>
      <pc:sldChg chg="addSp delSp modSp mod">
        <pc:chgData name="Papaioannou, Ioannis" userId="27d0d6e0-1133-45d1-b366-9071ba1a55b0" providerId="ADAL" clId="{AE32242B-AB1C-496F-9B1A-20E25321956D}" dt="2023-07-18T10:02:51.606" v="877" actId="571"/>
        <pc:sldMkLst>
          <pc:docMk/>
          <pc:sldMk cId="1608280500" sldId="266"/>
        </pc:sldMkLst>
        <pc:spChg chg="add mod">
          <ac:chgData name="Papaioannou, Ioannis" userId="27d0d6e0-1133-45d1-b366-9071ba1a55b0" providerId="ADAL" clId="{AE32242B-AB1C-496F-9B1A-20E25321956D}" dt="2023-07-18T10:02:05.706" v="869" actId="1076"/>
          <ac:spMkLst>
            <pc:docMk/>
            <pc:sldMk cId="1608280500" sldId="266"/>
            <ac:spMk id="2" creationId="{2CFB1818-7644-9C0A-C683-FC531EAD7EAE}"/>
          </ac:spMkLst>
        </pc:spChg>
        <pc:spChg chg="mod ord">
          <ac:chgData name="Papaioannou, Ioannis" userId="27d0d6e0-1133-45d1-b366-9071ba1a55b0" providerId="ADAL" clId="{AE32242B-AB1C-496F-9B1A-20E25321956D}" dt="2023-07-18T10:02:33.856" v="875" actId="1076"/>
          <ac:spMkLst>
            <pc:docMk/>
            <pc:sldMk cId="1608280500" sldId="266"/>
            <ac:spMk id="6" creationId="{B20D95A9-82C7-499D-AC8B-02CC0BA1BF81}"/>
          </ac:spMkLst>
        </pc:spChg>
        <pc:spChg chg="mod">
          <ac:chgData name="Papaioannou, Ioannis" userId="27d0d6e0-1133-45d1-b366-9071ba1a55b0" providerId="ADAL" clId="{AE32242B-AB1C-496F-9B1A-20E25321956D}" dt="2023-07-16T11:17:24.966" v="83" actId="1076"/>
          <ac:spMkLst>
            <pc:docMk/>
            <pc:sldMk cId="1608280500" sldId="266"/>
            <ac:spMk id="7" creationId="{694FA385-8809-4F28-BB80-FD3F777537E6}"/>
          </ac:spMkLst>
        </pc:spChg>
        <pc:spChg chg="mod">
          <ac:chgData name="Papaioannou, Ioannis" userId="27d0d6e0-1133-45d1-b366-9071ba1a55b0" providerId="ADAL" clId="{AE32242B-AB1C-496F-9B1A-20E25321956D}" dt="2023-07-16T11:17:24.966" v="83" actId="1076"/>
          <ac:spMkLst>
            <pc:docMk/>
            <pc:sldMk cId="1608280500" sldId="266"/>
            <ac:spMk id="8" creationId="{915D17D3-BA1E-4384-90A6-7E93F6E62093}"/>
          </ac:spMkLst>
        </pc:spChg>
        <pc:spChg chg="mod ord">
          <ac:chgData name="Papaioannou, Ioannis" userId="27d0d6e0-1133-45d1-b366-9071ba1a55b0" providerId="ADAL" clId="{AE32242B-AB1C-496F-9B1A-20E25321956D}" dt="2023-07-18T10:02:46.050" v="876" actId="1076"/>
          <ac:spMkLst>
            <pc:docMk/>
            <pc:sldMk cId="1608280500" sldId="266"/>
            <ac:spMk id="10" creationId="{2F9EB673-84E0-4B42-9C21-0CB54FC08656}"/>
          </ac:spMkLst>
        </pc:spChg>
        <pc:spChg chg="add mod">
          <ac:chgData name="Papaioannou, Ioannis" userId="27d0d6e0-1133-45d1-b366-9071ba1a55b0" providerId="ADAL" clId="{AE32242B-AB1C-496F-9B1A-20E25321956D}" dt="2023-07-18T10:02:51.606" v="877" actId="571"/>
          <ac:spMkLst>
            <pc:docMk/>
            <pc:sldMk cId="1608280500" sldId="266"/>
            <ac:spMk id="12" creationId="{13C476EF-94E5-D06C-01F5-A9EE8F941ED4}"/>
          </ac:spMkLst>
        </pc:spChg>
        <pc:spChg chg="add mod">
          <ac:chgData name="Papaioannou, Ioannis" userId="27d0d6e0-1133-45d1-b366-9071ba1a55b0" providerId="ADAL" clId="{AE32242B-AB1C-496F-9B1A-20E25321956D}" dt="2023-07-16T12:50:26.167" v="718" actId="20577"/>
          <ac:spMkLst>
            <pc:docMk/>
            <pc:sldMk cId="1608280500" sldId="266"/>
            <ac:spMk id="14" creationId="{F950B619-8676-B61E-92D4-095840883D86}"/>
          </ac:spMkLst>
        </pc:spChg>
        <pc:spChg chg="mod">
          <ac:chgData name="Papaioannou, Ioannis" userId="27d0d6e0-1133-45d1-b366-9071ba1a55b0" providerId="ADAL" clId="{AE32242B-AB1C-496F-9B1A-20E25321956D}" dt="2023-07-18T09:57:29.854" v="853" actId="1076"/>
          <ac:spMkLst>
            <pc:docMk/>
            <pc:sldMk cId="1608280500" sldId="266"/>
            <ac:spMk id="16" creationId="{873B2975-1D40-46FD-9CE0-15354C4A95CD}"/>
          </ac:spMkLst>
        </pc:spChg>
        <pc:spChg chg="add del mod">
          <ac:chgData name="Papaioannou, Ioannis" userId="27d0d6e0-1133-45d1-b366-9071ba1a55b0" providerId="ADAL" clId="{AE32242B-AB1C-496F-9B1A-20E25321956D}" dt="2023-07-16T11:22:18.801" v="104" actId="478"/>
          <ac:spMkLst>
            <pc:docMk/>
            <pc:sldMk cId="1608280500" sldId="266"/>
            <ac:spMk id="17" creationId="{E858355E-89F6-6C76-F556-DB5684E7EA47}"/>
          </ac:spMkLst>
        </pc:spChg>
        <pc:spChg chg="add mod">
          <ac:chgData name="Papaioannou, Ioannis" userId="27d0d6e0-1133-45d1-b366-9071ba1a55b0" providerId="ADAL" clId="{AE32242B-AB1C-496F-9B1A-20E25321956D}" dt="2023-07-18T10:00:41.353" v="855" actId="1076"/>
          <ac:spMkLst>
            <pc:docMk/>
            <pc:sldMk cId="1608280500" sldId="266"/>
            <ac:spMk id="18" creationId="{D9C336D2-01B9-AFAB-CF7B-E3ADA13BF1D0}"/>
          </ac:spMkLst>
        </pc:spChg>
        <pc:spChg chg="add mod">
          <ac:chgData name="Papaioannou, Ioannis" userId="27d0d6e0-1133-45d1-b366-9071ba1a55b0" providerId="ADAL" clId="{AE32242B-AB1C-496F-9B1A-20E25321956D}" dt="2023-07-18T10:00:41.353" v="855" actId="1076"/>
          <ac:spMkLst>
            <pc:docMk/>
            <pc:sldMk cId="1608280500" sldId="266"/>
            <ac:spMk id="19" creationId="{B47F0601-0624-9F6E-271A-4312C640E840}"/>
          </ac:spMkLst>
        </pc:spChg>
        <pc:spChg chg="mod">
          <ac:chgData name="Papaioannou, Ioannis" userId="27d0d6e0-1133-45d1-b366-9071ba1a55b0" providerId="ADAL" clId="{AE32242B-AB1C-496F-9B1A-20E25321956D}" dt="2023-07-18T10:00:41.353" v="855" actId="1076"/>
          <ac:spMkLst>
            <pc:docMk/>
            <pc:sldMk cId="1608280500" sldId="266"/>
            <ac:spMk id="20" creationId="{2E415E50-721C-4D4F-A316-AA4E3231A15C}"/>
          </ac:spMkLst>
        </pc:spChg>
        <pc:spChg chg="mod">
          <ac:chgData name="Papaioannou, Ioannis" userId="27d0d6e0-1133-45d1-b366-9071ba1a55b0" providerId="ADAL" clId="{AE32242B-AB1C-496F-9B1A-20E25321956D}" dt="2023-07-18T10:00:41.353" v="855" actId="1076"/>
          <ac:spMkLst>
            <pc:docMk/>
            <pc:sldMk cId="1608280500" sldId="266"/>
            <ac:spMk id="21" creationId="{F1B33612-8254-4E53-BCB7-DE9AB2321756}"/>
          </ac:spMkLst>
        </pc:spChg>
        <pc:spChg chg="add mod">
          <ac:chgData name="Papaioannou, Ioannis" userId="27d0d6e0-1133-45d1-b366-9071ba1a55b0" providerId="ADAL" clId="{AE32242B-AB1C-496F-9B1A-20E25321956D}" dt="2023-07-16T12:50:24.238" v="717" actId="20577"/>
          <ac:spMkLst>
            <pc:docMk/>
            <pc:sldMk cId="1608280500" sldId="266"/>
            <ac:spMk id="22" creationId="{B2FE04AC-852B-421C-25BB-07238D9BE4F2}"/>
          </ac:spMkLst>
        </pc:spChg>
        <pc:spChg chg="add mod">
          <ac:chgData name="Papaioannou, Ioannis" userId="27d0d6e0-1133-45d1-b366-9071ba1a55b0" providerId="ADAL" clId="{AE32242B-AB1C-496F-9B1A-20E25321956D}" dt="2023-07-16T12:50:38.475" v="724" actId="20577"/>
          <ac:spMkLst>
            <pc:docMk/>
            <pc:sldMk cId="1608280500" sldId="266"/>
            <ac:spMk id="23" creationId="{21055158-134F-6A99-F0CA-F59C2919D7EC}"/>
          </ac:spMkLst>
        </pc:spChg>
        <pc:spChg chg="add mod">
          <ac:chgData name="Papaioannou, Ioannis" userId="27d0d6e0-1133-45d1-b366-9071ba1a55b0" providerId="ADAL" clId="{AE32242B-AB1C-496F-9B1A-20E25321956D}" dt="2023-07-16T12:50:35.362" v="723" actId="20577"/>
          <ac:spMkLst>
            <pc:docMk/>
            <pc:sldMk cId="1608280500" sldId="266"/>
            <ac:spMk id="25" creationId="{E2353119-92A1-D360-8BBE-FCCD37189266}"/>
          </ac:spMkLst>
        </pc:spChg>
        <pc:spChg chg="add mod">
          <ac:chgData name="Papaioannou, Ioannis" userId="27d0d6e0-1133-45d1-b366-9071ba1a55b0" providerId="ADAL" clId="{AE32242B-AB1C-496F-9B1A-20E25321956D}" dt="2023-07-18T09:57:29.854" v="853" actId="1076"/>
          <ac:spMkLst>
            <pc:docMk/>
            <pc:sldMk cId="1608280500" sldId="266"/>
            <ac:spMk id="27" creationId="{8975D728-983D-84AE-8C9C-6B612D0564CD}"/>
          </ac:spMkLst>
        </pc:spChg>
        <pc:spChg chg="add mod">
          <ac:chgData name="Papaioannou, Ioannis" userId="27d0d6e0-1133-45d1-b366-9071ba1a55b0" providerId="ADAL" clId="{AE32242B-AB1C-496F-9B1A-20E25321956D}" dt="2023-07-18T09:57:29.854" v="853" actId="1076"/>
          <ac:spMkLst>
            <pc:docMk/>
            <pc:sldMk cId="1608280500" sldId="266"/>
            <ac:spMk id="28" creationId="{17635A0E-AECB-0D0A-F425-E68598F80F76}"/>
          </ac:spMkLst>
        </pc:spChg>
        <pc:spChg chg="mod">
          <ac:chgData name="Papaioannou, Ioannis" userId="27d0d6e0-1133-45d1-b366-9071ba1a55b0" providerId="ADAL" clId="{AE32242B-AB1C-496F-9B1A-20E25321956D}" dt="2023-07-18T10:01:16.959" v="863" actId="1076"/>
          <ac:spMkLst>
            <pc:docMk/>
            <pc:sldMk cId="1608280500" sldId="266"/>
            <ac:spMk id="30" creationId="{EDF4327F-56E5-CA0D-6CD0-27909867DB7F}"/>
          </ac:spMkLst>
        </pc:spChg>
        <pc:spChg chg="mod">
          <ac:chgData name="Papaioannou, Ioannis" userId="27d0d6e0-1133-45d1-b366-9071ba1a55b0" providerId="ADAL" clId="{AE32242B-AB1C-496F-9B1A-20E25321956D}" dt="2023-07-18T09:57:29.854" v="853" actId="1076"/>
          <ac:spMkLst>
            <pc:docMk/>
            <pc:sldMk cId="1608280500" sldId="266"/>
            <ac:spMk id="31" creationId="{CDDC0619-31D8-4D38-870F-7830F9EF1C73}"/>
          </ac:spMkLst>
        </pc:spChg>
        <pc:spChg chg="add del mod">
          <ac:chgData name="Papaioannou, Ioannis" userId="27d0d6e0-1133-45d1-b366-9071ba1a55b0" providerId="ADAL" clId="{AE32242B-AB1C-496F-9B1A-20E25321956D}" dt="2023-07-16T11:34:13.206" v="135" actId="478"/>
          <ac:spMkLst>
            <pc:docMk/>
            <pc:sldMk cId="1608280500" sldId="266"/>
            <ac:spMk id="35" creationId="{1BFC564A-0AE5-48EC-A0EA-B5A4C4067597}"/>
          </ac:spMkLst>
        </pc:spChg>
        <pc:spChg chg="del mod">
          <ac:chgData name="Papaioannou, Ioannis" userId="27d0d6e0-1133-45d1-b366-9071ba1a55b0" providerId="ADAL" clId="{AE32242B-AB1C-496F-9B1A-20E25321956D}" dt="2023-07-16T11:34:15.803" v="136" actId="478"/>
          <ac:spMkLst>
            <pc:docMk/>
            <pc:sldMk cId="1608280500" sldId="266"/>
            <ac:spMk id="36" creationId="{07152B2A-50F8-4DE6-891C-BFD3A7673C20}"/>
          </ac:spMkLst>
        </pc:spChg>
        <pc:spChg chg="add mod">
          <ac:chgData name="Papaioannou, Ioannis" userId="27d0d6e0-1133-45d1-b366-9071ba1a55b0" providerId="ADAL" clId="{AE32242B-AB1C-496F-9B1A-20E25321956D}" dt="2023-07-18T09:57:09.408" v="850" actId="164"/>
          <ac:spMkLst>
            <pc:docMk/>
            <pc:sldMk cId="1608280500" sldId="266"/>
            <ac:spMk id="39" creationId="{BE13C9D3-04B7-53B3-4CEE-DAFCBB3339F0}"/>
          </ac:spMkLst>
        </pc:spChg>
        <pc:spChg chg="add mod">
          <ac:chgData name="Papaioannou, Ioannis" userId="27d0d6e0-1133-45d1-b366-9071ba1a55b0" providerId="ADAL" clId="{AE32242B-AB1C-496F-9B1A-20E25321956D}" dt="2023-07-16T12:50:32.192" v="721" actId="20577"/>
          <ac:spMkLst>
            <pc:docMk/>
            <pc:sldMk cId="1608280500" sldId="266"/>
            <ac:spMk id="40" creationId="{369F39FC-84E6-B54B-B230-C37882499B28}"/>
          </ac:spMkLst>
        </pc:spChg>
        <pc:spChg chg="mod">
          <ac:chgData name="Papaioannou, Ioannis" userId="27d0d6e0-1133-45d1-b366-9071ba1a55b0" providerId="ADAL" clId="{AE32242B-AB1C-496F-9B1A-20E25321956D}" dt="2023-07-16T11:17:33.957" v="84" actId="1076"/>
          <ac:spMkLst>
            <pc:docMk/>
            <pc:sldMk cId="1608280500" sldId="266"/>
            <ac:spMk id="41" creationId="{0D0BDDF1-43FD-4627-9C13-09C7E776E272}"/>
          </ac:spMkLst>
        </pc:spChg>
        <pc:spChg chg="mod">
          <ac:chgData name="Papaioannou, Ioannis" userId="27d0d6e0-1133-45d1-b366-9071ba1a55b0" providerId="ADAL" clId="{AE32242B-AB1C-496F-9B1A-20E25321956D}" dt="2023-07-16T11:17:33.957" v="84" actId="1076"/>
          <ac:spMkLst>
            <pc:docMk/>
            <pc:sldMk cId="1608280500" sldId="266"/>
            <ac:spMk id="43" creationId="{B5B34BBA-A603-4288-BBBD-1331CC5FC8CD}"/>
          </ac:spMkLst>
        </pc:spChg>
        <pc:spChg chg="mod">
          <ac:chgData name="Papaioannou, Ioannis" userId="27d0d6e0-1133-45d1-b366-9071ba1a55b0" providerId="ADAL" clId="{AE32242B-AB1C-496F-9B1A-20E25321956D}" dt="2023-07-16T11:33:50.332" v="132" actId="20577"/>
          <ac:spMkLst>
            <pc:docMk/>
            <pc:sldMk cId="1608280500" sldId="266"/>
            <ac:spMk id="44" creationId="{EEDC18CB-1974-4AD4-8E95-DD7899D51041}"/>
          </ac:spMkLst>
        </pc:spChg>
        <pc:spChg chg="mod">
          <ac:chgData name="Papaioannou, Ioannis" userId="27d0d6e0-1133-45d1-b366-9071ba1a55b0" providerId="ADAL" clId="{AE32242B-AB1C-496F-9B1A-20E25321956D}" dt="2023-07-18T09:57:09.408" v="850" actId="164"/>
          <ac:spMkLst>
            <pc:docMk/>
            <pc:sldMk cId="1608280500" sldId="266"/>
            <ac:spMk id="46" creationId="{BADB01C4-4CF4-4714-8097-E9D6936103D5}"/>
          </ac:spMkLst>
        </pc:spChg>
        <pc:spChg chg="mod">
          <ac:chgData name="Papaioannou, Ioannis" userId="27d0d6e0-1133-45d1-b366-9071ba1a55b0" providerId="ADAL" clId="{AE32242B-AB1C-496F-9B1A-20E25321956D}" dt="2023-07-18T09:57:09.408" v="850" actId="164"/>
          <ac:spMkLst>
            <pc:docMk/>
            <pc:sldMk cId="1608280500" sldId="266"/>
            <ac:spMk id="47" creationId="{F72E833C-86C3-489C-BDC9-7A152FAE814C}"/>
          </ac:spMkLst>
        </pc:spChg>
        <pc:grpChg chg="add mod">
          <ac:chgData name="Papaioannou, Ioannis" userId="27d0d6e0-1133-45d1-b366-9071ba1a55b0" providerId="ADAL" clId="{AE32242B-AB1C-496F-9B1A-20E25321956D}" dt="2023-07-18T09:57:11.385" v="851" actId="1076"/>
          <ac:grpSpMkLst>
            <pc:docMk/>
            <pc:sldMk cId="1608280500" sldId="266"/>
            <ac:grpSpMk id="4" creationId="{E67A7FD9-5196-8990-370E-A8E13657C19D}"/>
          </ac:grpSpMkLst>
        </pc:grpChg>
        <pc:grpChg chg="add mod">
          <ac:chgData name="Papaioannou, Ioannis" userId="27d0d6e0-1133-45d1-b366-9071ba1a55b0" providerId="ADAL" clId="{AE32242B-AB1C-496F-9B1A-20E25321956D}" dt="2023-07-18T09:57:29.854" v="853" actId="1076"/>
          <ac:grpSpMkLst>
            <pc:docMk/>
            <pc:sldMk cId="1608280500" sldId="266"/>
            <ac:grpSpMk id="9" creationId="{83E97E85-7B2B-08E6-3B24-DBFA2249915C}"/>
          </ac:grpSpMkLst>
        </pc:grpChg>
        <pc:picChg chg="mod">
          <ac:chgData name="Papaioannou, Ioannis" userId="27d0d6e0-1133-45d1-b366-9071ba1a55b0" providerId="ADAL" clId="{AE32242B-AB1C-496F-9B1A-20E25321956D}" dt="2023-07-16T11:17:24.966" v="83" actId="1076"/>
          <ac:picMkLst>
            <pc:docMk/>
            <pc:sldMk cId="1608280500" sldId="266"/>
            <ac:picMk id="3" creationId="{EECBE821-42A0-4D15-AEE9-5823945E5703}"/>
          </ac:picMkLst>
        </pc:picChg>
        <pc:picChg chg="mod">
          <ac:chgData name="Papaioannou, Ioannis" userId="27d0d6e0-1133-45d1-b366-9071ba1a55b0" providerId="ADAL" clId="{AE32242B-AB1C-496F-9B1A-20E25321956D}" dt="2023-07-18T10:00:41.353" v="855" actId="1076"/>
          <ac:picMkLst>
            <pc:docMk/>
            <pc:sldMk cId="1608280500" sldId="266"/>
            <ac:picMk id="32" creationId="{FAE965A1-1B85-43DE-A23E-3B0679AE1F55}"/>
          </ac:picMkLst>
        </pc:picChg>
        <pc:picChg chg="mod">
          <ac:chgData name="Papaioannou, Ioannis" userId="27d0d6e0-1133-45d1-b366-9071ba1a55b0" providerId="ADAL" clId="{AE32242B-AB1C-496F-9B1A-20E25321956D}" dt="2023-07-18T09:57:29.854" v="853" actId="1076"/>
          <ac:picMkLst>
            <pc:docMk/>
            <pc:sldMk cId="1608280500" sldId="266"/>
            <ac:picMk id="33" creationId="{B07659F6-FF64-4375-8FD6-198FB2863040}"/>
          </ac:picMkLst>
        </pc:picChg>
        <pc:picChg chg="add del mod">
          <ac:chgData name="Papaioannou, Ioannis" userId="27d0d6e0-1133-45d1-b366-9071ba1a55b0" providerId="ADAL" clId="{AE32242B-AB1C-496F-9B1A-20E25321956D}" dt="2023-07-16T11:34:13.206" v="135" actId="478"/>
          <ac:picMkLst>
            <pc:docMk/>
            <pc:sldMk cId="1608280500" sldId="266"/>
            <ac:picMk id="34" creationId="{B4972A4B-289E-433A-B86D-DA2E760A91CC}"/>
          </ac:picMkLst>
        </pc:picChg>
        <pc:picChg chg="mod">
          <ac:chgData name="Papaioannou, Ioannis" userId="27d0d6e0-1133-45d1-b366-9071ba1a55b0" providerId="ADAL" clId="{AE32242B-AB1C-496F-9B1A-20E25321956D}" dt="2023-07-16T11:30:55.781" v="113" actId="1076"/>
          <ac:picMkLst>
            <pc:docMk/>
            <pc:sldMk cId="1608280500" sldId="266"/>
            <ac:picMk id="37" creationId="{2678878C-093B-4281-8024-C437A8EADE05}"/>
          </ac:picMkLst>
        </pc:picChg>
        <pc:picChg chg="add del mod modCrop">
          <ac:chgData name="Papaioannou, Ioannis" userId="27d0d6e0-1133-45d1-b366-9071ba1a55b0" providerId="ADAL" clId="{AE32242B-AB1C-496F-9B1A-20E25321956D}" dt="2023-07-16T11:38:24.730" v="169" actId="478"/>
          <ac:picMkLst>
            <pc:docMk/>
            <pc:sldMk cId="1608280500" sldId="266"/>
            <ac:picMk id="38" creationId="{111067D0-76AB-73D0-C247-C71557FECD16}"/>
          </ac:picMkLst>
        </pc:picChg>
        <pc:picChg chg="mod">
          <ac:chgData name="Papaioannou, Ioannis" userId="27d0d6e0-1133-45d1-b366-9071ba1a55b0" providerId="ADAL" clId="{AE32242B-AB1C-496F-9B1A-20E25321956D}" dt="2023-07-16T11:17:33.957" v="84" actId="1076"/>
          <ac:picMkLst>
            <pc:docMk/>
            <pc:sldMk cId="1608280500" sldId="266"/>
            <ac:picMk id="42" creationId="{9E490237-8AF9-4A76-9CAA-AB9EB66D86D8}"/>
          </ac:picMkLst>
        </pc:picChg>
        <pc:picChg chg="mod">
          <ac:chgData name="Papaioannou, Ioannis" userId="27d0d6e0-1133-45d1-b366-9071ba1a55b0" providerId="ADAL" clId="{AE32242B-AB1C-496F-9B1A-20E25321956D}" dt="2023-07-18T09:57:09.408" v="850" actId="164"/>
          <ac:picMkLst>
            <pc:docMk/>
            <pc:sldMk cId="1608280500" sldId="266"/>
            <ac:picMk id="45" creationId="{E0312B37-C2FD-4B98-A5D7-BF52343D4EEA}"/>
          </ac:picMkLst>
        </pc:picChg>
        <pc:picChg chg="add mod">
          <ac:chgData name="Papaioannou, Ioannis" userId="27d0d6e0-1133-45d1-b366-9071ba1a55b0" providerId="ADAL" clId="{AE32242B-AB1C-496F-9B1A-20E25321956D}" dt="2023-07-18T10:02:33.856" v="875" actId="1076"/>
          <ac:picMkLst>
            <pc:docMk/>
            <pc:sldMk cId="1608280500" sldId="266"/>
            <ac:picMk id="1026" creationId="{CE65153C-EA72-4A11-400E-5F664454D3C5}"/>
          </ac:picMkLst>
        </pc:picChg>
        <pc:cxnChg chg="add del mod">
          <ac:chgData name="Papaioannou, Ioannis" userId="27d0d6e0-1133-45d1-b366-9071ba1a55b0" providerId="ADAL" clId="{AE32242B-AB1C-496F-9B1A-20E25321956D}" dt="2023-07-18T10:01:59.857" v="868" actId="478"/>
          <ac:cxnSpMkLst>
            <pc:docMk/>
            <pc:sldMk cId="1608280500" sldId="266"/>
            <ac:cxnSpMk id="5" creationId="{613688D5-112D-F1F8-25B9-EB738D2F0F15}"/>
          </ac:cxnSpMkLst>
        </pc:cxnChg>
      </pc:sldChg>
      <pc:sldChg chg="addSp delSp modSp new mod">
        <pc:chgData name="Papaioannou, Ioannis" userId="27d0d6e0-1133-45d1-b366-9071ba1a55b0" providerId="ADAL" clId="{AE32242B-AB1C-496F-9B1A-20E25321956D}" dt="2023-07-16T11:50:10.334" v="244" actId="20577"/>
        <pc:sldMkLst>
          <pc:docMk/>
          <pc:sldMk cId="4106415198" sldId="267"/>
        </pc:sldMkLst>
        <pc:spChg chg="del">
          <ac:chgData name="Papaioannou, Ioannis" userId="27d0d6e0-1133-45d1-b366-9071ba1a55b0" providerId="ADAL" clId="{AE32242B-AB1C-496F-9B1A-20E25321956D}" dt="2023-07-15T22:00:09.886" v="2" actId="478"/>
          <ac:spMkLst>
            <pc:docMk/>
            <pc:sldMk cId="4106415198" sldId="267"/>
            <ac:spMk id="2" creationId="{82418C37-1E1D-6C9A-9685-488D299EB354}"/>
          </ac:spMkLst>
        </pc:spChg>
        <pc:spChg chg="del">
          <ac:chgData name="Papaioannou, Ioannis" userId="27d0d6e0-1133-45d1-b366-9071ba1a55b0" providerId="ADAL" clId="{AE32242B-AB1C-496F-9B1A-20E25321956D}" dt="2023-07-15T22:00:10.874" v="3" actId="478"/>
          <ac:spMkLst>
            <pc:docMk/>
            <pc:sldMk cId="4106415198" sldId="267"/>
            <ac:spMk id="3" creationId="{E70988B2-FE47-4D84-FABD-5ABA7775F68A}"/>
          </ac:spMkLst>
        </pc:spChg>
        <pc:spChg chg="add mod">
          <ac:chgData name="Papaioannou, Ioannis" userId="27d0d6e0-1133-45d1-b366-9071ba1a55b0" providerId="ADAL" clId="{AE32242B-AB1C-496F-9B1A-20E25321956D}" dt="2023-07-15T22:00:13.977" v="5" actId="20577"/>
          <ac:spMkLst>
            <pc:docMk/>
            <pc:sldMk cId="4106415198" sldId="267"/>
            <ac:spMk id="4" creationId="{885793FE-48AB-CB3C-B706-1B1E6CAC35D9}"/>
          </ac:spMkLst>
        </pc:spChg>
        <pc:spChg chg="add mod">
          <ac:chgData name="Papaioannou, Ioannis" userId="27d0d6e0-1133-45d1-b366-9071ba1a55b0" providerId="ADAL" clId="{AE32242B-AB1C-496F-9B1A-20E25321956D}" dt="2023-07-16T11:04:41.762" v="26" actId="20577"/>
          <ac:spMkLst>
            <pc:docMk/>
            <pc:sldMk cId="4106415198" sldId="267"/>
            <ac:spMk id="9" creationId="{F264FB75-7D58-1165-097B-06613D3F31B6}"/>
          </ac:spMkLst>
        </pc:spChg>
        <pc:spChg chg="add mod">
          <ac:chgData name="Papaioannou, Ioannis" userId="27d0d6e0-1133-45d1-b366-9071ba1a55b0" providerId="ADAL" clId="{AE32242B-AB1C-496F-9B1A-20E25321956D}" dt="2023-07-16T11:04:50.777" v="33" actId="20577"/>
          <ac:spMkLst>
            <pc:docMk/>
            <pc:sldMk cId="4106415198" sldId="267"/>
            <ac:spMk id="10" creationId="{5E72F9D9-F1FE-BF08-0F1C-765A7588EAF9}"/>
          </ac:spMkLst>
        </pc:spChg>
        <pc:spChg chg="add del mod">
          <ac:chgData name="Papaioannou, Ioannis" userId="27d0d6e0-1133-45d1-b366-9071ba1a55b0" providerId="ADAL" clId="{AE32242B-AB1C-496F-9B1A-20E25321956D}" dt="2023-07-16T11:05:31.849" v="41" actId="21"/>
          <ac:spMkLst>
            <pc:docMk/>
            <pc:sldMk cId="4106415198" sldId="267"/>
            <ac:spMk id="11" creationId="{4431568B-B19C-A308-88DE-DFEC6F21F1FB}"/>
          </ac:spMkLst>
        </pc:spChg>
        <pc:spChg chg="add mod">
          <ac:chgData name="Papaioannou, Ioannis" userId="27d0d6e0-1133-45d1-b366-9071ba1a55b0" providerId="ADAL" clId="{AE32242B-AB1C-496F-9B1A-20E25321956D}" dt="2023-07-16T11:05:29.647" v="39" actId="571"/>
          <ac:spMkLst>
            <pc:docMk/>
            <pc:sldMk cId="4106415198" sldId="267"/>
            <ac:spMk id="13" creationId="{7A435409-BDAC-F75C-B344-75716C8C1586}"/>
          </ac:spMkLst>
        </pc:spChg>
        <pc:spChg chg="add mod">
          <ac:chgData name="Papaioannou, Ioannis" userId="27d0d6e0-1133-45d1-b366-9071ba1a55b0" providerId="ADAL" clId="{AE32242B-AB1C-496F-9B1A-20E25321956D}" dt="2023-07-16T11:06:36.230" v="61" actId="14100"/>
          <ac:spMkLst>
            <pc:docMk/>
            <pc:sldMk cId="4106415198" sldId="267"/>
            <ac:spMk id="14" creationId="{5066F0DF-11D8-D723-9AF6-B179C86CEDC0}"/>
          </ac:spMkLst>
        </pc:spChg>
        <pc:spChg chg="add mod">
          <ac:chgData name="Papaioannou, Ioannis" userId="27d0d6e0-1133-45d1-b366-9071ba1a55b0" providerId="ADAL" clId="{AE32242B-AB1C-496F-9B1A-20E25321956D}" dt="2023-07-16T11:49:32.125" v="226" actId="1076"/>
          <ac:spMkLst>
            <pc:docMk/>
            <pc:sldMk cId="4106415198" sldId="267"/>
            <ac:spMk id="15" creationId="{56EA631A-1912-382C-A628-D04380C8C308}"/>
          </ac:spMkLst>
        </pc:spChg>
        <pc:spChg chg="add mod">
          <ac:chgData name="Papaioannou, Ioannis" userId="27d0d6e0-1133-45d1-b366-9071ba1a55b0" providerId="ADAL" clId="{AE32242B-AB1C-496F-9B1A-20E25321956D}" dt="2023-07-16T11:49:32.125" v="226" actId="1076"/>
          <ac:spMkLst>
            <pc:docMk/>
            <pc:sldMk cId="4106415198" sldId="267"/>
            <ac:spMk id="16" creationId="{0DE1D657-AAD9-E8E8-ADFE-A373B3D91CD7}"/>
          </ac:spMkLst>
        </pc:spChg>
        <pc:spChg chg="add mod">
          <ac:chgData name="Papaioannou, Ioannis" userId="27d0d6e0-1133-45d1-b366-9071ba1a55b0" providerId="ADAL" clId="{AE32242B-AB1C-496F-9B1A-20E25321956D}" dt="2023-07-16T11:49:55.727" v="237" actId="20577"/>
          <ac:spMkLst>
            <pc:docMk/>
            <pc:sldMk cId="4106415198" sldId="267"/>
            <ac:spMk id="17" creationId="{F8FBF526-7B58-945E-F910-2A599ADCA24E}"/>
          </ac:spMkLst>
        </pc:spChg>
        <pc:spChg chg="add mod">
          <ac:chgData name="Papaioannou, Ioannis" userId="27d0d6e0-1133-45d1-b366-9071ba1a55b0" providerId="ADAL" clId="{AE32242B-AB1C-496F-9B1A-20E25321956D}" dt="2023-07-16T11:50:03.459" v="241" actId="1076"/>
          <ac:spMkLst>
            <pc:docMk/>
            <pc:sldMk cId="4106415198" sldId="267"/>
            <ac:spMk id="18" creationId="{51C5407B-C2B4-338E-6FDE-AB32F560E00C}"/>
          </ac:spMkLst>
        </pc:spChg>
        <pc:spChg chg="add mod">
          <ac:chgData name="Papaioannou, Ioannis" userId="27d0d6e0-1133-45d1-b366-9071ba1a55b0" providerId="ADAL" clId="{AE32242B-AB1C-496F-9B1A-20E25321956D}" dt="2023-07-16T11:50:00.827" v="239" actId="571"/>
          <ac:spMkLst>
            <pc:docMk/>
            <pc:sldMk cId="4106415198" sldId="267"/>
            <ac:spMk id="20" creationId="{7C3417FA-6625-AAD7-1CDA-5342F5B5C4A5}"/>
          </ac:spMkLst>
        </pc:spChg>
        <pc:spChg chg="add mod">
          <ac:chgData name="Papaioannou, Ioannis" userId="27d0d6e0-1133-45d1-b366-9071ba1a55b0" providerId="ADAL" clId="{AE32242B-AB1C-496F-9B1A-20E25321956D}" dt="2023-07-16T11:50:10.334" v="244" actId="20577"/>
          <ac:spMkLst>
            <pc:docMk/>
            <pc:sldMk cId="4106415198" sldId="267"/>
            <ac:spMk id="21" creationId="{8D0DE743-20D0-267C-0297-05585C100F55}"/>
          </ac:spMkLst>
        </pc:spChg>
        <pc:picChg chg="add mod modCrop">
          <ac:chgData name="Papaioannou, Ioannis" userId="27d0d6e0-1133-45d1-b366-9071ba1a55b0" providerId="ADAL" clId="{AE32242B-AB1C-496F-9B1A-20E25321956D}" dt="2023-07-16T11:49:32.125" v="226" actId="1076"/>
          <ac:picMkLst>
            <pc:docMk/>
            <pc:sldMk cId="4106415198" sldId="267"/>
            <ac:picMk id="3" creationId="{F4F8A386-C9FB-167A-A4A8-1DCDB752834B}"/>
          </ac:picMkLst>
        </pc:picChg>
        <pc:picChg chg="add del mod modCrop">
          <ac:chgData name="Papaioannou, Ioannis" userId="27d0d6e0-1133-45d1-b366-9071ba1a55b0" providerId="ADAL" clId="{AE32242B-AB1C-496F-9B1A-20E25321956D}" dt="2023-07-16T11:50:03.459" v="241" actId="1076"/>
          <ac:picMkLst>
            <pc:docMk/>
            <pc:sldMk cId="4106415198" sldId="267"/>
            <ac:picMk id="6" creationId="{A6A80319-A7D0-7F6C-3331-9BA721EAF4BA}"/>
          </ac:picMkLst>
        </pc:picChg>
        <pc:picChg chg="add mod">
          <ac:chgData name="Papaioannou, Ioannis" userId="27d0d6e0-1133-45d1-b366-9071ba1a55b0" providerId="ADAL" clId="{AE32242B-AB1C-496F-9B1A-20E25321956D}" dt="2023-07-16T11:04:32.325" v="22" actId="1076"/>
          <ac:picMkLst>
            <pc:docMk/>
            <pc:sldMk cId="4106415198" sldId="267"/>
            <ac:picMk id="8" creationId="{B100EB6E-198A-7A0D-68FC-8440603A7C6B}"/>
          </ac:picMkLst>
        </pc:picChg>
        <pc:picChg chg="add mod">
          <ac:chgData name="Papaioannou, Ioannis" userId="27d0d6e0-1133-45d1-b366-9071ba1a55b0" providerId="ADAL" clId="{AE32242B-AB1C-496F-9B1A-20E25321956D}" dt="2023-07-16T11:05:29.647" v="39" actId="571"/>
          <ac:picMkLst>
            <pc:docMk/>
            <pc:sldMk cId="4106415198" sldId="267"/>
            <ac:picMk id="12" creationId="{6C6D6009-175E-272F-93DD-4F1E325F923B}"/>
          </ac:picMkLst>
        </pc:picChg>
        <pc:picChg chg="add mod">
          <ac:chgData name="Papaioannou, Ioannis" userId="27d0d6e0-1133-45d1-b366-9071ba1a55b0" providerId="ADAL" clId="{AE32242B-AB1C-496F-9B1A-20E25321956D}" dt="2023-07-16T11:50:00.827" v="239" actId="571"/>
          <ac:picMkLst>
            <pc:docMk/>
            <pc:sldMk cId="4106415198" sldId="267"/>
            <ac:picMk id="19" creationId="{0D6B1EC3-9FA9-44E5-C8B8-5C7115E83F49}"/>
          </ac:picMkLst>
        </pc:picChg>
      </pc:sldChg>
      <pc:sldChg chg="addSp delSp modSp new mod">
        <pc:chgData name="Papaioannou, Ioannis" userId="27d0d6e0-1133-45d1-b366-9071ba1a55b0" providerId="ADAL" clId="{AE32242B-AB1C-496F-9B1A-20E25321956D}" dt="2023-07-16T21:50:45.157" v="846" actId="14100"/>
        <pc:sldMkLst>
          <pc:docMk/>
          <pc:sldMk cId="3210901459" sldId="268"/>
        </pc:sldMkLst>
        <pc:spChg chg="del">
          <ac:chgData name="Papaioannou, Ioannis" userId="27d0d6e0-1133-45d1-b366-9071ba1a55b0" providerId="ADAL" clId="{AE32242B-AB1C-496F-9B1A-20E25321956D}" dt="2023-07-16T21:39:41.692" v="737" actId="478"/>
          <ac:spMkLst>
            <pc:docMk/>
            <pc:sldMk cId="3210901459" sldId="268"/>
            <ac:spMk id="2" creationId="{527EE68D-400C-7477-E93D-6C5BFA26CA47}"/>
          </ac:spMkLst>
        </pc:spChg>
        <pc:spChg chg="del">
          <ac:chgData name="Papaioannou, Ioannis" userId="27d0d6e0-1133-45d1-b366-9071ba1a55b0" providerId="ADAL" clId="{AE32242B-AB1C-496F-9B1A-20E25321956D}" dt="2023-07-16T21:39:41.692" v="737" actId="478"/>
          <ac:spMkLst>
            <pc:docMk/>
            <pc:sldMk cId="3210901459" sldId="268"/>
            <ac:spMk id="3" creationId="{5BFDC1C4-F4C5-F00B-416C-114427B271E0}"/>
          </ac:spMkLst>
        </pc:spChg>
        <pc:spChg chg="add mod">
          <ac:chgData name="Papaioannou, Ioannis" userId="27d0d6e0-1133-45d1-b366-9071ba1a55b0" providerId="ADAL" clId="{AE32242B-AB1C-496F-9B1A-20E25321956D}" dt="2023-07-16T21:40:37.936" v="751" actId="20577"/>
          <ac:spMkLst>
            <pc:docMk/>
            <pc:sldMk cId="3210901459" sldId="268"/>
            <ac:spMk id="6" creationId="{4AF44CBB-FF3C-C845-E71E-054ACBEF7AEB}"/>
          </ac:spMkLst>
        </pc:spChg>
        <pc:spChg chg="add mod">
          <ac:chgData name="Papaioannou, Ioannis" userId="27d0d6e0-1133-45d1-b366-9071ba1a55b0" providerId="ADAL" clId="{AE32242B-AB1C-496F-9B1A-20E25321956D}" dt="2023-07-16T21:42:32.702" v="766" actId="1076"/>
          <ac:spMkLst>
            <pc:docMk/>
            <pc:sldMk cId="3210901459" sldId="268"/>
            <ac:spMk id="13" creationId="{EF9E92AA-AC83-FAEC-0E6F-D95705EF9612}"/>
          </ac:spMkLst>
        </pc:spChg>
        <pc:spChg chg="add mod">
          <ac:chgData name="Papaioannou, Ioannis" userId="27d0d6e0-1133-45d1-b366-9071ba1a55b0" providerId="ADAL" clId="{AE32242B-AB1C-496F-9B1A-20E25321956D}" dt="2023-07-16T21:44:36.581" v="794" actId="1076"/>
          <ac:spMkLst>
            <pc:docMk/>
            <pc:sldMk cId="3210901459" sldId="268"/>
            <ac:spMk id="14" creationId="{CCB5F315-504B-D92E-B7E0-1C6B751D383D}"/>
          </ac:spMkLst>
        </pc:spChg>
        <pc:spChg chg="add mod">
          <ac:chgData name="Papaioannou, Ioannis" userId="27d0d6e0-1133-45d1-b366-9071ba1a55b0" providerId="ADAL" clId="{AE32242B-AB1C-496F-9B1A-20E25321956D}" dt="2023-07-16T21:44:36.581" v="794" actId="1076"/>
          <ac:spMkLst>
            <pc:docMk/>
            <pc:sldMk cId="3210901459" sldId="268"/>
            <ac:spMk id="15" creationId="{1B6B041E-354A-F728-0CBA-B48DF74EC42A}"/>
          </ac:spMkLst>
        </pc:spChg>
        <pc:spChg chg="add mod">
          <ac:chgData name="Papaioannou, Ioannis" userId="27d0d6e0-1133-45d1-b366-9071ba1a55b0" providerId="ADAL" clId="{AE32242B-AB1C-496F-9B1A-20E25321956D}" dt="2023-07-16T21:44:35.671" v="791" actId="571"/>
          <ac:spMkLst>
            <pc:docMk/>
            <pc:sldMk cId="3210901459" sldId="268"/>
            <ac:spMk id="18" creationId="{F3DA86DC-BF68-BDAD-AC60-29986AE1E9E0}"/>
          </ac:spMkLst>
        </pc:spChg>
        <pc:spChg chg="add mod">
          <ac:chgData name="Papaioannou, Ioannis" userId="27d0d6e0-1133-45d1-b366-9071ba1a55b0" providerId="ADAL" clId="{AE32242B-AB1C-496F-9B1A-20E25321956D}" dt="2023-07-16T21:45:22.969" v="805" actId="1076"/>
          <ac:spMkLst>
            <pc:docMk/>
            <pc:sldMk cId="3210901459" sldId="268"/>
            <ac:spMk id="19" creationId="{74A98619-C3CF-D02E-B18F-E3FB24D0B9D0}"/>
          </ac:spMkLst>
        </pc:spChg>
        <pc:spChg chg="add mod">
          <ac:chgData name="Papaioannou, Ioannis" userId="27d0d6e0-1133-45d1-b366-9071ba1a55b0" providerId="ADAL" clId="{AE32242B-AB1C-496F-9B1A-20E25321956D}" dt="2023-07-16T21:50:14.611" v="837" actId="1036"/>
          <ac:spMkLst>
            <pc:docMk/>
            <pc:sldMk cId="3210901459" sldId="268"/>
            <ac:spMk id="20" creationId="{65F172F6-54F4-13BF-69CC-52408A1A7594}"/>
          </ac:spMkLst>
        </pc:spChg>
        <pc:spChg chg="add mod">
          <ac:chgData name="Papaioannou, Ioannis" userId="27d0d6e0-1133-45d1-b366-9071ba1a55b0" providerId="ADAL" clId="{AE32242B-AB1C-496F-9B1A-20E25321956D}" dt="2023-07-16T21:45:22.969" v="805" actId="1076"/>
          <ac:spMkLst>
            <pc:docMk/>
            <pc:sldMk cId="3210901459" sldId="268"/>
            <ac:spMk id="21" creationId="{D91B97C8-B05F-9311-92DE-5B740264F0D2}"/>
          </ac:spMkLst>
        </pc:spChg>
        <pc:spChg chg="add mod">
          <ac:chgData name="Papaioannou, Ioannis" userId="27d0d6e0-1133-45d1-b366-9071ba1a55b0" providerId="ADAL" clId="{AE32242B-AB1C-496F-9B1A-20E25321956D}" dt="2023-07-16T21:44:53.838" v="801" actId="1036"/>
          <ac:spMkLst>
            <pc:docMk/>
            <pc:sldMk cId="3210901459" sldId="268"/>
            <ac:spMk id="22" creationId="{834BFD35-CD64-5905-9513-C94435053F06}"/>
          </ac:spMkLst>
        </pc:spChg>
        <pc:spChg chg="add mod">
          <ac:chgData name="Papaioannou, Ioannis" userId="27d0d6e0-1133-45d1-b366-9071ba1a55b0" providerId="ADAL" clId="{AE32242B-AB1C-496F-9B1A-20E25321956D}" dt="2023-07-16T21:45:22.969" v="805" actId="1076"/>
          <ac:spMkLst>
            <pc:docMk/>
            <pc:sldMk cId="3210901459" sldId="268"/>
            <ac:spMk id="23" creationId="{0CFEE491-9FB8-E834-D848-67AB84BDE699}"/>
          </ac:spMkLst>
        </pc:spChg>
        <pc:spChg chg="add mod">
          <ac:chgData name="Papaioannou, Ioannis" userId="27d0d6e0-1133-45d1-b366-9071ba1a55b0" providerId="ADAL" clId="{AE32242B-AB1C-496F-9B1A-20E25321956D}" dt="2023-07-16T21:45:31.245" v="813" actId="1076"/>
          <ac:spMkLst>
            <pc:docMk/>
            <pc:sldMk cId="3210901459" sldId="268"/>
            <ac:spMk id="24" creationId="{84DA329E-DBB2-A2EB-6A7D-809D011FE046}"/>
          </ac:spMkLst>
        </pc:spChg>
        <pc:spChg chg="add mod">
          <ac:chgData name="Papaioannou, Ioannis" userId="27d0d6e0-1133-45d1-b366-9071ba1a55b0" providerId="ADAL" clId="{AE32242B-AB1C-496F-9B1A-20E25321956D}" dt="2023-07-16T21:50:21.583" v="838" actId="1076"/>
          <ac:spMkLst>
            <pc:docMk/>
            <pc:sldMk cId="3210901459" sldId="268"/>
            <ac:spMk id="27" creationId="{220E2BBA-1E7B-5EE8-3925-EE579F0E4F7B}"/>
          </ac:spMkLst>
        </pc:spChg>
        <pc:spChg chg="add mod">
          <ac:chgData name="Papaioannou, Ioannis" userId="27d0d6e0-1133-45d1-b366-9071ba1a55b0" providerId="ADAL" clId="{AE32242B-AB1C-496F-9B1A-20E25321956D}" dt="2023-07-16T21:50:36.802" v="844" actId="1076"/>
          <ac:spMkLst>
            <pc:docMk/>
            <pc:sldMk cId="3210901459" sldId="268"/>
            <ac:spMk id="28" creationId="{D39DFF80-61C3-AF8C-24C7-5400E45D96F6}"/>
          </ac:spMkLst>
        </pc:spChg>
        <pc:spChg chg="add mod">
          <ac:chgData name="Papaioannou, Ioannis" userId="27d0d6e0-1133-45d1-b366-9071ba1a55b0" providerId="ADAL" clId="{AE32242B-AB1C-496F-9B1A-20E25321956D}" dt="2023-07-16T21:50:45.157" v="846" actId="14100"/>
          <ac:spMkLst>
            <pc:docMk/>
            <pc:sldMk cId="3210901459" sldId="268"/>
            <ac:spMk id="29" creationId="{05E82218-FD3A-3BE7-99DA-ED7DDD462301}"/>
          </ac:spMkLst>
        </pc:spChg>
        <pc:picChg chg="add mod">
          <ac:chgData name="Papaioannou, Ioannis" userId="27d0d6e0-1133-45d1-b366-9071ba1a55b0" providerId="ADAL" clId="{AE32242B-AB1C-496F-9B1A-20E25321956D}" dt="2023-07-16T21:40:00.646" v="741" actId="1076"/>
          <ac:picMkLst>
            <pc:docMk/>
            <pc:sldMk cId="3210901459" sldId="268"/>
            <ac:picMk id="5" creationId="{53D6B088-3784-C6E1-CC6D-34F8CE84434E}"/>
          </ac:picMkLst>
        </pc:picChg>
        <pc:picChg chg="add del mod">
          <ac:chgData name="Papaioannou, Ioannis" userId="27d0d6e0-1133-45d1-b366-9071ba1a55b0" providerId="ADAL" clId="{AE32242B-AB1C-496F-9B1A-20E25321956D}" dt="2023-07-16T21:41:02.307" v="755" actId="478"/>
          <ac:picMkLst>
            <pc:docMk/>
            <pc:sldMk cId="3210901459" sldId="268"/>
            <ac:picMk id="8" creationId="{2381F3FE-FE02-5286-C7AC-6ED529ABB9D2}"/>
          </ac:picMkLst>
        </pc:picChg>
        <pc:picChg chg="add del mod">
          <ac:chgData name="Papaioannou, Ioannis" userId="27d0d6e0-1133-45d1-b366-9071ba1a55b0" providerId="ADAL" clId="{AE32242B-AB1C-496F-9B1A-20E25321956D}" dt="2023-07-16T21:42:13.277" v="759" actId="478"/>
          <ac:picMkLst>
            <pc:docMk/>
            <pc:sldMk cId="3210901459" sldId="268"/>
            <ac:picMk id="10" creationId="{C9EA4C6A-9D4D-811D-BC7D-843637834713}"/>
          </ac:picMkLst>
        </pc:picChg>
        <pc:picChg chg="add mod">
          <ac:chgData name="Papaioannou, Ioannis" userId="27d0d6e0-1133-45d1-b366-9071ba1a55b0" providerId="ADAL" clId="{AE32242B-AB1C-496F-9B1A-20E25321956D}" dt="2023-07-16T21:42:15.576" v="761" actId="1076"/>
          <ac:picMkLst>
            <pc:docMk/>
            <pc:sldMk cId="3210901459" sldId="268"/>
            <ac:picMk id="12" creationId="{76F4AFB9-454E-AEAF-F400-FDEFBAA49F0A}"/>
          </ac:picMkLst>
        </pc:picChg>
        <pc:picChg chg="add mod">
          <ac:chgData name="Papaioannou, Ioannis" userId="27d0d6e0-1133-45d1-b366-9071ba1a55b0" providerId="ADAL" clId="{AE32242B-AB1C-496F-9B1A-20E25321956D}" dt="2023-07-16T21:45:22.969" v="805" actId="1076"/>
          <ac:picMkLst>
            <pc:docMk/>
            <pc:sldMk cId="3210901459" sldId="268"/>
            <ac:picMk id="17" creationId="{416AB67C-ED1A-9FDA-1230-7437F5E43631}"/>
          </ac:picMkLst>
        </pc:picChg>
        <pc:picChg chg="add mod">
          <ac:chgData name="Papaioannou, Ioannis" userId="27d0d6e0-1133-45d1-b366-9071ba1a55b0" providerId="ADAL" clId="{AE32242B-AB1C-496F-9B1A-20E25321956D}" dt="2023-07-16T21:49:37.049" v="815" actId="1076"/>
          <ac:picMkLst>
            <pc:docMk/>
            <pc:sldMk cId="3210901459" sldId="268"/>
            <ac:picMk id="26" creationId="{F064E2B7-E98E-31A2-73F9-5ED4EDF46263}"/>
          </ac:picMkLst>
        </pc:picChg>
      </pc:sldChg>
    </pc:docChg>
  </pc:docChgLst>
  <pc:docChgLst>
    <pc:chgData name="Papaioannou, Ioannis" userId="27d0d6e0-1133-45d1-b366-9071ba1a55b0" providerId="ADAL" clId="{CE92DEDD-AD8D-4461-BA83-EF7D6E8BC619}"/>
    <pc:docChg chg="undo custSel modSld">
      <pc:chgData name="Papaioannou, Ioannis" userId="27d0d6e0-1133-45d1-b366-9071ba1a55b0" providerId="ADAL" clId="{CE92DEDD-AD8D-4461-BA83-EF7D6E8BC619}" dt="2024-01-03T16:04:31.223" v="130" actId="1076"/>
      <pc:docMkLst>
        <pc:docMk/>
      </pc:docMkLst>
      <pc:sldChg chg="addSp delSp modSp mod">
        <pc:chgData name="Papaioannou, Ioannis" userId="27d0d6e0-1133-45d1-b366-9071ba1a55b0" providerId="ADAL" clId="{CE92DEDD-AD8D-4461-BA83-EF7D6E8BC619}" dt="2024-01-03T16:04:17.127" v="129" actId="1076"/>
        <pc:sldMkLst>
          <pc:docMk/>
          <pc:sldMk cId="1783988844" sldId="256"/>
        </pc:sldMkLst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2" creationId="{FFB3F725-DB17-D087-9E53-C750D965C6B3}"/>
          </ac:spMkLst>
        </pc:spChg>
        <pc:spChg chg="add del mod">
          <ac:chgData name="Papaioannou, Ioannis" userId="27d0d6e0-1133-45d1-b366-9071ba1a55b0" providerId="ADAL" clId="{CE92DEDD-AD8D-4461-BA83-EF7D6E8BC619}" dt="2024-01-03T16:04:02.619" v="125" actId="478"/>
          <ac:spMkLst>
            <pc:docMk/>
            <pc:sldMk cId="1783988844" sldId="256"/>
            <ac:spMk id="7" creationId="{124DCE07-3F8B-D0BC-4530-DADA81D3FEF4}"/>
          </ac:spMkLst>
        </pc:spChg>
        <pc:spChg chg="add del mod">
          <ac:chgData name="Papaioannou, Ioannis" userId="27d0d6e0-1133-45d1-b366-9071ba1a55b0" providerId="ADAL" clId="{CE92DEDD-AD8D-4461-BA83-EF7D6E8BC619}" dt="2024-01-03T16:04:02.619" v="125" actId="478"/>
          <ac:spMkLst>
            <pc:docMk/>
            <pc:sldMk cId="1783988844" sldId="256"/>
            <ac:spMk id="8" creationId="{0C831AA3-76B4-7CBA-F8C6-01FE4F300656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9" creationId="{486D8CB2-1F96-7A06-F3C9-36A7C8F70B15}"/>
          </ac:spMkLst>
        </pc:spChg>
        <pc:spChg chg="add del mod">
          <ac:chgData name="Papaioannou, Ioannis" userId="27d0d6e0-1133-45d1-b366-9071ba1a55b0" providerId="ADAL" clId="{CE92DEDD-AD8D-4461-BA83-EF7D6E8BC619}" dt="2024-01-03T16:04:02.619" v="125" actId="478"/>
          <ac:spMkLst>
            <pc:docMk/>
            <pc:sldMk cId="1783988844" sldId="256"/>
            <ac:spMk id="13" creationId="{C4BA707D-8866-6383-331E-985020B01BD6}"/>
          </ac:spMkLst>
        </pc:spChg>
        <pc:spChg chg="add del mod">
          <ac:chgData name="Papaioannou, Ioannis" userId="27d0d6e0-1133-45d1-b366-9071ba1a55b0" providerId="ADAL" clId="{CE92DEDD-AD8D-4461-BA83-EF7D6E8BC619}" dt="2024-01-03T16:04:17.127" v="129" actId="1076"/>
          <ac:spMkLst>
            <pc:docMk/>
            <pc:sldMk cId="1783988844" sldId="256"/>
            <ac:spMk id="14" creationId="{E050A7A1-B518-9476-DC1E-391BCEDC9163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15" creationId="{D5833022-505D-732F-F29C-DFFCA14A11A1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16" creationId="{FCE2F328-DF25-F19D-AD1A-08155EA983C0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18" creationId="{2A070ED4-BBFD-4C67-9BC8-C0F514F3F324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22" creationId="{058A77C2-BBE2-3BD8-BDA1-698A3552EF82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27" creationId="{1C308C02-65DF-39C2-1598-85E99E3908B1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28" creationId="{E19FA98D-F389-F6B2-7CE8-3F0E1DB0DD3D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29" creationId="{8992453E-2406-B23F-D22D-AA56AB1D4988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30" creationId="{D9172C64-B1BD-F188-6610-F39DDAE4868B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31" creationId="{9B3C8C6C-72D5-EAFB-DB52-D3F308ED5979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32" creationId="{0758D50E-4AE9-1E91-1EA9-847C5D906A3F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33" creationId="{D7417A8B-DD94-3B83-C575-AFDAA7482F0A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34" creationId="{29F9D628-C006-4567-7D77-C292F0340312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35" creationId="{D21DEF92-B797-826C-47A1-05ED4DA1C864}"/>
          </ac:spMkLst>
        </pc:spChg>
        <pc:spChg chg="add del mod">
          <ac:chgData name="Papaioannou, Ioannis" userId="27d0d6e0-1133-45d1-b366-9071ba1a55b0" providerId="ADAL" clId="{CE92DEDD-AD8D-4461-BA83-EF7D6E8BC619}" dt="2024-01-03T15:53:43.714" v="36" actId="478"/>
          <ac:spMkLst>
            <pc:docMk/>
            <pc:sldMk cId="1783988844" sldId="256"/>
            <ac:spMk id="36" creationId="{18B50A5B-C6E6-4C94-E48E-92F7ACBE70BB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37" creationId="{D5DEC5AB-9CFA-C942-1638-129695FA715E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38" creationId="{D055D737-7CE0-AE15-79A1-A421B5422589}"/>
          </ac:spMkLst>
        </pc:spChg>
        <pc:spChg chg="add del mod">
          <ac:chgData name="Papaioannou, Ioannis" userId="27d0d6e0-1133-45d1-b366-9071ba1a55b0" providerId="ADAL" clId="{CE92DEDD-AD8D-4461-BA83-EF7D6E8BC619}" dt="2024-01-03T16:04:12.262" v="128" actId="478"/>
          <ac:spMkLst>
            <pc:docMk/>
            <pc:sldMk cId="1783988844" sldId="256"/>
            <ac:spMk id="39" creationId="{0B339270-C742-0C58-CEFB-68853BFC4750}"/>
          </ac:spMkLst>
        </pc:spChg>
        <pc:spChg chg="add del mod">
          <ac:chgData name="Papaioannou, Ioannis" userId="27d0d6e0-1133-45d1-b366-9071ba1a55b0" providerId="ADAL" clId="{CE92DEDD-AD8D-4461-BA83-EF7D6E8BC619}" dt="2024-01-03T16:04:02.619" v="125" actId="478"/>
          <ac:spMkLst>
            <pc:docMk/>
            <pc:sldMk cId="1783988844" sldId="256"/>
            <ac:spMk id="52" creationId="{B8B10DE2-B391-73D4-52B1-ACFA9832A867}"/>
          </ac:spMkLst>
        </pc:spChg>
        <pc:spChg chg="add del mod">
          <ac:chgData name="Papaioannou, Ioannis" userId="27d0d6e0-1133-45d1-b366-9071ba1a55b0" providerId="ADAL" clId="{CE92DEDD-AD8D-4461-BA83-EF7D6E8BC619}" dt="2024-01-03T16:04:02.619" v="125" actId="478"/>
          <ac:spMkLst>
            <pc:docMk/>
            <pc:sldMk cId="1783988844" sldId="256"/>
            <ac:spMk id="59" creationId="{F57E4BA0-240F-CF88-CA79-62BEA686ECCA}"/>
          </ac:spMkLst>
        </pc:spChg>
        <pc:picChg chg="add del mod">
          <ac:chgData name="Papaioannou, Ioannis" userId="27d0d6e0-1133-45d1-b366-9071ba1a55b0" providerId="ADAL" clId="{CE92DEDD-AD8D-4461-BA83-EF7D6E8BC619}" dt="2024-01-03T16:04:02.619" v="125" actId="478"/>
          <ac:picMkLst>
            <pc:docMk/>
            <pc:sldMk cId="1783988844" sldId="256"/>
            <ac:picMk id="4" creationId="{B9A67C9D-082D-0D33-7851-C2053DA614F3}"/>
          </ac:picMkLst>
        </pc:picChg>
        <pc:picChg chg="mod">
          <ac:chgData name="Papaioannou, Ioannis" userId="27d0d6e0-1133-45d1-b366-9071ba1a55b0" providerId="ADAL" clId="{CE92DEDD-AD8D-4461-BA83-EF7D6E8BC619}" dt="2024-01-03T16:04:08.088" v="127" actId="1076"/>
          <ac:picMkLst>
            <pc:docMk/>
            <pc:sldMk cId="1783988844" sldId="256"/>
            <ac:picMk id="17" creationId="{6C32DC27-B56E-5065-1794-E24266D7A9CE}"/>
          </ac:picMkLst>
        </pc:picChg>
        <pc:picChg chg="add del mod">
          <ac:chgData name="Papaioannou, Ioannis" userId="27d0d6e0-1133-45d1-b366-9071ba1a55b0" providerId="ADAL" clId="{CE92DEDD-AD8D-4461-BA83-EF7D6E8BC619}" dt="2024-01-03T16:04:02.619" v="125" actId="478"/>
          <ac:picMkLst>
            <pc:docMk/>
            <pc:sldMk cId="1783988844" sldId="256"/>
            <ac:picMk id="47" creationId="{0AA1B274-6237-EF6E-8A44-41F8152C56AC}"/>
          </ac:picMkLst>
        </pc:picChg>
      </pc:sldChg>
      <pc:sldChg chg="addSp delSp modSp mod">
        <pc:chgData name="Papaioannou, Ioannis" userId="27d0d6e0-1133-45d1-b366-9071ba1a55b0" providerId="ADAL" clId="{CE92DEDD-AD8D-4461-BA83-EF7D6E8BC619}" dt="2024-01-03T16:04:31.223" v="130" actId="1076"/>
        <pc:sldMkLst>
          <pc:docMk/>
          <pc:sldMk cId="1419449853" sldId="257"/>
        </pc:sldMkLst>
        <pc:spChg chg="mod">
          <ac:chgData name="Papaioannou, Ioannis" userId="27d0d6e0-1133-45d1-b366-9071ba1a55b0" providerId="ADAL" clId="{CE92DEDD-AD8D-4461-BA83-EF7D6E8BC619}" dt="2024-01-03T16:03:05.576" v="102" actId="1076"/>
          <ac:spMkLst>
            <pc:docMk/>
            <pc:sldMk cId="1419449853" sldId="257"/>
            <ac:spMk id="5" creationId="{15762434-B673-84A5-B31D-C533133E0AEB}"/>
          </ac:spMkLst>
        </pc:spChg>
        <pc:spChg chg="mod">
          <ac:chgData name="Papaioannou, Ioannis" userId="27d0d6e0-1133-45d1-b366-9071ba1a55b0" providerId="ADAL" clId="{CE92DEDD-AD8D-4461-BA83-EF7D6E8BC619}" dt="2024-01-03T16:03:05.576" v="102" actId="1076"/>
          <ac:spMkLst>
            <pc:docMk/>
            <pc:sldMk cId="1419449853" sldId="257"/>
            <ac:spMk id="12" creationId="{614B11ED-CE24-366F-9772-12F5F5D7DBA0}"/>
          </ac:spMkLst>
        </pc:spChg>
        <pc:spChg chg="add del mod">
          <ac:chgData name="Papaioannou, Ioannis" userId="27d0d6e0-1133-45d1-b366-9071ba1a55b0" providerId="ADAL" clId="{CE92DEDD-AD8D-4461-BA83-EF7D6E8BC619}" dt="2024-01-03T15:57:28.739" v="46" actId="478"/>
          <ac:spMkLst>
            <pc:docMk/>
            <pc:sldMk cId="1419449853" sldId="257"/>
            <ac:spMk id="16" creationId="{6D24675A-7AF3-7E6F-CD26-0F3816119A83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17" creationId="{2BEB7BBC-1373-4413-8B51-C5D562BD1F87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19" creationId="{96287C47-920C-498F-5296-857CF9C29B1E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20" creationId="{D7C68E9E-DA8F-99CB-0A87-3CB9E9F898BD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21" creationId="{4D6653C5-EBE2-A26B-6196-E1B5B30D8E21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22" creationId="{407DCB5D-CB44-FF65-D576-9071EBD6833C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23" creationId="{30AE13FE-9054-4D8B-B548-3153F6D5A993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24" creationId="{DF33AE9D-7B73-749B-A79A-F6232840651A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26" creationId="{174A28FB-5133-66DA-B9FE-F0E05047248B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27" creationId="{85445F55-F735-1CEB-C83D-82D0A09FE6EA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28" creationId="{325963E4-B8AF-250A-9EDB-D41CC8163F26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29" creationId="{7D2B6894-F795-E412-BC91-8E1BE70DF878}"/>
          </ac:spMkLst>
        </pc:spChg>
        <pc:spChg chg="add del mod">
          <ac:chgData name="Papaioannou, Ioannis" userId="27d0d6e0-1133-45d1-b366-9071ba1a55b0" providerId="ADAL" clId="{CE92DEDD-AD8D-4461-BA83-EF7D6E8BC619}" dt="2024-01-03T16:03:24.646" v="123" actId="478"/>
          <ac:spMkLst>
            <pc:docMk/>
            <pc:sldMk cId="1419449853" sldId="257"/>
            <ac:spMk id="30" creationId="{E119C1C5-3B84-760C-4139-301A56179F26}"/>
          </ac:spMkLst>
        </pc:spChg>
        <pc:spChg chg="add mod">
          <ac:chgData name="Papaioannou, Ioannis" userId="27d0d6e0-1133-45d1-b366-9071ba1a55b0" providerId="ADAL" clId="{CE92DEDD-AD8D-4461-BA83-EF7D6E8BC619}" dt="2024-01-03T16:03:08.390" v="120" actId="571"/>
          <ac:spMkLst>
            <pc:docMk/>
            <pc:sldMk cId="1419449853" sldId="257"/>
            <ac:spMk id="31" creationId="{F51EE64A-9765-9827-5A47-483E4E83489A}"/>
          </ac:spMkLst>
        </pc:spChg>
        <pc:spChg chg="add mod">
          <ac:chgData name="Papaioannou, Ioannis" userId="27d0d6e0-1133-45d1-b366-9071ba1a55b0" providerId="ADAL" clId="{CE92DEDD-AD8D-4461-BA83-EF7D6E8BC619}" dt="2024-01-03T16:03:06.653" v="109" actId="571"/>
          <ac:spMkLst>
            <pc:docMk/>
            <pc:sldMk cId="1419449853" sldId="257"/>
            <ac:spMk id="32" creationId="{F59D5614-DA0A-76AD-BD97-36E78DD285A8}"/>
          </ac:spMkLst>
        </pc:spChg>
        <pc:picChg chg="mod">
          <ac:chgData name="Papaioannou, Ioannis" userId="27d0d6e0-1133-45d1-b366-9071ba1a55b0" providerId="ADAL" clId="{CE92DEDD-AD8D-4461-BA83-EF7D6E8BC619}" dt="2024-01-03T15:58:09.502" v="53" actId="1076"/>
          <ac:picMkLst>
            <pc:docMk/>
            <pc:sldMk cId="1419449853" sldId="257"/>
            <ac:picMk id="4" creationId="{00000000-0000-0000-0000-000000000000}"/>
          </ac:picMkLst>
        </pc:picChg>
        <pc:picChg chg="mod">
          <ac:chgData name="Papaioannou, Ioannis" userId="27d0d6e0-1133-45d1-b366-9071ba1a55b0" providerId="ADAL" clId="{CE92DEDD-AD8D-4461-BA83-EF7D6E8BC619}" dt="2024-01-03T16:04:31.223" v="130" actId="1076"/>
          <ac:picMkLst>
            <pc:docMk/>
            <pc:sldMk cId="1419449853" sldId="257"/>
            <ac:picMk id="6" creationId="{00000000-0000-0000-0000-000000000000}"/>
          </ac:picMkLst>
        </pc:picChg>
      </pc:sldChg>
    </pc:docChg>
  </pc:docChgLst>
  <pc:docChgLst>
    <pc:chgData name="Ponticos, Markella" userId="S::rmhampo@ucl.ac.uk::8ef50869-c47f-477f-819f-244d7318bb2d" providerId="AD" clId="Web-{08122492-AFCC-12A9-C1E4-8859A4C68137}"/>
    <pc:docChg chg="modSld">
      <pc:chgData name="Ponticos, Markella" userId="S::rmhampo@ucl.ac.uk::8ef50869-c47f-477f-819f-244d7318bb2d" providerId="AD" clId="Web-{08122492-AFCC-12A9-C1E4-8859A4C68137}" dt="2024-03-01T16:34:27.157" v="8"/>
      <pc:docMkLst>
        <pc:docMk/>
      </pc:docMkLst>
      <pc:sldChg chg="modSp">
        <pc:chgData name="Ponticos, Markella" userId="S::rmhampo@ucl.ac.uk::8ef50869-c47f-477f-819f-244d7318bb2d" providerId="AD" clId="Web-{08122492-AFCC-12A9-C1E4-8859A4C68137}" dt="2024-03-01T15:48:47.425" v="0" actId="1076"/>
        <pc:sldMkLst>
          <pc:docMk/>
          <pc:sldMk cId="1419449853" sldId="257"/>
        </pc:sldMkLst>
        <pc:spChg chg="mod">
          <ac:chgData name="Ponticos, Markella" userId="S::rmhampo@ucl.ac.uk::8ef50869-c47f-477f-819f-244d7318bb2d" providerId="AD" clId="Web-{08122492-AFCC-12A9-C1E4-8859A4C68137}" dt="2024-03-01T15:48:47.425" v="0" actId="1076"/>
          <ac:spMkLst>
            <pc:docMk/>
            <pc:sldMk cId="1419449853" sldId="257"/>
            <ac:spMk id="15" creationId="{3AB294E5-BFA6-E6CD-7AEF-152F22D9DAA6}"/>
          </ac:spMkLst>
        </pc:spChg>
      </pc:sldChg>
      <pc:sldChg chg="addSp delSp modSp">
        <pc:chgData name="Ponticos, Markella" userId="S::rmhampo@ucl.ac.uk::8ef50869-c47f-477f-819f-244d7318bb2d" providerId="AD" clId="Web-{08122492-AFCC-12A9-C1E4-8859A4C68137}" dt="2024-03-01T16:34:27.157" v="8"/>
        <pc:sldMkLst>
          <pc:docMk/>
          <pc:sldMk cId="1358340535" sldId="263"/>
        </pc:sldMkLst>
        <pc:spChg chg="mod">
          <ac:chgData name="Ponticos, Markella" userId="S::rmhampo@ucl.ac.uk::8ef50869-c47f-477f-819f-244d7318bb2d" providerId="AD" clId="Web-{08122492-AFCC-12A9-C1E4-8859A4C68137}" dt="2024-03-01T16:34:10.687" v="4" actId="1076"/>
          <ac:spMkLst>
            <pc:docMk/>
            <pc:sldMk cId="1358340535" sldId="263"/>
            <ac:spMk id="23" creationId="{7053130D-5B6F-1617-88A5-ACBD0005573F}"/>
          </ac:spMkLst>
        </pc:spChg>
        <pc:picChg chg="mod">
          <ac:chgData name="Ponticos, Markella" userId="S::rmhampo@ucl.ac.uk::8ef50869-c47f-477f-819f-244d7318bb2d" providerId="AD" clId="Web-{08122492-AFCC-12A9-C1E4-8859A4C68137}" dt="2024-03-01T16:34:14.375" v="6" actId="1076"/>
          <ac:picMkLst>
            <pc:docMk/>
            <pc:sldMk cId="1358340535" sldId="263"/>
            <ac:picMk id="4" creationId="{64F2952F-A7A5-B7D1-497D-BA577B44B9CE}"/>
          </ac:picMkLst>
        </pc:picChg>
        <pc:picChg chg="mod">
          <ac:chgData name="Ponticos, Markella" userId="S::rmhampo@ucl.ac.uk::8ef50869-c47f-477f-819f-244d7318bb2d" providerId="AD" clId="Web-{08122492-AFCC-12A9-C1E4-8859A4C68137}" dt="2024-03-01T16:34:13.438" v="5" actId="14100"/>
          <ac:picMkLst>
            <pc:docMk/>
            <pc:sldMk cId="1358340535" sldId="263"/>
            <ac:picMk id="7" creationId="{652C654C-A53C-22FA-B4D2-8F78B38F81C1}"/>
          </ac:picMkLst>
        </pc:picChg>
        <pc:picChg chg="add del mod">
          <ac:chgData name="Ponticos, Markella" userId="S::rmhampo@ucl.ac.uk::8ef50869-c47f-477f-819f-244d7318bb2d" providerId="AD" clId="Web-{08122492-AFCC-12A9-C1E4-8859A4C68137}" dt="2024-03-01T16:34:27.157" v="8"/>
          <ac:picMkLst>
            <pc:docMk/>
            <pc:sldMk cId="1358340535" sldId="263"/>
            <ac:picMk id="20" creationId="{17A69C42-A807-55F4-6CEC-E0C339469C63}"/>
          </ac:picMkLst>
        </pc:picChg>
      </pc:sldChg>
    </pc:docChg>
  </pc:docChgLst>
  <pc:docChgLst>
    <pc:chgData name="Papaioannou, Ioannis" userId="27d0d6e0-1133-45d1-b366-9071ba1a55b0" providerId="ADAL" clId="{420A7D14-0B6D-4BF5-8B64-A7F8518E9606}"/>
    <pc:docChg chg="undo custSel modSld">
      <pc:chgData name="Papaioannou, Ioannis" userId="27d0d6e0-1133-45d1-b366-9071ba1a55b0" providerId="ADAL" clId="{420A7D14-0B6D-4BF5-8B64-A7F8518E9606}" dt="2024-04-10T17:45:54.332" v="4" actId="1076"/>
      <pc:docMkLst>
        <pc:docMk/>
      </pc:docMkLst>
      <pc:sldChg chg="modSp mod">
        <pc:chgData name="Papaioannou, Ioannis" userId="27d0d6e0-1133-45d1-b366-9071ba1a55b0" providerId="ADAL" clId="{420A7D14-0B6D-4BF5-8B64-A7F8518E9606}" dt="2024-04-10T17:44:54.123" v="1" actId="1076"/>
        <pc:sldMkLst>
          <pc:docMk/>
          <pc:sldMk cId="1934854818" sldId="262"/>
        </pc:sldMkLst>
        <pc:picChg chg="mod">
          <ac:chgData name="Papaioannou, Ioannis" userId="27d0d6e0-1133-45d1-b366-9071ba1a55b0" providerId="ADAL" clId="{420A7D14-0B6D-4BF5-8B64-A7F8518E9606}" dt="2024-04-10T17:44:54.123" v="1" actId="1076"/>
          <ac:picMkLst>
            <pc:docMk/>
            <pc:sldMk cId="1934854818" sldId="262"/>
            <ac:picMk id="26" creationId="{D0D198E2-F698-334A-3276-2E337BE69EE0}"/>
          </ac:picMkLst>
        </pc:picChg>
      </pc:sldChg>
      <pc:sldChg chg="addSp delSp modSp mod">
        <pc:chgData name="Papaioannou, Ioannis" userId="27d0d6e0-1133-45d1-b366-9071ba1a55b0" providerId="ADAL" clId="{420A7D14-0B6D-4BF5-8B64-A7F8518E9606}" dt="2024-04-10T17:45:54.332" v="4" actId="1076"/>
        <pc:sldMkLst>
          <pc:docMk/>
          <pc:sldMk cId="3205824443" sldId="269"/>
        </pc:sldMkLst>
        <pc:picChg chg="add mod">
          <ac:chgData name="Papaioannou, Ioannis" userId="27d0d6e0-1133-45d1-b366-9071ba1a55b0" providerId="ADAL" clId="{420A7D14-0B6D-4BF5-8B64-A7F8518E9606}" dt="2024-04-10T17:45:54.332" v="4" actId="1076"/>
          <ac:picMkLst>
            <pc:docMk/>
            <pc:sldMk cId="3205824443" sldId="269"/>
            <ac:picMk id="4" creationId="{0D48CF63-C3F3-956D-E8E6-1A922CB5F84E}"/>
          </ac:picMkLst>
        </pc:picChg>
        <pc:picChg chg="del">
          <ac:chgData name="Papaioannou, Ioannis" userId="27d0d6e0-1133-45d1-b366-9071ba1a55b0" providerId="ADAL" clId="{420A7D14-0B6D-4BF5-8B64-A7F8518E9606}" dt="2024-04-10T17:45:39.225" v="2" actId="478"/>
          <ac:picMkLst>
            <pc:docMk/>
            <pc:sldMk cId="3205824443" sldId="269"/>
            <ac:picMk id="24" creationId="{38C29AED-E6FE-EEAB-2E27-324E697DA141}"/>
          </ac:picMkLst>
        </pc:picChg>
      </pc:sldChg>
    </pc:docChg>
  </pc:docChgLst>
  <pc:docChgLst>
    <pc:chgData name="Papaioannou, Ioannis" userId="27d0d6e0-1133-45d1-b366-9071ba1a55b0" providerId="ADAL" clId="{BA1F9235-DE2C-433E-8776-BF88F36CDC29}"/>
    <pc:docChg chg="undo redo custSel addSld delSld modSld">
      <pc:chgData name="Papaioannou, Ioannis" userId="27d0d6e0-1133-45d1-b366-9071ba1a55b0" providerId="ADAL" clId="{BA1F9235-DE2C-433E-8776-BF88F36CDC29}" dt="2022-07-19T14:57:25.956" v="1770" actId="11530"/>
      <pc:docMkLst>
        <pc:docMk/>
      </pc:docMkLst>
      <pc:sldChg chg="addSp delSp modSp mod">
        <pc:chgData name="Papaioannou, Ioannis" userId="27d0d6e0-1133-45d1-b366-9071ba1a55b0" providerId="ADAL" clId="{BA1F9235-DE2C-433E-8776-BF88F36CDC29}" dt="2022-07-11T21:38:08.132" v="1759" actId="20577"/>
        <pc:sldMkLst>
          <pc:docMk/>
          <pc:sldMk cId="1783988844" sldId="256"/>
        </pc:sldMkLst>
        <pc:spChg chg="add del mod">
          <ac:chgData name="Papaioannou, Ioannis" userId="27d0d6e0-1133-45d1-b366-9071ba1a55b0" providerId="ADAL" clId="{BA1F9235-DE2C-433E-8776-BF88F36CDC29}" dt="2022-07-11T20:48:02.626" v="1504" actId="767"/>
          <ac:spMkLst>
            <pc:docMk/>
            <pc:sldMk cId="1783988844" sldId="256"/>
            <ac:spMk id="2" creationId="{97DE8480-3039-3566-B42B-58B2E7ECACD4}"/>
          </ac:spMkLst>
        </pc:spChg>
        <pc:spChg chg="del">
          <ac:chgData name="Papaioannou, Ioannis" userId="27d0d6e0-1133-45d1-b366-9071ba1a55b0" providerId="ADAL" clId="{BA1F9235-DE2C-433E-8776-BF88F36CDC29}" dt="2022-06-23T12:00:16.102" v="0" actId="478"/>
          <ac:spMkLst>
            <pc:docMk/>
            <pc:sldMk cId="1783988844" sldId="256"/>
            <ac:spMk id="2" creationId="{ECB52440-D121-8D6E-CDAE-2A86E38CA109}"/>
          </ac:spMkLst>
        </pc:spChg>
        <pc:spChg chg="del">
          <ac:chgData name="Papaioannou, Ioannis" userId="27d0d6e0-1133-45d1-b366-9071ba1a55b0" providerId="ADAL" clId="{BA1F9235-DE2C-433E-8776-BF88F36CDC29}" dt="2022-06-23T12:00:16.102" v="0" actId="478"/>
          <ac:spMkLst>
            <pc:docMk/>
            <pc:sldMk cId="1783988844" sldId="256"/>
            <ac:spMk id="3" creationId="{4A2A2F0B-41B0-C469-8231-34ED132F8C14}"/>
          </ac:spMkLst>
        </pc:spChg>
        <pc:spChg chg="add mod">
          <ac:chgData name="Papaioannou, Ioannis" userId="27d0d6e0-1133-45d1-b366-9071ba1a55b0" providerId="ADAL" clId="{BA1F9235-DE2C-433E-8776-BF88F36CDC29}" dt="2022-07-11T21:37:29.284" v="1731" actId="1076"/>
          <ac:spMkLst>
            <pc:docMk/>
            <pc:sldMk cId="1783988844" sldId="256"/>
            <ac:spMk id="5" creationId="{9D7FE762-1A09-5608-35F3-82B99B644A3D}"/>
          </ac:spMkLst>
        </pc:spChg>
        <pc:spChg chg="add del mod">
          <ac:chgData name="Papaioannou, Ioannis" userId="27d0d6e0-1133-45d1-b366-9071ba1a55b0" providerId="ADAL" clId="{BA1F9235-DE2C-433E-8776-BF88F36CDC29}" dt="2022-06-23T12:00:23.989" v="2" actId="478"/>
          <ac:spMkLst>
            <pc:docMk/>
            <pc:sldMk cId="1783988844" sldId="256"/>
            <ac:spMk id="8" creationId="{FE4909A7-9228-0A01-7893-ED59CFB71A99}"/>
          </ac:spMkLst>
        </pc:spChg>
        <pc:spChg chg="add del mod">
          <ac:chgData name="Papaioannou, Ioannis" userId="27d0d6e0-1133-45d1-b366-9071ba1a55b0" providerId="ADAL" clId="{BA1F9235-DE2C-433E-8776-BF88F36CDC29}" dt="2022-06-23T12:00:23.989" v="2" actId="478"/>
          <ac:spMkLst>
            <pc:docMk/>
            <pc:sldMk cId="1783988844" sldId="256"/>
            <ac:spMk id="9" creationId="{1174DB97-CA17-D73C-A17B-3615AD4A3CA0}"/>
          </ac:spMkLst>
        </pc:spChg>
        <pc:spChg chg="add mod">
          <ac:chgData name="Papaioannou, Ioannis" userId="27d0d6e0-1133-45d1-b366-9071ba1a55b0" providerId="ADAL" clId="{BA1F9235-DE2C-433E-8776-BF88F36CDC29}" dt="2022-07-11T13:49:41.765" v="1461" actId="20577"/>
          <ac:spMkLst>
            <pc:docMk/>
            <pc:sldMk cId="1783988844" sldId="256"/>
            <ac:spMk id="10" creationId="{3C16DB6D-2F93-6176-465F-9A95D192B8D8}"/>
          </ac:spMkLst>
        </pc:spChg>
        <pc:spChg chg="add mod">
          <ac:chgData name="Papaioannou, Ioannis" userId="27d0d6e0-1133-45d1-b366-9071ba1a55b0" providerId="ADAL" clId="{BA1F9235-DE2C-433E-8776-BF88F36CDC29}" dt="2022-06-23T18:59:36.252" v="285" actId="1076"/>
          <ac:spMkLst>
            <pc:docMk/>
            <pc:sldMk cId="1783988844" sldId="256"/>
            <ac:spMk id="12" creationId="{D256E583-9CF0-7E8A-F921-602F81B40AEA}"/>
          </ac:spMkLst>
        </pc:spChg>
        <pc:spChg chg="add mod">
          <ac:chgData name="Papaioannou, Ioannis" userId="27d0d6e0-1133-45d1-b366-9071ba1a55b0" providerId="ADAL" clId="{BA1F9235-DE2C-433E-8776-BF88F36CDC29}" dt="2022-06-23T19:14:18.273" v="371" actId="14100"/>
          <ac:spMkLst>
            <pc:docMk/>
            <pc:sldMk cId="1783988844" sldId="256"/>
            <ac:spMk id="20" creationId="{B0EAA019-14C7-0F2C-E08F-973938194268}"/>
          </ac:spMkLst>
        </pc:spChg>
        <pc:spChg chg="add mod">
          <ac:chgData name="Papaioannou, Ioannis" userId="27d0d6e0-1133-45d1-b366-9071ba1a55b0" providerId="ADAL" clId="{BA1F9235-DE2C-433E-8776-BF88F36CDC29}" dt="2022-06-23T19:10:15.157" v="351" actId="14100"/>
          <ac:spMkLst>
            <pc:docMk/>
            <pc:sldMk cId="1783988844" sldId="256"/>
            <ac:spMk id="21" creationId="{A4196A9E-DBEE-CF70-F857-56E26493FEA9}"/>
          </ac:spMkLst>
        </pc:spChg>
        <pc:spChg chg="add mod">
          <ac:chgData name="Papaioannou, Ioannis" userId="27d0d6e0-1133-45d1-b366-9071ba1a55b0" providerId="ADAL" clId="{BA1F9235-DE2C-433E-8776-BF88F36CDC29}" dt="2022-06-23T19:13:51.540" v="369" actId="1037"/>
          <ac:spMkLst>
            <pc:docMk/>
            <pc:sldMk cId="1783988844" sldId="256"/>
            <ac:spMk id="24" creationId="{F863FC06-8519-5F15-A418-0A68892E4F59}"/>
          </ac:spMkLst>
        </pc:spChg>
        <pc:spChg chg="add mod">
          <ac:chgData name="Papaioannou, Ioannis" userId="27d0d6e0-1133-45d1-b366-9071ba1a55b0" providerId="ADAL" clId="{BA1F9235-DE2C-433E-8776-BF88F36CDC29}" dt="2022-06-23T19:16:46.540" v="389" actId="571"/>
          <ac:spMkLst>
            <pc:docMk/>
            <pc:sldMk cId="1783988844" sldId="256"/>
            <ac:spMk id="26" creationId="{E5E1AE59-8AD0-EE69-77C0-E60C4EE5CDF5}"/>
          </ac:spMkLst>
        </pc:spChg>
        <pc:spChg chg="add del mod">
          <ac:chgData name="Papaioannou, Ioannis" userId="27d0d6e0-1133-45d1-b366-9071ba1a55b0" providerId="ADAL" clId="{BA1F9235-DE2C-433E-8776-BF88F36CDC29}" dt="2022-07-11T20:46:58.997" v="1487" actId="478"/>
          <ac:spMkLst>
            <pc:docMk/>
            <pc:sldMk cId="1783988844" sldId="256"/>
            <ac:spMk id="27" creationId="{1149BCAA-72FB-BBBA-7265-E5807BB5723C}"/>
          </ac:spMkLst>
        </pc:spChg>
        <pc:spChg chg="add del mod">
          <ac:chgData name="Papaioannou, Ioannis" userId="27d0d6e0-1133-45d1-b366-9071ba1a55b0" providerId="ADAL" clId="{BA1F9235-DE2C-433E-8776-BF88F36CDC29}" dt="2022-07-11T20:46:58.997" v="1487" actId="478"/>
          <ac:spMkLst>
            <pc:docMk/>
            <pc:sldMk cId="1783988844" sldId="256"/>
            <ac:spMk id="28" creationId="{ABF343DD-F9FD-155E-7378-EB6D370C4AAC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30" creationId="{5CEF78FF-ADFB-A8FF-184F-485DC6606B0C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31" creationId="{86374ECE-64C9-A8E1-A3A8-346297EAFD2E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32" creationId="{838C40DD-2F8E-7615-4CBB-F0DAC70F40CB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33" creationId="{C423CA68-EA71-60EE-98B5-1EEF4F046444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34" creationId="{18AAF647-B14A-B9C1-11B9-83883E3F1199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35" creationId="{9E8A4B74-88C5-4698-3B5E-95987AA81E72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42" creationId="{61E3DF9F-400B-987F-26EA-CC8BD1A4A51C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43" creationId="{E6999153-FFF7-5D1F-6070-FAEA2E63A28C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44" creationId="{CAE1BDD1-07E5-7F57-7B0C-B87D3DF6D93F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45" creationId="{CBF372BD-39DE-B5FB-5CE6-5019E44A001D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46" creationId="{166CBB9D-E3EF-A4D3-9E2D-0EF519494799}"/>
          </ac:spMkLst>
        </pc:spChg>
        <pc:spChg chg="del mod">
          <ac:chgData name="Papaioannou, Ioannis" userId="27d0d6e0-1133-45d1-b366-9071ba1a55b0" providerId="ADAL" clId="{BA1F9235-DE2C-433E-8776-BF88F36CDC29}" dt="2022-06-24T10:45:36.159" v="471" actId="478"/>
          <ac:spMkLst>
            <pc:docMk/>
            <pc:sldMk cId="1783988844" sldId="256"/>
            <ac:spMk id="47" creationId="{0ED52E55-6E98-DD06-3818-4740E3107E60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50" creationId="{016F4E2B-A4D4-640D-EF7E-C5AC9B74F82F}"/>
          </ac:spMkLst>
        </pc:spChg>
        <pc:spChg chg="mod">
          <ac:chgData name="Papaioannou, Ioannis" userId="27d0d6e0-1133-45d1-b366-9071ba1a55b0" providerId="ADAL" clId="{BA1F9235-DE2C-433E-8776-BF88F36CDC29}" dt="2022-06-24T10:44:41.355" v="406"/>
          <ac:spMkLst>
            <pc:docMk/>
            <pc:sldMk cId="1783988844" sldId="256"/>
            <ac:spMk id="51" creationId="{D513605D-62BC-4423-6A86-03F33077BB2E}"/>
          </ac:spMkLst>
        </pc:spChg>
        <pc:spChg chg="add del mod">
          <ac:chgData name="Papaioannou, Ioannis" userId="27d0d6e0-1133-45d1-b366-9071ba1a55b0" providerId="ADAL" clId="{BA1F9235-DE2C-433E-8776-BF88F36CDC29}" dt="2022-06-24T10:45:32.666" v="470" actId="478"/>
          <ac:spMkLst>
            <pc:docMk/>
            <pc:sldMk cId="1783988844" sldId="256"/>
            <ac:spMk id="52" creationId="{6085534C-B217-C6D9-6C9C-3F4C37CA84C3}"/>
          </ac:spMkLst>
        </pc:spChg>
        <pc:spChg chg="add mod">
          <ac:chgData name="Papaioannou, Ioannis" userId="27d0d6e0-1133-45d1-b366-9071ba1a55b0" providerId="ADAL" clId="{BA1F9235-DE2C-433E-8776-BF88F36CDC29}" dt="2022-07-11T20:48:18.793" v="1513" actId="14100"/>
          <ac:spMkLst>
            <pc:docMk/>
            <pc:sldMk cId="1783988844" sldId="256"/>
            <ac:spMk id="52" creationId="{B8B10DE2-B391-73D4-52B1-ACFA9832A867}"/>
          </ac:spMkLst>
        </pc:spChg>
        <pc:spChg chg="add mod">
          <ac:chgData name="Papaioannou, Ioannis" userId="27d0d6e0-1133-45d1-b366-9071ba1a55b0" providerId="ADAL" clId="{BA1F9235-DE2C-433E-8776-BF88F36CDC29}" dt="2022-07-11T21:37:38.130" v="1736" actId="20577"/>
          <ac:spMkLst>
            <pc:docMk/>
            <pc:sldMk cId="1783988844" sldId="256"/>
            <ac:spMk id="53" creationId="{9499A77C-133B-137E-36E8-DF4383C196E0}"/>
          </ac:spMkLst>
        </pc:spChg>
        <pc:spChg chg="add mod">
          <ac:chgData name="Papaioannou, Ioannis" userId="27d0d6e0-1133-45d1-b366-9071ba1a55b0" providerId="ADAL" clId="{BA1F9235-DE2C-433E-8776-BF88F36CDC29}" dt="2022-07-11T21:37:45.058" v="1742" actId="20577"/>
          <ac:spMkLst>
            <pc:docMk/>
            <pc:sldMk cId="1783988844" sldId="256"/>
            <ac:spMk id="54" creationId="{9148308D-6424-4DA9-DCA3-6D2E41261E43}"/>
          </ac:spMkLst>
        </pc:spChg>
        <pc:spChg chg="add mod">
          <ac:chgData name="Papaioannou, Ioannis" userId="27d0d6e0-1133-45d1-b366-9071ba1a55b0" providerId="ADAL" clId="{BA1F9235-DE2C-433E-8776-BF88F36CDC29}" dt="2022-07-11T21:37:51.169" v="1748" actId="20577"/>
          <ac:spMkLst>
            <pc:docMk/>
            <pc:sldMk cId="1783988844" sldId="256"/>
            <ac:spMk id="55" creationId="{B83B2295-32E6-F04B-FB94-F4D50DF273AE}"/>
          </ac:spMkLst>
        </pc:spChg>
        <pc:spChg chg="add mod">
          <ac:chgData name="Papaioannou, Ioannis" userId="27d0d6e0-1133-45d1-b366-9071ba1a55b0" providerId="ADAL" clId="{BA1F9235-DE2C-433E-8776-BF88F36CDC29}" dt="2022-07-11T21:37:59.306" v="1754" actId="20577"/>
          <ac:spMkLst>
            <pc:docMk/>
            <pc:sldMk cId="1783988844" sldId="256"/>
            <ac:spMk id="56" creationId="{45B78F05-C527-208C-A656-3CE7EF5FCD66}"/>
          </ac:spMkLst>
        </pc:spChg>
        <pc:spChg chg="add mod">
          <ac:chgData name="Papaioannou, Ioannis" userId="27d0d6e0-1133-45d1-b366-9071ba1a55b0" providerId="ADAL" clId="{BA1F9235-DE2C-433E-8776-BF88F36CDC29}" dt="2022-07-11T21:38:08.132" v="1759" actId="20577"/>
          <ac:spMkLst>
            <pc:docMk/>
            <pc:sldMk cId="1783988844" sldId="256"/>
            <ac:spMk id="59" creationId="{F57E4BA0-240F-CF88-CA79-62BEA686ECCA}"/>
          </ac:spMkLst>
        </pc:spChg>
        <pc:grpChg chg="add del mod">
          <ac:chgData name="Papaioannou, Ioannis" userId="27d0d6e0-1133-45d1-b366-9071ba1a55b0" providerId="ADAL" clId="{BA1F9235-DE2C-433E-8776-BF88F36CDC29}" dt="2022-07-11T21:34:22.957" v="1721" actId="478"/>
          <ac:grpSpMkLst>
            <pc:docMk/>
            <pc:sldMk cId="1783988844" sldId="256"/>
            <ac:grpSpMk id="29" creationId="{C41B061A-F47E-F675-8D83-324E15756B15}"/>
          </ac:grpSpMkLst>
        </pc:grpChg>
        <pc:picChg chg="add del mod">
          <ac:chgData name="Papaioannou, Ioannis" userId="27d0d6e0-1133-45d1-b366-9071ba1a55b0" providerId="ADAL" clId="{BA1F9235-DE2C-433E-8776-BF88F36CDC29}" dt="2022-06-23T12:00:23.989" v="2" actId="478"/>
          <ac:picMkLst>
            <pc:docMk/>
            <pc:sldMk cId="1783988844" sldId="256"/>
            <ac:picMk id="4" creationId="{299549C5-86E6-9CB7-7AB7-82818A33D857}"/>
          </ac:picMkLst>
        </pc:picChg>
        <pc:picChg chg="add mod">
          <ac:chgData name="Papaioannou, Ioannis" userId="27d0d6e0-1133-45d1-b366-9071ba1a55b0" providerId="ADAL" clId="{BA1F9235-DE2C-433E-8776-BF88F36CDC29}" dt="2022-07-11T21:34:46.026" v="1725" actId="1076"/>
          <ac:picMkLst>
            <pc:docMk/>
            <pc:sldMk cId="1783988844" sldId="256"/>
            <ac:picMk id="4" creationId="{A7A64092-2C6B-47DF-EE61-3B35709A846A}"/>
          </ac:picMkLst>
        </pc:picChg>
        <pc:picChg chg="add del mod">
          <ac:chgData name="Papaioannou, Ioannis" userId="27d0d6e0-1133-45d1-b366-9071ba1a55b0" providerId="ADAL" clId="{BA1F9235-DE2C-433E-8776-BF88F36CDC29}" dt="2022-06-23T12:00:23.989" v="2" actId="478"/>
          <ac:picMkLst>
            <pc:docMk/>
            <pc:sldMk cId="1783988844" sldId="256"/>
            <ac:picMk id="5" creationId="{6182131C-671E-0AF5-4D79-C9BE1FCD81C1}"/>
          </ac:picMkLst>
        </pc:picChg>
        <pc:picChg chg="add del mod">
          <ac:chgData name="Papaioannou, Ioannis" userId="27d0d6e0-1133-45d1-b366-9071ba1a55b0" providerId="ADAL" clId="{BA1F9235-DE2C-433E-8776-BF88F36CDC29}" dt="2022-06-23T12:00:23.989" v="2" actId="478"/>
          <ac:picMkLst>
            <pc:docMk/>
            <pc:sldMk cId="1783988844" sldId="256"/>
            <ac:picMk id="6" creationId="{B05F2605-80C6-5976-5FAA-6EF165F0DD37}"/>
          </ac:picMkLst>
        </pc:picChg>
        <pc:picChg chg="add del mod">
          <ac:chgData name="Papaioannou, Ioannis" userId="27d0d6e0-1133-45d1-b366-9071ba1a55b0" providerId="ADAL" clId="{BA1F9235-DE2C-433E-8776-BF88F36CDC29}" dt="2022-06-23T12:00:23.989" v="2" actId="478"/>
          <ac:picMkLst>
            <pc:docMk/>
            <pc:sldMk cId="1783988844" sldId="256"/>
            <ac:picMk id="7" creationId="{889D98B4-24E0-742E-4054-D7F56B394B79}"/>
          </ac:picMkLst>
        </pc:picChg>
        <pc:picChg chg="add mod modCrop">
          <ac:chgData name="Papaioannou, Ioannis" userId="27d0d6e0-1133-45d1-b366-9071ba1a55b0" providerId="ADAL" clId="{BA1F9235-DE2C-433E-8776-BF88F36CDC29}" dt="2022-06-23T18:59:36.252" v="285" actId="1076"/>
          <ac:picMkLst>
            <pc:docMk/>
            <pc:sldMk cId="1783988844" sldId="256"/>
            <ac:picMk id="11" creationId="{63A0BF3A-AF5F-5870-F66F-2BE69BC3DEF8}"/>
          </ac:picMkLst>
        </pc:picChg>
        <pc:picChg chg="add del mod">
          <ac:chgData name="Papaioannou, Ioannis" userId="27d0d6e0-1133-45d1-b366-9071ba1a55b0" providerId="ADAL" clId="{BA1F9235-DE2C-433E-8776-BF88F36CDC29}" dt="2022-06-24T10:44:28.811" v="405" actId="22"/>
          <ac:picMkLst>
            <pc:docMk/>
            <pc:sldMk cId="1783988844" sldId="256"/>
            <ac:picMk id="14" creationId="{D486C192-2BE5-9140-C8D4-5D8DD23DA3B5}"/>
          </ac:picMkLst>
        </pc:picChg>
        <pc:picChg chg="add del mod modCrop">
          <ac:chgData name="Papaioannou, Ioannis" userId="27d0d6e0-1133-45d1-b366-9071ba1a55b0" providerId="ADAL" clId="{BA1F9235-DE2C-433E-8776-BF88F36CDC29}" dt="2022-06-23T19:06:48.262" v="311"/>
          <ac:picMkLst>
            <pc:docMk/>
            <pc:sldMk cId="1783988844" sldId="256"/>
            <ac:picMk id="17" creationId="{BF8E0465-C3E7-9BB6-8620-40F20CD27DF0}"/>
          </ac:picMkLst>
        </pc:picChg>
        <pc:picChg chg="add del mod">
          <ac:chgData name="Papaioannou, Ioannis" userId="27d0d6e0-1133-45d1-b366-9071ba1a55b0" providerId="ADAL" clId="{BA1F9235-DE2C-433E-8776-BF88F36CDC29}" dt="2022-06-23T19:07:00.988" v="326" actId="21"/>
          <ac:picMkLst>
            <pc:docMk/>
            <pc:sldMk cId="1783988844" sldId="256"/>
            <ac:picMk id="18" creationId="{24554C53-61B8-55A7-1DCC-00871C1701E8}"/>
          </ac:picMkLst>
        </pc:picChg>
        <pc:picChg chg="add mod modCrop">
          <ac:chgData name="Papaioannou, Ioannis" userId="27d0d6e0-1133-45d1-b366-9071ba1a55b0" providerId="ADAL" clId="{BA1F9235-DE2C-433E-8776-BF88F36CDC29}" dt="2022-07-11T13:50:13.211" v="1465" actId="1076"/>
          <ac:picMkLst>
            <pc:docMk/>
            <pc:sldMk cId="1783988844" sldId="256"/>
            <ac:picMk id="19" creationId="{BC7D0C30-9751-A5A0-8F65-295055330FF7}"/>
          </ac:picMkLst>
        </pc:picChg>
        <pc:picChg chg="add del mod">
          <ac:chgData name="Papaioannou, Ioannis" userId="27d0d6e0-1133-45d1-b366-9071ba1a55b0" providerId="ADAL" clId="{BA1F9235-DE2C-433E-8776-BF88F36CDC29}" dt="2022-06-23T19:12:41.146" v="355" actId="21"/>
          <ac:picMkLst>
            <pc:docMk/>
            <pc:sldMk cId="1783988844" sldId="256"/>
            <ac:picMk id="22" creationId="{3392F722-FB69-2147-DF06-A0323284E9D4}"/>
          </ac:picMkLst>
        </pc:picChg>
        <pc:picChg chg="add mod modCrop">
          <ac:chgData name="Papaioannou, Ioannis" userId="27d0d6e0-1133-45d1-b366-9071ba1a55b0" providerId="ADAL" clId="{BA1F9235-DE2C-433E-8776-BF88F36CDC29}" dt="2022-06-23T19:13:49.209" v="368" actId="14100"/>
          <ac:picMkLst>
            <pc:docMk/>
            <pc:sldMk cId="1783988844" sldId="256"/>
            <ac:picMk id="23" creationId="{2BC06D45-542B-2253-6C24-06633B7B0B9D}"/>
          </ac:picMkLst>
        </pc:picChg>
        <pc:picChg chg="add mod modCrop">
          <ac:chgData name="Papaioannou, Ioannis" userId="27d0d6e0-1133-45d1-b366-9071ba1a55b0" providerId="ADAL" clId="{BA1F9235-DE2C-433E-8776-BF88F36CDC29}" dt="2022-06-23T19:16:35.638" v="388" actId="197"/>
          <ac:picMkLst>
            <pc:docMk/>
            <pc:sldMk cId="1783988844" sldId="256"/>
            <ac:picMk id="25" creationId="{F2F2D079-D5C2-B4B0-73B0-BF6670D90E42}"/>
          </ac:picMkLst>
        </pc:picChg>
        <pc:picChg chg="mod">
          <ac:chgData name="Papaioannou, Ioannis" userId="27d0d6e0-1133-45d1-b366-9071ba1a55b0" providerId="ADAL" clId="{BA1F9235-DE2C-433E-8776-BF88F36CDC29}" dt="2022-06-24T10:44:41.355" v="406"/>
          <ac:picMkLst>
            <pc:docMk/>
            <pc:sldMk cId="1783988844" sldId="256"/>
            <ac:picMk id="36" creationId="{728305BB-75B5-DB2B-9C44-D1DD81636557}"/>
          </ac:picMkLst>
        </pc:picChg>
        <pc:picChg chg="mod">
          <ac:chgData name="Papaioannou, Ioannis" userId="27d0d6e0-1133-45d1-b366-9071ba1a55b0" providerId="ADAL" clId="{BA1F9235-DE2C-433E-8776-BF88F36CDC29}" dt="2022-06-24T10:44:41.355" v="406"/>
          <ac:picMkLst>
            <pc:docMk/>
            <pc:sldMk cId="1783988844" sldId="256"/>
            <ac:picMk id="37" creationId="{C510CE7E-2C0A-60FC-5486-0FF1AEBD6285}"/>
          </ac:picMkLst>
        </pc:picChg>
        <pc:picChg chg="mod">
          <ac:chgData name="Papaioannou, Ioannis" userId="27d0d6e0-1133-45d1-b366-9071ba1a55b0" providerId="ADAL" clId="{BA1F9235-DE2C-433E-8776-BF88F36CDC29}" dt="2022-06-24T10:44:41.355" v="406"/>
          <ac:picMkLst>
            <pc:docMk/>
            <pc:sldMk cId="1783988844" sldId="256"/>
            <ac:picMk id="38" creationId="{9F6DE045-0341-0BC9-B1F2-4353F984A610}"/>
          </ac:picMkLst>
        </pc:picChg>
        <pc:picChg chg="mod">
          <ac:chgData name="Papaioannou, Ioannis" userId="27d0d6e0-1133-45d1-b366-9071ba1a55b0" providerId="ADAL" clId="{BA1F9235-DE2C-433E-8776-BF88F36CDC29}" dt="2022-06-24T10:44:41.355" v="406"/>
          <ac:picMkLst>
            <pc:docMk/>
            <pc:sldMk cId="1783988844" sldId="256"/>
            <ac:picMk id="39" creationId="{04583A96-0CA2-E083-1AF4-987EF01D9FAC}"/>
          </ac:picMkLst>
        </pc:picChg>
        <pc:picChg chg="mod">
          <ac:chgData name="Papaioannou, Ioannis" userId="27d0d6e0-1133-45d1-b366-9071ba1a55b0" providerId="ADAL" clId="{BA1F9235-DE2C-433E-8776-BF88F36CDC29}" dt="2022-06-24T10:44:41.355" v="406"/>
          <ac:picMkLst>
            <pc:docMk/>
            <pc:sldMk cId="1783988844" sldId="256"/>
            <ac:picMk id="40" creationId="{F7B34101-79E0-B5FF-432F-7167516A7778}"/>
          </ac:picMkLst>
        </pc:picChg>
        <pc:picChg chg="mod">
          <ac:chgData name="Papaioannou, Ioannis" userId="27d0d6e0-1133-45d1-b366-9071ba1a55b0" providerId="ADAL" clId="{BA1F9235-DE2C-433E-8776-BF88F36CDC29}" dt="2022-06-24T10:44:41.355" v="406"/>
          <ac:picMkLst>
            <pc:docMk/>
            <pc:sldMk cId="1783988844" sldId="256"/>
            <ac:picMk id="41" creationId="{878800A4-9697-09BF-E03A-278550A9880A}"/>
          </ac:picMkLst>
        </pc:picChg>
        <pc:picChg chg="add mod">
          <ac:chgData name="Papaioannou, Ioannis" userId="27d0d6e0-1133-45d1-b366-9071ba1a55b0" providerId="ADAL" clId="{BA1F9235-DE2C-433E-8776-BF88F36CDC29}" dt="2022-07-11T20:48:08.883" v="1511" actId="1076"/>
          <ac:picMkLst>
            <pc:docMk/>
            <pc:sldMk cId="1783988844" sldId="256"/>
            <ac:picMk id="47" creationId="{0AA1B274-6237-EF6E-8A44-41F8152C56AC}"/>
          </ac:picMkLst>
        </pc:picChg>
        <pc:picChg chg="add del mod">
          <ac:chgData name="Papaioannou, Ioannis" userId="27d0d6e0-1133-45d1-b366-9071ba1a55b0" providerId="ADAL" clId="{BA1F9235-DE2C-433E-8776-BF88F36CDC29}" dt="2022-07-11T20:46:58.997" v="1487" actId="478"/>
          <ac:picMkLst>
            <pc:docMk/>
            <pc:sldMk cId="1783988844" sldId="256"/>
            <ac:picMk id="57" creationId="{9DFB6FA0-247F-00F9-1DDE-317AB12C005B}"/>
          </ac:picMkLst>
        </pc:picChg>
        <pc:picChg chg="add del mod">
          <ac:chgData name="Papaioannou, Ioannis" userId="27d0d6e0-1133-45d1-b366-9071ba1a55b0" providerId="ADAL" clId="{BA1F9235-DE2C-433E-8776-BF88F36CDC29}" dt="2022-07-11T20:46:58.997" v="1487" actId="478"/>
          <ac:picMkLst>
            <pc:docMk/>
            <pc:sldMk cId="1783988844" sldId="256"/>
            <ac:picMk id="58" creationId="{8F98EEA9-BA2D-08C7-1ADF-8D41C6885C26}"/>
          </ac:picMkLst>
        </pc:picChg>
        <pc:picChg chg="add del mod">
          <ac:chgData name="Papaioannou, Ioannis" userId="27d0d6e0-1133-45d1-b366-9071ba1a55b0" providerId="ADAL" clId="{BA1F9235-DE2C-433E-8776-BF88F36CDC29}" dt="2022-06-23T19:06:52.658" v="323"/>
          <ac:picMkLst>
            <pc:docMk/>
            <pc:sldMk cId="1783988844" sldId="256"/>
            <ac:picMk id="1026" creationId="{6623D5AC-5D00-3629-BD23-8B374FC7ECD7}"/>
          </ac:picMkLst>
        </pc:picChg>
        <pc:picChg chg="add del mod">
          <ac:chgData name="Papaioannou, Ioannis" userId="27d0d6e0-1133-45d1-b366-9071ba1a55b0" providerId="ADAL" clId="{BA1F9235-DE2C-433E-8776-BF88F36CDC29}" dt="2022-06-23T19:06:52.658" v="323"/>
          <ac:picMkLst>
            <pc:docMk/>
            <pc:sldMk cId="1783988844" sldId="256"/>
            <ac:picMk id="1027" creationId="{DB06C46A-E1E0-3615-C7FB-83D87D3152F6}"/>
          </ac:picMkLst>
        </pc:picChg>
        <pc:picChg chg="add del mod">
          <ac:chgData name="Papaioannou, Ioannis" userId="27d0d6e0-1133-45d1-b366-9071ba1a55b0" providerId="ADAL" clId="{BA1F9235-DE2C-433E-8776-BF88F36CDC29}" dt="2022-06-23T19:06:52.658" v="323"/>
          <ac:picMkLst>
            <pc:docMk/>
            <pc:sldMk cId="1783988844" sldId="256"/>
            <ac:picMk id="1028" creationId="{7F394BC3-211E-7751-A4B4-F59E03E22106}"/>
          </ac:picMkLst>
        </pc:picChg>
        <pc:picChg chg="add del mod">
          <ac:chgData name="Papaioannou, Ioannis" userId="27d0d6e0-1133-45d1-b366-9071ba1a55b0" providerId="ADAL" clId="{BA1F9235-DE2C-433E-8776-BF88F36CDC29}" dt="2022-06-23T19:06:52.658" v="323"/>
          <ac:picMkLst>
            <pc:docMk/>
            <pc:sldMk cId="1783988844" sldId="256"/>
            <ac:picMk id="1029" creationId="{B724B1B3-564A-6FA3-C1B7-47B6903A3095}"/>
          </ac:picMkLst>
        </pc:picChg>
        <pc:cxnChg chg="add del mod">
          <ac:chgData name="Papaioannou, Ioannis" userId="27d0d6e0-1133-45d1-b366-9071ba1a55b0" providerId="ADAL" clId="{BA1F9235-DE2C-433E-8776-BF88F36CDC29}" dt="2022-07-11T20:46:58.997" v="1487" actId="478"/>
          <ac:cxnSpMkLst>
            <pc:docMk/>
            <pc:sldMk cId="1783988844" sldId="256"/>
            <ac:cxnSpMk id="16" creationId="{633985A3-B770-1E90-05EC-75CF3D4653A5}"/>
          </ac:cxnSpMkLst>
        </pc:cxnChg>
        <pc:cxnChg chg="mod">
          <ac:chgData name="Papaioannou, Ioannis" userId="27d0d6e0-1133-45d1-b366-9071ba1a55b0" providerId="ADAL" clId="{BA1F9235-DE2C-433E-8776-BF88F36CDC29}" dt="2022-06-24T10:44:41.355" v="406"/>
          <ac:cxnSpMkLst>
            <pc:docMk/>
            <pc:sldMk cId="1783988844" sldId="256"/>
            <ac:cxnSpMk id="48" creationId="{B03C88EF-F50B-EA95-7CFA-4CCA3D933CEE}"/>
          </ac:cxnSpMkLst>
        </pc:cxnChg>
        <pc:cxnChg chg="mod">
          <ac:chgData name="Papaioannou, Ioannis" userId="27d0d6e0-1133-45d1-b366-9071ba1a55b0" providerId="ADAL" clId="{BA1F9235-DE2C-433E-8776-BF88F36CDC29}" dt="2022-06-24T10:44:41.355" v="406"/>
          <ac:cxnSpMkLst>
            <pc:docMk/>
            <pc:sldMk cId="1783988844" sldId="256"/>
            <ac:cxnSpMk id="49" creationId="{A47574C2-8E95-0111-A10F-649DDB39D814}"/>
          </ac:cxnSpMkLst>
        </pc:cxnChg>
      </pc:sldChg>
      <pc:sldChg chg="addSp delSp modSp add mod">
        <pc:chgData name="Papaioannou, Ioannis" userId="27d0d6e0-1133-45d1-b366-9071ba1a55b0" providerId="ADAL" clId="{BA1F9235-DE2C-433E-8776-BF88F36CDC29}" dt="2022-07-19T14:57:23.832" v="1766" actId="1076"/>
        <pc:sldMkLst>
          <pc:docMk/>
          <pc:sldMk cId="1419449853" sldId="257"/>
        </pc:sldMkLst>
        <pc:spChg chg="add mod">
          <ac:chgData name="Papaioannou, Ioannis" userId="27d0d6e0-1133-45d1-b366-9071ba1a55b0" providerId="ADAL" clId="{BA1F9235-DE2C-433E-8776-BF88F36CDC29}" dt="2022-07-11T13:49:45.238" v="1463" actId="20577"/>
          <ac:spMkLst>
            <pc:docMk/>
            <pc:sldMk cId="1419449853" sldId="257"/>
            <ac:spMk id="2" creationId="{D43F6FFC-58D9-8AC3-B022-60F9050BEFE6}"/>
          </ac:spMkLst>
        </pc:spChg>
        <pc:spChg chg="add mod">
          <ac:chgData name="Papaioannou, Ioannis" userId="27d0d6e0-1133-45d1-b366-9071ba1a55b0" providerId="ADAL" clId="{BA1F9235-DE2C-433E-8776-BF88F36CDC29}" dt="2022-07-19T14:57:23.832" v="1766" actId="1076"/>
          <ac:spMkLst>
            <pc:docMk/>
            <pc:sldMk cId="1419449853" sldId="257"/>
            <ac:spMk id="3" creationId="{FE5EEAF1-A486-2503-5C01-6EB8BF1AEEC9}"/>
          </ac:spMkLst>
        </pc:spChg>
        <pc:spChg chg="add del mod">
          <ac:chgData name="Papaioannou, Ioannis" userId="27d0d6e0-1133-45d1-b366-9071ba1a55b0" providerId="ADAL" clId="{BA1F9235-DE2C-433E-8776-BF88F36CDC29}" dt="2022-07-11T21:04:52.741" v="1633" actId="1076"/>
          <ac:spMkLst>
            <pc:docMk/>
            <pc:sldMk cId="1419449853" sldId="257"/>
            <ac:spMk id="5" creationId="{15762434-B673-84A5-B31D-C533133E0AEB}"/>
          </ac:spMkLst>
        </pc:spChg>
        <pc:spChg chg="del">
          <ac:chgData name="Papaioannou, Ioannis" userId="27d0d6e0-1133-45d1-b366-9071ba1a55b0" providerId="ADAL" clId="{BA1F9235-DE2C-433E-8776-BF88F36CDC29}" dt="2022-06-23T12:00:27.107" v="4" actId="478"/>
          <ac:spMkLst>
            <pc:docMk/>
            <pc:sldMk cId="1419449853" sldId="257"/>
            <ac:spMk id="11" creationId="{00000000-0000-0000-0000-000000000000}"/>
          </ac:spMkLst>
        </pc:spChg>
        <pc:spChg chg="add mod">
          <ac:chgData name="Papaioannou, Ioannis" userId="27d0d6e0-1133-45d1-b366-9071ba1a55b0" providerId="ADAL" clId="{BA1F9235-DE2C-433E-8776-BF88F36CDC29}" dt="2022-07-19T14:57:23.832" v="1766" actId="1076"/>
          <ac:spMkLst>
            <pc:docMk/>
            <pc:sldMk cId="1419449853" sldId="257"/>
            <ac:spMk id="11" creationId="{B1E772CA-BA61-D220-47D3-ABF571A4256F}"/>
          </ac:spMkLst>
        </pc:spChg>
        <pc:spChg chg="del">
          <ac:chgData name="Papaioannou, Ioannis" userId="27d0d6e0-1133-45d1-b366-9071ba1a55b0" providerId="ADAL" clId="{BA1F9235-DE2C-433E-8776-BF88F36CDC29}" dt="2022-06-23T12:00:27.107" v="4" actId="478"/>
          <ac:spMkLst>
            <pc:docMk/>
            <pc:sldMk cId="1419449853" sldId="257"/>
            <ac:spMk id="12" creationId="{00000000-0000-0000-0000-000000000000}"/>
          </ac:spMkLst>
        </pc:spChg>
        <pc:spChg chg="add mod">
          <ac:chgData name="Papaioannou, Ioannis" userId="27d0d6e0-1133-45d1-b366-9071ba1a55b0" providerId="ADAL" clId="{BA1F9235-DE2C-433E-8776-BF88F36CDC29}" dt="2022-07-11T21:04:52.741" v="1633" actId="1076"/>
          <ac:spMkLst>
            <pc:docMk/>
            <pc:sldMk cId="1419449853" sldId="257"/>
            <ac:spMk id="12" creationId="{614B11ED-CE24-366F-9772-12F5F5D7DBA0}"/>
          </ac:spMkLst>
        </pc:spChg>
        <pc:spChg chg="add mod">
          <ac:chgData name="Papaioannou, Ioannis" userId="27d0d6e0-1133-45d1-b366-9071ba1a55b0" providerId="ADAL" clId="{BA1F9235-DE2C-433E-8776-BF88F36CDC29}" dt="2022-07-11T21:04:56.637" v="1634" actId="1076"/>
          <ac:spMkLst>
            <pc:docMk/>
            <pc:sldMk cId="1419449853" sldId="257"/>
            <ac:spMk id="14" creationId="{D44C349A-8029-7967-927A-CE516B9B6631}"/>
          </ac:spMkLst>
        </pc:spChg>
        <pc:spChg chg="add mod">
          <ac:chgData name="Papaioannou, Ioannis" userId="27d0d6e0-1133-45d1-b366-9071ba1a55b0" providerId="ADAL" clId="{BA1F9235-DE2C-433E-8776-BF88F36CDC29}" dt="2022-07-11T21:04:56.637" v="1634" actId="1076"/>
          <ac:spMkLst>
            <pc:docMk/>
            <pc:sldMk cId="1419449853" sldId="257"/>
            <ac:spMk id="15" creationId="{3AB294E5-BFA6-E6CD-7AEF-152F22D9DAA6}"/>
          </ac:spMkLst>
        </pc:spChg>
        <pc:spChg chg="add del mod">
          <ac:chgData name="Papaioannou, Ioannis" userId="27d0d6e0-1133-45d1-b366-9071ba1a55b0" providerId="ADAL" clId="{BA1F9235-DE2C-433E-8776-BF88F36CDC29}" dt="2022-07-11T21:32:27.042" v="1718"/>
          <ac:spMkLst>
            <pc:docMk/>
            <pc:sldMk cId="1419449853" sldId="257"/>
            <ac:spMk id="17" creationId="{D4C83F25-5B53-9425-9305-C419BF433D03}"/>
          </ac:spMkLst>
        </pc:spChg>
        <pc:spChg chg="add mod">
          <ac:chgData name="Papaioannou, Ioannis" userId="27d0d6e0-1133-45d1-b366-9071ba1a55b0" providerId="ADAL" clId="{BA1F9235-DE2C-433E-8776-BF88F36CDC29}" dt="2022-07-19T14:57:23.832" v="1766" actId="1076"/>
          <ac:spMkLst>
            <pc:docMk/>
            <pc:sldMk cId="1419449853" sldId="257"/>
            <ac:spMk id="18" creationId="{627A2E1D-4C02-2536-C8DA-130733F31E3A}"/>
          </ac:spMkLst>
        </pc:spChg>
        <pc:picChg chg="mod">
          <ac:chgData name="Papaioannou, Ioannis" userId="27d0d6e0-1133-45d1-b366-9071ba1a55b0" providerId="ADAL" clId="{BA1F9235-DE2C-433E-8776-BF88F36CDC29}" dt="2022-07-19T14:57:23.832" v="1766" actId="1076"/>
          <ac:picMkLst>
            <pc:docMk/>
            <pc:sldMk cId="1419449853" sldId="257"/>
            <ac:picMk id="4" creationId="{00000000-0000-0000-0000-000000000000}"/>
          </ac:picMkLst>
        </pc:picChg>
        <pc:picChg chg="mod modCrop">
          <ac:chgData name="Papaioannou, Ioannis" userId="27d0d6e0-1133-45d1-b366-9071ba1a55b0" providerId="ADAL" clId="{BA1F9235-DE2C-433E-8776-BF88F36CDC29}" dt="2022-07-11T21:04:52.741" v="1633" actId="1076"/>
          <ac:picMkLst>
            <pc:docMk/>
            <pc:sldMk cId="1419449853" sldId="257"/>
            <ac:picMk id="6" creationId="{00000000-0000-0000-0000-000000000000}"/>
          </ac:picMkLst>
        </pc:picChg>
        <pc:picChg chg="del">
          <ac:chgData name="Papaioannou, Ioannis" userId="27d0d6e0-1133-45d1-b366-9071ba1a55b0" providerId="ADAL" clId="{BA1F9235-DE2C-433E-8776-BF88F36CDC29}" dt="2022-06-23T12:00:27.107" v="4" actId="478"/>
          <ac:picMkLst>
            <pc:docMk/>
            <pc:sldMk cId="1419449853" sldId="257"/>
            <ac:picMk id="7" creationId="{00000000-0000-0000-0000-000000000000}"/>
          </ac:picMkLst>
        </pc:picChg>
        <pc:picChg chg="del">
          <ac:chgData name="Papaioannou, Ioannis" userId="27d0d6e0-1133-45d1-b366-9071ba1a55b0" providerId="ADAL" clId="{BA1F9235-DE2C-433E-8776-BF88F36CDC29}" dt="2022-06-23T12:00:27.107" v="4" actId="478"/>
          <ac:picMkLst>
            <pc:docMk/>
            <pc:sldMk cId="1419449853" sldId="257"/>
            <ac:picMk id="8" creationId="{00000000-0000-0000-0000-000000000000}"/>
          </ac:picMkLst>
        </pc:picChg>
        <pc:picChg chg="del">
          <ac:chgData name="Papaioannou, Ioannis" userId="27d0d6e0-1133-45d1-b366-9071ba1a55b0" providerId="ADAL" clId="{BA1F9235-DE2C-433E-8776-BF88F36CDC29}" dt="2022-06-23T12:00:27.107" v="4" actId="478"/>
          <ac:picMkLst>
            <pc:docMk/>
            <pc:sldMk cId="1419449853" sldId="257"/>
            <ac:picMk id="9" creationId="{6ABC8B4E-8D82-412C-AB63-947398290A47}"/>
          </ac:picMkLst>
        </pc:picChg>
        <pc:picChg chg="del">
          <ac:chgData name="Papaioannou, Ioannis" userId="27d0d6e0-1133-45d1-b366-9071ba1a55b0" providerId="ADAL" clId="{BA1F9235-DE2C-433E-8776-BF88F36CDC29}" dt="2022-06-23T12:00:27.107" v="4" actId="478"/>
          <ac:picMkLst>
            <pc:docMk/>
            <pc:sldMk cId="1419449853" sldId="257"/>
            <ac:picMk id="10" creationId="{042C0231-D2E9-4888-86D1-61E73C4C35ED}"/>
          </ac:picMkLst>
        </pc:picChg>
        <pc:picChg chg="add mod">
          <ac:chgData name="Papaioannou, Ioannis" userId="27d0d6e0-1133-45d1-b366-9071ba1a55b0" providerId="ADAL" clId="{BA1F9235-DE2C-433E-8776-BF88F36CDC29}" dt="2022-07-11T21:04:56.637" v="1634" actId="1076"/>
          <ac:picMkLst>
            <pc:docMk/>
            <pc:sldMk cId="1419449853" sldId="257"/>
            <ac:picMk id="13" creationId="{A7805FDF-A19C-01D8-73F5-280AD1380105}"/>
          </ac:picMkLst>
        </pc:picChg>
        <pc:picChg chg="add mod">
          <ac:chgData name="Papaioannou, Ioannis" userId="27d0d6e0-1133-45d1-b366-9071ba1a55b0" providerId="ADAL" clId="{BA1F9235-DE2C-433E-8776-BF88F36CDC29}" dt="2022-07-11T21:04:56.637" v="1634" actId="1076"/>
          <ac:picMkLst>
            <pc:docMk/>
            <pc:sldMk cId="1419449853" sldId="257"/>
            <ac:picMk id="16" creationId="{76736938-7694-00B1-8E26-324A6C813F60}"/>
          </ac:picMkLst>
        </pc:picChg>
      </pc:sldChg>
      <pc:sldChg chg="addSp delSp modSp new mod">
        <pc:chgData name="Papaioannou, Ioannis" userId="27d0d6e0-1133-45d1-b366-9071ba1a55b0" providerId="ADAL" clId="{BA1F9235-DE2C-433E-8776-BF88F36CDC29}" dt="2022-07-11T21:05:42.318" v="1645" actId="1076"/>
        <pc:sldMkLst>
          <pc:docMk/>
          <pc:sldMk cId="2731541974" sldId="258"/>
        </pc:sldMkLst>
        <pc:spChg chg="add mod">
          <ac:chgData name="Papaioannou, Ioannis" userId="27d0d6e0-1133-45d1-b366-9071ba1a55b0" providerId="ADAL" clId="{BA1F9235-DE2C-433E-8776-BF88F36CDC29}" dt="2022-07-11T21:04:23.126" v="1625" actId="1076"/>
          <ac:spMkLst>
            <pc:docMk/>
            <pc:sldMk cId="2731541974" sldId="258"/>
            <ac:spMk id="2" creationId="{1D08719B-C5E3-F080-1578-5FB0B039E03D}"/>
          </ac:spMkLst>
        </pc:spChg>
        <pc:spChg chg="del">
          <ac:chgData name="Papaioannou, Ioannis" userId="27d0d6e0-1133-45d1-b366-9071ba1a55b0" providerId="ADAL" clId="{BA1F9235-DE2C-433E-8776-BF88F36CDC29}" dt="2022-06-23T15:17:12.829" v="40" actId="478"/>
          <ac:spMkLst>
            <pc:docMk/>
            <pc:sldMk cId="2731541974" sldId="258"/>
            <ac:spMk id="2" creationId="{AFDA03B2-7047-43F8-7A0A-C89AECC5CA49}"/>
          </ac:spMkLst>
        </pc:spChg>
        <pc:spChg chg="del">
          <ac:chgData name="Papaioannou, Ioannis" userId="27d0d6e0-1133-45d1-b366-9071ba1a55b0" providerId="ADAL" clId="{BA1F9235-DE2C-433E-8776-BF88F36CDC29}" dt="2022-06-23T15:17:12.829" v="40" actId="478"/>
          <ac:spMkLst>
            <pc:docMk/>
            <pc:sldMk cId="2731541974" sldId="258"/>
            <ac:spMk id="3" creationId="{76D610C1-E609-2C80-016D-91FFABD0C78A}"/>
          </ac:spMkLst>
        </pc:spChg>
        <pc:spChg chg="add mod">
          <ac:chgData name="Papaioannou, Ioannis" userId="27d0d6e0-1133-45d1-b366-9071ba1a55b0" providerId="ADAL" clId="{BA1F9235-DE2C-433E-8776-BF88F36CDC29}" dt="2022-07-11T21:05:42.318" v="1645" actId="1076"/>
          <ac:spMkLst>
            <pc:docMk/>
            <pc:sldMk cId="2731541974" sldId="258"/>
            <ac:spMk id="6" creationId="{9AB9B479-25F6-882E-F49A-83FA3CE7781B}"/>
          </ac:spMkLst>
        </pc:spChg>
        <pc:spChg chg="add mod">
          <ac:chgData name="Papaioannou, Ioannis" userId="27d0d6e0-1133-45d1-b366-9071ba1a55b0" providerId="ADAL" clId="{BA1F9235-DE2C-433E-8776-BF88F36CDC29}" dt="2022-07-11T21:04:39.240" v="1630" actId="1076"/>
          <ac:spMkLst>
            <pc:docMk/>
            <pc:sldMk cId="2731541974" sldId="258"/>
            <ac:spMk id="7" creationId="{226B207F-3370-A6C4-B0E1-B05E0BA39410}"/>
          </ac:spMkLst>
        </pc:spChg>
        <pc:spChg chg="add del mod">
          <ac:chgData name="Papaioannou, Ioannis" userId="27d0d6e0-1133-45d1-b366-9071ba1a55b0" providerId="ADAL" clId="{BA1F9235-DE2C-433E-8776-BF88F36CDC29}" dt="2022-06-23T18:38:12.472" v="260" actId="478"/>
          <ac:spMkLst>
            <pc:docMk/>
            <pc:sldMk cId="2731541974" sldId="258"/>
            <ac:spMk id="8" creationId="{87D2EDDE-4F84-9314-98EB-C2E90F37B8DF}"/>
          </ac:spMkLst>
        </pc:spChg>
        <pc:spChg chg="add mod">
          <ac:chgData name="Papaioannou, Ioannis" userId="27d0d6e0-1133-45d1-b366-9071ba1a55b0" providerId="ADAL" clId="{BA1F9235-DE2C-433E-8776-BF88F36CDC29}" dt="2022-06-23T18:29:50.039" v="226" actId="571"/>
          <ac:spMkLst>
            <pc:docMk/>
            <pc:sldMk cId="2731541974" sldId="258"/>
            <ac:spMk id="12" creationId="{F23820AA-B09E-66EC-0E7B-65510D19CDED}"/>
          </ac:spMkLst>
        </pc:spChg>
        <pc:spChg chg="add mod ord">
          <ac:chgData name="Papaioannou, Ioannis" userId="27d0d6e0-1133-45d1-b366-9071ba1a55b0" providerId="ADAL" clId="{BA1F9235-DE2C-433E-8776-BF88F36CDC29}" dt="2022-07-11T21:04:23.126" v="1625" actId="1076"/>
          <ac:spMkLst>
            <pc:docMk/>
            <pc:sldMk cId="2731541974" sldId="258"/>
            <ac:spMk id="13" creationId="{9B4E1444-D491-9690-0B1E-B70B66DCE323}"/>
          </ac:spMkLst>
        </pc:spChg>
        <pc:spChg chg="add mod">
          <ac:chgData name="Papaioannou, Ioannis" userId="27d0d6e0-1133-45d1-b366-9071ba1a55b0" providerId="ADAL" clId="{BA1F9235-DE2C-433E-8776-BF88F36CDC29}" dt="2022-07-11T21:04:23.126" v="1625" actId="1076"/>
          <ac:spMkLst>
            <pc:docMk/>
            <pc:sldMk cId="2731541974" sldId="258"/>
            <ac:spMk id="14" creationId="{A6470035-5CC6-37AF-849E-BA02803CCB36}"/>
          </ac:spMkLst>
        </pc:spChg>
        <pc:spChg chg="add mod">
          <ac:chgData name="Papaioannou, Ioannis" userId="27d0d6e0-1133-45d1-b366-9071ba1a55b0" providerId="ADAL" clId="{BA1F9235-DE2C-433E-8776-BF88F36CDC29}" dt="2022-07-11T21:04:23.126" v="1625" actId="1076"/>
          <ac:spMkLst>
            <pc:docMk/>
            <pc:sldMk cId="2731541974" sldId="258"/>
            <ac:spMk id="16" creationId="{EDB6816B-9EF5-18B5-20AC-D5ECA92D5863}"/>
          </ac:spMkLst>
        </pc:spChg>
        <pc:spChg chg="add mod">
          <ac:chgData name="Papaioannou, Ioannis" userId="27d0d6e0-1133-45d1-b366-9071ba1a55b0" providerId="ADAL" clId="{BA1F9235-DE2C-433E-8776-BF88F36CDC29}" dt="2022-07-11T21:04:23.126" v="1625" actId="1076"/>
          <ac:spMkLst>
            <pc:docMk/>
            <pc:sldMk cId="2731541974" sldId="258"/>
            <ac:spMk id="17" creationId="{EEB02D4F-522B-88D1-F363-B1C46C1F8FFE}"/>
          </ac:spMkLst>
        </pc:spChg>
        <pc:spChg chg="add mod">
          <ac:chgData name="Papaioannou, Ioannis" userId="27d0d6e0-1133-45d1-b366-9071ba1a55b0" providerId="ADAL" clId="{BA1F9235-DE2C-433E-8776-BF88F36CDC29}" dt="2022-07-11T21:04:23.126" v="1625" actId="1076"/>
          <ac:spMkLst>
            <pc:docMk/>
            <pc:sldMk cId="2731541974" sldId="258"/>
            <ac:spMk id="20" creationId="{9A290F32-8BBB-C317-F6BB-3DCA61B5BA51}"/>
          </ac:spMkLst>
        </pc:spChg>
        <pc:spChg chg="add mod">
          <ac:chgData name="Papaioannou, Ioannis" userId="27d0d6e0-1133-45d1-b366-9071ba1a55b0" providerId="ADAL" clId="{BA1F9235-DE2C-433E-8776-BF88F36CDC29}" dt="2022-07-11T21:04:23.126" v="1625" actId="1076"/>
          <ac:spMkLst>
            <pc:docMk/>
            <pc:sldMk cId="2731541974" sldId="258"/>
            <ac:spMk id="21" creationId="{66384553-1AE8-1B4E-964B-EA897C9AD67B}"/>
          </ac:spMkLst>
        </pc:spChg>
        <pc:picChg chg="add mod">
          <ac:chgData name="Papaioannou, Ioannis" userId="27d0d6e0-1133-45d1-b366-9071ba1a55b0" providerId="ADAL" clId="{BA1F9235-DE2C-433E-8776-BF88F36CDC29}" dt="2022-07-11T21:04:39.240" v="1630" actId="1076"/>
          <ac:picMkLst>
            <pc:docMk/>
            <pc:sldMk cId="2731541974" sldId="258"/>
            <ac:picMk id="5" creationId="{918CCB07-2FBD-D1F9-24D2-49EA0AC7821A}"/>
          </ac:picMkLst>
        </pc:picChg>
        <pc:picChg chg="add del mod">
          <ac:chgData name="Papaioannou, Ioannis" userId="27d0d6e0-1133-45d1-b366-9071ba1a55b0" providerId="ADAL" clId="{BA1F9235-DE2C-433E-8776-BF88F36CDC29}" dt="2022-06-23T18:38:38.578" v="266" actId="478"/>
          <ac:picMkLst>
            <pc:docMk/>
            <pc:sldMk cId="2731541974" sldId="258"/>
            <ac:picMk id="10" creationId="{60D79066-E892-4372-2CDA-6F4D6BA37956}"/>
          </ac:picMkLst>
        </pc:picChg>
        <pc:picChg chg="add mod">
          <ac:chgData name="Papaioannou, Ioannis" userId="27d0d6e0-1133-45d1-b366-9071ba1a55b0" providerId="ADAL" clId="{BA1F9235-DE2C-433E-8776-BF88F36CDC29}" dt="2022-06-23T18:29:50.039" v="226" actId="571"/>
          <ac:picMkLst>
            <pc:docMk/>
            <pc:sldMk cId="2731541974" sldId="258"/>
            <ac:picMk id="11" creationId="{68A168F1-06FB-1097-A8DE-E6D7812CF77D}"/>
          </ac:picMkLst>
        </pc:picChg>
        <pc:picChg chg="add mod">
          <ac:chgData name="Papaioannou, Ioannis" userId="27d0d6e0-1133-45d1-b366-9071ba1a55b0" providerId="ADAL" clId="{BA1F9235-DE2C-433E-8776-BF88F36CDC29}" dt="2022-07-11T21:04:23.126" v="1625" actId="1076"/>
          <ac:picMkLst>
            <pc:docMk/>
            <pc:sldMk cId="2731541974" sldId="258"/>
            <ac:picMk id="15" creationId="{603BC9CB-6719-EFE3-F3E5-35F66BF703C5}"/>
          </ac:picMkLst>
        </pc:picChg>
        <pc:picChg chg="add mod">
          <ac:chgData name="Papaioannou, Ioannis" userId="27d0d6e0-1133-45d1-b366-9071ba1a55b0" providerId="ADAL" clId="{BA1F9235-DE2C-433E-8776-BF88F36CDC29}" dt="2022-07-11T21:04:23.126" v="1625" actId="1076"/>
          <ac:picMkLst>
            <pc:docMk/>
            <pc:sldMk cId="2731541974" sldId="258"/>
            <ac:picMk id="18" creationId="{9732B990-FEB6-A28B-D8FD-4E6841947501}"/>
          </ac:picMkLst>
        </pc:picChg>
        <pc:picChg chg="add mod modCrop">
          <ac:chgData name="Papaioannou, Ioannis" userId="27d0d6e0-1133-45d1-b366-9071ba1a55b0" providerId="ADAL" clId="{BA1F9235-DE2C-433E-8776-BF88F36CDC29}" dt="2022-07-11T21:04:23.126" v="1625" actId="1076"/>
          <ac:picMkLst>
            <pc:docMk/>
            <pc:sldMk cId="2731541974" sldId="258"/>
            <ac:picMk id="19" creationId="{74086850-4D4C-1744-5FDA-DA4C72138CD3}"/>
          </ac:picMkLst>
        </pc:picChg>
        <pc:picChg chg="add mod">
          <ac:chgData name="Papaioannou, Ioannis" userId="27d0d6e0-1133-45d1-b366-9071ba1a55b0" providerId="ADAL" clId="{BA1F9235-DE2C-433E-8776-BF88F36CDC29}" dt="2022-07-11T21:05:38.323" v="1643" actId="1076"/>
          <ac:picMkLst>
            <pc:docMk/>
            <pc:sldMk cId="2731541974" sldId="258"/>
            <ac:picMk id="22" creationId="{0B9040E2-C572-8C81-F583-1FD4744DC28E}"/>
          </ac:picMkLst>
        </pc:picChg>
      </pc:sldChg>
      <pc:sldChg chg="addSp delSp modSp new mod">
        <pc:chgData name="Papaioannou, Ioannis" userId="27d0d6e0-1133-45d1-b366-9071ba1a55b0" providerId="ADAL" clId="{BA1F9235-DE2C-433E-8776-BF88F36CDC29}" dt="2022-07-11T21:05:32.707" v="1642" actId="1076"/>
        <pc:sldMkLst>
          <pc:docMk/>
          <pc:sldMk cId="905110383" sldId="259"/>
        </pc:sldMkLst>
        <pc:spChg chg="del">
          <ac:chgData name="Papaioannou, Ioannis" userId="27d0d6e0-1133-45d1-b366-9071ba1a55b0" providerId="ADAL" clId="{BA1F9235-DE2C-433E-8776-BF88F36CDC29}" dt="2022-06-23T15:21:39.250" v="92" actId="478"/>
          <ac:spMkLst>
            <pc:docMk/>
            <pc:sldMk cId="905110383" sldId="259"/>
            <ac:spMk id="2" creationId="{63EB861A-73AF-1381-F73A-36C7636E546A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2" creationId="{CA32329E-FFA3-2250-8638-928FD47BF3F0}"/>
          </ac:spMkLst>
        </pc:spChg>
        <pc:spChg chg="del">
          <ac:chgData name="Papaioannou, Ioannis" userId="27d0d6e0-1133-45d1-b366-9071ba1a55b0" providerId="ADAL" clId="{BA1F9235-DE2C-433E-8776-BF88F36CDC29}" dt="2022-06-23T15:21:39.250" v="92" actId="478"/>
          <ac:spMkLst>
            <pc:docMk/>
            <pc:sldMk cId="905110383" sldId="259"/>
            <ac:spMk id="3" creationId="{CEF065EC-0B94-415D-F775-032FE7289AD9}"/>
          </ac:spMkLst>
        </pc:spChg>
        <pc:spChg chg="add mod">
          <ac:chgData name="Papaioannou, Ioannis" userId="27d0d6e0-1133-45d1-b366-9071ba1a55b0" providerId="ADAL" clId="{BA1F9235-DE2C-433E-8776-BF88F36CDC29}" dt="2022-07-11T21:05:32.707" v="1642" actId="1076"/>
          <ac:spMkLst>
            <pc:docMk/>
            <pc:sldMk cId="905110383" sldId="259"/>
            <ac:spMk id="6" creationId="{36B3A51E-91DA-38FD-CB8F-5BE59ABA9A22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7" creationId="{159323F1-FAE4-3CF7-86E7-E9DFFC6F8A1E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10" creationId="{4F628CDA-D1FC-2024-D254-7A1A39A4E380}"/>
          </ac:spMkLst>
        </pc:spChg>
        <pc:spChg chg="add del mod">
          <ac:chgData name="Papaioannou, Ioannis" userId="27d0d6e0-1133-45d1-b366-9071ba1a55b0" providerId="ADAL" clId="{BA1F9235-DE2C-433E-8776-BF88F36CDC29}" dt="2022-07-01T19:11:06.792" v="851" actId="478"/>
          <ac:spMkLst>
            <pc:docMk/>
            <pc:sldMk cId="905110383" sldId="259"/>
            <ac:spMk id="12" creationId="{DF2BDDCE-0A72-7A4E-7C2E-FA9D0C3842E9}"/>
          </ac:spMkLst>
        </pc:spChg>
        <pc:spChg chg="add mod">
          <ac:chgData name="Papaioannou, Ioannis" userId="27d0d6e0-1133-45d1-b366-9071ba1a55b0" providerId="ADAL" clId="{BA1F9235-DE2C-433E-8776-BF88F36CDC29}" dt="2022-06-23T15:28:29.570" v="132" actId="571"/>
          <ac:spMkLst>
            <pc:docMk/>
            <pc:sldMk cId="905110383" sldId="259"/>
            <ac:spMk id="14" creationId="{9FA65461-8CA9-4B3E-1499-D31605640634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15" creationId="{F9C20C12-0239-87A1-19E5-E43A916AB390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16" creationId="{0E1BF01B-A8F0-241B-EF34-8B75213E34C1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18" creationId="{465EA8BD-B776-BB4E-9A98-41659920D396}"/>
          </ac:spMkLst>
        </pc:spChg>
        <pc:spChg chg="add del mod">
          <ac:chgData name="Papaioannou, Ioannis" userId="27d0d6e0-1133-45d1-b366-9071ba1a55b0" providerId="ADAL" clId="{BA1F9235-DE2C-433E-8776-BF88F36CDC29}" dt="2022-07-01T19:07:50.839" v="783" actId="478"/>
          <ac:spMkLst>
            <pc:docMk/>
            <pc:sldMk cId="905110383" sldId="259"/>
            <ac:spMk id="19" creationId="{70098967-FCAF-5A21-7D4B-216C6E0FFF37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22" creationId="{143DBF08-1FA5-299F-D3DC-AA8C7DC0A6AE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24" creationId="{04D4DE9A-B1B0-9E32-58A3-B8D2AE69D604}"/>
          </ac:spMkLst>
        </pc:spChg>
        <pc:spChg chg="add del mod">
          <ac:chgData name="Papaioannou, Ioannis" userId="27d0d6e0-1133-45d1-b366-9071ba1a55b0" providerId="ADAL" clId="{BA1F9235-DE2C-433E-8776-BF88F36CDC29}" dt="2022-07-01T19:11:32.046" v="876" actId="478"/>
          <ac:spMkLst>
            <pc:docMk/>
            <pc:sldMk cId="905110383" sldId="259"/>
            <ac:spMk id="26" creationId="{C8688C67-0E91-B785-048A-333ED2008CBF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28" creationId="{6E38B069-E61B-5F3D-7071-8AC9C53657D0}"/>
          </ac:spMkLst>
        </pc:spChg>
        <pc:spChg chg="add mod">
          <ac:chgData name="Papaioannou, Ioannis" userId="27d0d6e0-1133-45d1-b366-9071ba1a55b0" providerId="ADAL" clId="{BA1F9235-DE2C-433E-8776-BF88F36CDC29}" dt="2022-07-11T21:05:22.633" v="1638" actId="1076"/>
          <ac:spMkLst>
            <pc:docMk/>
            <pc:sldMk cId="905110383" sldId="259"/>
            <ac:spMk id="29" creationId="{F7A43B22-83BD-4653-DC7F-539A1E3430BD}"/>
          </ac:spMkLst>
        </pc:spChg>
        <pc:picChg chg="add del mod modCrop">
          <ac:chgData name="Papaioannou, Ioannis" userId="27d0d6e0-1133-45d1-b366-9071ba1a55b0" providerId="ADAL" clId="{BA1F9235-DE2C-433E-8776-BF88F36CDC29}" dt="2022-07-01T19:08:58.224" v="788" actId="478"/>
          <ac:picMkLst>
            <pc:docMk/>
            <pc:sldMk cId="905110383" sldId="259"/>
            <ac:picMk id="4" creationId="{32B75745-8CBF-2036-BE69-2F51440FEBAD}"/>
          </ac:picMkLst>
        </pc:picChg>
        <pc:picChg chg="add mod modCrop">
          <ac:chgData name="Papaioannou, Ioannis" userId="27d0d6e0-1133-45d1-b366-9071ba1a55b0" providerId="ADAL" clId="{BA1F9235-DE2C-433E-8776-BF88F36CDC29}" dt="2022-07-11T21:05:22.633" v="1638" actId="1076"/>
          <ac:picMkLst>
            <pc:docMk/>
            <pc:sldMk cId="905110383" sldId="259"/>
            <ac:picMk id="5" creationId="{472D531B-369D-7811-41EF-C89659EBD1E1}"/>
          </ac:picMkLst>
        </pc:picChg>
        <pc:picChg chg="add mod modCrop">
          <ac:chgData name="Papaioannou, Ioannis" userId="27d0d6e0-1133-45d1-b366-9071ba1a55b0" providerId="ADAL" clId="{BA1F9235-DE2C-433E-8776-BF88F36CDC29}" dt="2022-07-11T21:05:22.633" v="1638" actId="1076"/>
          <ac:picMkLst>
            <pc:docMk/>
            <pc:sldMk cId="905110383" sldId="259"/>
            <ac:picMk id="9" creationId="{6640F2CE-A230-E318-9AB5-A8730DB47DD3}"/>
          </ac:picMkLst>
        </pc:picChg>
        <pc:picChg chg="add mod">
          <ac:chgData name="Papaioannou, Ioannis" userId="27d0d6e0-1133-45d1-b366-9071ba1a55b0" providerId="ADAL" clId="{BA1F9235-DE2C-433E-8776-BF88F36CDC29}" dt="2022-07-11T21:05:22.633" v="1638" actId="1076"/>
          <ac:picMkLst>
            <pc:docMk/>
            <pc:sldMk cId="905110383" sldId="259"/>
            <ac:picMk id="11" creationId="{61F1ED7E-FA28-CB98-53A1-E8725AD0AC87}"/>
          </ac:picMkLst>
        </pc:picChg>
        <pc:picChg chg="add del mod modCrop">
          <ac:chgData name="Papaioannou, Ioannis" userId="27d0d6e0-1133-45d1-b366-9071ba1a55b0" providerId="ADAL" clId="{BA1F9235-DE2C-433E-8776-BF88F36CDC29}" dt="2022-06-24T11:24:54.704" v="696" actId="478"/>
          <ac:picMkLst>
            <pc:docMk/>
            <pc:sldMk cId="905110383" sldId="259"/>
            <ac:picMk id="12" creationId="{598378FD-A828-80E5-E36A-69833C72356B}"/>
          </ac:picMkLst>
        </pc:picChg>
        <pc:picChg chg="add mod">
          <ac:chgData name="Papaioannou, Ioannis" userId="27d0d6e0-1133-45d1-b366-9071ba1a55b0" providerId="ADAL" clId="{BA1F9235-DE2C-433E-8776-BF88F36CDC29}" dt="2022-06-23T15:28:29.570" v="132" actId="571"/>
          <ac:picMkLst>
            <pc:docMk/>
            <pc:sldMk cId="905110383" sldId="259"/>
            <ac:picMk id="13" creationId="{335CEC9E-9641-508B-5C80-27955995903A}"/>
          </ac:picMkLst>
        </pc:picChg>
        <pc:picChg chg="add mod">
          <ac:chgData name="Papaioannou, Ioannis" userId="27d0d6e0-1133-45d1-b366-9071ba1a55b0" providerId="ADAL" clId="{BA1F9235-DE2C-433E-8776-BF88F36CDC29}" dt="2022-07-11T21:05:22.633" v="1638" actId="1076"/>
          <ac:picMkLst>
            <pc:docMk/>
            <pc:sldMk cId="905110383" sldId="259"/>
            <ac:picMk id="17" creationId="{E670D596-B647-B478-E2AF-A7BAE8018B27}"/>
          </ac:picMkLst>
        </pc:picChg>
        <pc:picChg chg="add mod">
          <ac:chgData name="Papaioannou, Ioannis" userId="27d0d6e0-1133-45d1-b366-9071ba1a55b0" providerId="ADAL" clId="{BA1F9235-DE2C-433E-8776-BF88F36CDC29}" dt="2022-07-11T21:05:25.316" v="1639" actId="1076"/>
          <ac:picMkLst>
            <pc:docMk/>
            <pc:sldMk cId="905110383" sldId="259"/>
            <ac:picMk id="21" creationId="{3F32434A-9F5F-FA7F-F912-51CC503D81CA}"/>
          </ac:picMkLst>
        </pc:picChg>
        <pc:picChg chg="add mod ord">
          <ac:chgData name="Papaioannou, Ioannis" userId="27d0d6e0-1133-45d1-b366-9071ba1a55b0" providerId="ADAL" clId="{BA1F9235-DE2C-433E-8776-BF88F36CDC29}" dt="2022-07-11T21:05:22.633" v="1638" actId="1076"/>
          <ac:picMkLst>
            <pc:docMk/>
            <pc:sldMk cId="905110383" sldId="259"/>
            <ac:picMk id="27" creationId="{83A58578-A2D9-7749-326E-C71DB5043DA4}"/>
          </ac:picMkLst>
        </pc:picChg>
        <pc:cxnChg chg="add del mod">
          <ac:chgData name="Papaioannou, Ioannis" userId="27d0d6e0-1133-45d1-b366-9071ba1a55b0" providerId="ADAL" clId="{BA1F9235-DE2C-433E-8776-BF88F36CDC29}" dt="2022-07-01T19:07:50.839" v="783" actId="478"/>
          <ac:cxnSpMkLst>
            <pc:docMk/>
            <pc:sldMk cId="905110383" sldId="259"/>
            <ac:cxnSpMk id="23" creationId="{EB3BBCCF-F3CC-BC03-A965-B1004EC82049}"/>
          </ac:cxnSpMkLst>
        </pc:cxnChg>
        <pc:cxnChg chg="add del mod">
          <ac:chgData name="Papaioannou, Ioannis" userId="27d0d6e0-1133-45d1-b366-9071ba1a55b0" providerId="ADAL" clId="{BA1F9235-DE2C-433E-8776-BF88F36CDC29}" dt="2022-07-01T19:07:50.839" v="783" actId="478"/>
          <ac:cxnSpMkLst>
            <pc:docMk/>
            <pc:sldMk cId="905110383" sldId="259"/>
            <ac:cxnSpMk id="25" creationId="{0977A6E1-F44F-A292-7E12-75451434B470}"/>
          </ac:cxnSpMkLst>
        </pc:cxnChg>
      </pc:sldChg>
      <pc:sldChg chg="addSp modSp add del mod">
        <pc:chgData name="Papaioannou, Ioannis" userId="27d0d6e0-1133-45d1-b366-9071ba1a55b0" providerId="ADAL" clId="{BA1F9235-DE2C-433E-8776-BF88F36CDC29}" dt="2022-06-27T11:20:47.716" v="766" actId="47"/>
        <pc:sldMkLst>
          <pc:docMk/>
          <pc:sldMk cId="1006085126" sldId="260"/>
        </pc:sldMkLst>
        <pc:spChg chg="add mod">
          <ac:chgData name="Papaioannou, Ioannis" userId="27d0d6e0-1133-45d1-b366-9071ba1a55b0" providerId="ADAL" clId="{BA1F9235-DE2C-433E-8776-BF88F36CDC29}" dt="2022-06-24T11:13:57.140" v="621" actId="1076"/>
          <ac:spMkLst>
            <pc:docMk/>
            <pc:sldMk cId="1006085126" sldId="260"/>
            <ac:spMk id="6" creationId="{76063C09-6FB2-2961-5C06-0726CA38D943}"/>
          </ac:spMkLst>
        </pc:spChg>
        <pc:spChg chg="mod">
          <ac:chgData name="Papaioannou, Ioannis" userId="27d0d6e0-1133-45d1-b366-9071ba1a55b0" providerId="ADAL" clId="{BA1F9235-DE2C-433E-8776-BF88F36CDC29}" dt="2022-06-24T11:13:29.679" v="588" actId="20577"/>
          <ac:spMkLst>
            <pc:docMk/>
            <pc:sldMk cId="1006085126" sldId="260"/>
            <ac:spMk id="10" creationId="{3C16DB6D-2F93-6176-465F-9A95D192B8D8}"/>
          </ac:spMkLst>
        </pc:spChg>
        <pc:picChg chg="add mod">
          <ac:chgData name="Papaioannou, Ioannis" userId="27d0d6e0-1133-45d1-b366-9071ba1a55b0" providerId="ADAL" clId="{BA1F9235-DE2C-433E-8776-BF88F36CDC29}" dt="2022-06-24T11:13:15.881" v="539" actId="1076"/>
          <ac:picMkLst>
            <pc:docMk/>
            <pc:sldMk cId="1006085126" sldId="260"/>
            <ac:picMk id="3" creationId="{54BACB57-B8BB-3F13-328F-6E2435DBEE74}"/>
          </ac:picMkLst>
        </pc:picChg>
        <pc:cxnChg chg="add">
          <ac:chgData name="Papaioannou, Ioannis" userId="27d0d6e0-1133-45d1-b366-9071ba1a55b0" providerId="ADAL" clId="{BA1F9235-DE2C-433E-8776-BF88F36CDC29}" dt="2022-06-24T11:13:37.268" v="589" actId="11529"/>
          <ac:cxnSpMkLst>
            <pc:docMk/>
            <pc:sldMk cId="1006085126" sldId="260"/>
            <ac:cxnSpMk id="5" creationId="{4DF6FFCE-EEE8-48D6-5E36-4D6C4341AC02}"/>
          </ac:cxnSpMkLst>
        </pc:cxnChg>
        <pc:cxnChg chg="add mod">
          <ac:chgData name="Papaioannou, Ioannis" userId="27d0d6e0-1133-45d1-b366-9071ba1a55b0" providerId="ADAL" clId="{BA1F9235-DE2C-433E-8776-BF88F36CDC29}" dt="2022-06-24T11:13:40.172" v="590" actId="571"/>
          <ac:cxnSpMkLst>
            <pc:docMk/>
            <pc:sldMk cId="1006085126" sldId="260"/>
            <ac:cxnSpMk id="7" creationId="{9C4A111A-EC65-7188-F8A2-10660F9BCC62}"/>
          </ac:cxnSpMkLst>
        </pc:cxnChg>
      </pc:sldChg>
      <pc:sldChg chg="addSp delSp modSp add mod">
        <pc:chgData name="Papaioannou, Ioannis" userId="27d0d6e0-1133-45d1-b366-9071ba1a55b0" providerId="ADAL" clId="{BA1F9235-DE2C-433E-8776-BF88F36CDC29}" dt="2022-07-19T14:57:25.956" v="1770" actId="11530"/>
        <pc:sldMkLst>
          <pc:docMk/>
          <pc:sldMk cId="1022482673" sldId="261"/>
        </pc:sldMkLst>
        <pc:spChg chg="add mod topLvl">
          <ac:chgData name="Papaioannou, Ioannis" userId="27d0d6e0-1133-45d1-b366-9071ba1a55b0" providerId="ADAL" clId="{BA1F9235-DE2C-433E-8776-BF88F36CDC29}" dt="2022-07-19T14:57:20.801" v="1763" actId="165"/>
          <ac:spMkLst>
            <pc:docMk/>
            <pc:sldMk cId="1022482673" sldId="261"/>
            <ac:spMk id="2" creationId="{542C09B3-CEEE-27AC-EE4E-A362202369B9}"/>
          </ac:spMkLst>
        </pc:spChg>
        <pc:spChg chg="mod">
          <ac:chgData name="Papaioannou, Ioannis" userId="27d0d6e0-1133-45d1-b366-9071ba1a55b0" providerId="ADAL" clId="{BA1F9235-DE2C-433E-8776-BF88F36CDC29}" dt="2022-07-11T21:05:59.674" v="1665" actId="1076"/>
          <ac:spMkLst>
            <pc:docMk/>
            <pc:sldMk cId="1022482673" sldId="261"/>
            <ac:spMk id="10" creationId="{3C16DB6D-2F93-6176-465F-9A95D192B8D8}"/>
          </ac:spMkLst>
        </pc:spChg>
        <pc:spChg chg="add mod topLvl">
          <ac:chgData name="Papaioannou, Ioannis" userId="27d0d6e0-1133-45d1-b366-9071ba1a55b0" providerId="ADAL" clId="{BA1F9235-DE2C-433E-8776-BF88F36CDC29}" dt="2022-07-19T14:57:20.801" v="1763" actId="165"/>
          <ac:spMkLst>
            <pc:docMk/>
            <pc:sldMk cId="1022482673" sldId="261"/>
            <ac:spMk id="12" creationId="{8AAE4A41-7235-59AA-E902-49C3C731FD97}"/>
          </ac:spMkLst>
        </pc:spChg>
        <pc:spChg chg="add mod">
          <ac:chgData name="Papaioannou, Ioannis" userId="27d0d6e0-1133-45d1-b366-9071ba1a55b0" providerId="ADAL" clId="{BA1F9235-DE2C-433E-8776-BF88F36CDC29}" dt="2022-07-04T20:38:25.759" v="1029" actId="1076"/>
          <ac:spMkLst>
            <pc:docMk/>
            <pc:sldMk cId="1022482673" sldId="261"/>
            <ac:spMk id="16" creationId="{438F2016-A450-60DC-6554-C60B924EC593}"/>
          </ac:spMkLst>
        </pc:spChg>
        <pc:spChg chg="add mod">
          <ac:chgData name="Papaioannou, Ioannis" userId="27d0d6e0-1133-45d1-b366-9071ba1a55b0" providerId="ADAL" clId="{BA1F9235-DE2C-433E-8776-BF88F36CDC29}" dt="2022-07-04T20:38:25.759" v="1029" actId="1076"/>
          <ac:spMkLst>
            <pc:docMk/>
            <pc:sldMk cId="1022482673" sldId="261"/>
            <ac:spMk id="17" creationId="{FACEF8B2-68B2-CC5E-1076-5F8565DC8BD5}"/>
          </ac:spMkLst>
        </pc:spChg>
        <pc:spChg chg="add mod">
          <ac:chgData name="Papaioannou, Ioannis" userId="27d0d6e0-1133-45d1-b366-9071ba1a55b0" providerId="ADAL" clId="{BA1F9235-DE2C-433E-8776-BF88F36CDC29}" dt="2022-07-04T20:38:12.857" v="1026" actId="1076"/>
          <ac:spMkLst>
            <pc:docMk/>
            <pc:sldMk cId="1022482673" sldId="261"/>
            <ac:spMk id="20" creationId="{CE105129-3949-4D10-AD86-7127AD7AC886}"/>
          </ac:spMkLst>
        </pc:spChg>
        <pc:spChg chg="add mod">
          <ac:chgData name="Papaioannou, Ioannis" userId="27d0d6e0-1133-45d1-b366-9071ba1a55b0" providerId="ADAL" clId="{BA1F9235-DE2C-433E-8776-BF88F36CDC29}" dt="2022-07-04T20:38:12.857" v="1026" actId="1076"/>
          <ac:spMkLst>
            <pc:docMk/>
            <pc:sldMk cId="1022482673" sldId="261"/>
            <ac:spMk id="21" creationId="{543E88DA-1F31-FF42-C258-3565690DAC3B}"/>
          </ac:spMkLst>
        </pc:spChg>
        <pc:spChg chg="add mod">
          <ac:chgData name="Papaioannou, Ioannis" userId="27d0d6e0-1133-45d1-b366-9071ba1a55b0" providerId="ADAL" clId="{BA1F9235-DE2C-433E-8776-BF88F36CDC29}" dt="2022-07-08T15:40:00.936" v="1293" actId="1076"/>
          <ac:spMkLst>
            <pc:docMk/>
            <pc:sldMk cId="1022482673" sldId="261"/>
            <ac:spMk id="22" creationId="{2CAE0F4E-2002-8BD7-D913-9FD7CD684B64}"/>
          </ac:spMkLst>
        </pc:spChg>
        <pc:spChg chg="add mod">
          <ac:chgData name="Papaioannou, Ioannis" userId="27d0d6e0-1133-45d1-b366-9071ba1a55b0" providerId="ADAL" clId="{BA1F9235-DE2C-433E-8776-BF88F36CDC29}" dt="2022-07-04T20:39:17.352" v="1040" actId="14100"/>
          <ac:spMkLst>
            <pc:docMk/>
            <pc:sldMk cId="1022482673" sldId="261"/>
            <ac:spMk id="25" creationId="{6F37BCCB-B3C4-2CED-202B-6BCCD289589A}"/>
          </ac:spMkLst>
        </pc:spChg>
        <pc:spChg chg="add mod">
          <ac:chgData name="Papaioannou, Ioannis" userId="27d0d6e0-1133-45d1-b366-9071ba1a55b0" providerId="ADAL" clId="{BA1F9235-DE2C-433E-8776-BF88F36CDC29}" dt="2022-07-04T20:39:22.657" v="1041" actId="571"/>
          <ac:spMkLst>
            <pc:docMk/>
            <pc:sldMk cId="1022482673" sldId="261"/>
            <ac:spMk id="26" creationId="{820F78DB-6C9A-5E2F-1ABA-0A24B1D560C3}"/>
          </ac:spMkLst>
        </pc:spChg>
        <pc:spChg chg="add mod">
          <ac:chgData name="Papaioannou, Ioannis" userId="27d0d6e0-1133-45d1-b366-9071ba1a55b0" providerId="ADAL" clId="{BA1F9235-DE2C-433E-8776-BF88F36CDC29}" dt="2022-07-04T20:40:36.156" v="1050" actId="1076"/>
          <ac:spMkLst>
            <pc:docMk/>
            <pc:sldMk cId="1022482673" sldId="261"/>
            <ac:spMk id="28" creationId="{59935FA4-981C-ADDE-C0DA-7EC99B899270}"/>
          </ac:spMkLst>
        </pc:spChg>
        <pc:spChg chg="add mod">
          <ac:chgData name="Papaioannou, Ioannis" userId="27d0d6e0-1133-45d1-b366-9071ba1a55b0" providerId="ADAL" clId="{BA1F9235-DE2C-433E-8776-BF88F36CDC29}" dt="2022-07-04T20:40:41.807" v="1052" actId="14100"/>
          <ac:spMkLst>
            <pc:docMk/>
            <pc:sldMk cId="1022482673" sldId="261"/>
            <ac:spMk id="29" creationId="{CA282B91-B756-D2E1-B25C-AFA83559CCE2}"/>
          </ac:spMkLst>
        </pc:spChg>
        <pc:spChg chg="add mod">
          <ac:chgData name="Papaioannou, Ioannis" userId="27d0d6e0-1133-45d1-b366-9071ba1a55b0" providerId="ADAL" clId="{BA1F9235-DE2C-433E-8776-BF88F36CDC29}" dt="2022-07-04T20:40:53.275" v="1060" actId="20577"/>
          <ac:spMkLst>
            <pc:docMk/>
            <pc:sldMk cId="1022482673" sldId="261"/>
            <ac:spMk id="30" creationId="{3A56144D-BF54-7228-012E-1CDD54618EE7}"/>
          </ac:spMkLst>
        </pc:spChg>
        <pc:grpChg chg="add del mod">
          <ac:chgData name="Papaioannou, Ioannis" userId="27d0d6e0-1133-45d1-b366-9071ba1a55b0" providerId="ADAL" clId="{BA1F9235-DE2C-433E-8776-BF88F36CDC29}" dt="2022-07-19T14:57:25.956" v="1770" actId="11530"/>
          <ac:grpSpMkLst>
            <pc:docMk/>
            <pc:sldMk cId="1022482673" sldId="261"/>
            <ac:grpSpMk id="13" creationId="{8F2A8952-A4EA-26BB-E650-B9E9E6A9F7B2}"/>
          </ac:grpSpMkLst>
        </pc:grpChg>
        <pc:picChg chg="add mod">
          <ac:chgData name="Papaioannou, Ioannis" userId="27d0d6e0-1133-45d1-b366-9071ba1a55b0" providerId="ADAL" clId="{BA1F9235-DE2C-433E-8776-BF88F36CDC29}" dt="2022-06-24T11:16:02.589" v="681" actId="1076"/>
          <ac:picMkLst>
            <pc:docMk/>
            <pc:sldMk cId="1022482673" sldId="261"/>
            <ac:picMk id="3" creationId="{A1D3D332-DFDF-E141-6E08-402DA75BBEFD}"/>
          </ac:picMkLst>
        </pc:picChg>
        <pc:picChg chg="add del mod">
          <ac:chgData name="Papaioannou, Ioannis" userId="27d0d6e0-1133-45d1-b366-9071ba1a55b0" providerId="ADAL" clId="{BA1F9235-DE2C-433E-8776-BF88F36CDC29}" dt="2022-07-04T20:29:35.917" v="932" actId="478"/>
          <ac:picMkLst>
            <pc:docMk/>
            <pc:sldMk cId="1022482673" sldId="261"/>
            <ac:picMk id="4" creationId="{991D25CF-3A88-8BDA-7204-BD6B66B69180}"/>
          </ac:picMkLst>
        </pc:picChg>
        <pc:picChg chg="add del mod">
          <ac:chgData name="Papaioannou, Ioannis" userId="27d0d6e0-1133-45d1-b366-9071ba1a55b0" providerId="ADAL" clId="{BA1F9235-DE2C-433E-8776-BF88F36CDC29}" dt="2022-07-04T20:29:35.917" v="932" actId="478"/>
          <ac:picMkLst>
            <pc:docMk/>
            <pc:sldMk cId="1022482673" sldId="261"/>
            <ac:picMk id="5" creationId="{1BC669B7-D22C-D52E-BA94-766B44304F01}"/>
          </ac:picMkLst>
        </pc:picChg>
        <pc:picChg chg="add del mod">
          <ac:chgData name="Papaioannou, Ioannis" userId="27d0d6e0-1133-45d1-b366-9071ba1a55b0" providerId="ADAL" clId="{BA1F9235-DE2C-433E-8776-BF88F36CDC29}" dt="2022-07-04T20:29:35.917" v="932" actId="478"/>
          <ac:picMkLst>
            <pc:docMk/>
            <pc:sldMk cId="1022482673" sldId="261"/>
            <ac:picMk id="6" creationId="{31998EEA-D8E3-86A1-85F2-BCEB900AA836}"/>
          </ac:picMkLst>
        </pc:picChg>
        <pc:picChg chg="add del mod">
          <ac:chgData name="Papaioannou, Ioannis" userId="27d0d6e0-1133-45d1-b366-9071ba1a55b0" providerId="ADAL" clId="{BA1F9235-DE2C-433E-8776-BF88F36CDC29}" dt="2022-07-04T20:29:35.917" v="932" actId="478"/>
          <ac:picMkLst>
            <pc:docMk/>
            <pc:sldMk cId="1022482673" sldId="261"/>
            <ac:picMk id="7" creationId="{0E9EDC7B-79D3-81F3-FB45-E685DB5F40BA}"/>
          </ac:picMkLst>
        </pc:picChg>
        <pc:picChg chg="add mod topLvl">
          <ac:chgData name="Papaioannou, Ioannis" userId="27d0d6e0-1133-45d1-b366-9071ba1a55b0" providerId="ADAL" clId="{BA1F9235-DE2C-433E-8776-BF88F36CDC29}" dt="2022-07-19T14:57:20.801" v="1763" actId="165"/>
          <ac:picMkLst>
            <pc:docMk/>
            <pc:sldMk cId="1022482673" sldId="261"/>
            <ac:picMk id="8" creationId="{439F1EB9-1683-6C28-2EB0-BAEE4A6FDA2A}"/>
          </ac:picMkLst>
        </pc:picChg>
        <pc:picChg chg="add del mod">
          <ac:chgData name="Papaioannou, Ioannis" userId="27d0d6e0-1133-45d1-b366-9071ba1a55b0" providerId="ADAL" clId="{BA1F9235-DE2C-433E-8776-BF88F36CDC29}" dt="2022-07-04T20:28:05.053" v="914" actId="478"/>
          <ac:picMkLst>
            <pc:docMk/>
            <pc:sldMk cId="1022482673" sldId="261"/>
            <ac:picMk id="9" creationId="{D0F471DF-CCD0-AFE3-9DFC-9B46C6D5A0D9}"/>
          </ac:picMkLst>
        </pc:picChg>
        <pc:picChg chg="add mod">
          <ac:chgData name="Papaioannou, Ioannis" userId="27d0d6e0-1133-45d1-b366-9071ba1a55b0" providerId="ADAL" clId="{BA1F9235-DE2C-433E-8776-BF88F36CDC29}" dt="2022-07-04T20:27:44.328" v="908" actId="571"/>
          <ac:picMkLst>
            <pc:docMk/>
            <pc:sldMk cId="1022482673" sldId="261"/>
            <ac:picMk id="11" creationId="{1D2CEE11-860D-415D-B95D-DB06D8AA5C44}"/>
          </ac:picMkLst>
        </pc:picChg>
        <pc:picChg chg="add mod">
          <ac:chgData name="Papaioannou, Ioannis" userId="27d0d6e0-1133-45d1-b366-9071ba1a55b0" providerId="ADAL" clId="{BA1F9235-DE2C-433E-8776-BF88F36CDC29}" dt="2022-07-04T20:38:25.759" v="1029" actId="1076"/>
          <ac:picMkLst>
            <pc:docMk/>
            <pc:sldMk cId="1022482673" sldId="261"/>
            <ac:picMk id="14" creationId="{D0D0BF71-9037-DC8B-1481-26F9C896D48C}"/>
          </ac:picMkLst>
        </pc:picChg>
        <pc:picChg chg="add del mod">
          <ac:chgData name="Papaioannou, Ioannis" userId="27d0d6e0-1133-45d1-b366-9071ba1a55b0" providerId="ADAL" clId="{BA1F9235-DE2C-433E-8776-BF88F36CDC29}" dt="2022-07-04T20:29:31.678" v="931" actId="478"/>
          <ac:picMkLst>
            <pc:docMk/>
            <pc:sldMk cId="1022482673" sldId="261"/>
            <ac:picMk id="15" creationId="{33D1C16E-7CBB-7CA4-44B3-E4DAA2D2A8FD}"/>
          </ac:picMkLst>
        </pc:picChg>
        <pc:picChg chg="add del mod">
          <ac:chgData name="Papaioannou, Ioannis" userId="27d0d6e0-1133-45d1-b366-9071ba1a55b0" providerId="ADAL" clId="{BA1F9235-DE2C-433E-8776-BF88F36CDC29}" dt="2022-07-04T20:31:39.498" v="957" actId="478"/>
          <ac:picMkLst>
            <pc:docMk/>
            <pc:sldMk cId="1022482673" sldId="261"/>
            <ac:picMk id="18" creationId="{8D52DE10-FBF7-A2B1-D6FD-5C0287D4771F}"/>
          </ac:picMkLst>
        </pc:picChg>
        <pc:picChg chg="add mod">
          <ac:chgData name="Papaioannou, Ioannis" userId="27d0d6e0-1133-45d1-b366-9071ba1a55b0" providerId="ADAL" clId="{BA1F9235-DE2C-433E-8776-BF88F36CDC29}" dt="2022-07-04T20:38:12.857" v="1026" actId="1076"/>
          <ac:picMkLst>
            <pc:docMk/>
            <pc:sldMk cId="1022482673" sldId="261"/>
            <ac:picMk id="19" creationId="{5905179E-A623-3A91-68D5-1300808D2426}"/>
          </ac:picMkLst>
        </pc:picChg>
        <pc:picChg chg="add del mod">
          <ac:chgData name="Papaioannou, Ioannis" userId="27d0d6e0-1133-45d1-b366-9071ba1a55b0" providerId="ADAL" clId="{BA1F9235-DE2C-433E-8776-BF88F36CDC29}" dt="2022-07-04T20:37:32.846" v="1021" actId="478"/>
          <ac:picMkLst>
            <pc:docMk/>
            <pc:sldMk cId="1022482673" sldId="261"/>
            <ac:picMk id="23" creationId="{D32D25A9-CD58-ED7B-96DF-3B06AD9B31C2}"/>
          </ac:picMkLst>
        </pc:picChg>
        <pc:picChg chg="add mod">
          <ac:chgData name="Papaioannou, Ioannis" userId="27d0d6e0-1133-45d1-b366-9071ba1a55b0" providerId="ADAL" clId="{BA1F9235-DE2C-433E-8776-BF88F36CDC29}" dt="2022-07-04T20:39:02.737" v="1037" actId="1076"/>
          <ac:picMkLst>
            <pc:docMk/>
            <pc:sldMk cId="1022482673" sldId="261"/>
            <ac:picMk id="24" creationId="{E8028ADB-6395-C4DF-85EE-DED7FA1B2AA7}"/>
          </ac:picMkLst>
        </pc:picChg>
        <pc:picChg chg="add mod">
          <ac:chgData name="Papaioannou, Ioannis" userId="27d0d6e0-1133-45d1-b366-9071ba1a55b0" providerId="ADAL" clId="{BA1F9235-DE2C-433E-8776-BF88F36CDC29}" dt="2022-07-04T20:40:18.894" v="1048" actId="1076"/>
          <ac:picMkLst>
            <pc:docMk/>
            <pc:sldMk cId="1022482673" sldId="261"/>
            <ac:picMk id="27" creationId="{0C39A7AA-A84C-F22E-6C11-F77CBFC01406}"/>
          </ac:picMkLst>
        </pc:picChg>
      </pc:sldChg>
      <pc:sldChg chg="addSp modSp add mod">
        <pc:chgData name="Papaioannou, Ioannis" userId="27d0d6e0-1133-45d1-b366-9071ba1a55b0" providerId="ADAL" clId="{BA1F9235-DE2C-433E-8776-BF88F36CDC29}" dt="2022-07-11T21:31:19.328" v="1698" actId="1076"/>
        <pc:sldMkLst>
          <pc:docMk/>
          <pc:sldMk cId="1934854818" sldId="262"/>
        </pc:sldMkLst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2" creationId="{58012A5E-C80D-E6F4-5D46-9A4B72A10E52}"/>
          </ac:spMkLst>
        </pc:spChg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8" creationId="{4AB30319-4E42-5D64-D14E-3002682463E3}"/>
          </ac:spMkLst>
        </pc:spChg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9" creationId="{890D0D29-632E-01B5-A151-B1BAA3047027}"/>
          </ac:spMkLst>
        </pc:spChg>
        <pc:spChg chg="mod">
          <ac:chgData name="Papaioannou, Ioannis" userId="27d0d6e0-1133-45d1-b366-9071ba1a55b0" providerId="ADAL" clId="{BA1F9235-DE2C-433E-8776-BF88F36CDC29}" dt="2022-07-11T21:06:20.115" v="1685" actId="1076"/>
          <ac:spMkLst>
            <pc:docMk/>
            <pc:sldMk cId="1934854818" sldId="262"/>
            <ac:spMk id="10" creationId="{3C16DB6D-2F93-6176-465F-9A95D192B8D8}"/>
          </ac:spMkLst>
        </pc:spChg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11" creationId="{38E85E57-708A-8E9F-D247-27B0EA128805}"/>
          </ac:spMkLst>
        </pc:spChg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15" creationId="{7F18ABF3-450E-F50A-8F29-540B2862B5AB}"/>
          </ac:spMkLst>
        </pc:spChg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16" creationId="{1AFEF2B2-0575-8118-5275-53A9303FEDDD}"/>
          </ac:spMkLst>
        </pc:spChg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17" creationId="{F1D5FEE7-E2AF-D8CB-7011-801EF7147C3C}"/>
          </ac:spMkLst>
        </pc:spChg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18" creationId="{8F3A9F86-B694-FA5A-21CA-4315EE2B5B37}"/>
          </ac:spMkLst>
        </pc:spChg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19" creationId="{A1151C06-37F6-F6CF-5771-A39177D8A989}"/>
          </ac:spMkLst>
        </pc:spChg>
        <pc:spChg chg="add mod">
          <ac:chgData name="Papaioannou, Ioannis" userId="27d0d6e0-1133-45d1-b366-9071ba1a55b0" providerId="ADAL" clId="{BA1F9235-DE2C-433E-8776-BF88F36CDC29}" dt="2022-07-11T21:06:33.034" v="1686" actId="1076"/>
          <ac:spMkLst>
            <pc:docMk/>
            <pc:sldMk cId="1934854818" sldId="262"/>
            <ac:spMk id="20" creationId="{DBFB03F8-1828-A3A9-774C-6CD0B028C830}"/>
          </ac:spMkLst>
        </pc:spChg>
        <pc:spChg chg="add mod">
          <ac:chgData name="Papaioannou, Ioannis" userId="27d0d6e0-1133-45d1-b366-9071ba1a55b0" providerId="ADAL" clId="{BA1F9235-DE2C-433E-8776-BF88F36CDC29}" dt="2022-07-11T21:31:19.328" v="1698" actId="1076"/>
          <ac:spMkLst>
            <pc:docMk/>
            <pc:sldMk cId="1934854818" sldId="262"/>
            <ac:spMk id="21" creationId="{7B99ACD6-9F6A-5CA7-A0B5-EB50CBA71783}"/>
          </ac:spMkLst>
        </pc:spChg>
        <pc:picChg chg="add mod">
          <ac:chgData name="Papaioannou, Ioannis" userId="27d0d6e0-1133-45d1-b366-9071ba1a55b0" providerId="ADAL" clId="{BA1F9235-DE2C-433E-8776-BF88F36CDC29}" dt="2022-07-04T20:53:25.016" v="1144" actId="1076"/>
          <ac:picMkLst>
            <pc:docMk/>
            <pc:sldMk cId="1934854818" sldId="262"/>
            <ac:picMk id="3" creationId="{DF722C31-E267-2472-B3D1-FE229FE37563}"/>
          </ac:picMkLst>
        </pc:picChg>
        <pc:picChg chg="add mod">
          <ac:chgData name="Papaioannou, Ioannis" userId="27d0d6e0-1133-45d1-b366-9071ba1a55b0" providerId="ADAL" clId="{BA1F9235-DE2C-433E-8776-BF88F36CDC29}" dt="2022-07-11T21:06:33.034" v="1686" actId="1076"/>
          <ac:picMkLst>
            <pc:docMk/>
            <pc:sldMk cId="1934854818" sldId="262"/>
            <ac:picMk id="4" creationId="{EFB21EEC-04FE-E1E5-C0CD-7B593D9FC7B9}"/>
          </ac:picMkLst>
        </pc:picChg>
        <pc:picChg chg="add mod">
          <ac:chgData name="Papaioannou, Ioannis" userId="27d0d6e0-1133-45d1-b366-9071ba1a55b0" providerId="ADAL" clId="{BA1F9235-DE2C-433E-8776-BF88F36CDC29}" dt="2022-07-11T21:06:33.034" v="1686" actId="1076"/>
          <ac:picMkLst>
            <pc:docMk/>
            <pc:sldMk cId="1934854818" sldId="262"/>
            <ac:picMk id="5" creationId="{E8209F31-4F50-6FCC-600A-481C7AF930DA}"/>
          </ac:picMkLst>
        </pc:picChg>
        <pc:picChg chg="add mod">
          <ac:chgData name="Papaioannou, Ioannis" userId="27d0d6e0-1133-45d1-b366-9071ba1a55b0" providerId="ADAL" clId="{BA1F9235-DE2C-433E-8776-BF88F36CDC29}" dt="2022-07-11T21:06:33.034" v="1686" actId="1076"/>
          <ac:picMkLst>
            <pc:docMk/>
            <pc:sldMk cId="1934854818" sldId="262"/>
            <ac:picMk id="6" creationId="{C62F8E07-7152-E5A5-778A-674A9AFDDF88}"/>
          </ac:picMkLst>
        </pc:picChg>
        <pc:picChg chg="add mod">
          <ac:chgData name="Papaioannou, Ioannis" userId="27d0d6e0-1133-45d1-b366-9071ba1a55b0" providerId="ADAL" clId="{BA1F9235-DE2C-433E-8776-BF88F36CDC29}" dt="2022-07-11T21:06:33.034" v="1686" actId="1076"/>
          <ac:picMkLst>
            <pc:docMk/>
            <pc:sldMk cId="1934854818" sldId="262"/>
            <ac:picMk id="12" creationId="{B5F3576A-1F77-3D86-8002-57D10833F531}"/>
          </ac:picMkLst>
        </pc:picChg>
        <pc:picChg chg="add mod">
          <ac:chgData name="Papaioannou, Ioannis" userId="27d0d6e0-1133-45d1-b366-9071ba1a55b0" providerId="ADAL" clId="{BA1F9235-DE2C-433E-8776-BF88F36CDC29}" dt="2022-07-11T21:06:33.034" v="1686" actId="1076"/>
          <ac:picMkLst>
            <pc:docMk/>
            <pc:sldMk cId="1934854818" sldId="262"/>
            <ac:picMk id="13" creationId="{E3A3B174-E4C8-F26C-EB4D-804563F9567F}"/>
          </ac:picMkLst>
        </pc:picChg>
        <pc:picChg chg="add mod">
          <ac:chgData name="Papaioannou, Ioannis" userId="27d0d6e0-1133-45d1-b366-9071ba1a55b0" providerId="ADAL" clId="{BA1F9235-DE2C-433E-8776-BF88F36CDC29}" dt="2022-07-11T21:06:33.034" v="1686" actId="1076"/>
          <ac:picMkLst>
            <pc:docMk/>
            <pc:sldMk cId="1934854818" sldId="262"/>
            <ac:picMk id="14" creationId="{25E58EBA-8944-5FA6-ABFC-9B19EE1AEBC7}"/>
          </ac:picMkLst>
        </pc:picChg>
      </pc:sldChg>
      <pc:sldChg chg="addSp delSp modSp add mod">
        <pc:chgData name="Papaioannou, Ioannis" userId="27d0d6e0-1133-45d1-b366-9071ba1a55b0" providerId="ADAL" clId="{BA1F9235-DE2C-433E-8776-BF88F36CDC29}" dt="2022-07-11T21:31:10.192" v="1696" actId="6549"/>
        <pc:sldMkLst>
          <pc:docMk/>
          <pc:sldMk cId="1358340535" sldId="263"/>
        </pc:sldMkLst>
        <pc:spChg chg="add mod">
          <ac:chgData name="Papaioannou, Ioannis" userId="27d0d6e0-1133-45d1-b366-9071ba1a55b0" providerId="ADAL" clId="{BA1F9235-DE2C-433E-8776-BF88F36CDC29}" dt="2022-07-11T13:55:57.841" v="1486" actId="1076"/>
          <ac:spMkLst>
            <pc:docMk/>
            <pc:sldMk cId="1358340535" sldId="263"/>
            <ac:spMk id="2" creationId="{C958BD29-9B4A-3439-058B-25B4B0D09DC9}"/>
          </ac:spMkLst>
        </pc:spChg>
        <pc:spChg chg="mod">
          <ac:chgData name="Papaioannou, Ioannis" userId="27d0d6e0-1133-45d1-b366-9071ba1a55b0" providerId="ADAL" clId="{BA1F9235-DE2C-433E-8776-BF88F36CDC29}" dt="2022-07-11T12:43:39.498" v="1294" actId="1076"/>
          <ac:spMkLst>
            <pc:docMk/>
            <pc:sldMk cId="1358340535" sldId="263"/>
            <ac:spMk id="10" creationId="{3C16DB6D-2F93-6176-465F-9A95D192B8D8}"/>
          </ac:spMkLst>
        </pc:spChg>
        <pc:spChg chg="add del mod">
          <ac:chgData name="Papaioannou, Ioannis" userId="27d0d6e0-1133-45d1-b366-9071ba1a55b0" providerId="ADAL" clId="{BA1F9235-DE2C-433E-8776-BF88F36CDC29}" dt="2022-07-11T13:42:47.186" v="1321" actId="478"/>
          <ac:spMkLst>
            <pc:docMk/>
            <pc:sldMk cId="1358340535" sldId="263"/>
            <ac:spMk id="17" creationId="{BF470983-FA1C-6530-E746-0188AF2D77DB}"/>
          </ac:spMkLst>
        </pc:spChg>
        <pc:spChg chg="add mod">
          <ac:chgData name="Papaioannou, Ioannis" userId="27d0d6e0-1133-45d1-b366-9071ba1a55b0" providerId="ADAL" clId="{BA1F9235-DE2C-433E-8776-BF88F36CDC29}" dt="2022-07-11T13:55:38.715" v="1477" actId="196"/>
          <ac:spMkLst>
            <pc:docMk/>
            <pc:sldMk cId="1358340535" sldId="263"/>
            <ac:spMk id="18" creationId="{735DDD33-D945-06EE-5056-F69D006E1773}"/>
          </ac:spMkLst>
        </pc:spChg>
        <pc:spChg chg="add del mod">
          <ac:chgData name="Papaioannou, Ioannis" userId="27d0d6e0-1133-45d1-b366-9071ba1a55b0" providerId="ADAL" clId="{BA1F9235-DE2C-433E-8776-BF88F36CDC29}" dt="2022-07-11T13:46:46.156" v="1364" actId="478"/>
          <ac:spMkLst>
            <pc:docMk/>
            <pc:sldMk cId="1358340535" sldId="263"/>
            <ac:spMk id="19" creationId="{DFCB7E45-1811-4822-B3EF-D1DF0D80AC6F}"/>
          </ac:spMkLst>
        </pc:spChg>
        <pc:spChg chg="add mod">
          <ac:chgData name="Papaioannou, Ioannis" userId="27d0d6e0-1133-45d1-b366-9071ba1a55b0" providerId="ADAL" clId="{BA1F9235-DE2C-433E-8776-BF88F36CDC29}" dt="2022-07-11T13:44:15.074" v="1338" actId="1076"/>
          <ac:spMkLst>
            <pc:docMk/>
            <pc:sldMk cId="1358340535" sldId="263"/>
            <ac:spMk id="21" creationId="{FFBD5BD0-F438-8637-5D25-B3A17BB2B552}"/>
          </ac:spMkLst>
        </pc:spChg>
        <pc:spChg chg="add mod">
          <ac:chgData name="Papaioannou, Ioannis" userId="27d0d6e0-1133-45d1-b366-9071ba1a55b0" providerId="ADAL" clId="{BA1F9235-DE2C-433E-8776-BF88F36CDC29}" dt="2022-07-11T13:45:23.582" v="1346" actId="207"/>
          <ac:spMkLst>
            <pc:docMk/>
            <pc:sldMk cId="1358340535" sldId="263"/>
            <ac:spMk id="22" creationId="{3144D51A-C19A-CA27-7E50-FD9A93400158}"/>
          </ac:spMkLst>
        </pc:spChg>
        <pc:spChg chg="add mod">
          <ac:chgData name="Papaioannou, Ioannis" userId="27d0d6e0-1133-45d1-b366-9071ba1a55b0" providerId="ADAL" clId="{BA1F9235-DE2C-433E-8776-BF88F36CDC29}" dt="2022-07-11T13:45:30.054" v="1348" actId="14100"/>
          <ac:spMkLst>
            <pc:docMk/>
            <pc:sldMk cId="1358340535" sldId="263"/>
            <ac:spMk id="23" creationId="{7053130D-5B6F-1617-88A5-ACBD0005573F}"/>
          </ac:spMkLst>
        </pc:spChg>
        <pc:spChg chg="add mod">
          <ac:chgData name="Papaioannou, Ioannis" userId="27d0d6e0-1133-45d1-b366-9071ba1a55b0" providerId="ADAL" clId="{BA1F9235-DE2C-433E-8776-BF88F36CDC29}" dt="2022-07-11T13:45:51.740" v="1357" actId="1076"/>
          <ac:spMkLst>
            <pc:docMk/>
            <pc:sldMk cId="1358340535" sldId="263"/>
            <ac:spMk id="24" creationId="{70DA175B-314C-5321-D1A8-78431090A39E}"/>
          </ac:spMkLst>
        </pc:spChg>
        <pc:spChg chg="add mod">
          <ac:chgData name="Papaioannou, Ioannis" userId="27d0d6e0-1133-45d1-b366-9071ba1a55b0" providerId="ADAL" clId="{BA1F9235-DE2C-433E-8776-BF88F36CDC29}" dt="2022-07-11T13:48:41.645" v="1379" actId="571"/>
          <ac:spMkLst>
            <pc:docMk/>
            <pc:sldMk cId="1358340535" sldId="263"/>
            <ac:spMk id="25" creationId="{D476B235-64DD-7413-3ED3-DFA59D9B2716}"/>
          </ac:spMkLst>
        </pc:spChg>
        <pc:spChg chg="add mod">
          <ac:chgData name="Papaioannou, Ioannis" userId="27d0d6e0-1133-45d1-b366-9071ba1a55b0" providerId="ADAL" clId="{BA1F9235-DE2C-433E-8776-BF88F36CDC29}" dt="2022-07-11T13:55:38.715" v="1477" actId="196"/>
          <ac:spMkLst>
            <pc:docMk/>
            <pc:sldMk cId="1358340535" sldId="263"/>
            <ac:spMk id="26" creationId="{7766872C-0A07-1922-62AE-9D32E8C505F2}"/>
          </ac:spMkLst>
        </pc:spChg>
        <pc:spChg chg="add mod">
          <ac:chgData name="Papaioannou, Ioannis" userId="27d0d6e0-1133-45d1-b366-9071ba1a55b0" providerId="ADAL" clId="{BA1F9235-DE2C-433E-8776-BF88F36CDC29}" dt="2022-07-11T13:55:38.715" v="1477" actId="196"/>
          <ac:spMkLst>
            <pc:docMk/>
            <pc:sldMk cId="1358340535" sldId="263"/>
            <ac:spMk id="27" creationId="{EFF7B304-0A2D-CFCD-508D-9C3298095EC2}"/>
          </ac:spMkLst>
        </pc:spChg>
        <pc:spChg chg="add mod">
          <ac:chgData name="Papaioannou, Ioannis" userId="27d0d6e0-1133-45d1-b366-9071ba1a55b0" providerId="ADAL" clId="{BA1F9235-DE2C-433E-8776-BF88F36CDC29}" dt="2022-07-11T21:31:10.192" v="1696" actId="6549"/>
          <ac:spMkLst>
            <pc:docMk/>
            <pc:sldMk cId="1358340535" sldId="263"/>
            <ac:spMk id="28" creationId="{48B1942E-3A20-FF6E-39D0-60D2D2FC063F}"/>
          </ac:spMkLst>
        </pc:spChg>
        <pc:picChg chg="add del mod">
          <ac:chgData name="Papaioannou, Ioannis" userId="27d0d6e0-1133-45d1-b366-9071ba1a55b0" providerId="ADAL" clId="{BA1F9235-DE2C-433E-8776-BF88F36CDC29}" dt="2022-07-11T13:41:23.901" v="1305" actId="478"/>
          <ac:picMkLst>
            <pc:docMk/>
            <pc:sldMk cId="1358340535" sldId="263"/>
            <ac:picMk id="3" creationId="{F5B36811-CDBC-23E0-712D-36A9AB84F51A}"/>
          </ac:picMkLst>
        </pc:picChg>
        <pc:picChg chg="add mod">
          <ac:chgData name="Papaioannou, Ioannis" userId="27d0d6e0-1133-45d1-b366-9071ba1a55b0" providerId="ADAL" clId="{BA1F9235-DE2C-433E-8776-BF88F36CDC29}" dt="2022-07-11T13:43:20.766" v="1328" actId="1076"/>
          <ac:picMkLst>
            <pc:docMk/>
            <pc:sldMk cId="1358340535" sldId="263"/>
            <ac:picMk id="4" creationId="{64F2952F-A7A5-B7D1-497D-BA577B44B9CE}"/>
          </ac:picMkLst>
        </pc:picChg>
        <pc:picChg chg="add del mod">
          <ac:chgData name="Papaioannou, Ioannis" userId="27d0d6e0-1133-45d1-b366-9071ba1a55b0" providerId="ADAL" clId="{BA1F9235-DE2C-433E-8776-BF88F36CDC29}" dt="2022-07-04T21:03:26.940" v="1236" actId="478"/>
          <ac:picMkLst>
            <pc:docMk/>
            <pc:sldMk cId="1358340535" sldId="263"/>
            <ac:picMk id="4" creationId="{AB28BBE1-D421-D5E0-0CAC-C272AB557735}"/>
          </ac:picMkLst>
        </pc:picChg>
        <pc:picChg chg="add del mod">
          <ac:chgData name="Papaioannou, Ioannis" userId="27d0d6e0-1133-45d1-b366-9071ba1a55b0" providerId="ADAL" clId="{BA1F9235-DE2C-433E-8776-BF88F36CDC29}" dt="2022-07-04T21:03:26.169" v="1234" actId="478"/>
          <ac:picMkLst>
            <pc:docMk/>
            <pc:sldMk cId="1358340535" sldId="263"/>
            <ac:picMk id="5" creationId="{E63426FE-2AE7-78B2-11A4-DF3DF205B1C6}"/>
          </ac:picMkLst>
        </pc:picChg>
        <pc:picChg chg="add mod">
          <ac:chgData name="Papaioannou, Ioannis" userId="27d0d6e0-1133-45d1-b366-9071ba1a55b0" providerId="ADAL" clId="{BA1F9235-DE2C-433E-8776-BF88F36CDC29}" dt="2022-07-11T13:44:28.236" v="1340" actId="196"/>
          <ac:picMkLst>
            <pc:docMk/>
            <pc:sldMk cId="1358340535" sldId="263"/>
            <ac:picMk id="7" creationId="{652C654C-A53C-22FA-B4D2-8F78B38F81C1}"/>
          </ac:picMkLst>
        </pc:picChg>
        <pc:picChg chg="add del mod">
          <ac:chgData name="Papaioannou, Ioannis" userId="27d0d6e0-1133-45d1-b366-9071ba1a55b0" providerId="ADAL" clId="{BA1F9235-DE2C-433E-8776-BF88F36CDC29}" dt="2022-07-11T13:41:38.664" v="1310" actId="478"/>
          <ac:picMkLst>
            <pc:docMk/>
            <pc:sldMk cId="1358340535" sldId="263"/>
            <ac:picMk id="9" creationId="{1988FCC6-D9FE-442C-CB1A-E8B4906514A5}"/>
          </ac:picMkLst>
        </pc:picChg>
        <pc:picChg chg="add mod">
          <ac:chgData name="Papaioannou, Ioannis" userId="27d0d6e0-1133-45d1-b366-9071ba1a55b0" providerId="ADAL" clId="{BA1F9235-DE2C-433E-8776-BF88F36CDC29}" dt="2022-07-11T13:47:38.436" v="1372" actId="1076"/>
          <ac:picMkLst>
            <pc:docMk/>
            <pc:sldMk cId="1358340535" sldId="263"/>
            <ac:picMk id="11" creationId="{3D92CE0D-2F55-4716-F21A-C9967049CF04}"/>
          </ac:picMkLst>
        </pc:picChg>
        <pc:picChg chg="add mod">
          <ac:chgData name="Papaioannou, Ioannis" userId="27d0d6e0-1133-45d1-b366-9071ba1a55b0" providerId="ADAL" clId="{BA1F9235-DE2C-433E-8776-BF88F36CDC29}" dt="2022-07-11T13:55:38.715" v="1477" actId="196"/>
          <ac:picMkLst>
            <pc:docMk/>
            <pc:sldMk cId="1358340535" sldId="263"/>
            <ac:picMk id="12" creationId="{7E352516-7147-9605-6EB5-9088257FB0BA}"/>
          </ac:picMkLst>
        </pc:picChg>
        <pc:picChg chg="add mod">
          <ac:chgData name="Papaioannou, Ioannis" userId="27d0d6e0-1133-45d1-b366-9071ba1a55b0" providerId="ADAL" clId="{BA1F9235-DE2C-433E-8776-BF88F36CDC29}" dt="2022-07-11T13:55:38.715" v="1477" actId="196"/>
          <ac:picMkLst>
            <pc:docMk/>
            <pc:sldMk cId="1358340535" sldId="263"/>
            <ac:picMk id="13" creationId="{5E1EDE3B-B4BE-9D8F-E123-46F4192DC327}"/>
          </ac:picMkLst>
        </pc:picChg>
        <pc:picChg chg="add del mod">
          <ac:chgData name="Papaioannou, Ioannis" userId="27d0d6e0-1133-45d1-b366-9071ba1a55b0" providerId="ADAL" clId="{BA1F9235-DE2C-433E-8776-BF88F36CDC29}" dt="2022-07-08T15:09:02.680" v="1292" actId="478"/>
          <ac:picMkLst>
            <pc:docMk/>
            <pc:sldMk cId="1358340535" sldId="263"/>
            <ac:picMk id="20" creationId="{3CC4D7C2-F2F2-2237-A0DD-B140ACCBD846}"/>
          </ac:picMkLst>
        </pc:picChg>
        <pc:picChg chg="add mod">
          <ac:chgData name="Papaioannou, Ioannis" userId="27d0d6e0-1133-45d1-b366-9071ba1a55b0" providerId="ADAL" clId="{BA1F9235-DE2C-433E-8776-BF88F36CDC29}" dt="2022-07-11T13:41:30.026" v="1309" actId="1076"/>
          <ac:picMkLst>
            <pc:docMk/>
            <pc:sldMk cId="1358340535" sldId="263"/>
            <ac:picMk id="20" creationId="{58F00153-2B09-9F80-0277-A3362D1477E0}"/>
          </ac:picMkLst>
        </pc:picChg>
        <pc:inkChg chg="add del">
          <ac:chgData name="Papaioannou, Ioannis" userId="27d0d6e0-1133-45d1-b366-9071ba1a55b0" providerId="ADAL" clId="{BA1F9235-DE2C-433E-8776-BF88F36CDC29}" dt="2022-07-11T13:45:06.166" v="1342" actId="478"/>
          <ac:inkMkLst>
            <pc:docMk/>
            <pc:sldMk cId="1358340535" sldId="263"/>
            <ac:inkMk id="2" creationId="{2997DA4D-32B0-38AE-FCB5-BB03A896A479}"/>
          </ac:inkMkLst>
        </pc:inkChg>
        <pc:inkChg chg="add">
          <ac:chgData name="Papaioannou, Ioannis" userId="27d0d6e0-1133-45d1-b366-9071ba1a55b0" providerId="ADAL" clId="{BA1F9235-DE2C-433E-8776-BF88F36CDC29}" dt="2022-07-08T14:52:20.451" v="1242" actId="9405"/>
          <ac:inkMkLst>
            <pc:docMk/>
            <pc:sldMk cId="1358340535" sldId="263"/>
            <ac:inkMk id="5" creationId="{0FDC1146-7821-183A-1BDA-70A3F61A5BE7}"/>
          </ac:inkMkLst>
        </pc:inkChg>
        <pc:inkChg chg="add del mod">
          <ac:chgData name="Papaioannou, Ioannis" userId="27d0d6e0-1133-45d1-b366-9071ba1a55b0" providerId="ADAL" clId="{BA1F9235-DE2C-433E-8776-BF88F36CDC29}" dt="2022-07-11T13:44:49.174" v="1341" actId="478"/>
          <ac:inkMkLst>
            <pc:docMk/>
            <pc:sldMk cId="1358340535" sldId="263"/>
            <ac:inkMk id="6" creationId="{8CDAA1A9-90CE-4D7C-39D2-63400A53EFA8}"/>
          </ac:inkMkLst>
        </pc:inkChg>
        <pc:inkChg chg="add del">
          <ac:chgData name="Papaioannou, Ioannis" userId="27d0d6e0-1133-45d1-b366-9071ba1a55b0" providerId="ADAL" clId="{BA1F9235-DE2C-433E-8776-BF88F36CDC29}" dt="2022-07-11T13:45:06.166" v="1342" actId="478"/>
          <ac:inkMkLst>
            <pc:docMk/>
            <pc:sldMk cId="1358340535" sldId="263"/>
            <ac:inkMk id="8" creationId="{115F2E66-5259-CB3D-50F7-6345ED80DE67}"/>
          </ac:inkMkLst>
        </pc:inkChg>
        <pc:inkChg chg="add del mod">
          <ac:chgData name="Papaioannou, Ioannis" userId="27d0d6e0-1133-45d1-b366-9071ba1a55b0" providerId="ADAL" clId="{BA1F9235-DE2C-433E-8776-BF88F36CDC29}" dt="2022-07-11T13:45:06.166" v="1342" actId="478"/>
          <ac:inkMkLst>
            <pc:docMk/>
            <pc:sldMk cId="1358340535" sldId="263"/>
            <ac:inkMk id="14" creationId="{F15166BC-F6D6-D031-6CE2-91624856FDBB}"/>
          </ac:inkMkLst>
        </pc:inkChg>
        <pc:inkChg chg="add del">
          <ac:chgData name="Papaioannou, Ioannis" userId="27d0d6e0-1133-45d1-b366-9071ba1a55b0" providerId="ADAL" clId="{BA1F9235-DE2C-433E-8776-BF88F36CDC29}" dt="2022-07-08T14:59:58.407" v="1255" actId="9405"/>
          <ac:inkMkLst>
            <pc:docMk/>
            <pc:sldMk cId="1358340535" sldId="263"/>
            <ac:inkMk id="15" creationId="{2B780639-397D-F60A-1D1E-EAAF1E780473}"/>
          </ac:inkMkLst>
        </pc:inkChg>
        <pc:inkChg chg="add del mod">
          <ac:chgData name="Papaioannou, Ioannis" userId="27d0d6e0-1133-45d1-b366-9071ba1a55b0" providerId="ADAL" clId="{BA1F9235-DE2C-433E-8776-BF88F36CDC29}" dt="2022-07-11T13:45:06.166" v="1342" actId="478"/>
          <ac:inkMkLst>
            <pc:docMk/>
            <pc:sldMk cId="1358340535" sldId="263"/>
            <ac:inkMk id="16" creationId="{A98003E3-66EF-1B17-C1DC-48B17391FEE7}"/>
          </ac:inkMkLst>
        </pc:inkChg>
      </pc:sldChg>
      <pc:sldChg chg="addSp modSp add del mod">
        <pc:chgData name="Papaioannou, Ioannis" userId="27d0d6e0-1133-45d1-b366-9071ba1a55b0" providerId="ADAL" clId="{BA1F9235-DE2C-433E-8776-BF88F36CDC29}" dt="2022-07-11T13:50:58.393" v="1466" actId="47"/>
        <pc:sldMkLst>
          <pc:docMk/>
          <pc:sldMk cId="1136400467" sldId="264"/>
        </pc:sldMkLst>
        <pc:spChg chg="mod">
          <ac:chgData name="Papaioannou, Ioannis" userId="27d0d6e0-1133-45d1-b366-9071ba1a55b0" providerId="ADAL" clId="{BA1F9235-DE2C-433E-8776-BF88F36CDC29}" dt="2022-06-23T15:42:15.572" v="172" actId="20577"/>
          <ac:spMkLst>
            <pc:docMk/>
            <pc:sldMk cId="1136400467" sldId="264"/>
            <ac:spMk id="10" creationId="{3C16DB6D-2F93-6176-465F-9A95D192B8D8}"/>
          </ac:spMkLst>
        </pc:spChg>
        <pc:picChg chg="add mod">
          <ac:chgData name="Papaioannou, Ioannis" userId="27d0d6e0-1133-45d1-b366-9071ba1a55b0" providerId="ADAL" clId="{BA1F9235-DE2C-433E-8776-BF88F36CDC29}" dt="2022-06-24T11:16:51.197" v="687" actId="1076"/>
          <ac:picMkLst>
            <pc:docMk/>
            <pc:sldMk cId="1136400467" sldId="264"/>
            <ac:picMk id="3" creationId="{3C3EE137-E578-9C5E-5A95-6D449CE8EDCA}"/>
          </ac:picMkLst>
        </pc:picChg>
      </pc:sldChg>
      <pc:sldChg chg="addSp modSp add del mod">
        <pc:chgData name="Papaioannou, Ioannis" userId="27d0d6e0-1133-45d1-b366-9071ba1a55b0" providerId="ADAL" clId="{BA1F9235-DE2C-433E-8776-BF88F36CDC29}" dt="2022-07-11T13:50:58.393" v="1466" actId="47"/>
        <pc:sldMkLst>
          <pc:docMk/>
          <pc:sldMk cId="126496613" sldId="265"/>
        </pc:sldMkLst>
        <pc:spChg chg="mod">
          <ac:chgData name="Papaioannou, Ioannis" userId="27d0d6e0-1133-45d1-b366-9071ba1a55b0" providerId="ADAL" clId="{BA1F9235-DE2C-433E-8776-BF88F36CDC29}" dt="2022-06-23T15:42:25.911" v="174" actId="20577"/>
          <ac:spMkLst>
            <pc:docMk/>
            <pc:sldMk cId="126496613" sldId="265"/>
            <ac:spMk id="10" creationId="{3C16DB6D-2F93-6176-465F-9A95D192B8D8}"/>
          </ac:spMkLst>
        </pc:spChg>
        <pc:picChg chg="add mod">
          <ac:chgData name="Papaioannou, Ioannis" userId="27d0d6e0-1133-45d1-b366-9071ba1a55b0" providerId="ADAL" clId="{BA1F9235-DE2C-433E-8776-BF88F36CDC29}" dt="2022-06-24T11:17:03.650" v="689" actId="1076"/>
          <ac:picMkLst>
            <pc:docMk/>
            <pc:sldMk cId="126496613" sldId="265"/>
            <ac:picMk id="3" creationId="{38DA8977-FFC4-C6CF-4FE3-43A886474C40}"/>
          </ac:picMkLst>
        </pc:picChg>
      </pc:sldChg>
      <pc:sldChg chg="addSp delSp modSp mod">
        <pc:chgData name="Papaioannou, Ioannis" userId="27d0d6e0-1133-45d1-b366-9071ba1a55b0" providerId="ADAL" clId="{BA1F9235-DE2C-433E-8776-BF88F36CDC29}" dt="2022-07-11T21:32:20.986" v="1716" actId="1076"/>
        <pc:sldMkLst>
          <pc:docMk/>
          <pc:sldMk cId="1608280500" sldId="266"/>
        </pc:sldMkLst>
        <pc:spChg chg="del mod">
          <ac:chgData name="Papaioannou, Ioannis" userId="27d0d6e0-1133-45d1-b366-9071ba1a55b0" providerId="ADAL" clId="{BA1F9235-DE2C-433E-8776-BF88F36CDC29}" dt="2022-06-27T11:12:42.167" v="708" actId="478"/>
          <ac:spMkLst>
            <pc:docMk/>
            <pc:sldMk cId="1608280500" sldId="266"/>
            <ac:spMk id="5" creationId="{95320EB3-E309-4FE0-AF49-48005DAF6278}"/>
          </ac:spMkLst>
        </pc:spChg>
        <pc:spChg chg="mod">
          <ac:chgData name="Papaioannou, Ioannis" userId="27d0d6e0-1133-45d1-b366-9071ba1a55b0" providerId="ADAL" clId="{BA1F9235-DE2C-433E-8776-BF88F36CDC29}" dt="2022-06-27T11:21:19.751" v="769" actId="14100"/>
          <ac:spMkLst>
            <pc:docMk/>
            <pc:sldMk cId="1608280500" sldId="266"/>
            <ac:spMk id="6" creationId="{B20D95A9-82C7-499D-AC8B-02CC0BA1BF81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7" creationId="{694FA385-8809-4F28-BB80-FD3F777537E6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8" creationId="{915D17D3-BA1E-4384-90A6-7E93F6E62093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10" creationId="{2F9EB673-84E0-4B42-9C21-0CB54FC08656}"/>
          </ac:spMkLst>
        </pc:spChg>
        <pc:spChg chg="mod">
          <ac:chgData name="Papaioannou, Ioannis" userId="27d0d6e0-1133-45d1-b366-9071ba1a55b0" providerId="ADAL" clId="{BA1F9235-DE2C-433E-8776-BF88F36CDC29}" dt="2022-07-11T21:03:32.850" v="1561" actId="1076"/>
          <ac:spMkLst>
            <pc:docMk/>
            <pc:sldMk cId="1608280500" sldId="266"/>
            <ac:spMk id="11" creationId="{3DD62F02-5B08-409E-AB86-90723D464744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15" creationId="{F0DEC7C2-F7A0-49E9-9BE4-8065EF3A4211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16" creationId="{873B2975-1D40-46FD-9CE0-15354C4A95CD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20" creationId="{2E415E50-721C-4D4F-A316-AA4E3231A15C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21" creationId="{F1B33612-8254-4E53-BCB7-DE9AB2321756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26" creationId="{68BD16E7-15C5-4D9B-88D3-8EB419E7B758}"/>
          </ac:spMkLst>
        </pc:spChg>
        <pc:spChg chg="add mod">
          <ac:chgData name="Papaioannou, Ioannis" userId="27d0d6e0-1133-45d1-b366-9071ba1a55b0" providerId="ADAL" clId="{BA1F9235-DE2C-433E-8776-BF88F36CDC29}" dt="2022-07-11T21:32:20.986" v="1716" actId="1076"/>
          <ac:spMkLst>
            <pc:docMk/>
            <pc:sldMk cId="1608280500" sldId="266"/>
            <ac:spMk id="30" creationId="{EDF4327F-56E5-CA0D-6CD0-27909867DB7F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31" creationId="{CDDC0619-31D8-4D38-870F-7830F9EF1C73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35" creationId="{1BFC564A-0AE5-48EC-A0EA-B5A4C4067597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36" creationId="{07152B2A-50F8-4DE6-891C-BFD3A7673C20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41" creationId="{0D0BDDF1-43FD-4627-9C13-09C7E776E272}"/>
          </ac:spMkLst>
        </pc:spChg>
        <pc:spChg chg="mod">
          <ac:chgData name="Papaioannou, Ioannis" userId="27d0d6e0-1133-45d1-b366-9071ba1a55b0" providerId="ADAL" clId="{BA1F9235-DE2C-433E-8776-BF88F36CDC29}" dt="2022-06-27T11:21:29.126" v="771" actId="1038"/>
          <ac:spMkLst>
            <pc:docMk/>
            <pc:sldMk cId="1608280500" sldId="266"/>
            <ac:spMk id="43" creationId="{B5B34BBA-A603-4288-BBBD-1331CC5FC8CD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44" creationId="{EEDC18CB-1974-4AD4-8E95-DD7899D51041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46" creationId="{BADB01C4-4CF4-4714-8097-E9D6936103D5}"/>
          </ac:spMkLst>
        </pc:spChg>
        <pc:spChg chg="mod">
          <ac:chgData name="Papaioannou, Ioannis" userId="27d0d6e0-1133-45d1-b366-9071ba1a55b0" providerId="ADAL" clId="{BA1F9235-DE2C-433E-8776-BF88F36CDC29}" dt="2022-06-27T11:20:16.944" v="752" actId="1076"/>
          <ac:spMkLst>
            <pc:docMk/>
            <pc:sldMk cId="1608280500" sldId="266"/>
            <ac:spMk id="47" creationId="{F72E833C-86C3-489C-BDC9-7A152FAE814C}"/>
          </ac:spMkLst>
        </pc:spChg>
        <pc:picChg chg="mod">
          <ac:chgData name="Papaioannou, Ioannis" userId="27d0d6e0-1133-45d1-b366-9071ba1a55b0" providerId="ADAL" clId="{BA1F9235-DE2C-433E-8776-BF88F36CDC29}" dt="2022-06-27T11:20:16.944" v="752" actId="1076"/>
          <ac:picMkLst>
            <pc:docMk/>
            <pc:sldMk cId="1608280500" sldId="266"/>
            <ac:picMk id="3" creationId="{EECBE821-42A0-4D15-AEE9-5823945E5703}"/>
          </ac:picMkLst>
        </pc:picChg>
        <pc:picChg chg="mod">
          <ac:chgData name="Papaioannou, Ioannis" userId="27d0d6e0-1133-45d1-b366-9071ba1a55b0" providerId="ADAL" clId="{BA1F9235-DE2C-433E-8776-BF88F36CDC29}" dt="2022-06-27T11:20:16.944" v="752" actId="1076"/>
          <ac:picMkLst>
            <pc:docMk/>
            <pc:sldMk cId="1608280500" sldId="266"/>
            <ac:picMk id="24" creationId="{1E9E8DBC-A4F2-4DA5-9BD5-9AAE89F524C2}"/>
          </ac:picMkLst>
        </pc:picChg>
        <pc:picChg chg="add mod">
          <ac:chgData name="Papaioannou, Ioannis" userId="27d0d6e0-1133-45d1-b366-9071ba1a55b0" providerId="ADAL" clId="{BA1F9235-DE2C-433E-8776-BF88F36CDC29}" dt="2022-07-11T21:03:28.904" v="1559" actId="1076"/>
          <ac:picMkLst>
            <pc:docMk/>
            <pc:sldMk cId="1608280500" sldId="266"/>
            <ac:picMk id="29" creationId="{3AA77BD3-EBAE-720E-A7F7-AC62647F43CA}"/>
          </ac:picMkLst>
        </pc:picChg>
        <pc:picChg chg="mod">
          <ac:chgData name="Papaioannou, Ioannis" userId="27d0d6e0-1133-45d1-b366-9071ba1a55b0" providerId="ADAL" clId="{BA1F9235-DE2C-433E-8776-BF88F36CDC29}" dt="2022-06-27T11:20:16.944" v="752" actId="1076"/>
          <ac:picMkLst>
            <pc:docMk/>
            <pc:sldMk cId="1608280500" sldId="266"/>
            <ac:picMk id="32" creationId="{FAE965A1-1B85-43DE-A23E-3B0679AE1F55}"/>
          </ac:picMkLst>
        </pc:picChg>
        <pc:picChg chg="mod">
          <ac:chgData name="Papaioannou, Ioannis" userId="27d0d6e0-1133-45d1-b366-9071ba1a55b0" providerId="ADAL" clId="{BA1F9235-DE2C-433E-8776-BF88F36CDC29}" dt="2022-06-27T11:20:16.944" v="752" actId="1076"/>
          <ac:picMkLst>
            <pc:docMk/>
            <pc:sldMk cId="1608280500" sldId="266"/>
            <ac:picMk id="33" creationId="{B07659F6-FF64-4375-8FD6-198FB2863040}"/>
          </ac:picMkLst>
        </pc:picChg>
        <pc:picChg chg="mod">
          <ac:chgData name="Papaioannou, Ioannis" userId="27d0d6e0-1133-45d1-b366-9071ba1a55b0" providerId="ADAL" clId="{BA1F9235-DE2C-433E-8776-BF88F36CDC29}" dt="2022-06-27T11:20:16.944" v="752" actId="1076"/>
          <ac:picMkLst>
            <pc:docMk/>
            <pc:sldMk cId="1608280500" sldId="266"/>
            <ac:picMk id="34" creationId="{B4972A4B-289E-433A-B86D-DA2E760A91CC}"/>
          </ac:picMkLst>
        </pc:picChg>
        <pc:picChg chg="mod">
          <ac:chgData name="Papaioannou, Ioannis" userId="27d0d6e0-1133-45d1-b366-9071ba1a55b0" providerId="ADAL" clId="{BA1F9235-DE2C-433E-8776-BF88F36CDC29}" dt="2022-06-27T11:20:16.944" v="752" actId="1076"/>
          <ac:picMkLst>
            <pc:docMk/>
            <pc:sldMk cId="1608280500" sldId="266"/>
            <ac:picMk id="37" creationId="{2678878C-093B-4281-8024-C437A8EADE05}"/>
          </ac:picMkLst>
        </pc:picChg>
        <pc:picChg chg="mod">
          <ac:chgData name="Papaioannou, Ioannis" userId="27d0d6e0-1133-45d1-b366-9071ba1a55b0" providerId="ADAL" clId="{BA1F9235-DE2C-433E-8776-BF88F36CDC29}" dt="2022-06-27T11:20:16.944" v="752" actId="1076"/>
          <ac:picMkLst>
            <pc:docMk/>
            <pc:sldMk cId="1608280500" sldId="266"/>
            <ac:picMk id="42" creationId="{9E490237-8AF9-4A76-9CAA-AB9EB66D86D8}"/>
          </ac:picMkLst>
        </pc:picChg>
        <pc:picChg chg="mod">
          <ac:chgData name="Papaioannou, Ioannis" userId="27d0d6e0-1133-45d1-b366-9071ba1a55b0" providerId="ADAL" clId="{BA1F9235-DE2C-433E-8776-BF88F36CDC29}" dt="2022-06-27T11:20:16.944" v="752" actId="1076"/>
          <ac:picMkLst>
            <pc:docMk/>
            <pc:sldMk cId="1608280500" sldId="266"/>
            <ac:picMk id="45" creationId="{E0312B37-C2FD-4B98-A5D7-BF52343D4EEA}"/>
          </ac:picMkLst>
        </pc:picChg>
      </pc:sldChg>
      <pc:sldChg chg="add del">
        <pc:chgData name="Papaioannou, Ioannis" userId="27d0d6e0-1133-45d1-b366-9071ba1a55b0" providerId="ADAL" clId="{BA1F9235-DE2C-433E-8776-BF88F36CDC29}" dt="2022-06-24T11:15:52.483" v="679"/>
        <pc:sldMkLst>
          <pc:docMk/>
          <pc:sldMk cId="4125395835" sldId="267"/>
        </pc:sldMkLst>
      </pc:sldChg>
    </pc:docChg>
  </pc:docChgLst>
  <pc:docChgLst>
    <pc:chgData name="Ponticos, Markella" userId="S::rmhampo@ucl.ac.uk::8ef50869-c47f-477f-819f-244d7318bb2d" providerId="AD" clId="Web-{159B3FE9-98E7-F479-B7A8-5CC663989BBD}"/>
    <pc:docChg chg="modSld">
      <pc:chgData name="Ponticos, Markella" userId="S::rmhampo@ucl.ac.uk::8ef50869-c47f-477f-819f-244d7318bb2d" providerId="AD" clId="Web-{159B3FE9-98E7-F479-B7A8-5CC663989BBD}" dt="2024-03-06T11:07:54.303" v="9" actId="1076"/>
      <pc:docMkLst>
        <pc:docMk/>
      </pc:docMkLst>
      <pc:sldChg chg="modSp">
        <pc:chgData name="Ponticos, Markella" userId="S::rmhampo@ucl.ac.uk::8ef50869-c47f-477f-819f-244d7318bb2d" providerId="AD" clId="Web-{159B3FE9-98E7-F479-B7A8-5CC663989BBD}" dt="2024-03-06T11:07:54.303" v="9" actId="1076"/>
        <pc:sldMkLst>
          <pc:docMk/>
          <pc:sldMk cId="2731541974" sldId="258"/>
        </pc:sldMkLst>
        <pc:spChg chg="mod">
          <ac:chgData name="Ponticos, Markella" userId="S::rmhampo@ucl.ac.uk::8ef50869-c47f-477f-819f-244d7318bb2d" providerId="AD" clId="Web-{159B3FE9-98E7-F479-B7A8-5CC663989BBD}" dt="2024-03-06T11:07:54.303" v="9" actId="1076"/>
          <ac:spMkLst>
            <pc:docMk/>
            <pc:sldMk cId="2731541974" sldId="258"/>
            <ac:spMk id="13" creationId="{9B4E1444-D491-9690-0B1E-B70B66DCE323}"/>
          </ac:spMkLst>
        </pc:spChg>
      </pc:sldChg>
      <pc:sldChg chg="modSp">
        <pc:chgData name="Ponticos, Markella" userId="S::rmhampo@ucl.ac.uk::8ef50869-c47f-477f-819f-244d7318bb2d" providerId="AD" clId="Web-{159B3FE9-98E7-F479-B7A8-5CC663989BBD}" dt="2024-03-06T11:03:05.814" v="7" actId="14100"/>
        <pc:sldMkLst>
          <pc:docMk/>
          <pc:sldMk cId="1608280500" sldId="266"/>
        </pc:sldMkLst>
        <pc:spChg chg="mod">
          <ac:chgData name="Ponticos, Markella" userId="S::rmhampo@ucl.ac.uk::8ef50869-c47f-477f-819f-244d7318bb2d" providerId="AD" clId="Web-{159B3FE9-98E7-F479-B7A8-5CC663989BBD}" dt="2024-03-06T11:03:05.814" v="7" actId="14100"/>
          <ac:spMkLst>
            <pc:docMk/>
            <pc:sldMk cId="1608280500" sldId="266"/>
            <ac:spMk id="47" creationId="{F72E833C-86C3-489C-BDC9-7A152FAE814C}"/>
          </ac:spMkLst>
        </pc:spChg>
        <pc:grpChg chg="mod">
          <ac:chgData name="Ponticos, Markella" userId="S::rmhampo@ucl.ac.uk::8ef50869-c47f-477f-819f-244d7318bb2d" providerId="AD" clId="Web-{159B3FE9-98E7-F479-B7A8-5CC663989BBD}" dt="2024-03-06T11:02:09.344" v="3" actId="1076"/>
          <ac:grpSpMkLst>
            <pc:docMk/>
            <pc:sldMk cId="1608280500" sldId="266"/>
            <ac:grpSpMk id="1029" creationId="{887FA069-6ED9-D1BE-BDD8-2EA9A37F7A12}"/>
          </ac:grpSpMkLst>
        </pc:grpChg>
        <pc:picChg chg="mod">
          <ac:chgData name="Ponticos, Markella" userId="S::rmhampo@ucl.ac.uk::8ef50869-c47f-477f-819f-244d7318bb2d" providerId="AD" clId="Web-{159B3FE9-98E7-F479-B7A8-5CC663989BBD}" dt="2024-03-06T11:02:01.204" v="1" actId="1076"/>
          <ac:picMkLst>
            <pc:docMk/>
            <pc:sldMk cId="1608280500" sldId="266"/>
            <ac:picMk id="45" creationId="{E0312B37-C2FD-4B98-A5D7-BF52343D4EEA}"/>
          </ac:picMkLst>
        </pc:picChg>
      </pc:sldChg>
    </pc:docChg>
  </pc:docChgLst>
  <pc:docChgLst>
    <pc:chgData name="Papaioannou, Ioannis" userId="27d0d6e0-1133-45d1-b366-9071ba1a55b0" providerId="ADAL" clId="{C3BA2ABD-8857-41EF-9EF9-11D4CB3E2DBC}"/>
    <pc:docChg chg="custSel modSld">
      <pc:chgData name="Papaioannou, Ioannis" userId="27d0d6e0-1133-45d1-b366-9071ba1a55b0" providerId="ADAL" clId="{C3BA2ABD-8857-41EF-9EF9-11D4CB3E2DBC}" dt="2023-09-20T13:36:47.925" v="5" actId="1076"/>
      <pc:docMkLst>
        <pc:docMk/>
      </pc:docMkLst>
      <pc:sldChg chg="addSp delSp modSp mod">
        <pc:chgData name="Papaioannou, Ioannis" userId="27d0d6e0-1133-45d1-b366-9071ba1a55b0" providerId="ADAL" clId="{C3BA2ABD-8857-41EF-9EF9-11D4CB3E2DBC}" dt="2023-09-20T13:36:47.925" v="5" actId="1076"/>
        <pc:sldMkLst>
          <pc:docMk/>
          <pc:sldMk cId="1783988844" sldId="256"/>
        </pc:sldMkLst>
        <pc:picChg chg="add mod">
          <ac:chgData name="Papaioannou, Ioannis" userId="27d0d6e0-1133-45d1-b366-9071ba1a55b0" providerId="ADAL" clId="{C3BA2ABD-8857-41EF-9EF9-11D4CB3E2DBC}" dt="2023-09-20T13:36:47.925" v="5" actId="1076"/>
          <ac:picMkLst>
            <pc:docMk/>
            <pc:sldMk cId="1783988844" sldId="256"/>
            <ac:picMk id="2" creationId="{77121E52-3070-6894-1F08-370B3A2D6958}"/>
          </ac:picMkLst>
        </pc:picChg>
        <pc:picChg chg="del">
          <ac:chgData name="Papaioannou, Ioannis" userId="27d0d6e0-1133-45d1-b366-9071ba1a55b0" providerId="ADAL" clId="{C3BA2ABD-8857-41EF-9EF9-11D4CB3E2DBC}" dt="2023-09-20T13:36:41.179" v="0" actId="478"/>
          <ac:picMkLst>
            <pc:docMk/>
            <pc:sldMk cId="1783988844" sldId="256"/>
            <ac:picMk id="4" creationId="{A7A64092-2C6B-47DF-EE61-3B35709A846A}"/>
          </ac:picMkLst>
        </pc:picChg>
      </pc:sldChg>
    </pc:docChg>
  </pc:docChgLst>
  <pc:docChgLst>
    <pc:chgData name="Papaioannou, Ioannis" userId="27d0d6e0-1133-45d1-b366-9071ba1a55b0" providerId="ADAL" clId="{B0F2CD70-F772-4ABC-91C7-3B19E0DEB205}"/>
    <pc:docChg chg="undo redo custSel addSld modSld">
      <pc:chgData name="Papaioannou, Ioannis" userId="27d0d6e0-1133-45d1-b366-9071ba1a55b0" providerId="ADAL" clId="{B0F2CD70-F772-4ABC-91C7-3B19E0DEB205}" dt="2023-12-07T19:55:21.468" v="1757" actId="1076"/>
      <pc:docMkLst>
        <pc:docMk/>
      </pc:docMkLst>
      <pc:sldChg chg="addSp delSp modSp mod delCm">
        <pc:chgData name="Papaioannou, Ioannis" userId="27d0d6e0-1133-45d1-b366-9071ba1a55b0" providerId="ADAL" clId="{B0F2CD70-F772-4ABC-91C7-3B19E0DEB205}" dt="2023-11-12T19:50:10.809" v="1591" actId="14100"/>
        <pc:sldMkLst>
          <pc:docMk/>
          <pc:sldMk cId="1783988844" sldId="256"/>
        </pc:sldMkLst>
        <pc:spChg chg="mod topLvl">
          <ac:chgData name="Papaioannou, Ioannis" userId="27d0d6e0-1133-45d1-b366-9071ba1a55b0" providerId="ADAL" clId="{B0F2CD70-F772-4ABC-91C7-3B19E0DEB205}" dt="2023-11-05T15:31:50.726" v="311" actId="164"/>
          <ac:spMkLst>
            <pc:docMk/>
            <pc:sldMk cId="1783988844" sldId="256"/>
            <ac:spMk id="3" creationId="{04F7D3DD-32AA-780D-8D19-638513B3954B}"/>
          </ac:spMkLst>
        </pc:spChg>
        <pc:spChg chg="mod topLvl">
          <ac:chgData name="Papaioannou, Ioannis" userId="27d0d6e0-1133-45d1-b366-9071ba1a55b0" providerId="ADAL" clId="{B0F2CD70-F772-4ABC-91C7-3B19E0DEB205}" dt="2023-11-05T15:31:50.726" v="311" actId="164"/>
          <ac:spMkLst>
            <pc:docMk/>
            <pc:sldMk cId="1783988844" sldId="256"/>
            <ac:spMk id="6" creationId="{FAC3BE54-E60B-9283-82B0-490B2EA549FF}"/>
          </ac:spMkLst>
        </pc:spChg>
        <pc:spChg chg="mod">
          <ac:chgData name="Papaioannou, Ioannis" userId="27d0d6e0-1133-45d1-b366-9071ba1a55b0" providerId="ADAL" clId="{B0F2CD70-F772-4ABC-91C7-3B19E0DEB205}" dt="2023-11-12T19:38:47.362" v="1560" actId="1076"/>
          <ac:spMkLst>
            <pc:docMk/>
            <pc:sldMk cId="1783988844" sldId="256"/>
            <ac:spMk id="7" creationId="{124DCE07-3F8B-D0BC-4530-DADA81D3FEF4}"/>
          </ac:spMkLst>
        </pc:spChg>
        <pc:spChg chg="mod">
          <ac:chgData name="Papaioannou, Ioannis" userId="27d0d6e0-1133-45d1-b366-9071ba1a55b0" providerId="ADAL" clId="{B0F2CD70-F772-4ABC-91C7-3B19E0DEB205}" dt="2023-11-12T19:38:47.362" v="1560" actId="1076"/>
          <ac:spMkLst>
            <pc:docMk/>
            <pc:sldMk cId="1783988844" sldId="256"/>
            <ac:spMk id="8" creationId="{0C831AA3-76B4-7CBA-F8C6-01FE4F300656}"/>
          </ac:spMkLst>
        </pc:spChg>
        <pc:spChg chg="add mod">
          <ac:chgData name="Papaioannou, Ioannis" userId="27d0d6e0-1133-45d1-b366-9071ba1a55b0" providerId="ADAL" clId="{B0F2CD70-F772-4ABC-91C7-3B19E0DEB205}" dt="2023-11-12T19:39:02.490" v="1565" actId="14100"/>
          <ac:spMkLst>
            <pc:docMk/>
            <pc:sldMk cId="1783988844" sldId="256"/>
            <ac:spMk id="13" creationId="{C4BA707D-8866-6383-331E-985020B01BD6}"/>
          </ac:spMkLst>
        </pc:spChg>
        <pc:spChg chg="add mod">
          <ac:chgData name="Papaioannou, Ioannis" userId="27d0d6e0-1133-45d1-b366-9071ba1a55b0" providerId="ADAL" clId="{B0F2CD70-F772-4ABC-91C7-3B19E0DEB205}" dt="2023-11-12T19:39:18.862" v="1583" actId="20577"/>
          <ac:spMkLst>
            <pc:docMk/>
            <pc:sldMk cId="1783988844" sldId="256"/>
            <ac:spMk id="14" creationId="{E050A7A1-B518-9476-DC1E-391BCEDC9163}"/>
          </ac:spMkLst>
        </pc:spChg>
        <pc:spChg chg="mod">
          <ac:chgData name="Papaioannou, Ioannis" userId="27d0d6e0-1133-45d1-b366-9071ba1a55b0" providerId="ADAL" clId="{B0F2CD70-F772-4ABC-91C7-3B19E0DEB205}" dt="2023-11-05T15:31:31.249" v="280" actId="164"/>
          <ac:spMkLst>
            <pc:docMk/>
            <pc:sldMk cId="1783988844" sldId="256"/>
            <ac:spMk id="20" creationId="{B0EAA019-14C7-0F2C-E08F-973938194268}"/>
          </ac:spMkLst>
        </pc:spChg>
        <pc:spChg chg="mod">
          <ac:chgData name="Papaioannou, Ioannis" userId="27d0d6e0-1133-45d1-b366-9071ba1a55b0" providerId="ADAL" clId="{B0F2CD70-F772-4ABC-91C7-3B19E0DEB205}" dt="2023-11-05T15:31:31.249" v="280" actId="164"/>
          <ac:spMkLst>
            <pc:docMk/>
            <pc:sldMk cId="1783988844" sldId="256"/>
            <ac:spMk id="21" creationId="{A4196A9E-DBEE-CF70-F857-56E26493FEA9}"/>
          </ac:spMkLst>
        </pc:spChg>
        <pc:spChg chg="mod topLvl">
          <ac:chgData name="Papaioannou, Ioannis" userId="27d0d6e0-1133-45d1-b366-9071ba1a55b0" providerId="ADAL" clId="{B0F2CD70-F772-4ABC-91C7-3B19E0DEB205}" dt="2023-11-05T15:31:50.726" v="311" actId="164"/>
          <ac:spMkLst>
            <pc:docMk/>
            <pc:sldMk cId="1783988844" sldId="256"/>
            <ac:spMk id="24" creationId="{F863FC06-8519-5F15-A418-0A68892E4F59}"/>
          </ac:spMkLst>
        </pc:spChg>
        <pc:spChg chg="mod">
          <ac:chgData name="Papaioannou, Ioannis" userId="27d0d6e0-1133-45d1-b366-9071ba1a55b0" providerId="ADAL" clId="{B0F2CD70-F772-4ABC-91C7-3B19E0DEB205}" dt="2023-11-12T19:38:47.362" v="1560" actId="1076"/>
          <ac:spMkLst>
            <pc:docMk/>
            <pc:sldMk cId="1783988844" sldId="256"/>
            <ac:spMk id="52" creationId="{B8B10DE2-B391-73D4-52B1-ACFA9832A867}"/>
          </ac:spMkLst>
        </pc:spChg>
        <pc:spChg chg="mod">
          <ac:chgData name="Papaioannou, Ioannis" userId="27d0d6e0-1133-45d1-b366-9071ba1a55b0" providerId="ADAL" clId="{B0F2CD70-F772-4ABC-91C7-3B19E0DEB205}" dt="2023-11-05T15:31:30.081" v="278" actId="1076"/>
          <ac:spMkLst>
            <pc:docMk/>
            <pc:sldMk cId="1783988844" sldId="256"/>
            <ac:spMk id="53" creationId="{9499A77C-133B-137E-36E8-DF4383C196E0}"/>
          </ac:spMkLst>
        </pc:spChg>
        <pc:spChg chg="mod">
          <ac:chgData name="Papaioannou, Ioannis" userId="27d0d6e0-1133-45d1-b366-9071ba1a55b0" providerId="ADAL" clId="{B0F2CD70-F772-4ABC-91C7-3B19E0DEB205}" dt="2023-11-12T19:38:47.362" v="1560" actId="1076"/>
          <ac:spMkLst>
            <pc:docMk/>
            <pc:sldMk cId="1783988844" sldId="256"/>
            <ac:spMk id="59" creationId="{F57E4BA0-240F-CF88-CA79-62BEA686ECCA}"/>
          </ac:spMkLst>
        </pc:spChg>
        <pc:grpChg chg="add del mod">
          <ac:chgData name="Papaioannou, Ioannis" userId="27d0d6e0-1133-45d1-b366-9071ba1a55b0" providerId="ADAL" clId="{B0F2CD70-F772-4ABC-91C7-3B19E0DEB205}" dt="2023-11-05T15:31:50.726" v="311" actId="164"/>
          <ac:grpSpMkLst>
            <pc:docMk/>
            <pc:sldMk cId="1783988844" sldId="256"/>
            <ac:grpSpMk id="17" creationId="{1F40F15D-3369-4F67-355E-A4B8C7BE6D2D}"/>
          </ac:grpSpMkLst>
        </pc:grpChg>
        <pc:grpChg chg="add mod">
          <ac:chgData name="Papaioannou, Ioannis" userId="27d0d6e0-1133-45d1-b366-9071ba1a55b0" providerId="ADAL" clId="{B0F2CD70-F772-4ABC-91C7-3B19E0DEB205}" dt="2023-11-05T15:31:31.249" v="280" actId="164"/>
          <ac:grpSpMkLst>
            <pc:docMk/>
            <pc:sldMk cId="1783988844" sldId="256"/>
            <ac:grpSpMk id="27" creationId="{78D6128C-F8DB-1573-468E-1AD37B64DBB9}"/>
          </ac:grpSpMkLst>
        </pc:grpChg>
        <pc:picChg chg="del">
          <ac:chgData name="Papaioannou, Ioannis" userId="27d0d6e0-1133-45d1-b366-9071ba1a55b0" providerId="ADAL" clId="{B0F2CD70-F772-4ABC-91C7-3B19E0DEB205}" dt="2023-11-05T15:40:40.817" v="368" actId="478"/>
          <ac:picMkLst>
            <pc:docMk/>
            <pc:sldMk cId="1783988844" sldId="256"/>
            <ac:picMk id="2" creationId="{77121E52-3070-6894-1F08-370B3A2D6958}"/>
          </ac:picMkLst>
        </pc:picChg>
        <pc:picChg chg="add mod modCrop">
          <ac:chgData name="Papaioannou, Ioannis" userId="27d0d6e0-1133-45d1-b366-9071ba1a55b0" providerId="ADAL" clId="{B0F2CD70-F772-4ABC-91C7-3B19E0DEB205}" dt="2023-11-12T19:39:09.077" v="1566" actId="732"/>
          <ac:picMkLst>
            <pc:docMk/>
            <pc:sldMk cId="1783988844" sldId="256"/>
            <ac:picMk id="4" creationId="{B9A67C9D-082D-0D33-7851-C2053DA614F3}"/>
          </ac:picMkLst>
        </pc:picChg>
        <pc:picChg chg="add del mod modCrop">
          <ac:chgData name="Papaioannou, Ioannis" userId="27d0d6e0-1133-45d1-b366-9071ba1a55b0" providerId="ADAL" clId="{B0F2CD70-F772-4ABC-91C7-3B19E0DEB205}" dt="2023-11-12T19:38:21.096" v="1553" actId="21"/>
          <ac:picMkLst>
            <pc:docMk/>
            <pc:sldMk cId="1783988844" sldId="256"/>
            <ac:picMk id="9" creationId="{5143D854-F1A2-3B05-0380-4DEE7C57B096}"/>
          </ac:picMkLst>
        </pc:picChg>
        <pc:picChg chg="add del mod">
          <ac:chgData name="Papaioannou, Ioannis" userId="27d0d6e0-1133-45d1-b366-9071ba1a55b0" providerId="ADAL" clId="{B0F2CD70-F772-4ABC-91C7-3B19E0DEB205}" dt="2023-11-05T15:31:54.420" v="315" actId="478"/>
          <ac:picMkLst>
            <pc:docMk/>
            <pc:sldMk cId="1783988844" sldId="256"/>
            <ac:picMk id="9" creationId="{5B1469FF-E167-ECD9-9229-1F755C196A7C}"/>
          </ac:picMkLst>
        </pc:picChg>
        <pc:picChg chg="mod">
          <ac:chgData name="Papaioannou, Ioannis" userId="27d0d6e0-1133-45d1-b366-9071ba1a55b0" providerId="ADAL" clId="{B0F2CD70-F772-4ABC-91C7-3B19E0DEB205}" dt="2023-11-05T15:10:59.818" v="253" actId="1366"/>
          <ac:picMkLst>
            <pc:docMk/>
            <pc:sldMk cId="1783988844" sldId="256"/>
            <ac:picMk id="11" creationId="{63A0BF3A-AF5F-5870-F66F-2BE69BC3DEF8}"/>
          </ac:picMkLst>
        </pc:picChg>
        <pc:picChg chg="add del mod">
          <ac:chgData name="Papaioannou, Ioannis" userId="27d0d6e0-1133-45d1-b366-9071ba1a55b0" providerId="ADAL" clId="{B0F2CD70-F772-4ABC-91C7-3B19E0DEB205}" dt="2023-11-05T15:31:54.420" v="315" actId="478"/>
          <ac:picMkLst>
            <pc:docMk/>
            <pc:sldMk cId="1783988844" sldId="256"/>
            <ac:picMk id="14" creationId="{232D9913-6C31-A7BA-B816-8FE83AF943DB}"/>
          </ac:picMkLst>
        </pc:picChg>
        <pc:picChg chg="add del mod">
          <ac:chgData name="Papaioannou, Ioannis" userId="27d0d6e0-1133-45d1-b366-9071ba1a55b0" providerId="ADAL" clId="{B0F2CD70-F772-4ABC-91C7-3B19E0DEB205}" dt="2023-11-12T19:40:30.244" v="1585" actId="21"/>
          <ac:picMkLst>
            <pc:docMk/>
            <pc:sldMk cId="1783988844" sldId="256"/>
            <ac:picMk id="15" creationId="{949D7F12-7A26-1E4B-D2DE-D08214C091E9}"/>
          </ac:picMkLst>
        </pc:picChg>
        <pc:picChg chg="add del mod">
          <ac:chgData name="Papaioannou, Ioannis" userId="27d0d6e0-1133-45d1-b366-9071ba1a55b0" providerId="ADAL" clId="{B0F2CD70-F772-4ABC-91C7-3B19E0DEB205}" dt="2023-11-05T15:31:51.324" v="313" actId="22"/>
          <ac:picMkLst>
            <pc:docMk/>
            <pc:sldMk cId="1783988844" sldId="256"/>
            <ac:picMk id="16" creationId="{95DF8C53-78C7-B0BC-5383-944C844030B0}"/>
          </ac:picMkLst>
        </pc:picChg>
        <pc:picChg chg="add mod modCrop">
          <ac:chgData name="Papaioannou, Ioannis" userId="27d0d6e0-1133-45d1-b366-9071ba1a55b0" providerId="ADAL" clId="{B0F2CD70-F772-4ABC-91C7-3B19E0DEB205}" dt="2023-11-12T19:50:10.809" v="1591" actId="14100"/>
          <ac:picMkLst>
            <pc:docMk/>
            <pc:sldMk cId="1783988844" sldId="256"/>
            <ac:picMk id="17" creationId="{6C32DC27-B56E-5065-1794-E24266D7A9CE}"/>
          </ac:picMkLst>
        </pc:picChg>
        <pc:picChg chg="mod">
          <ac:chgData name="Papaioannou, Ioannis" userId="27d0d6e0-1133-45d1-b366-9071ba1a55b0" providerId="ADAL" clId="{B0F2CD70-F772-4ABC-91C7-3B19E0DEB205}" dt="2023-11-05T15:31:31.249" v="280" actId="164"/>
          <ac:picMkLst>
            <pc:docMk/>
            <pc:sldMk cId="1783988844" sldId="256"/>
            <ac:picMk id="19" creationId="{BC7D0C30-9751-A5A0-8F65-295055330FF7}"/>
          </ac:picMkLst>
        </pc:picChg>
        <pc:picChg chg="add del mod">
          <ac:chgData name="Papaioannou, Ioannis" userId="27d0d6e0-1133-45d1-b366-9071ba1a55b0" providerId="ADAL" clId="{B0F2CD70-F772-4ABC-91C7-3B19E0DEB205}" dt="2023-11-05T15:31:50.041" v="307" actId="22"/>
          <ac:picMkLst>
            <pc:docMk/>
            <pc:sldMk cId="1783988844" sldId="256"/>
            <ac:picMk id="22" creationId="{E0345BF9-544C-1770-C81F-E4C22F2F6A79}"/>
          </ac:picMkLst>
        </pc:picChg>
        <pc:picChg chg="mod topLvl">
          <ac:chgData name="Papaioannou, Ioannis" userId="27d0d6e0-1133-45d1-b366-9071ba1a55b0" providerId="ADAL" clId="{B0F2CD70-F772-4ABC-91C7-3B19E0DEB205}" dt="2023-11-05T15:31:50.726" v="311" actId="164"/>
          <ac:picMkLst>
            <pc:docMk/>
            <pc:sldMk cId="1783988844" sldId="256"/>
            <ac:picMk id="23" creationId="{2BC06D45-542B-2253-6C24-06633B7B0B9D}"/>
          </ac:picMkLst>
        </pc:picChg>
        <pc:picChg chg="mod">
          <ac:chgData name="Papaioannou, Ioannis" userId="27d0d6e0-1133-45d1-b366-9071ba1a55b0" providerId="ADAL" clId="{B0F2CD70-F772-4ABC-91C7-3B19E0DEB205}" dt="2023-11-05T15:10:59.818" v="253" actId="1366"/>
          <ac:picMkLst>
            <pc:docMk/>
            <pc:sldMk cId="1783988844" sldId="256"/>
            <ac:picMk id="25" creationId="{F2F2D079-D5C2-B4B0-73B0-BF6670D90E42}"/>
          </ac:picMkLst>
        </pc:picChg>
        <pc:picChg chg="add del mod">
          <ac:chgData name="Papaioannou, Ioannis" userId="27d0d6e0-1133-45d1-b366-9071ba1a55b0" providerId="ADAL" clId="{B0F2CD70-F772-4ABC-91C7-3B19E0DEB205}" dt="2023-11-05T15:40:49.870" v="371" actId="21"/>
          <ac:picMkLst>
            <pc:docMk/>
            <pc:sldMk cId="1783988844" sldId="256"/>
            <ac:picMk id="28" creationId="{EB8AFF3E-2738-24D7-C172-32B61F0CCD39}"/>
          </ac:picMkLst>
        </pc:picChg>
        <pc:picChg chg="add del mod modCrop">
          <ac:chgData name="Papaioannou, Ioannis" userId="27d0d6e0-1133-45d1-b366-9071ba1a55b0" providerId="ADAL" clId="{B0F2CD70-F772-4ABC-91C7-3B19E0DEB205}" dt="2023-11-05T15:40:49.870" v="371" actId="21"/>
          <ac:picMkLst>
            <pc:docMk/>
            <pc:sldMk cId="1783988844" sldId="256"/>
            <ac:picMk id="29" creationId="{6949DFF3-174F-EBD7-9A78-A2D4FF21414E}"/>
          </ac:picMkLst>
        </pc:picChg>
        <pc:picChg chg="add del mod modCrop">
          <ac:chgData name="Papaioannou, Ioannis" userId="27d0d6e0-1133-45d1-b366-9071ba1a55b0" providerId="ADAL" clId="{B0F2CD70-F772-4ABC-91C7-3B19E0DEB205}" dt="2023-11-05T15:40:49.870" v="371" actId="21"/>
          <ac:picMkLst>
            <pc:docMk/>
            <pc:sldMk cId="1783988844" sldId="256"/>
            <ac:picMk id="30" creationId="{904CB178-5CEC-DFDE-72FC-38BED98079FE}"/>
          </ac:picMkLst>
        </pc:picChg>
        <pc:picChg chg="add del mod modCrop">
          <ac:chgData name="Papaioannou, Ioannis" userId="27d0d6e0-1133-45d1-b366-9071ba1a55b0" providerId="ADAL" clId="{B0F2CD70-F772-4ABC-91C7-3B19E0DEB205}" dt="2023-11-05T15:40:49.870" v="371" actId="21"/>
          <ac:picMkLst>
            <pc:docMk/>
            <pc:sldMk cId="1783988844" sldId="256"/>
            <ac:picMk id="31" creationId="{A1C00103-B965-9DDD-B915-E81F096B8E8D}"/>
          </ac:picMkLst>
        </pc:picChg>
        <pc:picChg chg="add del mod modCrop">
          <ac:chgData name="Papaioannou, Ioannis" userId="27d0d6e0-1133-45d1-b366-9071ba1a55b0" providerId="ADAL" clId="{B0F2CD70-F772-4ABC-91C7-3B19E0DEB205}" dt="2023-11-05T15:40:49.870" v="371" actId="21"/>
          <ac:picMkLst>
            <pc:docMk/>
            <pc:sldMk cId="1783988844" sldId="256"/>
            <ac:picMk id="33" creationId="{495437BE-27C1-D54B-8086-A0B5A898D49B}"/>
          </ac:picMkLst>
        </pc:picChg>
        <pc:picChg chg="add del mod">
          <ac:chgData name="Papaioannou, Ioannis" userId="27d0d6e0-1133-45d1-b366-9071ba1a55b0" providerId="ADAL" clId="{B0F2CD70-F772-4ABC-91C7-3B19E0DEB205}" dt="2023-11-05T15:40:49.870" v="371" actId="21"/>
          <ac:picMkLst>
            <pc:docMk/>
            <pc:sldMk cId="1783988844" sldId="256"/>
            <ac:picMk id="35" creationId="{4DCDBAD9-3BD4-8228-FD17-32F4F5543535}"/>
          </ac:picMkLst>
        </pc:picChg>
        <pc:picChg chg="add del mod">
          <ac:chgData name="Papaioannou, Ioannis" userId="27d0d6e0-1133-45d1-b366-9071ba1a55b0" providerId="ADAL" clId="{B0F2CD70-F772-4ABC-91C7-3B19E0DEB205}" dt="2023-11-05T15:39:24.113" v="367" actId="478"/>
          <ac:picMkLst>
            <pc:docMk/>
            <pc:sldMk cId="1783988844" sldId="256"/>
            <ac:picMk id="37" creationId="{9941AAD1-D80E-E9D5-1A8D-CF62CEA068DC}"/>
          </ac:picMkLst>
        </pc:picChg>
        <pc:picChg chg="add del mod">
          <ac:chgData name="Papaioannou, Ioannis" userId="27d0d6e0-1133-45d1-b366-9071ba1a55b0" providerId="ADAL" clId="{B0F2CD70-F772-4ABC-91C7-3B19E0DEB205}" dt="2023-11-12T19:49:55.465" v="1586" actId="478"/>
          <ac:picMkLst>
            <pc:docMk/>
            <pc:sldMk cId="1783988844" sldId="256"/>
            <ac:picMk id="39" creationId="{80435909-0B2D-896D-4689-61713E704EE9}"/>
          </ac:picMkLst>
        </pc:picChg>
        <pc:picChg chg="mod">
          <ac:chgData name="Papaioannou, Ioannis" userId="27d0d6e0-1133-45d1-b366-9071ba1a55b0" providerId="ADAL" clId="{B0F2CD70-F772-4ABC-91C7-3B19E0DEB205}" dt="2023-11-12T19:38:47.362" v="1560" actId="1076"/>
          <ac:picMkLst>
            <pc:docMk/>
            <pc:sldMk cId="1783988844" sldId="256"/>
            <ac:picMk id="47" creationId="{0AA1B274-6237-EF6E-8A44-41F8152C56AC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Papaioannou, Ioannis" userId="27d0d6e0-1133-45d1-b366-9071ba1a55b0" providerId="ADAL" clId="{B0F2CD70-F772-4ABC-91C7-3B19E0DEB205}" dt="2023-11-12T19:26:27.145" v="1539"/>
              <pc2:cmMkLst xmlns:pc2="http://schemas.microsoft.com/office/powerpoint/2019/9/main/command">
                <pc:docMk/>
                <pc:sldMk cId="1783988844" sldId="256"/>
                <pc2:cmMk id="{23DDDB77-FBD8-40B9-B47B-AC649DB25F08}"/>
              </pc2:cmMkLst>
            </pc226:cmChg>
          </p:ext>
        </pc:extLst>
      </pc:sldChg>
      <pc:sldChg chg="addSp delSp modSp mod">
        <pc:chgData name="Papaioannou, Ioannis" userId="27d0d6e0-1133-45d1-b366-9071ba1a55b0" providerId="ADAL" clId="{B0F2CD70-F772-4ABC-91C7-3B19E0DEB205}" dt="2023-11-05T15:41:23.665" v="373" actId="1076"/>
        <pc:sldMkLst>
          <pc:docMk/>
          <pc:sldMk cId="1419449853" sldId="257"/>
        </pc:sldMkLst>
        <pc:picChg chg="del">
          <ac:chgData name="Papaioannou, Ioannis" userId="27d0d6e0-1133-45d1-b366-9071ba1a55b0" providerId="ADAL" clId="{B0F2CD70-F772-4ABC-91C7-3B19E0DEB205}" dt="2023-11-05T11:02:06.502" v="34" actId="478"/>
          <ac:picMkLst>
            <pc:docMk/>
            <pc:sldMk cId="1419449853" sldId="257"/>
            <ac:picMk id="16" creationId="{76736938-7694-00B1-8E26-324A6C813F60}"/>
          </ac:picMkLst>
        </pc:picChg>
        <pc:picChg chg="add del mod">
          <ac:chgData name="Papaioannou, Ioannis" userId="27d0d6e0-1133-45d1-b366-9071ba1a55b0" providerId="ADAL" clId="{B0F2CD70-F772-4ABC-91C7-3B19E0DEB205}" dt="2023-11-05T10:59:40.206" v="10" actId="478"/>
          <ac:picMkLst>
            <pc:docMk/>
            <pc:sldMk cId="1419449853" sldId="257"/>
            <ac:picMk id="19" creationId="{B11AFCED-248B-5B1B-16AC-F0B7E30E13A8}"/>
          </ac:picMkLst>
        </pc:picChg>
        <pc:picChg chg="add del mod">
          <ac:chgData name="Papaioannou, Ioannis" userId="27d0d6e0-1133-45d1-b366-9071ba1a55b0" providerId="ADAL" clId="{B0F2CD70-F772-4ABC-91C7-3B19E0DEB205}" dt="2023-11-05T11:00:40.920" v="24" actId="22"/>
          <ac:picMkLst>
            <pc:docMk/>
            <pc:sldMk cId="1419449853" sldId="257"/>
            <ac:picMk id="21" creationId="{04EE333E-1F49-3071-B897-C62AA0B1E5A3}"/>
          </ac:picMkLst>
        </pc:picChg>
        <pc:picChg chg="add del mod">
          <ac:chgData name="Papaioannou, Ioannis" userId="27d0d6e0-1133-45d1-b366-9071ba1a55b0" providerId="ADAL" clId="{B0F2CD70-F772-4ABC-91C7-3B19E0DEB205}" dt="2023-11-05T12:41:01.343" v="50" actId="478"/>
          <ac:picMkLst>
            <pc:docMk/>
            <pc:sldMk cId="1419449853" sldId="257"/>
            <ac:picMk id="23" creationId="{542AC602-B234-CF43-85D0-605F8AD4D99E}"/>
          </ac:picMkLst>
        </pc:picChg>
        <pc:picChg chg="add mod modCrop">
          <ac:chgData name="Papaioannou, Ioannis" userId="27d0d6e0-1133-45d1-b366-9071ba1a55b0" providerId="ADAL" clId="{B0F2CD70-F772-4ABC-91C7-3B19E0DEB205}" dt="2023-11-05T15:41:23.665" v="373" actId="1076"/>
          <ac:picMkLst>
            <pc:docMk/>
            <pc:sldMk cId="1419449853" sldId="257"/>
            <ac:picMk id="25" creationId="{C3DF3EC0-39B2-9B34-B4C4-3662A83627E7}"/>
          </ac:picMkLst>
        </pc:picChg>
      </pc:sldChg>
      <pc:sldChg chg="addSp delSp modSp mod">
        <pc:chgData name="Papaioannou, Ioannis" userId="27d0d6e0-1133-45d1-b366-9071ba1a55b0" providerId="ADAL" clId="{B0F2CD70-F772-4ABC-91C7-3B19E0DEB205}" dt="2023-11-05T16:31:07.507" v="526" actId="1076"/>
        <pc:sldMkLst>
          <pc:docMk/>
          <pc:sldMk cId="2731541974" sldId="258"/>
        </pc:sldMkLst>
        <pc:picChg chg="add del mod">
          <ac:chgData name="Papaioannou, Ioannis" userId="27d0d6e0-1133-45d1-b366-9071ba1a55b0" providerId="ADAL" clId="{B0F2CD70-F772-4ABC-91C7-3B19E0DEB205}" dt="2023-11-05T16:31:07.507" v="526" actId="1076"/>
          <ac:picMkLst>
            <pc:docMk/>
            <pc:sldMk cId="2731541974" sldId="258"/>
            <ac:picMk id="30" creationId="{C0041292-F2C6-A72D-1555-41EB75D1CD8C}"/>
          </ac:picMkLst>
        </pc:picChg>
      </pc:sldChg>
      <pc:sldChg chg="addSp modSp mod">
        <pc:chgData name="Papaioannou, Ioannis" userId="27d0d6e0-1133-45d1-b366-9071ba1a55b0" providerId="ADAL" clId="{B0F2CD70-F772-4ABC-91C7-3B19E0DEB205}" dt="2023-11-05T16:06:37.953" v="493" actId="692"/>
        <pc:sldMkLst>
          <pc:docMk/>
          <pc:sldMk cId="905110383" sldId="259"/>
        </pc:sldMkLst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19" creationId="{65E134F0-551E-AEE1-C65F-8368D6F92609}"/>
          </ac:picMkLst>
        </pc:picChg>
        <pc:picChg chg="mod">
          <ac:chgData name="Papaioannou, Ioannis" userId="27d0d6e0-1133-45d1-b366-9071ba1a55b0" providerId="ADAL" clId="{B0F2CD70-F772-4ABC-91C7-3B19E0DEB205}" dt="2023-11-05T14:44:43.849" v="246" actId="14100"/>
          <ac:picMkLst>
            <pc:docMk/>
            <pc:sldMk cId="905110383" sldId="259"/>
            <ac:picMk id="21" creationId="{3F32434A-9F5F-FA7F-F912-51CC503D81CA}"/>
          </ac:picMkLst>
        </pc:picChg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32" creationId="{349710CD-D759-902A-4E9A-4179AFC8FAB4}"/>
          </ac:picMkLst>
        </pc:picChg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34" creationId="{782E503A-BD32-11C4-AAB6-6462DB497AC6}"/>
          </ac:picMkLst>
        </pc:picChg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35" creationId="{344395E0-236A-6828-6FCE-53BABE178775}"/>
          </ac:picMkLst>
        </pc:picChg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37" creationId="{D9A0E98F-CE5E-4A2E-D8AF-D377C169B938}"/>
          </ac:picMkLst>
        </pc:picChg>
        <pc:picChg chg="add mod">
          <ac:chgData name="Papaioannou, Ioannis" userId="27d0d6e0-1133-45d1-b366-9071ba1a55b0" providerId="ADAL" clId="{B0F2CD70-F772-4ABC-91C7-3B19E0DEB205}" dt="2023-11-05T15:50:23.133" v="422" actId="571"/>
          <ac:picMkLst>
            <pc:docMk/>
            <pc:sldMk cId="905110383" sldId="259"/>
            <ac:picMk id="38" creationId="{CC8556F4-40AB-FEEE-3F99-238B41B30297}"/>
          </ac:picMkLst>
        </pc:picChg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39" creationId="{2664B09F-2C6A-3CFE-AEDD-A0A37E5028A6}"/>
          </ac:picMkLst>
        </pc:picChg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41" creationId="{B52D12E1-2062-B859-2480-4E13A9539470}"/>
          </ac:picMkLst>
        </pc:picChg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42" creationId="{F2C74E8A-AC59-78B6-65E5-CFA3CB087BC3}"/>
          </ac:picMkLst>
        </pc:picChg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44" creationId="{6ADD6146-20A1-8ACD-761B-9ACB4D05CD13}"/>
          </ac:picMkLst>
        </pc:picChg>
        <pc:picChg chg="add mod modCrop">
          <ac:chgData name="Papaioannou, Ioannis" userId="27d0d6e0-1133-45d1-b366-9071ba1a55b0" providerId="ADAL" clId="{B0F2CD70-F772-4ABC-91C7-3B19E0DEB205}" dt="2023-11-05T16:06:37.953" v="493" actId="692"/>
          <ac:picMkLst>
            <pc:docMk/>
            <pc:sldMk cId="905110383" sldId="259"/>
            <ac:picMk id="45" creationId="{BE65B48E-6C11-01FF-D2B7-FD392CDC342A}"/>
          </ac:picMkLst>
        </pc:picChg>
      </pc:sldChg>
      <pc:sldChg chg="addSp delSp modSp mod">
        <pc:chgData name="Papaioannou, Ioannis" userId="27d0d6e0-1133-45d1-b366-9071ba1a55b0" providerId="ADAL" clId="{B0F2CD70-F772-4ABC-91C7-3B19E0DEB205}" dt="2023-11-05T20:14:40.038" v="1017" actId="14100"/>
        <pc:sldMkLst>
          <pc:docMk/>
          <pc:sldMk cId="1022482673" sldId="261"/>
        </pc:sldMkLst>
        <pc:spChg chg="mod">
          <ac:chgData name="Papaioannou, Ioannis" userId="27d0d6e0-1133-45d1-b366-9071ba1a55b0" providerId="ADAL" clId="{B0F2CD70-F772-4ABC-91C7-3B19E0DEB205}" dt="2023-11-05T17:42:12.260" v="741" actId="1035"/>
          <ac:spMkLst>
            <pc:docMk/>
            <pc:sldMk cId="1022482673" sldId="261"/>
            <ac:spMk id="2" creationId="{542C09B3-CEEE-27AC-EE4E-A362202369B9}"/>
          </ac:spMkLst>
        </pc:spChg>
        <pc:spChg chg="mod">
          <ac:chgData name="Papaioannou, Ioannis" userId="27d0d6e0-1133-45d1-b366-9071ba1a55b0" providerId="ADAL" clId="{B0F2CD70-F772-4ABC-91C7-3B19E0DEB205}" dt="2023-11-05T17:42:12.260" v="741" actId="1035"/>
          <ac:spMkLst>
            <pc:docMk/>
            <pc:sldMk cId="1022482673" sldId="261"/>
            <ac:spMk id="4" creationId="{4C8B551D-045E-BF60-1C3E-2DD9C6263823}"/>
          </ac:spMkLst>
        </pc:spChg>
        <pc:spChg chg="mod">
          <ac:chgData name="Papaioannou, Ioannis" userId="27d0d6e0-1133-45d1-b366-9071ba1a55b0" providerId="ADAL" clId="{B0F2CD70-F772-4ABC-91C7-3B19E0DEB205}" dt="2023-11-05T17:42:12.260" v="741" actId="1035"/>
          <ac:spMkLst>
            <pc:docMk/>
            <pc:sldMk cId="1022482673" sldId="261"/>
            <ac:spMk id="5" creationId="{81E519C6-1A0D-A13D-3759-E5E690024443}"/>
          </ac:spMkLst>
        </pc:spChg>
        <pc:spChg chg="mod">
          <ac:chgData name="Papaioannou, Ioannis" userId="27d0d6e0-1133-45d1-b366-9071ba1a55b0" providerId="ADAL" clId="{B0F2CD70-F772-4ABC-91C7-3B19E0DEB205}" dt="2023-11-05T17:42:23.560" v="748" actId="1035"/>
          <ac:spMkLst>
            <pc:docMk/>
            <pc:sldMk cId="1022482673" sldId="261"/>
            <ac:spMk id="9" creationId="{4FC5FEA3-70A5-8611-B8AE-F575B44765E3}"/>
          </ac:spMkLst>
        </pc:spChg>
        <pc:spChg chg="mod">
          <ac:chgData name="Papaioannou, Ioannis" userId="27d0d6e0-1133-45d1-b366-9071ba1a55b0" providerId="ADAL" clId="{B0F2CD70-F772-4ABC-91C7-3B19E0DEB205}" dt="2023-11-05T18:44:21.648" v="943" actId="1076"/>
          <ac:spMkLst>
            <pc:docMk/>
            <pc:sldMk cId="1022482673" sldId="261"/>
            <ac:spMk id="10" creationId="{3C16DB6D-2F93-6176-465F-9A95D192B8D8}"/>
          </ac:spMkLst>
        </pc:spChg>
        <pc:spChg chg="mod">
          <ac:chgData name="Papaioannou, Ioannis" userId="27d0d6e0-1133-45d1-b366-9071ba1a55b0" providerId="ADAL" clId="{B0F2CD70-F772-4ABC-91C7-3B19E0DEB205}" dt="2023-11-05T17:42:23.560" v="748" actId="1035"/>
          <ac:spMkLst>
            <pc:docMk/>
            <pc:sldMk cId="1022482673" sldId="261"/>
            <ac:spMk id="11" creationId="{AEBEB3FD-DA1C-33FA-DEAC-1D3F8A03EB7D}"/>
          </ac:spMkLst>
        </pc:spChg>
        <pc:spChg chg="mod">
          <ac:chgData name="Papaioannou, Ioannis" userId="27d0d6e0-1133-45d1-b366-9071ba1a55b0" providerId="ADAL" clId="{B0F2CD70-F772-4ABC-91C7-3B19E0DEB205}" dt="2023-11-05T17:42:12.260" v="741" actId="1035"/>
          <ac:spMkLst>
            <pc:docMk/>
            <pc:sldMk cId="1022482673" sldId="261"/>
            <ac:spMk id="12" creationId="{8AAE4A41-7235-59AA-E902-49C3C731FD97}"/>
          </ac:spMkLst>
        </pc:spChg>
        <pc:spChg chg="mod">
          <ac:chgData name="Papaioannou, Ioannis" userId="27d0d6e0-1133-45d1-b366-9071ba1a55b0" providerId="ADAL" clId="{B0F2CD70-F772-4ABC-91C7-3B19E0DEB205}" dt="2023-11-05T17:42:03.705" v="730" actId="1076"/>
          <ac:spMkLst>
            <pc:docMk/>
            <pc:sldMk cId="1022482673" sldId="261"/>
            <ac:spMk id="15" creationId="{3E88507C-4281-EEDE-494E-80DC17D18A47}"/>
          </ac:spMkLst>
        </pc:spChg>
        <pc:spChg chg="mod">
          <ac:chgData name="Papaioannou, Ioannis" userId="27d0d6e0-1133-45d1-b366-9071ba1a55b0" providerId="ADAL" clId="{B0F2CD70-F772-4ABC-91C7-3B19E0DEB205}" dt="2023-11-05T17:42:23.560" v="748" actId="1035"/>
          <ac:spMkLst>
            <pc:docMk/>
            <pc:sldMk cId="1022482673" sldId="261"/>
            <ac:spMk id="16" creationId="{438F2016-A450-60DC-6554-C60B924EC593}"/>
          </ac:spMkLst>
        </pc:spChg>
        <pc:spChg chg="mod">
          <ac:chgData name="Papaioannou, Ioannis" userId="27d0d6e0-1133-45d1-b366-9071ba1a55b0" providerId="ADAL" clId="{B0F2CD70-F772-4ABC-91C7-3B19E0DEB205}" dt="2023-11-05T17:42:23.560" v="748" actId="1035"/>
          <ac:spMkLst>
            <pc:docMk/>
            <pc:sldMk cId="1022482673" sldId="261"/>
            <ac:spMk id="17" creationId="{FACEF8B2-68B2-CC5E-1076-5F8565DC8BD5}"/>
          </ac:spMkLst>
        </pc:spChg>
        <pc:spChg chg="mod">
          <ac:chgData name="Papaioannou, Ioannis" userId="27d0d6e0-1133-45d1-b366-9071ba1a55b0" providerId="ADAL" clId="{B0F2CD70-F772-4ABC-91C7-3B19E0DEB205}" dt="2023-11-05T18:07:24.527" v="774" actId="1076"/>
          <ac:spMkLst>
            <pc:docMk/>
            <pc:sldMk cId="1022482673" sldId="261"/>
            <ac:spMk id="18" creationId="{6788266F-7076-5A71-392C-8ED545B807BA}"/>
          </ac:spMkLst>
        </pc:spChg>
        <pc:spChg chg="del mod topLvl">
          <ac:chgData name="Papaioannou, Ioannis" userId="27d0d6e0-1133-45d1-b366-9071ba1a55b0" providerId="ADAL" clId="{B0F2CD70-F772-4ABC-91C7-3B19E0DEB205}" dt="2023-11-05T16:38:43.748" v="535" actId="478"/>
          <ac:spMkLst>
            <pc:docMk/>
            <pc:sldMk cId="1022482673" sldId="261"/>
            <ac:spMk id="23" creationId="{99D86CD2-EFE9-EC46-15D4-8E637DE5169A}"/>
          </ac:spMkLst>
        </pc:spChg>
        <pc:spChg chg="mod">
          <ac:chgData name="Papaioannou, Ioannis" userId="27d0d6e0-1133-45d1-b366-9071ba1a55b0" providerId="ADAL" clId="{B0F2CD70-F772-4ABC-91C7-3B19E0DEB205}" dt="2023-11-05T18:12:31.614" v="842" actId="1076"/>
          <ac:spMkLst>
            <pc:docMk/>
            <pc:sldMk cId="1022482673" sldId="261"/>
            <ac:spMk id="25" creationId="{6F37BCCB-B3C4-2CED-202B-6BCCD289589A}"/>
          </ac:spMkLst>
        </pc:spChg>
        <pc:spChg chg="mod">
          <ac:chgData name="Papaioannou, Ioannis" userId="27d0d6e0-1133-45d1-b366-9071ba1a55b0" providerId="ADAL" clId="{B0F2CD70-F772-4ABC-91C7-3B19E0DEB205}" dt="2023-11-05T18:12:41.556" v="845" actId="1076"/>
          <ac:spMkLst>
            <pc:docMk/>
            <pc:sldMk cId="1022482673" sldId="261"/>
            <ac:spMk id="26" creationId="{820F78DB-6C9A-5E2F-1ABA-0A24B1D560C3}"/>
          </ac:spMkLst>
        </pc:spChg>
        <pc:spChg chg="mod">
          <ac:chgData name="Papaioannou, Ioannis" userId="27d0d6e0-1133-45d1-b366-9071ba1a55b0" providerId="ADAL" clId="{B0F2CD70-F772-4ABC-91C7-3B19E0DEB205}" dt="2023-11-05T17:42:03.705" v="730" actId="1076"/>
          <ac:spMkLst>
            <pc:docMk/>
            <pc:sldMk cId="1022482673" sldId="261"/>
            <ac:spMk id="28" creationId="{59935FA4-981C-ADDE-C0DA-7EC99B899270}"/>
          </ac:spMkLst>
        </pc:spChg>
        <pc:spChg chg="mod">
          <ac:chgData name="Papaioannou, Ioannis" userId="27d0d6e0-1133-45d1-b366-9071ba1a55b0" providerId="ADAL" clId="{B0F2CD70-F772-4ABC-91C7-3B19E0DEB205}" dt="2023-11-05T17:42:03.705" v="730" actId="1076"/>
          <ac:spMkLst>
            <pc:docMk/>
            <pc:sldMk cId="1022482673" sldId="261"/>
            <ac:spMk id="29" creationId="{CA282B91-B756-D2E1-B25C-AFA83559CCE2}"/>
          </ac:spMkLst>
        </pc:spChg>
        <pc:spChg chg="mod">
          <ac:chgData name="Papaioannou, Ioannis" userId="27d0d6e0-1133-45d1-b366-9071ba1a55b0" providerId="ADAL" clId="{B0F2CD70-F772-4ABC-91C7-3B19E0DEB205}" dt="2023-11-05T17:42:12.260" v="741" actId="1035"/>
          <ac:spMkLst>
            <pc:docMk/>
            <pc:sldMk cId="1022482673" sldId="261"/>
            <ac:spMk id="30" creationId="{3A56144D-BF54-7228-012E-1CDD54618EE7}"/>
          </ac:spMkLst>
        </pc:spChg>
        <pc:spChg chg="del mod">
          <ac:chgData name="Papaioannou, Ioannis" userId="27d0d6e0-1133-45d1-b366-9071ba1a55b0" providerId="ADAL" clId="{B0F2CD70-F772-4ABC-91C7-3B19E0DEB205}" dt="2023-11-05T16:38:28.624" v="532" actId="478"/>
          <ac:spMkLst>
            <pc:docMk/>
            <pc:sldMk cId="1022482673" sldId="261"/>
            <ac:spMk id="31" creationId="{4EEA5DA5-6874-ED55-D6B2-B8C2630F050B}"/>
          </ac:spMkLst>
        </pc:spChg>
        <pc:spChg chg="del mod">
          <ac:chgData name="Papaioannou, Ioannis" userId="27d0d6e0-1133-45d1-b366-9071ba1a55b0" providerId="ADAL" clId="{B0F2CD70-F772-4ABC-91C7-3B19E0DEB205}" dt="2023-11-05T16:39:17.449" v="538" actId="478"/>
          <ac:spMkLst>
            <pc:docMk/>
            <pc:sldMk cId="1022482673" sldId="261"/>
            <ac:spMk id="34" creationId="{6160E8D1-0DFF-1FF8-48D7-1737E91EAF86}"/>
          </ac:spMkLst>
        </pc:spChg>
        <pc:spChg chg="mod">
          <ac:chgData name="Papaioannou, Ioannis" userId="27d0d6e0-1133-45d1-b366-9071ba1a55b0" providerId="ADAL" clId="{B0F2CD70-F772-4ABC-91C7-3B19E0DEB205}" dt="2023-11-05T16:39:21.353" v="540" actId="478"/>
          <ac:spMkLst>
            <pc:docMk/>
            <pc:sldMk cId="1022482673" sldId="261"/>
            <ac:spMk id="35" creationId="{717305B1-4F73-AB66-E974-25B7D0D66B5A}"/>
          </ac:spMkLst>
        </pc:spChg>
        <pc:spChg chg="add mod">
          <ac:chgData name="Papaioannou, Ioannis" userId="27d0d6e0-1133-45d1-b366-9071ba1a55b0" providerId="ADAL" clId="{B0F2CD70-F772-4ABC-91C7-3B19E0DEB205}" dt="2023-11-05T16:40:11.800" v="555" actId="478"/>
          <ac:spMkLst>
            <pc:docMk/>
            <pc:sldMk cId="1022482673" sldId="261"/>
            <ac:spMk id="39" creationId="{6E456C5C-B36F-894E-051D-21C624A469D2}"/>
          </ac:spMkLst>
        </pc:spChg>
        <pc:spChg chg="add del mod">
          <ac:chgData name="Papaioannou, Ioannis" userId="27d0d6e0-1133-45d1-b366-9071ba1a55b0" providerId="ADAL" clId="{B0F2CD70-F772-4ABC-91C7-3B19E0DEB205}" dt="2023-11-05T16:40:20.900" v="556" actId="478"/>
          <ac:spMkLst>
            <pc:docMk/>
            <pc:sldMk cId="1022482673" sldId="261"/>
            <ac:spMk id="40" creationId="{7207E5CE-2387-EBF8-7FFD-6BC4FC23C6D5}"/>
          </ac:spMkLst>
        </pc:spChg>
        <pc:spChg chg="del mod">
          <ac:chgData name="Papaioannou, Ioannis" userId="27d0d6e0-1133-45d1-b366-9071ba1a55b0" providerId="ADAL" clId="{B0F2CD70-F772-4ABC-91C7-3B19E0DEB205}" dt="2023-11-05T16:41:02.544" v="566" actId="478"/>
          <ac:spMkLst>
            <pc:docMk/>
            <pc:sldMk cId="1022482673" sldId="261"/>
            <ac:spMk id="44" creationId="{FD6B4856-AA64-CA7F-CFD1-E8B8AB75E8E5}"/>
          </ac:spMkLst>
        </pc:spChg>
        <pc:spChg chg="del mod">
          <ac:chgData name="Papaioannou, Ioannis" userId="27d0d6e0-1133-45d1-b366-9071ba1a55b0" providerId="ADAL" clId="{B0F2CD70-F772-4ABC-91C7-3B19E0DEB205}" dt="2023-11-05T16:41:06.504" v="568" actId="478"/>
          <ac:spMkLst>
            <pc:docMk/>
            <pc:sldMk cId="1022482673" sldId="261"/>
            <ac:spMk id="45" creationId="{600F0805-806D-B643-2B96-6EE60B0FF3B7}"/>
          </ac:spMkLst>
        </pc:spChg>
        <pc:spChg chg="del mod">
          <ac:chgData name="Papaioannou, Ioannis" userId="27d0d6e0-1133-45d1-b366-9071ba1a55b0" providerId="ADAL" clId="{B0F2CD70-F772-4ABC-91C7-3B19E0DEB205}" dt="2023-11-05T16:40:28.698" v="560" actId="478"/>
          <ac:spMkLst>
            <pc:docMk/>
            <pc:sldMk cId="1022482673" sldId="261"/>
            <ac:spMk id="48" creationId="{58D971AC-6645-0424-A5F2-C702A56416EE}"/>
          </ac:spMkLst>
        </pc:spChg>
        <pc:spChg chg="add mod">
          <ac:chgData name="Papaioannou, Ioannis" userId="27d0d6e0-1133-45d1-b366-9071ba1a55b0" providerId="ADAL" clId="{B0F2CD70-F772-4ABC-91C7-3B19E0DEB205}" dt="2023-11-05T16:42:27.880" v="588" actId="21"/>
          <ac:spMkLst>
            <pc:docMk/>
            <pc:sldMk cId="1022482673" sldId="261"/>
            <ac:spMk id="53" creationId="{FE09166E-1EC7-FB40-C2F1-2E75666A77B7}"/>
          </ac:spMkLst>
        </pc:spChg>
        <pc:spChg chg="add mod">
          <ac:chgData name="Papaioannou, Ioannis" userId="27d0d6e0-1133-45d1-b366-9071ba1a55b0" providerId="ADAL" clId="{B0F2CD70-F772-4ABC-91C7-3B19E0DEB205}" dt="2023-11-05T16:42:27.880" v="588" actId="21"/>
          <ac:spMkLst>
            <pc:docMk/>
            <pc:sldMk cId="1022482673" sldId="261"/>
            <ac:spMk id="54" creationId="{CFA5920E-AFD2-01F4-B379-D889DB30AE3E}"/>
          </ac:spMkLst>
        </pc:spChg>
        <pc:spChg chg="mod">
          <ac:chgData name="Papaioannou, Ioannis" userId="27d0d6e0-1133-45d1-b366-9071ba1a55b0" providerId="ADAL" clId="{B0F2CD70-F772-4ABC-91C7-3B19E0DEB205}" dt="2023-11-05T16:41:56.202" v="580" actId="21"/>
          <ac:spMkLst>
            <pc:docMk/>
            <pc:sldMk cId="1022482673" sldId="261"/>
            <ac:spMk id="58" creationId="{217A0736-5720-67E9-4D91-2F19A2BE2659}"/>
          </ac:spMkLst>
        </pc:spChg>
        <pc:spChg chg="mod">
          <ac:chgData name="Papaioannou, Ioannis" userId="27d0d6e0-1133-45d1-b366-9071ba1a55b0" providerId="ADAL" clId="{B0F2CD70-F772-4ABC-91C7-3B19E0DEB205}" dt="2023-11-05T16:41:56.202" v="580" actId="21"/>
          <ac:spMkLst>
            <pc:docMk/>
            <pc:sldMk cId="1022482673" sldId="261"/>
            <ac:spMk id="59" creationId="{25DEF0A0-6E14-9AA9-2129-4EA366813D35}"/>
          </ac:spMkLst>
        </pc:spChg>
        <pc:spChg chg="add mod">
          <ac:chgData name="Papaioannou, Ioannis" userId="27d0d6e0-1133-45d1-b366-9071ba1a55b0" providerId="ADAL" clId="{B0F2CD70-F772-4ABC-91C7-3B19E0DEB205}" dt="2023-11-05T16:43:43.539" v="604" actId="21"/>
          <ac:spMkLst>
            <pc:docMk/>
            <pc:sldMk cId="1022482673" sldId="261"/>
            <ac:spMk id="63" creationId="{AC4266B7-5A3F-3671-62CB-3414437BD7AD}"/>
          </ac:spMkLst>
        </pc:spChg>
        <pc:spChg chg="add mod">
          <ac:chgData name="Papaioannou, Ioannis" userId="27d0d6e0-1133-45d1-b366-9071ba1a55b0" providerId="ADAL" clId="{B0F2CD70-F772-4ABC-91C7-3B19E0DEB205}" dt="2023-11-05T16:43:43.539" v="604" actId="21"/>
          <ac:spMkLst>
            <pc:docMk/>
            <pc:sldMk cId="1022482673" sldId="261"/>
            <ac:spMk id="64" creationId="{45E03B0D-7581-298C-4A95-D7BE2C775830}"/>
          </ac:spMkLst>
        </pc:spChg>
        <pc:spChg chg="mod">
          <ac:chgData name="Papaioannou, Ioannis" userId="27d0d6e0-1133-45d1-b366-9071ba1a55b0" providerId="ADAL" clId="{B0F2CD70-F772-4ABC-91C7-3B19E0DEB205}" dt="2023-11-05T16:44:38.199" v="613" actId="21"/>
          <ac:spMkLst>
            <pc:docMk/>
            <pc:sldMk cId="1022482673" sldId="261"/>
            <ac:spMk id="68" creationId="{A179388A-1227-4A0E-4541-4A87615A340C}"/>
          </ac:spMkLst>
        </pc:spChg>
        <pc:spChg chg="mod">
          <ac:chgData name="Papaioannou, Ioannis" userId="27d0d6e0-1133-45d1-b366-9071ba1a55b0" providerId="ADAL" clId="{B0F2CD70-F772-4ABC-91C7-3B19E0DEB205}" dt="2023-11-05T16:44:38.199" v="613" actId="21"/>
          <ac:spMkLst>
            <pc:docMk/>
            <pc:sldMk cId="1022482673" sldId="261"/>
            <ac:spMk id="69" creationId="{793187A8-47F0-905F-D6BF-362C10CBF63B}"/>
          </ac:spMkLst>
        </pc:spChg>
        <pc:spChg chg="add mod">
          <ac:chgData name="Papaioannou, Ioannis" userId="27d0d6e0-1133-45d1-b366-9071ba1a55b0" providerId="ADAL" clId="{B0F2CD70-F772-4ABC-91C7-3B19E0DEB205}" dt="2023-11-05T18:09:21.097" v="808" actId="1076"/>
          <ac:spMkLst>
            <pc:docMk/>
            <pc:sldMk cId="1022482673" sldId="261"/>
            <ac:spMk id="87" creationId="{AE6C6E8E-137F-13EB-8937-78DE11ED9662}"/>
          </ac:spMkLst>
        </pc:spChg>
        <pc:spChg chg="add mod">
          <ac:chgData name="Papaioannou, Ioannis" userId="27d0d6e0-1133-45d1-b366-9071ba1a55b0" providerId="ADAL" clId="{B0F2CD70-F772-4ABC-91C7-3B19E0DEB205}" dt="2023-11-05T18:09:26.435" v="809" actId="571"/>
          <ac:spMkLst>
            <pc:docMk/>
            <pc:sldMk cId="1022482673" sldId="261"/>
            <ac:spMk id="88" creationId="{0E93A32B-29F6-5A97-C851-98F4190E0D19}"/>
          </ac:spMkLst>
        </pc:spChg>
        <pc:spChg chg="add mod">
          <ac:chgData name="Papaioannou, Ioannis" userId="27d0d6e0-1133-45d1-b366-9071ba1a55b0" providerId="ADAL" clId="{B0F2CD70-F772-4ABC-91C7-3B19E0DEB205}" dt="2023-11-05T18:09:31.450" v="810" actId="571"/>
          <ac:spMkLst>
            <pc:docMk/>
            <pc:sldMk cId="1022482673" sldId="261"/>
            <ac:spMk id="89" creationId="{3C483C96-AC72-5AE7-7A4B-02C252C70A64}"/>
          </ac:spMkLst>
        </pc:spChg>
        <pc:spChg chg="add mod">
          <ac:chgData name="Papaioannou, Ioannis" userId="27d0d6e0-1133-45d1-b366-9071ba1a55b0" providerId="ADAL" clId="{B0F2CD70-F772-4ABC-91C7-3B19E0DEB205}" dt="2023-11-05T18:09:35.839" v="812" actId="571"/>
          <ac:spMkLst>
            <pc:docMk/>
            <pc:sldMk cId="1022482673" sldId="261"/>
            <ac:spMk id="91" creationId="{70E27035-ADE3-2036-0E77-01C5D5F1B7FB}"/>
          </ac:spMkLst>
        </pc:spChg>
        <pc:spChg chg="add mod">
          <ac:chgData name="Papaioannou, Ioannis" userId="27d0d6e0-1133-45d1-b366-9071ba1a55b0" providerId="ADAL" clId="{B0F2CD70-F772-4ABC-91C7-3B19E0DEB205}" dt="2023-11-05T18:09:48.626" v="814" actId="14100"/>
          <ac:spMkLst>
            <pc:docMk/>
            <pc:sldMk cId="1022482673" sldId="261"/>
            <ac:spMk id="92" creationId="{90468D96-EE9A-F7AB-E6AB-BAA8444E8A96}"/>
          </ac:spMkLst>
        </pc:spChg>
        <pc:spChg chg="add mod">
          <ac:chgData name="Papaioannou, Ioannis" userId="27d0d6e0-1133-45d1-b366-9071ba1a55b0" providerId="ADAL" clId="{B0F2CD70-F772-4ABC-91C7-3B19E0DEB205}" dt="2023-11-05T18:26:49.495" v="855" actId="21"/>
          <ac:spMkLst>
            <pc:docMk/>
            <pc:sldMk cId="1022482673" sldId="261"/>
            <ac:spMk id="97" creationId="{94E98A22-9AD8-5AF1-C1EA-15DB855EABEF}"/>
          </ac:spMkLst>
        </pc:spChg>
        <pc:spChg chg="add mod">
          <ac:chgData name="Papaioannou, Ioannis" userId="27d0d6e0-1133-45d1-b366-9071ba1a55b0" providerId="ADAL" clId="{B0F2CD70-F772-4ABC-91C7-3B19E0DEB205}" dt="2023-11-05T18:26:49.495" v="855" actId="21"/>
          <ac:spMkLst>
            <pc:docMk/>
            <pc:sldMk cId="1022482673" sldId="261"/>
            <ac:spMk id="98" creationId="{86FA9474-6C0C-DD08-7BA3-21241437D9A3}"/>
          </ac:spMkLst>
        </pc:spChg>
        <pc:spChg chg="mod">
          <ac:chgData name="Papaioannou, Ioannis" userId="27d0d6e0-1133-45d1-b366-9071ba1a55b0" providerId="ADAL" clId="{B0F2CD70-F772-4ABC-91C7-3B19E0DEB205}" dt="2023-11-05T18:28:04.180" v="867" actId="21"/>
          <ac:spMkLst>
            <pc:docMk/>
            <pc:sldMk cId="1022482673" sldId="261"/>
            <ac:spMk id="102" creationId="{AE5CB4BA-CA34-030F-0B2E-E4EA7FA40577}"/>
          </ac:spMkLst>
        </pc:spChg>
        <pc:spChg chg="mod">
          <ac:chgData name="Papaioannou, Ioannis" userId="27d0d6e0-1133-45d1-b366-9071ba1a55b0" providerId="ADAL" clId="{B0F2CD70-F772-4ABC-91C7-3B19E0DEB205}" dt="2023-11-05T18:28:04.180" v="867" actId="21"/>
          <ac:spMkLst>
            <pc:docMk/>
            <pc:sldMk cId="1022482673" sldId="261"/>
            <ac:spMk id="103" creationId="{F4492926-F53D-DE23-53F1-81CB451E444E}"/>
          </ac:spMkLst>
        </pc:spChg>
        <pc:grpChg chg="add del mod">
          <ac:chgData name="Papaioannou, Ioannis" userId="27d0d6e0-1133-45d1-b366-9071ba1a55b0" providerId="ADAL" clId="{B0F2CD70-F772-4ABC-91C7-3B19E0DEB205}" dt="2023-11-05T16:38:43.748" v="535" actId="478"/>
          <ac:grpSpMkLst>
            <pc:docMk/>
            <pc:sldMk cId="1022482673" sldId="261"/>
            <ac:grpSpMk id="6" creationId="{869A7990-0DE1-69E1-62D0-F1792413DDFF}"/>
          </ac:grpSpMkLst>
        </pc:grpChg>
        <pc:grpChg chg="mod">
          <ac:chgData name="Papaioannou, Ioannis" userId="27d0d6e0-1133-45d1-b366-9071ba1a55b0" providerId="ADAL" clId="{B0F2CD70-F772-4ABC-91C7-3B19E0DEB205}" dt="2023-11-05T17:42:12.260" v="741" actId="1035"/>
          <ac:grpSpMkLst>
            <pc:docMk/>
            <pc:sldMk cId="1022482673" sldId="261"/>
            <ac:grpSpMk id="13" creationId="{8F2A8952-A4EA-26BB-E650-B9E9E6A9F7B2}"/>
          </ac:grpSpMkLst>
        </pc:grpChg>
        <pc:grpChg chg="add del mod">
          <ac:chgData name="Papaioannou, Ioannis" userId="27d0d6e0-1133-45d1-b366-9071ba1a55b0" providerId="ADAL" clId="{B0F2CD70-F772-4ABC-91C7-3B19E0DEB205}" dt="2023-11-05T16:39:32.068" v="543" actId="478"/>
          <ac:grpSpMkLst>
            <pc:docMk/>
            <pc:sldMk cId="1022482673" sldId="261"/>
            <ac:grpSpMk id="32" creationId="{EECC3705-7368-F659-CE93-FDBB17A16344}"/>
          </ac:grpSpMkLst>
        </pc:grpChg>
        <pc:grpChg chg="add del mod">
          <ac:chgData name="Papaioannou, Ioannis" userId="27d0d6e0-1133-45d1-b366-9071ba1a55b0" providerId="ADAL" clId="{B0F2CD70-F772-4ABC-91C7-3B19E0DEB205}" dt="2023-11-05T16:40:22.534" v="557" actId="21"/>
          <ac:grpSpMkLst>
            <pc:docMk/>
            <pc:sldMk cId="1022482673" sldId="261"/>
            <ac:grpSpMk id="41" creationId="{055EA20A-0D70-4ED5-0400-76F66CA7C969}"/>
          </ac:grpSpMkLst>
        </pc:grpChg>
        <pc:grpChg chg="add del mod">
          <ac:chgData name="Papaioannou, Ioannis" userId="27d0d6e0-1133-45d1-b366-9071ba1a55b0" providerId="ADAL" clId="{B0F2CD70-F772-4ABC-91C7-3B19E0DEB205}" dt="2023-11-05T16:41:04.541" v="567" actId="21"/>
          <ac:grpSpMkLst>
            <pc:docMk/>
            <pc:sldMk cId="1022482673" sldId="261"/>
            <ac:grpSpMk id="42" creationId="{4F84E098-552F-C67B-634B-C5179DFF5A0C}"/>
          </ac:grpSpMkLst>
        </pc:grpChg>
        <pc:grpChg chg="add del mod">
          <ac:chgData name="Papaioannou, Ioannis" userId="27d0d6e0-1133-45d1-b366-9071ba1a55b0" providerId="ADAL" clId="{B0F2CD70-F772-4ABC-91C7-3B19E0DEB205}" dt="2023-11-05T16:40:26.259" v="559" actId="21"/>
          <ac:grpSpMkLst>
            <pc:docMk/>
            <pc:sldMk cId="1022482673" sldId="261"/>
            <ac:grpSpMk id="46" creationId="{0B051C7D-7244-AD31-B1C7-F0CA65D97AA0}"/>
          </ac:grpSpMkLst>
        </pc:grpChg>
        <pc:grpChg chg="add del mod">
          <ac:chgData name="Papaioannou, Ioannis" userId="27d0d6e0-1133-45d1-b366-9071ba1a55b0" providerId="ADAL" clId="{B0F2CD70-F772-4ABC-91C7-3B19E0DEB205}" dt="2023-11-05T16:42:29.375" v="589" actId="478"/>
          <ac:grpSpMkLst>
            <pc:docMk/>
            <pc:sldMk cId="1022482673" sldId="261"/>
            <ac:grpSpMk id="55" creationId="{4BC50CA6-CF6D-FF28-1CC3-CB20AEE9E154}"/>
          </ac:grpSpMkLst>
        </pc:grpChg>
        <pc:grpChg chg="add del mod">
          <ac:chgData name="Papaioannou, Ioannis" userId="27d0d6e0-1133-45d1-b366-9071ba1a55b0" providerId="ADAL" clId="{B0F2CD70-F772-4ABC-91C7-3B19E0DEB205}" dt="2023-11-05T16:42:00.613" v="582" actId="478"/>
          <ac:grpSpMkLst>
            <pc:docMk/>
            <pc:sldMk cId="1022482673" sldId="261"/>
            <ac:grpSpMk id="56" creationId="{53A1DAC3-ABEF-E2D6-3562-FD2AEA515987}"/>
          </ac:grpSpMkLst>
        </pc:grpChg>
        <pc:grpChg chg="add del mod">
          <ac:chgData name="Papaioannou, Ioannis" userId="27d0d6e0-1133-45d1-b366-9071ba1a55b0" providerId="ADAL" clId="{B0F2CD70-F772-4ABC-91C7-3B19E0DEB205}" dt="2023-11-05T16:43:51.906" v="607" actId="478"/>
          <ac:grpSpMkLst>
            <pc:docMk/>
            <pc:sldMk cId="1022482673" sldId="261"/>
            <ac:grpSpMk id="65" creationId="{119EBFF0-05F0-54A7-D9FF-522EDA1C9887}"/>
          </ac:grpSpMkLst>
        </pc:grpChg>
        <pc:grpChg chg="add del mod">
          <ac:chgData name="Papaioannou, Ioannis" userId="27d0d6e0-1133-45d1-b366-9071ba1a55b0" providerId="ADAL" clId="{B0F2CD70-F772-4ABC-91C7-3B19E0DEB205}" dt="2023-11-05T16:56:33.106" v="708" actId="478"/>
          <ac:grpSpMkLst>
            <pc:docMk/>
            <pc:sldMk cId="1022482673" sldId="261"/>
            <ac:grpSpMk id="66" creationId="{7744D01F-151B-F8A4-9E38-B60FB5CD030B}"/>
          </ac:grpSpMkLst>
        </pc:grpChg>
        <pc:grpChg chg="add del mod">
          <ac:chgData name="Papaioannou, Ioannis" userId="27d0d6e0-1133-45d1-b366-9071ba1a55b0" providerId="ADAL" clId="{B0F2CD70-F772-4ABC-91C7-3B19E0DEB205}" dt="2023-11-05T18:27:05.414" v="859" actId="478"/>
          <ac:grpSpMkLst>
            <pc:docMk/>
            <pc:sldMk cId="1022482673" sldId="261"/>
            <ac:grpSpMk id="99" creationId="{B0A8FC3E-9008-7B45-0FF5-E3CAE7943451}"/>
          </ac:grpSpMkLst>
        </pc:grpChg>
        <pc:grpChg chg="add del mod">
          <ac:chgData name="Papaioannou, Ioannis" userId="27d0d6e0-1133-45d1-b366-9071ba1a55b0" providerId="ADAL" clId="{B0F2CD70-F772-4ABC-91C7-3B19E0DEB205}" dt="2023-11-05T18:28:06.050" v="868" actId="478"/>
          <ac:grpSpMkLst>
            <pc:docMk/>
            <pc:sldMk cId="1022482673" sldId="261"/>
            <ac:grpSpMk id="100" creationId="{5AB6AFED-FDBD-ADC3-80BA-6108DF46FDC5}"/>
          </ac:grpSpMkLst>
        </pc:grpChg>
        <pc:picChg chg="del">
          <ac:chgData name="Papaioannou, Ioannis" userId="27d0d6e0-1133-45d1-b366-9071ba1a55b0" providerId="ADAL" clId="{B0F2CD70-F772-4ABC-91C7-3B19E0DEB205}" dt="2023-11-05T18:44:05.403" v="936" actId="478"/>
          <ac:picMkLst>
            <pc:docMk/>
            <pc:sldMk cId="1022482673" sldId="261"/>
            <ac:picMk id="3" creationId="{A1D3D332-DFDF-E141-6E08-402DA75BBEFD}"/>
          </ac:picMkLst>
        </pc:picChg>
        <pc:picChg chg="del mod topLvl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7" creationId="{27120373-D044-1C91-1E10-13ED30C77FA2}"/>
          </ac:picMkLst>
        </pc:picChg>
        <pc:picChg chg="mod">
          <ac:chgData name="Papaioannou, Ioannis" userId="27d0d6e0-1133-45d1-b366-9071ba1a55b0" providerId="ADAL" clId="{B0F2CD70-F772-4ABC-91C7-3B19E0DEB205}" dt="2023-11-05T17:42:12.260" v="741" actId="1035"/>
          <ac:picMkLst>
            <pc:docMk/>
            <pc:sldMk cId="1022482673" sldId="261"/>
            <ac:picMk id="8" creationId="{439F1EB9-1683-6C28-2EB0-BAEE4A6FDA2A}"/>
          </ac:picMkLst>
        </pc:picChg>
        <pc:picChg chg="mod">
          <ac:chgData name="Papaioannou, Ioannis" userId="27d0d6e0-1133-45d1-b366-9071ba1a55b0" providerId="ADAL" clId="{B0F2CD70-F772-4ABC-91C7-3B19E0DEB205}" dt="2023-11-05T17:42:23.560" v="748" actId="1035"/>
          <ac:picMkLst>
            <pc:docMk/>
            <pc:sldMk cId="1022482673" sldId="261"/>
            <ac:picMk id="14" creationId="{D0D0BF71-9037-DC8B-1481-26F9C896D48C}"/>
          </ac:picMkLst>
        </pc:picChg>
        <pc:picChg chg="mod">
          <ac:chgData name="Papaioannou, Ioannis" userId="27d0d6e0-1133-45d1-b366-9071ba1a55b0" providerId="ADAL" clId="{B0F2CD70-F772-4ABC-91C7-3B19E0DEB205}" dt="2023-11-05T18:12:34.857" v="844" actId="1076"/>
          <ac:picMkLst>
            <pc:docMk/>
            <pc:sldMk cId="1022482673" sldId="261"/>
            <ac:picMk id="24" creationId="{E8028ADB-6395-C4DF-85EE-DED7FA1B2AA7}"/>
          </ac:picMkLst>
        </pc:picChg>
        <pc:picChg chg="mod">
          <ac:chgData name="Papaioannou, Ioannis" userId="27d0d6e0-1133-45d1-b366-9071ba1a55b0" providerId="ADAL" clId="{B0F2CD70-F772-4ABC-91C7-3B19E0DEB205}" dt="2023-11-05T17:42:03.705" v="730" actId="1076"/>
          <ac:picMkLst>
            <pc:docMk/>
            <pc:sldMk cId="1022482673" sldId="261"/>
            <ac:picMk id="27" creationId="{0C39A7AA-A84C-F22E-6C11-F77CBFC01406}"/>
          </ac:picMkLst>
        </pc:picChg>
        <pc:picChg chg="add del mod">
          <ac:chgData name="Papaioannou, Ioannis" userId="27d0d6e0-1133-45d1-b366-9071ba1a55b0" providerId="ADAL" clId="{B0F2CD70-F772-4ABC-91C7-3B19E0DEB205}" dt="2023-11-05T16:39:21.353" v="540" actId="478"/>
          <ac:picMkLst>
            <pc:docMk/>
            <pc:sldMk cId="1022482673" sldId="261"/>
            <ac:picMk id="33" creationId="{BA405233-42D5-3849-DA74-4BE03BF4DC89}"/>
          </ac:picMkLst>
        </pc:picChg>
        <pc:picChg chg="add del mod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36" creationId="{2265079F-CCD0-07C0-AC9F-DAC94B9DF231}"/>
          </ac:picMkLst>
        </pc:picChg>
        <pc:picChg chg="add del mod">
          <ac:chgData name="Papaioannou, Ioannis" userId="27d0d6e0-1133-45d1-b366-9071ba1a55b0" providerId="ADAL" clId="{B0F2CD70-F772-4ABC-91C7-3B19E0DEB205}" dt="2023-11-05T16:39:39.307" v="547"/>
          <ac:picMkLst>
            <pc:docMk/>
            <pc:sldMk cId="1022482673" sldId="261"/>
            <ac:picMk id="37" creationId="{C531A2F1-25B2-90E1-D206-4D32394DEA3F}"/>
          </ac:picMkLst>
        </pc:picChg>
        <pc:picChg chg="add del mod">
          <ac:chgData name="Papaioannou, Ioannis" userId="27d0d6e0-1133-45d1-b366-9071ba1a55b0" providerId="ADAL" clId="{B0F2CD70-F772-4ABC-91C7-3B19E0DEB205}" dt="2023-11-05T16:40:11.800" v="555" actId="478"/>
          <ac:picMkLst>
            <pc:docMk/>
            <pc:sldMk cId="1022482673" sldId="261"/>
            <ac:picMk id="38" creationId="{CC9D7625-347E-5B53-7CDA-D6049256AF1D}"/>
          </ac:picMkLst>
        </pc:picChg>
        <pc:picChg chg="del mod">
          <ac:chgData name="Papaioannou, Ioannis" userId="27d0d6e0-1133-45d1-b366-9071ba1a55b0" providerId="ADAL" clId="{B0F2CD70-F772-4ABC-91C7-3B19E0DEB205}" dt="2023-11-05T16:41:04.541" v="567" actId="21"/>
          <ac:picMkLst>
            <pc:docMk/>
            <pc:sldMk cId="1022482673" sldId="261"/>
            <ac:picMk id="43" creationId="{0374FD45-C7F9-A043-DFE7-26B2E86DC852}"/>
          </ac:picMkLst>
        </pc:picChg>
        <pc:picChg chg="del mod">
          <ac:chgData name="Papaioannou, Ioannis" userId="27d0d6e0-1133-45d1-b366-9071ba1a55b0" providerId="ADAL" clId="{B0F2CD70-F772-4ABC-91C7-3B19E0DEB205}" dt="2023-11-05T16:40:26.259" v="559" actId="21"/>
          <ac:picMkLst>
            <pc:docMk/>
            <pc:sldMk cId="1022482673" sldId="261"/>
            <ac:picMk id="47" creationId="{A0382135-D17D-4545-C9EE-98A30C9A0166}"/>
          </ac:picMkLst>
        </pc:picChg>
        <pc:picChg chg="add del mod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49" creationId="{E7C66F05-70AB-F5C6-A5AB-08355E5C910B}"/>
          </ac:picMkLst>
        </pc:picChg>
        <pc:picChg chg="add del mod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50" creationId="{5402C46A-0C36-4906-2829-A6E90D5938D5}"/>
          </ac:picMkLst>
        </pc:picChg>
        <pc:picChg chg="add del mod">
          <ac:chgData name="Papaioannou, Ioannis" userId="27d0d6e0-1133-45d1-b366-9071ba1a55b0" providerId="ADAL" clId="{B0F2CD70-F772-4ABC-91C7-3B19E0DEB205}" dt="2023-11-05T16:41:16.941" v="572"/>
          <ac:picMkLst>
            <pc:docMk/>
            <pc:sldMk cId="1022482673" sldId="261"/>
            <ac:picMk id="51" creationId="{16ACE956-42B1-A03D-836A-FFEBAD5EED7E}"/>
          </ac:picMkLst>
        </pc:picChg>
        <pc:picChg chg="add del mod">
          <ac:chgData name="Papaioannou, Ioannis" userId="27d0d6e0-1133-45d1-b366-9071ba1a55b0" providerId="ADAL" clId="{B0F2CD70-F772-4ABC-91C7-3B19E0DEB205}" dt="2023-11-05T16:42:27.880" v="588" actId="21"/>
          <ac:picMkLst>
            <pc:docMk/>
            <pc:sldMk cId="1022482673" sldId="261"/>
            <ac:picMk id="52" creationId="{0A35FB7A-C2F9-5C74-8866-68B6FA15FDBB}"/>
          </ac:picMkLst>
        </pc:picChg>
        <pc:picChg chg="del mod">
          <ac:chgData name="Papaioannou, Ioannis" userId="27d0d6e0-1133-45d1-b366-9071ba1a55b0" providerId="ADAL" clId="{B0F2CD70-F772-4ABC-91C7-3B19E0DEB205}" dt="2023-11-05T16:41:56.202" v="580" actId="21"/>
          <ac:picMkLst>
            <pc:docMk/>
            <pc:sldMk cId="1022482673" sldId="261"/>
            <ac:picMk id="57" creationId="{625E7C80-F2D9-F148-0DAF-26CF7437F757}"/>
          </ac:picMkLst>
        </pc:picChg>
        <pc:picChg chg="add del mod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60" creationId="{F46D0E48-CF42-3A12-07F8-86F697537B37}"/>
          </ac:picMkLst>
        </pc:picChg>
        <pc:picChg chg="add del mod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61" creationId="{EAB46DA4-96FE-FB96-B99A-CAB423985597}"/>
          </ac:picMkLst>
        </pc:picChg>
        <pc:picChg chg="add del mod">
          <ac:chgData name="Papaioannou, Ioannis" userId="27d0d6e0-1133-45d1-b366-9071ba1a55b0" providerId="ADAL" clId="{B0F2CD70-F772-4ABC-91C7-3B19E0DEB205}" dt="2023-11-05T16:43:43.539" v="604" actId="21"/>
          <ac:picMkLst>
            <pc:docMk/>
            <pc:sldMk cId="1022482673" sldId="261"/>
            <ac:picMk id="62" creationId="{809C6B84-F880-3122-B05D-C0BC5C2DA2A2}"/>
          </ac:picMkLst>
        </pc:picChg>
        <pc:picChg chg="del mod">
          <ac:chgData name="Papaioannou, Ioannis" userId="27d0d6e0-1133-45d1-b366-9071ba1a55b0" providerId="ADAL" clId="{B0F2CD70-F772-4ABC-91C7-3B19E0DEB205}" dt="2023-11-05T16:44:38.199" v="613" actId="21"/>
          <ac:picMkLst>
            <pc:docMk/>
            <pc:sldMk cId="1022482673" sldId="261"/>
            <ac:picMk id="67" creationId="{64AB3414-82AD-DC48-1A37-5D1CC00752A6}"/>
          </ac:picMkLst>
        </pc:picChg>
        <pc:picChg chg="add del mod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70" creationId="{46E0D97B-24ED-2E60-38F9-C4C7B196BEE0}"/>
          </ac:picMkLst>
        </pc:picChg>
        <pc:picChg chg="add del mod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71" creationId="{39321583-57D1-A706-7487-2C46AF6B6EAB}"/>
          </ac:picMkLst>
        </pc:picChg>
        <pc:picChg chg="add del mod">
          <ac:chgData name="Papaioannou, Ioannis" userId="27d0d6e0-1133-45d1-b366-9071ba1a55b0" providerId="ADAL" clId="{B0F2CD70-F772-4ABC-91C7-3B19E0DEB205}" dt="2023-11-05T16:46:59.357" v="652" actId="21"/>
          <ac:picMkLst>
            <pc:docMk/>
            <pc:sldMk cId="1022482673" sldId="261"/>
            <ac:picMk id="72" creationId="{3FBA3234-A9AE-D2B5-3C90-6C44691BB478}"/>
          </ac:picMkLst>
        </pc:picChg>
        <pc:picChg chg="add del mod">
          <ac:chgData name="Papaioannou, Ioannis" userId="27d0d6e0-1133-45d1-b366-9071ba1a55b0" providerId="ADAL" clId="{B0F2CD70-F772-4ABC-91C7-3B19E0DEB205}" dt="2023-11-05T16:46:59.357" v="652" actId="21"/>
          <ac:picMkLst>
            <pc:docMk/>
            <pc:sldMk cId="1022482673" sldId="261"/>
            <ac:picMk id="73" creationId="{23E7FDFE-4994-FAC7-934C-523E2D813672}"/>
          </ac:picMkLst>
        </pc:picChg>
        <pc:picChg chg="add del mod">
          <ac:chgData name="Papaioannou, Ioannis" userId="27d0d6e0-1133-45d1-b366-9071ba1a55b0" providerId="ADAL" clId="{B0F2CD70-F772-4ABC-91C7-3B19E0DEB205}" dt="2023-11-05T16:46:59.357" v="652" actId="21"/>
          <ac:picMkLst>
            <pc:docMk/>
            <pc:sldMk cId="1022482673" sldId="261"/>
            <ac:picMk id="74" creationId="{5DC681BF-E1FB-6762-8BB5-112EDE80BF53}"/>
          </ac:picMkLst>
        </pc:picChg>
        <pc:picChg chg="add del mod">
          <ac:chgData name="Papaioannou, Ioannis" userId="27d0d6e0-1133-45d1-b366-9071ba1a55b0" providerId="ADAL" clId="{B0F2CD70-F772-4ABC-91C7-3B19E0DEB205}" dt="2023-11-05T16:46:59.357" v="652" actId="21"/>
          <ac:picMkLst>
            <pc:docMk/>
            <pc:sldMk cId="1022482673" sldId="261"/>
            <ac:picMk id="75" creationId="{614FD305-6DDB-6AB7-F734-A8CB45076B5A}"/>
          </ac:picMkLst>
        </pc:picChg>
        <pc:picChg chg="add del mod">
          <ac:chgData name="Papaioannou, Ioannis" userId="27d0d6e0-1133-45d1-b366-9071ba1a55b0" providerId="ADAL" clId="{B0F2CD70-F772-4ABC-91C7-3B19E0DEB205}" dt="2023-11-05T17:44:05.187" v="757" actId="21"/>
          <ac:picMkLst>
            <pc:docMk/>
            <pc:sldMk cId="1022482673" sldId="261"/>
            <ac:picMk id="76" creationId="{7953EDF4-1776-BB1D-7DA7-26284728E436}"/>
          </ac:picMkLst>
        </pc:picChg>
        <pc:picChg chg="add del">
          <ac:chgData name="Papaioannou, Ioannis" userId="27d0d6e0-1133-45d1-b366-9071ba1a55b0" providerId="ADAL" clId="{B0F2CD70-F772-4ABC-91C7-3B19E0DEB205}" dt="2023-11-05T17:43:46.047" v="756"/>
          <ac:picMkLst>
            <pc:docMk/>
            <pc:sldMk cId="1022482673" sldId="261"/>
            <ac:picMk id="77" creationId="{2A742E64-C22C-9CB8-F1A0-7C113899BA48}"/>
          </ac:picMkLst>
        </pc:picChg>
        <pc:picChg chg="add del mod">
          <ac:chgData name="Papaioannou, Ioannis" userId="27d0d6e0-1133-45d1-b366-9071ba1a55b0" providerId="ADAL" clId="{B0F2CD70-F772-4ABC-91C7-3B19E0DEB205}" dt="2023-11-05T17:49:09.531" v="763" actId="478"/>
          <ac:picMkLst>
            <pc:docMk/>
            <pc:sldMk cId="1022482673" sldId="261"/>
            <ac:picMk id="79" creationId="{3E5C1BEB-3FB2-9D0B-7B28-8E4431D0055F}"/>
          </ac:picMkLst>
        </pc:picChg>
        <pc:picChg chg="add del mod modCrop">
          <ac:chgData name="Papaioannou, Ioannis" userId="27d0d6e0-1133-45d1-b366-9071ba1a55b0" providerId="ADAL" clId="{B0F2CD70-F772-4ABC-91C7-3B19E0DEB205}" dt="2023-11-05T18:08:41.261" v="791" actId="478"/>
          <ac:picMkLst>
            <pc:docMk/>
            <pc:sldMk cId="1022482673" sldId="261"/>
            <ac:picMk id="81" creationId="{5AF645BD-6D36-BFC9-0B8C-617E617A3B9F}"/>
          </ac:picMkLst>
        </pc:picChg>
        <pc:picChg chg="add del mod">
          <ac:chgData name="Papaioannou, Ioannis" userId="27d0d6e0-1133-45d1-b366-9071ba1a55b0" providerId="ADAL" clId="{B0F2CD70-F772-4ABC-91C7-3B19E0DEB205}" dt="2023-11-05T18:07:57.014" v="782"/>
          <ac:picMkLst>
            <pc:docMk/>
            <pc:sldMk cId="1022482673" sldId="261"/>
            <ac:picMk id="82" creationId="{14E90B4C-A7E3-8B99-ACAF-0F09038AF8F1}"/>
          </ac:picMkLst>
        </pc:picChg>
        <pc:picChg chg="add del mod">
          <ac:chgData name="Papaioannou, Ioannis" userId="27d0d6e0-1133-45d1-b366-9071ba1a55b0" providerId="ADAL" clId="{B0F2CD70-F772-4ABC-91C7-3B19E0DEB205}" dt="2023-11-05T18:08:41.261" v="791" actId="478"/>
          <ac:picMkLst>
            <pc:docMk/>
            <pc:sldMk cId="1022482673" sldId="261"/>
            <ac:picMk id="84" creationId="{E9C52BA7-F524-3349-7F67-BD6FC94CA08F}"/>
          </ac:picMkLst>
        </pc:picChg>
        <pc:picChg chg="add mod">
          <ac:chgData name="Papaioannou, Ioannis" userId="27d0d6e0-1133-45d1-b366-9071ba1a55b0" providerId="ADAL" clId="{B0F2CD70-F772-4ABC-91C7-3B19E0DEB205}" dt="2023-11-05T18:09:07.052" v="795" actId="1076"/>
          <ac:picMkLst>
            <pc:docMk/>
            <pc:sldMk cId="1022482673" sldId="261"/>
            <ac:picMk id="86" creationId="{58772CE6-29CA-32D7-16E9-6BFAA01A50DF}"/>
          </ac:picMkLst>
        </pc:picChg>
        <pc:picChg chg="add mod">
          <ac:chgData name="Papaioannou, Ioannis" userId="27d0d6e0-1133-45d1-b366-9071ba1a55b0" providerId="ADAL" clId="{B0F2CD70-F772-4ABC-91C7-3B19E0DEB205}" dt="2023-11-05T18:09:35.839" v="812" actId="571"/>
          <ac:picMkLst>
            <pc:docMk/>
            <pc:sldMk cId="1022482673" sldId="261"/>
            <ac:picMk id="90" creationId="{F8607AA5-2934-A39A-8672-69457672DEB7}"/>
          </ac:picMkLst>
        </pc:picChg>
        <pc:picChg chg="add del mod modCrop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93" creationId="{A48FC4FE-3EC7-0245-84A1-0FCBB2DBC295}"/>
          </ac:picMkLst>
        </pc:picChg>
        <pc:picChg chg="add del mod modCrop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94" creationId="{D3100A53-B01D-ADD3-2666-0D691FF731B2}"/>
          </ac:picMkLst>
        </pc:picChg>
        <pc:picChg chg="add del mod">
          <ac:chgData name="Papaioannou, Ioannis" userId="27d0d6e0-1133-45d1-b366-9071ba1a55b0" providerId="ADAL" clId="{B0F2CD70-F772-4ABC-91C7-3B19E0DEB205}" dt="2023-11-05T18:12:25.081" v="840"/>
          <ac:picMkLst>
            <pc:docMk/>
            <pc:sldMk cId="1022482673" sldId="261"/>
            <ac:picMk id="95" creationId="{41E0DF86-2A67-E21D-177A-398F1D20ABF3}"/>
          </ac:picMkLst>
        </pc:picChg>
        <pc:picChg chg="add del mod">
          <ac:chgData name="Papaioannou, Ioannis" userId="27d0d6e0-1133-45d1-b366-9071ba1a55b0" providerId="ADAL" clId="{B0F2CD70-F772-4ABC-91C7-3B19E0DEB205}" dt="2023-11-05T18:26:49.495" v="855" actId="21"/>
          <ac:picMkLst>
            <pc:docMk/>
            <pc:sldMk cId="1022482673" sldId="261"/>
            <ac:picMk id="96" creationId="{481727FE-61B0-C959-E2D4-F9EBBC014FC0}"/>
          </ac:picMkLst>
        </pc:picChg>
        <pc:picChg chg="del mod">
          <ac:chgData name="Papaioannou, Ioannis" userId="27d0d6e0-1133-45d1-b366-9071ba1a55b0" providerId="ADAL" clId="{B0F2CD70-F772-4ABC-91C7-3B19E0DEB205}" dt="2023-11-05T18:28:04.180" v="867" actId="21"/>
          <ac:picMkLst>
            <pc:docMk/>
            <pc:sldMk cId="1022482673" sldId="261"/>
            <ac:picMk id="101" creationId="{3403A5C6-48B1-5EB5-ED4D-A3EB13574E3E}"/>
          </ac:picMkLst>
        </pc:picChg>
        <pc:picChg chg="add del mod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104" creationId="{FAD15731-A8E7-6751-F3EA-00242CEFD19E}"/>
          </ac:picMkLst>
        </pc:picChg>
        <pc:picChg chg="add del mod">
          <ac:chgData name="Papaioannou, Ioannis" userId="27d0d6e0-1133-45d1-b366-9071ba1a55b0" providerId="ADAL" clId="{B0F2CD70-F772-4ABC-91C7-3B19E0DEB205}" dt="2023-11-05T18:44:29.863" v="944" actId="21"/>
          <ac:picMkLst>
            <pc:docMk/>
            <pc:sldMk cId="1022482673" sldId="261"/>
            <ac:picMk id="105" creationId="{A5499275-1BEE-E1D2-2D76-C17774F33E8C}"/>
          </ac:picMkLst>
        </pc:picChg>
        <pc:picChg chg="add del mod ord">
          <ac:chgData name="Papaioannou, Ioannis" userId="27d0d6e0-1133-45d1-b366-9071ba1a55b0" providerId="ADAL" clId="{B0F2CD70-F772-4ABC-91C7-3B19E0DEB205}" dt="2023-11-05T19:41:01.227" v="945" actId="478"/>
          <ac:picMkLst>
            <pc:docMk/>
            <pc:sldMk cId="1022482673" sldId="261"/>
            <ac:picMk id="107" creationId="{10EC9B3A-0163-6570-761E-110A14C17315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08" creationId="{B04D5732-A6D8-31AA-632F-F943E771FDF3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09" creationId="{8E11667A-8EC7-7EDD-F676-14AA052C8464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0" creationId="{3D7D4B17-95CA-A707-4519-900F6FFED8E8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1" creationId="{C4FDBA27-025C-2609-5FFD-B115B3603B15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2" creationId="{AEB86498-2E12-15FB-B45A-52AF16831290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3" creationId="{0AC17BAF-8B34-B046-5745-7E771F96267A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4" creationId="{469EF709-F8ED-E6FB-758C-A19A49065789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5" creationId="{17DF74DA-2D7B-E381-E84B-3BD8645AA27E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6" creationId="{0028B9BE-4B52-FA56-2BCF-60AB914810D1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7" creationId="{D183468D-AC98-E533-6CC1-F35A84CC3DBD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8" creationId="{42032A37-D016-5FC1-5433-76E6233DE1D4}"/>
          </ac:picMkLst>
        </pc:picChg>
        <pc:picChg chg="add del mod">
          <ac:chgData name="Papaioannou, Ioannis" userId="27d0d6e0-1133-45d1-b366-9071ba1a55b0" providerId="ADAL" clId="{B0F2CD70-F772-4ABC-91C7-3B19E0DEB205}" dt="2023-11-05T20:14:34.675" v="1015" actId="21"/>
          <ac:picMkLst>
            <pc:docMk/>
            <pc:sldMk cId="1022482673" sldId="261"/>
            <ac:picMk id="119" creationId="{327FBF37-545D-3A77-1DEC-8185544A6AD2}"/>
          </ac:picMkLst>
        </pc:picChg>
        <pc:picChg chg="add mod">
          <ac:chgData name="Papaioannou, Ioannis" userId="27d0d6e0-1133-45d1-b366-9071ba1a55b0" providerId="ADAL" clId="{B0F2CD70-F772-4ABC-91C7-3B19E0DEB205}" dt="2023-11-05T20:14:40.038" v="1017" actId="14100"/>
          <ac:picMkLst>
            <pc:docMk/>
            <pc:sldMk cId="1022482673" sldId="261"/>
            <ac:picMk id="123" creationId="{77853E38-F519-04EA-C899-346804CA0659}"/>
          </ac:picMkLst>
        </pc:picChg>
        <pc:cxnChg chg="add del mod">
          <ac:chgData name="Papaioannou, Ioannis" userId="27d0d6e0-1133-45d1-b366-9071ba1a55b0" providerId="ADAL" clId="{B0F2CD70-F772-4ABC-91C7-3B19E0DEB205}" dt="2023-11-05T20:14:34.675" v="1015" actId="21"/>
          <ac:cxnSpMkLst>
            <pc:docMk/>
            <pc:sldMk cId="1022482673" sldId="261"/>
            <ac:cxnSpMk id="121" creationId="{11524764-7B32-163D-52BE-697CB6F433ED}"/>
          </ac:cxnSpMkLst>
        </pc:cxnChg>
      </pc:sldChg>
      <pc:sldChg chg="addSp delSp modSp mod">
        <pc:chgData name="Papaioannou, Ioannis" userId="27d0d6e0-1133-45d1-b366-9071ba1a55b0" providerId="ADAL" clId="{B0F2CD70-F772-4ABC-91C7-3B19E0DEB205}" dt="2023-11-12T19:23:38.457" v="1508" actId="1076"/>
        <pc:sldMkLst>
          <pc:docMk/>
          <pc:sldMk cId="1934854818" sldId="262"/>
        </pc:sldMkLst>
        <pc:spChg chg="mod">
          <ac:chgData name="Papaioannou, Ioannis" userId="27d0d6e0-1133-45d1-b366-9071ba1a55b0" providerId="ADAL" clId="{B0F2CD70-F772-4ABC-91C7-3B19E0DEB205}" dt="2023-11-12T19:23:14.902" v="1505" actId="1076"/>
          <ac:spMkLst>
            <pc:docMk/>
            <pc:sldMk cId="1934854818" sldId="262"/>
            <ac:spMk id="2" creationId="{58012A5E-C80D-E6F4-5D46-9A4B72A10E52}"/>
          </ac:spMkLst>
        </pc:spChg>
        <pc:spChg chg="mod">
          <ac:chgData name="Papaioannou, Ioannis" userId="27d0d6e0-1133-45d1-b366-9071ba1a55b0" providerId="ADAL" clId="{B0F2CD70-F772-4ABC-91C7-3B19E0DEB205}" dt="2023-11-12T19:23:14.902" v="1505" actId="1076"/>
          <ac:spMkLst>
            <pc:docMk/>
            <pc:sldMk cId="1934854818" sldId="262"/>
            <ac:spMk id="7" creationId="{6CFA864F-00E5-9B5E-6F26-9C4134E770FE}"/>
          </ac:spMkLst>
        </pc:spChg>
        <pc:spChg chg="mod">
          <ac:chgData name="Papaioannou, Ioannis" userId="27d0d6e0-1133-45d1-b366-9071ba1a55b0" providerId="ADAL" clId="{B0F2CD70-F772-4ABC-91C7-3B19E0DEB205}" dt="2023-11-12T19:23:14.902" v="1505" actId="1076"/>
          <ac:spMkLst>
            <pc:docMk/>
            <pc:sldMk cId="1934854818" sldId="262"/>
            <ac:spMk id="9" creationId="{890D0D29-632E-01B5-A151-B1BAA3047027}"/>
          </ac:spMkLst>
        </pc:spChg>
        <pc:spChg chg="mod">
          <ac:chgData name="Papaioannou, Ioannis" userId="27d0d6e0-1133-45d1-b366-9071ba1a55b0" providerId="ADAL" clId="{B0F2CD70-F772-4ABC-91C7-3B19E0DEB205}" dt="2023-11-12T19:23:38.457" v="1508" actId="1076"/>
          <ac:spMkLst>
            <pc:docMk/>
            <pc:sldMk cId="1934854818" sldId="262"/>
            <ac:spMk id="10" creationId="{3C16DB6D-2F93-6176-465F-9A95D192B8D8}"/>
          </ac:spMkLst>
        </pc:spChg>
        <pc:spChg chg="mod">
          <ac:chgData name="Papaioannou, Ioannis" userId="27d0d6e0-1133-45d1-b366-9071ba1a55b0" providerId="ADAL" clId="{B0F2CD70-F772-4ABC-91C7-3B19E0DEB205}" dt="2023-11-12T19:23:14.902" v="1505" actId="1076"/>
          <ac:spMkLst>
            <pc:docMk/>
            <pc:sldMk cId="1934854818" sldId="262"/>
            <ac:spMk id="11" creationId="{38E85E57-708A-8E9F-D247-27B0EA128805}"/>
          </ac:spMkLst>
        </pc:spChg>
        <pc:spChg chg="mod">
          <ac:chgData name="Papaioannou, Ioannis" userId="27d0d6e0-1133-45d1-b366-9071ba1a55b0" providerId="ADAL" clId="{B0F2CD70-F772-4ABC-91C7-3B19E0DEB205}" dt="2023-11-05T20:05:28.520" v="954" actId="1036"/>
          <ac:spMkLst>
            <pc:docMk/>
            <pc:sldMk cId="1934854818" sldId="262"/>
            <ac:spMk id="17" creationId="{F1D5FEE7-E2AF-D8CB-7011-801EF7147C3C}"/>
          </ac:spMkLst>
        </pc:spChg>
        <pc:spChg chg="mod">
          <ac:chgData name="Papaioannou, Ioannis" userId="27d0d6e0-1133-45d1-b366-9071ba1a55b0" providerId="ADAL" clId="{B0F2CD70-F772-4ABC-91C7-3B19E0DEB205}" dt="2023-11-12T19:23:14.902" v="1505" actId="1076"/>
          <ac:spMkLst>
            <pc:docMk/>
            <pc:sldMk cId="1934854818" sldId="262"/>
            <ac:spMk id="22" creationId="{DDF32692-198B-8E5A-45BA-4236CC7D6E51}"/>
          </ac:spMkLst>
        </pc:spChg>
        <pc:spChg chg="add del mod">
          <ac:chgData name="Papaioannou, Ioannis" userId="27d0d6e0-1133-45d1-b366-9071ba1a55b0" providerId="ADAL" clId="{B0F2CD70-F772-4ABC-91C7-3B19E0DEB205}" dt="2023-11-05T20:23:29.660" v="1025" actId="478"/>
          <ac:spMkLst>
            <pc:docMk/>
            <pc:sldMk cId="1934854818" sldId="262"/>
            <ac:spMk id="26" creationId="{5599CEE6-90A8-5949-D244-D1F8DC4455E0}"/>
          </ac:spMkLst>
        </pc:spChg>
        <pc:spChg chg="add del mod">
          <ac:chgData name="Papaioannou, Ioannis" userId="27d0d6e0-1133-45d1-b366-9071ba1a55b0" providerId="ADAL" clId="{B0F2CD70-F772-4ABC-91C7-3B19E0DEB205}" dt="2023-11-05T20:28:38.871" v="1045" actId="478"/>
          <ac:spMkLst>
            <pc:docMk/>
            <pc:sldMk cId="1934854818" sldId="262"/>
            <ac:spMk id="33" creationId="{8C865A73-31A5-57BB-E595-E0C6D3B29368}"/>
          </ac:spMkLst>
        </pc:spChg>
        <pc:spChg chg="add del mod">
          <ac:chgData name="Papaioannou, Ioannis" userId="27d0d6e0-1133-45d1-b366-9071ba1a55b0" providerId="ADAL" clId="{B0F2CD70-F772-4ABC-91C7-3B19E0DEB205}" dt="2023-11-05T20:28:36.752" v="1044" actId="478"/>
          <ac:spMkLst>
            <pc:docMk/>
            <pc:sldMk cId="1934854818" sldId="262"/>
            <ac:spMk id="36" creationId="{A45FA9C2-303E-A627-4318-8D53EB9C2868}"/>
          </ac:spMkLst>
        </pc:spChg>
        <pc:spChg chg="add del mod">
          <ac:chgData name="Papaioannou, Ioannis" userId="27d0d6e0-1133-45d1-b366-9071ba1a55b0" providerId="ADAL" clId="{B0F2CD70-F772-4ABC-91C7-3B19E0DEB205}" dt="2023-11-05T20:33:42.782" v="1056" actId="478"/>
          <ac:spMkLst>
            <pc:docMk/>
            <pc:sldMk cId="1934854818" sldId="262"/>
            <ac:spMk id="39" creationId="{7DC7C916-D992-47B5-0BD8-574E8C4770AC}"/>
          </ac:spMkLst>
        </pc:spChg>
        <pc:spChg chg="add del mod">
          <ac:chgData name="Papaioannou, Ioannis" userId="27d0d6e0-1133-45d1-b366-9071ba1a55b0" providerId="ADAL" clId="{B0F2CD70-F772-4ABC-91C7-3B19E0DEB205}" dt="2023-11-05T20:34:39.004" v="1063" actId="478"/>
          <ac:spMkLst>
            <pc:docMk/>
            <pc:sldMk cId="1934854818" sldId="262"/>
            <ac:spMk id="43" creationId="{93735755-22D3-8E46-99EA-EE3E1645E195}"/>
          </ac:spMkLst>
        </pc:spChg>
        <pc:grpChg chg="add del mod">
          <ac:chgData name="Papaioannou, Ioannis" userId="27d0d6e0-1133-45d1-b366-9071ba1a55b0" providerId="ADAL" clId="{B0F2CD70-F772-4ABC-91C7-3B19E0DEB205}" dt="2023-11-05T20:23:27.845" v="1024" actId="21"/>
          <ac:grpSpMkLst>
            <pc:docMk/>
            <pc:sldMk cId="1934854818" sldId="262"/>
            <ac:grpSpMk id="28" creationId="{EC1403E8-CD38-4847-1A78-69DC2865D516}"/>
          </ac:grpSpMkLst>
        </pc:grpChg>
        <pc:grpChg chg="add del mod">
          <ac:chgData name="Papaioannou, Ioannis" userId="27d0d6e0-1133-45d1-b366-9071ba1a55b0" providerId="ADAL" clId="{B0F2CD70-F772-4ABC-91C7-3B19E0DEB205}" dt="2023-11-05T20:25:26.955" v="1035" actId="21"/>
          <ac:grpSpMkLst>
            <pc:docMk/>
            <pc:sldMk cId="1934854818" sldId="262"/>
            <ac:grpSpMk id="34" creationId="{B61DA9A5-934C-FC11-8988-EB0CFE6A36EA}"/>
          </ac:grpSpMkLst>
        </pc:grpChg>
        <pc:grpChg chg="add del mod">
          <ac:chgData name="Papaioannou, Ioannis" userId="27d0d6e0-1133-45d1-b366-9071ba1a55b0" providerId="ADAL" clId="{B0F2CD70-F772-4ABC-91C7-3B19E0DEB205}" dt="2023-11-05T20:28:33.657" v="1043" actId="21"/>
          <ac:grpSpMkLst>
            <pc:docMk/>
            <pc:sldMk cId="1934854818" sldId="262"/>
            <ac:grpSpMk id="37" creationId="{9F323F47-E17A-77FE-56E2-D4BDA00F36A3}"/>
          </ac:grpSpMkLst>
        </pc:grpChg>
        <pc:grpChg chg="add del mod">
          <ac:chgData name="Papaioannou, Ioannis" userId="27d0d6e0-1133-45d1-b366-9071ba1a55b0" providerId="ADAL" clId="{B0F2CD70-F772-4ABC-91C7-3B19E0DEB205}" dt="2023-11-05T20:29:35.209" v="1053" actId="21"/>
          <ac:grpSpMkLst>
            <pc:docMk/>
            <pc:sldMk cId="1934854818" sldId="262"/>
            <ac:grpSpMk id="40" creationId="{6A1095AE-1C73-BDBE-DD8C-FDD2663455D3}"/>
          </ac:grpSpMkLst>
        </pc:grpChg>
        <pc:grpChg chg="add del mod">
          <ac:chgData name="Papaioannou, Ioannis" userId="27d0d6e0-1133-45d1-b366-9071ba1a55b0" providerId="ADAL" clId="{B0F2CD70-F772-4ABC-91C7-3B19E0DEB205}" dt="2023-11-05T20:34:35.480" v="1062" actId="21"/>
          <ac:grpSpMkLst>
            <pc:docMk/>
            <pc:sldMk cId="1934854818" sldId="262"/>
            <ac:grpSpMk id="44" creationId="{70CFBA51-E122-61B4-AC58-79A492B824F8}"/>
          </ac:grpSpMkLst>
        </pc:grpChg>
        <pc:picChg chg="del">
          <ac:chgData name="Papaioannou, Ioannis" userId="27d0d6e0-1133-45d1-b366-9071ba1a55b0" providerId="ADAL" clId="{B0F2CD70-F772-4ABC-91C7-3B19E0DEB205}" dt="2023-11-12T19:22:03.235" v="1493" actId="478"/>
          <ac:picMkLst>
            <pc:docMk/>
            <pc:sldMk cId="1934854818" sldId="262"/>
            <ac:picMk id="3" creationId="{DF722C31-E267-2472-B3D1-FE229FE37563}"/>
          </ac:picMkLst>
        </pc:picChg>
        <pc:picChg chg="mod">
          <ac:chgData name="Papaioannou, Ioannis" userId="27d0d6e0-1133-45d1-b366-9071ba1a55b0" providerId="ADAL" clId="{B0F2CD70-F772-4ABC-91C7-3B19E0DEB205}" dt="2023-11-12T19:23:14.902" v="1505" actId="1076"/>
          <ac:picMkLst>
            <pc:docMk/>
            <pc:sldMk cId="1934854818" sldId="262"/>
            <ac:picMk id="5" creationId="{E8209F31-4F50-6FCC-600A-481C7AF930DA}"/>
          </ac:picMkLst>
        </pc:picChg>
        <pc:picChg chg="mod">
          <ac:chgData name="Papaioannou, Ioannis" userId="27d0d6e0-1133-45d1-b366-9071ba1a55b0" providerId="ADAL" clId="{B0F2CD70-F772-4ABC-91C7-3B19E0DEB205}" dt="2023-11-12T19:23:14.902" v="1505" actId="1076"/>
          <ac:picMkLst>
            <pc:docMk/>
            <pc:sldMk cId="1934854818" sldId="262"/>
            <ac:picMk id="6" creationId="{C62F8E07-7152-E5A5-778A-674A9AFDDF88}"/>
          </ac:picMkLst>
        </pc:picChg>
        <pc:picChg chg="add del mod">
          <ac:chgData name="Papaioannou, Ioannis" userId="27d0d6e0-1133-45d1-b366-9071ba1a55b0" providerId="ADAL" clId="{B0F2CD70-F772-4ABC-91C7-3B19E0DEB205}" dt="2023-11-05T20:23:27.845" v="1024" actId="21"/>
          <ac:picMkLst>
            <pc:docMk/>
            <pc:sldMk cId="1934854818" sldId="262"/>
            <ac:picMk id="25" creationId="{A8C28913-78C7-942B-43EB-C14BEE8EFA5D}"/>
          </ac:picMkLst>
        </pc:picChg>
        <pc:picChg chg="add mod ord modCrop">
          <ac:chgData name="Papaioannou, Ioannis" userId="27d0d6e0-1133-45d1-b366-9071ba1a55b0" providerId="ADAL" clId="{B0F2CD70-F772-4ABC-91C7-3B19E0DEB205}" dt="2023-11-12T19:23:34.878" v="1507" actId="14100"/>
          <ac:picMkLst>
            <pc:docMk/>
            <pc:sldMk cId="1934854818" sldId="262"/>
            <ac:picMk id="26" creationId="{D0D198E2-F698-334A-3276-2E337BE69EE0}"/>
          </ac:picMkLst>
        </pc:picChg>
        <pc:picChg chg="add del mod">
          <ac:chgData name="Papaioannou, Ioannis" userId="27d0d6e0-1133-45d1-b366-9071ba1a55b0" providerId="ADAL" clId="{B0F2CD70-F772-4ABC-91C7-3B19E0DEB205}" dt="2023-11-05T20:23:39.309" v="1028" actId="21"/>
          <ac:picMkLst>
            <pc:docMk/>
            <pc:sldMk cId="1934854818" sldId="262"/>
            <ac:picMk id="31" creationId="{74CD5787-DC57-BE22-B732-B736701AD41E}"/>
          </ac:picMkLst>
        </pc:picChg>
        <pc:picChg chg="add del mod">
          <ac:chgData name="Papaioannou, Ioannis" userId="27d0d6e0-1133-45d1-b366-9071ba1a55b0" providerId="ADAL" clId="{B0F2CD70-F772-4ABC-91C7-3B19E0DEB205}" dt="2023-11-05T20:25:26.955" v="1035" actId="21"/>
          <ac:picMkLst>
            <pc:docMk/>
            <pc:sldMk cId="1934854818" sldId="262"/>
            <ac:picMk id="32" creationId="{36C7E502-59EB-672C-F9AD-49815CC8A406}"/>
          </ac:picMkLst>
        </pc:picChg>
        <pc:picChg chg="add del mod">
          <ac:chgData name="Papaioannou, Ioannis" userId="27d0d6e0-1133-45d1-b366-9071ba1a55b0" providerId="ADAL" clId="{B0F2CD70-F772-4ABC-91C7-3B19E0DEB205}" dt="2023-11-05T20:28:33.657" v="1043" actId="21"/>
          <ac:picMkLst>
            <pc:docMk/>
            <pc:sldMk cId="1934854818" sldId="262"/>
            <ac:picMk id="35" creationId="{F160F34A-7E85-182D-C823-A2774DEE2704}"/>
          </ac:picMkLst>
        </pc:picChg>
        <pc:picChg chg="add del mod">
          <ac:chgData name="Papaioannou, Ioannis" userId="27d0d6e0-1133-45d1-b366-9071ba1a55b0" providerId="ADAL" clId="{B0F2CD70-F772-4ABC-91C7-3B19E0DEB205}" dt="2023-11-05T20:29:35.209" v="1053" actId="21"/>
          <ac:picMkLst>
            <pc:docMk/>
            <pc:sldMk cId="1934854818" sldId="262"/>
            <ac:picMk id="38" creationId="{03538C75-DF58-E1AA-66E1-BA545A3F0738}"/>
          </ac:picMkLst>
        </pc:picChg>
        <pc:picChg chg="add del mod">
          <ac:chgData name="Papaioannou, Ioannis" userId="27d0d6e0-1133-45d1-b366-9071ba1a55b0" providerId="ADAL" clId="{B0F2CD70-F772-4ABC-91C7-3B19E0DEB205}" dt="2023-11-05T20:29:40.544" v="1055"/>
          <ac:picMkLst>
            <pc:docMk/>
            <pc:sldMk cId="1934854818" sldId="262"/>
            <ac:picMk id="41" creationId="{0DAEBCF2-9BF9-E5C4-A67F-0CD9D8CB859E}"/>
          </ac:picMkLst>
        </pc:picChg>
        <pc:picChg chg="add del mod">
          <ac:chgData name="Papaioannou, Ioannis" userId="27d0d6e0-1133-45d1-b366-9071ba1a55b0" providerId="ADAL" clId="{B0F2CD70-F772-4ABC-91C7-3B19E0DEB205}" dt="2023-11-05T20:34:35.480" v="1062" actId="21"/>
          <ac:picMkLst>
            <pc:docMk/>
            <pc:sldMk cId="1934854818" sldId="262"/>
            <ac:picMk id="42" creationId="{4E280DBB-B7C5-8040-5808-E117E750E2B8}"/>
          </ac:picMkLst>
        </pc:picChg>
        <pc:picChg chg="add del mod">
          <ac:chgData name="Papaioannou, Ioannis" userId="27d0d6e0-1133-45d1-b366-9071ba1a55b0" providerId="ADAL" clId="{B0F2CD70-F772-4ABC-91C7-3B19E0DEB205}" dt="2023-11-05T20:34:42.520" v="1065"/>
          <ac:picMkLst>
            <pc:docMk/>
            <pc:sldMk cId="1934854818" sldId="262"/>
            <ac:picMk id="45" creationId="{36536E5F-56A7-F2C2-1405-8AAE16461E1B}"/>
          </ac:picMkLst>
        </pc:picChg>
      </pc:sldChg>
      <pc:sldChg chg="addSp delSp modSp mod">
        <pc:chgData name="Papaioannou, Ioannis" userId="27d0d6e0-1133-45d1-b366-9071ba1a55b0" providerId="ADAL" clId="{B0F2CD70-F772-4ABC-91C7-3B19E0DEB205}" dt="2023-11-12T19:21:30.908" v="1492" actId="14100"/>
        <pc:sldMkLst>
          <pc:docMk/>
          <pc:sldMk cId="1358340535" sldId="263"/>
        </pc:sldMkLst>
        <pc:spChg chg="mod">
          <ac:chgData name="Papaioannou, Ioannis" userId="27d0d6e0-1133-45d1-b366-9071ba1a55b0" providerId="ADAL" clId="{B0F2CD70-F772-4ABC-91C7-3B19E0DEB205}" dt="2023-11-05T20:46:43.567" v="1128" actId="1076"/>
          <ac:spMkLst>
            <pc:docMk/>
            <pc:sldMk cId="1358340535" sldId="263"/>
            <ac:spMk id="27" creationId="{EFF7B304-0A2D-CFCD-508D-9C3298095EC2}"/>
          </ac:spMkLst>
        </pc:spChg>
        <pc:picChg chg="mod">
          <ac:chgData name="Papaioannou, Ioannis" userId="27d0d6e0-1133-45d1-b366-9071ba1a55b0" providerId="ADAL" clId="{B0F2CD70-F772-4ABC-91C7-3B19E0DEB205}" dt="2023-11-05T20:46:35.477" v="1127" actId="1076"/>
          <ac:picMkLst>
            <pc:docMk/>
            <pc:sldMk cId="1358340535" sldId="263"/>
            <ac:picMk id="12" creationId="{7E352516-7147-9605-6EB5-9088257FB0BA}"/>
          </ac:picMkLst>
        </pc:picChg>
        <pc:picChg chg="mod">
          <ac:chgData name="Papaioannou, Ioannis" userId="27d0d6e0-1133-45d1-b366-9071ba1a55b0" providerId="ADAL" clId="{B0F2CD70-F772-4ABC-91C7-3B19E0DEB205}" dt="2023-11-05T20:42:53.097" v="1095" actId="14100"/>
          <ac:picMkLst>
            <pc:docMk/>
            <pc:sldMk cId="1358340535" sldId="263"/>
            <ac:picMk id="13" creationId="{5E1EDE3B-B4BE-9D8F-E123-46F4192DC327}"/>
          </ac:picMkLst>
        </pc:picChg>
        <pc:picChg chg="del mod">
          <ac:chgData name="Papaioannou, Ioannis" userId="27d0d6e0-1133-45d1-b366-9071ba1a55b0" providerId="ADAL" clId="{B0F2CD70-F772-4ABC-91C7-3B19E0DEB205}" dt="2023-11-12T19:20:48.566" v="1484" actId="478"/>
          <ac:picMkLst>
            <pc:docMk/>
            <pc:sldMk cId="1358340535" sldId="263"/>
            <ac:picMk id="20" creationId="{58F00153-2B09-9F80-0277-A3362D1477E0}"/>
          </ac:picMkLst>
        </pc:picChg>
        <pc:picChg chg="add del mod">
          <ac:chgData name="Papaioannou, Ioannis" userId="27d0d6e0-1133-45d1-b366-9071ba1a55b0" providerId="ADAL" clId="{B0F2CD70-F772-4ABC-91C7-3B19E0DEB205}" dt="2023-11-12T19:20:45.981" v="1483" actId="478"/>
          <ac:picMkLst>
            <pc:docMk/>
            <pc:sldMk cId="1358340535" sldId="263"/>
            <ac:picMk id="30" creationId="{D6581717-4B57-95B2-BE8A-1C152000E594}"/>
          </ac:picMkLst>
        </pc:picChg>
        <pc:picChg chg="add mod modCrop">
          <ac:chgData name="Papaioannou, Ioannis" userId="27d0d6e0-1133-45d1-b366-9071ba1a55b0" providerId="ADAL" clId="{B0F2CD70-F772-4ABC-91C7-3B19E0DEB205}" dt="2023-11-12T19:21:30.908" v="1492" actId="14100"/>
          <ac:picMkLst>
            <pc:docMk/>
            <pc:sldMk cId="1358340535" sldId="263"/>
            <ac:picMk id="31" creationId="{50BECEA1-C418-70E9-84CC-FE58E670104C}"/>
          </ac:picMkLst>
        </pc:picChg>
        <pc:picChg chg="add del mod">
          <ac:chgData name="Papaioannou, Ioannis" userId="27d0d6e0-1133-45d1-b366-9071ba1a55b0" providerId="ADAL" clId="{B0F2CD70-F772-4ABC-91C7-3B19E0DEB205}" dt="2023-11-05T20:47:12.925" v="1131" actId="478"/>
          <ac:picMkLst>
            <pc:docMk/>
            <pc:sldMk cId="1358340535" sldId="263"/>
            <ac:picMk id="32" creationId="{483BD111-8DC3-3DF6-A461-8ABADE5BE170}"/>
          </ac:picMkLst>
        </pc:picChg>
        <pc:picChg chg="add del mod">
          <ac:chgData name="Papaioannou, Ioannis" userId="27d0d6e0-1133-45d1-b366-9071ba1a55b0" providerId="ADAL" clId="{B0F2CD70-F772-4ABC-91C7-3B19E0DEB205}" dt="2023-11-12T19:20:45.981" v="1483" actId="478"/>
          <ac:picMkLst>
            <pc:docMk/>
            <pc:sldMk cId="1358340535" sldId="263"/>
            <ac:picMk id="34" creationId="{BEEBC087-C856-3F03-E9FB-D51BBCC1A2A6}"/>
          </ac:picMkLst>
        </pc:picChg>
        <pc:picChg chg="add del mod">
          <ac:chgData name="Papaioannou, Ioannis" userId="27d0d6e0-1133-45d1-b366-9071ba1a55b0" providerId="ADAL" clId="{B0F2CD70-F772-4ABC-91C7-3B19E0DEB205}" dt="2023-11-12T19:20:45.981" v="1483" actId="478"/>
          <ac:picMkLst>
            <pc:docMk/>
            <pc:sldMk cId="1358340535" sldId="263"/>
            <ac:picMk id="36" creationId="{E8038BF4-48BA-8F96-5FB0-E4535BA6AD74}"/>
          </ac:picMkLst>
        </pc:picChg>
        <pc:picChg chg="add del mod">
          <ac:chgData name="Papaioannou, Ioannis" userId="27d0d6e0-1133-45d1-b366-9071ba1a55b0" providerId="ADAL" clId="{B0F2CD70-F772-4ABC-91C7-3B19E0DEB205}" dt="2023-11-12T19:20:45.981" v="1483" actId="478"/>
          <ac:picMkLst>
            <pc:docMk/>
            <pc:sldMk cId="1358340535" sldId="263"/>
            <ac:picMk id="38" creationId="{C7BA5518-ED89-A017-3286-F4CF98061B93}"/>
          </ac:picMkLst>
        </pc:picChg>
        <pc:picChg chg="add del mod">
          <ac:chgData name="Papaioannou, Ioannis" userId="27d0d6e0-1133-45d1-b366-9071ba1a55b0" providerId="ADAL" clId="{B0F2CD70-F772-4ABC-91C7-3B19E0DEB205}" dt="2023-11-12T19:20:45.981" v="1483" actId="478"/>
          <ac:picMkLst>
            <pc:docMk/>
            <pc:sldMk cId="1358340535" sldId="263"/>
            <ac:picMk id="40" creationId="{64CF8C22-DCF5-D89E-EF01-79F8092CE9D3}"/>
          </ac:picMkLst>
        </pc:picChg>
      </pc:sldChg>
      <pc:sldChg chg="addSp delSp modSp mod delCm">
        <pc:chgData name="Papaioannou, Ioannis" userId="27d0d6e0-1133-45d1-b366-9071ba1a55b0" providerId="ADAL" clId="{B0F2CD70-F772-4ABC-91C7-3B19E0DEB205}" dt="2023-12-07T19:55:21.468" v="1757" actId="1076"/>
        <pc:sldMkLst>
          <pc:docMk/>
          <pc:sldMk cId="1608280500" sldId="266"/>
        </pc:sldMkLst>
        <pc:spChg chg="mod">
          <ac:chgData name="Papaioannou, Ioannis" userId="27d0d6e0-1133-45d1-b366-9071ba1a55b0" providerId="ADAL" clId="{B0F2CD70-F772-4ABC-91C7-3B19E0DEB205}" dt="2023-11-05T12:58:17.697" v="112" actId="1076"/>
          <ac:spMkLst>
            <pc:docMk/>
            <pc:sldMk cId="1608280500" sldId="266"/>
            <ac:spMk id="2" creationId="{2CFB1818-7644-9C0A-C683-FC531EAD7EAE}"/>
          </ac:spMkLst>
        </pc:spChg>
        <pc:spChg chg="mod topLvl">
          <ac:chgData name="Papaioannou, Ioannis" userId="27d0d6e0-1133-45d1-b366-9071ba1a55b0" providerId="ADAL" clId="{B0F2CD70-F772-4ABC-91C7-3B19E0DEB205}" dt="2023-11-05T14:33:54.215" v="243" actId="338"/>
          <ac:spMkLst>
            <pc:docMk/>
            <pc:sldMk cId="1608280500" sldId="266"/>
            <ac:spMk id="16" creationId="{873B2975-1D40-46FD-9CE0-15354C4A95CD}"/>
          </ac:spMkLst>
        </pc:spChg>
        <pc:spChg chg="mod topLvl">
          <ac:chgData name="Papaioannou, Ioannis" userId="27d0d6e0-1133-45d1-b366-9071ba1a55b0" providerId="ADAL" clId="{B0F2CD70-F772-4ABC-91C7-3B19E0DEB205}" dt="2023-11-05T14:33:54.215" v="243" actId="338"/>
          <ac:spMkLst>
            <pc:docMk/>
            <pc:sldMk cId="1608280500" sldId="266"/>
            <ac:spMk id="27" creationId="{8975D728-983D-84AE-8C9C-6B612D0564CD}"/>
          </ac:spMkLst>
        </pc:spChg>
        <pc:spChg chg="mod topLvl">
          <ac:chgData name="Papaioannou, Ioannis" userId="27d0d6e0-1133-45d1-b366-9071ba1a55b0" providerId="ADAL" clId="{B0F2CD70-F772-4ABC-91C7-3B19E0DEB205}" dt="2023-11-05T14:33:54.215" v="243" actId="338"/>
          <ac:spMkLst>
            <pc:docMk/>
            <pc:sldMk cId="1608280500" sldId="266"/>
            <ac:spMk id="28" creationId="{17635A0E-AECB-0D0A-F425-E68598F80F76}"/>
          </ac:spMkLst>
        </pc:spChg>
        <pc:spChg chg="mod topLvl">
          <ac:chgData name="Papaioannou, Ioannis" userId="27d0d6e0-1133-45d1-b366-9071ba1a55b0" providerId="ADAL" clId="{B0F2CD70-F772-4ABC-91C7-3B19E0DEB205}" dt="2023-11-05T14:33:54.215" v="243" actId="338"/>
          <ac:spMkLst>
            <pc:docMk/>
            <pc:sldMk cId="1608280500" sldId="266"/>
            <ac:spMk id="31" creationId="{CDDC0619-31D8-4D38-870F-7830F9EF1C73}"/>
          </ac:spMkLst>
        </pc:spChg>
        <pc:spChg chg="mod topLvl">
          <ac:chgData name="Papaioannou, Ioannis" userId="27d0d6e0-1133-45d1-b366-9071ba1a55b0" providerId="ADAL" clId="{B0F2CD70-F772-4ABC-91C7-3B19E0DEB205}" dt="2023-11-05T14:33:54.215" v="243" actId="338"/>
          <ac:spMkLst>
            <pc:docMk/>
            <pc:sldMk cId="1608280500" sldId="266"/>
            <ac:spMk id="39" creationId="{BE13C9D3-04B7-53B3-4CEE-DAFCBB3339F0}"/>
          </ac:spMkLst>
        </pc:spChg>
        <pc:spChg chg="mod topLvl">
          <ac:chgData name="Papaioannou, Ioannis" userId="27d0d6e0-1133-45d1-b366-9071ba1a55b0" providerId="ADAL" clId="{B0F2CD70-F772-4ABC-91C7-3B19E0DEB205}" dt="2023-11-05T14:33:54.215" v="243" actId="338"/>
          <ac:spMkLst>
            <pc:docMk/>
            <pc:sldMk cId="1608280500" sldId="266"/>
            <ac:spMk id="46" creationId="{BADB01C4-4CF4-4714-8097-E9D6936103D5}"/>
          </ac:spMkLst>
        </pc:spChg>
        <pc:spChg chg="mod topLvl">
          <ac:chgData name="Papaioannou, Ioannis" userId="27d0d6e0-1133-45d1-b366-9071ba1a55b0" providerId="ADAL" clId="{B0F2CD70-F772-4ABC-91C7-3B19E0DEB205}" dt="2023-11-05T14:33:54.215" v="243" actId="338"/>
          <ac:spMkLst>
            <pc:docMk/>
            <pc:sldMk cId="1608280500" sldId="266"/>
            <ac:spMk id="47" creationId="{F72E833C-86C3-489C-BDC9-7A152FAE814C}"/>
          </ac:spMkLst>
        </pc:spChg>
        <pc:grpChg chg="del">
          <ac:chgData name="Papaioannou, Ioannis" userId="27d0d6e0-1133-45d1-b366-9071ba1a55b0" providerId="ADAL" clId="{B0F2CD70-F772-4ABC-91C7-3B19E0DEB205}" dt="2023-11-05T14:20:10.190" v="155" actId="165"/>
          <ac:grpSpMkLst>
            <pc:docMk/>
            <pc:sldMk cId="1608280500" sldId="266"/>
            <ac:grpSpMk id="4" creationId="{E67A7FD9-5196-8990-370E-A8E13657C19D}"/>
          </ac:grpSpMkLst>
        </pc:grpChg>
        <pc:grpChg chg="del">
          <ac:chgData name="Papaioannou, Ioannis" userId="27d0d6e0-1133-45d1-b366-9071ba1a55b0" providerId="ADAL" clId="{B0F2CD70-F772-4ABC-91C7-3B19E0DEB205}" dt="2023-11-05T13:25:14.656" v="154" actId="165"/>
          <ac:grpSpMkLst>
            <pc:docMk/>
            <pc:sldMk cId="1608280500" sldId="266"/>
            <ac:grpSpMk id="9" creationId="{83E97E85-7B2B-08E6-3B24-DBFA2249915C}"/>
          </ac:grpSpMkLst>
        </pc:grpChg>
        <pc:grpChg chg="add del mod">
          <ac:chgData name="Papaioannou, Ioannis" userId="27d0d6e0-1133-45d1-b366-9071ba1a55b0" providerId="ADAL" clId="{B0F2CD70-F772-4ABC-91C7-3B19E0DEB205}" dt="2023-12-07T19:55:12.537" v="1752" actId="478"/>
          <ac:grpSpMkLst>
            <pc:docMk/>
            <pc:sldMk cId="1608280500" sldId="266"/>
            <ac:grpSpMk id="1027" creationId="{AFF5D408-0433-133C-6FE2-CBB43E89172D}"/>
          </ac:grpSpMkLst>
        </pc:grpChg>
        <pc:grpChg chg="add mod">
          <ac:chgData name="Papaioannou, Ioannis" userId="27d0d6e0-1133-45d1-b366-9071ba1a55b0" providerId="ADAL" clId="{B0F2CD70-F772-4ABC-91C7-3B19E0DEB205}" dt="2023-11-05T15:25:02.071" v="254" actId="1366"/>
          <ac:grpSpMkLst>
            <pc:docMk/>
            <pc:sldMk cId="1608280500" sldId="266"/>
            <ac:grpSpMk id="1028" creationId="{76A19AE7-EDA3-7032-CBC5-51EBF99507AF}"/>
          </ac:grpSpMkLst>
        </pc:grpChg>
        <pc:grpChg chg="add mod">
          <ac:chgData name="Papaioannou, Ioannis" userId="27d0d6e0-1133-45d1-b366-9071ba1a55b0" providerId="ADAL" clId="{B0F2CD70-F772-4ABC-91C7-3B19E0DEB205}" dt="2023-11-05T15:25:02.071" v="254" actId="1366"/>
          <ac:grpSpMkLst>
            <pc:docMk/>
            <pc:sldMk cId="1608280500" sldId="266"/>
            <ac:grpSpMk id="1029" creationId="{887FA069-6ED9-D1BE-BDD8-2EA9A37F7A12}"/>
          </ac:grpSpMkLst>
        </pc:grpChg>
        <pc:picChg chg="mod">
          <ac:chgData name="Papaioannou, Ioannis" userId="27d0d6e0-1133-45d1-b366-9071ba1a55b0" providerId="ADAL" clId="{B0F2CD70-F772-4ABC-91C7-3B19E0DEB205}" dt="2023-11-05T15:25:02.071" v="254" actId="1366"/>
          <ac:picMkLst>
            <pc:docMk/>
            <pc:sldMk cId="1608280500" sldId="266"/>
            <ac:picMk id="3" creationId="{EECBE821-42A0-4D15-AEE9-5823945E5703}"/>
          </ac:picMkLst>
        </pc:picChg>
        <pc:picChg chg="add mod">
          <ac:chgData name="Papaioannou, Ioannis" userId="27d0d6e0-1133-45d1-b366-9071ba1a55b0" providerId="ADAL" clId="{B0F2CD70-F772-4ABC-91C7-3B19E0DEB205}" dt="2023-12-07T19:55:21.468" v="1757" actId="1076"/>
          <ac:picMkLst>
            <pc:docMk/>
            <pc:sldMk cId="1608280500" sldId="266"/>
            <ac:picMk id="5" creationId="{0D564AD1-B804-0E7A-A4C2-7961CDF80E68}"/>
          </ac:picMkLst>
        </pc:picChg>
        <pc:picChg chg="add del mod">
          <ac:chgData name="Papaioannou, Ioannis" userId="27d0d6e0-1133-45d1-b366-9071ba1a55b0" providerId="ADAL" clId="{B0F2CD70-F772-4ABC-91C7-3B19E0DEB205}" dt="2023-11-05T12:50:35.707" v="59" actId="478"/>
          <ac:picMkLst>
            <pc:docMk/>
            <pc:sldMk cId="1608280500" sldId="266"/>
            <ac:picMk id="13" creationId="{270F5B49-DD8E-084E-0A30-5DF7D764C007}"/>
          </ac:picMkLst>
        </pc:picChg>
        <pc:picChg chg="mod">
          <ac:chgData name="Papaioannou, Ioannis" userId="27d0d6e0-1133-45d1-b366-9071ba1a55b0" providerId="ADAL" clId="{B0F2CD70-F772-4ABC-91C7-3B19E0DEB205}" dt="2023-11-05T15:25:02.071" v="254" actId="1366"/>
          <ac:picMkLst>
            <pc:docMk/>
            <pc:sldMk cId="1608280500" sldId="266"/>
            <ac:picMk id="24" creationId="{1E9E8DBC-A4F2-4DA5-9BD5-9AAE89F524C2}"/>
          </ac:picMkLst>
        </pc:picChg>
        <pc:picChg chg="del">
          <ac:chgData name="Papaioannou, Ioannis" userId="27d0d6e0-1133-45d1-b366-9071ba1a55b0" providerId="ADAL" clId="{B0F2CD70-F772-4ABC-91C7-3B19E0DEB205}" dt="2023-11-05T12:54:23.648" v="85" actId="478"/>
          <ac:picMkLst>
            <pc:docMk/>
            <pc:sldMk cId="1608280500" sldId="266"/>
            <ac:picMk id="29" creationId="{3AA77BD3-EBAE-720E-A7F7-AC62647F43CA}"/>
          </ac:picMkLst>
        </pc:picChg>
        <pc:picChg chg="mod">
          <ac:chgData name="Papaioannou, Ioannis" userId="27d0d6e0-1133-45d1-b366-9071ba1a55b0" providerId="ADAL" clId="{B0F2CD70-F772-4ABC-91C7-3B19E0DEB205}" dt="2023-11-05T15:25:02.071" v="254" actId="1366"/>
          <ac:picMkLst>
            <pc:docMk/>
            <pc:sldMk cId="1608280500" sldId="266"/>
            <ac:picMk id="32" creationId="{FAE965A1-1B85-43DE-A23E-3B0679AE1F55}"/>
          </ac:picMkLst>
        </pc:picChg>
        <pc:picChg chg="mod topLvl">
          <ac:chgData name="Papaioannou, Ioannis" userId="27d0d6e0-1133-45d1-b366-9071ba1a55b0" providerId="ADAL" clId="{B0F2CD70-F772-4ABC-91C7-3B19E0DEB205}" dt="2023-11-05T14:33:54.215" v="243" actId="338"/>
          <ac:picMkLst>
            <pc:docMk/>
            <pc:sldMk cId="1608280500" sldId="266"/>
            <ac:picMk id="33" creationId="{B07659F6-FF64-4375-8FD6-198FB2863040}"/>
          </ac:picMkLst>
        </pc:picChg>
        <pc:picChg chg="add del mod">
          <ac:chgData name="Papaioannou, Ioannis" userId="27d0d6e0-1133-45d1-b366-9071ba1a55b0" providerId="ADAL" clId="{B0F2CD70-F772-4ABC-91C7-3B19E0DEB205}" dt="2023-11-05T12:51:47.469" v="62" actId="478"/>
          <ac:picMkLst>
            <pc:docMk/>
            <pc:sldMk cId="1608280500" sldId="266"/>
            <ac:picMk id="34" creationId="{3AEC67DB-4DC5-1723-0E8A-8A9D0D0E4758}"/>
          </ac:picMkLst>
        </pc:picChg>
        <pc:picChg chg="add mod modCrop">
          <ac:chgData name="Papaioannou, Ioannis" userId="27d0d6e0-1133-45d1-b366-9071ba1a55b0" providerId="ADAL" clId="{B0F2CD70-F772-4ABC-91C7-3B19E0DEB205}" dt="2023-11-05T14:28:18.546" v="242" actId="164"/>
          <ac:picMkLst>
            <pc:docMk/>
            <pc:sldMk cId="1608280500" sldId="266"/>
            <ac:picMk id="36" creationId="{E31163A5-9519-7D95-40B0-A5CD5C67BCD9}"/>
          </ac:picMkLst>
        </pc:picChg>
        <pc:picChg chg="mod">
          <ac:chgData name="Papaioannou, Ioannis" userId="27d0d6e0-1133-45d1-b366-9071ba1a55b0" providerId="ADAL" clId="{B0F2CD70-F772-4ABC-91C7-3B19E0DEB205}" dt="2023-11-05T15:25:02.071" v="254" actId="1366"/>
          <ac:picMkLst>
            <pc:docMk/>
            <pc:sldMk cId="1608280500" sldId="266"/>
            <ac:picMk id="37" creationId="{2678878C-093B-4281-8024-C437A8EADE05}"/>
          </ac:picMkLst>
        </pc:picChg>
        <pc:picChg chg="mod">
          <ac:chgData name="Papaioannou, Ioannis" userId="27d0d6e0-1133-45d1-b366-9071ba1a55b0" providerId="ADAL" clId="{B0F2CD70-F772-4ABC-91C7-3B19E0DEB205}" dt="2023-11-05T15:25:02.071" v="254" actId="1366"/>
          <ac:picMkLst>
            <pc:docMk/>
            <pc:sldMk cId="1608280500" sldId="266"/>
            <ac:picMk id="42" creationId="{9E490237-8AF9-4A76-9CAA-AB9EB66D86D8}"/>
          </ac:picMkLst>
        </pc:picChg>
        <pc:picChg chg="mod topLvl">
          <ac:chgData name="Papaioannou, Ioannis" userId="27d0d6e0-1133-45d1-b366-9071ba1a55b0" providerId="ADAL" clId="{B0F2CD70-F772-4ABC-91C7-3B19E0DEB205}" dt="2023-11-05T14:33:54.215" v="243" actId="338"/>
          <ac:picMkLst>
            <pc:docMk/>
            <pc:sldMk cId="1608280500" sldId="266"/>
            <ac:picMk id="45" creationId="{E0312B37-C2FD-4B98-A5D7-BF52343D4EEA}"/>
          </ac:picMkLst>
        </pc:picChg>
        <pc:picChg chg="add mod modCrop">
          <ac:chgData name="Papaioannou, Ioannis" userId="27d0d6e0-1133-45d1-b366-9071ba1a55b0" providerId="ADAL" clId="{B0F2CD70-F772-4ABC-91C7-3B19E0DEB205}" dt="2023-11-05T14:28:18.546" v="242" actId="164"/>
          <ac:picMkLst>
            <pc:docMk/>
            <pc:sldMk cId="1608280500" sldId="266"/>
            <ac:picMk id="48" creationId="{E37CF769-D615-6D83-3685-963CBDF0FC12}"/>
          </ac:picMkLst>
        </pc:picChg>
        <pc:picChg chg="add mod modCrop">
          <ac:chgData name="Papaioannou, Ioannis" userId="27d0d6e0-1133-45d1-b366-9071ba1a55b0" providerId="ADAL" clId="{B0F2CD70-F772-4ABC-91C7-3B19E0DEB205}" dt="2023-11-05T14:28:18.546" v="242" actId="164"/>
          <ac:picMkLst>
            <pc:docMk/>
            <pc:sldMk cId="1608280500" sldId="266"/>
            <ac:picMk id="50" creationId="{51629AF0-CDBE-D573-285B-258BDE5E1F42}"/>
          </ac:picMkLst>
        </pc:picChg>
        <pc:picChg chg="add del mod modCrop">
          <ac:chgData name="Papaioannou, Ioannis" userId="27d0d6e0-1133-45d1-b366-9071ba1a55b0" providerId="ADAL" clId="{B0F2CD70-F772-4ABC-91C7-3B19E0DEB205}" dt="2023-11-05T13:21:15.678" v="131" actId="478"/>
          <ac:picMkLst>
            <pc:docMk/>
            <pc:sldMk cId="1608280500" sldId="266"/>
            <ac:picMk id="52" creationId="{7C7232AC-27A1-B3AC-90D2-04D3A3E2FBF7}"/>
          </ac:picMkLst>
        </pc:picChg>
        <pc:picChg chg="add mod">
          <ac:chgData name="Papaioannou, Ioannis" userId="27d0d6e0-1133-45d1-b366-9071ba1a55b0" providerId="ADAL" clId="{B0F2CD70-F772-4ABC-91C7-3B19E0DEB205}" dt="2023-11-05T14:28:18.546" v="242" actId="164"/>
          <ac:picMkLst>
            <pc:docMk/>
            <pc:sldMk cId="1608280500" sldId="266"/>
            <ac:picMk id="53" creationId="{64B8B9AF-7BF4-3EBB-3BA8-C6CA1F93C5E8}"/>
          </ac:picMkLst>
        </pc:picChg>
        <pc:picChg chg="add del">
          <ac:chgData name="Papaioannou, Ioannis" userId="27d0d6e0-1133-45d1-b366-9071ba1a55b0" providerId="ADAL" clId="{B0F2CD70-F772-4ABC-91C7-3B19E0DEB205}" dt="2023-11-05T13:24:02.868" v="149" actId="22"/>
          <ac:picMkLst>
            <pc:docMk/>
            <pc:sldMk cId="1608280500" sldId="266"/>
            <ac:picMk id="55" creationId="{3D3CA39C-E482-CDED-E829-173A6BAABF22}"/>
          </ac:picMkLst>
        </pc:picChg>
        <pc:picChg chg="add mod">
          <ac:chgData name="Papaioannou, Ioannis" userId="27d0d6e0-1133-45d1-b366-9071ba1a55b0" providerId="ADAL" clId="{B0F2CD70-F772-4ABC-91C7-3B19E0DEB205}" dt="2023-11-05T14:28:18.546" v="242" actId="164"/>
          <ac:picMkLst>
            <pc:docMk/>
            <pc:sldMk cId="1608280500" sldId="266"/>
            <ac:picMk id="57" creationId="{A7A745A8-1444-E599-1A8E-A72256E19758}"/>
          </ac:picMkLst>
        </pc:picChg>
        <pc:picChg chg="add mod">
          <ac:chgData name="Papaioannou, Ioannis" userId="27d0d6e0-1133-45d1-b366-9071ba1a55b0" providerId="ADAL" clId="{B0F2CD70-F772-4ABC-91C7-3B19E0DEB205}" dt="2023-11-05T14:28:18.546" v="242" actId="164"/>
          <ac:picMkLst>
            <pc:docMk/>
            <pc:sldMk cId="1608280500" sldId="266"/>
            <ac:picMk id="59" creationId="{D9ED96F0-1039-1E99-AB3D-7A1DC4CFC996}"/>
          </ac:picMkLst>
        </pc:picChg>
        <pc:picChg chg="add mod modCrop">
          <ac:chgData name="Papaioannou, Ioannis" userId="27d0d6e0-1133-45d1-b366-9071ba1a55b0" providerId="ADAL" clId="{B0F2CD70-F772-4ABC-91C7-3B19E0DEB205}" dt="2023-11-05T14:28:18.546" v="242" actId="164"/>
          <ac:picMkLst>
            <pc:docMk/>
            <pc:sldMk cId="1608280500" sldId="266"/>
            <ac:picMk id="61" creationId="{8B0333BD-601B-B191-6E18-92E53F3DBECE}"/>
          </ac:picMkLst>
        </pc:picChg>
        <pc:picChg chg="add del">
          <ac:chgData name="Papaioannou, Ioannis" userId="27d0d6e0-1133-45d1-b366-9071ba1a55b0" providerId="ADAL" clId="{B0F2CD70-F772-4ABC-91C7-3B19E0DEB205}" dt="2023-11-05T14:21:04.153" v="159" actId="478"/>
          <ac:picMkLst>
            <pc:docMk/>
            <pc:sldMk cId="1608280500" sldId="266"/>
            <ac:picMk id="63" creationId="{8DBCFD3F-9FDE-BC22-541B-43E617B4544B}"/>
          </ac:picMkLst>
        </pc:picChg>
        <pc:picChg chg="add mod modCrop">
          <ac:chgData name="Papaioannou, Ioannis" userId="27d0d6e0-1133-45d1-b366-9071ba1a55b0" providerId="ADAL" clId="{B0F2CD70-F772-4ABC-91C7-3B19E0DEB205}" dt="2023-11-05T14:28:18.546" v="242" actId="164"/>
          <ac:picMkLst>
            <pc:docMk/>
            <pc:sldMk cId="1608280500" sldId="266"/>
            <ac:picMk id="1025" creationId="{229078BD-A274-FDE3-F0B0-7E5B565FCBF3}"/>
          </ac:picMkLst>
        </pc:picChg>
        <pc:picChg chg="mod">
          <ac:chgData name="Papaioannou, Ioannis" userId="27d0d6e0-1133-45d1-b366-9071ba1a55b0" providerId="ADAL" clId="{B0F2CD70-F772-4ABC-91C7-3B19E0DEB205}" dt="2023-11-05T15:25:02.071" v="254" actId="1366"/>
          <ac:picMkLst>
            <pc:docMk/>
            <pc:sldMk cId="1608280500" sldId="266"/>
            <ac:picMk id="1026" creationId="{CE65153C-EA72-4A11-400E-5F664454D3C5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Papaioannou, Ioannis" userId="27d0d6e0-1133-45d1-b366-9071ba1a55b0" providerId="ADAL" clId="{B0F2CD70-F772-4ABC-91C7-3B19E0DEB205}" dt="2023-12-07T19:53:16.578" v="1751"/>
              <pc2:cmMkLst xmlns:pc2="http://schemas.microsoft.com/office/powerpoint/2019/9/main/command">
                <pc:docMk/>
                <pc:sldMk cId="1608280500" sldId="266"/>
                <pc2:cmMk id="{E2BE4A36-66FB-45CA-82A4-98B4AC064538}"/>
              </pc2:cmMkLst>
            </pc226:cmChg>
          </p:ext>
        </pc:extLst>
      </pc:sldChg>
      <pc:sldChg chg="addSp delSp modSp mod">
        <pc:chgData name="Papaioannou, Ioannis" userId="27d0d6e0-1133-45d1-b366-9071ba1a55b0" providerId="ADAL" clId="{B0F2CD70-F772-4ABC-91C7-3B19E0DEB205}" dt="2023-11-12T19:25:48.088" v="1538" actId="1076"/>
        <pc:sldMkLst>
          <pc:docMk/>
          <pc:sldMk cId="4106415198" sldId="267"/>
        </pc:sldMkLst>
        <pc:spChg chg="mod">
          <ac:chgData name="Papaioannou, Ioannis" userId="27d0d6e0-1133-45d1-b366-9071ba1a55b0" providerId="ADAL" clId="{B0F2CD70-F772-4ABC-91C7-3B19E0DEB205}" dt="2023-11-12T19:25:48.088" v="1538" actId="1076"/>
          <ac:spMkLst>
            <pc:docMk/>
            <pc:sldMk cId="4106415198" sldId="267"/>
            <ac:spMk id="4" creationId="{885793FE-48AB-CB3C-B706-1B1E6CAC35D9}"/>
          </ac:spMkLst>
        </pc:spChg>
        <pc:spChg chg="mod">
          <ac:chgData name="Papaioannou, Ioannis" userId="27d0d6e0-1133-45d1-b366-9071ba1a55b0" providerId="ADAL" clId="{B0F2CD70-F772-4ABC-91C7-3B19E0DEB205}" dt="2023-11-12T19:24:55.842" v="1517" actId="1076"/>
          <ac:spMkLst>
            <pc:docMk/>
            <pc:sldMk cId="4106415198" sldId="267"/>
            <ac:spMk id="11" creationId="{4431568B-B19C-A308-88DE-DFEC6F21F1FB}"/>
          </ac:spMkLst>
        </pc:spChg>
        <pc:spChg chg="mod">
          <ac:chgData name="Papaioannou, Ioannis" userId="27d0d6e0-1133-45d1-b366-9071ba1a55b0" providerId="ADAL" clId="{B0F2CD70-F772-4ABC-91C7-3B19E0DEB205}" dt="2023-11-12T19:25:39.655" v="1536" actId="1076"/>
          <ac:spMkLst>
            <pc:docMk/>
            <pc:sldMk cId="4106415198" sldId="267"/>
            <ac:spMk id="15" creationId="{56EA631A-1912-382C-A628-D04380C8C308}"/>
          </ac:spMkLst>
        </pc:spChg>
        <pc:spChg chg="mod">
          <ac:chgData name="Papaioannou, Ioannis" userId="27d0d6e0-1133-45d1-b366-9071ba1a55b0" providerId="ADAL" clId="{B0F2CD70-F772-4ABC-91C7-3B19E0DEB205}" dt="2023-11-12T19:25:39.655" v="1536" actId="1076"/>
          <ac:spMkLst>
            <pc:docMk/>
            <pc:sldMk cId="4106415198" sldId="267"/>
            <ac:spMk id="16" creationId="{0DE1D657-AAD9-E8E8-ADFE-A373B3D91CD7}"/>
          </ac:spMkLst>
        </pc:spChg>
        <pc:picChg chg="mod">
          <ac:chgData name="Papaioannou, Ioannis" userId="27d0d6e0-1133-45d1-b366-9071ba1a55b0" providerId="ADAL" clId="{B0F2CD70-F772-4ABC-91C7-3B19E0DEB205}" dt="2023-11-12T19:25:31.947" v="1530" actId="1076"/>
          <ac:picMkLst>
            <pc:docMk/>
            <pc:sldMk cId="4106415198" sldId="267"/>
            <ac:picMk id="3" creationId="{F4F8A386-C9FB-167A-A4A8-1DCDB752834B}"/>
          </ac:picMkLst>
        </pc:picChg>
        <pc:picChg chg="add del mod modCrop">
          <ac:chgData name="Papaioannou, Ioannis" userId="27d0d6e0-1133-45d1-b366-9071ba1a55b0" providerId="ADAL" clId="{B0F2CD70-F772-4ABC-91C7-3B19E0DEB205}" dt="2023-11-12T19:24:34.594" v="1511" actId="21"/>
          <ac:picMkLst>
            <pc:docMk/>
            <pc:sldMk cId="4106415198" sldId="267"/>
            <ac:picMk id="5" creationId="{1018D959-0800-5A44-E6BA-15D811F8D141}"/>
          </ac:picMkLst>
        </pc:picChg>
        <pc:picChg chg="mod">
          <ac:chgData name="Papaioannou, Ioannis" userId="27d0d6e0-1133-45d1-b366-9071ba1a55b0" providerId="ADAL" clId="{B0F2CD70-F772-4ABC-91C7-3B19E0DEB205}" dt="2023-11-12T19:24:55.842" v="1517" actId="1076"/>
          <ac:picMkLst>
            <pc:docMk/>
            <pc:sldMk cId="4106415198" sldId="267"/>
            <ac:picMk id="6" creationId="{A6A80319-A7D0-7F6C-3331-9BA721EAF4BA}"/>
          </ac:picMkLst>
        </pc:picChg>
        <pc:picChg chg="add mod modCrop">
          <ac:chgData name="Papaioannou, Ioannis" userId="27d0d6e0-1133-45d1-b366-9071ba1a55b0" providerId="ADAL" clId="{B0F2CD70-F772-4ABC-91C7-3B19E0DEB205}" dt="2023-11-12T19:25:43.269" v="1537" actId="1076"/>
          <ac:picMkLst>
            <pc:docMk/>
            <pc:sldMk cId="4106415198" sldId="267"/>
            <ac:picMk id="7" creationId="{AB2D5722-3EBD-9101-2848-15054041EA5F}"/>
          </ac:picMkLst>
        </pc:picChg>
        <pc:picChg chg="del">
          <ac:chgData name="Papaioannou, Ioannis" userId="27d0d6e0-1133-45d1-b366-9071ba1a55b0" providerId="ADAL" clId="{B0F2CD70-F772-4ABC-91C7-3B19E0DEB205}" dt="2023-11-12T19:24:27.655" v="1509" actId="478"/>
          <ac:picMkLst>
            <pc:docMk/>
            <pc:sldMk cId="4106415198" sldId="267"/>
            <ac:picMk id="8" creationId="{B100EB6E-198A-7A0D-68FC-8440603A7C6B}"/>
          </ac:picMkLst>
        </pc:picChg>
        <pc:picChg chg="add del mod">
          <ac:chgData name="Papaioannou, Ioannis" userId="27d0d6e0-1133-45d1-b366-9071ba1a55b0" providerId="ADAL" clId="{B0F2CD70-F772-4ABC-91C7-3B19E0DEB205}" dt="2023-11-05T16:24:03.262" v="511" actId="478"/>
          <ac:picMkLst>
            <pc:docMk/>
            <pc:sldMk cId="4106415198" sldId="267"/>
            <ac:picMk id="12" creationId="{AE5B569E-5222-D7F4-CF42-916989DBAE2F}"/>
          </ac:picMkLst>
        </pc:picChg>
        <pc:picChg chg="add del mod">
          <ac:chgData name="Papaioannou, Ioannis" userId="27d0d6e0-1133-45d1-b366-9071ba1a55b0" providerId="ADAL" clId="{B0F2CD70-F772-4ABC-91C7-3B19E0DEB205}" dt="2023-11-12T19:24:34.594" v="1511" actId="21"/>
          <ac:picMkLst>
            <pc:docMk/>
            <pc:sldMk cId="4106415198" sldId="267"/>
            <ac:picMk id="19" creationId="{00E89A01-E84B-F217-048A-482C5A93350F}"/>
          </ac:picMkLst>
        </pc:picChg>
      </pc:sldChg>
      <pc:sldChg chg="addSp delSp modSp mod">
        <pc:chgData name="Papaioannou, Ioannis" userId="27d0d6e0-1133-45d1-b366-9071ba1a55b0" providerId="ADAL" clId="{B0F2CD70-F772-4ABC-91C7-3B19E0DEB205}" dt="2023-11-12T17:12:21.756" v="1212" actId="1076"/>
        <pc:sldMkLst>
          <pc:docMk/>
          <pc:sldMk cId="3210901459" sldId="268"/>
        </pc:sldMkLst>
        <pc:picChg chg="add del mod">
          <ac:chgData name="Papaioannou, Ioannis" userId="27d0d6e0-1133-45d1-b366-9071ba1a55b0" providerId="ADAL" clId="{B0F2CD70-F772-4ABC-91C7-3B19E0DEB205}" dt="2023-11-12T17:11:24.562" v="1209" actId="21"/>
          <ac:picMkLst>
            <pc:docMk/>
            <pc:sldMk cId="3210901459" sldId="268"/>
            <ac:picMk id="3" creationId="{95B604BB-20C4-EEC9-467D-CB44D5D2C3C6}"/>
          </ac:picMkLst>
        </pc:picChg>
        <pc:picChg chg="add mod">
          <ac:chgData name="Papaioannou, Ioannis" userId="27d0d6e0-1133-45d1-b366-9071ba1a55b0" providerId="ADAL" clId="{B0F2CD70-F772-4ABC-91C7-3B19E0DEB205}" dt="2023-11-12T17:12:21.756" v="1212" actId="1076"/>
          <ac:picMkLst>
            <pc:docMk/>
            <pc:sldMk cId="3210901459" sldId="268"/>
            <ac:picMk id="4" creationId="{398E1E4D-8B1D-F222-0473-23C9124ECCBD}"/>
          </ac:picMkLst>
        </pc:picChg>
        <pc:picChg chg="del">
          <ac:chgData name="Papaioannou, Ioannis" userId="27d0d6e0-1133-45d1-b366-9071ba1a55b0" providerId="ADAL" clId="{B0F2CD70-F772-4ABC-91C7-3B19E0DEB205}" dt="2023-11-12T17:12:19.215" v="1210" actId="478"/>
          <ac:picMkLst>
            <pc:docMk/>
            <pc:sldMk cId="3210901459" sldId="268"/>
            <ac:picMk id="5" creationId="{53D6B088-3784-C6E1-CC6D-34F8CE84434E}"/>
          </ac:picMkLst>
        </pc:picChg>
        <pc:picChg chg="add del mod">
          <ac:chgData name="Papaioannou, Ioannis" userId="27d0d6e0-1133-45d1-b366-9071ba1a55b0" providerId="ADAL" clId="{B0F2CD70-F772-4ABC-91C7-3B19E0DEB205}" dt="2023-11-12T17:11:24.562" v="1209" actId="21"/>
          <ac:picMkLst>
            <pc:docMk/>
            <pc:sldMk cId="3210901459" sldId="268"/>
            <ac:picMk id="7" creationId="{BE3F11A3-A0B5-3ACD-94E3-8E9E8818C635}"/>
          </ac:picMkLst>
        </pc:picChg>
        <pc:picChg chg="add del mod">
          <ac:chgData name="Papaioannou, Ioannis" userId="27d0d6e0-1133-45d1-b366-9071ba1a55b0" providerId="ADAL" clId="{B0F2CD70-F772-4ABC-91C7-3B19E0DEB205}" dt="2023-11-12T17:11:24.562" v="1209" actId="21"/>
          <ac:picMkLst>
            <pc:docMk/>
            <pc:sldMk cId="3210901459" sldId="268"/>
            <ac:picMk id="9" creationId="{99A78B0A-0C99-D4DA-21AB-1513ADBE1E76}"/>
          </ac:picMkLst>
        </pc:picChg>
      </pc:sldChg>
      <pc:sldChg chg="addSp delSp modSp new mod">
        <pc:chgData name="Papaioannou, Ioannis" userId="27d0d6e0-1133-45d1-b366-9071ba1a55b0" providerId="ADAL" clId="{B0F2CD70-F772-4ABC-91C7-3B19E0DEB205}" dt="2023-11-12T19:32:26.043" v="1540" actId="1076"/>
        <pc:sldMkLst>
          <pc:docMk/>
          <pc:sldMk cId="3205824443" sldId="269"/>
        </pc:sldMkLst>
        <pc:spChg chg="del">
          <ac:chgData name="Papaioannou, Ioannis" userId="27d0d6e0-1133-45d1-b366-9071ba1a55b0" providerId="ADAL" clId="{B0F2CD70-F772-4ABC-91C7-3B19E0DEB205}" dt="2023-11-05T21:27:50.019" v="1185" actId="478"/>
          <ac:spMkLst>
            <pc:docMk/>
            <pc:sldMk cId="3205824443" sldId="269"/>
            <ac:spMk id="2" creationId="{25E822EF-3077-5CAB-EC57-1E2AB3C90BD2}"/>
          </ac:spMkLst>
        </pc:spChg>
        <pc:spChg chg="del">
          <ac:chgData name="Papaioannou, Ioannis" userId="27d0d6e0-1133-45d1-b366-9071ba1a55b0" providerId="ADAL" clId="{B0F2CD70-F772-4ABC-91C7-3B19E0DEB205}" dt="2023-11-05T21:27:50.019" v="1185" actId="478"/>
          <ac:spMkLst>
            <pc:docMk/>
            <pc:sldMk cId="3205824443" sldId="269"/>
            <ac:spMk id="3" creationId="{CCFF9371-C0CF-9BF9-F41B-4D1FDB4BA9A0}"/>
          </ac:spMkLst>
        </pc:spChg>
        <pc:spChg chg="add del mod">
          <ac:chgData name="Papaioannou, Ioannis" userId="27d0d6e0-1133-45d1-b366-9071ba1a55b0" providerId="ADAL" clId="{B0F2CD70-F772-4ABC-91C7-3B19E0DEB205}" dt="2023-11-12T17:16:07.644" v="1226" actId="478"/>
          <ac:spMkLst>
            <pc:docMk/>
            <pc:sldMk cId="3205824443" sldId="269"/>
            <ac:spMk id="4" creationId="{2963EE04-B708-A061-1DB5-B7F6C4366451}"/>
          </ac:spMkLst>
        </pc:spChg>
        <pc:spChg chg="add mod">
          <ac:chgData name="Papaioannou, Ioannis" userId="27d0d6e0-1133-45d1-b366-9071ba1a55b0" providerId="ADAL" clId="{B0F2CD70-F772-4ABC-91C7-3B19E0DEB205}" dt="2023-11-05T21:28:15.020" v="1191" actId="20577"/>
          <ac:spMkLst>
            <pc:docMk/>
            <pc:sldMk cId="3205824443" sldId="269"/>
            <ac:spMk id="6" creationId="{7566630B-B214-2CCF-E52E-6E93D6F9E769}"/>
          </ac:spMkLst>
        </pc:spChg>
        <pc:spChg chg="add mod">
          <ac:chgData name="Papaioannou, Ioannis" userId="27d0d6e0-1133-45d1-b366-9071ba1a55b0" providerId="ADAL" clId="{B0F2CD70-F772-4ABC-91C7-3B19E0DEB205}" dt="2023-11-12T17:31:47.837" v="1363" actId="1076"/>
          <ac:spMkLst>
            <pc:docMk/>
            <pc:sldMk cId="3205824443" sldId="269"/>
            <ac:spMk id="7" creationId="{5C7A4544-7D61-C96A-14DB-677A5D064060}"/>
          </ac:spMkLst>
        </pc:spChg>
        <pc:spChg chg="add mod">
          <ac:chgData name="Papaioannou, Ioannis" userId="27d0d6e0-1133-45d1-b366-9071ba1a55b0" providerId="ADAL" clId="{B0F2CD70-F772-4ABC-91C7-3B19E0DEB205}" dt="2023-11-12T17:31:47.837" v="1363" actId="1076"/>
          <ac:spMkLst>
            <pc:docMk/>
            <pc:sldMk cId="3205824443" sldId="269"/>
            <ac:spMk id="9" creationId="{1FFDB0A5-7FEF-1C9A-A500-C70ACB39B996}"/>
          </ac:spMkLst>
        </pc:spChg>
        <pc:spChg chg="add mod">
          <ac:chgData name="Papaioannou, Ioannis" userId="27d0d6e0-1133-45d1-b366-9071ba1a55b0" providerId="ADAL" clId="{B0F2CD70-F772-4ABC-91C7-3B19E0DEB205}" dt="2023-11-12T17:27:59.528" v="1266" actId="14100"/>
          <ac:spMkLst>
            <pc:docMk/>
            <pc:sldMk cId="3205824443" sldId="269"/>
            <ac:spMk id="12" creationId="{BE62FB9C-A158-4932-0B74-A4D311F59564}"/>
          </ac:spMkLst>
        </pc:spChg>
        <pc:spChg chg="add mod">
          <ac:chgData name="Papaioannou, Ioannis" userId="27d0d6e0-1133-45d1-b366-9071ba1a55b0" providerId="ADAL" clId="{B0F2CD70-F772-4ABC-91C7-3B19E0DEB205}" dt="2023-11-12T19:32:26.043" v="1540" actId="1076"/>
          <ac:spMkLst>
            <pc:docMk/>
            <pc:sldMk cId="3205824443" sldId="269"/>
            <ac:spMk id="14" creationId="{6627666E-3267-1F99-E3D8-B931DA6BE0E5}"/>
          </ac:spMkLst>
        </pc:spChg>
        <pc:spChg chg="add mod">
          <ac:chgData name="Papaioannou, Ioannis" userId="27d0d6e0-1133-45d1-b366-9071ba1a55b0" providerId="ADAL" clId="{B0F2CD70-F772-4ABC-91C7-3B19E0DEB205}" dt="2023-11-12T17:32:12.159" v="1374" actId="20577"/>
          <ac:spMkLst>
            <pc:docMk/>
            <pc:sldMk cId="3205824443" sldId="269"/>
            <ac:spMk id="17" creationId="{3E70B091-6525-D431-BD84-4D97B451E18B}"/>
          </ac:spMkLst>
        </pc:spChg>
        <pc:spChg chg="add mod">
          <ac:chgData name="Papaioannou, Ioannis" userId="27d0d6e0-1133-45d1-b366-9071ba1a55b0" providerId="ADAL" clId="{B0F2CD70-F772-4ABC-91C7-3B19E0DEB205}" dt="2023-11-12T17:32:27.402" v="1376" actId="571"/>
          <ac:spMkLst>
            <pc:docMk/>
            <pc:sldMk cId="3205824443" sldId="269"/>
            <ac:spMk id="19" creationId="{3C0A07C2-6BEA-FEE1-02D5-99FB63B10D1A}"/>
          </ac:spMkLst>
        </pc:spChg>
        <pc:spChg chg="add mod">
          <ac:chgData name="Papaioannou, Ioannis" userId="27d0d6e0-1133-45d1-b366-9071ba1a55b0" providerId="ADAL" clId="{B0F2CD70-F772-4ABC-91C7-3B19E0DEB205}" dt="2023-11-12T17:32:49.374" v="1379" actId="14100"/>
          <ac:spMkLst>
            <pc:docMk/>
            <pc:sldMk cId="3205824443" sldId="269"/>
            <ac:spMk id="20" creationId="{359127C1-5C87-ECB5-4B01-CABAEFC05844}"/>
          </ac:spMkLst>
        </pc:spChg>
        <pc:picChg chg="add mod modCrop">
          <ac:chgData name="Papaioannou, Ioannis" userId="27d0d6e0-1133-45d1-b366-9071ba1a55b0" providerId="ADAL" clId="{B0F2CD70-F772-4ABC-91C7-3B19E0DEB205}" dt="2023-11-12T17:31:47.837" v="1363" actId="1076"/>
          <ac:picMkLst>
            <pc:docMk/>
            <pc:sldMk cId="3205824443" sldId="269"/>
            <ac:picMk id="3" creationId="{4E2BA53E-8416-A696-405A-2C18C80DCAC8}"/>
          </ac:picMkLst>
        </pc:picChg>
        <pc:picChg chg="add del mod">
          <ac:chgData name="Papaioannou, Ioannis" userId="27d0d6e0-1133-45d1-b366-9071ba1a55b0" providerId="ADAL" clId="{B0F2CD70-F772-4ABC-91C7-3B19E0DEB205}" dt="2023-11-12T17:46:00.564" v="1467" actId="478"/>
          <ac:picMkLst>
            <pc:docMk/>
            <pc:sldMk cId="3205824443" sldId="269"/>
            <ac:picMk id="5" creationId="{EF37330D-161B-A88B-25CB-9339B5D5DD6C}"/>
          </ac:picMkLst>
        </pc:picChg>
        <pc:picChg chg="add mod modCrop">
          <ac:chgData name="Papaioannou, Ioannis" userId="27d0d6e0-1133-45d1-b366-9071ba1a55b0" providerId="ADAL" clId="{B0F2CD70-F772-4ABC-91C7-3B19E0DEB205}" dt="2023-11-12T17:29:57.384" v="1290" actId="1076"/>
          <ac:picMkLst>
            <pc:docMk/>
            <pc:sldMk cId="3205824443" sldId="269"/>
            <ac:picMk id="8" creationId="{4F07EA81-ACAC-CA4C-6461-500859EB1CA2}"/>
          </ac:picMkLst>
        </pc:picChg>
        <pc:picChg chg="add mod modCrop">
          <ac:chgData name="Papaioannou, Ioannis" userId="27d0d6e0-1133-45d1-b366-9071ba1a55b0" providerId="ADAL" clId="{B0F2CD70-F772-4ABC-91C7-3B19E0DEB205}" dt="2023-11-12T17:29:20.343" v="1281" actId="14100"/>
          <ac:picMkLst>
            <pc:docMk/>
            <pc:sldMk cId="3205824443" sldId="269"/>
            <ac:picMk id="10" creationId="{9A928FFE-0CD4-BCCC-9C69-8F7CAC9B0322}"/>
          </ac:picMkLst>
        </pc:picChg>
        <pc:picChg chg="add del mod ord modCrop">
          <ac:chgData name="Papaioannou, Ioannis" userId="27d0d6e0-1133-45d1-b366-9071ba1a55b0" providerId="ADAL" clId="{B0F2CD70-F772-4ABC-91C7-3B19E0DEB205}" dt="2023-11-12T17:46:15.938" v="1473" actId="21"/>
          <ac:picMkLst>
            <pc:docMk/>
            <pc:sldMk cId="3205824443" sldId="269"/>
            <ac:picMk id="11" creationId="{C71048FD-4549-097B-66FC-11158588EB6F}"/>
          </ac:picMkLst>
        </pc:picChg>
        <pc:picChg chg="add del mod ord modCrop">
          <ac:chgData name="Papaioannou, Ioannis" userId="27d0d6e0-1133-45d1-b366-9071ba1a55b0" providerId="ADAL" clId="{B0F2CD70-F772-4ABC-91C7-3B19E0DEB205}" dt="2023-11-12T17:46:15.938" v="1473" actId="21"/>
          <ac:picMkLst>
            <pc:docMk/>
            <pc:sldMk cId="3205824443" sldId="269"/>
            <ac:picMk id="13" creationId="{A098FA82-5A48-216E-E8F3-D4CBE61BED02}"/>
          </ac:picMkLst>
        </pc:picChg>
        <pc:picChg chg="add mod modCrop">
          <ac:chgData name="Papaioannou, Ioannis" userId="27d0d6e0-1133-45d1-b366-9071ba1a55b0" providerId="ADAL" clId="{B0F2CD70-F772-4ABC-91C7-3B19E0DEB205}" dt="2023-11-12T17:32:04.424" v="1366" actId="1076"/>
          <ac:picMkLst>
            <pc:docMk/>
            <pc:sldMk cId="3205824443" sldId="269"/>
            <ac:picMk id="16" creationId="{8FA4497D-B078-EDB4-2270-8BA0BC734CB2}"/>
          </ac:picMkLst>
        </pc:picChg>
        <pc:picChg chg="add mod">
          <ac:chgData name="Papaioannou, Ioannis" userId="27d0d6e0-1133-45d1-b366-9071ba1a55b0" providerId="ADAL" clId="{B0F2CD70-F772-4ABC-91C7-3B19E0DEB205}" dt="2023-11-12T17:32:27.402" v="1376" actId="571"/>
          <ac:picMkLst>
            <pc:docMk/>
            <pc:sldMk cId="3205824443" sldId="269"/>
            <ac:picMk id="18" creationId="{6710871A-B4B0-4C18-C657-82961A24EAAD}"/>
          </ac:picMkLst>
        </pc:picChg>
        <pc:picChg chg="add del mod modCrop">
          <ac:chgData name="Papaioannou, Ioannis" userId="27d0d6e0-1133-45d1-b366-9071ba1a55b0" providerId="ADAL" clId="{B0F2CD70-F772-4ABC-91C7-3B19E0DEB205}" dt="2023-11-12T17:46:15.938" v="1473" actId="21"/>
          <ac:picMkLst>
            <pc:docMk/>
            <pc:sldMk cId="3205824443" sldId="269"/>
            <ac:picMk id="21" creationId="{0E8132FC-A069-F733-DD0F-A75D3A45E3C4}"/>
          </ac:picMkLst>
        </pc:picChg>
        <pc:picChg chg="add del mod modCrop">
          <ac:chgData name="Papaioannou, Ioannis" userId="27d0d6e0-1133-45d1-b366-9071ba1a55b0" providerId="ADAL" clId="{B0F2CD70-F772-4ABC-91C7-3B19E0DEB205}" dt="2023-11-12T17:46:15.938" v="1473" actId="21"/>
          <ac:picMkLst>
            <pc:docMk/>
            <pc:sldMk cId="3205824443" sldId="269"/>
            <ac:picMk id="22" creationId="{03F27C4E-363E-2449-CAB1-069E5116E38A}"/>
          </ac:picMkLst>
        </pc:picChg>
        <pc:picChg chg="add mod">
          <ac:chgData name="Papaioannou, Ioannis" userId="27d0d6e0-1133-45d1-b366-9071ba1a55b0" providerId="ADAL" clId="{B0F2CD70-F772-4ABC-91C7-3B19E0DEB205}" dt="2023-11-12T17:46:09.986" v="1472" actId="14100"/>
          <ac:picMkLst>
            <pc:docMk/>
            <pc:sldMk cId="3205824443" sldId="269"/>
            <ac:picMk id="24" creationId="{38C29AED-E6FE-EEAB-2E27-324E697DA141}"/>
          </ac:picMkLst>
        </pc:picChg>
      </pc:sldChg>
      <pc:sldChg chg="addSp delSp modSp new mod">
        <pc:chgData name="Papaioannou, Ioannis" userId="27d0d6e0-1133-45d1-b366-9071ba1a55b0" providerId="ADAL" clId="{B0F2CD70-F772-4ABC-91C7-3B19E0DEB205}" dt="2023-11-12T20:12:00.160" v="1676" actId="1076"/>
        <pc:sldMkLst>
          <pc:docMk/>
          <pc:sldMk cId="3619489513" sldId="270"/>
        </pc:sldMkLst>
        <pc:spChg chg="del">
          <ac:chgData name="Papaioannou, Ioannis" userId="27d0d6e0-1133-45d1-b366-9071ba1a55b0" providerId="ADAL" clId="{B0F2CD70-F772-4ABC-91C7-3B19E0DEB205}" dt="2023-11-12T19:11:22.516" v="1475" actId="478"/>
          <ac:spMkLst>
            <pc:docMk/>
            <pc:sldMk cId="3619489513" sldId="270"/>
            <ac:spMk id="2" creationId="{88394550-AC7A-7570-0E6F-184A23BF0FD5}"/>
          </ac:spMkLst>
        </pc:spChg>
        <pc:spChg chg="del">
          <ac:chgData name="Papaioannou, Ioannis" userId="27d0d6e0-1133-45d1-b366-9071ba1a55b0" providerId="ADAL" clId="{B0F2CD70-F772-4ABC-91C7-3B19E0DEB205}" dt="2023-11-12T19:11:22.516" v="1475" actId="478"/>
          <ac:spMkLst>
            <pc:docMk/>
            <pc:sldMk cId="3619489513" sldId="270"/>
            <ac:spMk id="3" creationId="{7B0347D4-6E19-13F1-8A5A-C16D298D4A94}"/>
          </ac:spMkLst>
        </pc:spChg>
        <pc:spChg chg="add mod">
          <ac:chgData name="Papaioannou, Ioannis" userId="27d0d6e0-1133-45d1-b366-9071ba1a55b0" providerId="ADAL" clId="{B0F2CD70-F772-4ABC-91C7-3B19E0DEB205}" dt="2023-11-12T20:12:00.160" v="1676" actId="1076"/>
          <ac:spMkLst>
            <pc:docMk/>
            <pc:sldMk cId="3619489513" sldId="270"/>
            <ac:spMk id="8" creationId="{35D3DB68-4A33-EB2F-34BB-2AED26C52B4A}"/>
          </ac:spMkLst>
        </pc:spChg>
        <pc:spChg chg="add mod">
          <ac:chgData name="Papaioannou, Ioannis" userId="27d0d6e0-1133-45d1-b366-9071ba1a55b0" providerId="ADAL" clId="{B0F2CD70-F772-4ABC-91C7-3B19E0DEB205}" dt="2023-11-12T20:12:00.160" v="1676" actId="1076"/>
          <ac:spMkLst>
            <pc:docMk/>
            <pc:sldMk cId="3619489513" sldId="270"/>
            <ac:spMk id="9" creationId="{786C362D-B87D-D7A7-BCBA-20E8AA75AE81}"/>
          </ac:spMkLst>
        </pc:spChg>
        <pc:spChg chg="add mod">
          <ac:chgData name="Papaioannou, Ioannis" userId="27d0d6e0-1133-45d1-b366-9071ba1a55b0" providerId="ADAL" clId="{B0F2CD70-F772-4ABC-91C7-3B19E0DEB205}" dt="2023-11-12T20:12:00.160" v="1676" actId="1076"/>
          <ac:spMkLst>
            <pc:docMk/>
            <pc:sldMk cId="3619489513" sldId="270"/>
            <ac:spMk id="10" creationId="{19BAAFFC-35E3-95FD-33D0-D0319F51DEBC}"/>
          </ac:spMkLst>
        </pc:spChg>
        <pc:spChg chg="add mod">
          <ac:chgData name="Papaioannou, Ioannis" userId="27d0d6e0-1133-45d1-b366-9071ba1a55b0" providerId="ADAL" clId="{B0F2CD70-F772-4ABC-91C7-3B19E0DEB205}" dt="2023-11-12T20:12:00.160" v="1676" actId="1076"/>
          <ac:spMkLst>
            <pc:docMk/>
            <pc:sldMk cId="3619489513" sldId="270"/>
            <ac:spMk id="11" creationId="{FACE4584-7B8D-7519-CC95-3E884FDAD333}"/>
          </ac:spMkLst>
        </pc:spChg>
        <pc:spChg chg="add mod">
          <ac:chgData name="Papaioannou, Ioannis" userId="27d0d6e0-1133-45d1-b366-9071ba1a55b0" providerId="ADAL" clId="{B0F2CD70-F772-4ABC-91C7-3B19E0DEB205}" dt="2023-11-12T20:11:54.968" v="1675" actId="20577"/>
          <ac:spMkLst>
            <pc:docMk/>
            <pc:sldMk cId="3619489513" sldId="270"/>
            <ac:spMk id="18" creationId="{1E57038C-C5C6-5551-1E21-0F11B2FA6A49}"/>
          </ac:spMkLst>
        </pc:spChg>
        <pc:picChg chg="add mod modCrop">
          <ac:chgData name="Papaioannou, Ioannis" userId="27d0d6e0-1133-45d1-b366-9071ba1a55b0" providerId="ADAL" clId="{B0F2CD70-F772-4ABC-91C7-3B19E0DEB205}" dt="2023-11-12T20:12:00.160" v="1676" actId="1076"/>
          <ac:picMkLst>
            <pc:docMk/>
            <pc:sldMk cId="3619489513" sldId="270"/>
            <ac:picMk id="5" creationId="{D5F92F0F-5204-894C-A465-1E5118329F67}"/>
          </ac:picMkLst>
        </pc:picChg>
        <pc:picChg chg="add del mod">
          <ac:chgData name="Papaioannou, Ioannis" userId="27d0d6e0-1133-45d1-b366-9071ba1a55b0" providerId="ADAL" clId="{B0F2CD70-F772-4ABC-91C7-3B19E0DEB205}" dt="2023-11-12T20:10:06.108" v="1662" actId="478"/>
          <ac:picMkLst>
            <pc:docMk/>
            <pc:sldMk cId="3619489513" sldId="270"/>
            <ac:picMk id="7" creationId="{6159FCA1-7C6D-0643-E9B1-C60072B3A321}"/>
          </ac:picMkLst>
        </pc:picChg>
        <pc:picChg chg="add del mod modCrop">
          <ac:chgData name="Papaioannou, Ioannis" userId="27d0d6e0-1133-45d1-b366-9071ba1a55b0" providerId="ADAL" clId="{B0F2CD70-F772-4ABC-91C7-3B19E0DEB205}" dt="2023-11-12T20:10:06.108" v="1662" actId="478"/>
          <ac:picMkLst>
            <pc:docMk/>
            <pc:sldMk cId="3619489513" sldId="270"/>
            <ac:picMk id="12" creationId="{E2CFC372-5567-1BE0-74C4-FD4250EA37D0}"/>
          </ac:picMkLst>
        </pc:picChg>
        <pc:picChg chg="add del mod modCrop">
          <ac:chgData name="Papaioannou, Ioannis" userId="27d0d6e0-1133-45d1-b366-9071ba1a55b0" providerId="ADAL" clId="{B0F2CD70-F772-4ABC-91C7-3B19E0DEB205}" dt="2023-11-12T20:10:06.108" v="1662" actId="478"/>
          <ac:picMkLst>
            <pc:docMk/>
            <pc:sldMk cId="3619489513" sldId="270"/>
            <ac:picMk id="13" creationId="{7F48813B-2461-53AB-9947-C3919895642A}"/>
          </ac:picMkLst>
        </pc:picChg>
        <pc:picChg chg="add del mod">
          <ac:chgData name="Papaioannou, Ioannis" userId="27d0d6e0-1133-45d1-b366-9071ba1a55b0" providerId="ADAL" clId="{B0F2CD70-F772-4ABC-91C7-3B19E0DEB205}" dt="2023-11-12T20:06:28.416" v="1661"/>
          <ac:picMkLst>
            <pc:docMk/>
            <pc:sldMk cId="3619489513" sldId="270"/>
            <ac:picMk id="14" creationId="{9A32923B-60E9-07CF-8BCE-4ACA1718307A}"/>
          </ac:picMkLst>
        </pc:picChg>
        <pc:picChg chg="add del mod">
          <ac:chgData name="Papaioannou, Ioannis" userId="27d0d6e0-1133-45d1-b366-9071ba1a55b0" providerId="ADAL" clId="{B0F2CD70-F772-4ABC-91C7-3B19E0DEB205}" dt="2023-11-12T20:06:28.416" v="1661"/>
          <ac:picMkLst>
            <pc:docMk/>
            <pc:sldMk cId="3619489513" sldId="270"/>
            <ac:picMk id="15" creationId="{637A43FA-9307-089D-3410-D6BC8EE224D3}"/>
          </ac:picMkLst>
        </pc:picChg>
        <pc:picChg chg="add mod">
          <ac:chgData name="Papaioannou, Ioannis" userId="27d0d6e0-1133-45d1-b366-9071ba1a55b0" providerId="ADAL" clId="{B0F2CD70-F772-4ABC-91C7-3B19E0DEB205}" dt="2023-11-12T20:10:08.603" v="1664" actId="1076"/>
          <ac:picMkLst>
            <pc:docMk/>
            <pc:sldMk cId="3619489513" sldId="270"/>
            <ac:picMk id="17" creationId="{12C7AB26-1F36-B95E-6913-0BF483A07CE4}"/>
          </ac:picMkLst>
        </pc:picChg>
      </pc:sldChg>
      <pc:sldChg chg="addSp delSp modSp new mod">
        <pc:chgData name="Papaioannou, Ioannis" userId="27d0d6e0-1133-45d1-b366-9071ba1a55b0" providerId="ADAL" clId="{B0F2CD70-F772-4ABC-91C7-3B19E0DEB205}" dt="2023-11-12T20:32:38.334" v="1750" actId="1076"/>
        <pc:sldMkLst>
          <pc:docMk/>
          <pc:sldMk cId="711307936" sldId="271"/>
        </pc:sldMkLst>
        <pc:spChg chg="del">
          <ac:chgData name="Papaioannou, Ioannis" userId="27d0d6e0-1133-45d1-b366-9071ba1a55b0" providerId="ADAL" clId="{B0F2CD70-F772-4ABC-91C7-3B19E0DEB205}" dt="2023-11-12T20:11:38.552" v="1666" actId="478"/>
          <ac:spMkLst>
            <pc:docMk/>
            <pc:sldMk cId="711307936" sldId="271"/>
            <ac:spMk id="2" creationId="{89DA8DF6-5CBA-B0ED-207E-595749889064}"/>
          </ac:spMkLst>
        </pc:spChg>
        <pc:spChg chg="del">
          <ac:chgData name="Papaioannou, Ioannis" userId="27d0d6e0-1133-45d1-b366-9071ba1a55b0" providerId="ADAL" clId="{B0F2CD70-F772-4ABC-91C7-3B19E0DEB205}" dt="2023-11-12T20:11:38.552" v="1666" actId="478"/>
          <ac:spMkLst>
            <pc:docMk/>
            <pc:sldMk cId="711307936" sldId="271"/>
            <ac:spMk id="3" creationId="{A18D9BBC-5B8D-74DF-A937-1A0D8A0804FF}"/>
          </ac:spMkLst>
        </pc:spChg>
        <pc:spChg chg="add mod">
          <ac:chgData name="Papaioannou, Ioannis" userId="27d0d6e0-1133-45d1-b366-9071ba1a55b0" providerId="ADAL" clId="{B0F2CD70-F772-4ABC-91C7-3B19E0DEB205}" dt="2023-11-12T20:13:33.851" v="1696" actId="20577"/>
          <ac:spMkLst>
            <pc:docMk/>
            <pc:sldMk cId="711307936" sldId="271"/>
            <ac:spMk id="6" creationId="{FB5746EE-56CA-FABD-F449-638CD2A659E6}"/>
          </ac:spMkLst>
        </pc:spChg>
        <pc:spChg chg="add mod">
          <ac:chgData name="Papaioannou, Ioannis" userId="27d0d6e0-1133-45d1-b366-9071ba1a55b0" providerId="ADAL" clId="{B0F2CD70-F772-4ABC-91C7-3B19E0DEB205}" dt="2023-11-12T20:32:38.334" v="1750" actId="1076"/>
          <ac:spMkLst>
            <pc:docMk/>
            <pc:sldMk cId="711307936" sldId="271"/>
            <ac:spMk id="18" creationId="{FF7C429D-4CFC-BDD5-8F7B-EE92DECBB2B8}"/>
          </ac:spMkLst>
        </pc:spChg>
        <pc:spChg chg="add mod">
          <ac:chgData name="Papaioannou, Ioannis" userId="27d0d6e0-1133-45d1-b366-9071ba1a55b0" providerId="ADAL" clId="{B0F2CD70-F772-4ABC-91C7-3B19E0DEB205}" dt="2023-11-12T20:32:32.843" v="1749" actId="20577"/>
          <ac:spMkLst>
            <pc:docMk/>
            <pc:sldMk cId="711307936" sldId="271"/>
            <ac:spMk id="19" creationId="{DC2E901B-175E-8111-971B-D5E82E0B0DD7}"/>
          </ac:spMkLst>
        </pc:spChg>
        <pc:picChg chg="add mod">
          <ac:chgData name="Papaioannou, Ioannis" userId="27d0d6e0-1133-45d1-b366-9071ba1a55b0" providerId="ADAL" clId="{B0F2CD70-F772-4ABC-91C7-3B19E0DEB205}" dt="2023-11-12T20:13:38.626" v="1698" actId="14100"/>
          <ac:picMkLst>
            <pc:docMk/>
            <pc:sldMk cId="711307936" sldId="271"/>
            <ac:picMk id="5" creationId="{6FDD3D08-4764-D0BB-5E18-DFA625AE0832}"/>
          </ac:picMkLst>
        </pc:picChg>
        <pc:picChg chg="add mod modCrop">
          <ac:chgData name="Papaioannou, Ioannis" userId="27d0d6e0-1133-45d1-b366-9071ba1a55b0" providerId="ADAL" clId="{B0F2CD70-F772-4ABC-91C7-3B19E0DEB205}" dt="2023-11-12T20:32:21.928" v="1736" actId="1076"/>
          <ac:picMkLst>
            <pc:docMk/>
            <pc:sldMk cId="711307936" sldId="271"/>
            <ac:picMk id="8" creationId="{801BAD8B-3657-E439-84F5-5501B7598B15}"/>
          </ac:picMkLst>
        </pc:picChg>
        <pc:picChg chg="add mod modCrop">
          <ac:chgData name="Papaioannou, Ioannis" userId="27d0d6e0-1133-45d1-b366-9071ba1a55b0" providerId="ADAL" clId="{B0F2CD70-F772-4ABC-91C7-3B19E0DEB205}" dt="2023-11-12T20:26:27.144" v="1715" actId="1076"/>
          <ac:picMkLst>
            <pc:docMk/>
            <pc:sldMk cId="711307936" sldId="271"/>
            <ac:picMk id="10" creationId="{744151D6-5D3B-B5F6-DC47-9B3FB734638D}"/>
          </ac:picMkLst>
        </pc:picChg>
        <pc:picChg chg="add del mod">
          <ac:chgData name="Papaioannou, Ioannis" userId="27d0d6e0-1133-45d1-b366-9071ba1a55b0" providerId="ADAL" clId="{B0F2CD70-F772-4ABC-91C7-3B19E0DEB205}" dt="2023-11-12T20:32:14.830" v="1735" actId="478"/>
          <ac:picMkLst>
            <pc:docMk/>
            <pc:sldMk cId="711307936" sldId="271"/>
            <ac:picMk id="11" creationId="{EEB6E2DC-1B72-553F-0866-3734BD190B4D}"/>
          </ac:picMkLst>
        </pc:picChg>
        <pc:picChg chg="add mod">
          <ac:chgData name="Papaioannou, Ioannis" userId="27d0d6e0-1133-45d1-b366-9071ba1a55b0" providerId="ADAL" clId="{B0F2CD70-F772-4ABC-91C7-3B19E0DEB205}" dt="2023-11-12T20:27:58.014" v="1723" actId="1582"/>
          <ac:picMkLst>
            <pc:docMk/>
            <pc:sldMk cId="711307936" sldId="271"/>
            <ac:picMk id="13" creationId="{AB502056-235C-E043-2E28-BF1CA61065F0}"/>
          </ac:picMkLst>
        </pc:picChg>
        <pc:picChg chg="add mod modCrop">
          <ac:chgData name="Papaioannou, Ioannis" userId="27d0d6e0-1133-45d1-b366-9071ba1a55b0" providerId="ADAL" clId="{B0F2CD70-F772-4ABC-91C7-3B19E0DEB205}" dt="2023-11-12T20:29:31.660" v="1731" actId="1076"/>
          <ac:picMkLst>
            <pc:docMk/>
            <pc:sldMk cId="711307936" sldId="271"/>
            <ac:picMk id="15" creationId="{A0459FD8-F975-19CD-0AEC-CA40CBAEE594}"/>
          </ac:picMkLst>
        </pc:picChg>
        <pc:picChg chg="add del mod">
          <ac:chgData name="Papaioannou, Ioannis" userId="27d0d6e0-1133-45d1-b366-9071ba1a55b0" providerId="ADAL" clId="{B0F2CD70-F772-4ABC-91C7-3B19E0DEB205}" dt="2023-11-12T20:30:27.586" v="1733"/>
          <ac:picMkLst>
            <pc:docMk/>
            <pc:sldMk cId="711307936" sldId="271"/>
            <ac:picMk id="16" creationId="{FDE55C62-50E0-828E-62E7-CF4CA53206D0}"/>
          </ac:picMkLst>
        </pc:picChg>
        <pc:picChg chg="add del mod">
          <ac:chgData name="Papaioannou, Ioannis" userId="27d0d6e0-1133-45d1-b366-9071ba1a55b0" providerId="ADAL" clId="{B0F2CD70-F772-4ABC-91C7-3B19E0DEB205}" dt="2023-11-12T20:30:27.586" v="1733"/>
          <ac:picMkLst>
            <pc:docMk/>
            <pc:sldMk cId="711307936" sldId="271"/>
            <ac:picMk id="17" creationId="{09976B5F-3306-E3B7-3B82-DA2B6A0D7F16}"/>
          </ac:picMkLst>
        </pc:picChg>
      </pc:sldChg>
    </pc:docChg>
  </pc:docChgLst>
</pc:chgInfo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07-08T14:52:20.451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1 24575,'0'0'-8191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26T04:39:09.112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1 24575,'0'0'-8191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D70A94-5077-47C3-A0D6-AB478065BCB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DF7287-4EB2-4DFA-9838-09693ACE0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823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F7287-4EB2-4DFA-9838-09693ACE020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122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F7287-4EB2-4DFA-9838-09693ACE020D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7222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1D2B90-1C14-916D-1CF4-D1B18E1280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9A1BBD1-9DCE-05BC-42AB-25CB3D9AFB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042910-D23E-0A4E-6A12-2BF0B4050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9508FF-8B77-0B6A-ED97-5D394CDF6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FEA279-23A0-1CDD-6D43-994EE38A8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609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81122E-7C4E-E665-F064-81305B230B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D32E9E-D5AA-99F6-C4F2-40A72FAFFD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DEBC3B-B2D6-7B56-C8E3-6BA80BD57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BAD836-E200-27C0-67FB-7A8A662CF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DF94E2-FE18-FCFE-C212-734A27F8C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414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E8B5C41-04E3-4F0C-F55F-79B7DCB94E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CE448A-934A-D001-BB63-1C4036B5D8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CA19A7-1A1D-24E5-DC5E-B5FEB8F0E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DD0176-A657-0A0D-6083-4798CA5CC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E80AD4-F3E1-34F3-D3DE-9869B3F5D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00994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087672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826283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459863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360544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065787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090572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249036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873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C06EFF-D773-E34F-E520-B83F8431F3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FB4E11-0927-7C22-E9FC-498B4435BC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89ED5-3F4C-0A9D-262B-250496C1DC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11D873-B8FA-CF57-A09F-DB25CC8D2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6904ED-5974-8ABA-75CF-7FE0A42A0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64411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606533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25993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2821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6CEC5C-63C1-9925-C42C-CC24DEFAD9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FA40F4-0A10-F533-A2F3-8CE86B6F70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14B4A4-254F-882D-CE16-8296D19DA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F8DDC8-A07A-3545-701A-C3EE456D3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9F6CED-9D2B-184B-6670-7ECABEEAA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530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43CC93-D107-A8AC-1939-6ADC25EAF5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D18C59-B177-ACAB-A6FB-6E971CF32F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80FD5A-BFA0-0FC2-9BBB-F1D0BB8228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389237-9200-4D6C-9855-1647100BE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439F40-F20F-01BA-B75B-2C866ACDE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28760B-A773-85C5-3418-C020852E6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106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B90030-0558-1BFF-3930-CEBBA9C6FF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B5A862-1E23-1E43-AAB9-7AC86501D1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CB117C-DBE7-A6DD-706F-7E052E8E09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EABC04-39A5-4112-9495-2B0DD65F04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EBC16B6-274C-D0A5-4861-5BC4F9ADB2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97EB09-D54D-40AF-5C56-8FACFD979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5EDED87-24BE-0C57-77E3-024C42CF3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2361D8-0522-1984-A10F-3F7C6A130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43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3D843-E78C-C089-3604-9C39AAC26C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AB4200-4466-5AC8-38BB-B6C837CEF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5C8125-04FF-F8DC-07A1-D001E93FE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1DA687-73C9-0BE7-120B-244945A21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112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24D9CD3-B3A9-18DD-F425-C81CDCB8A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E88112-38AE-E368-3269-D22F94DD5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1EBCCB-D19F-63A9-9DD2-56C129152B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901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E88B30-8F38-05A3-0B3A-C31FF8C773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D61CB3-B902-0367-1140-8EAF32B3B7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093F6E-20F4-450E-C55D-85A60729FC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3952D0-909F-1087-30A9-1230A664E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A37C86-5192-1EAA-29CC-C0512F038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6EC227-EB47-2811-3EB9-9B36BDBF7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5043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46FF6E-AA61-DD07-4389-2209C4C9D6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9D14C68-74C4-718D-F890-2E6923863B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233497-9C29-6BCC-B272-27F6415C79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D9B89E-E184-0ECA-58F6-1BB7ECF25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3BBD0F-712D-B419-79EF-20301C63F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EE2931-93D2-2F3D-1513-F17C5E093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79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6A1D502-8B3A-ED5B-2CB4-4FF9E61C2D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D1F23C-9FA0-334B-0659-E0380F3B41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2069E6-A6F3-AA03-E3B2-2EDED3A43D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71CD5-1259-4BEC-B457-E6E548F1EF63}" type="datetimeFigureOut">
              <a:rPr lang="en-US" smtClean="0"/>
              <a:t>4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206613-0389-8422-E25A-5360C2B8D02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790A4A-A43D-48B3-0D94-EE28976B2A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0A5EEF-C9F9-4147-A393-B95AD38B07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449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0A2CD-D662-4D2D-B8A2-F277024F5A0A}" type="datetimeFigureOut">
              <a:rPr lang="en-GB" smtClean="0"/>
              <a:t>10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9B622-3197-4C26-94E8-02E8DE83F8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1311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13" Type="http://schemas.openxmlformats.org/officeDocument/2006/relationships/image" Target="../media/image57.png"/><Relationship Id="rId3" Type="http://schemas.openxmlformats.org/officeDocument/2006/relationships/image" Target="../media/image51.jpeg"/><Relationship Id="rId7" Type="http://schemas.openxmlformats.org/officeDocument/2006/relationships/image" Target="../media/image53.jpeg"/><Relationship Id="rId12" Type="http://schemas.microsoft.com/office/2007/relationships/hdphoto" Target="../media/hdphoto17.wdp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11" Type="http://schemas.openxmlformats.org/officeDocument/2006/relationships/image" Target="../media/image56.png"/><Relationship Id="rId5" Type="http://schemas.openxmlformats.org/officeDocument/2006/relationships/customXml" Target="../ink/ink2.xml"/><Relationship Id="rId10" Type="http://schemas.openxmlformats.org/officeDocument/2006/relationships/image" Target="../media/image55.jpeg"/><Relationship Id="rId4" Type="http://schemas.openxmlformats.org/officeDocument/2006/relationships/image" Target="../media/image52.jpeg"/><Relationship Id="rId9" Type="http://schemas.microsoft.com/office/2007/relationships/hdphoto" Target="../media/hdphoto16.wdp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3.png"/><Relationship Id="rId4" Type="http://schemas.openxmlformats.org/officeDocument/2006/relationships/image" Target="../media/image6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jpeg"/><Relationship Id="rId7" Type="http://schemas.openxmlformats.org/officeDocument/2006/relationships/image" Target="../media/image6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7.jpeg"/><Relationship Id="rId5" Type="http://schemas.openxmlformats.org/officeDocument/2006/relationships/image" Target="../media/image66.jpeg"/><Relationship Id="rId4" Type="http://schemas.openxmlformats.org/officeDocument/2006/relationships/image" Target="../media/image65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jpe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5.png"/><Relationship Id="rId5" Type="http://schemas.openxmlformats.org/officeDocument/2006/relationships/image" Target="../media/image74.png"/><Relationship Id="rId4" Type="http://schemas.openxmlformats.org/officeDocument/2006/relationships/image" Target="../media/image7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7.png"/><Relationship Id="rId18" Type="http://schemas.openxmlformats.org/officeDocument/2006/relationships/image" Target="../media/image20.png"/><Relationship Id="rId3" Type="http://schemas.openxmlformats.org/officeDocument/2006/relationships/image" Target="../media/image12.png"/><Relationship Id="rId7" Type="http://schemas.openxmlformats.org/officeDocument/2006/relationships/image" Target="../media/image14.png"/><Relationship Id="rId12" Type="http://schemas.microsoft.com/office/2007/relationships/hdphoto" Target="../media/hdphoto5.wdp"/><Relationship Id="rId17" Type="http://schemas.openxmlformats.org/officeDocument/2006/relationships/image" Target="../media/image19.jpe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1" Type="http://schemas.openxmlformats.org/officeDocument/2006/relationships/slideLayout" Target="../slideLayouts/slideLayout18.xml"/><Relationship Id="rId6" Type="http://schemas.microsoft.com/office/2007/relationships/hdphoto" Target="../media/hdphoto2.wdp"/><Relationship Id="rId11" Type="http://schemas.openxmlformats.org/officeDocument/2006/relationships/image" Target="../media/image16.png"/><Relationship Id="rId5" Type="http://schemas.openxmlformats.org/officeDocument/2006/relationships/image" Target="../media/image13.png"/><Relationship Id="rId15" Type="http://schemas.openxmlformats.org/officeDocument/2006/relationships/image" Target="../media/image18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15.png"/><Relationship Id="rId14" Type="http://schemas.microsoft.com/office/2007/relationships/hdphoto" Target="../media/hdphoto6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emf"/><Relationship Id="rId4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emf"/><Relationship Id="rId4" Type="http://schemas.openxmlformats.org/officeDocument/2006/relationships/image" Target="../media/image2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3" Type="http://schemas.openxmlformats.org/officeDocument/2006/relationships/image" Target="../media/image37.jpeg"/><Relationship Id="rId7" Type="http://schemas.openxmlformats.org/officeDocument/2006/relationships/image" Target="../media/image40.png"/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8.wdp"/><Relationship Id="rId5" Type="http://schemas.openxmlformats.org/officeDocument/2006/relationships/image" Target="../media/image39.png"/><Relationship Id="rId10" Type="http://schemas.openxmlformats.org/officeDocument/2006/relationships/image" Target="../media/image42.png"/><Relationship Id="rId4" Type="http://schemas.openxmlformats.org/officeDocument/2006/relationships/image" Target="../media/image38.jpeg"/><Relationship Id="rId9" Type="http://schemas.openxmlformats.org/officeDocument/2006/relationships/image" Target="../media/image41.png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12.wdp"/><Relationship Id="rId13" Type="http://schemas.openxmlformats.org/officeDocument/2006/relationships/image" Target="../media/image49.png"/><Relationship Id="rId3" Type="http://schemas.openxmlformats.org/officeDocument/2006/relationships/image" Target="../media/image44.png"/><Relationship Id="rId7" Type="http://schemas.openxmlformats.org/officeDocument/2006/relationships/image" Target="../media/image46.png"/><Relationship Id="rId12" Type="http://schemas.microsoft.com/office/2007/relationships/hdphoto" Target="../media/hdphoto14.wdp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1.wdp"/><Relationship Id="rId11" Type="http://schemas.openxmlformats.org/officeDocument/2006/relationships/image" Target="../media/image48.png"/><Relationship Id="rId5" Type="http://schemas.openxmlformats.org/officeDocument/2006/relationships/image" Target="../media/image45.png"/><Relationship Id="rId15" Type="http://schemas.openxmlformats.org/officeDocument/2006/relationships/image" Target="../media/image50.jpeg"/><Relationship Id="rId10" Type="http://schemas.microsoft.com/office/2007/relationships/hdphoto" Target="../media/hdphoto13.wdp"/><Relationship Id="rId4" Type="http://schemas.microsoft.com/office/2007/relationships/hdphoto" Target="../media/hdphoto10.wdp"/><Relationship Id="rId9" Type="http://schemas.openxmlformats.org/officeDocument/2006/relationships/image" Target="../media/image47.png"/><Relationship Id="rId14" Type="http://schemas.microsoft.com/office/2007/relationships/hdphoto" Target="../media/hdphoto15.wdp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16.wdp"/><Relationship Id="rId13" Type="http://schemas.openxmlformats.org/officeDocument/2006/relationships/image" Target="../media/image58.png"/><Relationship Id="rId3" Type="http://schemas.openxmlformats.org/officeDocument/2006/relationships/image" Target="../media/image52.jpeg"/><Relationship Id="rId7" Type="http://schemas.openxmlformats.org/officeDocument/2006/relationships/image" Target="../media/image54.png"/><Relationship Id="rId12" Type="http://schemas.openxmlformats.org/officeDocument/2006/relationships/image" Target="../media/image57.png"/><Relationship Id="rId2" Type="http://schemas.openxmlformats.org/officeDocument/2006/relationships/image" Target="../media/image5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jpeg"/><Relationship Id="rId11" Type="http://schemas.microsoft.com/office/2007/relationships/hdphoto" Target="../media/hdphoto17.wdp"/><Relationship Id="rId5" Type="http://schemas.openxmlformats.org/officeDocument/2006/relationships/image" Target="../media/image53.png"/><Relationship Id="rId10" Type="http://schemas.openxmlformats.org/officeDocument/2006/relationships/image" Target="../media/image56.png"/><Relationship Id="rId4" Type="http://schemas.openxmlformats.org/officeDocument/2006/relationships/customXml" Target="../ink/ink1.xml"/><Relationship Id="rId9" Type="http://schemas.openxmlformats.org/officeDocument/2006/relationships/image" Target="../media/image5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16DB6D-2F93-6176-465F-9A95D192B8D8}"/>
              </a:ext>
            </a:extLst>
          </p:cNvPr>
          <p:cNvSpPr txBox="1"/>
          <p:nvPr/>
        </p:nvSpPr>
        <p:spPr>
          <a:xfrm>
            <a:off x="639079" y="144216"/>
            <a:ext cx="3639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Unedited Western blots for figure 2A</a:t>
            </a:r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3A0BF3A-AF5F-5870-F66F-2BE69BC3DEF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38303" y="501790"/>
            <a:ext cx="2608323" cy="2819523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D256E583-9CF0-7E8A-F921-602F81B40AEA}"/>
              </a:ext>
            </a:extLst>
          </p:cNvPr>
          <p:cNvSpPr/>
          <p:nvPr/>
        </p:nvSpPr>
        <p:spPr>
          <a:xfrm>
            <a:off x="1543207" y="862903"/>
            <a:ext cx="1180943" cy="3788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BC7D0C30-9751-A5A0-8F65-295055330FF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10800000" flipH="1">
            <a:off x="2892003" y="564830"/>
            <a:ext cx="3101126" cy="2417816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B0EAA019-14C7-0F2C-E08F-973938194268}"/>
              </a:ext>
            </a:extLst>
          </p:cNvPr>
          <p:cNvSpPr/>
          <p:nvPr/>
        </p:nvSpPr>
        <p:spPr>
          <a:xfrm>
            <a:off x="4101391" y="1995641"/>
            <a:ext cx="834387" cy="3157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A4196A9E-DBEE-CF70-F857-56E26493FEA9}"/>
              </a:ext>
            </a:extLst>
          </p:cNvPr>
          <p:cNvSpPr/>
          <p:nvPr/>
        </p:nvSpPr>
        <p:spPr>
          <a:xfrm>
            <a:off x="3069477" y="2248718"/>
            <a:ext cx="834387" cy="2624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2BC06D45-542B-2253-6C24-06633B7B0B9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10800000" flipH="1">
            <a:off x="6034829" y="482740"/>
            <a:ext cx="1508972" cy="2495673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F863FC06-8519-5F15-A418-0A68892E4F59}"/>
              </a:ext>
            </a:extLst>
          </p:cNvPr>
          <p:cNvSpPr/>
          <p:nvPr/>
        </p:nvSpPr>
        <p:spPr>
          <a:xfrm>
            <a:off x="6536994" y="2373870"/>
            <a:ext cx="834387" cy="3788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F2F2D079-D5C2-B4B0-73B0-BF6670D90E4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7791025" y="588150"/>
            <a:ext cx="1508972" cy="2276861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E5E1AE59-8AD0-EE69-77C0-E60C4EE5CDF5}"/>
              </a:ext>
            </a:extLst>
          </p:cNvPr>
          <p:cNvSpPr/>
          <p:nvPr/>
        </p:nvSpPr>
        <p:spPr>
          <a:xfrm>
            <a:off x="7873546" y="1971102"/>
            <a:ext cx="834387" cy="3788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7" name="Picture 46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0AA1B274-6237-EF6E-8A44-41F8152C56A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81045" y="3255233"/>
            <a:ext cx="4357065" cy="3477359"/>
          </a:xfrm>
          <a:prstGeom prst="rect">
            <a:avLst/>
          </a:prstGeom>
        </p:spPr>
      </p:pic>
      <p:sp>
        <p:nvSpPr>
          <p:cNvPr id="52" name="Rectangle 51">
            <a:extLst>
              <a:ext uri="{FF2B5EF4-FFF2-40B4-BE49-F238E27FC236}">
                <a16:creationId xmlns:a16="http://schemas.microsoft.com/office/drawing/2014/main" id="{B8B10DE2-B391-73D4-52B1-ACFA9832A867}"/>
              </a:ext>
            </a:extLst>
          </p:cNvPr>
          <p:cNvSpPr/>
          <p:nvPr/>
        </p:nvSpPr>
        <p:spPr>
          <a:xfrm>
            <a:off x="4652983" y="4345279"/>
            <a:ext cx="1246390" cy="3788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D7FE762-1A09-5608-35F3-82B99B644A3D}"/>
              </a:ext>
            </a:extLst>
          </p:cNvPr>
          <p:cNvSpPr txBox="1"/>
          <p:nvPr/>
        </p:nvSpPr>
        <p:spPr>
          <a:xfrm>
            <a:off x="986718" y="867666"/>
            <a:ext cx="609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FN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499A77C-133B-137E-36E8-DF4383C196E0}"/>
              </a:ext>
            </a:extLst>
          </p:cNvPr>
          <p:cNvSpPr txBox="1"/>
          <p:nvPr/>
        </p:nvSpPr>
        <p:spPr>
          <a:xfrm>
            <a:off x="3111400" y="1896906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NN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148308D-6424-4DA9-DCA3-6D2E41261E43}"/>
              </a:ext>
            </a:extLst>
          </p:cNvPr>
          <p:cNvSpPr txBox="1"/>
          <p:nvPr/>
        </p:nvSpPr>
        <p:spPr>
          <a:xfrm>
            <a:off x="4193725" y="640349"/>
            <a:ext cx="784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A2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83B2295-32E6-F04B-FB94-F4D50DF273AE}"/>
              </a:ext>
            </a:extLst>
          </p:cNvPr>
          <p:cNvSpPr txBox="1"/>
          <p:nvPr/>
        </p:nvSpPr>
        <p:spPr>
          <a:xfrm>
            <a:off x="6474108" y="2085589"/>
            <a:ext cx="80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GLN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5B78F05-C527-208C-A656-3CE7EF5FCD66}"/>
              </a:ext>
            </a:extLst>
          </p:cNvPr>
          <p:cNvSpPr txBox="1"/>
          <p:nvPr/>
        </p:nvSpPr>
        <p:spPr>
          <a:xfrm>
            <a:off x="7938854" y="2523216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57E4BA0-240F-CF88-CA79-62BEA686ECCA}"/>
              </a:ext>
            </a:extLst>
          </p:cNvPr>
          <p:cNvSpPr txBox="1"/>
          <p:nvPr/>
        </p:nvSpPr>
        <p:spPr>
          <a:xfrm>
            <a:off x="4130027" y="6025881"/>
            <a:ext cx="673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L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4F7D3DD-32AA-780D-8D19-638513B3954B}"/>
              </a:ext>
            </a:extLst>
          </p:cNvPr>
          <p:cNvSpPr txBox="1"/>
          <p:nvPr/>
        </p:nvSpPr>
        <p:spPr>
          <a:xfrm>
            <a:off x="5929308" y="69300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7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AC3BE54-E60B-9283-82B0-490B2EA549FF}"/>
              </a:ext>
            </a:extLst>
          </p:cNvPr>
          <p:cNvSpPr txBox="1"/>
          <p:nvPr/>
        </p:nvSpPr>
        <p:spPr>
          <a:xfrm>
            <a:off x="5929308" y="969779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24DCE07-3F8B-D0BC-4530-DADA81D3FEF4}"/>
              </a:ext>
            </a:extLst>
          </p:cNvPr>
          <p:cNvSpPr txBox="1"/>
          <p:nvPr/>
        </p:nvSpPr>
        <p:spPr>
          <a:xfrm>
            <a:off x="3837437" y="4118674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98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C831AA3-76B4-7CBA-F8C6-01FE4F300656}"/>
              </a:ext>
            </a:extLst>
          </p:cNvPr>
          <p:cNvSpPr txBox="1"/>
          <p:nvPr/>
        </p:nvSpPr>
        <p:spPr>
          <a:xfrm>
            <a:off x="3837437" y="458563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98kDa</a:t>
            </a:r>
          </a:p>
        </p:txBody>
      </p:sp>
      <p:pic>
        <p:nvPicPr>
          <p:cNvPr id="4" name="Picture 3" descr="A close-up of a test tube&#10;&#10;Description automatically generated">
            <a:extLst>
              <a:ext uri="{FF2B5EF4-FFF2-40B4-BE49-F238E27FC236}">
                <a16:creationId xmlns:a16="http://schemas.microsoft.com/office/drawing/2014/main" id="{B9A67C9D-082D-0D33-7851-C2053DA614F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242583" y="3135880"/>
            <a:ext cx="3949418" cy="3478343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C4BA707D-8866-6383-331E-985020B01BD6}"/>
              </a:ext>
            </a:extLst>
          </p:cNvPr>
          <p:cNvSpPr/>
          <p:nvPr/>
        </p:nvSpPr>
        <p:spPr>
          <a:xfrm>
            <a:off x="9011072" y="5765014"/>
            <a:ext cx="1136351" cy="3114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050A7A1-B518-9476-DC1E-391BCEDC9163}"/>
              </a:ext>
            </a:extLst>
          </p:cNvPr>
          <p:cNvSpPr txBox="1"/>
          <p:nvPr/>
        </p:nvSpPr>
        <p:spPr>
          <a:xfrm>
            <a:off x="9299997" y="3429000"/>
            <a:ext cx="17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 for COL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0BEF6A5-880B-1684-7F3A-762BE2CC97B2}"/>
              </a:ext>
            </a:extLst>
          </p:cNvPr>
          <p:cNvSpPr txBox="1"/>
          <p:nvPr/>
        </p:nvSpPr>
        <p:spPr>
          <a:xfrm>
            <a:off x="3051099" y="2883553"/>
            <a:ext cx="80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GLN</a:t>
            </a:r>
            <a:endParaRPr lang="en-US" dirty="0"/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1E0F4BA-63A5-4D84-2500-D66C2D739CD0}"/>
              </a:ext>
            </a:extLst>
          </p:cNvPr>
          <p:cNvCxnSpPr>
            <a:cxnSpLocks/>
          </p:cNvCxnSpPr>
          <p:nvPr/>
        </p:nvCxnSpPr>
        <p:spPr>
          <a:xfrm flipV="1">
            <a:off x="3486150" y="2714625"/>
            <a:ext cx="95250" cy="2381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26">
            <a:extLst>
              <a:ext uri="{FF2B5EF4-FFF2-40B4-BE49-F238E27FC236}">
                <a16:creationId xmlns:a16="http://schemas.microsoft.com/office/drawing/2014/main" id="{0993C4F0-9CD9-0119-F6CD-4E6DD55BCC2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1644" y="3314147"/>
            <a:ext cx="2521373" cy="3558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39888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0410DB8-75FE-BC52-70BA-044CF3549E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398" y="618072"/>
            <a:ext cx="2090330" cy="359064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037B612-3E26-E651-B74C-07E5C37D2A6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86" t="45394" r="6740" b="858"/>
          <a:stretch/>
        </p:blipFill>
        <p:spPr bwMode="auto">
          <a:xfrm>
            <a:off x="2126097" y="3354099"/>
            <a:ext cx="4690064" cy="1990912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C06F814-6402-5F64-3B54-3F921671868F}"/>
              </a:ext>
            </a:extLst>
          </p:cNvPr>
          <p:cNvSpPr txBox="1"/>
          <p:nvPr/>
        </p:nvSpPr>
        <p:spPr>
          <a:xfrm>
            <a:off x="152305" y="285865"/>
            <a:ext cx="1883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s for figure 6D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74298BC-70FD-8E5E-D8B2-56AADC4A8FB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5" b="7240"/>
          <a:stretch/>
        </p:blipFill>
        <p:spPr bwMode="auto">
          <a:xfrm>
            <a:off x="2364470" y="419960"/>
            <a:ext cx="4137700" cy="291317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C99ED75-16A9-E9E4-D0D8-4EFBB1EA7A77}"/>
              </a:ext>
            </a:extLst>
          </p:cNvPr>
          <p:cNvSpPr txBox="1"/>
          <p:nvPr/>
        </p:nvSpPr>
        <p:spPr>
          <a:xfrm>
            <a:off x="2126765" y="1669897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KX2-5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C192D49-3779-773B-40D0-C646A5C87B74}"/>
              </a:ext>
            </a:extLst>
          </p:cNvPr>
          <p:cNvSpPr/>
          <p:nvPr/>
        </p:nvSpPr>
        <p:spPr>
          <a:xfrm>
            <a:off x="5353050" y="2141888"/>
            <a:ext cx="619125" cy="3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3AED6B2A-799C-EEF0-C927-055C1C0EB8D0}"/>
              </a:ext>
            </a:extLst>
          </p:cNvPr>
          <p:cNvGrpSpPr/>
          <p:nvPr/>
        </p:nvGrpSpPr>
        <p:grpSpPr>
          <a:xfrm>
            <a:off x="6642645" y="132969"/>
            <a:ext cx="5436687" cy="1796748"/>
            <a:chOff x="6688733" y="917370"/>
            <a:chExt cx="5436687" cy="1796748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5">
              <p14:nvContentPartPr>
                <p14:cNvPr id="12" name="Ink 11">
                  <a:extLst>
                    <a:ext uri="{FF2B5EF4-FFF2-40B4-BE49-F238E27FC236}">
                      <a16:creationId xmlns:a16="http://schemas.microsoft.com/office/drawing/2014/main" id="{C86DD16C-C5D0-B443-D459-BEA081F05104}"/>
                    </a:ext>
                  </a:extLst>
                </p14:cNvPr>
                <p14:cNvContentPartPr/>
                <p14:nvPr/>
              </p14:nvContentPartPr>
              <p14:xfrm>
                <a:off x="7934151" y="1913123"/>
                <a:ext cx="360" cy="360"/>
              </p14:xfrm>
            </p:contentPart>
          </mc:Choice>
          <mc:Fallback xmlns="">
            <p:pic>
              <p:nvPicPr>
                <p:cNvPr id="12" name="Ink 11">
                  <a:extLst>
                    <a:ext uri="{FF2B5EF4-FFF2-40B4-BE49-F238E27FC236}">
                      <a16:creationId xmlns:a16="http://schemas.microsoft.com/office/drawing/2014/main" id="{C86DD16C-C5D0-B443-D459-BEA081F05104}"/>
                    </a:ext>
                  </a:extLst>
                </p:cNvPr>
                <p:cNvPicPr/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7925151" y="1904123"/>
                  <a:ext cx="18000" cy="18000"/>
                </a:xfrm>
                <a:prstGeom prst="rect">
                  <a:avLst/>
                </a:prstGeom>
              </p:spPr>
            </p:pic>
          </mc:Fallback>
        </mc:AlternateContent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8FFA765-6F88-3F12-0550-63B77E7B153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 flipH="1">
              <a:off x="6688733" y="917370"/>
              <a:ext cx="5436687" cy="1796748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B242167E-8B8B-CCF8-CB15-8E813FE71897}"/>
                </a:ext>
              </a:extLst>
            </p:cNvPr>
            <p:cNvSpPr/>
            <p:nvPr/>
          </p:nvSpPr>
          <p:spPr>
            <a:xfrm>
              <a:off x="7880802" y="1604493"/>
              <a:ext cx="771525" cy="3205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97730379-E969-530C-B7D1-D0515759DEE1}"/>
              </a:ext>
            </a:extLst>
          </p:cNvPr>
          <p:cNvSpPr txBox="1"/>
          <p:nvPr/>
        </p:nvSpPr>
        <p:spPr>
          <a:xfrm>
            <a:off x="2906103" y="29664"/>
            <a:ext cx="26183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JansonText-Roman"/>
              </a:rPr>
              <a:t>NKX2-5 antibody: a54567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C18D6DF-0B79-7223-F192-8F12D23575E8}"/>
              </a:ext>
            </a:extLst>
          </p:cNvPr>
          <p:cNvSpPr txBox="1"/>
          <p:nvPr/>
        </p:nvSpPr>
        <p:spPr>
          <a:xfrm>
            <a:off x="2325495" y="209309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04DD825-D237-5605-0C56-3FDD6BB0712E}"/>
              </a:ext>
            </a:extLst>
          </p:cNvPr>
          <p:cNvSpPr txBox="1"/>
          <p:nvPr/>
        </p:nvSpPr>
        <p:spPr>
          <a:xfrm>
            <a:off x="2325495" y="236986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3C522663-5620-8413-6ACD-BB53CCE68ECF}"/>
              </a:ext>
            </a:extLst>
          </p:cNvPr>
          <p:cNvGrpSpPr/>
          <p:nvPr/>
        </p:nvGrpSpPr>
        <p:grpSpPr>
          <a:xfrm>
            <a:off x="-79536" y="5631586"/>
            <a:ext cx="3217136" cy="1226414"/>
            <a:chOff x="8369533" y="3343911"/>
            <a:chExt cx="3217136" cy="1226414"/>
          </a:xfrm>
        </p:grpSpPr>
        <p:pic>
          <p:nvPicPr>
            <p:cNvPr id="19" name="Picture 7">
              <a:extLst>
                <a:ext uri="{FF2B5EF4-FFF2-40B4-BE49-F238E27FC236}">
                  <a16:creationId xmlns:a16="http://schemas.microsoft.com/office/drawing/2014/main" id="{472E72EF-2F46-C5E1-D6AE-5986BBD0832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987" r="9684"/>
            <a:stretch/>
          </p:blipFill>
          <p:spPr bwMode="auto">
            <a:xfrm>
              <a:off x="8449305" y="3343911"/>
              <a:ext cx="3137364" cy="120204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E0FF45C-7B33-1092-78B7-27FAD6D973EC}"/>
                </a:ext>
              </a:extLst>
            </p:cNvPr>
            <p:cNvSpPr txBox="1"/>
            <p:nvPr/>
          </p:nvSpPr>
          <p:spPr>
            <a:xfrm>
              <a:off x="10781663" y="3951013"/>
              <a:ext cx="7809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ERK5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B073EC57-4B30-7792-B7DD-3DB52889BDD2}"/>
                </a:ext>
              </a:extLst>
            </p:cNvPr>
            <p:cNvSpPr/>
            <p:nvPr/>
          </p:nvSpPr>
          <p:spPr>
            <a:xfrm>
              <a:off x="10241389" y="4026672"/>
              <a:ext cx="537892" cy="33501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E41C95B-32C5-213D-400D-C00579AF59A5}"/>
                </a:ext>
              </a:extLst>
            </p:cNvPr>
            <p:cNvSpPr txBox="1"/>
            <p:nvPr/>
          </p:nvSpPr>
          <p:spPr>
            <a:xfrm>
              <a:off x="8369533" y="3970862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98kD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2A2F0B6-EEDF-20A6-B0AE-D9AA897CC432}"/>
                </a:ext>
              </a:extLst>
            </p:cNvPr>
            <p:cNvSpPr txBox="1"/>
            <p:nvPr/>
          </p:nvSpPr>
          <p:spPr>
            <a:xfrm>
              <a:off x="8369533" y="4293326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2kDa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B8A5246-041D-C142-B218-ED86EEE4DD98}"/>
              </a:ext>
            </a:extLst>
          </p:cNvPr>
          <p:cNvGrpSpPr/>
          <p:nvPr/>
        </p:nvGrpSpPr>
        <p:grpSpPr>
          <a:xfrm>
            <a:off x="6684463" y="2023447"/>
            <a:ext cx="5353050" cy="2619375"/>
            <a:chOff x="11445627" y="2716984"/>
            <a:chExt cx="5353050" cy="2619375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E771275F-0274-F7C1-7270-272AB4C84DA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 flipH="1">
              <a:off x="11445627" y="2716984"/>
              <a:ext cx="5353050" cy="2619375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C905AF88-563F-6B94-5E13-8FEDCE15DDAA}"/>
                </a:ext>
              </a:extLst>
            </p:cNvPr>
            <p:cNvSpPr/>
            <p:nvPr/>
          </p:nvSpPr>
          <p:spPr>
            <a:xfrm>
              <a:off x="12183001" y="3061571"/>
              <a:ext cx="771525" cy="3205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790096E-B864-D526-22FB-C4F8BB2E7563}"/>
                </a:ext>
              </a:extLst>
            </p:cNvPr>
            <p:cNvSpPr txBox="1"/>
            <p:nvPr/>
          </p:nvSpPr>
          <p:spPr>
            <a:xfrm>
              <a:off x="11566566" y="2719685"/>
              <a:ext cx="10021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SMAD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00E5DAB-94EA-1FC5-681F-DB11B983C305}"/>
                </a:ext>
              </a:extLst>
            </p:cNvPr>
            <p:cNvSpPr txBox="1"/>
            <p:nvPr/>
          </p:nvSpPr>
          <p:spPr>
            <a:xfrm>
              <a:off x="11543140" y="3750716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8kD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2338310-2DD4-BFA4-733A-08E9801D740E}"/>
                </a:ext>
              </a:extLst>
            </p:cNvPr>
            <p:cNvSpPr txBox="1"/>
            <p:nvPr/>
          </p:nvSpPr>
          <p:spPr>
            <a:xfrm>
              <a:off x="11543140" y="2961171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2kD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5934693-FBE2-DCDC-F2E0-C19BDEEF21F1}"/>
                </a:ext>
              </a:extLst>
            </p:cNvPr>
            <p:cNvSpPr txBox="1"/>
            <p:nvPr/>
          </p:nvSpPr>
          <p:spPr>
            <a:xfrm>
              <a:off x="11543140" y="3336893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9kD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1E3B98D-06E4-7E07-54F9-2A8DD7273EFD}"/>
                </a:ext>
              </a:extLst>
            </p:cNvPr>
            <p:cNvSpPr txBox="1"/>
            <p:nvPr/>
          </p:nvSpPr>
          <p:spPr>
            <a:xfrm>
              <a:off x="11552665" y="4163325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8kDa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44EC4933-C5AC-8A9C-FE15-8875581AFC10}"/>
              </a:ext>
            </a:extLst>
          </p:cNvPr>
          <p:cNvGrpSpPr/>
          <p:nvPr/>
        </p:nvGrpSpPr>
        <p:grpSpPr>
          <a:xfrm>
            <a:off x="3217372" y="5431736"/>
            <a:ext cx="4015512" cy="1462319"/>
            <a:chOff x="5524500" y="4868320"/>
            <a:chExt cx="4015512" cy="1462319"/>
          </a:xfrm>
        </p:grpSpPr>
        <p:pic>
          <p:nvPicPr>
            <p:cNvPr id="33" name="Picture 5">
              <a:extLst>
                <a:ext uri="{FF2B5EF4-FFF2-40B4-BE49-F238E27FC236}">
                  <a16:creationId xmlns:a16="http://schemas.microsoft.com/office/drawing/2014/main" id="{33BD5FB9-81E8-5644-D4A1-23B30860786B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6504"/>
            <a:stretch/>
          </p:blipFill>
          <p:spPr bwMode="auto">
            <a:xfrm>
              <a:off x="5524500" y="4868320"/>
              <a:ext cx="4015512" cy="1462319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DE20AA59-4EE3-A94B-3C84-55653281763A}"/>
                </a:ext>
              </a:extLst>
            </p:cNvPr>
            <p:cNvSpPr/>
            <p:nvPr/>
          </p:nvSpPr>
          <p:spPr>
            <a:xfrm>
              <a:off x="8443711" y="5679079"/>
              <a:ext cx="663964" cy="3205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6118E17-D03F-5CD2-4B51-39635AE177A4}"/>
                </a:ext>
              </a:extLst>
            </p:cNvPr>
            <p:cNvSpPr txBox="1"/>
            <p:nvPr/>
          </p:nvSpPr>
          <p:spPr>
            <a:xfrm>
              <a:off x="5579042" y="5282626"/>
              <a:ext cx="136969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ADPH for pERK5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0B5D88B-B653-1DC9-3D02-58F5A81DEF83}"/>
                </a:ext>
              </a:extLst>
            </p:cNvPr>
            <p:cNvSpPr txBox="1"/>
            <p:nvPr/>
          </p:nvSpPr>
          <p:spPr>
            <a:xfrm>
              <a:off x="6397107" y="5751204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8kDa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D61850B7-31A3-53D7-EEC2-36CE96895557}"/>
              </a:ext>
            </a:extLst>
          </p:cNvPr>
          <p:cNvGrpSpPr/>
          <p:nvPr/>
        </p:nvGrpSpPr>
        <p:grpSpPr>
          <a:xfrm>
            <a:off x="6816161" y="4736552"/>
            <a:ext cx="4763976" cy="1086904"/>
            <a:chOff x="7315356" y="4753692"/>
            <a:chExt cx="4763976" cy="1086904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FEBDB793-0746-8E86-7E17-8E14B19BAA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0251" t="24333" b="19008"/>
            <a:stretch/>
          </p:blipFill>
          <p:spPr>
            <a:xfrm flipH="1">
              <a:off x="7315356" y="4753692"/>
              <a:ext cx="4763976" cy="1086904"/>
            </a:xfrm>
            <a:prstGeom prst="rect">
              <a:avLst/>
            </a:prstGeom>
          </p:spPr>
        </p:pic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417A63A0-2A1C-1F91-EE76-03F4763EDE9D}"/>
                </a:ext>
              </a:extLst>
            </p:cNvPr>
            <p:cNvSpPr/>
            <p:nvPr/>
          </p:nvSpPr>
          <p:spPr>
            <a:xfrm>
              <a:off x="8643743" y="5233626"/>
              <a:ext cx="771525" cy="3205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67C6AF7B-13DD-0CCA-D62A-1147AD51A982}"/>
              </a:ext>
            </a:extLst>
          </p:cNvPr>
          <p:cNvSpPr txBox="1"/>
          <p:nvPr/>
        </p:nvSpPr>
        <p:spPr>
          <a:xfrm>
            <a:off x="7685346" y="5704139"/>
            <a:ext cx="299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 for pSMAD3 and ERK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A60A5AF-48A0-CF9A-79E7-48B156498A5C}"/>
              </a:ext>
            </a:extLst>
          </p:cNvPr>
          <p:cNvSpPr txBox="1"/>
          <p:nvPr/>
        </p:nvSpPr>
        <p:spPr>
          <a:xfrm rot="16200000">
            <a:off x="8744314" y="-1517893"/>
            <a:ext cx="1403980" cy="33958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1600"/>
              </a:spcAft>
            </a:pPr>
            <a:r>
              <a:rPr lang="en-GB" sz="1200" b="1" dirty="0"/>
              <a:t>Untreated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PI3K/AKT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PI3K/690693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ASK1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ERK5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ER1,2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P38</a:t>
            </a:r>
          </a:p>
          <a:p>
            <a:pPr>
              <a:spcAft>
                <a:spcPts val="1600"/>
              </a:spcAft>
            </a:pPr>
            <a:r>
              <a:rPr lang="en-GB" sz="1200" b="1" dirty="0" err="1"/>
              <a:t>TGFb</a:t>
            </a:r>
            <a:r>
              <a:rPr lang="en-GB" sz="1200" b="1" dirty="0"/>
              <a:t>/ALK5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Untreated</a:t>
            </a:r>
          </a:p>
        </p:txBody>
      </p:sp>
      <p:sp>
        <p:nvSpPr>
          <p:cNvPr id="42" name="TextBox 4">
            <a:extLst>
              <a:ext uri="{FF2B5EF4-FFF2-40B4-BE49-F238E27FC236}">
                <a16:creationId xmlns:a16="http://schemas.microsoft.com/office/drawing/2014/main" id="{41A7CA88-3FD7-C229-1C89-7416E86F86A9}"/>
              </a:ext>
            </a:extLst>
          </p:cNvPr>
          <p:cNvSpPr txBox="1"/>
          <p:nvPr/>
        </p:nvSpPr>
        <p:spPr>
          <a:xfrm rot="16200000">
            <a:off x="865545" y="4723893"/>
            <a:ext cx="1262352" cy="1769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600"/>
              </a:spcAft>
            </a:pPr>
            <a:r>
              <a:rPr lang="en-GB" sz="1400" b="1" dirty="0"/>
              <a:t>Untreated</a:t>
            </a:r>
          </a:p>
          <a:p>
            <a:pPr>
              <a:spcAft>
                <a:spcPts val="600"/>
              </a:spcAft>
            </a:pPr>
            <a:r>
              <a:rPr lang="en-GB" sz="1400" b="1" dirty="0"/>
              <a:t>AKT</a:t>
            </a:r>
          </a:p>
          <a:p>
            <a:pPr>
              <a:spcAft>
                <a:spcPts val="600"/>
              </a:spcAft>
            </a:pPr>
            <a:r>
              <a:rPr lang="en-GB" sz="1400" b="1" dirty="0"/>
              <a:t>ERK5</a:t>
            </a:r>
          </a:p>
          <a:p>
            <a:pPr>
              <a:spcAft>
                <a:spcPts val="600"/>
              </a:spcAft>
            </a:pPr>
            <a:r>
              <a:rPr lang="en-GB" sz="1400" b="1" dirty="0"/>
              <a:t>ASK1</a:t>
            </a:r>
          </a:p>
          <a:p>
            <a:pPr>
              <a:spcAft>
                <a:spcPts val="600"/>
              </a:spcAft>
            </a:pPr>
            <a:r>
              <a:rPr lang="en-GB" sz="1400" b="1" dirty="0" err="1"/>
              <a:t>TGFb</a:t>
            </a:r>
            <a:r>
              <a:rPr lang="en-GB" sz="1400" b="1" dirty="0"/>
              <a:t>/ALK5</a:t>
            </a:r>
          </a:p>
          <a:p>
            <a:pPr>
              <a:spcAft>
                <a:spcPts val="600"/>
              </a:spcAft>
            </a:pPr>
            <a:r>
              <a:rPr lang="en-GB" sz="1400" b="1" dirty="0"/>
              <a:t>Untreated</a:t>
            </a:r>
          </a:p>
        </p:txBody>
      </p:sp>
      <p:sp>
        <p:nvSpPr>
          <p:cNvPr id="43" name="TextBox 9">
            <a:extLst>
              <a:ext uri="{FF2B5EF4-FFF2-40B4-BE49-F238E27FC236}">
                <a16:creationId xmlns:a16="http://schemas.microsoft.com/office/drawing/2014/main" id="{6B200875-74C8-EDDA-4A19-4ACFF05D3EC7}"/>
              </a:ext>
            </a:extLst>
          </p:cNvPr>
          <p:cNvSpPr txBox="1"/>
          <p:nvPr/>
        </p:nvSpPr>
        <p:spPr>
          <a:xfrm rot="16200000">
            <a:off x="3018412" y="2441845"/>
            <a:ext cx="1519968" cy="29751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400"/>
              </a:spcAft>
            </a:pPr>
            <a:r>
              <a:rPr lang="en-GB" sz="1400" b="1" dirty="0"/>
              <a:t>ASK1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P38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ERK1,2,3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ERK5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Untreated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PI3K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PI3K-690693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HIF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ALK5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Untreated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TAK1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536D637A-5ECA-176F-2E5B-229A5A0635E6}"/>
              </a:ext>
            </a:extLst>
          </p:cNvPr>
          <p:cNvSpPr/>
          <p:nvPr/>
        </p:nvSpPr>
        <p:spPr>
          <a:xfrm>
            <a:off x="4397641" y="4783186"/>
            <a:ext cx="568059" cy="2968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9BC7027-1E8A-E3F2-6552-408DF44DEF3B}"/>
              </a:ext>
            </a:extLst>
          </p:cNvPr>
          <p:cNvSpPr txBox="1"/>
          <p:nvPr/>
        </p:nvSpPr>
        <p:spPr>
          <a:xfrm>
            <a:off x="5304148" y="4043085"/>
            <a:ext cx="12056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for NKX2-5</a:t>
            </a:r>
          </a:p>
        </p:txBody>
      </p:sp>
    </p:spTree>
    <p:extLst>
      <p:ext uri="{BB962C8B-B14F-4D97-AF65-F5344CB8AC3E}">
        <p14:creationId xmlns:p14="http://schemas.microsoft.com/office/powerpoint/2010/main" val="19384046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AF44CBB-FF3C-C845-E71E-054ACBEF7AEB}"/>
              </a:ext>
            </a:extLst>
          </p:cNvPr>
          <p:cNvSpPr txBox="1"/>
          <p:nvPr/>
        </p:nvSpPr>
        <p:spPr>
          <a:xfrm>
            <a:off x="42942" y="1067485"/>
            <a:ext cx="19074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figure 6E</a:t>
            </a:r>
            <a:endParaRPr lang="en-US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76F4AFB9-454E-AEAF-F400-FDEFBAA49F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8877" y="1395128"/>
            <a:ext cx="1228896" cy="406774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EF9E92AA-AC83-FAEC-0E6F-D95705EF9612}"/>
              </a:ext>
            </a:extLst>
          </p:cNvPr>
          <p:cNvSpPr txBox="1"/>
          <p:nvPr/>
        </p:nvSpPr>
        <p:spPr>
          <a:xfrm>
            <a:off x="2858610" y="3244333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B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CB5F315-504B-D92E-B7E0-1C6B751D383D}"/>
              </a:ext>
            </a:extLst>
          </p:cNvPr>
          <p:cNvSpPr txBox="1"/>
          <p:nvPr/>
        </p:nvSpPr>
        <p:spPr>
          <a:xfrm>
            <a:off x="4198839" y="343504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B6B041E-354A-F728-0CBA-B48DF74EC42A}"/>
              </a:ext>
            </a:extLst>
          </p:cNvPr>
          <p:cNvSpPr txBox="1"/>
          <p:nvPr/>
        </p:nvSpPr>
        <p:spPr>
          <a:xfrm>
            <a:off x="4198839" y="311647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9kDa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416AB67C-ED1A-9FDA-1230-7437F5E4363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3536" y="1478148"/>
            <a:ext cx="1008289" cy="3818056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74A98619-C3CF-D02E-B18F-E3FB24D0B9D0}"/>
              </a:ext>
            </a:extLst>
          </p:cNvPr>
          <p:cNvSpPr txBox="1"/>
          <p:nvPr/>
        </p:nvSpPr>
        <p:spPr>
          <a:xfrm>
            <a:off x="6922989" y="3387421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5F172F6-54F4-13BF-69CC-52408A1A7594}"/>
              </a:ext>
            </a:extLst>
          </p:cNvPr>
          <p:cNvSpPr txBox="1"/>
          <p:nvPr/>
        </p:nvSpPr>
        <p:spPr>
          <a:xfrm>
            <a:off x="10123905" y="225249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98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91B97C8-B05F-9311-92DE-5B740264F0D2}"/>
              </a:ext>
            </a:extLst>
          </p:cNvPr>
          <p:cNvSpPr txBox="1"/>
          <p:nvPr/>
        </p:nvSpPr>
        <p:spPr>
          <a:xfrm>
            <a:off x="6922989" y="3696469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834BFD35-CD64-5905-9513-C94435053F06}"/>
              </a:ext>
            </a:extLst>
          </p:cNvPr>
          <p:cNvSpPr/>
          <p:nvPr/>
        </p:nvSpPr>
        <p:spPr>
          <a:xfrm>
            <a:off x="3350467" y="3233959"/>
            <a:ext cx="848372" cy="3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CFEE491-9FB8-E834-D848-67AB84BDE699}"/>
              </a:ext>
            </a:extLst>
          </p:cNvPr>
          <p:cNvSpPr/>
          <p:nvPr/>
        </p:nvSpPr>
        <p:spPr>
          <a:xfrm rot="21287040">
            <a:off x="6069119" y="3419474"/>
            <a:ext cx="848372" cy="3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4DA329E-DBB2-A2EB-6A7D-809D011FE046}"/>
              </a:ext>
            </a:extLst>
          </p:cNvPr>
          <p:cNvSpPr txBox="1"/>
          <p:nvPr/>
        </p:nvSpPr>
        <p:spPr>
          <a:xfrm>
            <a:off x="5171497" y="3393671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KX2-5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F064E2B7-E98E-31A2-73F9-5ED4EDF4626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0909" y="1178048"/>
            <a:ext cx="1838582" cy="497274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220E2BBA-1E7B-5EE8-3925-EE579F0E4F7B}"/>
              </a:ext>
            </a:extLst>
          </p:cNvPr>
          <p:cNvSpPr txBox="1"/>
          <p:nvPr/>
        </p:nvSpPr>
        <p:spPr>
          <a:xfrm>
            <a:off x="10123905" y="291113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2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39DFF80-61C3-AF8C-24C7-5400E45D96F6}"/>
              </a:ext>
            </a:extLst>
          </p:cNvPr>
          <p:cNvSpPr txBox="1"/>
          <p:nvPr/>
        </p:nvSpPr>
        <p:spPr>
          <a:xfrm>
            <a:off x="7641754" y="241024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K5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5E82218-FD3A-3BE7-99DA-ED7DDD462301}"/>
              </a:ext>
            </a:extLst>
          </p:cNvPr>
          <p:cNvSpPr/>
          <p:nvPr/>
        </p:nvSpPr>
        <p:spPr>
          <a:xfrm>
            <a:off x="8739992" y="2459042"/>
            <a:ext cx="1261257" cy="3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98E1E4D-8B1D-F222-0473-23C9124ECCB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998" y="2252498"/>
            <a:ext cx="1619476" cy="24006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090145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566630B-B214-2CCF-E52E-6E93D6F9E769}"/>
              </a:ext>
            </a:extLst>
          </p:cNvPr>
          <p:cNvSpPr txBox="1"/>
          <p:nvPr/>
        </p:nvSpPr>
        <p:spPr>
          <a:xfrm>
            <a:off x="388109" y="143560"/>
            <a:ext cx="19074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figure 7C</a:t>
            </a:r>
            <a:endParaRPr lang="en-US" dirty="0"/>
          </a:p>
        </p:txBody>
      </p:sp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4F07EA81-ACAC-CA4C-6461-500859EB1CA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417820" y="621792"/>
            <a:ext cx="3107056" cy="2807208"/>
          </a:xfrm>
          <a:prstGeom prst="rect">
            <a:avLst/>
          </a:prstGeom>
        </p:spPr>
      </p:pic>
      <p:pic>
        <p:nvPicPr>
          <p:cNvPr id="10" name="Picture 9" descr="A white surface with black lines&#10;&#10;Description automatically generated">
            <a:extLst>
              <a:ext uri="{FF2B5EF4-FFF2-40B4-BE49-F238E27FC236}">
                <a16:creationId xmlns:a16="http://schemas.microsoft.com/office/drawing/2014/main" id="{9A928FFE-0CD4-BCCC-9C69-8F7CAC9B032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764146" y="633984"/>
            <a:ext cx="3351653" cy="2807208"/>
          </a:xfrm>
          <a:prstGeom prst="rect">
            <a:avLst/>
          </a:prstGeom>
        </p:spPr>
      </p:pic>
      <p:pic>
        <p:nvPicPr>
          <p:cNvPr id="3" name="Picture 2" descr="A close-up of a white rectangular object&#10;&#10;Description automatically generated">
            <a:extLst>
              <a:ext uri="{FF2B5EF4-FFF2-40B4-BE49-F238E27FC236}">
                <a16:creationId xmlns:a16="http://schemas.microsoft.com/office/drawing/2014/main" id="{4E2BA53E-8416-A696-405A-2C18C80DCAC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727450" y="3612152"/>
            <a:ext cx="4006340" cy="3041971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5C7A4544-7D61-C96A-14DB-677A5D064060}"/>
              </a:ext>
            </a:extLst>
          </p:cNvPr>
          <p:cNvSpPr/>
          <p:nvPr/>
        </p:nvSpPr>
        <p:spPr>
          <a:xfrm>
            <a:off x="5525342" y="5224194"/>
            <a:ext cx="669083" cy="3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FFDB0A5-7FEF-1C9A-A500-C70ACB39B996}"/>
              </a:ext>
            </a:extLst>
          </p:cNvPr>
          <p:cNvSpPr txBox="1"/>
          <p:nvPr/>
        </p:nvSpPr>
        <p:spPr>
          <a:xfrm>
            <a:off x="4060825" y="6095510"/>
            <a:ext cx="16554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KX2-5 hypoxia</a:t>
            </a:r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E62FB9C-A158-4932-0B74-A4D311F59564}"/>
              </a:ext>
            </a:extLst>
          </p:cNvPr>
          <p:cNvSpPr/>
          <p:nvPr/>
        </p:nvSpPr>
        <p:spPr>
          <a:xfrm>
            <a:off x="7123411" y="1898650"/>
            <a:ext cx="325140" cy="1714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627666E-3267-1F99-E3D8-B931DA6BE0E5}"/>
              </a:ext>
            </a:extLst>
          </p:cNvPr>
          <p:cNvSpPr/>
          <p:nvPr/>
        </p:nvSpPr>
        <p:spPr>
          <a:xfrm>
            <a:off x="10446048" y="1930400"/>
            <a:ext cx="325140" cy="1714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" name="Picture 15" descr="A close-up of a test tube&#10;&#10;Description automatically generated">
            <a:extLst>
              <a:ext uri="{FF2B5EF4-FFF2-40B4-BE49-F238E27FC236}">
                <a16:creationId xmlns:a16="http://schemas.microsoft.com/office/drawing/2014/main" id="{8FA4497D-B078-EDB4-2270-8BA0BC734CB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793273" y="3597783"/>
            <a:ext cx="3825874" cy="321843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3E70B091-6525-D431-BD84-4D97B451E18B}"/>
              </a:ext>
            </a:extLst>
          </p:cNvPr>
          <p:cNvSpPr txBox="1"/>
          <p:nvPr/>
        </p:nvSpPr>
        <p:spPr>
          <a:xfrm>
            <a:off x="8430573" y="5847318"/>
            <a:ext cx="1645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 hypoxia</a:t>
            </a:r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59127C1-5C87-ECB5-4B01-CABAEFC05844}"/>
              </a:ext>
            </a:extLst>
          </p:cNvPr>
          <p:cNvSpPr/>
          <p:nvPr/>
        </p:nvSpPr>
        <p:spPr>
          <a:xfrm>
            <a:off x="9630617" y="4878913"/>
            <a:ext cx="669083" cy="2050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D48CF63-C3F3-956D-E8E6-1A922CB5F84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8109" y="696728"/>
            <a:ext cx="4372585" cy="26387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582444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black line&#10;&#10;Description automatically generated">
            <a:extLst>
              <a:ext uri="{FF2B5EF4-FFF2-40B4-BE49-F238E27FC236}">
                <a16:creationId xmlns:a16="http://schemas.microsoft.com/office/drawing/2014/main" id="{D5F92F0F-5204-894C-A465-1E5118329F6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6328227" y="1126018"/>
            <a:ext cx="3147133" cy="4605963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35D3DB68-4A33-EB2F-34BB-2AED26C52B4A}"/>
              </a:ext>
            </a:extLst>
          </p:cNvPr>
          <p:cNvSpPr/>
          <p:nvPr/>
        </p:nvSpPr>
        <p:spPr>
          <a:xfrm>
            <a:off x="7740585" y="1790913"/>
            <a:ext cx="951658" cy="3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86C362D-B87D-D7A7-BCBA-20E8AA75AE81}"/>
              </a:ext>
            </a:extLst>
          </p:cNvPr>
          <p:cNvSpPr/>
          <p:nvPr/>
        </p:nvSpPr>
        <p:spPr>
          <a:xfrm>
            <a:off x="7105585" y="4549195"/>
            <a:ext cx="951658" cy="3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9BAAFFC-35E3-95FD-33D0-D0319F51DEBC}"/>
              </a:ext>
            </a:extLst>
          </p:cNvPr>
          <p:cNvSpPr txBox="1"/>
          <p:nvPr/>
        </p:nvSpPr>
        <p:spPr>
          <a:xfrm>
            <a:off x="6585516" y="1199271"/>
            <a:ext cx="16258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ardiac NKX2-5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ACE4584-7B8D-7519-CC95-3E884FDAD333}"/>
              </a:ext>
            </a:extLst>
          </p:cNvPr>
          <p:cNvSpPr txBox="1"/>
          <p:nvPr/>
        </p:nvSpPr>
        <p:spPr>
          <a:xfrm>
            <a:off x="6371464" y="499903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  <a:endParaRPr lang="en-US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12C7AB26-1F36-B95E-6913-0BF483A07C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9034" y="913727"/>
            <a:ext cx="3991532" cy="3801005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1E57038C-C5C6-5551-1E21-0F11B2FA6A49}"/>
              </a:ext>
            </a:extLst>
          </p:cNvPr>
          <p:cNvSpPr txBox="1"/>
          <p:nvPr/>
        </p:nvSpPr>
        <p:spPr>
          <a:xfrm>
            <a:off x="388109" y="143560"/>
            <a:ext cx="19074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figure 8F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FDB9CC5-513C-B313-C028-1A14D1DDAB22}"/>
              </a:ext>
            </a:extLst>
          </p:cNvPr>
          <p:cNvSpPr txBox="1"/>
          <p:nvPr/>
        </p:nvSpPr>
        <p:spPr>
          <a:xfrm>
            <a:off x="6617656" y="15323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A84B725-5BD1-D101-460A-FBDCAE8728F8}"/>
              </a:ext>
            </a:extLst>
          </p:cNvPr>
          <p:cNvSpPr txBox="1"/>
          <p:nvPr/>
        </p:nvSpPr>
        <p:spPr>
          <a:xfrm>
            <a:off x="6845912" y="15323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2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CAD1C7D-A30B-0233-902B-2F947BDEED07}"/>
              </a:ext>
            </a:extLst>
          </p:cNvPr>
          <p:cNvSpPr txBox="1"/>
          <p:nvPr/>
        </p:nvSpPr>
        <p:spPr>
          <a:xfrm>
            <a:off x="7044283" y="15323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0AD61B-B356-29A6-CE2E-E9C9FF3F9C09}"/>
              </a:ext>
            </a:extLst>
          </p:cNvPr>
          <p:cNvSpPr txBox="1"/>
          <p:nvPr/>
        </p:nvSpPr>
        <p:spPr>
          <a:xfrm>
            <a:off x="7270885" y="15323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7951800-5779-86F4-D435-D758471A7C15}"/>
              </a:ext>
            </a:extLst>
          </p:cNvPr>
          <p:cNvSpPr txBox="1"/>
          <p:nvPr/>
        </p:nvSpPr>
        <p:spPr>
          <a:xfrm>
            <a:off x="7491264" y="15323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9D4C46E-B7CC-514A-F276-7EC40E57395F}"/>
              </a:ext>
            </a:extLst>
          </p:cNvPr>
          <p:cNvSpPr txBox="1"/>
          <p:nvPr/>
        </p:nvSpPr>
        <p:spPr>
          <a:xfrm>
            <a:off x="7711157" y="15323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6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FFB6C31-0EC1-B2C8-1554-21E67039AFDF}"/>
              </a:ext>
            </a:extLst>
          </p:cNvPr>
          <p:cNvSpPr txBox="1"/>
          <p:nvPr/>
        </p:nvSpPr>
        <p:spPr>
          <a:xfrm>
            <a:off x="7933778" y="15323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7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CE8C495-667B-A2EA-2A1A-F7B09EC5C3A5}"/>
              </a:ext>
            </a:extLst>
          </p:cNvPr>
          <p:cNvSpPr txBox="1"/>
          <p:nvPr/>
        </p:nvSpPr>
        <p:spPr>
          <a:xfrm>
            <a:off x="8180986" y="15323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8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F37F4B2-A5FC-C0A5-71FB-F9E066918F18}"/>
              </a:ext>
            </a:extLst>
          </p:cNvPr>
          <p:cNvSpPr txBox="1"/>
          <p:nvPr/>
        </p:nvSpPr>
        <p:spPr>
          <a:xfrm>
            <a:off x="8409607" y="153235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9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AAD6096-D04C-24EE-D8BF-3F2E42FC9A2E}"/>
              </a:ext>
            </a:extLst>
          </p:cNvPr>
          <p:cNvSpPr txBox="1"/>
          <p:nvPr/>
        </p:nvSpPr>
        <p:spPr>
          <a:xfrm>
            <a:off x="8625568" y="153235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0</a:t>
            </a:r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A1C6FA8-E7A7-E56A-EDCE-7BB8BB50C41D}"/>
              </a:ext>
            </a:extLst>
          </p:cNvPr>
          <p:cNvSpPr txBox="1"/>
          <p:nvPr/>
        </p:nvSpPr>
        <p:spPr>
          <a:xfrm>
            <a:off x="8912915" y="153235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1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B3D5B41-9420-75DB-9C3E-3A55272CCCFC}"/>
              </a:ext>
            </a:extLst>
          </p:cNvPr>
          <p:cNvSpPr txBox="1"/>
          <p:nvPr/>
        </p:nvSpPr>
        <p:spPr>
          <a:xfrm>
            <a:off x="9173015" y="153235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2</a:t>
            </a:r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D1C12AE-CA4F-C615-CF99-4071107319FA}"/>
              </a:ext>
            </a:extLst>
          </p:cNvPr>
          <p:cNvSpPr txBox="1"/>
          <p:nvPr/>
        </p:nvSpPr>
        <p:spPr>
          <a:xfrm>
            <a:off x="8893429" y="417986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</a:t>
            </a:r>
            <a:endParaRPr 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C3041F6-8666-E790-CE77-84A61463AB91}"/>
              </a:ext>
            </a:extLst>
          </p:cNvPr>
          <p:cNvSpPr txBox="1"/>
          <p:nvPr/>
        </p:nvSpPr>
        <p:spPr>
          <a:xfrm>
            <a:off x="8199329" y="438026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6F362F4-754D-1A7A-C387-B12D754D1393}"/>
              </a:ext>
            </a:extLst>
          </p:cNvPr>
          <p:cNvSpPr txBox="1"/>
          <p:nvPr/>
        </p:nvSpPr>
        <p:spPr>
          <a:xfrm>
            <a:off x="7984443" y="439149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</a:t>
            </a:r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BC289CB-C845-3301-1259-661D80D3579D}"/>
              </a:ext>
            </a:extLst>
          </p:cNvPr>
          <p:cNvSpPr txBox="1"/>
          <p:nvPr/>
        </p:nvSpPr>
        <p:spPr>
          <a:xfrm>
            <a:off x="7763702" y="426628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6</a:t>
            </a:r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77E4537-D205-9E5A-4A52-0F20750CA9E3}"/>
              </a:ext>
            </a:extLst>
          </p:cNvPr>
          <p:cNvSpPr txBox="1"/>
          <p:nvPr/>
        </p:nvSpPr>
        <p:spPr>
          <a:xfrm>
            <a:off x="7546451" y="426609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7</a:t>
            </a:r>
            <a:endParaRPr lang="en-US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5A9911F-5BD1-D657-20A6-18D9F0E261E7}"/>
              </a:ext>
            </a:extLst>
          </p:cNvPr>
          <p:cNvSpPr txBox="1"/>
          <p:nvPr/>
        </p:nvSpPr>
        <p:spPr>
          <a:xfrm>
            <a:off x="7335198" y="426609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8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DCFC4AE-B431-6FF0-4D1F-32BE2CBEE0B9}"/>
              </a:ext>
            </a:extLst>
          </p:cNvPr>
          <p:cNvSpPr txBox="1"/>
          <p:nvPr/>
        </p:nvSpPr>
        <p:spPr>
          <a:xfrm>
            <a:off x="7089770" y="426609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9</a:t>
            </a:r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3435353-3533-F883-11C7-CA5DEFB964FC}"/>
              </a:ext>
            </a:extLst>
          </p:cNvPr>
          <p:cNvSpPr txBox="1"/>
          <p:nvPr/>
        </p:nvSpPr>
        <p:spPr>
          <a:xfrm>
            <a:off x="6770641" y="426609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0</a:t>
            </a:r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EE2717D-5BDC-9E78-1EF7-23C820874804}"/>
              </a:ext>
            </a:extLst>
          </p:cNvPr>
          <p:cNvSpPr txBox="1"/>
          <p:nvPr/>
        </p:nvSpPr>
        <p:spPr>
          <a:xfrm>
            <a:off x="6573380" y="443201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1</a:t>
            </a:r>
            <a:endParaRPr 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D1238C1-E85A-C073-3F3E-5D86E0CBE8D9}"/>
              </a:ext>
            </a:extLst>
          </p:cNvPr>
          <p:cNvSpPr txBox="1"/>
          <p:nvPr/>
        </p:nvSpPr>
        <p:spPr>
          <a:xfrm>
            <a:off x="6329403" y="437661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2</a:t>
            </a:r>
            <a:endParaRPr 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F6F220F-AC6B-D905-B596-000220F27E64}"/>
              </a:ext>
            </a:extLst>
          </p:cNvPr>
          <p:cNvSpPr txBox="1"/>
          <p:nvPr/>
        </p:nvSpPr>
        <p:spPr>
          <a:xfrm>
            <a:off x="8611229" y="426628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2</a:t>
            </a:r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D3CE195-F962-72F3-CD90-75B65179A722}"/>
              </a:ext>
            </a:extLst>
          </p:cNvPr>
          <p:cNvSpPr txBox="1"/>
          <p:nvPr/>
        </p:nvSpPr>
        <p:spPr>
          <a:xfrm>
            <a:off x="8403477" y="437661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948951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FDD3D08-4764-D0BB-5E18-DFA625AE08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029" y="1603271"/>
            <a:ext cx="3614228" cy="203300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B5746EE-56CA-FABD-F449-638CD2A659E6}"/>
              </a:ext>
            </a:extLst>
          </p:cNvPr>
          <p:cNvSpPr txBox="1"/>
          <p:nvPr/>
        </p:nvSpPr>
        <p:spPr>
          <a:xfrm>
            <a:off x="388108" y="143560"/>
            <a:ext cx="24421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</a:t>
            </a:r>
            <a:r>
              <a:rPr lang="en-GB" dirty="0" err="1"/>
              <a:t>suppl</a:t>
            </a:r>
            <a:r>
              <a:rPr lang="en-GB" dirty="0"/>
              <a:t> figure 6E</a:t>
            </a:r>
            <a:endParaRPr lang="en-US" dirty="0"/>
          </a:p>
        </p:txBody>
      </p:sp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801BAD8B-3657-E439-84F5-5501B7598B1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73936" y="197585"/>
            <a:ext cx="4332515" cy="2422187"/>
          </a:xfrm>
          <a:prstGeom prst="rect">
            <a:avLst/>
          </a:prstGeom>
        </p:spPr>
      </p:pic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744151D6-5D3B-B5F6-DC47-9B3FB734638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773936" y="3019425"/>
            <a:ext cx="4156586" cy="276225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B502056-235C-E043-2E28-BF1CA61065F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28518" y="2419724"/>
            <a:ext cx="2539455" cy="40920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0459FD8-F975-19CD-0AEC-CA40CBAEE59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8644"/>
          <a:stretch/>
        </p:blipFill>
        <p:spPr>
          <a:xfrm>
            <a:off x="1028517" y="3000375"/>
            <a:ext cx="2543357" cy="2640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F7C429D-4CFC-BDD5-8F7B-EE92DECBB2B8}"/>
              </a:ext>
            </a:extLst>
          </p:cNvPr>
          <p:cNvSpPr txBox="1"/>
          <p:nvPr/>
        </p:nvSpPr>
        <p:spPr>
          <a:xfrm>
            <a:off x="6292016" y="1085850"/>
            <a:ext cx="673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OL1</a:t>
            </a:r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C2E901B-175E-8111-971B-D5E82E0B0DD7}"/>
              </a:ext>
            </a:extLst>
          </p:cNvPr>
          <p:cNvSpPr txBox="1"/>
          <p:nvPr/>
        </p:nvSpPr>
        <p:spPr>
          <a:xfrm>
            <a:off x="6096000" y="3645799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1C664A6-6367-01E6-1AAB-5567E758C241}"/>
              </a:ext>
            </a:extLst>
          </p:cNvPr>
          <p:cNvSpPr txBox="1"/>
          <p:nvPr/>
        </p:nvSpPr>
        <p:spPr>
          <a:xfrm>
            <a:off x="8916537" y="3252716"/>
            <a:ext cx="2743200" cy="3657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dirty="0">
                <a:cs typeface="Calibri"/>
              </a:rPr>
              <a:t>Higher expos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1307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 flipH="1">
            <a:off x="4611745" y="1031760"/>
            <a:ext cx="4979558" cy="3970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9592444" y="609477"/>
            <a:ext cx="1871152" cy="468153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43F6FFC-58D9-8AC3-B022-60F9050BEFE6}"/>
              </a:ext>
            </a:extLst>
          </p:cNvPr>
          <p:cNvSpPr txBox="1"/>
          <p:nvPr/>
        </p:nvSpPr>
        <p:spPr>
          <a:xfrm>
            <a:off x="1062182" y="240145"/>
            <a:ext cx="36312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Unedited Western blots for figure 2B</a:t>
            </a:r>
            <a:endParaRPr lang="en-US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FE5EEAF1-A486-2503-5C01-6EB8BF1AEEC9}"/>
              </a:ext>
            </a:extLst>
          </p:cNvPr>
          <p:cNvSpPr/>
          <p:nvPr/>
        </p:nvSpPr>
        <p:spPr>
          <a:xfrm>
            <a:off x="7033289" y="3615030"/>
            <a:ext cx="1699491" cy="563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5762434-B673-84A5-B31D-C533133E0AEB}"/>
              </a:ext>
            </a:extLst>
          </p:cNvPr>
          <p:cNvSpPr/>
          <p:nvPr/>
        </p:nvSpPr>
        <p:spPr>
          <a:xfrm>
            <a:off x="9534727" y="3679102"/>
            <a:ext cx="1794295" cy="5865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A7805FDF-A19C-01D8-73F5-280AD138010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09683" y="1433470"/>
            <a:ext cx="1581806" cy="4180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44C349A-8029-7967-927A-CE516B9B6631}"/>
              </a:ext>
            </a:extLst>
          </p:cNvPr>
          <p:cNvSpPr txBox="1"/>
          <p:nvPr/>
        </p:nvSpPr>
        <p:spPr>
          <a:xfrm>
            <a:off x="489892" y="1557573"/>
            <a:ext cx="9197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Helvetica" panose="020B0604020202020204" pitchFamily="34" charset="0"/>
                <a:cs typeface="Helvetica" panose="020B0604020202020204" pitchFamily="34" charset="0"/>
              </a:rPr>
              <a:t>NKX2-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B294E5-BFA6-E6CD-7AEF-152F22D9DAA6}"/>
              </a:ext>
            </a:extLst>
          </p:cNvPr>
          <p:cNvSpPr txBox="1"/>
          <p:nvPr/>
        </p:nvSpPr>
        <p:spPr>
          <a:xfrm>
            <a:off x="656518" y="1889550"/>
            <a:ext cx="5822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600" dirty="0">
                <a:latin typeface="Helvetica" panose="020B0604020202020204" pitchFamily="34" charset="0"/>
                <a:cs typeface="Helvetica" panose="020B0604020202020204" pitchFamily="34" charset="0"/>
              </a:rPr>
              <a:t>TB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1E772CA-BA61-D220-47D3-ABF571A4256F}"/>
              </a:ext>
            </a:extLst>
          </p:cNvPr>
          <p:cNvSpPr txBox="1"/>
          <p:nvPr/>
        </p:nvSpPr>
        <p:spPr>
          <a:xfrm>
            <a:off x="7391526" y="4256185"/>
            <a:ext cx="9197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>
                <a:latin typeface="Helvetica" panose="020B0604020202020204" pitchFamily="34" charset="0"/>
                <a:cs typeface="Helvetica" panose="020B0604020202020204" pitchFamily="34" charset="0"/>
              </a:rPr>
              <a:t>NKX2-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14B11ED-CE24-366F-9772-12F5F5D7DBA0}"/>
              </a:ext>
            </a:extLst>
          </p:cNvPr>
          <p:cNvSpPr txBox="1"/>
          <p:nvPr/>
        </p:nvSpPr>
        <p:spPr>
          <a:xfrm>
            <a:off x="9888670" y="4439798"/>
            <a:ext cx="5822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600" dirty="0">
                <a:latin typeface="Helvetica" panose="020B0604020202020204" pitchFamily="34" charset="0"/>
                <a:cs typeface="Helvetica" panose="020B0604020202020204" pitchFamily="34" charset="0"/>
              </a:rPr>
              <a:t>TB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27A2E1D-4C02-2536-C8DA-130733F31E3A}"/>
              </a:ext>
            </a:extLst>
          </p:cNvPr>
          <p:cNvSpPr txBox="1"/>
          <p:nvPr/>
        </p:nvSpPr>
        <p:spPr>
          <a:xfrm>
            <a:off x="5752213" y="4991609"/>
            <a:ext cx="26986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JansonText-Roman"/>
              </a:rPr>
              <a:t>NKX2-5 antibody: E1Y8H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63C4422-D1FE-AC2D-9BB9-6191C9B1C339}"/>
              </a:ext>
            </a:extLst>
          </p:cNvPr>
          <p:cNvSpPr txBox="1"/>
          <p:nvPr/>
        </p:nvSpPr>
        <p:spPr>
          <a:xfrm>
            <a:off x="9111834" y="385996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0AFCB14-25FC-FB46-76A5-A1454EED26F7}"/>
              </a:ext>
            </a:extLst>
          </p:cNvPr>
          <p:cNvSpPr txBox="1"/>
          <p:nvPr/>
        </p:nvSpPr>
        <p:spPr>
          <a:xfrm>
            <a:off x="4866183" y="432399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8129A36-E324-85F6-9512-ECEA7B4CAF6C}"/>
              </a:ext>
            </a:extLst>
          </p:cNvPr>
          <p:cNvSpPr txBox="1"/>
          <p:nvPr/>
        </p:nvSpPr>
        <p:spPr>
          <a:xfrm>
            <a:off x="9111834" y="323772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7B511B-44BE-16CE-5A61-A757B9366098}"/>
              </a:ext>
            </a:extLst>
          </p:cNvPr>
          <p:cNvSpPr txBox="1"/>
          <p:nvPr/>
        </p:nvSpPr>
        <p:spPr>
          <a:xfrm>
            <a:off x="4854201" y="383138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kDa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C3DF3EC0-39B2-9B34-B4C4-3662A83627E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409679" y="1851481"/>
            <a:ext cx="1581809" cy="35249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4194498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10">
            <a:extLst>
              <a:ext uri="{FF2B5EF4-FFF2-40B4-BE49-F238E27FC236}">
                <a16:creationId xmlns:a16="http://schemas.microsoft.com/office/drawing/2014/main" id="{FAE965A1-1B85-43DE-A23E-3B0679AE1F5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59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740" t="-1249" r="-338" b="-2"/>
          <a:stretch/>
        </p:blipFill>
        <p:spPr bwMode="auto">
          <a:xfrm rot="16200000">
            <a:off x="4427071" y="4447375"/>
            <a:ext cx="2524419" cy="134060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ECBE821-42A0-4D15-AEE9-5823945E570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372781" y="234865"/>
            <a:ext cx="1349656" cy="32061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94FA385-8809-4F28-BB80-FD3F777537E6}"/>
              </a:ext>
            </a:extLst>
          </p:cNvPr>
          <p:cNvSpPr txBox="1"/>
          <p:nvPr/>
        </p:nvSpPr>
        <p:spPr>
          <a:xfrm>
            <a:off x="3429501" y="970618"/>
            <a:ext cx="1305418" cy="3693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15D17D3-BA1E-4384-90A6-7E93F6E62093}"/>
              </a:ext>
            </a:extLst>
          </p:cNvPr>
          <p:cNvSpPr txBox="1"/>
          <p:nvPr/>
        </p:nvSpPr>
        <p:spPr>
          <a:xfrm>
            <a:off x="2782273" y="930285"/>
            <a:ext cx="55656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/>
              <a:t>FN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DD62F02-5B08-409E-AB86-90723D464744}"/>
              </a:ext>
            </a:extLst>
          </p:cNvPr>
          <p:cNvSpPr txBox="1"/>
          <p:nvPr/>
        </p:nvSpPr>
        <p:spPr>
          <a:xfrm>
            <a:off x="381080" y="588041"/>
            <a:ext cx="21412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Figure 3 A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E415E50-721C-4D4F-A316-AA4E3231A15C}"/>
              </a:ext>
            </a:extLst>
          </p:cNvPr>
          <p:cNvSpPr/>
          <p:nvPr/>
        </p:nvSpPr>
        <p:spPr>
          <a:xfrm>
            <a:off x="5052015" y="5097935"/>
            <a:ext cx="1285136" cy="3693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1B33612-8254-4E53-BCB7-DE9AB2321756}"/>
              </a:ext>
            </a:extLst>
          </p:cNvPr>
          <p:cNvSpPr txBox="1"/>
          <p:nvPr/>
        </p:nvSpPr>
        <p:spPr>
          <a:xfrm>
            <a:off x="5458385" y="3835744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NKX2-5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1E9E8DBC-A4F2-4DA5-9BD5-9AAE89F524C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823" r="776" b="9124"/>
          <a:stretch/>
        </p:blipFill>
        <p:spPr>
          <a:xfrm>
            <a:off x="5185881" y="199760"/>
            <a:ext cx="1297343" cy="32061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0DEC7C2-F7A0-49E9-9BE4-8065EF3A4211}"/>
              </a:ext>
            </a:extLst>
          </p:cNvPr>
          <p:cNvSpPr txBox="1"/>
          <p:nvPr/>
        </p:nvSpPr>
        <p:spPr>
          <a:xfrm>
            <a:off x="5654757" y="150500"/>
            <a:ext cx="784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ACTA2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8BD16E7-15C5-4D9B-88D3-8EB419E7B758}"/>
              </a:ext>
            </a:extLst>
          </p:cNvPr>
          <p:cNvSpPr/>
          <p:nvPr/>
        </p:nvSpPr>
        <p:spPr>
          <a:xfrm>
            <a:off x="5252847" y="1803826"/>
            <a:ext cx="1186805" cy="43257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7" name="Picture 9">
            <a:extLst>
              <a:ext uri="{FF2B5EF4-FFF2-40B4-BE49-F238E27FC236}">
                <a16:creationId xmlns:a16="http://schemas.microsoft.com/office/drawing/2014/main" id="{2678878C-093B-4281-8024-C437A8EADE0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grayscl/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colorTemperature colorTemp="59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611" t="-803" r="-1606" b="12073"/>
          <a:stretch/>
        </p:blipFill>
        <p:spPr bwMode="auto">
          <a:xfrm flipH="1">
            <a:off x="6991728" y="195697"/>
            <a:ext cx="1220253" cy="320614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0D0BDDF1-43FD-4627-9C13-09C7E776E272}"/>
              </a:ext>
            </a:extLst>
          </p:cNvPr>
          <p:cNvSpPr txBox="1"/>
          <p:nvPr/>
        </p:nvSpPr>
        <p:spPr>
          <a:xfrm>
            <a:off x="7364480" y="195696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SMTN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9E490237-8AF9-4A76-9CAA-AB9EB66D86D8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grayscl/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colorTemperature colorTemp="59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-907"/>
          <a:stretch/>
        </p:blipFill>
        <p:spPr>
          <a:xfrm>
            <a:off x="8399526" y="371785"/>
            <a:ext cx="3741035" cy="3057215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B5B34BBA-A603-4288-BBBD-1331CC5FC8CD}"/>
              </a:ext>
            </a:extLst>
          </p:cNvPr>
          <p:cNvSpPr/>
          <p:nvPr/>
        </p:nvSpPr>
        <p:spPr>
          <a:xfrm>
            <a:off x="10485623" y="1924481"/>
            <a:ext cx="1080654" cy="36933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EDC18CB-1974-4AD4-8E95-DD7899D51041}"/>
              </a:ext>
            </a:extLst>
          </p:cNvPr>
          <p:cNvSpPr txBox="1"/>
          <p:nvPr/>
        </p:nvSpPr>
        <p:spPr>
          <a:xfrm>
            <a:off x="8433486" y="380362"/>
            <a:ext cx="12691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CN1/CTGF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DF4327F-56E5-CA0D-6CD0-27909867DB7F}"/>
              </a:ext>
            </a:extLst>
          </p:cNvPr>
          <p:cNvSpPr txBox="1"/>
          <p:nvPr/>
        </p:nvSpPr>
        <p:spPr>
          <a:xfrm>
            <a:off x="4520000" y="6360126"/>
            <a:ext cx="220284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600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JansonText-Roman"/>
              </a:rPr>
              <a:t>NKX2-5 antibody: E1Y8H</a:t>
            </a:r>
            <a:endParaRPr lang="en-US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CFB1818-7644-9C0A-C683-FC531EAD7EAE}"/>
              </a:ext>
            </a:extLst>
          </p:cNvPr>
          <p:cNvSpPr txBox="1"/>
          <p:nvPr/>
        </p:nvSpPr>
        <p:spPr>
          <a:xfrm>
            <a:off x="2698558" y="1339950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98kD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950B619-8676-B61E-92D4-095840883D86}"/>
              </a:ext>
            </a:extLst>
          </p:cNvPr>
          <p:cNvSpPr txBox="1"/>
          <p:nvPr/>
        </p:nvSpPr>
        <p:spPr>
          <a:xfrm>
            <a:off x="4681025" y="208440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9C336D2-01B9-AFAB-CF7B-E3ADA13BF1D0}"/>
              </a:ext>
            </a:extLst>
          </p:cNvPr>
          <p:cNvSpPr txBox="1"/>
          <p:nvPr/>
        </p:nvSpPr>
        <p:spPr>
          <a:xfrm>
            <a:off x="4432081" y="5135891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47F0601-0624-9F6E-271A-4312C640E840}"/>
              </a:ext>
            </a:extLst>
          </p:cNvPr>
          <p:cNvSpPr txBox="1"/>
          <p:nvPr/>
        </p:nvSpPr>
        <p:spPr>
          <a:xfrm>
            <a:off x="4427772" y="546426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2FE04AC-852B-421C-25BB-07238D9BE4F2}"/>
              </a:ext>
            </a:extLst>
          </p:cNvPr>
          <p:cNvSpPr txBox="1"/>
          <p:nvPr/>
        </p:nvSpPr>
        <p:spPr>
          <a:xfrm>
            <a:off x="4681025" y="178029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9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1055158-134F-6A99-F0CA-F59C2919D7EC}"/>
              </a:ext>
            </a:extLst>
          </p:cNvPr>
          <p:cNvSpPr txBox="1"/>
          <p:nvPr/>
        </p:nvSpPr>
        <p:spPr>
          <a:xfrm>
            <a:off x="11548289" y="204509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2353119-92A1-D360-8BBE-FCCD37189266}"/>
              </a:ext>
            </a:extLst>
          </p:cNvPr>
          <p:cNvSpPr txBox="1"/>
          <p:nvPr/>
        </p:nvSpPr>
        <p:spPr>
          <a:xfrm>
            <a:off x="6500039" y="130282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9kDa</a:t>
            </a:r>
          </a:p>
        </p:txBody>
      </p:sp>
      <p:grpSp>
        <p:nvGrpSpPr>
          <p:cNvPr id="1028" name="Group 1027">
            <a:extLst>
              <a:ext uri="{FF2B5EF4-FFF2-40B4-BE49-F238E27FC236}">
                <a16:creationId xmlns:a16="http://schemas.microsoft.com/office/drawing/2014/main" id="{76A19AE7-EDA3-7032-CBC5-51EBF99507AF}"/>
              </a:ext>
            </a:extLst>
          </p:cNvPr>
          <p:cNvGrpSpPr/>
          <p:nvPr/>
        </p:nvGrpSpPr>
        <p:grpSpPr>
          <a:xfrm>
            <a:off x="6328690" y="3724793"/>
            <a:ext cx="1941083" cy="2982707"/>
            <a:chOff x="6328690" y="3724793"/>
            <a:chExt cx="1941083" cy="2982707"/>
          </a:xfrm>
        </p:grpSpPr>
        <p:pic>
          <p:nvPicPr>
            <p:cNvPr id="33" name="Picture 7">
              <a:extLst>
                <a:ext uri="{FF2B5EF4-FFF2-40B4-BE49-F238E27FC236}">
                  <a16:creationId xmlns:a16="http://schemas.microsoft.com/office/drawing/2014/main" id="{B07659F6-FF64-4375-8FD6-198FB286304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colorTemperature colorTemp="59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2" b="12145"/>
            <a:stretch/>
          </p:blipFill>
          <p:spPr bwMode="auto">
            <a:xfrm flipV="1">
              <a:off x="6929166" y="3726758"/>
              <a:ext cx="1340607" cy="298074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CDDC0619-31D8-4D38-870F-7830F9EF1C73}"/>
                </a:ext>
              </a:extLst>
            </p:cNvPr>
            <p:cNvSpPr/>
            <p:nvPr/>
          </p:nvSpPr>
          <p:spPr>
            <a:xfrm>
              <a:off x="6913771" y="4160821"/>
              <a:ext cx="1326531" cy="369333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73B2975-1D40-46FD-9CE0-15354C4A95CD}"/>
                </a:ext>
              </a:extLst>
            </p:cNvPr>
            <p:cNvSpPr txBox="1"/>
            <p:nvPr/>
          </p:nvSpPr>
          <p:spPr>
            <a:xfrm>
              <a:off x="7189587" y="3724793"/>
              <a:ext cx="6731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COL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975D728-983D-84AE-8C9C-6B612D0564CD}"/>
                </a:ext>
              </a:extLst>
            </p:cNvPr>
            <p:cNvSpPr txBox="1"/>
            <p:nvPr/>
          </p:nvSpPr>
          <p:spPr>
            <a:xfrm>
              <a:off x="6328690" y="3945995"/>
              <a:ext cx="6591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98kD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7635A0E-AECB-0D0A-F425-E68598F80F76}"/>
                </a:ext>
              </a:extLst>
            </p:cNvPr>
            <p:cNvSpPr txBox="1"/>
            <p:nvPr/>
          </p:nvSpPr>
          <p:spPr>
            <a:xfrm>
              <a:off x="6386134" y="4367046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98kDa</a:t>
              </a:r>
            </a:p>
          </p:txBody>
        </p:sp>
      </p:grpSp>
      <p:grpSp>
        <p:nvGrpSpPr>
          <p:cNvPr id="1029" name="Group 1028">
            <a:extLst>
              <a:ext uri="{FF2B5EF4-FFF2-40B4-BE49-F238E27FC236}">
                <a16:creationId xmlns:a16="http://schemas.microsoft.com/office/drawing/2014/main" id="{887FA069-6ED9-D1BE-BDD8-2EA9A37F7A12}"/>
              </a:ext>
            </a:extLst>
          </p:cNvPr>
          <p:cNvGrpSpPr/>
          <p:nvPr/>
        </p:nvGrpSpPr>
        <p:grpSpPr>
          <a:xfrm>
            <a:off x="8206273" y="3654612"/>
            <a:ext cx="3926685" cy="3069915"/>
            <a:chOff x="8269773" y="3629212"/>
            <a:chExt cx="3926685" cy="3069915"/>
          </a:xfrm>
        </p:grpSpPr>
        <p:pic>
          <p:nvPicPr>
            <p:cNvPr id="45" name="Picture 44">
              <a:extLst>
                <a:ext uri="{FF2B5EF4-FFF2-40B4-BE49-F238E27FC236}">
                  <a16:creationId xmlns:a16="http://schemas.microsoft.com/office/drawing/2014/main" id="{E0312B37-C2FD-4B98-A5D7-BF52343D4E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colorTemperature colorTemp="59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75"/>
            <a:stretch/>
          </p:blipFill>
          <p:spPr>
            <a:xfrm>
              <a:off x="8453140" y="3629212"/>
              <a:ext cx="3743318" cy="306991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ADB01C4-4CF4-4714-8097-E9D6936103D5}"/>
                </a:ext>
              </a:extLst>
            </p:cNvPr>
            <p:cNvSpPr txBox="1"/>
            <p:nvPr/>
          </p:nvSpPr>
          <p:spPr>
            <a:xfrm>
              <a:off x="8588185" y="3652809"/>
              <a:ext cx="9220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GAPDH 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F72E833C-86C3-489C-BDC9-7A152FAE814C}"/>
                </a:ext>
              </a:extLst>
            </p:cNvPr>
            <p:cNvSpPr/>
            <p:nvPr/>
          </p:nvSpPr>
          <p:spPr>
            <a:xfrm>
              <a:off x="10678526" y="4737289"/>
              <a:ext cx="1025240" cy="368744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E13C9D3-04B7-53B3-4CEE-DAFCBB3339F0}"/>
                </a:ext>
              </a:extLst>
            </p:cNvPr>
            <p:cNvSpPr txBox="1"/>
            <p:nvPr/>
          </p:nvSpPr>
          <p:spPr>
            <a:xfrm>
              <a:off x="8269773" y="4840680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8kDa</a:t>
              </a:r>
            </a:p>
          </p:txBody>
        </p:sp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369F39FC-84E6-B54B-B230-C37882499B28}"/>
              </a:ext>
            </a:extLst>
          </p:cNvPr>
          <p:cNvSpPr txBox="1"/>
          <p:nvPr/>
        </p:nvSpPr>
        <p:spPr>
          <a:xfrm>
            <a:off x="6500039" y="91120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2kDa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CE65153C-EA72-4A11-400E-5F664454D3C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60659" y="3554800"/>
            <a:ext cx="1486147" cy="3057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20D95A9-82C7-499D-AC8B-02CC0BA1BF81}"/>
              </a:ext>
            </a:extLst>
          </p:cNvPr>
          <p:cNvSpPr txBox="1"/>
          <p:nvPr/>
        </p:nvSpPr>
        <p:spPr>
          <a:xfrm>
            <a:off x="3025652" y="3949089"/>
            <a:ext cx="1283934" cy="36933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F9EB673-84E0-4B42-9C21-0CB54FC08656}"/>
              </a:ext>
            </a:extLst>
          </p:cNvPr>
          <p:cNvSpPr txBox="1"/>
          <p:nvPr/>
        </p:nvSpPr>
        <p:spPr>
          <a:xfrm>
            <a:off x="2218190" y="3893054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YH1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3C476EF-94E5-D06C-01F5-A9EE8F941ED4}"/>
              </a:ext>
            </a:extLst>
          </p:cNvPr>
          <p:cNvSpPr txBox="1"/>
          <p:nvPr/>
        </p:nvSpPr>
        <p:spPr>
          <a:xfrm>
            <a:off x="2218190" y="4262386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98kDa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693BDD8A-F8FD-BA0B-4947-17473D54E10D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2129" y="1319965"/>
            <a:ext cx="2079509" cy="3139851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BF293408-33CA-A0A8-1CB1-3D020796E2B1}"/>
              </a:ext>
            </a:extLst>
          </p:cNvPr>
          <p:cNvSpPr/>
          <p:nvPr/>
        </p:nvSpPr>
        <p:spPr>
          <a:xfrm>
            <a:off x="7005287" y="1078575"/>
            <a:ext cx="1186805" cy="43257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82805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83A58578-A2D9-7749-326E-C71DB5043D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8225" y="4795139"/>
            <a:ext cx="4246500" cy="186750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72D531B-369D-7811-41EF-C89659EBD1E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10800000">
            <a:off x="2938372" y="549427"/>
            <a:ext cx="5253487" cy="204585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6B3A51E-91DA-38FD-CB8F-5BE59ABA9A22}"/>
              </a:ext>
            </a:extLst>
          </p:cNvPr>
          <p:cNvSpPr txBox="1"/>
          <p:nvPr/>
        </p:nvSpPr>
        <p:spPr>
          <a:xfrm>
            <a:off x="566166" y="549426"/>
            <a:ext cx="20789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figure 4A</a:t>
            </a:r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59323F1-FAE4-3CF7-86E7-E9DFFC6F8A1E}"/>
              </a:ext>
            </a:extLst>
          </p:cNvPr>
          <p:cNvSpPr/>
          <p:nvPr/>
        </p:nvSpPr>
        <p:spPr>
          <a:xfrm>
            <a:off x="4606146" y="1430806"/>
            <a:ext cx="1463616" cy="2493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640F2CE-A230-E318-9AB5-A8730DB47DD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16010" y="2648612"/>
            <a:ext cx="5193102" cy="1914762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4F628CDA-D1FC-2024-D254-7A1A39A4E380}"/>
              </a:ext>
            </a:extLst>
          </p:cNvPr>
          <p:cNvSpPr/>
          <p:nvPr/>
        </p:nvSpPr>
        <p:spPr>
          <a:xfrm>
            <a:off x="4821806" y="3801548"/>
            <a:ext cx="1480868" cy="2493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9C20C12-0239-87A1-19E5-E43A916AB390}"/>
              </a:ext>
            </a:extLst>
          </p:cNvPr>
          <p:cNvSpPr/>
          <p:nvPr/>
        </p:nvSpPr>
        <p:spPr>
          <a:xfrm>
            <a:off x="4457930" y="5626123"/>
            <a:ext cx="2258812" cy="2493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E670D596-B647-B478-E2AF-A7BAE8018B2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7363467" y="4734754"/>
            <a:ext cx="3369465" cy="1963111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465EA8BD-B776-BB4E-9A98-41659920D396}"/>
              </a:ext>
            </a:extLst>
          </p:cNvPr>
          <p:cNvSpPr/>
          <p:nvPr/>
        </p:nvSpPr>
        <p:spPr>
          <a:xfrm>
            <a:off x="8307765" y="5020574"/>
            <a:ext cx="2121470" cy="2811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A32329E-FFA3-2250-8638-928FD47BF3F0}"/>
              </a:ext>
            </a:extLst>
          </p:cNvPr>
          <p:cNvSpPr txBox="1"/>
          <p:nvPr/>
        </p:nvSpPr>
        <p:spPr>
          <a:xfrm>
            <a:off x="4056441" y="2868164"/>
            <a:ext cx="80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GLN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E1BF01B-A8F0-241B-EF34-8B75213E34C1}"/>
              </a:ext>
            </a:extLst>
          </p:cNvPr>
          <p:cNvSpPr txBox="1"/>
          <p:nvPr/>
        </p:nvSpPr>
        <p:spPr>
          <a:xfrm>
            <a:off x="3333166" y="493283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NN1</a:t>
            </a:r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1F1ED7E-FA28-CB98-53A1-E8725AD0AC8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0328" y="95019"/>
            <a:ext cx="3152813" cy="4579797"/>
          </a:xfrm>
          <a:prstGeom prst="rect">
            <a:avLst/>
          </a:prstGeom>
        </p:spPr>
      </p:pic>
      <p:sp>
        <p:nvSpPr>
          <p:cNvPr id="22" name="Rectangle 21">
            <a:extLst>
              <a:ext uri="{FF2B5EF4-FFF2-40B4-BE49-F238E27FC236}">
                <a16:creationId xmlns:a16="http://schemas.microsoft.com/office/drawing/2014/main" id="{143DBF08-1FA5-299F-D3DC-AA8C7DC0A6AE}"/>
              </a:ext>
            </a:extLst>
          </p:cNvPr>
          <p:cNvSpPr/>
          <p:nvPr/>
        </p:nvSpPr>
        <p:spPr>
          <a:xfrm>
            <a:off x="10013975" y="3215288"/>
            <a:ext cx="926341" cy="2436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4D4DE9A-B1B0-9E32-58A3-B8D2AE69D604}"/>
              </a:ext>
            </a:extLst>
          </p:cNvPr>
          <p:cNvSpPr/>
          <p:nvPr/>
        </p:nvSpPr>
        <p:spPr>
          <a:xfrm>
            <a:off x="9087634" y="3185319"/>
            <a:ext cx="926341" cy="2436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E38B069-E61B-5F3D-7071-8AC9C53657D0}"/>
              </a:ext>
            </a:extLst>
          </p:cNvPr>
          <p:cNvSpPr txBox="1"/>
          <p:nvPr/>
        </p:nvSpPr>
        <p:spPr>
          <a:xfrm>
            <a:off x="11115675" y="438897"/>
            <a:ext cx="11680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OL1 high exposure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7A43B22-83BD-4653-DC7F-539A1E3430BD}"/>
              </a:ext>
            </a:extLst>
          </p:cNvPr>
          <p:cNvSpPr txBox="1"/>
          <p:nvPr/>
        </p:nvSpPr>
        <p:spPr>
          <a:xfrm>
            <a:off x="11088202" y="3112803"/>
            <a:ext cx="8606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OL1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C2155DD-7AD9-ABA6-D376-3DAFB90C3306}"/>
              </a:ext>
            </a:extLst>
          </p:cNvPr>
          <p:cNvSpPr txBox="1"/>
          <p:nvPr/>
        </p:nvSpPr>
        <p:spPr>
          <a:xfrm>
            <a:off x="3860881" y="3917121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9kD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8F8AE33-ECA7-5429-C641-FC4A12F890EC}"/>
              </a:ext>
            </a:extLst>
          </p:cNvPr>
          <p:cNvSpPr txBox="1"/>
          <p:nvPr/>
        </p:nvSpPr>
        <p:spPr>
          <a:xfrm>
            <a:off x="3860881" y="361300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24169E-362F-A4FE-43A9-27DB685FED10}"/>
              </a:ext>
            </a:extLst>
          </p:cNvPr>
          <p:cNvSpPr txBox="1"/>
          <p:nvPr/>
        </p:nvSpPr>
        <p:spPr>
          <a:xfrm>
            <a:off x="3885948" y="133222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480954-94FF-681D-F7AB-D4A1ACAAB225}"/>
              </a:ext>
            </a:extLst>
          </p:cNvPr>
          <p:cNvSpPr txBox="1"/>
          <p:nvPr/>
        </p:nvSpPr>
        <p:spPr>
          <a:xfrm>
            <a:off x="8094812" y="503082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91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6680A63-C083-BDC3-7C89-4092E2B0A8F0}"/>
              </a:ext>
            </a:extLst>
          </p:cNvPr>
          <p:cNvSpPr txBox="1"/>
          <p:nvPr/>
        </p:nvSpPr>
        <p:spPr>
          <a:xfrm>
            <a:off x="8156028" y="846721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97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49CD344-022E-24D0-7219-C7D1F16DF709}"/>
              </a:ext>
            </a:extLst>
          </p:cNvPr>
          <p:cNvSpPr txBox="1"/>
          <p:nvPr/>
        </p:nvSpPr>
        <p:spPr>
          <a:xfrm>
            <a:off x="3660758" y="605769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9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D599E63-5E7F-CA3C-4528-BB80371FF57C}"/>
              </a:ext>
            </a:extLst>
          </p:cNvPr>
          <p:cNvSpPr txBox="1"/>
          <p:nvPr/>
        </p:nvSpPr>
        <p:spPr>
          <a:xfrm>
            <a:off x="3660758" y="5753584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2E3F97E-9698-CCD4-0CAC-C1113ABB25AB}"/>
              </a:ext>
            </a:extLst>
          </p:cNvPr>
          <p:cNvSpPr txBox="1"/>
          <p:nvPr/>
        </p:nvSpPr>
        <p:spPr>
          <a:xfrm>
            <a:off x="7590992" y="515932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53E1F13-F346-5C1B-C23B-397D0EA25D3B}"/>
              </a:ext>
            </a:extLst>
          </p:cNvPr>
          <p:cNvSpPr txBox="1"/>
          <p:nvPr/>
        </p:nvSpPr>
        <p:spPr>
          <a:xfrm>
            <a:off x="7590992" y="485521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B9B8998-970E-1A0E-65B2-FE6D15D12859}"/>
              </a:ext>
            </a:extLst>
          </p:cNvPr>
          <p:cNvSpPr txBox="1"/>
          <p:nvPr/>
        </p:nvSpPr>
        <p:spPr>
          <a:xfrm>
            <a:off x="8094812" y="2914254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91kD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D42C36D-E187-27AE-024E-314C55D396B6}"/>
              </a:ext>
            </a:extLst>
          </p:cNvPr>
          <p:cNvSpPr txBox="1"/>
          <p:nvPr/>
        </p:nvSpPr>
        <p:spPr>
          <a:xfrm>
            <a:off x="8156028" y="325789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97kD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6BF7955-C017-E284-56E6-47B9E8821DC6}"/>
              </a:ext>
            </a:extLst>
          </p:cNvPr>
          <p:cNvSpPr txBox="1"/>
          <p:nvPr/>
        </p:nvSpPr>
        <p:spPr>
          <a:xfrm>
            <a:off x="8145764" y="1897014"/>
            <a:ext cx="80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GLN</a:t>
            </a:r>
            <a:endParaRPr 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7EE6EC6-DF68-1112-87D4-658EFF56EE3B}"/>
              </a:ext>
            </a:extLst>
          </p:cNvPr>
          <p:cNvSpPr txBox="1"/>
          <p:nvPr/>
        </p:nvSpPr>
        <p:spPr>
          <a:xfrm>
            <a:off x="8070469" y="4236701"/>
            <a:ext cx="80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GLN</a:t>
            </a:r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C80706-0308-C948-D23C-4369ACA2BD74}"/>
              </a:ext>
            </a:extLst>
          </p:cNvPr>
          <p:cNvSpPr txBox="1"/>
          <p:nvPr/>
        </p:nvSpPr>
        <p:spPr>
          <a:xfrm>
            <a:off x="5985452" y="4923029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aSMA</a:t>
            </a:r>
            <a:endParaRPr lang="en-US" dirty="0"/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A535B4FA-6514-BAAC-E2A6-3E33C9F7F12A}"/>
              </a:ext>
            </a:extLst>
          </p:cNvPr>
          <p:cNvCxnSpPr>
            <a:cxnSpLocks/>
          </p:cNvCxnSpPr>
          <p:nvPr/>
        </p:nvCxnSpPr>
        <p:spPr>
          <a:xfrm flipH="1">
            <a:off x="5638800" y="5152680"/>
            <a:ext cx="406920" cy="860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3FF62DA3-4322-C51D-104D-F732C3F04C2E}"/>
              </a:ext>
            </a:extLst>
          </p:cNvPr>
          <p:cNvSpPr txBox="1"/>
          <p:nvPr/>
        </p:nvSpPr>
        <p:spPr>
          <a:xfrm>
            <a:off x="4151185" y="641581"/>
            <a:ext cx="2201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A (GAPDH alone)</a:t>
            </a:r>
            <a:endParaRPr lang="en-US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4FC3B81-E9F4-107C-E461-E06CD7A831A5}"/>
              </a:ext>
            </a:extLst>
          </p:cNvPr>
          <p:cNvSpPr txBox="1"/>
          <p:nvPr/>
        </p:nvSpPr>
        <p:spPr>
          <a:xfrm>
            <a:off x="4701493" y="2667792"/>
            <a:ext cx="3454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B (COL1, TAGLN) low exposure</a:t>
            </a:r>
            <a:endParaRPr lang="en-US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09E150E-D9CC-5B47-C8E1-24407908DE76}"/>
              </a:ext>
            </a:extLst>
          </p:cNvPr>
          <p:cNvSpPr txBox="1"/>
          <p:nvPr/>
        </p:nvSpPr>
        <p:spPr>
          <a:xfrm>
            <a:off x="8789015" y="2562434"/>
            <a:ext cx="3454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B (COL1, TAGLN) low exposure</a:t>
            </a:r>
            <a:endParaRPr 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57A5690-9955-A97C-2A38-A8294F9C4E92}"/>
              </a:ext>
            </a:extLst>
          </p:cNvPr>
          <p:cNvSpPr txBox="1"/>
          <p:nvPr/>
        </p:nvSpPr>
        <p:spPr>
          <a:xfrm>
            <a:off x="8701967" y="103589"/>
            <a:ext cx="1895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eplicate of Blot B</a:t>
            </a:r>
            <a:endParaRPr lang="en-US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F274987-D584-BB41-B718-9B922972C550}"/>
              </a:ext>
            </a:extLst>
          </p:cNvPr>
          <p:cNvSpPr txBox="1"/>
          <p:nvPr/>
        </p:nvSpPr>
        <p:spPr>
          <a:xfrm>
            <a:off x="3248636" y="4507234"/>
            <a:ext cx="42285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C (</a:t>
            </a:r>
            <a:r>
              <a:rPr lang="en-GB" dirty="0" err="1"/>
              <a:t>aSMA</a:t>
            </a:r>
            <a:r>
              <a:rPr lang="en-GB" dirty="0"/>
              <a:t>, CNN1, TAGLN) high exposure</a:t>
            </a:r>
            <a:endParaRPr lang="en-U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154960D-AE91-1055-D4A8-91BEED67523E}"/>
              </a:ext>
            </a:extLst>
          </p:cNvPr>
          <p:cNvSpPr txBox="1"/>
          <p:nvPr/>
        </p:nvSpPr>
        <p:spPr>
          <a:xfrm>
            <a:off x="7647640" y="4582554"/>
            <a:ext cx="416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C (</a:t>
            </a:r>
            <a:r>
              <a:rPr lang="en-GB" dirty="0" err="1"/>
              <a:t>aSMA</a:t>
            </a:r>
            <a:r>
              <a:rPr lang="en-GB" dirty="0"/>
              <a:t>, CNN1, TAGLN) low exposure</a:t>
            </a:r>
            <a:endParaRPr lang="en-US" dirty="0"/>
          </a:p>
        </p:txBody>
      </p:sp>
      <p:pic>
        <p:nvPicPr>
          <p:cNvPr id="60" name="Picture 59">
            <a:extLst>
              <a:ext uri="{FF2B5EF4-FFF2-40B4-BE49-F238E27FC236}">
                <a16:creationId xmlns:a16="http://schemas.microsoft.com/office/drawing/2014/main" id="{3639585F-55E9-3DD0-385F-228DDB1FF3D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985" y="1460351"/>
            <a:ext cx="3612484" cy="19624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51103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18CCB07-2FBD-D1F9-24D2-49EA0AC782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3438" y="756232"/>
            <a:ext cx="4668264" cy="295656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AB9B479-25F6-882E-F49A-83FA3CE7781B}"/>
              </a:ext>
            </a:extLst>
          </p:cNvPr>
          <p:cNvSpPr txBox="1"/>
          <p:nvPr/>
        </p:nvSpPr>
        <p:spPr>
          <a:xfrm>
            <a:off x="340495" y="831841"/>
            <a:ext cx="22427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figure 4b</a:t>
            </a:r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26B207F-3370-A6C4-B0E1-B05E0BA39410}"/>
              </a:ext>
            </a:extLst>
          </p:cNvPr>
          <p:cNvSpPr/>
          <p:nvPr/>
        </p:nvSpPr>
        <p:spPr>
          <a:xfrm>
            <a:off x="5789260" y="2355507"/>
            <a:ext cx="1337095" cy="3292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603BC9CB-6719-EFE3-F3E5-35F66BF703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H="1">
            <a:off x="4173549" y="3191972"/>
            <a:ext cx="2487382" cy="4056992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EDB6816B-9EF5-18B5-20AC-D5ECA92D5863}"/>
              </a:ext>
            </a:extLst>
          </p:cNvPr>
          <p:cNvSpPr/>
          <p:nvPr/>
        </p:nvSpPr>
        <p:spPr>
          <a:xfrm>
            <a:off x="6113972" y="5743908"/>
            <a:ext cx="966159" cy="3292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9732B990-FEB6-A28B-D8FD-4E684194750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H="1">
            <a:off x="8472673" y="3393150"/>
            <a:ext cx="2658195" cy="360411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74086850-4D4C-1744-5FDA-DA4C72138CD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911"/>
          <a:stretch/>
        </p:blipFill>
        <p:spPr>
          <a:xfrm rot="16200000" flipH="1">
            <a:off x="8132474" y="294897"/>
            <a:ext cx="3253518" cy="3814192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9A290F32-8BBB-C317-F6BB-3DCA61B5BA51}"/>
              </a:ext>
            </a:extLst>
          </p:cNvPr>
          <p:cNvSpPr/>
          <p:nvPr/>
        </p:nvSpPr>
        <p:spPr>
          <a:xfrm>
            <a:off x="10122953" y="3065425"/>
            <a:ext cx="966159" cy="3292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B4E1444-D491-9690-0B1E-B70B66DCE323}"/>
              </a:ext>
            </a:extLst>
          </p:cNvPr>
          <p:cNvSpPr/>
          <p:nvPr/>
        </p:nvSpPr>
        <p:spPr>
          <a:xfrm>
            <a:off x="10053886" y="5595934"/>
            <a:ext cx="1052423" cy="3292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D08719B-C5E3-F080-1578-5FB0B039E03D}"/>
              </a:ext>
            </a:extLst>
          </p:cNvPr>
          <p:cNvSpPr txBox="1"/>
          <p:nvPr/>
        </p:nvSpPr>
        <p:spPr>
          <a:xfrm>
            <a:off x="6036945" y="785675"/>
            <a:ext cx="784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CTA2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6470035-5CC6-37AF-849E-BA02803CCB36}"/>
              </a:ext>
            </a:extLst>
          </p:cNvPr>
          <p:cNvSpPr txBox="1"/>
          <p:nvPr/>
        </p:nvSpPr>
        <p:spPr>
          <a:xfrm>
            <a:off x="8362570" y="525936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EB02D4F-522B-88D1-F363-B1C46C1F8FFE}"/>
              </a:ext>
            </a:extLst>
          </p:cNvPr>
          <p:cNvSpPr txBox="1"/>
          <p:nvPr/>
        </p:nvSpPr>
        <p:spPr>
          <a:xfrm>
            <a:off x="11174287" y="3150145"/>
            <a:ext cx="802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AGLN</a:t>
            </a:r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6384553-1AE8-1B4E-964B-EA897C9AD67B}"/>
              </a:ext>
            </a:extLst>
          </p:cNvPr>
          <p:cNvSpPr txBox="1"/>
          <p:nvPr/>
        </p:nvSpPr>
        <p:spPr>
          <a:xfrm>
            <a:off x="6138949" y="540315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NN1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D4E6264-A2FF-21EA-597A-607EA3D2EA73}"/>
              </a:ext>
            </a:extLst>
          </p:cNvPr>
          <p:cNvSpPr txBox="1"/>
          <p:nvPr/>
        </p:nvSpPr>
        <p:spPr>
          <a:xfrm>
            <a:off x="3335684" y="27660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84BCCEF-585B-7300-481A-806D94988A95}"/>
              </a:ext>
            </a:extLst>
          </p:cNvPr>
          <p:cNvSpPr txBox="1"/>
          <p:nvPr/>
        </p:nvSpPr>
        <p:spPr>
          <a:xfrm>
            <a:off x="4605162" y="27660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C8B088-6FB8-A60D-F15E-50A17F46EC62}"/>
              </a:ext>
            </a:extLst>
          </p:cNvPr>
          <p:cNvSpPr txBox="1"/>
          <p:nvPr/>
        </p:nvSpPr>
        <p:spPr>
          <a:xfrm>
            <a:off x="5824362" y="27660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101BF665-1556-9861-45E6-5EE8504304FF}"/>
              </a:ext>
            </a:extLst>
          </p:cNvPr>
          <p:cNvCxnSpPr>
            <a:endCxn id="3" idx="3"/>
          </p:cNvCxnSpPr>
          <p:nvPr/>
        </p:nvCxnSpPr>
        <p:spPr>
          <a:xfrm flipV="1">
            <a:off x="3335684" y="3057525"/>
            <a:ext cx="255241" cy="33718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B907CA25-A7EE-C2B2-10C9-464034F5866E}"/>
              </a:ext>
            </a:extLst>
          </p:cNvPr>
          <p:cNvSpPr txBox="1"/>
          <p:nvPr/>
        </p:nvSpPr>
        <p:spPr>
          <a:xfrm>
            <a:off x="2869883" y="3334811"/>
            <a:ext cx="250221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This means +5% serum added to base media (which already contain 5% serum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CC966A9-0988-B170-DDF9-0910C8BD3C8B}"/>
              </a:ext>
            </a:extLst>
          </p:cNvPr>
          <p:cNvSpPr txBox="1"/>
          <p:nvPr/>
        </p:nvSpPr>
        <p:spPr>
          <a:xfrm>
            <a:off x="2808135" y="251655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D5FFCB5-18F5-6578-3195-530DEC8B7860}"/>
              </a:ext>
            </a:extLst>
          </p:cNvPr>
          <p:cNvSpPr txBox="1"/>
          <p:nvPr/>
        </p:nvSpPr>
        <p:spPr>
          <a:xfrm>
            <a:off x="2808135" y="221243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AF7D4A4-5B95-1A1E-4497-E3D1B63CD8B4}"/>
              </a:ext>
            </a:extLst>
          </p:cNvPr>
          <p:cNvSpPr txBox="1"/>
          <p:nvPr/>
        </p:nvSpPr>
        <p:spPr>
          <a:xfrm>
            <a:off x="11241189" y="355683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9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BD089CB-5098-CDEF-6C92-B6A797526734}"/>
              </a:ext>
            </a:extLst>
          </p:cNvPr>
          <p:cNvSpPr txBox="1"/>
          <p:nvPr/>
        </p:nvSpPr>
        <p:spPr>
          <a:xfrm>
            <a:off x="11241189" y="293836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B623AEC-DE4A-21B5-2A9A-B4BA632452C9}"/>
              </a:ext>
            </a:extLst>
          </p:cNvPr>
          <p:cNvSpPr txBox="1"/>
          <p:nvPr/>
        </p:nvSpPr>
        <p:spPr>
          <a:xfrm>
            <a:off x="11270262" y="469168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4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6E73462-4B9F-AA46-4F33-A010E9635393}"/>
              </a:ext>
            </a:extLst>
          </p:cNvPr>
          <p:cNvSpPr txBox="1"/>
          <p:nvPr/>
        </p:nvSpPr>
        <p:spPr>
          <a:xfrm>
            <a:off x="3412137" y="6031229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02A8AB1-9E5E-771B-52FF-A366E4EB6C5B}"/>
              </a:ext>
            </a:extLst>
          </p:cNvPr>
          <p:cNvSpPr txBox="1"/>
          <p:nvPr/>
        </p:nvSpPr>
        <p:spPr>
          <a:xfrm>
            <a:off x="11295632" y="561671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C027824-C764-618B-11C8-36268260F2B9}"/>
              </a:ext>
            </a:extLst>
          </p:cNvPr>
          <p:cNvSpPr txBox="1"/>
          <p:nvPr/>
        </p:nvSpPr>
        <p:spPr>
          <a:xfrm>
            <a:off x="11279787" y="600238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8D82FA3-73E1-C94A-6C71-2CBE5CBB1A98}"/>
              </a:ext>
            </a:extLst>
          </p:cNvPr>
          <p:cNvSpPr txBox="1"/>
          <p:nvPr/>
        </p:nvSpPr>
        <p:spPr>
          <a:xfrm rot="16200000">
            <a:off x="5976864" y="612279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hC</a:t>
            </a:r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18BCABD-B5C9-9268-89B4-02A2122BF2EF}"/>
              </a:ext>
            </a:extLst>
          </p:cNvPr>
          <p:cNvSpPr txBox="1"/>
          <p:nvPr/>
        </p:nvSpPr>
        <p:spPr>
          <a:xfrm rot="16200000">
            <a:off x="6189060" y="6122798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KX</a:t>
            </a:r>
            <a:endParaRPr 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5632058-BCD3-7457-0A67-C014CDB257A9}"/>
              </a:ext>
            </a:extLst>
          </p:cNvPr>
          <p:cNvSpPr txBox="1"/>
          <p:nvPr/>
        </p:nvSpPr>
        <p:spPr>
          <a:xfrm rot="16200000">
            <a:off x="6462457" y="612279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hC</a:t>
            </a:r>
            <a:endParaRPr 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2B7513F-C1CC-86CA-F0E6-FFDE4EA7F37F}"/>
              </a:ext>
            </a:extLst>
          </p:cNvPr>
          <p:cNvSpPr txBox="1"/>
          <p:nvPr/>
        </p:nvSpPr>
        <p:spPr>
          <a:xfrm rot="16200000">
            <a:off x="6674653" y="6122798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KX</a:t>
            </a:r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A2E0B7C-DC2C-A662-3FB1-02F3951E3813}"/>
              </a:ext>
            </a:extLst>
          </p:cNvPr>
          <p:cNvSpPr txBox="1"/>
          <p:nvPr/>
        </p:nvSpPr>
        <p:spPr>
          <a:xfrm>
            <a:off x="11169256" y="2470383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GAPDH</a:t>
            </a:r>
            <a:endParaRPr 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7A2C486-8C21-F11C-0829-BFB342568FA2}"/>
              </a:ext>
            </a:extLst>
          </p:cNvPr>
          <p:cNvSpPr txBox="1"/>
          <p:nvPr/>
        </p:nvSpPr>
        <p:spPr>
          <a:xfrm rot="16200000">
            <a:off x="9936756" y="643652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hC</a:t>
            </a:r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633D25E-6693-133B-3D6B-32B2F4BF8F3E}"/>
              </a:ext>
            </a:extLst>
          </p:cNvPr>
          <p:cNvSpPr txBox="1"/>
          <p:nvPr/>
        </p:nvSpPr>
        <p:spPr>
          <a:xfrm rot="16200000">
            <a:off x="10148952" y="6436526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KX</a:t>
            </a:r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6255447-1EB8-853C-DF8E-6F311D7933D9}"/>
              </a:ext>
            </a:extLst>
          </p:cNvPr>
          <p:cNvSpPr txBox="1"/>
          <p:nvPr/>
        </p:nvSpPr>
        <p:spPr>
          <a:xfrm rot="16200000">
            <a:off x="10422349" y="643652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ShC</a:t>
            </a:r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1B8E99A-692B-A5D7-675E-5DB571DEE883}"/>
              </a:ext>
            </a:extLst>
          </p:cNvPr>
          <p:cNvSpPr txBox="1"/>
          <p:nvPr/>
        </p:nvSpPr>
        <p:spPr>
          <a:xfrm rot="16200000">
            <a:off x="10634545" y="6455718"/>
            <a:ext cx="5741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NKX</a:t>
            </a:r>
            <a:endParaRPr 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5B9921D-B80C-3553-CB26-9027ACBADD16}"/>
              </a:ext>
            </a:extLst>
          </p:cNvPr>
          <p:cNvSpPr txBox="1"/>
          <p:nvPr/>
        </p:nvSpPr>
        <p:spPr>
          <a:xfrm>
            <a:off x="7852137" y="283413"/>
            <a:ext cx="43146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C (COL1, GAPDH, TAGLN) high exposure</a:t>
            </a:r>
            <a:endParaRPr lang="en-US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7FC54BC-1222-5DBE-3B82-E0C5A57E38E6}"/>
              </a:ext>
            </a:extLst>
          </p:cNvPr>
          <p:cNvSpPr txBox="1"/>
          <p:nvPr/>
        </p:nvSpPr>
        <p:spPr>
          <a:xfrm>
            <a:off x="7852137" y="3590186"/>
            <a:ext cx="2048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C low exposure</a:t>
            </a:r>
            <a:endParaRPr lang="en-US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C59481F-3BE6-FF0C-0C0E-CE3B397EB40C}"/>
              </a:ext>
            </a:extLst>
          </p:cNvPr>
          <p:cNvSpPr txBox="1"/>
          <p:nvPr/>
        </p:nvSpPr>
        <p:spPr>
          <a:xfrm>
            <a:off x="3495645" y="330378"/>
            <a:ext cx="2153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A (BTUB, ACTA2)</a:t>
            </a:r>
            <a:endParaRPr lang="en-US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CCEEE1F-C554-2D0B-9B47-D39DF19771C0}"/>
              </a:ext>
            </a:extLst>
          </p:cNvPr>
          <p:cNvSpPr txBox="1"/>
          <p:nvPr/>
        </p:nvSpPr>
        <p:spPr>
          <a:xfrm>
            <a:off x="3696291" y="3750309"/>
            <a:ext cx="2070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 B (COL1, CNN1)</a:t>
            </a:r>
            <a:endParaRPr lang="en-US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960A0EF-AD57-F396-757E-68A6D5739FDE}"/>
              </a:ext>
            </a:extLst>
          </p:cNvPr>
          <p:cNvSpPr txBox="1"/>
          <p:nvPr/>
        </p:nvSpPr>
        <p:spPr>
          <a:xfrm>
            <a:off x="280374" y="4294175"/>
            <a:ext cx="24533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ShC</a:t>
            </a:r>
            <a:r>
              <a:rPr lang="en-GB" dirty="0"/>
              <a:t> has been renamed to control in the figure</a:t>
            </a:r>
            <a:endParaRPr lang="en-US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E8F2456-6A5C-7D87-AADF-AC46912E66C7}"/>
              </a:ext>
            </a:extLst>
          </p:cNvPr>
          <p:cNvSpPr txBox="1"/>
          <p:nvPr/>
        </p:nvSpPr>
        <p:spPr>
          <a:xfrm>
            <a:off x="11279787" y="5109189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kDa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0D176E81-92DF-7B52-588A-ADFB35BACE3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8163" y="1657921"/>
            <a:ext cx="2382376" cy="2054879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69C554A6-77FD-CAD5-29CD-110A0793B460}"/>
              </a:ext>
            </a:extLst>
          </p:cNvPr>
          <p:cNvSpPr txBox="1"/>
          <p:nvPr/>
        </p:nvSpPr>
        <p:spPr>
          <a:xfrm>
            <a:off x="3374796" y="486925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4kD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8B4C3C4-72ED-BC41-499D-CB684DD4F99B}"/>
              </a:ext>
            </a:extLst>
          </p:cNvPr>
          <p:cNvSpPr txBox="1"/>
          <p:nvPr/>
        </p:nvSpPr>
        <p:spPr>
          <a:xfrm>
            <a:off x="3400166" y="568924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kDa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FDFE927-58DB-424F-3022-5F4278FBF997}"/>
              </a:ext>
            </a:extLst>
          </p:cNvPr>
          <p:cNvSpPr txBox="1"/>
          <p:nvPr/>
        </p:nvSpPr>
        <p:spPr>
          <a:xfrm>
            <a:off x="3384321" y="5286764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kD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2B940D7-B9C2-89AC-42F7-57595331C774}"/>
              </a:ext>
            </a:extLst>
          </p:cNvPr>
          <p:cNvSpPr txBox="1"/>
          <p:nvPr/>
        </p:nvSpPr>
        <p:spPr>
          <a:xfrm>
            <a:off x="11286107" y="163139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4kD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9696DAF-78C2-67F8-70A1-BD255AF942A8}"/>
              </a:ext>
            </a:extLst>
          </p:cNvPr>
          <p:cNvSpPr txBox="1"/>
          <p:nvPr/>
        </p:nvSpPr>
        <p:spPr>
          <a:xfrm>
            <a:off x="11295632" y="204890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kDa</a:t>
            </a:r>
          </a:p>
        </p:txBody>
      </p:sp>
    </p:spTree>
    <p:extLst>
      <p:ext uri="{BB962C8B-B14F-4D97-AF65-F5344CB8AC3E}">
        <p14:creationId xmlns:p14="http://schemas.microsoft.com/office/powerpoint/2010/main" val="27315419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85793FE-48AB-CB3C-B706-1B1E6CAC35D9}"/>
              </a:ext>
            </a:extLst>
          </p:cNvPr>
          <p:cNvSpPr txBox="1"/>
          <p:nvPr/>
        </p:nvSpPr>
        <p:spPr>
          <a:xfrm>
            <a:off x="288410" y="780133"/>
            <a:ext cx="22427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figure 4c</a:t>
            </a:r>
            <a:endParaRPr lang="en-US" dirty="0"/>
          </a:p>
        </p:txBody>
      </p:sp>
      <p:pic>
        <p:nvPicPr>
          <p:cNvPr id="3" name="Picture 2" descr="A close-up of a white sheet&#10;&#10;Description automatically generated">
            <a:extLst>
              <a:ext uri="{FF2B5EF4-FFF2-40B4-BE49-F238E27FC236}">
                <a16:creationId xmlns:a16="http://schemas.microsoft.com/office/drawing/2014/main" id="{F4F8A386-C9FB-167A-A4A8-1DCDB752834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8022" b="54885"/>
          <a:stretch/>
        </p:blipFill>
        <p:spPr>
          <a:xfrm>
            <a:off x="4007779" y="1664588"/>
            <a:ext cx="3072620" cy="2868367"/>
          </a:xfrm>
          <a:prstGeom prst="rect">
            <a:avLst/>
          </a:prstGeom>
        </p:spPr>
      </p:pic>
      <p:pic>
        <p:nvPicPr>
          <p:cNvPr id="6" name="Picture 5" descr="A white board with black lines&#10;&#10;Description automatically generated">
            <a:extLst>
              <a:ext uri="{FF2B5EF4-FFF2-40B4-BE49-F238E27FC236}">
                <a16:creationId xmlns:a16="http://schemas.microsoft.com/office/drawing/2014/main" id="{A6A80319-A7D0-7F6C-3331-9BA721EAF4B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5400000">
            <a:off x="7509736" y="1617725"/>
            <a:ext cx="4669536" cy="476326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264FB75-7D58-1165-097B-06613D3F31B6}"/>
              </a:ext>
            </a:extLst>
          </p:cNvPr>
          <p:cNvSpPr txBox="1"/>
          <p:nvPr/>
        </p:nvSpPr>
        <p:spPr>
          <a:xfrm>
            <a:off x="5907243" y="2021750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B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E72F9D9-F1FE-BF08-0F1C-765A7588EAF9}"/>
              </a:ext>
            </a:extLst>
          </p:cNvPr>
          <p:cNvSpPr txBox="1"/>
          <p:nvPr/>
        </p:nvSpPr>
        <p:spPr>
          <a:xfrm>
            <a:off x="8474805" y="1674114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KX2-5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431568B-B19C-A308-88DE-DFEC6F21F1FB}"/>
              </a:ext>
            </a:extLst>
          </p:cNvPr>
          <p:cNvSpPr/>
          <p:nvPr/>
        </p:nvSpPr>
        <p:spPr>
          <a:xfrm>
            <a:off x="10091861" y="4560868"/>
            <a:ext cx="1138115" cy="47148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066F0DF-11D8-D723-9AF6-B179C86CEDC0}"/>
              </a:ext>
            </a:extLst>
          </p:cNvPr>
          <p:cNvSpPr/>
          <p:nvPr/>
        </p:nvSpPr>
        <p:spPr>
          <a:xfrm>
            <a:off x="5702644" y="2616373"/>
            <a:ext cx="452250" cy="2476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6EA631A-1912-382C-A628-D04380C8C308}"/>
              </a:ext>
            </a:extLst>
          </p:cNvPr>
          <p:cNvSpPr txBox="1"/>
          <p:nvPr/>
        </p:nvSpPr>
        <p:spPr>
          <a:xfrm>
            <a:off x="4463772" y="271599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DE1D657-AAD9-E8E8-ADFE-A373B3D91CD7}"/>
              </a:ext>
            </a:extLst>
          </p:cNvPr>
          <p:cNvSpPr txBox="1"/>
          <p:nvPr/>
        </p:nvSpPr>
        <p:spPr>
          <a:xfrm>
            <a:off x="4463772" y="241188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8FBF526-7B58-945E-F910-2A599ADCA24E}"/>
              </a:ext>
            </a:extLst>
          </p:cNvPr>
          <p:cNvSpPr txBox="1"/>
          <p:nvPr/>
        </p:nvSpPr>
        <p:spPr>
          <a:xfrm>
            <a:off x="7462873" y="490975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1C5407B-C2B4-338E-6FDE-AB32F560E00C}"/>
              </a:ext>
            </a:extLst>
          </p:cNvPr>
          <p:cNvSpPr txBox="1"/>
          <p:nvPr/>
        </p:nvSpPr>
        <p:spPr>
          <a:xfrm>
            <a:off x="7462873" y="454342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D0DE743-20D0-267C-0297-05585C100F55}"/>
              </a:ext>
            </a:extLst>
          </p:cNvPr>
          <p:cNvSpPr txBox="1"/>
          <p:nvPr/>
        </p:nvSpPr>
        <p:spPr>
          <a:xfrm>
            <a:off x="7462873" y="415341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1kDa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B2D5722-3EBD-9101-2848-15054041EA5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2542" y="1684583"/>
            <a:ext cx="2598058" cy="286836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E5C56FF-630D-24D0-D7C5-6C1975DCD67A}"/>
              </a:ext>
            </a:extLst>
          </p:cNvPr>
          <p:cNvSpPr txBox="1"/>
          <p:nvPr/>
        </p:nvSpPr>
        <p:spPr>
          <a:xfrm rot="16200000">
            <a:off x="8170191" y="2318927"/>
            <a:ext cx="8595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err="1">
                <a:latin typeface="Helvetica" panose="020B0604020202020204" pitchFamily="34" charset="0"/>
                <a:cs typeface="Helvetica" panose="020B0604020202020204" pitchFamily="34" charset="0"/>
              </a:rPr>
              <a:t>iPSMC</a:t>
            </a:r>
            <a:r>
              <a:rPr lang="en-GB" sz="1050" dirty="0">
                <a:latin typeface="Helvetica" panose="020B0604020202020204" pitchFamily="34" charset="0"/>
                <a:cs typeface="Helvetica" panose="020B0604020202020204" pitchFamily="34" charset="0"/>
              </a:rPr>
              <a:t>-ctr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1575AF9-3607-C46F-A134-A77CF6E423C1}"/>
              </a:ext>
            </a:extLst>
          </p:cNvPr>
          <p:cNvSpPr txBox="1"/>
          <p:nvPr/>
        </p:nvSpPr>
        <p:spPr>
          <a:xfrm rot="16200000">
            <a:off x="8504452" y="2318926"/>
            <a:ext cx="8915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err="1">
                <a:latin typeface="Helvetica" panose="020B0604020202020204" pitchFamily="34" charset="0"/>
                <a:cs typeface="Helvetica" panose="020B0604020202020204" pitchFamily="34" charset="0"/>
              </a:rPr>
              <a:t>iPSMC-nkx</a:t>
            </a:r>
            <a:endParaRPr lang="en-GB" sz="105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4D2D12A-BDFC-C442-1EF8-951235C9B71D}"/>
              </a:ext>
            </a:extLst>
          </p:cNvPr>
          <p:cNvSpPr txBox="1"/>
          <p:nvPr/>
        </p:nvSpPr>
        <p:spPr>
          <a:xfrm rot="16200000">
            <a:off x="8905238" y="2353392"/>
            <a:ext cx="7906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>
                <a:latin typeface="Helvetica" panose="020B0604020202020204" pitchFamily="34" charset="0"/>
                <a:cs typeface="Helvetica" panose="020B0604020202020204" pitchFamily="34" charset="0"/>
              </a:rPr>
              <a:t>HPASM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5E8D235-A1D1-9BBB-7DF9-24A784FD8E49}"/>
              </a:ext>
            </a:extLst>
          </p:cNvPr>
          <p:cNvSpPr txBox="1"/>
          <p:nvPr/>
        </p:nvSpPr>
        <p:spPr>
          <a:xfrm rot="16200000">
            <a:off x="8011881" y="2322774"/>
            <a:ext cx="6719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>
                <a:latin typeface="Helvetica" panose="020B0604020202020204" pitchFamily="34" charset="0"/>
                <a:cs typeface="Helvetica" panose="020B0604020202020204" pitchFamily="34" charset="0"/>
              </a:rPr>
              <a:t>Marker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6E00BEC-8A42-8100-3ED1-E88EAD8BA0E7}"/>
              </a:ext>
            </a:extLst>
          </p:cNvPr>
          <p:cNvSpPr txBox="1"/>
          <p:nvPr/>
        </p:nvSpPr>
        <p:spPr>
          <a:xfrm rot="16200000">
            <a:off x="9652521" y="2322774"/>
            <a:ext cx="6719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>
                <a:latin typeface="Helvetica" panose="020B0604020202020204" pitchFamily="34" charset="0"/>
                <a:cs typeface="Helvetica" panose="020B0604020202020204" pitchFamily="34" charset="0"/>
              </a:rPr>
              <a:t>Marke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80F1045-D588-B73B-D3B8-A40013C9560E}"/>
              </a:ext>
            </a:extLst>
          </p:cNvPr>
          <p:cNvSpPr txBox="1"/>
          <p:nvPr/>
        </p:nvSpPr>
        <p:spPr>
          <a:xfrm rot="16200000">
            <a:off x="11478053" y="2322774"/>
            <a:ext cx="6719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>
                <a:latin typeface="Helvetica" panose="020B0604020202020204" pitchFamily="34" charset="0"/>
                <a:cs typeface="Helvetica" panose="020B0604020202020204" pitchFamily="34" charset="0"/>
              </a:rPr>
              <a:t>Marke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045FC47-5419-DF81-2F4E-520C371A7E59}"/>
              </a:ext>
            </a:extLst>
          </p:cNvPr>
          <p:cNvSpPr txBox="1"/>
          <p:nvPr/>
        </p:nvSpPr>
        <p:spPr>
          <a:xfrm rot="16200000">
            <a:off x="8975791" y="2115524"/>
            <a:ext cx="12891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Helvetica" panose="020B0604020202020204" pitchFamily="34" charset="0"/>
                <a:cs typeface="Helvetica" panose="020B0604020202020204" pitchFamily="34" charset="0"/>
              </a:rPr>
              <a:t>Internal contro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C5C0157-9E13-AA68-282E-8F17F881AA40}"/>
              </a:ext>
            </a:extLst>
          </p:cNvPr>
          <p:cNvSpPr txBox="1"/>
          <p:nvPr/>
        </p:nvSpPr>
        <p:spPr>
          <a:xfrm rot="16200000">
            <a:off x="9904859" y="2318927"/>
            <a:ext cx="8595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err="1">
                <a:latin typeface="Helvetica" panose="020B0604020202020204" pitchFamily="34" charset="0"/>
                <a:cs typeface="Helvetica" panose="020B0604020202020204" pitchFamily="34" charset="0"/>
              </a:rPr>
              <a:t>iPSMC</a:t>
            </a:r>
            <a:r>
              <a:rPr lang="en-GB" sz="1050" dirty="0">
                <a:latin typeface="Helvetica" panose="020B0604020202020204" pitchFamily="34" charset="0"/>
                <a:cs typeface="Helvetica" panose="020B0604020202020204" pitchFamily="34" charset="0"/>
              </a:rPr>
              <a:t>-ctr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E22AEEE-5E07-3BB1-C871-9AC5AF7BAE5F}"/>
              </a:ext>
            </a:extLst>
          </p:cNvPr>
          <p:cNvSpPr txBox="1"/>
          <p:nvPr/>
        </p:nvSpPr>
        <p:spPr>
          <a:xfrm rot="16200000">
            <a:off x="10239120" y="2318926"/>
            <a:ext cx="8915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err="1">
                <a:latin typeface="Helvetica" panose="020B0604020202020204" pitchFamily="34" charset="0"/>
                <a:cs typeface="Helvetica" panose="020B0604020202020204" pitchFamily="34" charset="0"/>
              </a:rPr>
              <a:t>iPSMC-nkx</a:t>
            </a:r>
            <a:endParaRPr lang="en-GB" sz="105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A3153A1-43A5-136C-6599-6EFACC8A8330}"/>
              </a:ext>
            </a:extLst>
          </p:cNvPr>
          <p:cNvSpPr txBox="1"/>
          <p:nvPr/>
        </p:nvSpPr>
        <p:spPr>
          <a:xfrm rot="16200000">
            <a:off x="10639906" y="2353392"/>
            <a:ext cx="79060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>
                <a:latin typeface="Helvetica" panose="020B0604020202020204" pitchFamily="34" charset="0"/>
                <a:cs typeface="Helvetica" panose="020B0604020202020204" pitchFamily="34" charset="0"/>
              </a:rPr>
              <a:t>HPASM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82CAC0D-7B37-992C-F621-64EA966B564F}"/>
              </a:ext>
            </a:extLst>
          </p:cNvPr>
          <p:cNvSpPr txBox="1"/>
          <p:nvPr/>
        </p:nvSpPr>
        <p:spPr>
          <a:xfrm rot="16200000">
            <a:off x="10806615" y="2115524"/>
            <a:ext cx="128913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Helvetica" panose="020B0604020202020204" pitchFamily="34" charset="0"/>
                <a:cs typeface="Helvetica" panose="020B0604020202020204" pitchFamily="34" charset="0"/>
              </a:rPr>
              <a:t>Internal control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8C2D7AE-089F-8EA5-4C46-DFABFCDCA9A3}"/>
              </a:ext>
            </a:extLst>
          </p:cNvPr>
          <p:cNvGrpSpPr/>
          <p:nvPr/>
        </p:nvGrpSpPr>
        <p:grpSpPr>
          <a:xfrm>
            <a:off x="-13515" y="4430414"/>
            <a:ext cx="3497580" cy="1774840"/>
            <a:chOff x="54473" y="4399441"/>
            <a:chExt cx="3497580" cy="177484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0F566EC-C352-412A-D1D3-4C5AC9CEBC1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0700" y="4481195"/>
              <a:ext cx="3431353" cy="164782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3C5F23F-9C54-9BF0-5F69-86652E08ACEB}"/>
                </a:ext>
              </a:extLst>
            </p:cNvPr>
            <p:cNvSpPr txBox="1"/>
            <p:nvPr/>
          </p:nvSpPr>
          <p:spPr>
            <a:xfrm>
              <a:off x="54473" y="4399441"/>
              <a:ext cx="19720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u="sng" dirty="0"/>
                <a:t>Magnified TBP blot</a:t>
              </a:r>
              <a:endParaRPr lang="en-US" u="sng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632B3D9-FCFB-ED11-7E9C-9B44543296BE}"/>
                </a:ext>
              </a:extLst>
            </p:cNvPr>
            <p:cNvSpPr txBox="1"/>
            <p:nvPr/>
          </p:nvSpPr>
          <p:spPr>
            <a:xfrm rot="16200000">
              <a:off x="-13100" y="5398908"/>
              <a:ext cx="8595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PSMC</a:t>
              </a:r>
              <a:r>
                <a:rPr lang="en-GB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-ctrl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FB8648E-ADDD-2AF8-6C92-3060317995D2}"/>
                </a:ext>
              </a:extLst>
            </p:cNvPr>
            <p:cNvSpPr txBox="1"/>
            <p:nvPr/>
          </p:nvSpPr>
          <p:spPr>
            <a:xfrm rot="16200000">
              <a:off x="291560" y="5439700"/>
              <a:ext cx="89159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PSMC-nkx</a:t>
              </a:r>
              <a:endParaRPr lang="en-GB" sz="10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0E9C516-27EE-7F21-5CD6-60FEB1C1D1FD}"/>
                </a:ext>
              </a:extLst>
            </p:cNvPr>
            <p:cNvSpPr txBox="1"/>
            <p:nvPr/>
          </p:nvSpPr>
          <p:spPr>
            <a:xfrm rot="16200000">
              <a:off x="644063" y="5437912"/>
              <a:ext cx="79060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HPASMC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3AF92BF-CA9B-0F81-91FE-D04A8DD159D5}"/>
                </a:ext>
              </a:extLst>
            </p:cNvPr>
            <p:cNvSpPr txBox="1"/>
            <p:nvPr/>
          </p:nvSpPr>
          <p:spPr>
            <a:xfrm rot="16200000">
              <a:off x="679394" y="5402755"/>
              <a:ext cx="128913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Internal control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D9BD21D-F354-8FC1-8D0F-912A198451F7}"/>
                </a:ext>
              </a:extLst>
            </p:cNvPr>
            <p:cNvSpPr txBox="1"/>
            <p:nvPr/>
          </p:nvSpPr>
          <p:spPr>
            <a:xfrm rot="16200000">
              <a:off x="1178795" y="5427483"/>
              <a:ext cx="8595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PSMC</a:t>
              </a:r>
              <a:r>
                <a:rPr lang="en-GB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-ctrl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86002C5-C259-B71F-0436-A742318BAF66}"/>
                </a:ext>
              </a:extLst>
            </p:cNvPr>
            <p:cNvSpPr txBox="1"/>
            <p:nvPr/>
          </p:nvSpPr>
          <p:spPr>
            <a:xfrm rot="16200000">
              <a:off x="1483455" y="5468275"/>
              <a:ext cx="89159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PSMC-nkx</a:t>
              </a:r>
              <a:endParaRPr lang="en-GB" sz="10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45E3D1C-00FD-FA0B-091E-1945955E13EC}"/>
                </a:ext>
              </a:extLst>
            </p:cNvPr>
            <p:cNvSpPr txBox="1"/>
            <p:nvPr/>
          </p:nvSpPr>
          <p:spPr>
            <a:xfrm rot="16200000">
              <a:off x="1835958" y="5466487"/>
              <a:ext cx="79060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HPASMC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E664FDC-7F3B-40B5-40E1-BAD5B2B32891}"/>
                </a:ext>
              </a:extLst>
            </p:cNvPr>
            <p:cNvSpPr txBox="1"/>
            <p:nvPr/>
          </p:nvSpPr>
          <p:spPr>
            <a:xfrm rot="16200000">
              <a:off x="1893182" y="5402755"/>
              <a:ext cx="128913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Internal contro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064151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16DB6D-2F93-6176-465F-9A95D192B8D8}"/>
              </a:ext>
            </a:extLst>
          </p:cNvPr>
          <p:cNvSpPr txBox="1"/>
          <p:nvPr/>
        </p:nvSpPr>
        <p:spPr>
          <a:xfrm>
            <a:off x="423138" y="-584"/>
            <a:ext cx="22802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figure 6A</a:t>
            </a:r>
            <a:endParaRPr lang="en-US" dirty="0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F2A8952-A4EA-26BB-E650-B9E9E6A9F7B2}"/>
              </a:ext>
            </a:extLst>
          </p:cNvPr>
          <p:cNvGrpSpPr/>
          <p:nvPr/>
        </p:nvGrpSpPr>
        <p:grpSpPr>
          <a:xfrm>
            <a:off x="3731658" y="14663"/>
            <a:ext cx="3000374" cy="2819522"/>
            <a:chOff x="6534151" y="609478"/>
            <a:chExt cx="3000374" cy="2819522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39F1EB9-1683-6C28-2EB0-BAEE4A6FDA2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6534151" y="609478"/>
              <a:ext cx="3000374" cy="281952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542C09B3-CEEE-27AC-EE4E-A362202369B9}"/>
                </a:ext>
              </a:extLst>
            </p:cNvPr>
            <p:cNvSpPr/>
            <p:nvPr/>
          </p:nvSpPr>
          <p:spPr>
            <a:xfrm>
              <a:off x="6717760" y="2065662"/>
              <a:ext cx="900706" cy="2922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8AAE4A41-7235-59AA-E902-49C3C731FD97}"/>
                </a:ext>
              </a:extLst>
            </p:cNvPr>
            <p:cNvSpPr/>
            <p:nvPr/>
          </p:nvSpPr>
          <p:spPr>
            <a:xfrm>
              <a:off x="8032210" y="2094237"/>
              <a:ext cx="826040" cy="2922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4" name="Picture 13">
            <a:extLst>
              <a:ext uri="{FF2B5EF4-FFF2-40B4-BE49-F238E27FC236}">
                <a16:creationId xmlns:a16="http://schemas.microsoft.com/office/drawing/2014/main" id="{D0D0BF71-9037-DC8B-1481-26F9C896D48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705580" y="2832501"/>
            <a:ext cx="3228843" cy="281952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438F2016-A450-60DC-6554-C60B924EC593}"/>
              </a:ext>
            </a:extLst>
          </p:cNvPr>
          <p:cNvSpPr/>
          <p:nvPr/>
        </p:nvSpPr>
        <p:spPr>
          <a:xfrm>
            <a:off x="3930683" y="4549193"/>
            <a:ext cx="900706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ACEF8B2-68B2-CC5E-1076-5F8565DC8BD5}"/>
              </a:ext>
            </a:extLst>
          </p:cNvPr>
          <p:cNvSpPr/>
          <p:nvPr/>
        </p:nvSpPr>
        <p:spPr>
          <a:xfrm>
            <a:off x="5264183" y="4562316"/>
            <a:ext cx="900706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9" name="Picture 5">
            <a:extLst>
              <a:ext uri="{FF2B5EF4-FFF2-40B4-BE49-F238E27FC236}">
                <a16:creationId xmlns:a16="http://schemas.microsoft.com/office/drawing/2014/main" id="{5905179E-A623-3A91-68D5-1300808D242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92834" y="3049175"/>
            <a:ext cx="3149631" cy="371357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CE105129-3949-4D10-AD86-7127AD7AC886}"/>
              </a:ext>
            </a:extLst>
          </p:cNvPr>
          <p:cNvSpPr/>
          <p:nvPr/>
        </p:nvSpPr>
        <p:spPr>
          <a:xfrm>
            <a:off x="186500" y="5353929"/>
            <a:ext cx="900706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543E88DA-1F31-FF42-C258-3565690DAC3B}"/>
              </a:ext>
            </a:extLst>
          </p:cNvPr>
          <p:cNvSpPr/>
          <p:nvPr/>
        </p:nvSpPr>
        <p:spPr>
          <a:xfrm>
            <a:off x="1462850" y="5363454"/>
            <a:ext cx="826040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CAE0F4E-2002-8BD7-D913-9FD7CD684B64}"/>
              </a:ext>
            </a:extLst>
          </p:cNvPr>
          <p:cNvSpPr txBox="1"/>
          <p:nvPr/>
        </p:nvSpPr>
        <p:spPr>
          <a:xfrm>
            <a:off x="561083" y="4938676"/>
            <a:ext cx="10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MAD2</a:t>
            </a:r>
          </a:p>
        </p:txBody>
      </p:sp>
      <p:pic>
        <p:nvPicPr>
          <p:cNvPr id="24" name="Picture 6">
            <a:extLst>
              <a:ext uri="{FF2B5EF4-FFF2-40B4-BE49-F238E27FC236}">
                <a16:creationId xmlns:a16="http://schemas.microsoft.com/office/drawing/2014/main" id="{E8028ADB-6395-C4DF-85EE-DED7FA1B2AA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297538" y="262742"/>
            <a:ext cx="3435533" cy="446583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6F37BCCB-B3C4-2CED-202B-6BCCD289589A}"/>
              </a:ext>
            </a:extLst>
          </p:cNvPr>
          <p:cNvSpPr/>
          <p:nvPr/>
        </p:nvSpPr>
        <p:spPr>
          <a:xfrm>
            <a:off x="7548189" y="2475628"/>
            <a:ext cx="704358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820F78DB-6C9A-5E2F-1ABA-0A24B1D560C3}"/>
              </a:ext>
            </a:extLst>
          </p:cNvPr>
          <p:cNvSpPr/>
          <p:nvPr/>
        </p:nvSpPr>
        <p:spPr>
          <a:xfrm>
            <a:off x="8639366" y="2475628"/>
            <a:ext cx="704358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7" name="Picture 2">
            <a:extLst>
              <a:ext uri="{FF2B5EF4-FFF2-40B4-BE49-F238E27FC236}">
                <a16:creationId xmlns:a16="http://schemas.microsoft.com/office/drawing/2014/main" id="{0C39A7AA-A84C-F22E-6C11-F77CBFC0140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 cstate="print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631940" y="5489292"/>
            <a:ext cx="3650217" cy="1524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Rectangle 27">
            <a:extLst>
              <a:ext uri="{FF2B5EF4-FFF2-40B4-BE49-F238E27FC236}">
                <a16:creationId xmlns:a16="http://schemas.microsoft.com/office/drawing/2014/main" id="{59935FA4-981C-ADDE-C0DA-7EC99B899270}"/>
              </a:ext>
            </a:extLst>
          </p:cNvPr>
          <p:cNvSpPr/>
          <p:nvPr/>
        </p:nvSpPr>
        <p:spPr>
          <a:xfrm>
            <a:off x="4168287" y="6289979"/>
            <a:ext cx="900706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A282B91-B756-D2E1-B25C-AFA83559CCE2}"/>
              </a:ext>
            </a:extLst>
          </p:cNvPr>
          <p:cNvSpPr/>
          <p:nvPr/>
        </p:nvSpPr>
        <p:spPr>
          <a:xfrm>
            <a:off x="5520836" y="6318554"/>
            <a:ext cx="900705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A56144D-BF54-7228-012E-1CDD54618EE7}"/>
              </a:ext>
            </a:extLst>
          </p:cNvPr>
          <p:cNvSpPr txBox="1"/>
          <p:nvPr/>
        </p:nvSpPr>
        <p:spPr>
          <a:xfrm>
            <a:off x="4743286" y="5434773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C8B551D-045E-BF60-1C3E-2DD9C6263823}"/>
              </a:ext>
            </a:extLst>
          </p:cNvPr>
          <p:cNvSpPr txBox="1"/>
          <p:nvPr/>
        </p:nvSpPr>
        <p:spPr>
          <a:xfrm>
            <a:off x="3379755" y="112146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2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1E519C6-1A0D-A13D-3759-E5E690024443}"/>
              </a:ext>
            </a:extLst>
          </p:cNvPr>
          <p:cNvSpPr txBox="1"/>
          <p:nvPr/>
        </p:nvSpPr>
        <p:spPr>
          <a:xfrm>
            <a:off x="3379755" y="1651734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9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FC5FEA3-70A5-8611-B8AE-F575B44765E3}"/>
              </a:ext>
            </a:extLst>
          </p:cNvPr>
          <p:cNvSpPr txBox="1"/>
          <p:nvPr/>
        </p:nvSpPr>
        <p:spPr>
          <a:xfrm>
            <a:off x="3379755" y="426475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2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EBEB3FD-DA1C-33FA-DEAC-1D3F8A03EB7D}"/>
              </a:ext>
            </a:extLst>
          </p:cNvPr>
          <p:cNvSpPr txBox="1"/>
          <p:nvPr/>
        </p:nvSpPr>
        <p:spPr>
          <a:xfrm>
            <a:off x="3379755" y="479501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9kD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E88507C-4281-EEDE-494E-80DC17D18A47}"/>
              </a:ext>
            </a:extLst>
          </p:cNvPr>
          <p:cNvSpPr txBox="1"/>
          <p:nvPr/>
        </p:nvSpPr>
        <p:spPr>
          <a:xfrm>
            <a:off x="3558906" y="642657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788266F-7076-5A71-392C-8ED545B807BA}"/>
              </a:ext>
            </a:extLst>
          </p:cNvPr>
          <p:cNvSpPr txBox="1"/>
          <p:nvPr/>
        </p:nvSpPr>
        <p:spPr>
          <a:xfrm>
            <a:off x="7534259" y="-60188"/>
            <a:ext cx="26183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JansonText-Roman"/>
              </a:rPr>
              <a:t>NKX2-5 antibody: a54567</a:t>
            </a:r>
            <a:endParaRPr lang="en-US" dirty="0"/>
          </a:p>
        </p:txBody>
      </p:sp>
      <p:pic>
        <p:nvPicPr>
          <p:cNvPr id="86" name="Picture 85">
            <a:extLst>
              <a:ext uri="{FF2B5EF4-FFF2-40B4-BE49-F238E27FC236}">
                <a16:creationId xmlns:a16="http://schemas.microsoft.com/office/drawing/2014/main" id="{58772CE6-29CA-32D7-16E9-6BFAA01A50D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6266" y="4795018"/>
            <a:ext cx="3435533" cy="2339250"/>
          </a:xfrm>
          <a:prstGeom prst="rect">
            <a:avLst/>
          </a:prstGeom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AE6C6E8E-137F-13EB-8937-78DE11ED9662}"/>
              </a:ext>
            </a:extLst>
          </p:cNvPr>
          <p:cNvSpPr txBox="1"/>
          <p:nvPr/>
        </p:nvSpPr>
        <p:spPr>
          <a:xfrm>
            <a:off x="9760808" y="5619439"/>
            <a:ext cx="1936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 for NKX2-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E93A32B-29F6-5A97-C851-98F4190E0D19}"/>
              </a:ext>
            </a:extLst>
          </p:cNvPr>
          <p:cNvSpPr txBox="1"/>
          <p:nvPr/>
        </p:nvSpPr>
        <p:spPr>
          <a:xfrm>
            <a:off x="7064887" y="6565071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3C483C96-AC72-5AE7-7A4B-02C252C70A64}"/>
              </a:ext>
            </a:extLst>
          </p:cNvPr>
          <p:cNvSpPr/>
          <p:nvPr/>
        </p:nvSpPr>
        <p:spPr>
          <a:xfrm>
            <a:off x="7715496" y="6464672"/>
            <a:ext cx="900706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90468D96-EE9A-F7AB-E6AB-BAA8444E8A96}"/>
              </a:ext>
            </a:extLst>
          </p:cNvPr>
          <p:cNvSpPr/>
          <p:nvPr/>
        </p:nvSpPr>
        <p:spPr>
          <a:xfrm>
            <a:off x="9104032" y="6464672"/>
            <a:ext cx="973418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3" name="Picture 122">
            <a:extLst>
              <a:ext uri="{FF2B5EF4-FFF2-40B4-BE49-F238E27FC236}">
                <a16:creationId xmlns:a16="http://schemas.microsoft.com/office/drawing/2014/main" id="{77853E38-F519-04EA-C899-346804CA065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931" y="701193"/>
            <a:ext cx="2549216" cy="22493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24826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D0D198E2-F698-334A-3276-2E337BE69EE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7991" y="2104561"/>
            <a:ext cx="2062032" cy="311230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C16DB6D-2F93-6176-465F-9A95D192B8D8}"/>
              </a:ext>
            </a:extLst>
          </p:cNvPr>
          <p:cNvSpPr txBox="1"/>
          <p:nvPr/>
        </p:nvSpPr>
        <p:spPr>
          <a:xfrm>
            <a:off x="-61941" y="1506872"/>
            <a:ext cx="19074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Unedited Western blots for figure 6B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FB21EEC-04FE-E1E5-C0CD-7B593D9FC7B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121808" y="571501"/>
            <a:ext cx="5050518" cy="236791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8209F31-4F50-6FCC-600A-481C7AF930D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603744" y="3138425"/>
            <a:ext cx="4184196" cy="16375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62F8E07-7152-E5A5-778A-674A9AFDDF8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603744" y="4974977"/>
            <a:ext cx="4357007" cy="1359627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8012A5E-C80D-E6F4-5D46-9A4B72A10E52}"/>
              </a:ext>
            </a:extLst>
          </p:cNvPr>
          <p:cNvSpPr txBox="1"/>
          <p:nvPr/>
        </p:nvSpPr>
        <p:spPr>
          <a:xfrm>
            <a:off x="6294001" y="3190876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KT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AB30319-4E42-5D64-D14E-3002682463E3}"/>
              </a:ext>
            </a:extLst>
          </p:cNvPr>
          <p:cNvSpPr/>
          <p:nvPr/>
        </p:nvSpPr>
        <p:spPr>
          <a:xfrm>
            <a:off x="2164481" y="2231928"/>
            <a:ext cx="1409208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90D0D29-632E-01B5-A151-B1BAA3047027}"/>
              </a:ext>
            </a:extLst>
          </p:cNvPr>
          <p:cNvSpPr/>
          <p:nvPr/>
        </p:nvSpPr>
        <p:spPr>
          <a:xfrm>
            <a:off x="3284592" y="3355878"/>
            <a:ext cx="1352059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8E85E57-708A-8E9F-D247-27B0EA128805}"/>
              </a:ext>
            </a:extLst>
          </p:cNvPr>
          <p:cNvSpPr/>
          <p:nvPr/>
        </p:nvSpPr>
        <p:spPr>
          <a:xfrm>
            <a:off x="2603744" y="5683680"/>
            <a:ext cx="1352059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5F3576A-1F77-3D86-8002-57D10833F53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grayscl/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7291661" y="202168"/>
            <a:ext cx="4815076" cy="161069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7F18ABF3-450E-F50A-8F29-540B2862B5AB}"/>
              </a:ext>
            </a:extLst>
          </p:cNvPr>
          <p:cNvSpPr/>
          <p:nvPr/>
        </p:nvSpPr>
        <p:spPr>
          <a:xfrm>
            <a:off x="7372928" y="968592"/>
            <a:ext cx="1447575" cy="2922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F3A9F86-B694-FA5A-21CA-4315EE2B5B37}"/>
              </a:ext>
            </a:extLst>
          </p:cNvPr>
          <p:cNvSpPr txBox="1"/>
          <p:nvPr/>
        </p:nvSpPr>
        <p:spPr>
          <a:xfrm>
            <a:off x="8632302" y="469219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K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B99ACD6-9F6A-5CA7-A0B5-EB50CBA71783}"/>
              </a:ext>
            </a:extLst>
          </p:cNvPr>
          <p:cNvSpPr txBox="1"/>
          <p:nvPr/>
        </p:nvSpPr>
        <p:spPr>
          <a:xfrm>
            <a:off x="3193667" y="202168"/>
            <a:ext cx="26183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JansonText-Roman"/>
              </a:rPr>
              <a:t>NKX2-5 antibody: a54567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CFA864F-00E5-9B5E-6F26-9C4134E770FE}"/>
              </a:ext>
            </a:extLst>
          </p:cNvPr>
          <p:cNvSpPr txBox="1"/>
          <p:nvPr/>
        </p:nvSpPr>
        <p:spPr>
          <a:xfrm>
            <a:off x="2065810" y="548556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2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DF32692-198B-8E5A-45BA-4236CC7D6E51}"/>
              </a:ext>
            </a:extLst>
          </p:cNvPr>
          <p:cNvSpPr txBox="1"/>
          <p:nvPr/>
        </p:nvSpPr>
        <p:spPr>
          <a:xfrm>
            <a:off x="2065810" y="591179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9kDa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0550A726-8816-D262-06A8-F31B8B4317E2}"/>
              </a:ext>
            </a:extLst>
          </p:cNvPr>
          <p:cNvGrpSpPr/>
          <p:nvPr/>
        </p:nvGrpSpPr>
        <p:grpSpPr>
          <a:xfrm>
            <a:off x="7132952" y="1902347"/>
            <a:ext cx="5040460" cy="1805062"/>
            <a:chOff x="7113549" y="4974977"/>
            <a:chExt cx="5040460" cy="1805062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3A3B174-E4C8-F26C-EB4D-804563F9567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>
              <a:grayscl/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402"/>
            <a:stretch/>
          </p:blipFill>
          <p:spPr bwMode="auto">
            <a:xfrm>
              <a:off x="7152175" y="4974977"/>
              <a:ext cx="5001834" cy="180506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F1D5FEE7-E2AF-D8CB-7011-801EF7147C3C}"/>
                </a:ext>
              </a:extLst>
            </p:cNvPr>
            <p:cNvSpPr/>
            <p:nvPr/>
          </p:nvSpPr>
          <p:spPr>
            <a:xfrm>
              <a:off x="7705950" y="5906083"/>
              <a:ext cx="1523775" cy="2922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BFB03F8-1828-A3A9-774C-6CD0B028C830}"/>
                </a:ext>
              </a:extLst>
            </p:cNvPr>
            <p:cNvSpPr txBox="1"/>
            <p:nvPr/>
          </p:nvSpPr>
          <p:spPr>
            <a:xfrm>
              <a:off x="9746471" y="5216865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GAPDH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706F11F-BFEF-296E-E127-67FC30948410}"/>
                </a:ext>
              </a:extLst>
            </p:cNvPr>
            <p:cNvSpPr txBox="1"/>
            <p:nvPr/>
          </p:nvSpPr>
          <p:spPr>
            <a:xfrm>
              <a:off x="7113549" y="6100306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8kDa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53859E71-4C8A-0838-25F8-60711A94D5EA}"/>
              </a:ext>
            </a:extLst>
          </p:cNvPr>
          <p:cNvSpPr txBox="1"/>
          <p:nvPr/>
        </p:nvSpPr>
        <p:spPr>
          <a:xfrm>
            <a:off x="1695559" y="214513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C556FE6-23FF-436D-6A09-FB025EDA35A5}"/>
              </a:ext>
            </a:extLst>
          </p:cNvPr>
          <p:cNvSpPr txBox="1"/>
          <p:nvPr/>
        </p:nvSpPr>
        <p:spPr>
          <a:xfrm>
            <a:off x="1695559" y="242190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71CB408B-F0D6-7A26-E5FB-7331787ED1DD}"/>
              </a:ext>
            </a:extLst>
          </p:cNvPr>
          <p:cNvGrpSpPr/>
          <p:nvPr/>
        </p:nvGrpSpPr>
        <p:grpSpPr>
          <a:xfrm>
            <a:off x="7102591" y="3266605"/>
            <a:ext cx="4907930" cy="2087465"/>
            <a:chOff x="7164812" y="2104561"/>
            <a:chExt cx="4907930" cy="2087465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25E58EBA-8944-5FA6-ABFC-9B19EE1AEBC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>
              <a:grayscl/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4507"/>
            <a:stretch/>
          </p:blipFill>
          <p:spPr bwMode="auto">
            <a:xfrm>
              <a:off x="7420200" y="2581335"/>
              <a:ext cx="4652542" cy="161069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1AFEF2B2-0575-8118-5275-53A9303FEDDD}"/>
                </a:ext>
              </a:extLst>
            </p:cNvPr>
            <p:cNvSpPr/>
            <p:nvPr/>
          </p:nvSpPr>
          <p:spPr>
            <a:xfrm>
              <a:off x="8563200" y="3267971"/>
              <a:ext cx="1523775" cy="29223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1151C06-37F6-F6CF-5771-A39177D8A989}"/>
                </a:ext>
              </a:extLst>
            </p:cNvPr>
            <p:cNvSpPr txBox="1"/>
            <p:nvPr/>
          </p:nvSpPr>
          <p:spPr>
            <a:xfrm>
              <a:off x="7164812" y="3286127"/>
              <a:ext cx="7809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ERK5</a:t>
              </a:r>
            </a:p>
          </p:txBody>
        </p:sp>
        <p:sp>
          <p:nvSpPr>
            <p:cNvPr id="28" name="TextBox 4">
              <a:extLst>
                <a:ext uri="{FF2B5EF4-FFF2-40B4-BE49-F238E27FC236}">
                  <a16:creationId xmlns:a16="http://schemas.microsoft.com/office/drawing/2014/main" id="{7A2BDE81-A33E-E7E0-8DB4-73201EF2D7CC}"/>
                </a:ext>
              </a:extLst>
            </p:cNvPr>
            <p:cNvSpPr txBox="1"/>
            <p:nvPr/>
          </p:nvSpPr>
          <p:spPr>
            <a:xfrm rot="16200000">
              <a:off x="9290646" y="1396909"/>
              <a:ext cx="1262352" cy="26776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>
                <a:spcAft>
                  <a:spcPts val="1400"/>
                </a:spcAft>
              </a:pPr>
              <a:r>
                <a:rPr lang="en-GB" sz="1400" b="1" dirty="0"/>
                <a:t>Untreated</a:t>
              </a:r>
            </a:p>
            <a:p>
              <a:pPr>
                <a:spcAft>
                  <a:spcPts val="1400"/>
                </a:spcAft>
              </a:pPr>
              <a:r>
                <a:rPr lang="en-GB" sz="1400" b="1" dirty="0"/>
                <a:t>TC ASC10</a:t>
              </a:r>
            </a:p>
            <a:p>
              <a:pPr>
                <a:spcAft>
                  <a:spcPts val="1400"/>
                </a:spcAft>
              </a:pPr>
              <a:r>
                <a:rPr lang="en-GB" sz="1400" b="1" dirty="0"/>
                <a:t>ERK5-IN-1</a:t>
              </a:r>
            </a:p>
            <a:p>
              <a:pPr>
                <a:spcAft>
                  <a:spcPts val="1400"/>
                </a:spcAft>
              </a:pPr>
              <a:r>
                <a:rPr lang="en-GB" sz="1400" b="1" dirty="0"/>
                <a:t>GSK2126458</a:t>
              </a:r>
            </a:p>
            <a:p>
              <a:pPr>
                <a:spcAft>
                  <a:spcPts val="1400"/>
                </a:spcAft>
              </a:pPr>
              <a:r>
                <a:rPr lang="en-GB" sz="1400" b="1" dirty="0"/>
                <a:t>P38</a:t>
              </a:r>
            </a:p>
            <a:p>
              <a:pPr>
                <a:spcAft>
                  <a:spcPts val="1400"/>
                </a:spcAft>
              </a:pPr>
              <a:r>
                <a:rPr lang="en-GB" sz="1400" b="1" dirty="0" err="1"/>
                <a:t>TGFb</a:t>
              </a:r>
              <a:r>
                <a:rPr lang="en-GB" sz="1400" b="1" dirty="0"/>
                <a:t>/ALK5</a:t>
              </a:r>
            </a:p>
            <a:p>
              <a:pPr>
                <a:spcAft>
                  <a:spcPts val="1400"/>
                </a:spcAft>
              </a:pPr>
              <a:r>
                <a:rPr lang="en-GB" sz="1400" b="1" dirty="0"/>
                <a:t>Untreated</a:t>
              </a:r>
            </a:p>
          </p:txBody>
        </p:sp>
      </p:grpSp>
      <p:pic>
        <p:nvPicPr>
          <p:cNvPr id="33" name="Picture 32">
            <a:extLst>
              <a:ext uri="{FF2B5EF4-FFF2-40B4-BE49-F238E27FC236}">
                <a16:creationId xmlns:a16="http://schemas.microsoft.com/office/drawing/2014/main" id="{C857B45B-18ED-B9B6-0B19-C74FE179E74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18" t="28701" r="1255" b="43811"/>
          <a:stretch/>
        </p:blipFill>
        <p:spPr bwMode="auto">
          <a:xfrm>
            <a:off x="7221016" y="5370943"/>
            <a:ext cx="5089715" cy="1459441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Box 4">
            <a:extLst>
              <a:ext uri="{FF2B5EF4-FFF2-40B4-BE49-F238E27FC236}">
                <a16:creationId xmlns:a16="http://schemas.microsoft.com/office/drawing/2014/main" id="{DEFC00D4-AAD8-79B7-FE40-EDA4312615AD}"/>
              </a:ext>
            </a:extLst>
          </p:cNvPr>
          <p:cNvSpPr txBox="1"/>
          <p:nvPr/>
        </p:nvSpPr>
        <p:spPr>
          <a:xfrm rot="16200000">
            <a:off x="8437315" y="4146739"/>
            <a:ext cx="126235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1400"/>
              </a:spcAft>
            </a:pPr>
            <a:r>
              <a:rPr lang="en-GB" sz="1400" b="1" dirty="0"/>
              <a:t>Untreated</a:t>
            </a:r>
          </a:p>
          <a:p>
            <a:pPr>
              <a:spcAft>
                <a:spcPts val="1400"/>
              </a:spcAft>
            </a:pPr>
            <a:r>
              <a:rPr lang="en-GB" sz="1400" b="1" dirty="0"/>
              <a:t>TC ASC10</a:t>
            </a:r>
          </a:p>
          <a:p>
            <a:pPr>
              <a:spcAft>
                <a:spcPts val="1400"/>
              </a:spcAft>
            </a:pPr>
            <a:r>
              <a:rPr lang="en-GB" sz="1400" b="1" dirty="0"/>
              <a:t>ERK5-IN-1</a:t>
            </a:r>
          </a:p>
          <a:p>
            <a:pPr>
              <a:spcAft>
                <a:spcPts val="1400"/>
              </a:spcAft>
            </a:pPr>
            <a:r>
              <a:rPr lang="en-GB" sz="1400" b="1" dirty="0"/>
              <a:t>GSK2126458</a:t>
            </a:r>
          </a:p>
          <a:p>
            <a:pPr>
              <a:spcAft>
                <a:spcPts val="1400"/>
              </a:spcAft>
            </a:pPr>
            <a:r>
              <a:rPr lang="en-GB" sz="1400" b="1" dirty="0"/>
              <a:t>P38</a:t>
            </a:r>
          </a:p>
          <a:p>
            <a:pPr>
              <a:spcAft>
                <a:spcPts val="1400"/>
              </a:spcAft>
            </a:pPr>
            <a:r>
              <a:rPr lang="en-GB" sz="1400" b="1" dirty="0" err="1"/>
              <a:t>TGFb</a:t>
            </a:r>
            <a:r>
              <a:rPr lang="en-GB" sz="1400" b="1" dirty="0"/>
              <a:t>/ALK5</a:t>
            </a:r>
          </a:p>
          <a:p>
            <a:pPr>
              <a:spcAft>
                <a:spcPts val="1400"/>
              </a:spcAft>
            </a:pPr>
            <a:r>
              <a:rPr lang="en-GB" sz="1400" b="1" dirty="0"/>
              <a:t>Untreated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558CA01-A6DF-684F-DAFB-7153A06903E0}"/>
              </a:ext>
            </a:extLst>
          </p:cNvPr>
          <p:cNvSpPr/>
          <p:nvPr/>
        </p:nvSpPr>
        <p:spPr>
          <a:xfrm>
            <a:off x="7544716" y="6058862"/>
            <a:ext cx="1704412" cy="3269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8548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42">
            <a:extLst>
              <a:ext uri="{FF2B5EF4-FFF2-40B4-BE49-F238E27FC236}">
                <a16:creationId xmlns:a16="http://schemas.microsoft.com/office/drawing/2014/main" id="{6DDFD04A-835A-6DB4-7CFD-E65C91939AD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86" t="45394" r="6740" b="858"/>
          <a:stretch/>
        </p:blipFill>
        <p:spPr bwMode="auto">
          <a:xfrm>
            <a:off x="2126097" y="3354099"/>
            <a:ext cx="4690064" cy="1990912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C16DB6D-2F93-6176-465F-9A95D192B8D8}"/>
              </a:ext>
            </a:extLst>
          </p:cNvPr>
          <p:cNvSpPr txBox="1"/>
          <p:nvPr/>
        </p:nvSpPr>
        <p:spPr>
          <a:xfrm>
            <a:off x="152305" y="285865"/>
            <a:ext cx="1883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lots for figure 6D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4F2952F-A7A5-B7D1-497D-BA577B44B9C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5" b="7240"/>
          <a:stretch/>
        </p:blipFill>
        <p:spPr bwMode="auto">
          <a:xfrm>
            <a:off x="2364470" y="419960"/>
            <a:ext cx="4137700" cy="291317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FBD5BD0-F438-8637-5D25-B3A17BB2B552}"/>
              </a:ext>
            </a:extLst>
          </p:cNvPr>
          <p:cNvSpPr txBox="1"/>
          <p:nvPr/>
        </p:nvSpPr>
        <p:spPr>
          <a:xfrm>
            <a:off x="2126765" y="1669897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KX2-5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144D51A-C19A-CA27-7E50-FD9A93400158}"/>
              </a:ext>
            </a:extLst>
          </p:cNvPr>
          <p:cNvSpPr/>
          <p:nvPr/>
        </p:nvSpPr>
        <p:spPr>
          <a:xfrm>
            <a:off x="5353050" y="2141888"/>
            <a:ext cx="619125" cy="3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F9E7E111-F260-9B30-8BF7-59F78CD65A55}"/>
              </a:ext>
            </a:extLst>
          </p:cNvPr>
          <p:cNvGrpSpPr/>
          <p:nvPr/>
        </p:nvGrpSpPr>
        <p:grpSpPr>
          <a:xfrm>
            <a:off x="6642645" y="132969"/>
            <a:ext cx="5436687" cy="1796748"/>
            <a:chOff x="6688733" y="917370"/>
            <a:chExt cx="5436687" cy="1796748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4">
              <p14:nvContentPartPr>
                <p14:cNvPr id="5" name="Ink 4">
                  <a:extLst>
                    <a:ext uri="{FF2B5EF4-FFF2-40B4-BE49-F238E27FC236}">
                      <a16:creationId xmlns:a16="http://schemas.microsoft.com/office/drawing/2014/main" id="{0FDC1146-7821-183A-1BDA-70A3F61A5BE7}"/>
                    </a:ext>
                  </a:extLst>
                </p14:cNvPr>
                <p14:cNvContentPartPr/>
                <p14:nvPr/>
              </p14:nvContentPartPr>
              <p14:xfrm>
                <a:off x="7934151" y="1913123"/>
                <a:ext cx="360" cy="360"/>
              </p14:xfrm>
            </p:contentPart>
          </mc:Choice>
          <mc:Fallback xmlns="">
            <p:pic>
              <p:nvPicPr>
                <p:cNvPr id="5" name="Ink 4">
                  <a:extLst>
                    <a:ext uri="{FF2B5EF4-FFF2-40B4-BE49-F238E27FC236}">
                      <a16:creationId xmlns:a16="http://schemas.microsoft.com/office/drawing/2014/main" id="{0FDC1146-7821-183A-1BDA-70A3F61A5BE7}"/>
                    </a:ext>
                  </a:extLst>
                </p:cNvPr>
                <p:cNvPicPr/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7925151" y="1904123"/>
                  <a:ext cx="18000" cy="18000"/>
                </a:xfrm>
                <a:prstGeom prst="rect">
                  <a:avLst/>
                </a:prstGeom>
              </p:spPr>
            </p:pic>
          </mc:Fallback>
        </mc:AlternateContent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D92CE0D-2F55-4716-F21A-C9967049CF0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 flipH="1">
              <a:off x="6688733" y="917370"/>
              <a:ext cx="5436687" cy="1796748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D476B235-64DD-7413-3ED3-DFA59D9B2716}"/>
                </a:ext>
              </a:extLst>
            </p:cNvPr>
            <p:cNvSpPr/>
            <p:nvPr/>
          </p:nvSpPr>
          <p:spPr>
            <a:xfrm>
              <a:off x="7880802" y="1604493"/>
              <a:ext cx="771525" cy="3205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48B1942E-3A20-FF6E-39D0-60D2D2FC063F}"/>
              </a:ext>
            </a:extLst>
          </p:cNvPr>
          <p:cNvSpPr txBox="1"/>
          <p:nvPr/>
        </p:nvSpPr>
        <p:spPr>
          <a:xfrm>
            <a:off x="2906103" y="29664"/>
            <a:ext cx="26183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dirty="0">
                <a:effectLst/>
                <a:latin typeface="Calibri" panose="020F0502020204030204" pitchFamily="34" charset="0"/>
                <a:ea typeface="MS Mincho" panose="02020609040205080304" pitchFamily="49" charset="-128"/>
                <a:cs typeface="JansonText-Roman"/>
              </a:rPr>
              <a:t>NKX2-5 antibody: a54567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C49AA6C-72D5-809D-013C-C0012325D236}"/>
              </a:ext>
            </a:extLst>
          </p:cNvPr>
          <p:cNvSpPr txBox="1"/>
          <p:nvPr/>
        </p:nvSpPr>
        <p:spPr>
          <a:xfrm>
            <a:off x="2325495" y="209309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8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E7BC3C-FA36-89A8-CEB6-C539C407F467}"/>
              </a:ext>
            </a:extLst>
          </p:cNvPr>
          <p:cNvSpPr txBox="1"/>
          <p:nvPr/>
        </p:nvSpPr>
        <p:spPr>
          <a:xfrm>
            <a:off x="2325495" y="2369865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8kDa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F351CAA6-F7E7-8B39-9025-4B09B4B7C6E1}"/>
              </a:ext>
            </a:extLst>
          </p:cNvPr>
          <p:cNvGrpSpPr/>
          <p:nvPr/>
        </p:nvGrpSpPr>
        <p:grpSpPr>
          <a:xfrm>
            <a:off x="-79536" y="5631586"/>
            <a:ext cx="3217136" cy="1226414"/>
            <a:chOff x="8369533" y="3343911"/>
            <a:chExt cx="3217136" cy="1226414"/>
          </a:xfrm>
        </p:grpSpPr>
        <p:pic>
          <p:nvPicPr>
            <p:cNvPr id="13" name="Picture 7">
              <a:extLst>
                <a:ext uri="{FF2B5EF4-FFF2-40B4-BE49-F238E27FC236}">
                  <a16:creationId xmlns:a16="http://schemas.microsoft.com/office/drawing/2014/main" id="{5E1EDE3B-B4BE-9D8F-E123-46F4192DC32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987" r="9684"/>
            <a:stretch/>
          </p:blipFill>
          <p:spPr bwMode="auto">
            <a:xfrm>
              <a:off x="8449305" y="3343911"/>
              <a:ext cx="3137364" cy="120204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35DDD33-D945-06EE-5056-F69D006E1773}"/>
                </a:ext>
              </a:extLst>
            </p:cNvPr>
            <p:cNvSpPr txBox="1"/>
            <p:nvPr/>
          </p:nvSpPr>
          <p:spPr>
            <a:xfrm>
              <a:off x="10781663" y="3951013"/>
              <a:ext cx="7809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ERK5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766872C-0A07-1922-62AE-9D32E8C505F2}"/>
                </a:ext>
              </a:extLst>
            </p:cNvPr>
            <p:cNvSpPr/>
            <p:nvPr/>
          </p:nvSpPr>
          <p:spPr>
            <a:xfrm>
              <a:off x="10241389" y="4026672"/>
              <a:ext cx="537892" cy="33501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9326353-2AD2-B794-5976-B918F5BF3CE8}"/>
                </a:ext>
              </a:extLst>
            </p:cNvPr>
            <p:cNvSpPr txBox="1"/>
            <p:nvPr/>
          </p:nvSpPr>
          <p:spPr>
            <a:xfrm>
              <a:off x="8369533" y="3970862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98kD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A16CA11-994B-AFC8-C85E-342481E6FC67}"/>
                </a:ext>
              </a:extLst>
            </p:cNvPr>
            <p:cNvSpPr txBox="1"/>
            <p:nvPr/>
          </p:nvSpPr>
          <p:spPr>
            <a:xfrm>
              <a:off x="8369533" y="4293326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2kDa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83CB0300-445C-66C6-5350-6DAB0CA22870}"/>
              </a:ext>
            </a:extLst>
          </p:cNvPr>
          <p:cNvGrpSpPr/>
          <p:nvPr/>
        </p:nvGrpSpPr>
        <p:grpSpPr>
          <a:xfrm>
            <a:off x="6684463" y="2023447"/>
            <a:ext cx="5353050" cy="2619375"/>
            <a:chOff x="11445627" y="2716984"/>
            <a:chExt cx="5353050" cy="261937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52C654C-A53C-22FA-B4D2-8F78B38F81C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 flipH="1">
              <a:off x="11445627" y="2716984"/>
              <a:ext cx="5353050" cy="2619375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7053130D-5B6F-1617-88A5-ACBD0005573F}"/>
                </a:ext>
              </a:extLst>
            </p:cNvPr>
            <p:cNvSpPr/>
            <p:nvPr/>
          </p:nvSpPr>
          <p:spPr>
            <a:xfrm>
              <a:off x="12183001" y="3061571"/>
              <a:ext cx="771525" cy="3205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0DA175B-314C-5321-D1A8-78431090A39E}"/>
                </a:ext>
              </a:extLst>
            </p:cNvPr>
            <p:cNvSpPr txBox="1"/>
            <p:nvPr/>
          </p:nvSpPr>
          <p:spPr>
            <a:xfrm>
              <a:off x="11566566" y="2719685"/>
              <a:ext cx="10021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SMAD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0A20ACC-4EFD-A662-76D3-0C08FA9A4D98}"/>
                </a:ext>
              </a:extLst>
            </p:cNvPr>
            <p:cNvSpPr txBox="1"/>
            <p:nvPr/>
          </p:nvSpPr>
          <p:spPr>
            <a:xfrm>
              <a:off x="11543140" y="3750716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8kDa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D1BDBDD-44F7-AA89-9F09-EDFA2D0BCD6F}"/>
                </a:ext>
              </a:extLst>
            </p:cNvPr>
            <p:cNvSpPr txBox="1"/>
            <p:nvPr/>
          </p:nvSpPr>
          <p:spPr>
            <a:xfrm>
              <a:off x="11543140" y="2961171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62kD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BED3FF6-D479-E8FE-373A-2ED3E85CB65C}"/>
                </a:ext>
              </a:extLst>
            </p:cNvPr>
            <p:cNvSpPr txBox="1"/>
            <p:nvPr/>
          </p:nvSpPr>
          <p:spPr>
            <a:xfrm>
              <a:off x="11543140" y="3336893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49kD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D78C35C-B803-B04B-277D-4F4401FA0895}"/>
                </a:ext>
              </a:extLst>
            </p:cNvPr>
            <p:cNvSpPr txBox="1"/>
            <p:nvPr/>
          </p:nvSpPr>
          <p:spPr>
            <a:xfrm>
              <a:off x="11552665" y="4163325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8kDa</a:t>
              </a:r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063BC638-1081-EAB2-0D50-590056C290B5}"/>
              </a:ext>
            </a:extLst>
          </p:cNvPr>
          <p:cNvGrpSpPr/>
          <p:nvPr/>
        </p:nvGrpSpPr>
        <p:grpSpPr>
          <a:xfrm>
            <a:off x="3217372" y="5431736"/>
            <a:ext cx="4015512" cy="1462319"/>
            <a:chOff x="5524500" y="4868320"/>
            <a:chExt cx="4015512" cy="1462319"/>
          </a:xfrm>
        </p:grpSpPr>
        <p:pic>
          <p:nvPicPr>
            <p:cNvPr id="12" name="Picture 5">
              <a:extLst>
                <a:ext uri="{FF2B5EF4-FFF2-40B4-BE49-F238E27FC236}">
                  <a16:creationId xmlns:a16="http://schemas.microsoft.com/office/drawing/2014/main" id="{7E352516-7147-9605-6EB5-9088257FB0B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6504"/>
            <a:stretch/>
          </p:blipFill>
          <p:spPr bwMode="auto">
            <a:xfrm>
              <a:off x="5524500" y="4868320"/>
              <a:ext cx="4015512" cy="1462319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EFF7B304-0A2D-CFCD-508D-9C3298095EC2}"/>
                </a:ext>
              </a:extLst>
            </p:cNvPr>
            <p:cNvSpPr/>
            <p:nvPr/>
          </p:nvSpPr>
          <p:spPr>
            <a:xfrm>
              <a:off x="8443711" y="5679079"/>
              <a:ext cx="663964" cy="3205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958BD29-9B4A-3439-058B-25B4B0D09DC9}"/>
                </a:ext>
              </a:extLst>
            </p:cNvPr>
            <p:cNvSpPr txBox="1"/>
            <p:nvPr/>
          </p:nvSpPr>
          <p:spPr>
            <a:xfrm>
              <a:off x="5579042" y="5282626"/>
              <a:ext cx="136969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ADPH for pERK5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A8886BA-C104-C0BA-111A-331DFA51B03E}"/>
                </a:ext>
              </a:extLst>
            </p:cNvPr>
            <p:cNvSpPr txBox="1"/>
            <p:nvPr/>
          </p:nvSpPr>
          <p:spPr>
            <a:xfrm>
              <a:off x="6397107" y="5751204"/>
              <a:ext cx="5806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8kDa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160A5978-9F16-9183-9269-D14F9B09C7BC}"/>
              </a:ext>
            </a:extLst>
          </p:cNvPr>
          <p:cNvGrpSpPr/>
          <p:nvPr/>
        </p:nvGrpSpPr>
        <p:grpSpPr>
          <a:xfrm>
            <a:off x="6816161" y="4736552"/>
            <a:ext cx="4763976" cy="1086904"/>
            <a:chOff x="7315356" y="4753692"/>
            <a:chExt cx="4763976" cy="1086904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69FEFFBF-C37A-47C4-DA40-53AFA0F4F3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0251" t="24333" b="19008"/>
            <a:stretch/>
          </p:blipFill>
          <p:spPr>
            <a:xfrm flipH="1">
              <a:off x="7315356" y="4753692"/>
              <a:ext cx="4763976" cy="1086904"/>
            </a:xfrm>
            <a:prstGeom prst="rect">
              <a:avLst/>
            </a:prstGeom>
          </p:spPr>
        </p:pic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6465EFB9-603A-5F0F-7EE2-D265A9E569CF}"/>
                </a:ext>
              </a:extLst>
            </p:cNvPr>
            <p:cNvSpPr/>
            <p:nvPr/>
          </p:nvSpPr>
          <p:spPr>
            <a:xfrm>
              <a:off x="8643743" y="5233626"/>
              <a:ext cx="771525" cy="32053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3E027B03-9A7F-7DD6-F891-ED6E980CC2C8}"/>
              </a:ext>
            </a:extLst>
          </p:cNvPr>
          <p:cNvSpPr txBox="1"/>
          <p:nvPr/>
        </p:nvSpPr>
        <p:spPr>
          <a:xfrm>
            <a:off x="7685346" y="5704139"/>
            <a:ext cx="299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 for pSMAD3 and ERK5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5B181E3-ADEB-6274-1B27-299467C55889}"/>
              </a:ext>
            </a:extLst>
          </p:cNvPr>
          <p:cNvSpPr txBox="1"/>
          <p:nvPr/>
        </p:nvSpPr>
        <p:spPr>
          <a:xfrm rot="16200000">
            <a:off x="8744314" y="-1517893"/>
            <a:ext cx="1403980" cy="33958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1600"/>
              </a:spcAft>
            </a:pPr>
            <a:r>
              <a:rPr lang="en-GB" sz="1200" b="1" dirty="0"/>
              <a:t>Untreated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PI3K/AKT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PI3K/690693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ASK1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ERK5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ER1,2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P38</a:t>
            </a:r>
          </a:p>
          <a:p>
            <a:pPr>
              <a:spcAft>
                <a:spcPts val="1600"/>
              </a:spcAft>
            </a:pPr>
            <a:r>
              <a:rPr lang="en-GB" sz="1200" b="1" dirty="0" err="1"/>
              <a:t>TGFb</a:t>
            </a:r>
            <a:r>
              <a:rPr lang="en-GB" sz="1200" b="1" dirty="0"/>
              <a:t>/ALK5</a:t>
            </a:r>
          </a:p>
          <a:p>
            <a:pPr>
              <a:spcAft>
                <a:spcPts val="1600"/>
              </a:spcAft>
            </a:pPr>
            <a:r>
              <a:rPr lang="en-GB" sz="1200" b="1" dirty="0"/>
              <a:t>Untreated</a:t>
            </a:r>
          </a:p>
        </p:txBody>
      </p:sp>
      <p:sp>
        <p:nvSpPr>
          <p:cNvPr id="41" name="TextBox 4">
            <a:extLst>
              <a:ext uri="{FF2B5EF4-FFF2-40B4-BE49-F238E27FC236}">
                <a16:creationId xmlns:a16="http://schemas.microsoft.com/office/drawing/2014/main" id="{A0F78179-CDAB-937B-6C9F-DD1EB16B820C}"/>
              </a:ext>
            </a:extLst>
          </p:cNvPr>
          <p:cNvSpPr txBox="1"/>
          <p:nvPr/>
        </p:nvSpPr>
        <p:spPr>
          <a:xfrm rot="16200000">
            <a:off x="865545" y="4723893"/>
            <a:ext cx="1262352" cy="1769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600"/>
              </a:spcAft>
            </a:pPr>
            <a:r>
              <a:rPr lang="en-GB" sz="1400" b="1" dirty="0"/>
              <a:t>Untreated</a:t>
            </a:r>
          </a:p>
          <a:p>
            <a:pPr>
              <a:spcAft>
                <a:spcPts val="600"/>
              </a:spcAft>
            </a:pPr>
            <a:r>
              <a:rPr lang="en-GB" sz="1400" b="1" dirty="0"/>
              <a:t>AKT</a:t>
            </a:r>
          </a:p>
          <a:p>
            <a:pPr>
              <a:spcAft>
                <a:spcPts val="600"/>
              </a:spcAft>
            </a:pPr>
            <a:r>
              <a:rPr lang="en-GB" sz="1400" b="1" dirty="0"/>
              <a:t>ERK5</a:t>
            </a:r>
          </a:p>
          <a:p>
            <a:pPr>
              <a:spcAft>
                <a:spcPts val="600"/>
              </a:spcAft>
            </a:pPr>
            <a:r>
              <a:rPr lang="en-GB" sz="1400" b="1" dirty="0"/>
              <a:t>ASK1</a:t>
            </a:r>
          </a:p>
          <a:p>
            <a:pPr>
              <a:spcAft>
                <a:spcPts val="600"/>
              </a:spcAft>
            </a:pPr>
            <a:r>
              <a:rPr lang="en-GB" sz="1400" b="1" dirty="0" err="1"/>
              <a:t>TGFb</a:t>
            </a:r>
            <a:r>
              <a:rPr lang="en-GB" sz="1400" b="1" dirty="0"/>
              <a:t>/ALK5</a:t>
            </a:r>
          </a:p>
          <a:p>
            <a:pPr>
              <a:spcAft>
                <a:spcPts val="600"/>
              </a:spcAft>
            </a:pPr>
            <a:r>
              <a:rPr lang="en-GB" sz="1400" b="1" dirty="0"/>
              <a:t>Untreated</a:t>
            </a:r>
          </a:p>
        </p:txBody>
      </p:sp>
      <p:sp>
        <p:nvSpPr>
          <p:cNvPr id="44" name="TextBox 9">
            <a:extLst>
              <a:ext uri="{FF2B5EF4-FFF2-40B4-BE49-F238E27FC236}">
                <a16:creationId xmlns:a16="http://schemas.microsoft.com/office/drawing/2014/main" id="{61794B5C-AA83-C65F-8458-89108179F265}"/>
              </a:ext>
            </a:extLst>
          </p:cNvPr>
          <p:cNvSpPr txBox="1"/>
          <p:nvPr/>
        </p:nvSpPr>
        <p:spPr>
          <a:xfrm rot="16200000">
            <a:off x="3018412" y="2441845"/>
            <a:ext cx="1519968" cy="29751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spcAft>
                <a:spcPts val="400"/>
              </a:spcAft>
            </a:pPr>
            <a:r>
              <a:rPr lang="en-GB" sz="1400" b="1" dirty="0"/>
              <a:t>ASK1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P38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ERK1,2,3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ERK5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Untreated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PI3K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PI3K-690693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HIF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ALK5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Untreated</a:t>
            </a:r>
          </a:p>
          <a:p>
            <a:pPr>
              <a:spcAft>
                <a:spcPts val="400"/>
              </a:spcAft>
            </a:pPr>
            <a:r>
              <a:rPr lang="en-GB" sz="1400" b="1" dirty="0"/>
              <a:t>TAK1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1BC16573-5E65-D197-C92E-9D9375CA3250}"/>
              </a:ext>
            </a:extLst>
          </p:cNvPr>
          <p:cNvSpPr/>
          <p:nvPr/>
        </p:nvSpPr>
        <p:spPr>
          <a:xfrm>
            <a:off x="4397641" y="4783186"/>
            <a:ext cx="568059" cy="2968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436EAB0-4270-3104-CF00-C226D14AB41D}"/>
              </a:ext>
            </a:extLst>
          </p:cNvPr>
          <p:cNvSpPr txBox="1"/>
          <p:nvPr/>
        </p:nvSpPr>
        <p:spPr>
          <a:xfrm>
            <a:off x="5304148" y="4043085"/>
            <a:ext cx="12056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 for NKX2-5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6E06BE5E-F3E6-E3A2-2E8A-9BCDB90F44A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3211" y="600662"/>
            <a:ext cx="2067498" cy="28283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8340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03</TotalTime>
  <Words>540</Words>
  <Application>Microsoft Office PowerPoint</Application>
  <PresentationFormat>Widescreen</PresentationFormat>
  <Paragraphs>303</Paragraphs>
  <Slides>1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4</vt:i4>
      </vt:variant>
    </vt:vector>
  </HeadingPairs>
  <TitlesOfParts>
    <vt:vector size="21" baseType="lpstr">
      <vt:lpstr>Aptos</vt:lpstr>
      <vt:lpstr>Arial</vt:lpstr>
      <vt:lpstr>Calibri</vt:lpstr>
      <vt:lpstr>Calibri Light</vt:lpstr>
      <vt:lpstr>Helvetica</vt:lpstr>
      <vt:lpstr>Office Them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oannis Papaioannou</dc:creator>
  <cp:lastModifiedBy>Ioannis Papaioannou</cp:lastModifiedBy>
  <cp:revision>46</cp:revision>
  <dcterms:created xsi:type="dcterms:W3CDTF">2022-06-23T11:59:59Z</dcterms:created>
  <dcterms:modified xsi:type="dcterms:W3CDTF">2024-04-10T17:46:02Z</dcterms:modified>
</cp:coreProperties>
</file>